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4"/>
  </p:sldMasterIdLst>
  <p:notesMasterIdLst>
    <p:notesMasterId r:id="rId8"/>
  </p:notesMasterIdLst>
  <p:sldIdLst>
    <p:sldId id="328" r:id="rId5"/>
    <p:sldId id="330" r:id="rId6"/>
    <p:sldId id="331" r:id="rId7"/>
  </p:sldIdLst>
  <p:sldSz cx="10080625" cy="136794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en, Shiyi" initials="CS" lastIdx="1" clrIdx="0">
    <p:extLst>
      <p:ext uri="{19B8F6BF-5375-455C-9EA6-DF929625EA0E}">
        <p15:presenceInfo xmlns:p15="http://schemas.microsoft.com/office/powerpoint/2012/main" userId="Chen, Shiy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C743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660B408-B3CF-4A94-85FC-2B1E0A45F4A2}" styleName="Dark Style 2 - Accent 1/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6390" autoAdjust="0"/>
    <p:restoredTop sz="86917"/>
  </p:normalViewPr>
  <p:slideViewPr>
    <p:cSldViewPr snapToGrid="0">
      <p:cViewPr>
        <p:scale>
          <a:sx n="23" d="100"/>
          <a:sy n="23" d="100"/>
        </p:scale>
        <p:origin x="2792" y="2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DA1D60-157C-1A47-9820-AB7AD693F8C0}" type="datetimeFigureOut">
              <a:rPr lang="en-US" smtClean="0"/>
              <a:t>4/1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2350" y="1143000"/>
            <a:ext cx="22733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D552A8-9CB7-A549-93FD-FE0816639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82819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92350" y="1143000"/>
            <a:ext cx="22733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ppendix 1. Sub analyses of waitlist mortality, liver-related mortality and incidence of transplant of listed patients with a potential living donor. 1. Waitlist mortality by sex (a) male or (b) female, age (c) &lt;60 or (d) ≥ 60 and body mass index (e) &lt;25 or (f) ≥ 25. Transplant is used as a competing risk. </a:t>
            </a:r>
            <a:r>
              <a:rPr lang="en-US" sz="1800" dirty="0"/>
              <a:t>Plots truncated at 2 years ensuring at least 10% patients are still in the cohort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D552A8-9CB7-A549-93FD-FE081663993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27967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92350" y="1143000"/>
            <a:ext cx="22733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ppendix 1. Sub analyses of waitlist mortality, liver-related mortality and incidence of transplant of listed patients with a potential living donor. 2. Liver-related mortality by sex (a) male or (b) female, age (c) &lt;60 or (d) ≥ 60 and body mass index (e) &lt;25 or (f) ≥ 25.  3. Incidence of transplant by sex (a) male or (b) female, age (c) &lt;60 or (d) ≥ 60 and body mass index (e) &lt;25 or (f) ≥ 25. </a:t>
            </a:r>
            <a:r>
              <a:rPr lang="en-US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r</a:t>
            </a:r>
            <a:r>
              <a:rPr lang="en-US" sz="1800" dirty="0">
                <a:solidFill>
                  <a:srgbClr val="FF0000"/>
                </a:solidFill>
              </a:rPr>
              <a:t>ansplant and non-liver related death as competing risks</a:t>
            </a: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800" dirty="0"/>
              <a:t>Plots truncated at 2 years ensuring at least 10% patients are still in the cohort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D552A8-9CB7-A549-93FD-FE081663993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86665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92350" y="1143000"/>
            <a:ext cx="22733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ppendix 1. Sub analyses of waitlist mortality, liver-related mortality and incidence of transplant of listed patients with a potential living donor. 3. Liver-related mortality by sex (a) male or (b) female, age (c) &lt;60 or (d) ≥ 60 and body mass index (e) &lt;25 or (f) ≥ 25.  3. Incidence of transplant by sex (a) male or (b) female, age (c) &lt;60 or (d) ≥ 60 and body mass index (e) &lt;25 or (f) ≥ 25.  Death is used as a competing risk. </a:t>
            </a:r>
            <a:r>
              <a:rPr lang="en-US" sz="1800" dirty="0"/>
              <a:t>Plots truncated at 2 years ensuring at least 10% patients are still in the cohort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D552A8-9CB7-A549-93FD-FE081663993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1670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6047" y="2238751"/>
            <a:ext cx="8568531" cy="4762488"/>
          </a:xfrm>
        </p:spPr>
        <p:txBody>
          <a:bodyPr anchor="b"/>
          <a:lstStyle>
            <a:lvl1pPr algn="ctr">
              <a:defRPr sz="661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60078" y="7184899"/>
            <a:ext cx="7560469" cy="3302709"/>
          </a:xfrm>
        </p:spPr>
        <p:txBody>
          <a:bodyPr/>
          <a:lstStyle>
            <a:lvl1pPr marL="0" indent="0" algn="ctr">
              <a:buNone/>
              <a:defRPr sz="2646"/>
            </a:lvl1pPr>
            <a:lvl2pPr marL="504017" indent="0" algn="ctr">
              <a:buNone/>
              <a:defRPr sz="2205"/>
            </a:lvl2pPr>
            <a:lvl3pPr marL="1008035" indent="0" algn="ctr">
              <a:buNone/>
              <a:defRPr sz="1984"/>
            </a:lvl3pPr>
            <a:lvl4pPr marL="1512052" indent="0" algn="ctr">
              <a:buNone/>
              <a:defRPr sz="1764"/>
            </a:lvl4pPr>
            <a:lvl5pPr marL="2016069" indent="0" algn="ctr">
              <a:buNone/>
              <a:defRPr sz="1764"/>
            </a:lvl5pPr>
            <a:lvl6pPr marL="2520086" indent="0" algn="ctr">
              <a:buNone/>
              <a:defRPr sz="1764"/>
            </a:lvl6pPr>
            <a:lvl7pPr marL="3024104" indent="0" algn="ctr">
              <a:buNone/>
              <a:defRPr sz="1764"/>
            </a:lvl7pPr>
            <a:lvl8pPr marL="3528121" indent="0" algn="ctr">
              <a:buNone/>
              <a:defRPr sz="1764"/>
            </a:lvl8pPr>
            <a:lvl9pPr marL="4032138" indent="0" algn="ctr">
              <a:buNone/>
              <a:defRPr sz="176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6C491-C6B0-474B-A5D5-13D7955E6C33}" type="datetimeFigureOut">
              <a:rPr lang="en-US" smtClean="0"/>
              <a:t>4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4F0E7-7EB9-43B8-AD2C-26C3FCA16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617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6C491-C6B0-474B-A5D5-13D7955E6C33}" type="datetimeFigureOut">
              <a:rPr lang="en-US" smtClean="0"/>
              <a:t>4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4F0E7-7EB9-43B8-AD2C-26C3FCA16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0875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213948" y="728306"/>
            <a:ext cx="2173635" cy="115927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3044" y="728306"/>
            <a:ext cx="6394896" cy="1159273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6C491-C6B0-474B-A5D5-13D7955E6C33}" type="datetimeFigureOut">
              <a:rPr lang="en-US" smtClean="0"/>
              <a:t>4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4F0E7-7EB9-43B8-AD2C-26C3FCA16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358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6C491-C6B0-474B-A5D5-13D7955E6C33}" type="datetimeFigureOut">
              <a:rPr lang="en-US" smtClean="0"/>
              <a:t>4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4F0E7-7EB9-43B8-AD2C-26C3FCA16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675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7793" y="3410376"/>
            <a:ext cx="8694539" cy="5690286"/>
          </a:xfrm>
        </p:spPr>
        <p:txBody>
          <a:bodyPr anchor="b"/>
          <a:lstStyle>
            <a:lvl1pPr>
              <a:defRPr sz="661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7793" y="9154495"/>
            <a:ext cx="8694539" cy="2992387"/>
          </a:xfrm>
        </p:spPr>
        <p:txBody>
          <a:bodyPr/>
          <a:lstStyle>
            <a:lvl1pPr marL="0" indent="0">
              <a:buNone/>
              <a:defRPr sz="2646">
                <a:solidFill>
                  <a:schemeClr val="tx1"/>
                </a:solidFill>
              </a:defRPr>
            </a:lvl1pPr>
            <a:lvl2pPr marL="504017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2pPr>
            <a:lvl3pPr marL="1008035" indent="0">
              <a:buNone/>
              <a:defRPr sz="1984">
                <a:solidFill>
                  <a:schemeClr val="tx1">
                    <a:tint val="75000"/>
                  </a:schemeClr>
                </a:solidFill>
              </a:defRPr>
            </a:lvl3pPr>
            <a:lvl4pPr marL="1512052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4pPr>
            <a:lvl5pPr marL="2016069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5pPr>
            <a:lvl6pPr marL="2520086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6pPr>
            <a:lvl7pPr marL="3024104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7pPr>
            <a:lvl8pPr marL="3528121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8pPr>
            <a:lvl9pPr marL="4032138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6C491-C6B0-474B-A5D5-13D7955E6C33}" type="datetimeFigureOut">
              <a:rPr lang="en-US" smtClean="0"/>
              <a:t>4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4F0E7-7EB9-43B8-AD2C-26C3FCA16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386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3043" y="3641531"/>
            <a:ext cx="4284266" cy="867950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03316" y="3641531"/>
            <a:ext cx="4284266" cy="867950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6C491-C6B0-474B-A5D5-13D7955E6C33}" type="datetimeFigureOut">
              <a:rPr lang="en-US" smtClean="0"/>
              <a:t>4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4F0E7-7EB9-43B8-AD2C-26C3FCA16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9962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728309"/>
            <a:ext cx="8694539" cy="26440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4357" y="3353376"/>
            <a:ext cx="4264576" cy="1643437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4017" indent="0">
              <a:buNone/>
              <a:defRPr sz="2205" b="1"/>
            </a:lvl2pPr>
            <a:lvl3pPr marL="1008035" indent="0">
              <a:buNone/>
              <a:defRPr sz="1984" b="1"/>
            </a:lvl3pPr>
            <a:lvl4pPr marL="1512052" indent="0">
              <a:buNone/>
              <a:defRPr sz="1764" b="1"/>
            </a:lvl4pPr>
            <a:lvl5pPr marL="2016069" indent="0">
              <a:buNone/>
              <a:defRPr sz="1764" b="1"/>
            </a:lvl5pPr>
            <a:lvl6pPr marL="2520086" indent="0">
              <a:buNone/>
              <a:defRPr sz="1764" b="1"/>
            </a:lvl6pPr>
            <a:lvl7pPr marL="3024104" indent="0">
              <a:buNone/>
              <a:defRPr sz="1764" b="1"/>
            </a:lvl7pPr>
            <a:lvl8pPr marL="3528121" indent="0">
              <a:buNone/>
              <a:defRPr sz="1764" b="1"/>
            </a:lvl8pPr>
            <a:lvl9pPr marL="4032138" indent="0">
              <a:buNone/>
              <a:defRPr sz="176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57" y="4996813"/>
            <a:ext cx="4264576" cy="73495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3317" y="3353376"/>
            <a:ext cx="4285579" cy="1643437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4017" indent="0">
              <a:buNone/>
              <a:defRPr sz="2205" b="1"/>
            </a:lvl2pPr>
            <a:lvl3pPr marL="1008035" indent="0">
              <a:buNone/>
              <a:defRPr sz="1984" b="1"/>
            </a:lvl3pPr>
            <a:lvl4pPr marL="1512052" indent="0">
              <a:buNone/>
              <a:defRPr sz="1764" b="1"/>
            </a:lvl4pPr>
            <a:lvl5pPr marL="2016069" indent="0">
              <a:buNone/>
              <a:defRPr sz="1764" b="1"/>
            </a:lvl5pPr>
            <a:lvl6pPr marL="2520086" indent="0">
              <a:buNone/>
              <a:defRPr sz="1764" b="1"/>
            </a:lvl6pPr>
            <a:lvl7pPr marL="3024104" indent="0">
              <a:buNone/>
              <a:defRPr sz="1764" b="1"/>
            </a:lvl7pPr>
            <a:lvl8pPr marL="3528121" indent="0">
              <a:buNone/>
              <a:defRPr sz="1764" b="1"/>
            </a:lvl8pPr>
            <a:lvl9pPr marL="4032138" indent="0">
              <a:buNone/>
              <a:defRPr sz="176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3317" y="4996813"/>
            <a:ext cx="4285579" cy="73495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6C491-C6B0-474B-A5D5-13D7955E6C33}" type="datetimeFigureOut">
              <a:rPr lang="en-US" smtClean="0"/>
              <a:t>4/1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4F0E7-7EB9-43B8-AD2C-26C3FCA16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542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6C491-C6B0-474B-A5D5-13D7955E6C33}" type="datetimeFigureOut">
              <a:rPr lang="en-US" smtClean="0"/>
              <a:t>4/1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4F0E7-7EB9-43B8-AD2C-26C3FCA16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1114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6C491-C6B0-474B-A5D5-13D7955E6C33}" type="datetimeFigureOut">
              <a:rPr lang="en-US" smtClean="0"/>
              <a:t>4/1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4F0E7-7EB9-43B8-AD2C-26C3FCA16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246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911966"/>
            <a:ext cx="3251264" cy="3191881"/>
          </a:xfrm>
        </p:spPr>
        <p:txBody>
          <a:bodyPr anchor="b"/>
          <a:lstStyle>
            <a:lvl1pPr>
              <a:defRPr sz="352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85579" y="1969596"/>
            <a:ext cx="5103316" cy="9721303"/>
          </a:xfrm>
        </p:spPr>
        <p:txBody>
          <a:bodyPr/>
          <a:lstStyle>
            <a:lvl1pPr>
              <a:defRPr sz="3528"/>
            </a:lvl1pPr>
            <a:lvl2pPr>
              <a:defRPr sz="3087"/>
            </a:lvl2pPr>
            <a:lvl3pPr>
              <a:defRPr sz="2646"/>
            </a:lvl3pPr>
            <a:lvl4pPr>
              <a:defRPr sz="2205"/>
            </a:lvl4pPr>
            <a:lvl5pPr>
              <a:defRPr sz="2205"/>
            </a:lvl5pPr>
            <a:lvl6pPr>
              <a:defRPr sz="2205"/>
            </a:lvl6pPr>
            <a:lvl7pPr>
              <a:defRPr sz="2205"/>
            </a:lvl7pPr>
            <a:lvl8pPr>
              <a:defRPr sz="2205"/>
            </a:lvl8pPr>
            <a:lvl9pPr>
              <a:defRPr sz="220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4103846"/>
            <a:ext cx="3251264" cy="7602883"/>
          </a:xfrm>
        </p:spPr>
        <p:txBody>
          <a:bodyPr/>
          <a:lstStyle>
            <a:lvl1pPr marL="0" indent="0">
              <a:buNone/>
              <a:defRPr sz="1764"/>
            </a:lvl1pPr>
            <a:lvl2pPr marL="504017" indent="0">
              <a:buNone/>
              <a:defRPr sz="1543"/>
            </a:lvl2pPr>
            <a:lvl3pPr marL="1008035" indent="0">
              <a:buNone/>
              <a:defRPr sz="1323"/>
            </a:lvl3pPr>
            <a:lvl4pPr marL="1512052" indent="0">
              <a:buNone/>
              <a:defRPr sz="1102"/>
            </a:lvl4pPr>
            <a:lvl5pPr marL="2016069" indent="0">
              <a:buNone/>
              <a:defRPr sz="1102"/>
            </a:lvl5pPr>
            <a:lvl6pPr marL="2520086" indent="0">
              <a:buNone/>
              <a:defRPr sz="1102"/>
            </a:lvl6pPr>
            <a:lvl7pPr marL="3024104" indent="0">
              <a:buNone/>
              <a:defRPr sz="1102"/>
            </a:lvl7pPr>
            <a:lvl8pPr marL="3528121" indent="0">
              <a:buNone/>
              <a:defRPr sz="1102"/>
            </a:lvl8pPr>
            <a:lvl9pPr marL="4032138" indent="0">
              <a:buNone/>
              <a:defRPr sz="110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6C491-C6B0-474B-A5D5-13D7955E6C33}" type="datetimeFigureOut">
              <a:rPr lang="en-US" smtClean="0"/>
              <a:t>4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4F0E7-7EB9-43B8-AD2C-26C3FCA16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2388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911966"/>
            <a:ext cx="3251264" cy="3191881"/>
          </a:xfrm>
        </p:spPr>
        <p:txBody>
          <a:bodyPr anchor="b"/>
          <a:lstStyle>
            <a:lvl1pPr>
              <a:defRPr sz="352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85579" y="1969596"/>
            <a:ext cx="5103316" cy="9721303"/>
          </a:xfrm>
        </p:spPr>
        <p:txBody>
          <a:bodyPr anchor="t"/>
          <a:lstStyle>
            <a:lvl1pPr marL="0" indent="0">
              <a:buNone/>
              <a:defRPr sz="3528"/>
            </a:lvl1pPr>
            <a:lvl2pPr marL="504017" indent="0">
              <a:buNone/>
              <a:defRPr sz="3087"/>
            </a:lvl2pPr>
            <a:lvl3pPr marL="1008035" indent="0">
              <a:buNone/>
              <a:defRPr sz="2646"/>
            </a:lvl3pPr>
            <a:lvl4pPr marL="1512052" indent="0">
              <a:buNone/>
              <a:defRPr sz="2205"/>
            </a:lvl4pPr>
            <a:lvl5pPr marL="2016069" indent="0">
              <a:buNone/>
              <a:defRPr sz="2205"/>
            </a:lvl5pPr>
            <a:lvl6pPr marL="2520086" indent="0">
              <a:buNone/>
              <a:defRPr sz="2205"/>
            </a:lvl6pPr>
            <a:lvl7pPr marL="3024104" indent="0">
              <a:buNone/>
              <a:defRPr sz="2205"/>
            </a:lvl7pPr>
            <a:lvl8pPr marL="3528121" indent="0">
              <a:buNone/>
              <a:defRPr sz="2205"/>
            </a:lvl8pPr>
            <a:lvl9pPr marL="4032138" indent="0">
              <a:buNone/>
              <a:defRPr sz="220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4103846"/>
            <a:ext cx="3251264" cy="7602883"/>
          </a:xfrm>
        </p:spPr>
        <p:txBody>
          <a:bodyPr/>
          <a:lstStyle>
            <a:lvl1pPr marL="0" indent="0">
              <a:buNone/>
              <a:defRPr sz="1764"/>
            </a:lvl1pPr>
            <a:lvl2pPr marL="504017" indent="0">
              <a:buNone/>
              <a:defRPr sz="1543"/>
            </a:lvl2pPr>
            <a:lvl3pPr marL="1008035" indent="0">
              <a:buNone/>
              <a:defRPr sz="1323"/>
            </a:lvl3pPr>
            <a:lvl4pPr marL="1512052" indent="0">
              <a:buNone/>
              <a:defRPr sz="1102"/>
            </a:lvl4pPr>
            <a:lvl5pPr marL="2016069" indent="0">
              <a:buNone/>
              <a:defRPr sz="1102"/>
            </a:lvl5pPr>
            <a:lvl6pPr marL="2520086" indent="0">
              <a:buNone/>
              <a:defRPr sz="1102"/>
            </a:lvl6pPr>
            <a:lvl7pPr marL="3024104" indent="0">
              <a:buNone/>
              <a:defRPr sz="1102"/>
            </a:lvl7pPr>
            <a:lvl8pPr marL="3528121" indent="0">
              <a:buNone/>
              <a:defRPr sz="1102"/>
            </a:lvl8pPr>
            <a:lvl9pPr marL="4032138" indent="0">
              <a:buNone/>
              <a:defRPr sz="110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56C491-C6B0-474B-A5D5-13D7955E6C33}" type="datetimeFigureOut">
              <a:rPr lang="en-US" smtClean="0"/>
              <a:t>4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4F0E7-7EB9-43B8-AD2C-26C3FCA16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342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3043" y="728309"/>
            <a:ext cx="8694539" cy="2644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3043" y="3641531"/>
            <a:ext cx="8694539" cy="86795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3043" y="12678862"/>
            <a:ext cx="2268141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56C491-C6B0-474B-A5D5-13D7955E6C33}" type="datetimeFigureOut">
              <a:rPr lang="en-US" smtClean="0"/>
              <a:t>4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9207" y="12678862"/>
            <a:ext cx="3402211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19441" y="12678862"/>
            <a:ext cx="2268141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A4F0E7-7EB9-43B8-AD2C-26C3FCA165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2081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008035" rtl="0" eaLnBrk="1" latinLnBrk="0" hangingPunct="1">
        <a:lnSpc>
          <a:spcPct val="90000"/>
        </a:lnSpc>
        <a:spcBef>
          <a:spcPct val="0"/>
        </a:spcBef>
        <a:buNone/>
        <a:defRPr sz="485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2009" indent="-252009" algn="l" defTabSz="1008035" rtl="0" eaLnBrk="1" latinLnBrk="0" hangingPunct="1">
        <a:lnSpc>
          <a:spcPct val="90000"/>
        </a:lnSpc>
        <a:spcBef>
          <a:spcPts val="1102"/>
        </a:spcBef>
        <a:buFont typeface="Arial" panose="020B0604020202020204" pitchFamily="34" charset="0"/>
        <a:buChar char="•"/>
        <a:defRPr sz="3087" kern="1200">
          <a:solidFill>
            <a:schemeClr val="tx1"/>
          </a:solidFill>
          <a:latin typeface="+mn-lt"/>
          <a:ea typeface="+mn-ea"/>
          <a:cs typeface="+mn-cs"/>
        </a:defRPr>
      </a:lvl1pPr>
      <a:lvl2pPr marL="756026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260043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3pPr>
      <a:lvl4pPr marL="1764060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268078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772095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276112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780130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284147" indent="-252009" algn="l" defTabSz="1008035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504017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1008035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512052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016069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520086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024104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528121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032138" algn="l" defTabSz="1008035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9" name="Group 218">
            <a:extLst>
              <a:ext uri="{FF2B5EF4-FFF2-40B4-BE49-F238E27FC236}">
                <a16:creationId xmlns:a16="http://schemas.microsoft.com/office/drawing/2014/main" id="{E6F5A9B0-F7F2-53D5-E214-B59C221DEE2B}"/>
              </a:ext>
            </a:extLst>
          </p:cNvPr>
          <p:cNvGrpSpPr>
            <a:grpSpLocks noChangeAspect="1"/>
          </p:cNvGrpSpPr>
          <p:nvPr/>
        </p:nvGrpSpPr>
        <p:grpSpPr>
          <a:xfrm>
            <a:off x="137206" y="1540271"/>
            <a:ext cx="4845280" cy="3571875"/>
            <a:chOff x="0" y="0"/>
            <a:chExt cx="9144000" cy="6858000"/>
          </a:xfrm>
        </p:grpSpPr>
        <p:sp>
          <p:nvSpPr>
            <p:cNvPr id="220" name="rc3">
              <a:extLst>
                <a:ext uri="{FF2B5EF4-FFF2-40B4-BE49-F238E27FC236}">
                  <a16:creationId xmlns:a16="http://schemas.microsoft.com/office/drawing/2014/main" id="{FF008BCA-A8B5-2D5F-5781-43F295E248F6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21" name="rc4">
              <a:extLst>
                <a:ext uri="{FF2B5EF4-FFF2-40B4-BE49-F238E27FC236}">
                  <a16:creationId xmlns:a16="http://schemas.microsoft.com/office/drawing/2014/main" id="{E1FB6702-13D1-39F5-28FE-E56137D95CF6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22" name="rc5">
              <a:extLst>
                <a:ext uri="{FF2B5EF4-FFF2-40B4-BE49-F238E27FC236}">
                  <a16:creationId xmlns:a16="http://schemas.microsoft.com/office/drawing/2014/main" id="{08DE3E49-1526-BAE1-309F-ABA47CC01EE8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23" name="rc6">
              <a:extLst>
                <a:ext uri="{FF2B5EF4-FFF2-40B4-BE49-F238E27FC236}">
                  <a16:creationId xmlns:a16="http://schemas.microsoft.com/office/drawing/2014/main" id="{1814460D-BD71-5AAE-9A13-DD7C15CBC2EF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24" name="rc7">
              <a:extLst>
                <a:ext uri="{FF2B5EF4-FFF2-40B4-BE49-F238E27FC236}">
                  <a16:creationId xmlns:a16="http://schemas.microsoft.com/office/drawing/2014/main" id="{52E843B0-7294-13D2-063E-816355EACA24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25" name="pl18">
              <a:extLst>
                <a:ext uri="{FF2B5EF4-FFF2-40B4-BE49-F238E27FC236}">
                  <a16:creationId xmlns:a16="http://schemas.microsoft.com/office/drawing/2014/main" id="{932F7DC5-5BDA-0EB8-DB0E-282F8395AD77}"/>
                </a:ext>
              </a:extLst>
            </p:cNvPr>
            <p:cNvSpPr/>
            <p:nvPr/>
          </p:nvSpPr>
          <p:spPr>
            <a:xfrm>
              <a:off x="776476" y="3534137"/>
              <a:ext cx="8228345" cy="0"/>
            </a:xfrm>
            <a:custGeom>
              <a:avLst/>
              <a:gdLst/>
              <a:ahLst/>
              <a:cxnLst/>
              <a:rect l="0" t="0" r="0" b="0"/>
              <a:pathLst>
                <a:path w="8228345">
                  <a:moveTo>
                    <a:pt x="0" y="0"/>
                  </a:moveTo>
                  <a:lnTo>
                    <a:pt x="8228345" y="0"/>
                  </a:lnTo>
                  <a:lnTo>
                    <a:pt x="8228345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26" name="pl23">
              <a:extLst>
                <a:ext uri="{FF2B5EF4-FFF2-40B4-BE49-F238E27FC236}">
                  <a16:creationId xmlns:a16="http://schemas.microsoft.com/office/drawing/2014/main" id="{FE5C4B34-C864-D35B-7C3A-8D8BE54F4975}"/>
                </a:ext>
              </a:extLst>
            </p:cNvPr>
            <p:cNvSpPr/>
            <p:nvPr/>
          </p:nvSpPr>
          <p:spPr>
            <a:xfrm>
              <a:off x="1150492" y="139178"/>
              <a:ext cx="0" cy="3556623"/>
            </a:xfrm>
            <a:custGeom>
              <a:avLst/>
              <a:gdLst/>
              <a:ahLst/>
              <a:cxnLst/>
              <a:rect l="0" t="0" r="0" b="0"/>
              <a:pathLst>
                <a:path h="3556623">
                  <a:moveTo>
                    <a:pt x="0" y="35566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27" name="pl27">
              <a:extLst>
                <a:ext uri="{FF2B5EF4-FFF2-40B4-BE49-F238E27FC236}">
                  <a16:creationId xmlns:a16="http://schemas.microsoft.com/office/drawing/2014/main" id="{D3A427CA-BC78-44D8-5F1B-C27CE31C7275}"/>
                </a:ext>
              </a:extLst>
            </p:cNvPr>
            <p:cNvSpPr/>
            <p:nvPr/>
          </p:nvSpPr>
          <p:spPr>
            <a:xfrm>
              <a:off x="1150492" y="2263914"/>
              <a:ext cx="6209685" cy="1270222"/>
            </a:xfrm>
            <a:custGeom>
              <a:avLst/>
              <a:gdLst/>
              <a:ahLst/>
              <a:cxnLst/>
              <a:rect l="0" t="0" r="0" b="0"/>
              <a:pathLst>
                <a:path w="6209685" h="1270222">
                  <a:moveTo>
                    <a:pt x="0" y="1270222"/>
                  </a:moveTo>
                  <a:lnTo>
                    <a:pt x="61482" y="1270222"/>
                  </a:lnTo>
                  <a:lnTo>
                    <a:pt x="61482" y="1270222"/>
                  </a:lnTo>
                  <a:lnTo>
                    <a:pt x="184446" y="1270222"/>
                  </a:lnTo>
                  <a:lnTo>
                    <a:pt x="184446" y="1270222"/>
                  </a:lnTo>
                  <a:lnTo>
                    <a:pt x="317657" y="1270222"/>
                  </a:lnTo>
                  <a:lnTo>
                    <a:pt x="317657" y="1270222"/>
                  </a:lnTo>
                  <a:lnTo>
                    <a:pt x="389386" y="1270222"/>
                  </a:lnTo>
                  <a:lnTo>
                    <a:pt x="389386" y="1270222"/>
                  </a:lnTo>
                  <a:lnTo>
                    <a:pt x="440621" y="1270222"/>
                  </a:lnTo>
                  <a:lnTo>
                    <a:pt x="440621" y="1068141"/>
                  </a:lnTo>
                  <a:lnTo>
                    <a:pt x="809513" y="1068141"/>
                  </a:lnTo>
                  <a:lnTo>
                    <a:pt x="809513" y="866061"/>
                  </a:lnTo>
                  <a:lnTo>
                    <a:pt x="1619026" y="866061"/>
                  </a:lnTo>
                  <a:lnTo>
                    <a:pt x="1619026" y="866061"/>
                  </a:lnTo>
                  <a:lnTo>
                    <a:pt x="1834213" y="866061"/>
                  </a:lnTo>
                  <a:lnTo>
                    <a:pt x="1834213" y="866061"/>
                  </a:lnTo>
                  <a:lnTo>
                    <a:pt x="2490022" y="866061"/>
                  </a:lnTo>
                  <a:lnTo>
                    <a:pt x="2490022" y="606242"/>
                  </a:lnTo>
                  <a:lnTo>
                    <a:pt x="2520763" y="606242"/>
                  </a:lnTo>
                  <a:lnTo>
                    <a:pt x="2520763" y="606242"/>
                  </a:lnTo>
                  <a:lnTo>
                    <a:pt x="3340523" y="606242"/>
                  </a:lnTo>
                  <a:lnTo>
                    <a:pt x="3340523" y="346424"/>
                  </a:lnTo>
                  <a:lnTo>
                    <a:pt x="4324236" y="346424"/>
                  </a:lnTo>
                  <a:lnTo>
                    <a:pt x="4324236" y="346424"/>
                  </a:lnTo>
                  <a:lnTo>
                    <a:pt x="4672634" y="346424"/>
                  </a:lnTo>
                  <a:lnTo>
                    <a:pt x="4672634" y="0"/>
                  </a:lnTo>
                  <a:lnTo>
                    <a:pt x="6209685" y="0"/>
                  </a:lnTo>
                  <a:lnTo>
                    <a:pt x="6209685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28" name="pl28">
              <a:extLst>
                <a:ext uri="{FF2B5EF4-FFF2-40B4-BE49-F238E27FC236}">
                  <a16:creationId xmlns:a16="http://schemas.microsoft.com/office/drawing/2014/main" id="{21E72414-38C4-54D2-7463-22CCAFB745F2}"/>
                </a:ext>
              </a:extLst>
            </p:cNvPr>
            <p:cNvSpPr/>
            <p:nvPr/>
          </p:nvSpPr>
          <p:spPr>
            <a:xfrm>
              <a:off x="1150492" y="3226566"/>
              <a:ext cx="6527342" cy="307571"/>
            </a:xfrm>
            <a:custGeom>
              <a:avLst/>
              <a:gdLst/>
              <a:ahLst/>
              <a:cxnLst/>
              <a:rect l="0" t="0" r="0" b="0"/>
              <a:pathLst>
                <a:path w="6527342" h="307571">
                  <a:moveTo>
                    <a:pt x="0" y="307571"/>
                  </a:moveTo>
                  <a:lnTo>
                    <a:pt x="10247" y="307571"/>
                  </a:lnTo>
                  <a:lnTo>
                    <a:pt x="10247" y="307571"/>
                  </a:lnTo>
                  <a:lnTo>
                    <a:pt x="61482" y="307571"/>
                  </a:lnTo>
                  <a:lnTo>
                    <a:pt x="61482" y="307571"/>
                  </a:lnTo>
                  <a:lnTo>
                    <a:pt x="204940" y="307571"/>
                  </a:lnTo>
                  <a:lnTo>
                    <a:pt x="204940" y="307571"/>
                  </a:lnTo>
                  <a:lnTo>
                    <a:pt x="266422" y="307571"/>
                  </a:lnTo>
                  <a:lnTo>
                    <a:pt x="266422" y="264997"/>
                  </a:lnTo>
                  <a:lnTo>
                    <a:pt x="286916" y="264997"/>
                  </a:lnTo>
                  <a:lnTo>
                    <a:pt x="286916" y="264997"/>
                  </a:lnTo>
                  <a:lnTo>
                    <a:pt x="338151" y="264997"/>
                  </a:lnTo>
                  <a:lnTo>
                    <a:pt x="338151" y="222423"/>
                  </a:lnTo>
                  <a:lnTo>
                    <a:pt x="389386" y="222423"/>
                  </a:lnTo>
                  <a:lnTo>
                    <a:pt x="389386" y="222423"/>
                  </a:lnTo>
                  <a:lnTo>
                    <a:pt x="430374" y="222423"/>
                  </a:lnTo>
                  <a:lnTo>
                    <a:pt x="430374" y="222423"/>
                  </a:lnTo>
                  <a:lnTo>
                    <a:pt x="440621" y="222423"/>
                  </a:lnTo>
                  <a:lnTo>
                    <a:pt x="440621" y="179849"/>
                  </a:lnTo>
                  <a:lnTo>
                    <a:pt x="471362" y="179849"/>
                  </a:lnTo>
                  <a:lnTo>
                    <a:pt x="471362" y="179849"/>
                  </a:lnTo>
                  <a:lnTo>
                    <a:pt x="491856" y="179849"/>
                  </a:lnTo>
                  <a:lnTo>
                    <a:pt x="491856" y="179849"/>
                  </a:lnTo>
                  <a:lnTo>
                    <a:pt x="502103" y="179849"/>
                  </a:lnTo>
                  <a:lnTo>
                    <a:pt x="502103" y="179849"/>
                  </a:lnTo>
                  <a:lnTo>
                    <a:pt x="532844" y="179849"/>
                  </a:lnTo>
                  <a:lnTo>
                    <a:pt x="532844" y="179849"/>
                  </a:lnTo>
                  <a:lnTo>
                    <a:pt x="635314" y="179849"/>
                  </a:lnTo>
                  <a:lnTo>
                    <a:pt x="635314" y="179849"/>
                  </a:lnTo>
                  <a:lnTo>
                    <a:pt x="645561" y="179849"/>
                  </a:lnTo>
                  <a:lnTo>
                    <a:pt x="645561" y="179849"/>
                  </a:lnTo>
                  <a:lnTo>
                    <a:pt x="717290" y="179849"/>
                  </a:lnTo>
                  <a:lnTo>
                    <a:pt x="717290" y="179849"/>
                  </a:lnTo>
                  <a:lnTo>
                    <a:pt x="789019" y="179849"/>
                  </a:lnTo>
                  <a:lnTo>
                    <a:pt x="789019" y="179849"/>
                  </a:lnTo>
                  <a:lnTo>
                    <a:pt x="840254" y="179849"/>
                  </a:lnTo>
                  <a:lnTo>
                    <a:pt x="840254" y="136588"/>
                  </a:lnTo>
                  <a:lnTo>
                    <a:pt x="860748" y="136588"/>
                  </a:lnTo>
                  <a:lnTo>
                    <a:pt x="860748" y="136588"/>
                  </a:lnTo>
                  <a:lnTo>
                    <a:pt x="901736" y="136588"/>
                  </a:lnTo>
                  <a:lnTo>
                    <a:pt x="901736" y="136588"/>
                  </a:lnTo>
                  <a:lnTo>
                    <a:pt x="942724" y="136588"/>
                  </a:lnTo>
                  <a:lnTo>
                    <a:pt x="942724" y="136588"/>
                  </a:lnTo>
                  <a:lnTo>
                    <a:pt x="1065688" y="136588"/>
                  </a:lnTo>
                  <a:lnTo>
                    <a:pt x="1065688" y="136588"/>
                  </a:lnTo>
                  <a:lnTo>
                    <a:pt x="1096429" y="136588"/>
                  </a:lnTo>
                  <a:lnTo>
                    <a:pt x="1096429" y="136588"/>
                  </a:lnTo>
                  <a:lnTo>
                    <a:pt x="1116923" y="136588"/>
                  </a:lnTo>
                  <a:lnTo>
                    <a:pt x="1116923" y="136588"/>
                  </a:lnTo>
                  <a:lnTo>
                    <a:pt x="1157911" y="136588"/>
                  </a:lnTo>
                  <a:lnTo>
                    <a:pt x="1157911" y="136588"/>
                  </a:lnTo>
                  <a:lnTo>
                    <a:pt x="1168158" y="136588"/>
                  </a:lnTo>
                  <a:lnTo>
                    <a:pt x="1168158" y="136588"/>
                  </a:lnTo>
                  <a:lnTo>
                    <a:pt x="1178405" y="136588"/>
                  </a:lnTo>
                  <a:lnTo>
                    <a:pt x="1178405" y="136588"/>
                  </a:lnTo>
                  <a:lnTo>
                    <a:pt x="1250134" y="136588"/>
                  </a:lnTo>
                  <a:lnTo>
                    <a:pt x="1250134" y="136588"/>
                  </a:lnTo>
                  <a:lnTo>
                    <a:pt x="1280875" y="136588"/>
                  </a:lnTo>
                  <a:lnTo>
                    <a:pt x="1280875" y="136588"/>
                  </a:lnTo>
                  <a:lnTo>
                    <a:pt x="1291122" y="136588"/>
                  </a:lnTo>
                  <a:lnTo>
                    <a:pt x="1291122" y="136588"/>
                  </a:lnTo>
                  <a:lnTo>
                    <a:pt x="1332110" y="136588"/>
                  </a:lnTo>
                  <a:lnTo>
                    <a:pt x="1332110" y="93327"/>
                  </a:lnTo>
                  <a:lnTo>
                    <a:pt x="1434580" y="93327"/>
                  </a:lnTo>
                  <a:lnTo>
                    <a:pt x="1434580" y="93327"/>
                  </a:lnTo>
                  <a:lnTo>
                    <a:pt x="1485815" y="93327"/>
                  </a:lnTo>
                  <a:lnTo>
                    <a:pt x="1485815" y="93327"/>
                  </a:lnTo>
                  <a:lnTo>
                    <a:pt x="1547297" y="93327"/>
                  </a:lnTo>
                  <a:lnTo>
                    <a:pt x="1547297" y="93327"/>
                  </a:lnTo>
                  <a:lnTo>
                    <a:pt x="1711249" y="93327"/>
                  </a:lnTo>
                  <a:lnTo>
                    <a:pt x="1711249" y="93327"/>
                  </a:lnTo>
                  <a:lnTo>
                    <a:pt x="1731743" y="93327"/>
                  </a:lnTo>
                  <a:lnTo>
                    <a:pt x="1731743" y="93327"/>
                  </a:lnTo>
                  <a:lnTo>
                    <a:pt x="1741990" y="93327"/>
                  </a:lnTo>
                  <a:lnTo>
                    <a:pt x="1741990" y="93327"/>
                  </a:lnTo>
                  <a:lnTo>
                    <a:pt x="1752237" y="93327"/>
                  </a:lnTo>
                  <a:lnTo>
                    <a:pt x="1752237" y="93327"/>
                  </a:lnTo>
                  <a:lnTo>
                    <a:pt x="1905942" y="93327"/>
                  </a:lnTo>
                  <a:lnTo>
                    <a:pt x="1905942" y="93327"/>
                  </a:lnTo>
                  <a:lnTo>
                    <a:pt x="1936683" y="93327"/>
                  </a:lnTo>
                  <a:lnTo>
                    <a:pt x="1936683" y="93327"/>
                  </a:lnTo>
                  <a:lnTo>
                    <a:pt x="1957177" y="93327"/>
                  </a:lnTo>
                  <a:lnTo>
                    <a:pt x="1957177" y="93327"/>
                  </a:lnTo>
                  <a:lnTo>
                    <a:pt x="2121130" y="93327"/>
                  </a:lnTo>
                  <a:lnTo>
                    <a:pt x="2121130" y="93327"/>
                  </a:lnTo>
                  <a:lnTo>
                    <a:pt x="2244094" y="93327"/>
                  </a:lnTo>
                  <a:lnTo>
                    <a:pt x="2244094" y="47482"/>
                  </a:lnTo>
                  <a:lnTo>
                    <a:pt x="2356811" y="47482"/>
                  </a:lnTo>
                  <a:lnTo>
                    <a:pt x="2356811" y="47482"/>
                  </a:lnTo>
                  <a:lnTo>
                    <a:pt x="2367058" y="47482"/>
                  </a:lnTo>
                  <a:lnTo>
                    <a:pt x="2367058" y="47482"/>
                  </a:lnTo>
                  <a:lnTo>
                    <a:pt x="2418293" y="47482"/>
                  </a:lnTo>
                  <a:lnTo>
                    <a:pt x="2418293" y="47482"/>
                  </a:lnTo>
                  <a:lnTo>
                    <a:pt x="2571998" y="47482"/>
                  </a:lnTo>
                  <a:lnTo>
                    <a:pt x="2571998" y="47482"/>
                  </a:lnTo>
                  <a:lnTo>
                    <a:pt x="2705209" y="47482"/>
                  </a:lnTo>
                  <a:lnTo>
                    <a:pt x="2705209" y="47482"/>
                  </a:lnTo>
                  <a:lnTo>
                    <a:pt x="2725703" y="47482"/>
                  </a:lnTo>
                  <a:lnTo>
                    <a:pt x="2725703" y="47482"/>
                  </a:lnTo>
                  <a:lnTo>
                    <a:pt x="2787185" y="47482"/>
                  </a:lnTo>
                  <a:lnTo>
                    <a:pt x="2787185" y="0"/>
                  </a:lnTo>
                  <a:lnTo>
                    <a:pt x="3002372" y="0"/>
                  </a:lnTo>
                  <a:lnTo>
                    <a:pt x="3002372" y="0"/>
                  </a:lnTo>
                  <a:lnTo>
                    <a:pt x="3279041" y="0"/>
                  </a:lnTo>
                  <a:lnTo>
                    <a:pt x="3279041" y="0"/>
                  </a:lnTo>
                  <a:lnTo>
                    <a:pt x="3340523" y="0"/>
                  </a:lnTo>
                  <a:lnTo>
                    <a:pt x="3340523" y="0"/>
                  </a:lnTo>
                  <a:lnTo>
                    <a:pt x="3945096" y="0"/>
                  </a:lnTo>
                  <a:lnTo>
                    <a:pt x="3945096" y="0"/>
                  </a:lnTo>
                  <a:lnTo>
                    <a:pt x="4590658" y="0"/>
                  </a:lnTo>
                  <a:lnTo>
                    <a:pt x="4590658" y="0"/>
                  </a:lnTo>
                  <a:lnTo>
                    <a:pt x="4877574" y="0"/>
                  </a:lnTo>
                  <a:lnTo>
                    <a:pt x="4877574" y="0"/>
                  </a:lnTo>
                  <a:lnTo>
                    <a:pt x="5512888" y="0"/>
                  </a:lnTo>
                  <a:lnTo>
                    <a:pt x="5512888" y="0"/>
                  </a:lnTo>
                  <a:lnTo>
                    <a:pt x="5994498" y="0"/>
                  </a:lnTo>
                  <a:lnTo>
                    <a:pt x="5994498" y="0"/>
                  </a:lnTo>
                  <a:lnTo>
                    <a:pt x="6045733" y="0"/>
                  </a:lnTo>
                  <a:lnTo>
                    <a:pt x="6045733" y="0"/>
                  </a:lnTo>
                  <a:lnTo>
                    <a:pt x="6301908" y="0"/>
                  </a:lnTo>
                  <a:lnTo>
                    <a:pt x="6301908" y="0"/>
                  </a:lnTo>
                  <a:lnTo>
                    <a:pt x="6527342" y="0"/>
                  </a:lnTo>
                  <a:lnTo>
                    <a:pt x="6527342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29" name="rc29">
              <a:extLst>
                <a:ext uri="{FF2B5EF4-FFF2-40B4-BE49-F238E27FC236}">
                  <a16:creationId xmlns:a16="http://schemas.microsoft.com/office/drawing/2014/main" id="{4F6F520D-E1CE-E0B5-E219-D0B6585FF425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30" name="tx30">
              <a:extLst>
                <a:ext uri="{FF2B5EF4-FFF2-40B4-BE49-F238E27FC236}">
                  <a16:creationId xmlns:a16="http://schemas.microsoft.com/office/drawing/2014/main" id="{B1D32796-02ED-5C10-F548-997A9B92734A}"/>
                </a:ext>
              </a:extLst>
            </p:cNvPr>
            <p:cNvSpPr/>
            <p:nvPr/>
          </p:nvSpPr>
          <p:spPr>
            <a:xfrm>
              <a:off x="466667" y="3486760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231" name="tx31">
              <a:extLst>
                <a:ext uri="{FF2B5EF4-FFF2-40B4-BE49-F238E27FC236}">
                  <a16:creationId xmlns:a16="http://schemas.microsoft.com/office/drawing/2014/main" id="{82ECFC59-213F-D206-E79C-F00DF7D88203}"/>
                </a:ext>
              </a:extLst>
            </p:cNvPr>
            <p:cNvSpPr/>
            <p:nvPr/>
          </p:nvSpPr>
          <p:spPr>
            <a:xfrm>
              <a:off x="466667" y="2678436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232" name="tx32">
              <a:extLst>
                <a:ext uri="{FF2B5EF4-FFF2-40B4-BE49-F238E27FC236}">
                  <a16:creationId xmlns:a16="http://schemas.microsoft.com/office/drawing/2014/main" id="{8BE9AC95-9B86-6931-7762-E62EB083671E}"/>
                </a:ext>
              </a:extLst>
            </p:cNvPr>
            <p:cNvSpPr/>
            <p:nvPr/>
          </p:nvSpPr>
          <p:spPr>
            <a:xfrm>
              <a:off x="466667" y="1870113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233" name="tx33">
              <a:extLst>
                <a:ext uri="{FF2B5EF4-FFF2-40B4-BE49-F238E27FC236}">
                  <a16:creationId xmlns:a16="http://schemas.microsoft.com/office/drawing/2014/main" id="{E931C147-437B-8261-4B83-5E24E0BC1B81}"/>
                </a:ext>
              </a:extLst>
            </p:cNvPr>
            <p:cNvSpPr/>
            <p:nvPr/>
          </p:nvSpPr>
          <p:spPr>
            <a:xfrm>
              <a:off x="466667" y="1061789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234" name="tx34">
              <a:extLst>
                <a:ext uri="{FF2B5EF4-FFF2-40B4-BE49-F238E27FC236}">
                  <a16:creationId xmlns:a16="http://schemas.microsoft.com/office/drawing/2014/main" id="{34C31730-D37E-F872-DDA7-E577ABBE0A9A}"/>
                </a:ext>
              </a:extLst>
            </p:cNvPr>
            <p:cNvSpPr/>
            <p:nvPr/>
          </p:nvSpPr>
          <p:spPr>
            <a:xfrm>
              <a:off x="466667" y="253465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0</a:t>
              </a:r>
            </a:p>
          </p:txBody>
        </p:sp>
        <p:sp>
          <p:nvSpPr>
            <p:cNvPr id="235" name="pl35">
              <a:extLst>
                <a:ext uri="{FF2B5EF4-FFF2-40B4-BE49-F238E27FC236}">
                  <a16:creationId xmlns:a16="http://schemas.microsoft.com/office/drawing/2014/main" id="{631CE732-CA1A-0202-90DE-1F8B5EA4150F}"/>
                </a:ext>
              </a:extLst>
            </p:cNvPr>
            <p:cNvSpPr/>
            <p:nvPr/>
          </p:nvSpPr>
          <p:spPr>
            <a:xfrm>
              <a:off x="741682" y="353413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36" name="pl36">
              <a:extLst>
                <a:ext uri="{FF2B5EF4-FFF2-40B4-BE49-F238E27FC236}">
                  <a16:creationId xmlns:a16="http://schemas.microsoft.com/office/drawing/2014/main" id="{CBB7B7BD-4281-D42C-15B9-0FBA14DAD715}"/>
                </a:ext>
              </a:extLst>
            </p:cNvPr>
            <p:cNvSpPr/>
            <p:nvPr/>
          </p:nvSpPr>
          <p:spPr>
            <a:xfrm>
              <a:off x="741682" y="2725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37" name="pl37">
              <a:extLst>
                <a:ext uri="{FF2B5EF4-FFF2-40B4-BE49-F238E27FC236}">
                  <a16:creationId xmlns:a16="http://schemas.microsoft.com/office/drawing/2014/main" id="{C4C8ED25-A9E2-A5B9-912B-5FD2A917BDC7}"/>
                </a:ext>
              </a:extLst>
            </p:cNvPr>
            <p:cNvSpPr/>
            <p:nvPr/>
          </p:nvSpPr>
          <p:spPr>
            <a:xfrm>
              <a:off x="741682" y="19174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38" name="pl38">
              <a:extLst>
                <a:ext uri="{FF2B5EF4-FFF2-40B4-BE49-F238E27FC236}">
                  <a16:creationId xmlns:a16="http://schemas.microsoft.com/office/drawing/2014/main" id="{56FE9D73-D0E1-15BC-3EF5-54541D233997}"/>
                </a:ext>
              </a:extLst>
            </p:cNvPr>
            <p:cNvSpPr/>
            <p:nvPr/>
          </p:nvSpPr>
          <p:spPr>
            <a:xfrm>
              <a:off x="741682" y="11091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39" name="pl39">
              <a:extLst>
                <a:ext uri="{FF2B5EF4-FFF2-40B4-BE49-F238E27FC236}">
                  <a16:creationId xmlns:a16="http://schemas.microsoft.com/office/drawing/2014/main" id="{D6B9E7BF-01EC-E528-50EF-623F75E9766F}"/>
                </a:ext>
              </a:extLst>
            </p:cNvPr>
            <p:cNvSpPr/>
            <p:nvPr/>
          </p:nvSpPr>
          <p:spPr>
            <a:xfrm>
              <a:off x="741682" y="3008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40" name="pl40">
              <a:extLst>
                <a:ext uri="{FF2B5EF4-FFF2-40B4-BE49-F238E27FC236}">
                  <a16:creationId xmlns:a16="http://schemas.microsoft.com/office/drawing/2014/main" id="{09C8D28C-5824-4ED1-0577-9EB7A5CBEDA4}"/>
                </a:ext>
              </a:extLst>
            </p:cNvPr>
            <p:cNvSpPr/>
            <p:nvPr/>
          </p:nvSpPr>
          <p:spPr>
            <a:xfrm>
              <a:off x="1150492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41" name="pl41">
              <a:extLst>
                <a:ext uri="{FF2B5EF4-FFF2-40B4-BE49-F238E27FC236}">
                  <a16:creationId xmlns:a16="http://schemas.microsoft.com/office/drawing/2014/main" id="{F892C30C-5FBC-45D8-A4FD-FD46C44849D0}"/>
                </a:ext>
              </a:extLst>
            </p:cNvPr>
            <p:cNvSpPr/>
            <p:nvPr/>
          </p:nvSpPr>
          <p:spPr>
            <a:xfrm>
              <a:off x="3199893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42" name="pl42">
              <a:extLst>
                <a:ext uri="{FF2B5EF4-FFF2-40B4-BE49-F238E27FC236}">
                  <a16:creationId xmlns:a16="http://schemas.microsoft.com/office/drawing/2014/main" id="{EC51E979-AA6C-6FC2-956D-207AF3D45893}"/>
                </a:ext>
              </a:extLst>
            </p:cNvPr>
            <p:cNvSpPr/>
            <p:nvPr/>
          </p:nvSpPr>
          <p:spPr>
            <a:xfrm>
              <a:off x="5249294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43" name="pl43">
              <a:extLst>
                <a:ext uri="{FF2B5EF4-FFF2-40B4-BE49-F238E27FC236}">
                  <a16:creationId xmlns:a16="http://schemas.microsoft.com/office/drawing/2014/main" id="{3496B03C-F5DC-0AA0-FEDB-900583BB4431}"/>
                </a:ext>
              </a:extLst>
            </p:cNvPr>
            <p:cNvSpPr/>
            <p:nvPr/>
          </p:nvSpPr>
          <p:spPr>
            <a:xfrm>
              <a:off x="7298695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44" name="tx44">
              <a:extLst>
                <a:ext uri="{FF2B5EF4-FFF2-40B4-BE49-F238E27FC236}">
                  <a16:creationId xmlns:a16="http://schemas.microsoft.com/office/drawing/2014/main" id="{A7CA078F-D9DA-6FFB-5C5D-3D991C9D8191}"/>
                </a:ext>
              </a:extLst>
            </p:cNvPr>
            <p:cNvSpPr/>
            <p:nvPr/>
          </p:nvSpPr>
          <p:spPr>
            <a:xfrm>
              <a:off x="1115176" y="3756509"/>
              <a:ext cx="70631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45" name="tx45">
              <a:extLst>
                <a:ext uri="{FF2B5EF4-FFF2-40B4-BE49-F238E27FC236}">
                  <a16:creationId xmlns:a16="http://schemas.microsoft.com/office/drawing/2014/main" id="{0B32FF08-DBC1-FE1C-5FE0-11BFF10C508A}"/>
                </a:ext>
              </a:extLst>
            </p:cNvPr>
            <p:cNvSpPr/>
            <p:nvPr/>
          </p:nvSpPr>
          <p:spPr>
            <a:xfrm>
              <a:off x="3093946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246" name="tx46">
              <a:extLst>
                <a:ext uri="{FF2B5EF4-FFF2-40B4-BE49-F238E27FC236}">
                  <a16:creationId xmlns:a16="http://schemas.microsoft.com/office/drawing/2014/main" id="{DA28246F-393E-9C21-D8B9-3DF3856D27DC}"/>
                </a:ext>
              </a:extLst>
            </p:cNvPr>
            <p:cNvSpPr/>
            <p:nvPr/>
          </p:nvSpPr>
          <p:spPr>
            <a:xfrm>
              <a:off x="5143347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247" name="tx47">
              <a:extLst>
                <a:ext uri="{FF2B5EF4-FFF2-40B4-BE49-F238E27FC236}">
                  <a16:creationId xmlns:a16="http://schemas.microsoft.com/office/drawing/2014/main" id="{7E5B87DC-C040-23BA-FD4D-CC6F8D79AB57}"/>
                </a:ext>
              </a:extLst>
            </p:cNvPr>
            <p:cNvSpPr/>
            <p:nvPr/>
          </p:nvSpPr>
          <p:spPr>
            <a:xfrm>
              <a:off x="7192748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248" name="tx48">
              <a:extLst>
                <a:ext uri="{FF2B5EF4-FFF2-40B4-BE49-F238E27FC236}">
                  <a16:creationId xmlns:a16="http://schemas.microsoft.com/office/drawing/2014/main" id="{40CFCA9D-021E-46BD-C288-87F99D74B529}"/>
                </a:ext>
              </a:extLst>
            </p:cNvPr>
            <p:cNvSpPr/>
            <p:nvPr/>
          </p:nvSpPr>
          <p:spPr>
            <a:xfrm>
              <a:off x="4081990" y="3938539"/>
              <a:ext cx="1617315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 to mortality (Days)</a:t>
              </a:r>
            </a:p>
          </p:txBody>
        </p:sp>
        <p:sp>
          <p:nvSpPr>
            <p:cNvPr id="249" name="rc50">
              <a:extLst>
                <a:ext uri="{FF2B5EF4-FFF2-40B4-BE49-F238E27FC236}">
                  <a16:creationId xmlns:a16="http://schemas.microsoft.com/office/drawing/2014/main" id="{FF9DA7AE-7DEA-B0A2-E731-ABFE80529300}"/>
                </a:ext>
              </a:extLst>
            </p:cNvPr>
            <p:cNvSpPr/>
            <p:nvPr/>
          </p:nvSpPr>
          <p:spPr>
            <a:xfrm>
              <a:off x="4276688" y="4189554"/>
              <a:ext cx="1227921" cy="358634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250" name="rc51">
              <a:extLst>
                <a:ext uri="{FF2B5EF4-FFF2-40B4-BE49-F238E27FC236}">
                  <a16:creationId xmlns:a16="http://schemas.microsoft.com/office/drawing/2014/main" id="{E0E318E7-430B-9362-A886-A30E1644FE47}"/>
                </a:ext>
              </a:extLst>
            </p:cNvPr>
            <p:cNvSpPr/>
            <p:nvPr/>
          </p:nvSpPr>
          <p:spPr>
            <a:xfrm>
              <a:off x="4415866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251" name="pl52">
              <a:extLst>
                <a:ext uri="{FF2B5EF4-FFF2-40B4-BE49-F238E27FC236}">
                  <a16:creationId xmlns:a16="http://schemas.microsoft.com/office/drawing/2014/main" id="{53AE0285-A4B8-FF2F-09B8-EDBF9FA65852}"/>
                </a:ext>
              </a:extLst>
            </p:cNvPr>
            <p:cNvSpPr/>
            <p:nvPr/>
          </p:nvSpPr>
          <p:spPr>
            <a:xfrm>
              <a:off x="4437812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52" name="rc53">
              <a:extLst>
                <a:ext uri="{FF2B5EF4-FFF2-40B4-BE49-F238E27FC236}">
                  <a16:creationId xmlns:a16="http://schemas.microsoft.com/office/drawing/2014/main" id="{9513DBE9-8345-513F-CDC4-1EB0857C8D81}"/>
                </a:ext>
              </a:extLst>
            </p:cNvPr>
            <p:cNvSpPr/>
            <p:nvPr/>
          </p:nvSpPr>
          <p:spPr>
            <a:xfrm>
              <a:off x="4926900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253" name="pl54">
              <a:extLst>
                <a:ext uri="{FF2B5EF4-FFF2-40B4-BE49-F238E27FC236}">
                  <a16:creationId xmlns:a16="http://schemas.microsoft.com/office/drawing/2014/main" id="{8397181A-3646-B222-E2F3-ECA8102EC0BA}"/>
                </a:ext>
              </a:extLst>
            </p:cNvPr>
            <p:cNvSpPr/>
            <p:nvPr/>
          </p:nvSpPr>
          <p:spPr>
            <a:xfrm>
              <a:off x="4948846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54" name="tx55">
              <a:extLst>
                <a:ext uri="{FF2B5EF4-FFF2-40B4-BE49-F238E27FC236}">
                  <a16:creationId xmlns:a16="http://schemas.microsoft.com/office/drawing/2014/main" id="{FAE1C513-7B74-6EE7-FE64-7AB6322656C5}"/>
                </a:ext>
              </a:extLst>
            </p:cNvPr>
            <p:cNvSpPr/>
            <p:nvPr/>
          </p:nvSpPr>
          <p:spPr>
            <a:xfrm>
              <a:off x="4704911" y="4321929"/>
              <a:ext cx="162346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255" name="tx56">
              <a:extLst>
                <a:ext uri="{FF2B5EF4-FFF2-40B4-BE49-F238E27FC236}">
                  <a16:creationId xmlns:a16="http://schemas.microsoft.com/office/drawing/2014/main" id="{6D85BA45-0A52-1D2F-18F3-9D7B25F891E0}"/>
                </a:ext>
              </a:extLst>
            </p:cNvPr>
            <p:cNvSpPr/>
            <p:nvPr/>
          </p:nvSpPr>
          <p:spPr>
            <a:xfrm>
              <a:off x="5215945" y="4321929"/>
              <a:ext cx="218839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  <p:sp>
          <p:nvSpPr>
            <p:cNvPr id="256" name="rc57">
              <a:extLst>
                <a:ext uri="{FF2B5EF4-FFF2-40B4-BE49-F238E27FC236}">
                  <a16:creationId xmlns:a16="http://schemas.microsoft.com/office/drawing/2014/main" id="{D48B9D9A-BB89-1015-2AE0-1F1D805AAE28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57" name="rc58">
              <a:extLst>
                <a:ext uri="{FF2B5EF4-FFF2-40B4-BE49-F238E27FC236}">
                  <a16:creationId xmlns:a16="http://schemas.microsoft.com/office/drawing/2014/main" id="{980FDCCB-E802-221C-F0BD-C57C131D03EB}"/>
                </a:ext>
              </a:extLst>
            </p:cNvPr>
            <p:cNvSpPr/>
            <p:nvPr/>
          </p:nvSpPr>
          <p:spPr>
            <a:xfrm>
              <a:off x="776476" y="4996549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258" name="tx59">
              <a:extLst>
                <a:ext uri="{FF2B5EF4-FFF2-40B4-BE49-F238E27FC236}">
                  <a16:creationId xmlns:a16="http://schemas.microsoft.com/office/drawing/2014/main" id="{3587EAA4-058A-82DB-D32B-B769B557ED53}"/>
                </a:ext>
              </a:extLst>
            </p:cNvPr>
            <p:cNvSpPr/>
            <p:nvPr/>
          </p:nvSpPr>
          <p:spPr>
            <a:xfrm>
              <a:off x="1115323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59" name="tx60">
              <a:extLst>
                <a:ext uri="{FF2B5EF4-FFF2-40B4-BE49-F238E27FC236}">
                  <a16:creationId xmlns:a16="http://schemas.microsoft.com/office/drawing/2014/main" id="{30C7EE3B-0E48-ABF6-8387-649C18C126F4}"/>
                </a:ext>
              </a:extLst>
            </p:cNvPr>
            <p:cNvSpPr/>
            <p:nvPr/>
          </p:nvSpPr>
          <p:spPr>
            <a:xfrm>
              <a:off x="1080154" y="5132574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6</a:t>
              </a:r>
            </a:p>
          </p:txBody>
        </p:sp>
        <p:sp>
          <p:nvSpPr>
            <p:cNvPr id="260" name="tx61">
              <a:extLst>
                <a:ext uri="{FF2B5EF4-FFF2-40B4-BE49-F238E27FC236}">
                  <a16:creationId xmlns:a16="http://schemas.microsoft.com/office/drawing/2014/main" id="{69E0729A-3B61-5D36-959F-4DABAC78E5D5}"/>
                </a:ext>
              </a:extLst>
            </p:cNvPr>
            <p:cNvSpPr/>
            <p:nvPr/>
          </p:nvSpPr>
          <p:spPr>
            <a:xfrm>
              <a:off x="3164724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261" name="tx62">
              <a:extLst>
                <a:ext uri="{FF2B5EF4-FFF2-40B4-BE49-F238E27FC236}">
                  <a16:creationId xmlns:a16="http://schemas.microsoft.com/office/drawing/2014/main" id="{AFBAC95A-E064-46A1-C30F-9324B588E58D}"/>
                </a:ext>
              </a:extLst>
            </p:cNvPr>
            <p:cNvSpPr/>
            <p:nvPr/>
          </p:nvSpPr>
          <p:spPr>
            <a:xfrm>
              <a:off x="3164724" y="5135661"/>
              <a:ext cx="70337" cy="8935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</a:t>
              </a:r>
            </a:p>
          </p:txBody>
        </p:sp>
        <p:sp>
          <p:nvSpPr>
            <p:cNvPr id="262" name="tx63">
              <a:extLst>
                <a:ext uri="{FF2B5EF4-FFF2-40B4-BE49-F238E27FC236}">
                  <a16:creationId xmlns:a16="http://schemas.microsoft.com/office/drawing/2014/main" id="{8F1CA7F3-3B97-9113-FFE2-0D35904ED790}"/>
                </a:ext>
              </a:extLst>
            </p:cNvPr>
            <p:cNvSpPr/>
            <p:nvPr/>
          </p:nvSpPr>
          <p:spPr>
            <a:xfrm>
              <a:off x="5214125" y="5439829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263" name="tx64">
              <a:extLst>
                <a:ext uri="{FF2B5EF4-FFF2-40B4-BE49-F238E27FC236}">
                  <a16:creationId xmlns:a16="http://schemas.microsoft.com/office/drawing/2014/main" id="{4FA80480-4C9C-B756-2B86-15F8F2267DE5}"/>
                </a:ext>
              </a:extLst>
            </p:cNvPr>
            <p:cNvSpPr/>
            <p:nvPr/>
          </p:nvSpPr>
          <p:spPr>
            <a:xfrm>
              <a:off x="5214125" y="5134488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264" name="tx65">
              <a:extLst>
                <a:ext uri="{FF2B5EF4-FFF2-40B4-BE49-F238E27FC236}">
                  <a16:creationId xmlns:a16="http://schemas.microsoft.com/office/drawing/2014/main" id="{95FDA97B-B7C0-DF93-2897-20AC011DB771}"/>
                </a:ext>
              </a:extLst>
            </p:cNvPr>
            <p:cNvSpPr/>
            <p:nvPr/>
          </p:nvSpPr>
          <p:spPr>
            <a:xfrm>
              <a:off x="7263526" y="5439520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265" name="tx66">
              <a:extLst>
                <a:ext uri="{FF2B5EF4-FFF2-40B4-BE49-F238E27FC236}">
                  <a16:creationId xmlns:a16="http://schemas.microsoft.com/office/drawing/2014/main" id="{DA199126-916C-D14B-D46F-D5FF3B88EF75}"/>
                </a:ext>
              </a:extLst>
            </p:cNvPr>
            <p:cNvSpPr/>
            <p:nvPr/>
          </p:nvSpPr>
          <p:spPr>
            <a:xfrm>
              <a:off x="7263526" y="5134117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266" name="tx67">
              <a:extLst>
                <a:ext uri="{FF2B5EF4-FFF2-40B4-BE49-F238E27FC236}">
                  <a16:creationId xmlns:a16="http://schemas.microsoft.com/office/drawing/2014/main" id="{4249BBC7-2CAB-FB1C-5D4A-257AE3A9C7A1}"/>
                </a:ext>
              </a:extLst>
            </p:cNvPr>
            <p:cNvSpPr/>
            <p:nvPr/>
          </p:nvSpPr>
          <p:spPr>
            <a:xfrm>
              <a:off x="325591" y="5438152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267" name="tx68">
              <a:extLst>
                <a:ext uri="{FF2B5EF4-FFF2-40B4-BE49-F238E27FC236}">
                  <a16:creationId xmlns:a16="http://schemas.microsoft.com/office/drawing/2014/main" id="{64A10702-88A2-DB0C-9A21-DB729CBBD503}"/>
                </a:ext>
              </a:extLst>
            </p:cNvPr>
            <p:cNvSpPr/>
            <p:nvPr/>
          </p:nvSpPr>
          <p:spPr>
            <a:xfrm>
              <a:off x="311638" y="5132811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268" name="tx69">
              <a:extLst>
                <a:ext uri="{FF2B5EF4-FFF2-40B4-BE49-F238E27FC236}">
                  <a16:creationId xmlns:a16="http://schemas.microsoft.com/office/drawing/2014/main" id="{2D3B1FD5-4650-1B88-D354-904DAD7CD267}"/>
                </a:ext>
              </a:extLst>
            </p:cNvPr>
            <p:cNvSpPr/>
            <p:nvPr/>
          </p:nvSpPr>
          <p:spPr>
            <a:xfrm>
              <a:off x="776476" y="4827633"/>
              <a:ext cx="17452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269" name="rc70">
              <a:extLst>
                <a:ext uri="{FF2B5EF4-FFF2-40B4-BE49-F238E27FC236}">
                  <a16:creationId xmlns:a16="http://schemas.microsoft.com/office/drawing/2014/main" id="{00B61DD2-02D9-F109-8EAD-BEF298CC1784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70" name="rc71">
              <a:extLst>
                <a:ext uri="{FF2B5EF4-FFF2-40B4-BE49-F238E27FC236}">
                  <a16:creationId xmlns:a16="http://schemas.microsoft.com/office/drawing/2014/main" id="{47226F44-B087-D71E-34E3-BFD5BFC8FE95}"/>
                </a:ext>
              </a:extLst>
            </p:cNvPr>
            <p:cNvSpPr/>
            <p:nvPr/>
          </p:nvSpPr>
          <p:spPr>
            <a:xfrm>
              <a:off x="776476" y="6081865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271" name="tx72">
              <a:extLst>
                <a:ext uri="{FF2B5EF4-FFF2-40B4-BE49-F238E27FC236}">
                  <a16:creationId xmlns:a16="http://schemas.microsoft.com/office/drawing/2014/main" id="{0D169F84-3AF9-EDF1-E088-8A10F81725AB}"/>
                </a:ext>
              </a:extLst>
            </p:cNvPr>
            <p:cNvSpPr/>
            <p:nvPr/>
          </p:nvSpPr>
          <p:spPr>
            <a:xfrm>
              <a:off x="1115323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72" name="tx73">
              <a:extLst>
                <a:ext uri="{FF2B5EF4-FFF2-40B4-BE49-F238E27FC236}">
                  <a16:creationId xmlns:a16="http://schemas.microsoft.com/office/drawing/2014/main" id="{B68B9C06-F3BF-4B63-0C95-6D3D7FFDB519}"/>
                </a:ext>
              </a:extLst>
            </p:cNvPr>
            <p:cNvSpPr/>
            <p:nvPr/>
          </p:nvSpPr>
          <p:spPr>
            <a:xfrm>
              <a:off x="1080154" y="6220978"/>
              <a:ext cx="140675" cy="8935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7</a:t>
              </a:r>
            </a:p>
          </p:txBody>
        </p:sp>
        <p:sp>
          <p:nvSpPr>
            <p:cNvPr id="273" name="tx74">
              <a:extLst>
                <a:ext uri="{FF2B5EF4-FFF2-40B4-BE49-F238E27FC236}">
                  <a16:creationId xmlns:a16="http://schemas.microsoft.com/office/drawing/2014/main" id="{A9CB4651-3ED6-9A8A-3927-7A80E143F994}"/>
                </a:ext>
              </a:extLst>
            </p:cNvPr>
            <p:cNvSpPr/>
            <p:nvPr/>
          </p:nvSpPr>
          <p:spPr>
            <a:xfrm>
              <a:off x="3164724" y="6524837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274" name="tx75">
              <a:extLst>
                <a:ext uri="{FF2B5EF4-FFF2-40B4-BE49-F238E27FC236}">
                  <a16:creationId xmlns:a16="http://schemas.microsoft.com/office/drawing/2014/main" id="{4F70538E-B296-6E07-C7F8-02DA914FD12E}"/>
                </a:ext>
              </a:extLst>
            </p:cNvPr>
            <p:cNvSpPr/>
            <p:nvPr/>
          </p:nvSpPr>
          <p:spPr>
            <a:xfrm>
              <a:off x="3129555" y="6217828"/>
              <a:ext cx="140675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2</a:t>
              </a:r>
            </a:p>
          </p:txBody>
        </p:sp>
        <p:sp>
          <p:nvSpPr>
            <p:cNvPr id="275" name="tx76">
              <a:extLst>
                <a:ext uri="{FF2B5EF4-FFF2-40B4-BE49-F238E27FC236}">
                  <a16:creationId xmlns:a16="http://schemas.microsoft.com/office/drawing/2014/main" id="{5E884367-A806-3B14-895B-F7289E0CE91A}"/>
                </a:ext>
              </a:extLst>
            </p:cNvPr>
            <p:cNvSpPr/>
            <p:nvPr/>
          </p:nvSpPr>
          <p:spPr>
            <a:xfrm>
              <a:off x="5214125" y="6526319"/>
              <a:ext cx="70337" cy="8935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</a:t>
              </a:r>
            </a:p>
          </p:txBody>
        </p:sp>
        <p:sp>
          <p:nvSpPr>
            <p:cNvPr id="276" name="tx77">
              <a:extLst>
                <a:ext uri="{FF2B5EF4-FFF2-40B4-BE49-F238E27FC236}">
                  <a16:creationId xmlns:a16="http://schemas.microsoft.com/office/drawing/2014/main" id="{8A908BBD-4425-2130-2CE5-613E1C0D49BA}"/>
                </a:ext>
              </a:extLst>
            </p:cNvPr>
            <p:cNvSpPr/>
            <p:nvPr/>
          </p:nvSpPr>
          <p:spPr>
            <a:xfrm>
              <a:off x="5178956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7</a:t>
              </a:r>
            </a:p>
          </p:txBody>
        </p:sp>
        <p:sp>
          <p:nvSpPr>
            <p:cNvPr id="277" name="tx78">
              <a:extLst>
                <a:ext uri="{FF2B5EF4-FFF2-40B4-BE49-F238E27FC236}">
                  <a16:creationId xmlns:a16="http://schemas.microsoft.com/office/drawing/2014/main" id="{5401D9B6-F25E-A266-9DFA-51F2FD74F122}"/>
                </a:ext>
              </a:extLst>
            </p:cNvPr>
            <p:cNvSpPr/>
            <p:nvPr/>
          </p:nvSpPr>
          <p:spPr>
            <a:xfrm>
              <a:off x="7263526" y="6526319"/>
              <a:ext cx="70337" cy="8935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</a:t>
              </a:r>
            </a:p>
          </p:txBody>
        </p:sp>
        <p:sp>
          <p:nvSpPr>
            <p:cNvPr id="278" name="tx79">
              <a:extLst>
                <a:ext uri="{FF2B5EF4-FFF2-40B4-BE49-F238E27FC236}">
                  <a16:creationId xmlns:a16="http://schemas.microsoft.com/office/drawing/2014/main" id="{DF3ABCEA-E542-0DE8-2CBE-011023E5856F}"/>
                </a:ext>
              </a:extLst>
            </p:cNvPr>
            <p:cNvSpPr/>
            <p:nvPr/>
          </p:nvSpPr>
          <p:spPr>
            <a:xfrm>
              <a:off x="7228357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1</a:t>
              </a:r>
            </a:p>
          </p:txBody>
        </p:sp>
        <p:sp>
          <p:nvSpPr>
            <p:cNvPr id="279" name="tx80">
              <a:extLst>
                <a:ext uri="{FF2B5EF4-FFF2-40B4-BE49-F238E27FC236}">
                  <a16:creationId xmlns:a16="http://schemas.microsoft.com/office/drawing/2014/main" id="{A8606E4C-5018-B8E6-D761-570883319481}"/>
                </a:ext>
              </a:extLst>
            </p:cNvPr>
            <p:cNvSpPr/>
            <p:nvPr/>
          </p:nvSpPr>
          <p:spPr>
            <a:xfrm>
              <a:off x="325591" y="6523468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280" name="tx81">
              <a:extLst>
                <a:ext uri="{FF2B5EF4-FFF2-40B4-BE49-F238E27FC236}">
                  <a16:creationId xmlns:a16="http://schemas.microsoft.com/office/drawing/2014/main" id="{1ADFCBB0-CF0C-E84A-B27A-7F6FDC482D3E}"/>
                </a:ext>
              </a:extLst>
            </p:cNvPr>
            <p:cNvSpPr/>
            <p:nvPr/>
          </p:nvSpPr>
          <p:spPr>
            <a:xfrm>
              <a:off x="311638" y="6218127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281" name="tx82">
              <a:extLst>
                <a:ext uri="{FF2B5EF4-FFF2-40B4-BE49-F238E27FC236}">
                  <a16:creationId xmlns:a16="http://schemas.microsoft.com/office/drawing/2014/main" id="{DC8D69A6-3B82-F42C-153A-29F78208C5DA}"/>
                </a:ext>
              </a:extLst>
            </p:cNvPr>
            <p:cNvSpPr/>
            <p:nvPr/>
          </p:nvSpPr>
          <p:spPr>
            <a:xfrm>
              <a:off x="776476" y="5912949"/>
              <a:ext cx="23525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</p:grpSp>
      <p:sp>
        <p:nvSpPr>
          <p:cNvPr id="282" name="tx47">
            <a:extLst>
              <a:ext uri="{FF2B5EF4-FFF2-40B4-BE49-F238E27FC236}">
                <a16:creationId xmlns:a16="http://schemas.microsoft.com/office/drawing/2014/main" id="{905F0A46-F501-8610-65B0-C42FC388A33F}"/>
              </a:ext>
            </a:extLst>
          </p:cNvPr>
          <p:cNvSpPr>
            <a:spLocks noChangeAspect="1"/>
          </p:cNvSpPr>
          <p:nvPr/>
        </p:nvSpPr>
        <p:spPr>
          <a:xfrm rot="16200000">
            <a:off x="-227177" y="2496059"/>
            <a:ext cx="917105" cy="7613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992"/>
              </a:lnSpc>
            </a:pPr>
            <a:r>
              <a:rPr sz="992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rPr>
              <a:t>Cumulative Incidence</a:t>
            </a:r>
            <a:r>
              <a:rPr lang="en-US" sz="992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rPr>
              <a:t> of Mortality (%)</a:t>
            </a:r>
            <a:endParaRPr sz="992" dirty="0">
              <a:solidFill>
                <a:srgbClr val="000000">
                  <a:alpha val="100000"/>
                </a:srgbClr>
              </a:solidFill>
              <a:latin typeface="Arial"/>
              <a:cs typeface="Arial"/>
            </a:endParaRPr>
          </a:p>
        </p:txBody>
      </p:sp>
      <p:sp>
        <p:nvSpPr>
          <p:cNvPr id="283" name="TextBox 282">
            <a:extLst>
              <a:ext uri="{FF2B5EF4-FFF2-40B4-BE49-F238E27FC236}">
                <a16:creationId xmlns:a16="http://schemas.microsoft.com/office/drawing/2014/main" id="{BB7597B7-053A-99E3-6A28-91CC10E67E13}"/>
              </a:ext>
            </a:extLst>
          </p:cNvPr>
          <p:cNvSpPr txBox="1">
            <a:spLocks noChangeAspect="1"/>
          </p:cNvSpPr>
          <p:nvPr/>
        </p:nvSpPr>
        <p:spPr>
          <a:xfrm>
            <a:off x="641127" y="1676171"/>
            <a:ext cx="3208931" cy="6519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9" b="1" dirty="0">
                <a:latin typeface="Arial" panose="020B0604020202020204" pitchFamily="34" charset="0"/>
                <a:cs typeface="Arial" panose="020B0604020202020204" pitchFamily="34" charset="0"/>
              </a:rPr>
              <a:t>Potential Living Donor  Total   Event   HR (95% CI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No                                     16        5         Reference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Yes                                    77        7        0.27 (0.09 – 0.81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Gray K-Sample Test P-value: 0.0148        </a:t>
            </a:r>
          </a:p>
        </p:txBody>
      </p:sp>
      <p:sp>
        <p:nvSpPr>
          <p:cNvPr id="284" name="pl48">
            <a:extLst>
              <a:ext uri="{FF2B5EF4-FFF2-40B4-BE49-F238E27FC236}">
                <a16:creationId xmlns:a16="http://schemas.microsoft.com/office/drawing/2014/main" id="{A6272018-0631-2A89-D3A5-C14DD8FDD086}"/>
              </a:ext>
            </a:extLst>
          </p:cNvPr>
          <p:cNvSpPr>
            <a:spLocks noChangeAspect="1"/>
          </p:cNvSpPr>
          <p:nvPr/>
        </p:nvSpPr>
        <p:spPr>
          <a:xfrm>
            <a:off x="3420298" y="2123749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285" name="pl50">
            <a:extLst>
              <a:ext uri="{FF2B5EF4-FFF2-40B4-BE49-F238E27FC236}">
                <a16:creationId xmlns:a16="http://schemas.microsoft.com/office/drawing/2014/main" id="{48AA1383-98A6-ABB5-E10A-891F65ACA886}"/>
              </a:ext>
            </a:extLst>
          </p:cNvPr>
          <p:cNvSpPr>
            <a:spLocks noChangeAspect="1"/>
          </p:cNvSpPr>
          <p:nvPr/>
        </p:nvSpPr>
        <p:spPr>
          <a:xfrm>
            <a:off x="3420298" y="2250026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286" name="TextBox 285">
            <a:extLst>
              <a:ext uri="{FF2B5EF4-FFF2-40B4-BE49-F238E27FC236}">
                <a16:creationId xmlns:a16="http://schemas.microsoft.com/office/drawing/2014/main" id="{A75EA8EE-FE95-828D-9B7C-E1475333B3D1}"/>
              </a:ext>
            </a:extLst>
          </p:cNvPr>
          <p:cNvSpPr txBox="1"/>
          <p:nvPr/>
        </p:nvSpPr>
        <p:spPr>
          <a:xfrm>
            <a:off x="1403668" y="1308268"/>
            <a:ext cx="2528642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88" b="1" dirty="0"/>
              <a:t>a. MALE: mortality on waitlist</a:t>
            </a:r>
            <a:endParaRPr lang="en-US" sz="1488" dirty="0"/>
          </a:p>
        </p:txBody>
      </p:sp>
      <p:grpSp>
        <p:nvGrpSpPr>
          <p:cNvPr id="353" name="Group 352">
            <a:extLst>
              <a:ext uri="{FF2B5EF4-FFF2-40B4-BE49-F238E27FC236}">
                <a16:creationId xmlns:a16="http://schemas.microsoft.com/office/drawing/2014/main" id="{78BA9EB3-929B-1DDD-1172-BB119E9D519C}"/>
              </a:ext>
            </a:extLst>
          </p:cNvPr>
          <p:cNvGrpSpPr>
            <a:grpSpLocks noChangeAspect="1"/>
          </p:cNvGrpSpPr>
          <p:nvPr/>
        </p:nvGrpSpPr>
        <p:grpSpPr>
          <a:xfrm>
            <a:off x="4974983" y="1540271"/>
            <a:ext cx="4986370" cy="3571875"/>
            <a:chOff x="0" y="0"/>
            <a:chExt cx="9144000" cy="6858000"/>
          </a:xfrm>
        </p:grpSpPr>
        <p:sp>
          <p:nvSpPr>
            <p:cNvPr id="354" name="rc3">
              <a:extLst>
                <a:ext uri="{FF2B5EF4-FFF2-40B4-BE49-F238E27FC236}">
                  <a16:creationId xmlns:a16="http://schemas.microsoft.com/office/drawing/2014/main" id="{73B9298F-DC31-E8BF-02A4-56EB28E8727F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55" name="rc4">
              <a:extLst>
                <a:ext uri="{FF2B5EF4-FFF2-40B4-BE49-F238E27FC236}">
                  <a16:creationId xmlns:a16="http://schemas.microsoft.com/office/drawing/2014/main" id="{30A9A4D2-AB3D-1A63-A86D-856844AA64FC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56" name="rc5">
              <a:extLst>
                <a:ext uri="{FF2B5EF4-FFF2-40B4-BE49-F238E27FC236}">
                  <a16:creationId xmlns:a16="http://schemas.microsoft.com/office/drawing/2014/main" id="{5DD83064-6B24-9D64-242E-D203CC681776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57" name="rc6">
              <a:extLst>
                <a:ext uri="{FF2B5EF4-FFF2-40B4-BE49-F238E27FC236}">
                  <a16:creationId xmlns:a16="http://schemas.microsoft.com/office/drawing/2014/main" id="{8B9FE7DF-9BA1-B257-7EF1-2A86F10156D1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58" name="rc7">
              <a:extLst>
                <a:ext uri="{FF2B5EF4-FFF2-40B4-BE49-F238E27FC236}">
                  <a16:creationId xmlns:a16="http://schemas.microsoft.com/office/drawing/2014/main" id="{3F6EA6BA-B66F-8D97-40C3-A23BE965696C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59" name="rc8">
              <a:extLst>
                <a:ext uri="{FF2B5EF4-FFF2-40B4-BE49-F238E27FC236}">
                  <a16:creationId xmlns:a16="http://schemas.microsoft.com/office/drawing/2014/main" id="{D5F237CE-2D44-75BA-EB82-F52857C9A668}"/>
                </a:ext>
              </a:extLst>
            </p:cNvPr>
            <p:cNvSpPr/>
            <p:nvPr/>
          </p:nvSpPr>
          <p:spPr>
            <a:xfrm>
              <a:off x="69589" y="69588"/>
              <a:ext cx="8715669" cy="454914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60" name="pl18">
              <a:extLst>
                <a:ext uri="{FF2B5EF4-FFF2-40B4-BE49-F238E27FC236}">
                  <a16:creationId xmlns:a16="http://schemas.microsoft.com/office/drawing/2014/main" id="{A4F8ED40-FC41-B21A-6F94-20AB4A960CF0}"/>
                </a:ext>
              </a:extLst>
            </p:cNvPr>
            <p:cNvSpPr/>
            <p:nvPr/>
          </p:nvSpPr>
          <p:spPr>
            <a:xfrm>
              <a:off x="776476" y="3534137"/>
              <a:ext cx="8228345" cy="0"/>
            </a:xfrm>
            <a:custGeom>
              <a:avLst/>
              <a:gdLst/>
              <a:ahLst/>
              <a:cxnLst/>
              <a:rect l="0" t="0" r="0" b="0"/>
              <a:pathLst>
                <a:path w="8228345">
                  <a:moveTo>
                    <a:pt x="0" y="0"/>
                  </a:moveTo>
                  <a:lnTo>
                    <a:pt x="8228345" y="0"/>
                  </a:lnTo>
                  <a:lnTo>
                    <a:pt x="8228345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61" name="pl23">
              <a:extLst>
                <a:ext uri="{FF2B5EF4-FFF2-40B4-BE49-F238E27FC236}">
                  <a16:creationId xmlns:a16="http://schemas.microsoft.com/office/drawing/2014/main" id="{1DF2B33C-7B6D-9FD3-89C8-285CCD57E2D8}"/>
                </a:ext>
              </a:extLst>
            </p:cNvPr>
            <p:cNvSpPr/>
            <p:nvPr/>
          </p:nvSpPr>
          <p:spPr>
            <a:xfrm>
              <a:off x="1150492" y="139178"/>
              <a:ext cx="0" cy="3556623"/>
            </a:xfrm>
            <a:custGeom>
              <a:avLst/>
              <a:gdLst/>
              <a:ahLst/>
              <a:cxnLst/>
              <a:rect l="0" t="0" r="0" b="0"/>
              <a:pathLst>
                <a:path h="3556623">
                  <a:moveTo>
                    <a:pt x="0" y="35566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62" name="pl27">
              <a:extLst>
                <a:ext uri="{FF2B5EF4-FFF2-40B4-BE49-F238E27FC236}">
                  <a16:creationId xmlns:a16="http://schemas.microsoft.com/office/drawing/2014/main" id="{14E7155F-4FCF-7E5E-A21C-565ABE26E09B}"/>
                </a:ext>
              </a:extLst>
            </p:cNvPr>
            <p:cNvSpPr/>
            <p:nvPr/>
          </p:nvSpPr>
          <p:spPr>
            <a:xfrm>
              <a:off x="1150492" y="2402484"/>
              <a:ext cx="4354977" cy="1131653"/>
            </a:xfrm>
            <a:custGeom>
              <a:avLst/>
              <a:gdLst/>
              <a:ahLst/>
              <a:cxnLst/>
              <a:rect l="0" t="0" r="0" b="0"/>
              <a:pathLst>
                <a:path w="4354977" h="1131653">
                  <a:moveTo>
                    <a:pt x="0" y="1131653"/>
                  </a:moveTo>
                  <a:lnTo>
                    <a:pt x="51235" y="1131653"/>
                  </a:lnTo>
                  <a:lnTo>
                    <a:pt x="51235" y="808323"/>
                  </a:lnTo>
                  <a:lnTo>
                    <a:pt x="71729" y="808323"/>
                  </a:lnTo>
                  <a:lnTo>
                    <a:pt x="71729" y="808323"/>
                  </a:lnTo>
                  <a:lnTo>
                    <a:pt x="1014453" y="808323"/>
                  </a:lnTo>
                  <a:lnTo>
                    <a:pt x="1014453" y="808323"/>
                  </a:lnTo>
                  <a:lnTo>
                    <a:pt x="1250134" y="808323"/>
                  </a:lnTo>
                  <a:lnTo>
                    <a:pt x="1250134" y="808323"/>
                  </a:lnTo>
                  <a:lnTo>
                    <a:pt x="2100636" y="808323"/>
                  </a:lnTo>
                  <a:lnTo>
                    <a:pt x="2100636" y="484994"/>
                  </a:lnTo>
                  <a:lnTo>
                    <a:pt x="3074101" y="484994"/>
                  </a:lnTo>
                  <a:lnTo>
                    <a:pt x="3074101" y="484994"/>
                  </a:lnTo>
                  <a:lnTo>
                    <a:pt x="3863120" y="484994"/>
                  </a:lnTo>
                  <a:lnTo>
                    <a:pt x="3863120" y="484994"/>
                  </a:lnTo>
                  <a:lnTo>
                    <a:pt x="4027073" y="484994"/>
                  </a:lnTo>
                  <a:lnTo>
                    <a:pt x="4027073" y="484994"/>
                  </a:lnTo>
                  <a:lnTo>
                    <a:pt x="4273001" y="484994"/>
                  </a:lnTo>
                  <a:lnTo>
                    <a:pt x="4273001" y="484994"/>
                  </a:lnTo>
                  <a:lnTo>
                    <a:pt x="4354977" y="484994"/>
                  </a:lnTo>
                  <a:lnTo>
                    <a:pt x="4354977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63" name="pl28">
              <a:extLst>
                <a:ext uri="{FF2B5EF4-FFF2-40B4-BE49-F238E27FC236}">
                  <a16:creationId xmlns:a16="http://schemas.microsoft.com/office/drawing/2014/main" id="{F134A828-2AB2-BE20-0E63-C9E130A63DDD}"/>
                </a:ext>
              </a:extLst>
            </p:cNvPr>
            <p:cNvSpPr/>
            <p:nvPr/>
          </p:nvSpPr>
          <p:spPr>
            <a:xfrm>
              <a:off x="1150492" y="3452957"/>
              <a:ext cx="7265126" cy="81180"/>
            </a:xfrm>
            <a:custGeom>
              <a:avLst/>
              <a:gdLst/>
              <a:ahLst/>
              <a:cxnLst/>
              <a:rect l="0" t="0" r="0" b="0"/>
              <a:pathLst>
                <a:path w="7265126" h="81180">
                  <a:moveTo>
                    <a:pt x="0" y="81180"/>
                  </a:moveTo>
                  <a:lnTo>
                    <a:pt x="10247" y="81180"/>
                  </a:lnTo>
                  <a:lnTo>
                    <a:pt x="10247" y="81180"/>
                  </a:lnTo>
                  <a:lnTo>
                    <a:pt x="71729" y="81180"/>
                  </a:lnTo>
                  <a:lnTo>
                    <a:pt x="71729" y="81180"/>
                  </a:lnTo>
                  <a:lnTo>
                    <a:pt x="112717" y="81180"/>
                  </a:lnTo>
                  <a:lnTo>
                    <a:pt x="112717" y="81180"/>
                  </a:lnTo>
                  <a:lnTo>
                    <a:pt x="194693" y="81180"/>
                  </a:lnTo>
                  <a:lnTo>
                    <a:pt x="194693" y="81180"/>
                  </a:lnTo>
                  <a:lnTo>
                    <a:pt x="256175" y="81180"/>
                  </a:lnTo>
                  <a:lnTo>
                    <a:pt x="256175" y="81180"/>
                  </a:lnTo>
                  <a:lnTo>
                    <a:pt x="297163" y="81180"/>
                  </a:lnTo>
                  <a:lnTo>
                    <a:pt x="297163" y="81180"/>
                  </a:lnTo>
                  <a:lnTo>
                    <a:pt x="389386" y="81180"/>
                  </a:lnTo>
                  <a:lnTo>
                    <a:pt x="389386" y="81180"/>
                  </a:lnTo>
                  <a:lnTo>
                    <a:pt x="409880" y="81180"/>
                  </a:lnTo>
                  <a:lnTo>
                    <a:pt x="409880" y="81180"/>
                  </a:lnTo>
                  <a:lnTo>
                    <a:pt x="522597" y="81180"/>
                  </a:lnTo>
                  <a:lnTo>
                    <a:pt x="522597" y="81180"/>
                  </a:lnTo>
                  <a:lnTo>
                    <a:pt x="635314" y="81180"/>
                  </a:lnTo>
                  <a:lnTo>
                    <a:pt x="635314" y="81180"/>
                  </a:lnTo>
                  <a:lnTo>
                    <a:pt x="737784" y="81180"/>
                  </a:lnTo>
                  <a:lnTo>
                    <a:pt x="737784" y="81180"/>
                  </a:lnTo>
                  <a:lnTo>
                    <a:pt x="830007" y="81180"/>
                  </a:lnTo>
                  <a:lnTo>
                    <a:pt x="830007" y="81180"/>
                  </a:lnTo>
                  <a:lnTo>
                    <a:pt x="922230" y="81180"/>
                  </a:lnTo>
                  <a:lnTo>
                    <a:pt x="922230" y="81180"/>
                  </a:lnTo>
                  <a:lnTo>
                    <a:pt x="1004206" y="81180"/>
                  </a:lnTo>
                  <a:lnTo>
                    <a:pt x="1004206" y="81180"/>
                  </a:lnTo>
                  <a:lnTo>
                    <a:pt x="1014453" y="81180"/>
                  </a:lnTo>
                  <a:lnTo>
                    <a:pt x="1014453" y="81180"/>
                  </a:lnTo>
                  <a:lnTo>
                    <a:pt x="1034947" y="81180"/>
                  </a:lnTo>
                  <a:lnTo>
                    <a:pt x="1034947" y="81180"/>
                  </a:lnTo>
                  <a:lnTo>
                    <a:pt x="1065688" y="81180"/>
                  </a:lnTo>
                  <a:lnTo>
                    <a:pt x="1065688" y="81180"/>
                  </a:lnTo>
                  <a:lnTo>
                    <a:pt x="1157911" y="81180"/>
                  </a:lnTo>
                  <a:lnTo>
                    <a:pt x="1157911" y="81180"/>
                  </a:lnTo>
                  <a:lnTo>
                    <a:pt x="1198899" y="81180"/>
                  </a:lnTo>
                  <a:lnTo>
                    <a:pt x="1198899" y="81180"/>
                  </a:lnTo>
                  <a:lnTo>
                    <a:pt x="1444827" y="81180"/>
                  </a:lnTo>
                  <a:lnTo>
                    <a:pt x="1444827" y="81180"/>
                  </a:lnTo>
                  <a:lnTo>
                    <a:pt x="1588285" y="81180"/>
                  </a:lnTo>
                  <a:lnTo>
                    <a:pt x="1588285" y="81180"/>
                  </a:lnTo>
                  <a:lnTo>
                    <a:pt x="1649767" y="81180"/>
                  </a:lnTo>
                  <a:lnTo>
                    <a:pt x="1649767" y="0"/>
                  </a:lnTo>
                  <a:lnTo>
                    <a:pt x="1762484" y="0"/>
                  </a:lnTo>
                  <a:lnTo>
                    <a:pt x="1762484" y="0"/>
                  </a:lnTo>
                  <a:lnTo>
                    <a:pt x="1864954" y="0"/>
                  </a:lnTo>
                  <a:lnTo>
                    <a:pt x="1864954" y="0"/>
                  </a:lnTo>
                  <a:lnTo>
                    <a:pt x="1895695" y="0"/>
                  </a:lnTo>
                  <a:lnTo>
                    <a:pt x="1895695" y="0"/>
                  </a:lnTo>
                  <a:lnTo>
                    <a:pt x="2285082" y="0"/>
                  </a:lnTo>
                  <a:lnTo>
                    <a:pt x="2285082" y="0"/>
                  </a:lnTo>
                  <a:lnTo>
                    <a:pt x="2408046" y="0"/>
                  </a:lnTo>
                  <a:lnTo>
                    <a:pt x="2408046" y="0"/>
                  </a:lnTo>
                  <a:lnTo>
                    <a:pt x="2735950" y="0"/>
                  </a:lnTo>
                  <a:lnTo>
                    <a:pt x="2735950" y="0"/>
                  </a:lnTo>
                  <a:lnTo>
                    <a:pt x="3217559" y="0"/>
                  </a:lnTo>
                  <a:lnTo>
                    <a:pt x="3217559" y="0"/>
                  </a:lnTo>
                  <a:lnTo>
                    <a:pt x="3842626" y="0"/>
                  </a:lnTo>
                  <a:lnTo>
                    <a:pt x="3842626" y="0"/>
                  </a:lnTo>
                  <a:lnTo>
                    <a:pt x="3863120" y="0"/>
                  </a:lnTo>
                  <a:lnTo>
                    <a:pt x="3863120" y="0"/>
                  </a:lnTo>
                  <a:lnTo>
                    <a:pt x="3873367" y="0"/>
                  </a:lnTo>
                  <a:lnTo>
                    <a:pt x="3873367" y="0"/>
                  </a:lnTo>
                  <a:lnTo>
                    <a:pt x="5092761" y="0"/>
                  </a:lnTo>
                  <a:lnTo>
                    <a:pt x="5092761" y="0"/>
                  </a:lnTo>
                  <a:lnTo>
                    <a:pt x="5379677" y="0"/>
                  </a:lnTo>
                  <a:lnTo>
                    <a:pt x="5379677" y="0"/>
                  </a:lnTo>
                  <a:lnTo>
                    <a:pt x="7008951" y="0"/>
                  </a:lnTo>
                  <a:lnTo>
                    <a:pt x="7008951" y="0"/>
                  </a:lnTo>
                  <a:lnTo>
                    <a:pt x="7049939" y="0"/>
                  </a:lnTo>
                  <a:lnTo>
                    <a:pt x="7049939" y="0"/>
                  </a:lnTo>
                  <a:lnTo>
                    <a:pt x="7265126" y="0"/>
                  </a:lnTo>
                  <a:lnTo>
                    <a:pt x="7265126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64" name="rc29">
              <a:extLst>
                <a:ext uri="{FF2B5EF4-FFF2-40B4-BE49-F238E27FC236}">
                  <a16:creationId xmlns:a16="http://schemas.microsoft.com/office/drawing/2014/main" id="{B2841EF7-E84F-5CB1-F872-2BA0D109C402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65" name="tx30">
              <a:extLst>
                <a:ext uri="{FF2B5EF4-FFF2-40B4-BE49-F238E27FC236}">
                  <a16:creationId xmlns:a16="http://schemas.microsoft.com/office/drawing/2014/main" id="{06486144-8E02-3E23-E3B1-5803F57F06E4}"/>
                </a:ext>
              </a:extLst>
            </p:cNvPr>
            <p:cNvSpPr/>
            <p:nvPr/>
          </p:nvSpPr>
          <p:spPr>
            <a:xfrm>
              <a:off x="466667" y="3486760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366" name="tx31">
              <a:extLst>
                <a:ext uri="{FF2B5EF4-FFF2-40B4-BE49-F238E27FC236}">
                  <a16:creationId xmlns:a16="http://schemas.microsoft.com/office/drawing/2014/main" id="{159C2516-2A55-5BA7-25E5-16AF48E60215}"/>
                </a:ext>
              </a:extLst>
            </p:cNvPr>
            <p:cNvSpPr/>
            <p:nvPr/>
          </p:nvSpPr>
          <p:spPr>
            <a:xfrm>
              <a:off x="466667" y="2678436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367" name="tx32">
              <a:extLst>
                <a:ext uri="{FF2B5EF4-FFF2-40B4-BE49-F238E27FC236}">
                  <a16:creationId xmlns:a16="http://schemas.microsoft.com/office/drawing/2014/main" id="{A8576D15-6BA8-4195-F95E-C6D718843064}"/>
                </a:ext>
              </a:extLst>
            </p:cNvPr>
            <p:cNvSpPr/>
            <p:nvPr/>
          </p:nvSpPr>
          <p:spPr>
            <a:xfrm>
              <a:off x="466667" y="1870113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368" name="tx33">
              <a:extLst>
                <a:ext uri="{FF2B5EF4-FFF2-40B4-BE49-F238E27FC236}">
                  <a16:creationId xmlns:a16="http://schemas.microsoft.com/office/drawing/2014/main" id="{DBF2475C-089F-F58B-7C76-E984B0A7DAD9}"/>
                </a:ext>
              </a:extLst>
            </p:cNvPr>
            <p:cNvSpPr/>
            <p:nvPr/>
          </p:nvSpPr>
          <p:spPr>
            <a:xfrm>
              <a:off x="466667" y="1061789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369" name="tx34">
              <a:extLst>
                <a:ext uri="{FF2B5EF4-FFF2-40B4-BE49-F238E27FC236}">
                  <a16:creationId xmlns:a16="http://schemas.microsoft.com/office/drawing/2014/main" id="{58ED54BB-434F-32E3-691E-D602B8489C96}"/>
                </a:ext>
              </a:extLst>
            </p:cNvPr>
            <p:cNvSpPr/>
            <p:nvPr/>
          </p:nvSpPr>
          <p:spPr>
            <a:xfrm>
              <a:off x="466667" y="253465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0</a:t>
              </a:r>
            </a:p>
          </p:txBody>
        </p:sp>
        <p:sp>
          <p:nvSpPr>
            <p:cNvPr id="370" name="pl35">
              <a:extLst>
                <a:ext uri="{FF2B5EF4-FFF2-40B4-BE49-F238E27FC236}">
                  <a16:creationId xmlns:a16="http://schemas.microsoft.com/office/drawing/2014/main" id="{1A55CA98-768E-B488-E733-F9089B0B74D6}"/>
                </a:ext>
              </a:extLst>
            </p:cNvPr>
            <p:cNvSpPr/>
            <p:nvPr/>
          </p:nvSpPr>
          <p:spPr>
            <a:xfrm>
              <a:off x="741682" y="353413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71" name="pl36">
              <a:extLst>
                <a:ext uri="{FF2B5EF4-FFF2-40B4-BE49-F238E27FC236}">
                  <a16:creationId xmlns:a16="http://schemas.microsoft.com/office/drawing/2014/main" id="{CD87BD71-ACD5-55FB-2B32-F81466959CD5}"/>
                </a:ext>
              </a:extLst>
            </p:cNvPr>
            <p:cNvSpPr/>
            <p:nvPr/>
          </p:nvSpPr>
          <p:spPr>
            <a:xfrm>
              <a:off x="741682" y="2725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72" name="pl37">
              <a:extLst>
                <a:ext uri="{FF2B5EF4-FFF2-40B4-BE49-F238E27FC236}">
                  <a16:creationId xmlns:a16="http://schemas.microsoft.com/office/drawing/2014/main" id="{E8B279C8-ED36-E0F8-A11F-02E7D79931CC}"/>
                </a:ext>
              </a:extLst>
            </p:cNvPr>
            <p:cNvSpPr/>
            <p:nvPr/>
          </p:nvSpPr>
          <p:spPr>
            <a:xfrm>
              <a:off x="741682" y="19174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73" name="pl38">
              <a:extLst>
                <a:ext uri="{FF2B5EF4-FFF2-40B4-BE49-F238E27FC236}">
                  <a16:creationId xmlns:a16="http://schemas.microsoft.com/office/drawing/2014/main" id="{4ECA59D0-74FC-72F3-64BF-834D16632957}"/>
                </a:ext>
              </a:extLst>
            </p:cNvPr>
            <p:cNvSpPr/>
            <p:nvPr/>
          </p:nvSpPr>
          <p:spPr>
            <a:xfrm>
              <a:off x="741682" y="11091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74" name="pl39">
              <a:extLst>
                <a:ext uri="{FF2B5EF4-FFF2-40B4-BE49-F238E27FC236}">
                  <a16:creationId xmlns:a16="http://schemas.microsoft.com/office/drawing/2014/main" id="{F295EFDD-7248-ECFB-87EB-7502E309F8B9}"/>
                </a:ext>
              </a:extLst>
            </p:cNvPr>
            <p:cNvSpPr/>
            <p:nvPr/>
          </p:nvSpPr>
          <p:spPr>
            <a:xfrm>
              <a:off x="741682" y="3008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75" name="pl40">
              <a:extLst>
                <a:ext uri="{FF2B5EF4-FFF2-40B4-BE49-F238E27FC236}">
                  <a16:creationId xmlns:a16="http://schemas.microsoft.com/office/drawing/2014/main" id="{121206C4-9B8F-A2B1-3654-661407E069EA}"/>
                </a:ext>
              </a:extLst>
            </p:cNvPr>
            <p:cNvSpPr/>
            <p:nvPr/>
          </p:nvSpPr>
          <p:spPr>
            <a:xfrm>
              <a:off x="1150492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76" name="pl41">
              <a:extLst>
                <a:ext uri="{FF2B5EF4-FFF2-40B4-BE49-F238E27FC236}">
                  <a16:creationId xmlns:a16="http://schemas.microsoft.com/office/drawing/2014/main" id="{F9190C8D-2F2E-B02B-6153-F0F436F60C7B}"/>
                </a:ext>
              </a:extLst>
            </p:cNvPr>
            <p:cNvSpPr/>
            <p:nvPr/>
          </p:nvSpPr>
          <p:spPr>
            <a:xfrm>
              <a:off x="3199893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77" name="pl42">
              <a:extLst>
                <a:ext uri="{FF2B5EF4-FFF2-40B4-BE49-F238E27FC236}">
                  <a16:creationId xmlns:a16="http://schemas.microsoft.com/office/drawing/2014/main" id="{EB78ACA2-09FE-2983-988B-D5EB86C54DA3}"/>
                </a:ext>
              </a:extLst>
            </p:cNvPr>
            <p:cNvSpPr/>
            <p:nvPr/>
          </p:nvSpPr>
          <p:spPr>
            <a:xfrm>
              <a:off x="5249294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78" name="pl43">
              <a:extLst>
                <a:ext uri="{FF2B5EF4-FFF2-40B4-BE49-F238E27FC236}">
                  <a16:creationId xmlns:a16="http://schemas.microsoft.com/office/drawing/2014/main" id="{4C218E5E-DE0E-2C09-B9F4-4254CA48515C}"/>
                </a:ext>
              </a:extLst>
            </p:cNvPr>
            <p:cNvSpPr/>
            <p:nvPr/>
          </p:nvSpPr>
          <p:spPr>
            <a:xfrm>
              <a:off x="7298695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79" name="tx44">
              <a:extLst>
                <a:ext uri="{FF2B5EF4-FFF2-40B4-BE49-F238E27FC236}">
                  <a16:creationId xmlns:a16="http://schemas.microsoft.com/office/drawing/2014/main" id="{E75497BA-E111-A815-7501-D29DFDAE3956}"/>
                </a:ext>
              </a:extLst>
            </p:cNvPr>
            <p:cNvSpPr/>
            <p:nvPr/>
          </p:nvSpPr>
          <p:spPr>
            <a:xfrm>
              <a:off x="1115176" y="3756509"/>
              <a:ext cx="70631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80" name="tx45">
              <a:extLst>
                <a:ext uri="{FF2B5EF4-FFF2-40B4-BE49-F238E27FC236}">
                  <a16:creationId xmlns:a16="http://schemas.microsoft.com/office/drawing/2014/main" id="{6889F942-C4A7-4A8F-BF45-7F4555A8425F}"/>
                </a:ext>
              </a:extLst>
            </p:cNvPr>
            <p:cNvSpPr/>
            <p:nvPr/>
          </p:nvSpPr>
          <p:spPr>
            <a:xfrm>
              <a:off x="3093946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381" name="tx46">
              <a:extLst>
                <a:ext uri="{FF2B5EF4-FFF2-40B4-BE49-F238E27FC236}">
                  <a16:creationId xmlns:a16="http://schemas.microsoft.com/office/drawing/2014/main" id="{3C411FC7-EBE7-8811-FD7E-888797E0DB12}"/>
                </a:ext>
              </a:extLst>
            </p:cNvPr>
            <p:cNvSpPr/>
            <p:nvPr/>
          </p:nvSpPr>
          <p:spPr>
            <a:xfrm>
              <a:off x="5143347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382" name="tx47">
              <a:extLst>
                <a:ext uri="{FF2B5EF4-FFF2-40B4-BE49-F238E27FC236}">
                  <a16:creationId xmlns:a16="http://schemas.microsoft.com/office/drawing/2014/main" id="{FAC0EB2B-9FB5-E22F-BEB7-D65929A0A9A8}"/>
                </a:ext>
              </a:extLst>
            </p:cNvPr>
            <p:cNvSpPr/>
            <p:nvPr/>
          </p:nvSpPr>
          <p:spPr>
            <a:xfrm>
              <a:off x="7192748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383" name="tx48">
              <a:extLst>
                <a:ext uri="{FF2B5EF4-FFF2-40B4-BE49-F238E27FC236}">
                  <a16:creationId xmlns:a16="http://schemas.microsoft.com/office/drawing/2014/main" id="{5A862D1D-E0D9-8AF6-BB31-79C79F4A835A}"/>
                </a:ext>
              </a:extLst>
            </p:cNvPr>
            <p:cNvSpPr/>
            <p:nvPr/>
          </p:nvSpPr>
          <p:spPr>
            <a:xfrm>
              <a:off x="4081990" y="3908557"/>
              <a:ext cx="1617314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 to mortality (Days)</a:t>
              </a:r>
            </a:p>
          </p:txBody>
        </p:sp>
        <p:sp>
          <p:nvSpPr>
            <p:cNvPr id="384" name="rc50">
              <a:extLst>
                <a:ext uri="{FF2B5EF4-FFF2-40B4-BE49-F238E27FC236}">
                  <a16:creationId xmlns:a16="http://schemas.microsoft.com/office/drawing/2014/main" id="{CB6D8CD2-3B23-A092-D120-0CCFADB477CD}"/>
                </a:ext>
              </a:extLst>
            </p:cNvPr>
            <p:cNvSpPr/>
            <p:nvPr/>
          </p:nvSpPr>
          <p:spPr>
            <a:xfrm>
              <a:off x="4276688" y="4189554"/>
              <a:ext cx="1227921" cy="358634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385" name="rc51">
              <a:extLst>
                <a:ext uri="{FF2B5EF4-FFF2-40B4-BE49-F238E27FC236}">
                  <a16:creationId xmlns:a16="http://schemas.microsoft.com/office/drawing/2014/main" id="{20061B16-097D-CE5C-3042-BDB3F6CC0330}"/>
                </a:ext>
              </a:extLst>
            </p:cNvPr>
            <p:cNvSpPr/>
            <p:nvPr/>
          </p:nvSpPr>
          <p:spPr>
            <a:xfrm>
              <a:off x="4415866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386" name="pl52">
              <a:extLst>
                <a:ext uri="{FF2B5EF4-FFF2-40B4-BE49-F238E27FC236}">
                  <a16:creationId xmlns:a16="http://schemas.microsoft.com/office/drawing/2014/main" id="{EE09A157-1F26-DEC6-7708-4C57C0E3233C}"/>
                </a:ext>
              </a:extLst>
            </p:cNvPr>
            <p:cNvSpPr/>
            <p:nvPr/>
          </p:nvSpPr>
          <p:spPr>
            <a:xfrm>
              <a:off x="4437812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87" name="rc53">
              <a:extLst>
                <a:ext uri="{FF2B5EF4-FFF2-40B4-BE49-F238E27FC236}">
                  <a16:creationId xmlns:a16="http://schemas.microsoft.com/office/drawing/2014/main" id="{29CB1BE5-0251-9E77-F18A-9AF301DD0BE9}"/>
                </a:ext>
              </a:extLst>
            </p:cNvPr>
            <p:cNvSpPr/>
            <p:nvPr/>
          </p:nvSpPr>
          <p:spPr>
            <a:xfrm>
              <a:off x="4926900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388" name="pl54">
              <a:extLst>
                <a:ext uri="{FF2B5EF4-FFF2-40B4-BE49-F238E27FC236}">
                  <a16:creationId xmlns:a16="http://schemas.microsoft.com/office/drawing/2014/main" id="{881CC7AD-4DD3-3487-52F3-FBA48863654A}"/>
                </a:ext>
              </a:extLst>
            </p:cNvPr>
            <p:cNvSpPr/>
            <p:nvPr/>
          </p:nvSpPr>
          <p:spPr>
            <a:xfrm>
              <a:off x="4948846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89" name="tx55">
              <a:extLst>
                <a:ext uri="{FF2B5EF4-FFF2-40B4-BE49-F238E27FC236}">
                  <a16:creationId xmlns:a16="http://schemas.microsoft.com/office/drawing/2014/main" id="{0D6711BA-F373-8E4D-4FA3-0AFD7F0F46F9}"/>
                </a:ext>
              </a:extLst>
            </p:cNvPr>
            <p:cNvSpPr/>
            <p:nvPr/>
          </p:nvSpPr>
          <p:spPr>
            <a:xfrm>
              <a:off x="4704911" y="4321929"/>
              <a:ext cx="162346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390" name="tx56">
              <a:extLst>
                <a:ext uri="{FF2B5EF4-FFF2-40B4-BE49-F238E27FC236}">
                  <a16:creationId xmlns:a16="http://schemas.microsoft.com/office/drawing/2014/main" id="{0DC676DF-C704-0135-29DC-C048FDCCE050}"/>
                </a:ext>
              </a:extLst>
            </p:cNvPr>
            <p:cNvSpPr/>
            <p:nvPr/>
          </p:nvSpPr>
          <p:spPr>
            <a:xfrm>
              <a:off x="5215945" y="4321929"/>
              <a:ext cx="218839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  <p:sp>
          <p:nvSpPr>
            <p:cNvPr id="391" name="rc57">
              <a:extLst>
                <a:ext uri="{FF2B5EF4-FFF2-40B4-BE49-F238E27FC236}">
                  <a16:creationId xmlns:a16="http://schemas.microsoft.com/office/drawing/2014/main" id="{1EAEA5B6-92AA-A298-4FB8-0B4FE9641A88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92" name="rc58">
              <a:extLst>
                <a:ext uri="{FF2B5EF4-FFF2-40B4-BE49-F238E27FC236}">
                  <a16:creationId xmlns:a16="http://schemas.microsoft.com/office/drawing/2014/main" id="{3E1DABF1-7C0D-B60C-6ACB-38E23B10E0C4}"/>
                </a:ext>
              </a:extLst>
            </p:cNvPr>
            <p:cNvSpPr/>
            <p:nvPr/>
          </p:nvSpPr>
          <p:spPr>
            <a:xfrm>
              <a:off x="776476" y="4996549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393" name="tx59">
              <a:extLst>
                <a:ext uri="{FF2B5EF4-FFF2-40B4-BE49-F238E27FC236}">
                  <a16:creationId xmlns:a16="http://schemas.microsoft.com/office/drawing/2014/main" id="{85C185D3-A364-9CE9-9771-86708245328E}"/>
                </a:ext>
              </a:extLst>
            </p:cNvPr>
            <p:cNvSpPr/>
            <p:nvPr/>
          </p:nvSpPr>
          <p:spPr>
            <a:xfrm>
              <a:off x="1115323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94" name="tx60">
              <a:extLst>
                <a:ext uri="{FF2B5EF4-FFF2-40B4-BE49-F238E27FC236}">
                  <a16:creationId xmlns:a16="http://schemas.microsoft.com/office/drawing/2014/main" id="{1F95CFA6-0429-1C1C-A228-5FFBD4C0EE84}"/>
                </a:ext>
              </a:extLst>
            </p:cNvPr>
            <p:cNvSpPr/>
            <p:nvPr/>
          </p:nvSpPr>
          <p:spPr>
            <a:xfrm>
              <a:off x="1080154" y="5132574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395" name="tx61">
              <a:extLst>
                <a:ext uri="{FF2B5EF4-FFF2-40B4-BE49-F238E27FC236}">
                  <a16:creationId xmlns:a16="http://schemas.microsoft.com/office/drawing/2014/main" id="{B83A2B44-8F79-E2D7-99A8-B63098351A51}"/>
                </a:ext>
              </a:extLst>
            </p:cNvPr>
            <p:cNvSpPr/>
            <p:nvPr/>
          </p:nvSpPr>
          <p:spPr>
            <a:xfrm>
              <a:off x="3164724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396" name="tx62">
              <a:extLst>
                <a:ext uri="{FF2B5EF4-FFF2-40B4-BE49-F238E27FC236}">
                  <a16:creationId xmlns:a16="http://schemas.microsoft.com/office/drawing/2014/main" id="{26ACE6EE-CF86-50EB-1717-71BF0EE207F8}"/>
                </a:ext>
              </a:extLst>
            </p:cNvPr>
            <p:cNvSpPr/>
            <p:nvPr/>
          </p:nvSpPr>
          <p:spPr>
            <a:xfrm>
              <a:off x="3164724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397" name="tx63">
              <a:extLst>
                <a:ext uri="{FF2B5EF4-FFF2-40B4-BE49-F238E27FC236}">
                  <a16:creationId xmlns:a16="http://schemas.microsoft.com/office/drawing/2014/main" id="{4BF84177-36D3-977E-1706-A95518456D52}"/>
                </a:ext>
              </a:extLst>
            </p:cNvPr>
            <p:cNvSpPr/>
            <p:nvPr/>
          </p:nvSpPr>
          <p:spPr>
            <a:xfrm>
              <a:off x="5214125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398" name="tx64">
              <a:extLst>
                <a:ext uri="{FF2B5EF4-FFF2-40B4-BE49-F238E27FC236}">
                  <a16:creationId xmlns:a16="http://schemas.microsoft.com/office/drawing/2014/main" id="{29656935-A020-809A-EFBF-9BCCCE59A567}"/>
                </a:ext>
              </a:extLst>
            </p:cNvPr>
            <p:cNvSpPr/>
            <p:nvPr/>
          </p:nvSpPr>
          <p:spPr>
            <a:xfrm>
              <a:off x="5214125" y="5134117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399" name="tx65">
              <a:extLst>
                <a:ext uri="{FF2B5EF4-FFF2-40B4-BE49-F238E27FC236}">
                  <a16:creationId xmlns:a16="http://schemas.microsoft.com/office/drawing/2014/main" id="{0F5A51FA-8C24-41FD-2F0A-FB553D39B7AD}"/>
                </a:ext>
              </a:extLst>
            </p:cNvPr>
            <p:cNvSpPr/>
            <p:nvPr/>
          </p:nvSpPr>
          <p:spPr>
            <a:xfrm>
              <a:off x="7263526" y="5437853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400" name="tx66">
              <a:extLst>
                <a:ext uri="{FF2B5EF4-FFF2-40B4-BE49-F238E27FC236}">
                  <a16:creationId xmlns:a16="http://schemas.microsoft.com/office/drawing/2014/main" id="{15EE9969-EB17-0BD5-2B68-E3920299AFB9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401" name="tx67">
              <a:extLst>
                <a:ext uri="{FF2B5EF4-FFF2-40B4-BE49-F238E27FC236}">
                  <a16:creationId xmlns:a16="http://schemas.microsoft.com/office/drawing/2014/main" id="{7CE86267-E3B4-45C7-7DE7-2FC4EC587736}"/>
                </a:ext>
              </a:extLst>
            </p:cNvPr>
            <p:cNvSpPr/>
            <p:nvPr/>
          </p:nvSpPr>
          <p:spPr>
            <a:xfrm>
              <a:off x="7263526" y="5437853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402" name="tx68">
              <a:extLst>
                <a:ext uri="{FF2B5EF4-FFF2-40B4-BE49-F238E27FC236}">
                  <a16:creationId xmlns:a16="http://schemas.microsoft.com/office/drawing/2014/main" id="{D8A221E3-7F81-AF9C-E074-6CC4224A5FB5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403" name="tx69">
              <a:extLst>
                <a:ext uri="{FF2B5EF4-FFF2-40B4-BE49-F238E27FC236}">
                  <a16:creationId xmlns:a16="http://schemas.microsoft.com/office/drawing/2014/main" id="{C7AAE7EA-BE85-00D5-13CC-2A0CC954180F}"/>
                </a:ext>
              </a:extLst>
            </p:cNvPr>
            <p:cNvSpPr/>
            <p:nvPr/>
          </p:nvSpPr>
          <p:spPr>
            <a:xfrm>
              <a:off x="325591" y="5438152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404" name="tx70">
              <a:extLst>
                <a:ext uri="{FF2B5EF4-FFF2-40B4-BE49-F238E27FC236}">
                  <a16:creationId xmlns:a16="http://schemas.microsoft.com/office/drawing/2014/main" id="{B2239E35-71DD-39C3-B101-E00C043C2290}"/>
                </a:ext>
              </a:extLst>
            </p:cNvPr>
            <p:cNvSpPr/>
            <p:nvPr/>
          </p:nvSpPr>
          <p:spPr>
            <a:xfrm>
              <a:off x="311638" y="5132811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405" name="tx71">
              <a:extLst>
                <a:ext uri="{FF2B5EF4-FFF2-40B4-BE49-F238E27FC236}">
                  <a16:creationId xmlns:a16="http://schemas.microsoft.com/office/drawing/2014/main" id="{4BB91778-EEB9-F2D5-C4FB-BC3AC30DF44A}"/>
                </a:ext>
              </a:extLst>
            </p:cNvPr>
            <p:cNvSpPr/>
            <p:nvPr/>
          </p:nvSpPr>
          <p:spPr>
            <a:xfrm>
              <a:off x="776476" y="4827633"/>
              <a:ext cx="17452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406" name="rc72">
              <a:extLst>
                <a:ext uri="{FF2B5EF4-FFF2-40B4-BE49-F238E27FC236}">
                  <a16:creationId xmlns:a16="http://schemas.microsoft.com/office/drawing/2014/main" id="{F6A0CDA2-080D-A280-F877-0EB85F5148E5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07" name="rc73">
              <a:extLst>
                <a:ext uri="{FF2B5EF4-FFF2-40B4-BE49-F238E27FC236}">
                  <a16:creationId xmlns:a16="http://schemas.microsoft.com/office/drawing/2014/main" id="{618F2FB1-D127-184D-892F-2EC8D6A96B34}"/>
                </a:ext>
              </a:extLst>
            </p:cNvPr>
            <p:cNvSpPr/>
            <p:nvPr/>
          </p:nvSpPr>
          <p:spPr>
            <a:xfrm>
              <a:off x="776476" y="6081865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408" name="tx74">
              <a:extLst>
                <a:ext uri="{FF2B5EF4-FFF2-40B4-BE49-F238E27FC236}">
                  <a16:creationId xmlns:a16="http://schemas.microsoft.com/office/drawing/2014/main" id="{ADD9F0BD-DEFF-708B-9B69-9A39D5871E07}"/>
                </a:ext>
              </a:extLst>
            </p:cNvPr>
            <p:cNvSpPr/>
            <p:nvPr/>
          </p:nvSpPr>
          <p:spPr>
            <a:xfrm>
              <a:off x="1115323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409" name="tx75">
              <a:extLst>
                <a:ext uri="{FF2B5EF4-FFF2-40B4-BE49-F238E27FC236}">
                  <a16:creationId xmlns:a16="http://schemas.microsoft.com/office/drawing/2014/main" id="{302B7B55-B7BD-1785-88F0-D015544A3C12}"/>
                </a:ext>
              </a:extLst>
            </p:cNvPr>
            <p:cNvSpPr/>
            <p:nvPr/>
          </p:nvSpPr>
          <p:spPr>
            <a:xfrm>
              <a:off x="1080154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1</a:t>
              </a:r>
            </a:p>
          </p:txBody>
        </p:sp>
        <p:sp>
          <p:nvSpPr>
            <p:cNvPr id="410" name="tx76">
              <a:extLst>
                <a:ext uri="{FF2B5EF4-FFF2-40B4-BE49-F238E27FC236}">
                  <a16:creationId xmlns:a16="http://schemas.microsoft.com/office/drawing/2014/main" id="{003ABF85-A8AA-356E-0928-4380B2E8422E}"/>
                </a:ext>
              </a:extLst>
            </p:cNvPr>
            <p:cNvSpPr/>
            <p:nvPr/>
          </p:nvSpPr>
          <p:spPr>
            <a:xfrm>
              <a:off x="3164724" y="6524775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411" name="tx77">
              <a:extLst>
                <a:ext uri="{FF2B5EF4-FFF2-40B4-BE49-F238E27FC236}">
                  <a16:creationId xmlns:a16="http://schemas.microsoft.com/office/drawing/2014/main" id="{6BE23A3E-5780-8F51-D272-61E49BA6B5F4}"/>
                </a:ext>
              </a:extLst>
            </p:cNvPr>
            <p:cNvSpPr/>
            <p:nvPr/>
          </p:nvSpPr>
          <p:spPr>
            <a:xfrm>
              <a:off x="3129555" y="6217890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6</a:t>
              </a:r>
            </a:p>
          </p:txBody>
        </p:sp>
        <p:sp>
          <p:nvSpPr>
            <p:cNvPr id="412" name="tx78">
              <a:extLst>
                <a:ext uri="{FF2B5EF4-FFF2-40B4-BE49-F238E27FC236}">
                  <a16:creationId xmlns:a16="http://schemas.microsoft.com/office/drawing/2014/main" id="{5B8DC65D-D6A2-712B-DA98-266169538A81}"/>
                </a:ext>
              </a:extLst>
            </p:cNvPr>
            <p:cNvSpPr/>
            <p:nvPr/>
          </p:nvSpPr>
          <p:spPr>
            <a:xfrm>
              <a:off x="5214125" y="6524775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413" name="tx79">
              <a:extLst>
                <a:ext uri="{FF2B5EF4-FFF2-40B4-BE49-F238E27FC236}">
                  <a16:creationId xmlns:a16="http://schemas.microsoft.com/office/drawing/2014/main" id="{AC70A7D1-C008-96D8-41A6-8382EB1DFC14}"/>
                </a:ext>
              </a:extLst>
            </p:cNvPr>
            <p:cNvSpPr/>
            <p:nvPr/>
          </p:nvSpPr>
          <p:spPr>
            <a:xfrm>
              <a:off x="5214125" y="6217890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</a:t>
              </a:r>
            </a:p>
          </p:txBody>
        </p:sp>
        <p:sp>
          <p:nvSpPr>
            <p:cNvPr id="414" name="tx80">
              <a:extLst>
                <a:ext uri="{FF2B5EF4-FFF2-40B4-BE49-F238E27FC236}">
                  <a16:creationId xmlns:a16="http://schemas.microsoft.com/office/drawing/2014/main" id="{4499FF2E-B338-9C62-0687-B21D79244E62}"/>
                </a:ext>
              </a:extLst>
            </p:cNvPr>
            <p:cNvSpPr/>
            <p:nvPr/>
          </p:nvSpPr>
          <p:spPr>
            <a:xfrm>
              <a:off x="7263526" y="6524775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415" name="tx81">
              <a:extLst>
                <a:ext uri="{FF2B5EF4-FFF2-40B4-BE49-F238E27FC236}">
                  <a16:creationId xmlns:a16="http://schemas.microsoft.com/office/drawing/2014/main" id="{CCDD0DE9-6332-7CBF-6176-77FBD270688E}"/>
                </a:ext>
              </a:extLst>
            </p:cNvPr>
            <p:cNvSpPr/>
            <p:nvPr/>
          </p:nvSpPr>
          <p:spPr>
            <a:xfrm>
              <a:off x="7263526" y="6220978"/>
              <a:ext cx="70337" cy="8935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</a:t>
              </a:r>
            </a:p>
          </p:txBody>
        </p:sp>
        <p:sp>
          <p:nvSpPr>
            <p:cNvPr id="416" name="tx82">
              <a:extLst>
                <a:ext uri="{FF2B5EF4-FFF2-40B4-BE49-F238E27FC236}">
                  <a16:creationId xmlns:a16="http://schemas.microsoft.com/office/drawing/2014/main" id="{021D5637-00F8-BA6D-9EB8-3CC32DB6AF8B}"/>
                </a:ext>
              </a:extLst>
            </p:cNvPr>
            <p:cNvSpPr/>
            <p:nvPr/>
          </p:nvSpPr>
          <p:spPr>
            <a:xfrm>
              <a:off x="325591" y="6523468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417" name="tx83">
              <a:extLst>
                <a:ext uri="{FF2B5EF4-FFF2-40B4-BE49-F238E27FC236}">
                  <a16:creationId xmlns:a16="http://schemas.microsoft.com/office/drawing/2014/main" id="{0EC139CE-83A8-1B1A-5A74-12F4EFA2C1E2}"/>
                </a:ext>
              </a:extLst>
            </p:cNvPr>
            <p:cNvSpPr/>
            <p:nvPr/>
          </p:nvSpPr>
          <p:spPr>
            <a:xfrm>
              <a:off x="311638" y="6218127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418" name="tx84">
              <a:extLst>
                <a:ext uri="{FF2B5EF4-FFF2-40B4-BE49-F238E27FC236}">
                  <a16:creationId xmlns:a16="http://schemas.microsoft.com/office/drawing/2014/main" id="{2B9005BA-6336-088D-A4F3-DE93255E0264}"/>
                </a:ext>
              </a:extLst>
            </p:cNvPr>
            <p:cNvSpPr/>
            <p:nvPr/>
          </p:nvSpPr>
          <p:spPr>
            <a:xfrm>
              <a:off x="776476" y="5912949"/>
              <a:ext cx="23525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</p:grpSp>
      <p:sp>
        <p:nvSpPr>
          <p:cNvPr id="419" name="tx47">
            <a:extLst>
              <a:ext uri="{FF2B5EF4-FFF2-40B4-BE49-F238E27FC236}">
                <a16:creationId xmlns:a16="http://schemas.microsoft.com/office/drawing/2014/main" id="{283A3384-59A4-C991-A6D8-795AFCFA54F7}"/>
              </a:ext>
            </a:extLst>
          </p:cNvPr>
          <p:cNvSpPr>
            <a:spLocks noChangeAspect="1"/>
          </p:cNvSpPr>
          <p:nvPr/>
        </p:nvSpPr>
        <p:spPr>
          <a:xfrm rot="16200000">
            <a:off x="4609736" y="2477434"/>
            <a:ext cx="917105" cy="7613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992"/>
              </a:lnSpc>
            </a:pPr>
            <a:r>
              <a:rPr sz="992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rPr>
              <a:t>Cumulative Incidence</a:t>
            </a:r>
            <a:r>
              <a:rPr lang="en-US" sz="992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rPr>
              <a:t> of Mortality (%)</a:t>
            </a:r>
            <a:endParaRPr sz="992" dirty="0">
              <a:solidFill>
                <a:srgbClr val="000000">
                  <a:alpha val="100000"/>
                </a:srgbClr>
              </a:solidFill>
              <a:latin typeface="Arial"/>
              <a:cs typeface="Arial"/>
            </a:endParaRPr>
          </a:p>
        </p:txBody>
      </p:sp>
      <p:sp>
        <p:nvSpPr>
          <p:cNvPr id="420" name="TextBox 419">
            <a:extLst>
              <a:ext uri="{FF2B5EF4-FFF2-40B4-BE49-F238E27FC236}">
                <a16:creationId xmlns:a16="http://schemas.microsoft.com/office/drawing/2014/main" id="{32F34182-1EAF-ECB3-9A09-8F852B58D9F4}"/>
              </a:ext>
            </a:extLst>
          </p:cNvPr>
          <p:cNvSpPr txBox="1">
            <a:spLocks noChangeAspect="1"/>
          </p:cNvSpPr>
          <p:nvPr/>
        </p:nvSpPr>
        <p:spPr>
          <a:xfrm>
            <a:off x="5526695" y="1757478"/>
            <a:ext cx="3208931" cy="6519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9" b="1" dirty="0">
                <a:latin typeface="Arial" panose="020B0604020202020204" pitchFamily="34" charset="0"/>
                <a:cs typeface="Arial" panose="020B0604020202020204" pitchFamily="34" charset="0"/>
              </a:rPr>
              <a:t>Potential Living Donor  Total   Event   HR (95% CI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No                                     10        3         Reference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Yes                                    41        1         0.07 (0.01 – 0.69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Gray K-Sample Test P-value: 0.0041        </a:t>
            </a:r>
          </a:p>
        </p:txBody>
      </p:sp>
      <p:sp>
        <p:nvSpPr>
          <p:cNvPr id="421" name="pl48">
            <a:extLst>
              <a:ext uri="{FF2B5EF4-FFF2-40B4-BE49-F238E27FC236}">
                <a16:creationId xmlns:a16="http://schemas.microsoft.com/office/drawing/2014/main" id="{0903B11A-D26F-9A29-BFFA-C0C9172347D4}"/>
              </a:ext>
            </a:extLst>
          </p:cNvPr>
          <p:cNvSpPr>
            <a:spLocks noChangeAspect="1"/>
          </p:cNvSpPr>
          <p:nvPr/>
        </p:nvSpPr>
        <p:spPr>
          <a:xfrm>
            <a:off x="8258073" y="2058946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422" name="pl50">
            <a:extLst>
              <a:ext uri="{FF2B5EF4-FFF2-40B4-BE49-F238E27FC236}">
                <a16:creationId xmlns:a16="http://schemas.microsoft.com/office/drawing/2014/main" id="{8A21790B-59E5-65EF-3558-AA61790F994D}"/>
              </a:ext>
            </a:extLst>
          </p:cNvPr>
          <p:cNvSpPr>
            <a:spLocks noChangeAspect="1"/>
          </p:cNvSpPr>
          <p:nvPr/>
        </p:nvSpPr>
        <p:spPr>
          <a:xfrm>
            <a:off x="8258073" y="2178022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424" name="TextBox 423">
            <a:extLst>
              <a:ext uri="{FF2B5EF4-FFF2-40B4-BE49-F238E27FC236}">
                <a16:creationId xmlns:a16="http://schemas.microsoft.com/office/drawing/2014/main" id="{D6ABF3E3-DFFB-F858-BC13-503F6981CBA7}"/>
              </a:ext>
            </a:extLst>
          </p:cNvPr>
          <p:cNvSpPr txBox="1"/>
          <p:nvPr/>
        </p:nvSpPr>
        <p:spPr>
          <a:xfrm>
            <a:off x="6278925" y="1318690"/>
            <a:ext cx="2761077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b.  FEMALE: mortality on waitlist</a:t>
            </a:r>
            <a:endParaRPr lang="en-US" sz="1488" dirty="0"/>
          </a:p>
        </p:txBody>
      </p:sp>
      <p:grpSp>
        <p:nvGrpSpPr>
          <p:cNvPr id="425" name="Group 424">
            <a:extLst>
              <a:ext uri="{FF2B5EF4-FFF2-40B4-BE49-F238E27FC236}">
                <a16:creationId xmlns:a16="http://schemas.microsoft.com/office/drawing/2014/main" id="{9E7774EA-D06E-926A-0330-DF67D1019F19}"/>
              </a:ext>
            </a:extLst>
          </p:cNvPr>
          <p:cNvGrpSpPr>
            <a:grpSpLocks noChangeAspect="1"/>
          </p:cNvGrpSpPr>
          <p:nvPr/>
        </p:nvGrpSpPr>
        <p:grpSpPr>
          <a:xfrm>
            <a:off x="42454" y="5386713"/>
            <a:ext cx="4932528" cy="3571875"/>
            <a:chOff x="0" y="0"/>
            <a:chExt cx="9144000" cy="6858000"/>
          </a:xfrm>
        </p:grpSpPr>
        <p:sp>
          <p:nvSpPr>
            <p:cNvPr id="426" name="rc3">
              <a:extLst>
                <a:ext uri="{FF2B5EF4-FFF2-40B4-BE49-F238E27FC236}">
                  <a16:creationId xmlns:a16="http://schemas.microsoft.com/office/drawing/2014/main" id="{C8632B7C-B82E-6FF5-1361-B6C8980955C9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27" name="rc4">
              <a:extLst>
                <a:ext uri="{FF2B5EF4-FFF2-40B4-BE49-F238E27FC236}">
                  <a16:creationId xmlns:a16="http://schemas.microsoft.com/office/drawing/2014/main" id="{412B77AE-B5D5-25C4-6079-5326B280E17E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28" name="rc5">
              <a:extLst>
                <a:ext uri="{FF2B5EF4-FFF2-40B4-BE49-F238E27FC236}">
                  <a16:creationId xmlns:a16="http://schemas.microsoft.com/office/drawing/2014/main" id="{5B2B1B5C-A852-88F0-C507-D8C5380F8DA8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29" name="rc6">
              <a:extLst>
                <a:ext uri="{FF2B5EF4-FFF2-40B4-BE49-F238E27FC236}">
                  <a16:creationId xmlns:a16="http://schemas.microsoft.com/office/drawing/2014/main" id="{49854FD1-7DB9-55BE-D0A7-0B6A8B554B33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30" name="rc7">
              <a:extLst>
                <a:ext uri="{FF2B5EF4-FFF2-40B4-BE49-F238E27FC236}">
                  <a16:creationId xmlns:a16="http://schemas.microsoft.com/office/drawing/2014/main" id="{DF7674F0-CB98-A4A0-7CBC-409AFDB47587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31" name="rc8">
              <a:extLst>
                <a:ext uri="{FF2B5EF4-FFF2-40B4-BE49-F238E27FC236}">
                  <a16:creationId xmlns:a16="http://schemas.microsoft.com/office/drawing/2014/main" id="{61A49B3E-9CE1-A23B-54AB-0D22C125B904}"/>
                </a:ext>
              </a:extLst>
            </p:cNvPr>
            <p:cNvSpPr/>
            <p:nvPr/>
          </p:nvSpPr>
          <p:spPr>
            <a:xfrm>
              <a:off x="69590" y="69590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32" name="pl18">
              <a:extLst>
                <a:ext uri="{FF2B5EF4-FFF2-40B4-BE49-F238E27FC236}">
                  <a16:creationId xmlns:a16="http://schemas.microsoft.com/office/drawing/2014/main" id="{80E82CF1-CADD-6220-F172-86C78B10D535}"/>
                </a:ext>
              </a:extLst>
            </p:cNvPr>
            <p:cNvSpPr/>
            <p:nvPr/>
          </p:nvSpPr>
          <p:spPr>
            <a:xfrm>
              <a:off x="776476" y="3534137"/>
              <a:ext cx="8228345" cy="0"/>
            </a:xfrm>
            <a:custGeom>
              <a:avLst/>
              <a:gdLst/>
              <a:ahLst/>
              <a:cxnLst/>
              <a:rect l="0" t="0" r="0" b="0"/>
              <a:pathLst>
                <a:path w="8228345">
                  <a:moveTo>
                    <a:pt x="0" y="0"/>
                  </a:moveTo>
                  <a:lnTo>
                    <a:pt x="8228345" y="0"/>
                  </a:lnTo>
                  <a:lnTo>
                    <a:pt x="8228345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33" name="pl23">
              <a:extLst>
                <a:ext uri="{FF2B5EF4-FFF2-40B4-BE49-F238E27FC236}">
                  <a16:creationId xmlns:a16="http://schemas.microsoft.com/office/drawing/2014/main" id="{272B004E-E90E-B7DB-81C3-EE585CA578E3}"/>
                </a:ext>
              </a:extLst>
            </p:cNvPr>
            <p:cNvSpPr/>
            <p:nvPr/>
          </p:nvSpPr>
          <p:spPr>
            <a:xfrm>
              <a:off x="1150492" y="139178"/>
              <a:ext cx="0" cy="3556623"/>
            </a:xfrm>
            <a:custGeom>
              <a:avLst/>
              <a:gdLst/>
              <a:ahLst/>
              <a:cxnLst/>
              <a:rect l="0" t="0" r="0" b="0"/>
              <a:pathLst>
                <a:path h="3556623">
                  <a:moveTo>
                    <a:pt x="0" y="35566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34" name="pl27">
              <a:extLst>
                <a:ext uri="{FF2B5EF4-FFF2-40B4-BE49-F238E27FC236}">
                  <a16:creationId xmlns:a16="http://schemas.microsoft.com/office/drawing/2014/main" id="{3C1420AE-E734-D0A9-DCAD-8F77EB0EF4EB}"/>
                </a:ext>
              </a:extLst>
            </p:cNvPr>
            <p:cNvSpPr/>
            <p:nvPr/>
          </p:nvSpPr>
          <p:spPr>
            <a:xfrm>
              <a:off x="1150492" y="2650968"/>
              <a:ext cx="6209685" cy="883168"/>
            </a:xfrm>
            <a:custGeom>
              <a:avLst/>
              <a:gdLst/>
              <a:ahLst/>
              <a:cxnLst/>
              <a:rect l="0" t="0" r="0" b="0"/>
              <a:pathLst>
                <a:path w="6209685" h="883168">
                  <a:moveTo>
                    <a:pt x="0" y="883168"/>
                  </a:moveTo>
                  <a:lnTo>
                    <a:pt x="71729" y="883168"/>
                  </a:lnTo>
                  <a:lnTo>
                    <a:pt x="71729" y="883168"/>
                  </a:lnTo>
                  <a:lnTo>
                    <a:pt x="317657" y="883168"/>
                  </a:lnTo>
                  <a:lnTo>
                    <a:pt x="317657" y="883168"/>
                  </a:lnTo>
                  <a:lnTo>
                    <a:pt x="389386" y="883168"/>
                  </a:lnTo>
                  <a:lnTo>
                    <a:pt x="389386" y="883168"/>
                  </a:lnTo>
                  <a:lnTo>
                    <a:pt x="440621" y="883168"/>
                  </a:lnTo>
                  <a:lnTo>
                    <a:pt x="440621" y="703540"/>
                  </a:lnTo>
                  <a:lnTo>
                    <a:pt x="809513" y="703540"/>
                  </a:lnTo>
                  <a:lnTo>
                    <a:pt x="809513" y="523913"/>
                  </a:lnTo>
                  <a:lnTo>
                    <a:pt x="1014453" y="523913"/>
                  </a:lnTo>
                  <a:lnTo>
                    <a:pt x="1014453" y="523913"/>
                  </a:lnTo>
                  <a:lnTo>
                    <a:pt x="1250134" y="523913"/>
                  </a:lnTo>
                  <a:lnTo>
                    <a:pt x="1250134" y="523913"/>
                  </a:lnTo>
                  <a:lnTo>
                    <a:pt x="1619026" y="523913"/>
                  </a:lnTo>
                  <a:lnTo>
                    <a:pt x="1619026" y="523913"/>
                  </a:lnTo>
                  <a:lnTo>
                    <a:pt x="1834213" y="523913"/>
                  </a:lnTo>
                  <a:lnTo>
                    <a:pt x="1834213" y="523913"/>
                  </a:lnTo>
                  <a:lnTo>
                    <a:pt x="2490022" y="523913"/>
                  </a:lnTo>
                  <a:lnTo>
                    <a:pt x="2490022" y="299379"/>
                  </a:lnTo>
                  <a:lnTo>
                    <a:pt x="2520763" y="299379"/>
                  </a:lnTo>
                  <a:lnTo>
                    <a:pt x="2520763" y="299379"/>
                  </a:lnTo>
                  <a:lnTo>
                    <a:pt x="3074101" y="299379"/>
                  </a:lnTo>
                  <a:lnTo>
                    <a:pt x="3074101" y="299379"/>
                  </a:lnTo>
                  <a:lnTo>
                    <a:pt x="4273001" y="299379"/>
                  </a:lnTo>
                  <a:lnTo>
                    <a:pt x="4273001" y="299379"/>
                  </a:lnTo>
                  <a:lnTo>
                    <a:pt x="4324236" y="299379"/>
                  </a:lnTo>
                  <a:lnTo>
                    <a:pt x="4324236" y="299379"/>
                  </a:lnTo>
                  <a:lnTo>
                    <a:pt x="4672634" y="299379"/>
                  </a:lnTo>
                  <a:lnTo>
                    <a:pt x="4672634" y="0"/>
                  </a:lnTo>
                  <a:lnTo>
                    <a:pt x="6209685" y="0"/>
                  </a:lnTo>
                  <a:lnTo>
                    <a:pt x="6209685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35" name="pl28">
              <a:extLst>
                <a:ext uri="{FF2B5EF4-FFF2-40B4-BE49-F238E27FC236}">
                  <a16:creationId xmlns:a16="http://schemas.microsoft.com/office/drawing/2014/main" id="{2B22C0C4-4372-688C-087B-ECC8982018E6}"/>
                </a:ext>
              </a:extLst>
            </p:cNvPr>
            <p:cNvSpPr/>
            <p:nvPr/>
          </p:nvSpPr>
          <p:spPr>
            <a:xfrm>
              <a:off x="1150492" y="3393425"/>
              <a:ext cx="7265126" cy="140711"/>
            </a:xfrm>
            <a:custGeom>
              <a:avLst/>
              <a:gdLst/>
              <a:ahLst/>
              <a:cxnLst/>
              <a:rect l="0" t="0" r="0" b="0"/>
              <a:pathLst>
                <a:path w="7265126" h="140711">
                  <a:moveTo>
                    <a:pt x="0" y="140711"/>
                  </a:moveTo>
                  <a:lnTo>
                    <a:pt x="10247" y="140711"/>
                  </a:lnTo>
                  <a:lnTo>
                    <a:pt x="10247" y="140711"/>
                  </a:lnTo>
                  <a:lnTo>
                    <a:pt x="194693" y="140711"/>
                  </a:lnTo>
                  <a:lnTo>
                    <a:pt x="194693" y="140711"/>
                  </a:lnTo>
                  <a:lnTo>
                    <a:pt x="204940" y="140711"/>
                  </a:lnTo>
                  <a:lnTo>
                    <a:pt x="204940" y="140711"/>
                  </a:lnTo>
                  <a:lnTo>
                    <a:pt x="256175" y="140711"/>
                  </a:lnTo>
                  <a:lnTo>
                    <a:pt x="256175" y="140711"/>
                  </a:lnTo>
                  <a:lnTo>
                    <a:pt x="297163" y="140711"/>
                  </a:lnTo>
                  <a:lnTo>
                    <a:pt x="297163" y="140711"/>
                  </a:lnTo>
                  <a:lnTo>
                    <a:pt x="338151" y="140711"/>
                  </a:lnTo>
                  <a:lnTo>
                    <a:pt x="338151" y="106657"/>
                  </a:lnTo>
                  <a:lnTo>
                    <a:pt x="389386" y="106657"/>
                  </a:lnTo>
                  <a:lnTo>
                    <a:pt x="389386" y="106657"/>
                  </a:lnTo>
                  <a:lnTo>
                    <a:pt x="409880" y="106657"/>
                  </a:lnTo>
                  <a:lnTo>
                    <a:pt x="409880" y="106657"/>
                  </a:lnTo>
                  <a:lnTo>
                    <a:pt x="440621" y="106657"/>
                  </a:lnTo>
                  <a:lnTo>
                    <a:pt x="440621" y="72202"/>
                  </a:lnTo>
                  <a:lnTo>
                    <a:pt x="471362" y="72202"/>
                  </a:lnTo>
                  <a:lnTo>
                    <a:pt x="471362" y="72202"/>
                  </a:lnTo>
                  <a:lnTo>
                    <a:pt x="491856" y="72202"/>
                  </a:lnTo>
                  <a:lnTo>
                    <a:pt x="491856" y="72202"/>
                  </a:lnTo>
                  <a:lnTo>
                    <a:pt x="502103" y="72202"/>
                  </a:lnTo>
                  <a:lnTo>
                    <a:pt x="502103" y="72202"/>
                  </a:lnTo>
                  <a:lnTo>
                    <a:pt x="532844" y="72202"/>
                  </a:lnTo>
                  <a:lnTo>
                    <a:pt x="532844" y="72202"/>
                  </a:lnTo>
                  <a:lnTo>
                    <a:pt x="635314" y="72202"/>
                  </a:lnTo>
                  <a:lnTo>
                    <a:pt x="635314" y="72202"/>
                  </a:lnTo>
                  <a:lnTo>
                    <a:pt x="645561" y="72202"/>
                  </a:lnTo>
                  <a:lnTo>
                    <a:pt x="645561" y="72202"/>
                  </a:lnTo>
                  <a:lnTo>
                    <a:pt x="717290" y="72202"/>
                  </a:lnTo>
                  <a:lnTo>
                    <a:pt x="717290" y="72202"/>
                  </a:lnTo>
                  <a:lnTo>
                    <a:pt x="737784" y="72202"/>
                  </a:lnTo>
                  <a:lnTo>
                    <a:pt x="737784" y="72202"/>
                  </a:lnTo>
                  <a:lnTo>
                    <a:pt x="789019" y="72202"/>
                  </a:lnTo>
                  <a:lnTo>
                    <a:pt x="789019" y="72202"/>
                  </a:lnTo>
                  <a:lnTo>
                    <a:pt x="830007" y="72202"/>
                  </a:lnTo>
                  <a:lnTo>
                    <a:pt x="830007" y="72202"/>
                  </a:lnTo>
                  <a:lnTo>
                    <a:pt x="860748" y="72202"/>
                  </a:lnTo>
                  <a:lnTo>
                    <a:pt x="860748" y="72202"/>
                  </a:lnTo>
                  <a:lnTo>
                    <a:pt x="901736" y="72202"/>
                  </a:lnTo>
                  <a:lnTo>
                    <a:pt x="901736" y="72202"/>
                  </a:lnTo>
                  <a:lnTo>
                    <a:pt x="922230" y="72202"/>
                  </a:lnTo>
                  <a:lnTo>
                    <a:pt x="922230" y="72202"/>
                  </a:lnTo>
                  <a:lnTo>
                    <a:pt x="1004206" y="72202"/>
                  </a:lnTo>
                  <a:lnTo>
                    <a:pt x="1004206" y="72202"/>
                  </a:lnTo>
                  <a:lnTo>
                    <a:pt x="1034947" y="72202"/>
                  </a:lnTo>
                  <a:lnTo>
                    <a:pt x="1034947" y="72202"/>
                  </a:lnTo>
                  <a:lnTo>
                    <a:pt x="1065688" y="72202"/>
                  </a:lnTo>
                  <a:lnTo>
                    <a:pt x="1065688" y="72202"/>
                  </a:lnTo>
                  <a:lnTo>
                    <a:pt x="1096429" y="72202"/>
                  </a:lnTo>
                  <a:lnTo>
                    <a:pt x="1096429" y="72202"/>
                  </a:lnTo>
                  <a:lnTo>
                    <a:pt x="1116923" y="72202"/>
                  </a:lnTo>
                  <a:lnTo>
                    <a:pt x="1116923" y="72202"/>
                  </a:lnTo>
                  <a:lnTo>
                    <a:pt x="1157911" y="72202"/>
                  </a:lnTo>
                  <a:lnTo>
                    <a:pt x="1157911" y="72202"/>
                  </a:lnTo>
                  <a:lnTo>
                    <a:pt x="1168158" y="72202"/>
                  </a:lnTo>
                  <a:lnTo>
                    <a:pt x="1168158" y="72202"/>
                  </a:lnTo>
                  <a:lnTo>
                    <a:pt x="1178405" y="72202"/>
                  </a:lnTo>
                  <a:lnTo>
                    <a:pt x="1178405" y="72202"/>
                  </a:lnTo>
                  <a:lnTo>
                    <a:pt x="1250134" y="72202"/>
                  </a:lnTo>
                  <a:lnTo>
                    <a:pt x="1250134" y="72202"/>
                  </a:lnTo>
                  <a:lnTo>
                    <a:pt x="1280875" y="72202"/>
                  </a:lnTo>
                  <a:lnTo>
                    <a:pt x="1280875" y="72202"/>
                  </a:lnTo>
                  <a:lnTo>
                    <a:pt x="1291122" y="72202"/>
                  </a:lnTo>
                  <a:lnTo>
                    <a:pt x="1291122" y="72202"/>
                  </a:lnTo>
                  <a:lnTo>
                    <a:pt x="1332110" y="72202"/>
                  </a:lnTo>
                  <a:lnTo>
                    <a:pt x="1332110" y="37311"/>
                  </a:lnTo>
                  <a:lnTo>
                    <a:pt x="1434580" y="37311"/>
                  </a:lnTo>
                  <a:lnTo>
                    <a:pt x="1434580" y="37311"/>
                  </a:lnTo>
                  <a:lnTo>
                    <a:pt x="1444827" y="37311"/>
                  </a:lnTo>
                  <a:lnTo>
                    <a:pt x="1444827" y="37311"/>
                  </a:lnTo>
                  <a:lnTo>
                    <a:pt x="1547297" y="37311"/>
                  </a:lnTo>
                  <a:lnTo>
                    <a:pt x="1547297" y="37311"/>
                  </a:lnTo>
                  <a:lnTo>
                    <a:pt x="1588285" y="37311"/>
                  </a:lnTo>
                  <a:lnTo>
                    <a:pt x="1588285" y="37311"/>
                  </a:lnTo>
                  <a:lnTo>
                    <a:pt x="1711249" y="37311"/>
                  </a:lnTo>
                  <a:lnTo>
                    <a:pt x="1711249" y="37311"/>
                  </a:lnTo>
                  <a:lnTo>
                    <a:pt x="1752237" y="37311"/>
                  </a:lnTo>
                  <a:lnTo>
                    <a:pt x="1752237" y="37311"/>
                  </a:lnTo>
                  <a:lnTo>
                    <a:pt x="1762484" y="37311"/>
                  </a:lnTo>
                  <a:lnTo>
                    <a:pt x="1762484" y="37311"/>
                  </a:lnTo>
                  <a:lnTo>
                    <a:pt x="1864954" y="37311"/>
                  </a:lnTo>
                  <a:lnTo>
                    <a:pt x="1864954" y="37311"/>
                  </a:lnTo>
                  <a:lnTo>
                    <a:pt x="1895695" y="37311"/>
                  </a:lnTo>
                  <a:lnTo>
                    <a:pt x="1895695" y="37311"/>
                  </a:lnTo>
                  <a:lnTo>
                    <a:pt x="1905942" y="37311"/>
                  </a:lnTo>
                  <a:lnTo>
                    <a:pt x="1905942" y="37311"/>
                  </a:lnTo>
                  <a:lnTo>
                    <a:pt x="1936683" y="37311"/>
                  </a:lnTo>
                  <a:lnTo>
                    <a:pt x="1936683" y="37311"/>
                  </a:lnTo>
                  <a:lnTo>
                    <a:pt x="1957177" y="37311"/>
                  </a:lnTo>
                  <a:lnTo>
                    <a:pt x="1957177" y="37311"/>
                  </a:lnTo>
                  <a:lnTo>
                    <a:pt x="2244094" y="37311"/>
                  </a:lnTo>
                  <a:lnTo>
                    <a:pt x="2244094" y="0"/>
                  </a:lnTo>
                  <a:lnTo>
                    <a:pt x="2356811" y="0"/>
                  </a:lnTo>
                  <a:lnTo>
                    <a:pt x="2356811" y="0"/>
                  </a:lnTo>
                  <a:lnTo>
                    <a:pt x="2367058" y="0"/>
                  </a:lnTo>
                  <a:lnTo>
                    <a:pt x="2367058" y="0"/>
                  </a:lnTo>
                  <a:lnTo>
                    <a:pt x="2408046" y="0"/>
                  </a:lnTo>
                  <a:lnTo>
                    <a:pt x="2408046" y="0"/>
                  </a:lnTo>
                  <a:lnTo>
                    <a:pt x="2418293" y="0"/>
                  </a:lnTo>
                  <a:lnTo>
                    <a:pt x="2418293" y="0"/>
                  </a:lnTo>
                  <a:lnTo>
                    <a:pt x="2571998" y="0"/>
                  </a:lnTo>
                  <a:lnTo>
                    <a:pt x="2571998" y="0"/>
                  </a:lnTo>
                  <a:lnTo>
                    <a:pt x="2705209" y="0"/>
                  </a:lnTo>
                  <a:lnTo>
                    <a:pt x="2705209" y="0"/>
                  </a:lnTo>
                  <a:lnTo>
                    <a:pt x="2725703" y="0"/>
                  </a:lnTo>
                  <a:lnTo>
                    <a:pt x="2725703" y="0"/>
                  </a:lnTo>
                  <a:lnTo>
                    <a:pt x="2735950" y="0"/>
                  </a:lnTo>
                  <a:lnTo>
                    <a:pt x="2735950" y="0"/>
                  </a:lnTo>
                  <a:lnTo>
                    <a:pt x="2787185" y="0"/>
                  </a:lnTo>
                  <a:lnTo>
                    <a:pt x="2787185" y="0"/>
                  </a:lnTo>
                  <a:lnTo>
                    <a:pt x="3002372" y="0"/>
                  </a:lnTo>
                  <a:lnTo>
                    <a:pt x="3002372" y="0"/>
                  </a:lnTo>
                  <a:lnTo>
                    <a:pt x="3340523" y="0"/>
                  </a:lnTo>
                  <a:lnTo>
                    <a:pt x="3340523" y="0"/>
                  </a:lnTo>
                  <a:lnTo>
                    <a:pt x="3842626" y="0"/>
                  </a:lnTo>
                  <a:lnTo>
                    <a:pt x="3842626" y="0"/>
                  </a:lnTo>
                  <a:lnTo>
                    <a:pt x="3863120" y="0"/>
                  </a:lnTo>
                  <a:lnTo>
                    <a:pt x="3863120" y="0"/>
                  </a:lnTo>
                  <a:lnTo>
                    <a:pt x="3873367" y="0"/>
                  </a:lnTo>
                  <a:lnTo>
                    <a:pt x="3873367" y="0"/>
                  </a:lnTo>
                  <a:lnTo>
                    <a:pt x="3945096" y="0"/>
                  </a:lnTo>
                  <a:lnTo>
                    <a:pt x="3945096" y="0"/>
                  </a:lnTo>
                  <a:lnTo>
                    <a:pt x="4590658" y="0"/>
                  </a:lnTo>
                  <a:lnTo>
                    <a:pt x="4590658" y="0"/>
                  </a:lnTo>
                  <a:lnTo>
                    <a:pt x="4877574" y="0"/>
                  </a:lnTo>
                  <a:lnTo>
                    <a:pt x="4877574" y="0"/>
                  </a:lnTo>
                  <a:lnTo>
                    <a:pt x="5092761" y="0"/>
                  </a:lnTo>
                  <a:lnTo>
                    <a:pt x="5092761" y="0"/>
                  </a:lnTo>
                  <a:lnTo>
                    <a:pt x="5379677" y="0"/>
                  </a:lnTo>
                  <a:lnTo>
                    <a:pt x="5379677" y="0"/>
                  </a:lnTo>
                  <a:lnTo>
                    <a:pt x="5512888" y="0"/>
                  </a:lnTo>
                  <a:lnTo>
                    <a:pt x="5512888" y="0"/>
                  </a:lnTo>
                  <a:lnTo>
                    <a:pt x="5994498" y="0"/>
                  </a:lnTo>
                  <a:lnTo>
                    <a:pt x="5994498" y="0"/>
                  </a:lnTo>
                  <a:lnTo>
                    <a:pt x="6045733" y="0"/>
                  </a:lnTo>
                  <a:lnTo>
                    <a:pt x="6045733" y="0"/>
                  </a:lnTo>
                  <a:lnTo>
                    <a:pt x="6301908" y="0"/>
                  </a:lnTo>
                  <a:lnTo>
                    <a:pt x="6301908" y="0"/>
                  </a:lnTo>
                  <a:lnTo>
                    <a:pt x="6527342" y="0"/>
                  </a:lnTo>
                  <a:lnTo>
                    <a:pt x="6527342" y="0"/>
                  </a:lnTo>
                  <a:lnTo>
                    <a:pt x="7049939" y="0"/>
                  </a:lnTo>
                  <a:lnTo>
                    <a:pt x="7049939" y="0"/>
                  </a:lnTo>
                  <a:lnTo>
                    <a:pt x="7265126" y="0"/>
                  </a:lnTo>
                  <a:lnTo>
                    <a:pt x="7265126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36" name="rc29">
              <a:extLst>
                <a:ext uri="{FF2B5EF4-FFF2-40B4-BE49-F238E27FC236}">
                  <a16:creationId xmlns:a16="http://schemas.microsoft.com/office/drawing/2014/main" id="{EC6A369F-90C3-1398-7A4B-03773E724AEE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37" name="tx30">
              <a:extLst>
                <a:ext uri="{FF2B5EF4-FFF2-40B4-BE49-F238E27FC236}">
                  <a16:creationId xmlns:a16="http://schemas.microsoft.com/office/drawing/2014/main" id="{691E58F3-07B3-903B-CA16-EB133B1652CF}"/>
                </a:ext>
              </a:extLst>
            </p:cNvPr>
            <p:cNvSpPr/>
            <p:nvPr/>
          </p:nvSpPr>
          <p:spPr>
            <a:xfrm>
              <a:off x="466667" y="3486760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438" name="tx31">
              <a:extLst>
                <a:ext uri="{FF2B5EF4-FFF2-40B4-BE49-F238E27FC236}">
                  <a16:creationId xmlns:a16="http://schemas.microsoft.com/office/drawing/2014/main" id="{6862760D-75C7-34C3-ACE2-10AC190D2F4F}"/>
                </a:ext>
              </a:extLst>
            </p:cNvPr>
            <p:cNvSpPr/>
            <p:nvPr/>
          </p:nvSpPr>
          <p:spPr>
            <a:xfrm>
              <a:off x="466667" y="2678436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439" name="tx32">
              <a:extLst>
                <a:ext uri="{FF2B5EF4-FFF2-40B4-BE49-F238E27FC236}">
                  <a16:creationId xmlns:a16="http://schemas.microsoft.com/office/drawing/2014/main" id="{CE5CC5F7-0C28-05ED-DE62-D9791A542D8B}"/>
                </a:ext>
              </a:extLst>
            </p:cNvPr>
            <p:cNvSpPr/>
            <p:nvPr/>
          </p:nvSpPr>
          <p:spPr>
            <a:xfrm>
              <a:off x="466667" y="1870113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440" name="tx33">
              <a:extLst>
                <a:ext uri="{FF2B5EF4-FFF2-40B4-BE49-F238E27FC236}">
                  <a16:creationId xmlns:a16="http://schemas.microsoft.com/office/drawing/2014/main" id="{746E7071-12DF-8ACB-F9F2-EA91000DBB19}"/>
                </a:ext>
              </a:extLst>
            </p:cNvPr>
            <p:cNvSpPr/>
            <p:nvPr/>
          </p:nvSpPr>
          <p:spPr>
            <a:xfrm>
              <a:off x="466667" y="1061789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441" name="tx34">
              <a:extLst>
                <a:ext uri="{FF2B5EF4-FFF2-40B4-BE49-F238E27FC236}">
                  <a16:creationId xmlns:a16="http://schemas.microsoft.com/office/drawing/2014/main" id="{ECCD9972-AA66-061A-8D37-DE598D933CBD}"/>
                </a:ext>
              </a:extLst>
            </p:cNvPr>
            <p:cNvSpPr/>
            <p:nvPr/>
          </p:nvSpPr>
          <p:spPr>
            <a:xfrm>
              <a:off x="466667" y="253465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0</a:t>
              </a:r>
            </a:p>
          </p:txBody>
        </p:sp>
        <p:sp>
          <p:nvSpPr>
            <p:cNvPr id="442" name="pl35">
              <a:extLst>
                <a:ext uri="{FF2B5EF4-FFF2-40B4-BE49-F238E27FC236}">
                  <a16:creationId xmlns:a16="http://schemas.microsoft.com/office/drawing/2014/main" id="{42953F99-51E6-2471-3F76-F30D76FB791B}"/>
                </a:ext>
              </a:extLst>
            </p:cNvPr>
            <p:cNvSpPr/>
            <p:nvPr/>
          </p:nvSpPr>
          <p:spPr>
            <a:xfrm>
              <a:off x="741682" y="353413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43" name="pl36">
              <a:extLst>
                <a:ext uri="{FF2B5EF4-FFF2-40B4-BE49-F238E27FC236}">
                  <a16:creationId xmlns:a16="http://schemas.microsoft.com/office/drawing/2014/main" id="{3ACA6B88-16B6-2FE7-B1F9-5BDE779D6AB6}"/>
                </a:ext>
              </a:extLst>
            </p:cNvPr>
            <p:cNvSpPr/>
            <p:nvPr/>
          </p:nvSpPr>
          <p:spPr>
            <a:xfrm>
              <a:off x="741682" y="2725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44" name="pl37">
              <a:extLst>
                <a:ext uri="{FF2B5EF4-FFF2-40B4-BE49-F238E27FC236}">
                  <a16:creationId xmlns:a16="http://schemas.microsoft.com/office/drawing/2014/main" id="{4EB55F03-754C-352A-BD5D-41E42006F332}"/>
                </a:ext>
              </a:extLst>
            </p:cNvPr>
            <p:cNvSpPr/>
            <p:nvPr/>
          </p:nvSpPr>
          <p:spPr>
            <a:xfrm>
              <a:off x="741682" y="19174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45" name="pl38">
              <a:extLst>
                <a:ext uri="{FF2B5EF4-FFF2-40B4-BE49-F238E27FC236}">
                  <a16:creationId xmlns:a16="http://schemas.microsoft.com/office/drawing/2014/main" id="{F604B198-190C-EEE0-2AEA-EEF8970E96FD}"/>
                </a:ext>
              </a:extLst>
            </p:cNvPr>
            <p:cNvSpPr/>
            <p:nvPr/>
          </p:nvSpPr>
          <p:spPr>
            <a:xfrm>
              <a:off x="741682" y="11091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46" name="pl39">
              <a:extLst>
                <a:ext uri="{FF2B5EF4-FFF2-40B4-BE49-F238E27FC236}">
                  <a16:creationId xmlns:a16="http://schemas.microsoft.com/office/drawing/2014/main" id="{7369B7BC-4CBB-3877-0768-9729EC1B6102}"/>
                </a:ext>
              </a:extLst>
            </p:cNvPr>
            <p:cNvSpPr/>
            <p:nvPr/>
          </p:nvSpPr>
          <p:spPr>
            <a:xfrm>
              <a:off x="741682" y="3008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47" name="pl40">
              <a:extLst>
                <a:ext uri="{FF2B5EF4-FFF2-40B4-BE49-F238E27FC236}">
                  <a16:creationId xmlns:a16="http://schemas.microsoft.com/office/drawing/2014/main" id="{3A52AD99-7379-4C79-2A12-71F166944E9F}"/>
                </a:ext>
              </a:extLst>
            </p:cNvPr>
            <p:cNvSpPr/>
            <p:nvPr/>
          </p:nvSpPr>
          <p:spPr>
            <a:xfrm>
              <a:off x="1150492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48" name="pl41">
              <a:extLst>
                <a:ext uri="{FF2B5EF4-FFF2-40B4-BE49-F238E27FC236}">
                  <a16:creationId xmlns:a16="http://schemas.microsoft.com/office/drawing/2014/main" id="{0D06921A-3B67-E070-DD60-D114E0E35280}"/>
                </a:ext>
              </a:extLst>
            </p:cNvPr>
            <p:cNvSpPr/>
            <p:nvPr/>
          </p:nvSpPr>
          <p:spPr>
            <a:xfrm>
              <a:off x="3199893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49" name="pl42">
              <a:extLst>
                <a:ext uri="{FF2B5EF4-FFF2-40B4-BE49-F238E27FC236}">
                  <a16:creationId xmlns:a16="http://schemas.microsoft.com/office/drawing/2014/main" id="{AE2B6E4D-8392-1511-4C86-AD57382C2519}"/>
                </a:ext>
              </a:extLst>
            </p:cNvPr>
            <p:cNvSpPr/>
            <p:nvPr/>
          </p:nvSpPr>
          <p:spPr>
            <a:xfrm>
              <a:off x="5249294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50" name="pl43">
              <a:extLst>
                <a:ext uri="{FF2B5EF4-FFF2-40B4-BE49-F238E27FC236}">
                  <a16:creationId xmlns:a16="http://schemas.microsoft.com/office/drawing/2014/main" id="{497A8BAC-3F7E-2B11-E432-5373039B2500}"/>
                </a:ext>
              </a:extLst>
            </p:cNvPr>
            <p:cNvSpPr/>
            <p:nvPr/>
          </p:nvSpPr>
          <p:spPr>
            <a:xfrm>
              <a:off x="7298695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51" name="tx44">
              <a:extLst>
                <a:ext uri="{FF2B5EF4-FFF2-40B4-BE49-F238E27FC236}">
                  <a16:creationId xmlns:a16="http://schemas.microsoft.com/office/drawing/2014/main" id="{51C625A7-A17D-61B6-25F3-8FC8F3B0346F}"/>
                </a:ext>
              </a:extLst>
            </p:cNvPr>
            <p:cNvSpPr/>
            <p:nvPr/>
          </p:nvSpPr>
          <p:spPr>
            <a:xfrm>
              <a:off x="1115176" y="3756509"/>
              <a:ext cx="70631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452" name="tx45">
              <a:extLst>
                <a:ext uri="{FF2B5EF4-FFF2-40B4-BE49-F238E27FC236}">
                  <a16:creationId xmlns:a16="http://schemas.microsoft.com/office/drawing/2014/main" id="{B7C014A6-3C0C-7E78-C375-B6A045BFC8B5}"/>
                </a:ext>
              </a:extLst>
            </p:cNvPr>
            <p:cNvSpPr/>
            <p:nvPr/>
          </p:nvSpPr>
          <p:spPr>
            <a:xfrm>
              <a:off x="3093946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453" name="tx46">
              <a:extLst>
                <a:ext uri="{FF2B5EF4-FFF2-40B4-BE49-F238E27FC236}">
                  <a16:creationId xmlns:a16="http://schemas.microsoft.com/office/drawing/2014/main" id="{11959E6E-E8EE-37B8-438F-BABB01927DCF}"/>
                </a:ext>
              </a:extLst>
            </p:cNvPr>
            <p:cNvSpPr/>
            <p:nvPr/>
          </p:nvSpPr>
          <p:spPr>
            <a:xfrm>
              <a:off x="5143347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454" name="tx47">
              <a:extLst>
                <a:ext uri="{FF2B5EF4-FFF2-40B4-BE49-F238E27FC236}">
                  <a16:creationId xmlns:a16="http://schemas.microsoft.com/office/drawing/2014/main" id="{45DC6605-CE56-4EE9-3266-1ABBDE6DDCF2}"/>
                </a:ext>
              </a:extLst>
            </p:cNvPr>
            <p:cNvSpPr/>
            <p:nvPr/>
          </p:nvSpPr>
          <p:spPr>
            <a:xfrm>
              <a:off x="7192748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455" name="tx48">
              <a:extLst>
                <a:ext uri="{FF2B5EF4-FFF2-40B4-BE49-F238E27FC236}">
                  <a16:creationId xmlns:a16="http://schemas.microsoft.com/office/drawing/2014/main" id="{3F20DF2C-A921-E02D-6426-28BA61ABF4D2}"/>
                </a:ext>
              </a:extLst>
            </p:cNvPr>
            <p:cNvSpPr/>
            <p:nvPr/>
          </p:nvSpPr>
          <p:spPr>
            <a:xfrm>
              <a:off x="4081991" y="3901313"/>
              <a:ext cx="1617314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 to mortality (Days)</a:t>
              </a:r>
            </a:p>
          </p:txBody>
        </p:sp>
        <p:sp>
          <p:nvSpPr>
            <p:cNvPr id="456" name="rc50">
              <a:extLst>
                <a:ext uri="{FF2B5EF4-FFF2-40B4-BE49-F238E27FC236}">
                  <a16:creationId xmlns:a16="http://schemas.microsoft.com/office/drawing/2014/main" id="{DA7F13A7-BC59-423C-586E-3CE4E2951680}"/>
                </a:ext>
              </a:extLst>
            </p:cNvPr>
            <p:cNvSpPr/>
            <p:nvPr/>
          </p:nvSpPr>
          <p:spPr>
            <a:xfrm>
              <a:off x="4276688" y="4189554"/>
              <a:ext cx="1227921" cy="358634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457" name="rc51">
              <a:extLst>
                <a:ext uri="{FF2B5EF4-FFF2-40B4-BE49-F238E27FC236}">
                  <a16:creationId xmlns:a16="http://schemas.microsoft.com/office/drawing/2014/main" id="{3668F124-5156-B282-B79A-7497A61C8E97}"/>
                </a:ext>
              </a:extLst>
            </p:cNvPr>
            <p:cNvSpPr/>
            <p:nvPr/>
          </p:nvSpPr>
          <p:spPr>
            <a:xfrm>
              <a:off x="4415866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458" name="pl52">
              <a:extLst>
                <a:ext uri="{FF2B5EF4-FFF2-40B4-BE49-F238E27FC236}">
                  <a16:creationId xmlns:a16="http://schemas.microsoft.com/office/drawing/2014/main" id="{1907F9F4-13D2-31C1-5968-15C462FC2E9E}"/>
                </a:ext>
              </a:extLst>
            </p:cNvPr>
            <p:cNvSpPr/>
            <p:nvPr/>
          </p:nvSpPr>
          <p:spPr>
            <a:xfrm>
              <a:off x="4437812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59" name="rc53">
              <a:extLst>
                <a:ext uri="{FF2B5EF4-FFF2-40B4-BE49-F238E27FC236}">
                  <a16:creationId xmlns:a16="http://schemas.microsoft.com/office/drawing/2014/main" id="{26BD28CD-6112-6BAF-7878-37ED13C4071E}"/>
                </a:ext>
              </a:extLst>
            </p:cNvPr>
            <p:cNvSpPr/>
            <p:nvPr/>
          </p:nvSpPr>
          <p:spPr>
            <a:xfrm>
              <a:off x="4926900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460" name="pl54">
              <a:extLst>
                <a:ext uri="{FF2B5EF4-FFF2-40B4-BE49-F238E27FC236}">
                  <a16:creationId xmlns:a16="http://schemas.microsoft.com/office/drawing/2014/main" id="{EB7C229A-1236-054B-F880-2B26964193AA}"/>
                </a:ext>
              </a:extLst>
            </p:cNvPr>
            <p:cNvSpPr/>
            <p:nvPr/>
          </p:nvSpPr>
          <p:spPr>
            <a:xfrm>
              <a:off x="4948846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61" name="tx55">
              <a:extLst>
                <a:ext uri="{FF2B5EF4-FFF2-40B4-BE49-F238E27FC236}">
                  <a16:creationId xmlns:a16="http://schemas.microsoft.com/office/drawing/2014/main" id="{FE5203E0-1679-9193-AC35-9452416DEA1C}"/>
                </a:ext>
              </a:extLst>
            </p:cNvPr>
            <p:cNvSpPr/>
            <p:nvPr/>
          </p:nvSpPr>
          <p:spPr>
            <a:xfrm>
              <a:off x="4704911" y="4321929"/>
              <a:ext cx="162346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462" name="tx56">
              <a:extLst>
                <a:ext uri="{FF2B5EF4-FFF2-40B4-BE49-F238E27FC236}">
                  <a16:creationId xmlns:a16="http://schemas.microsoft.com/office/drawing/2014/main" id="{9FE1BE47-134D-E8FE-0637-F06465EA15AD}"/>
                </a:ext>
              </a:extLst>
            </p:cNvPr>
            <p:cNvSpPr/>
            <p:nvPr/>
          </p:nvSpPr>
          <p:spPr>
            <a:xfrm>
              <a:off x="5215945" y="4321929"/>
              <a:ext cx="218839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  <p:sp>
          <p:nvSpPr>
            <p:cNvPr id="463" name="rc57">
              <a:extLst>
                <a:ext uri="{FF2B5EF4-FFF2-40B4-BE49-F238E27FC236}">
                  <a16:creationId xmlns:a16="http://schemas.microsoft.com/office/drawing/2014/main" id="{D133B7E3-4642-CB1D-6094-E2965809CE59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64" name="rc58">
              <a:extLst>
                <a:ext uri="{FF2B5EF4-FFF2-40B4-BE49-F238E27FC236}">
                  <a16:creationId xmlns:a16="http://schemas.microsoft.com/office/drawing/2014/main" id="{6D7A1E17-E1AA-C90B-D868-279E0B38D2EB}"/>
                </a:ext>
              </a:extLst>
            </p:cNvPr>
            <p:cNvSpPr/>
            <p:nvPr/>
          </p:nvSpPr>
          <p:spPr>
            <a:xfrm>
              <a:off x="776476" y="4996549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465" name="tx59">
              <a:extLst>
                <a:ext uri="{FF2B5EF4-FFF2-40B4-BE49-F238E27FC236}">
                  <a16:creationId xmlns:a16="http://schemas.microsoft.com/office/drawing/2014/main" id="{4E9304E3-1348-E14D-533F-8BCE47CF6A44}"/>
                </a:ext>
              </a:extLst>
            </p:cNvPr>
            <p:cNvSpPr/>
            <p:nvPr/>
          </p:nvSpPr>
          <p:spPr>
            <a:xfrm>
              <a:off x="1115323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466" name="tx60">
              <a:extLst>
                <a:ext uri="{FF2B5EF4-FFF2-40B4-BE49-F238E27FC236}">
                  <a16:creationId xmlns:a16="http://schemas.microsoft.com/office/drawing/2014/main" id="{17C35790-0498-2F6D-1165-45E0E2E011D8}"/>
                </a:ext>
              </a:extLst>
            </p:cNvPr>
            <p:cNvSpPr/>
            <p:nvPr/>
          </p:nvSpPr>
          <p:spPr>
            <a:xfrm>
              <a:off x="1080154" y="5132574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8</a:t>
              </a:r>
            </a:p>
          </p:txBody>
        </p:sp>
        <p:sp>
          <p:nvSpPr>
            <p:cNvPr id="467" name="tx61">
              <a:extLst>
                <a:ext uri="{FF2B5EF4-FFF2-40B4-BE49-F238E27FC236}">
                  <a16:creationId xmlns:a16="http://schemas.microsoft.com/office/drawing/2014/main" id="{649BA501-0169-507D-1896-32AAD5E9ED20}"/>
                </a:ext>
              </a:extLst>
            </p:cNvPr>
            <p:cNvSpPr/>
            <p:nvPr/>
          </p:nvSpPr>
          <p:spPr>
            <a:xfrm>
              <a:off x="3164724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468" name="tx62">
              <a:extLst>
                <a:ext uri="{FF2B5EF4-FFF2-40B4-BE49-F238E27FC236}">
                  <a16:creationId xmlns:a16="http://schemas.microsoft.com/office/drawing/2014/main" id="{35D0D934-3C1F-4FB3-E72E-B1A633FE949B}"/>
                </a:ext>
              </a:extLst>
            </p:cNvPr>
            <p:cNvSpPr/>
            <p:nvPr/>
          </p:nvSpPr>
          <p:spPr>
            <a:xfrm>
              <a:off x="3164724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469" name="tx63">
              <a:extLst>
                <a:ext uri="{FF2B5EF4-FFF2-40B4-BE49-F238E27FC236}">
                  <a16:creationId xmlns:a16="http://schemas.microsoft.com/office/drawing/2014/main" id="{712FFDF2-7E4F-F4E6-269B-716DAE5461BD}"/>
                </a:ext>
              </a:extLst>
            </p:cNvPr>
            <p:cNvSpPr/>
            <p:nvPr/>
          </p:nvSpPr>
          <p:spPr>
            <a:xfrm>
              <a:off x="5214125" y="5437853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470" name="tx64">
              <a:extLst>
                <a:ext uri="{FF2B5EF4-FFF2-40B4-BE49-F238E27FC236}">
                  <a16:creationId xmlns:a16="http://schemas.microsoft.com/office/drawing/2014/main" id="{FCF6F4F1-3FF4-C314-28B1-77D85AE0E01C}"/>
                </a:ext>
              </a:extLst>
            </p:cNvPr>
            <p:cNvSpPr/>
            <p:nvPr/>
          </p:nvSpPr>
          <p:spPr>
            <a:xfrm>
              <a:off x="5214125" y="5134179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471" name="tx65">
              <a:extLst>
                <a:ext uri="{FF2B5EF4-FFF2-40B4-BE49-F238E27FC236}">
                  <a16:creationId xmlns:a16="http://schemas.microsoft.com/office/drawing/2014/main" id="{441C9F4C-91BB-6381-6264-392A75398280}"/>
                </a:ext>
              </a:extLst>
            </p:cNvPr>
            <p:cNvSpPr/>
            <p:nvPr/>
          </p:nvSpPr>
          <p:spPr>
            <a:xfrm>
              <a:off x="7263526" y="5439829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472" name="tx66">
              <a:extLst>
                <a:ext uri="{FF2B5EF4-FFF2-40B4-BE49-F238E27FC236}">
                  <a16:creationId xmlns:a16="http://schemas.microsoft.com/office/drawing/2014/main" id="{4B757A24-5EE9-90CF-B79C-9F82748B066D}"/>
                </a:ext>
              </a:extLst>
            </p:cNvPr>
            <p:cNvSpPr/>
            <p:nvPr/>
          </p:nvSpPr>
          <p:spPr>
            <a:xfrm>
              <a:off x="7263526" y="5134117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473" name="tx67">
              <a:extLst>
                <a:ext uri="{FF2B5EF4-FFF2-40B4-BE49-F238E27FC236}">
                  <a16:creationId xmlns:a16="http://schemas.microsoft.com/office/drawing/2014/main" id="{F0AAA265-6DAB-AE86-1684-B79317D73107}"/>
                </a:ext>
              </a:extLst>
            </p:cNvPr>
            <p:cNvSpPr/>
            <p:nvPr/>
          </p:nvSpPr>
          <p:spPr>
            <a:xfrm>
              <a:off x="325591" y="5438152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474" name="tx68">
              <a:extLst>
                <a:ext uri="{FF2B5EF4-FFF2-40B4-BE49-F238E27FC236}">
                  <a16:creationId xmlns:a16="http://schemas.microsoft.com/office/drawing/2014/main" id="{9E70F7B1-B13B-5ECF-1A52-23E1E6E4660B}"/>
                </a:ext>
              </a:extLst>
            </p:cNvPr>
            <p:cNvSpPr/>
            <p:nvPr/>
          </p:nvSpPr>
          <p:spPr>
            <a:xfrm>
              <a:off x="311638" y="5132811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475" name="tx69">
              <a:extLst>
                <a:ext uri="{FF2B5EF4-FFF2-40B4-BE49-F238E27FC236}">
                  <a16:creationId xmlns:a16="http://schemas.microsoft.com/office/drawing/2014/main" id="{5100E4E4-724A-F041-A3A3-FFE196BF8F99}"/>
                </a:ext>
              </a:extLst>
            </p:cNvPr>
            <p:cNvSpPr/>
            <p:nvPr/>
          </p:nvSpPr>
          <p:spPr>
            <a:xfrm>
              <a:off x="776476" y="4827633"/>
              <a:ext cx="17452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476" name="rc70">
              <a:extLst>
                <a:ext uri="{FF2B5EF4-FFF2-40B4-BE49-F238E27FC236}">
                  <a16:creationId xmlns:a16="http://schemas.microsoft.com/office/drawing/2014/main" id="{EF3A4189-7981-2E9D-6C8D-5592B242E2A1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77" name="rc71">
              <a:extLst>
                <a:ext uri="{FF2B5EF4-FFF2-40B4-BE49-F238E27FC236}">
                  <a16:creationId xmlns:a16="http://schemas.microsoft.com/office/drawing/2014/main" id="{480AB28D-DA79-1488-BD2E-DF18072C0E43}"/>
                </a:ext>
              </a:extLst>
            </p:cNvPr>
            <p:cNvSpPr/>
            <p:nvPr/>
          </p:nvSpPr>
          <p:spPr>
            <a:xfrm>
              <a:off x="776476" y="6081865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478" name="tx72">
              <a:extLst>
                <a:ext uri="{FF2B5EF4-FFF2-40B4-BE49-F238E27FC236}">
                  <a16:creationId xmlns:a16="http://schemas.microsoft.com/office/drawing/2014/main" id="{08969288-2F6F-33DE-B74A-74C680D87E57}"/>
                </a:ext>
              </a:extLst>
            </p:cNvPr>
            <p:cNvSpPr/>
            <p:nvPr/>
          </p:nvSpPr>
          <p:spPr>
            <a:xfrm>
              <a:off x="1115323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479" name="tx73">
              <a:extLst>
                <a:ext uri="{FF2B5EF4-FFF2-40B4-BE49-F238E27FC236}">
                  <a16:creationId xmlns:a16="http://schemas.microsoft.com/office/drawing/2014/main" id="{D16C79FA-1188-D62C-CE39-DF102382E369}"/>
                </a:ext>
              </a:extLst>
            </p:cNvPr>
            <p:cNvSpPr/>
            <p:nvPr/>
          </p:nvSpPr>
          <p:spPr>
            <a:xfrm>
              <a:off x="1080154" y="6217890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6</a:t>
              </a:r>
            </a:p>
          </p:txBody>
        </p:sp>
        <p:sp>
          <p:nvSpPr>
            <p:cNvPr id="480" name="tx74">
              <a:extLst>
                <a:ext uri="{FF2B5EF4-FFF2-40B4-BE49-F238E27FC236}">
                  <a16:creationId xmlns:a16="http://schemas.microsoft.com/office/drawing/2014/main" id="{B5783CEE-681E-1C4B-3E7D-D8A63DC4DAE8}"/>
                </a:ext>
              </a:extLst>
            </p:cNvPr>
            <p:cNvSpPr/>
            <p:nvPr/>
          </p:nvSpPr>
          <p:spPr>
            <a:xfrm>
              <a:off x="3164724" y="6523169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481" name="tx75">
              <a:extLst>
                <a:ext uri="{FF2B5EF4-FFF2-40B4-BE49-F238E27FC236}">
                  <a16:creationId xmlns:a16="http://schemas.microsoft.com/office/drawing/2014/main" id="{AAE2B960-320E-7BA8-0734-582BB3E68C04}"/>
                </a:ext>
              </a:extLst>
            </p:cNvPr>
            <p:cNvSpPr/>
            <p:nvPr/>
          </p:nvSpPr>
          <p:spPr>
            <a:xfrm>
              <a:off x="3129555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1</a:t>
              </a:r>
            </a:p>
          </p:txBody>
        </p:sp>
        <p:sp>
          <p:nvSpPr>
            <p:cNvPr id="482" name="tx76">
              <a:extLst>
                <a:ext uri="{FF2B5EF4-FFF2-40B4-BE49-F238E27FC236}">
                  <a16:creationId xmlns:a16="http://schemas.microsoft.com/office/drawing/2014/main" id="{EF5CF390-6C93-105A-9490-F833EACF254E}"/>
                </a:ext>
              </a:extLst>
            </p:cNvPr>
            <p:cNvSpPr/>
            <p:nvPr/>
          </p:nvSpPr>
          <p:spPr>
            <a:xfrm>
              <a:off x="5214125" y="6525145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483" name="tx77">
              <a:extLst>
                <a:ext uri="{FF2B5EF4-FFF2-40B4-BE49-F238E27FC236}">
                  <a16:creationId xmlns:a16="http://schemas.microsoft.com/office/drawing/2014/main" id="{ED4A8E9B-C9A7-D52C-BE6D-D5D778544F89}"/>
                </a:ext>
              </a:extLst>
            </p:cNvPr>
            <p:cNvSpPr/>
            <p:nvPr/>
          </p:nvSpPr>
          <p:spPr>
            <a:xfrm>
              <a:off x="5178956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4</a:t>
              </a:r>
            </a:p>
          </p:txBody>
        </p:sp>
        <p:sp>
          <p:nvSpPr>
            <p:cNvPr id="484" name="tx78">
              <a:extLst>
                <a:ext uri="{FF2B5EF4-FFF2-40B4-BE49-F238E27FC236}">
                  <a16:creationId xmlns:a16="http://schemas.microsoft.com/office/drawing/2014/main" id="{5740CC2E-B1B3-F9C3-269E-15BB6473F6C5}"/>
                </a:ext>
              </a:extLst>
            </p:cNvPr>
            <p:cNvSpPr/>
            <p:nvPr/>
          </p:nvSpPr>
          <p:spPr>
            <a:xfrm>
              <a:off x="7263526" y="6525145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485" name="tx79">
              <a:extLst>
                <a:ext uri="{FF2B5EF4-FFF2-40B4-BE49-F238E27FC236}">
                  <a16:creationId xmlns:a16="http://schemas.microsoft.com/office/drawing/2014/main" id="{B6E4B294-B709-FF0B-5B4D-6950481A9B30}"/>
                </a:ext>
              </a:extLst>
            </p:cNvPr>
            <p:cNvSpPr/>
            <p:nvPr/>
          </p:nvSpPr>
          <p:spPr>
            <a:xfrm>
              <a:off x="7228357" y="6217890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6</a:t>
              </a:r>
            </a:p>
          </p:txBody>
        </p:sp>
        <p:sp>
          <p:nvSpPr>
            <p:cNvPr id="486" name="tx80">
              <a:extLst>
                <a:ext uri="{FF2B5EF4-FFF2-40B4-BE49-F238E27FC236}">
                  <a16:creationId xmlns:a16="http://schemas.microsoft.com/office/drawing/2014/main" id="{F60541B9-1B79-0E28-CA93-6EF2654E23E5}"/>
                </a:ext>
              </a:extLst>
            </p:cNvPr>
            <p:cNvSpPr/>
            <p:nvPr/>
          </p:nvSpPr>
          <p:spPr>
            <a:xfrm>
              <a:off x="325591" y="6523468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487" name="tx81">
              <a:extLst>
                <a:ext uri="{FF2B5EF4-FFF2-40B4-BE49-F238E27FC236}">
                  <a16:creationId xmlns:a16="http://schemas.microsoft.com/office/drawing/2014/main" id="{990AA342-1714-B5C8-B0BB-682E3C934B5F}"/>
                </a:ext>
              </a:extLst>
            </p:cNvPr>
            <p:cNvSpPr/>
            <p:nvPr/>
          </p:nvSpPr>
          <p:spPr>
            <a:xfrm>
              <a:off x="311638" y="6218127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488" name="tx82">
              <a:extLst>
                <a:ext uri="{FF2B5EF4-FFF2-40B4-BE49-F238E27FC236}">
                  <a16:creationId xmlns:a16="http://schemas.microsoft.com/office/drawing/2014/main" id="{71DA981A-6752-E032-5B15-27A7AD7F863E}"/>
                </a:ext>
              </a:extLst>
            </p:cNvPr>
            <p:cNvSpPr/>
            <p:nvPr/>
          </p:nvSpPr>
          <p:spPr>
            <a:xfrm>
              <a:off x="776476" y="5912949"/>
              <a:ext cx="23525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</p:grpSp>
      <p:sp>
        <p:nvSpPr>
          <p:cNvPr id="489" name="tx47">
            <a:extLst>
              <a:ext uri="{FF2B5EF4-FFF2-40B4-BE49-F238E27FC236}">
                <a16:creationId xmlns:a16="http://schemas.microsoft.com/office/drawing/2014/main" id="{BBA05D08-ADA9-A3B3-EB34-34747B83030D}"/>
              </a:ext>
            </a:extLst>
          </p:cNvPr>
          <p:cNvSpPr>
            <a:spLocks noChangeAspect="1"/>
          </p:cNvSpPr>
          <p:nvPr/>
        </p:nvSpPr>
        <p:spPr>
          <a:xfrm rot="16200000">
            <a:off x="-303307" y="6339772"/>
            <a:ext cx="917105" cy="7613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992"/>
              </a:lnSpc>
            </a:pPr>
            <a:r>
              <a:rPr sz="992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rPr>
              <a:t>Cumulative Incidence</a:t>
            </a:r>
            <a:r>
              <a:rPr lang="en-US" sz="992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rPr>
              <a:t> of Mortality (%)</a:t>
            </a:r>
            <a:endParaRPr sz="992" dirty="0">
              <a:solidFill>
                <a:srgbClr val="000000">
                  <a:alpha val="100000"/>
                </a:srgbClr>
              </a:solidFill>
              <a:latin typeface="Arial"/>
              <a:cs typeface="Arial"/>
            </a:endParaRPr>
          </a:p>
        </p:txBody>
      </p:sp>
      <p:sp>
        <p:nvSpPr>
          <p:cNvPr id="490" name="TextBox 489">
            <a:extLst>
              <a:ext uri="{FF2B5EF4-FFF2-40B4-BE49-F238E27FC236}">
                <a16:creationId xmlns:a16="http://schemas.microsoft.com/office/drawing/2014/main" id="{E89B57E1-3682-2BCC-A231-23F70E68639B}"/>
              </a:ext>
            </a:extLst>
          </p:cNvPr>
          <p:cNvSpPr txBox="1">
            <a:spLocks noChangeAspect="1"/>
          </p:cNvSpPr>
          <p:nvPr/>
        </p:nvSpPr>
        <p:spPr>
          <a:xfrm>
            <a:off x="523461" y="5549105"/>
            <a:ext cx="3142172" cy="6519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9" b="1" dirty="0">
                <a:latin typeface="Arial" panose="020B0604020202020204" pitchFamily="34" charset="0"/>
                <a:cs typeface="Arial" panose="020B0604020202020204" pitchFamily="34" charset="0"/>
              </a:rPr>
              <a:t>Potential Living Donor  Total   Event   HR (95% CI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No                                     18        4         Reference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Yes                                    96        4        0.17 (0.04 – 0.69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Gray K-Sample Test P-value: 0.005        </a:t>
            </a:r>
          </a:p>
        </p:txBody>
      </p:sp>
      <p:sp>
        <p:nvSpPr>
          <p:cNvPr id="491" name="pl48">
            <a:extLst>
              <a:ext uri="{FF2B5EF4-FFF2-40B4-BE49-F238E27FC236}">
                <a16:creationId xmlns:a16="http://schemas.microsoft.com/office/drawing/2014/main" id="{E09FEB36-9014-1DEB-7E8F-24305AFC22EA}"/>
              </a:ext>
            </a:extLst>
          </p:cNvPr>
          <p:cNvSpPr>
            <a:spLocks noChangeAspect="1"/>
          </p:cNvSpPr>
          <p:nvPr/>
        </p:nvSpPr>
        <p:spPr>
          <a:xfrm>
            <a:off x="3227888" y="5891621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492" name="pl50">
            <a:extLst>
              <a:ext uri="{FF2B5EF4-FFF2-40B4-BE49-F238E27FC236}">
                <a16:creationId xmlns:a16="http://schemas.microsoft.com/office/drawing/2014/main" id="{05114FBE-37F3-D8EF-A748-648C7AF5A907}"/>
              </a:ext>
            </a:extLst>
          </p:cNvPr>
          <p:cNvSpPr>
            <a:spLocks noChangeAspect="1"/>
          </p:cNvSpPr>
          <p:nvPr/>
        </p:nvSpPr>
        <p:spPr>
          <a:xfrm>
            <a:off x="3233739" y="6025773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493" name="Title 1">
            <a:extLst>
              <a:ext uri="{FF2B5EF4-FFF2-40B4-BE49-F238E27FC236}">
                <a16:creationId xmlns:a16="http://schemas.microsoft.com/office/drawing/2014/main" id="{2D266D8C-F4F6-F5B2-39CF-BD655A44205A}"/>
              </a:ext>
            </a:extLst>
          </p:cNvPr>
          <p:cNvSpPr txBox="1">
            <a:spLocks/>
          </p:cNvSpPr>
          <p:nvPr/>
        </p:nvSpPr>
        <p:spPr>
          <a:xfrm>
            <a:off x="429118" y="5007109"/>
            <a:ext cx="4599151" cy="571493"/>
          </a:xfrm>
          <a:prstGeom prst="rect">
            <a:avLst/>
          </a:prstGeom>
        </p:spPr>
        <p:txBody>
          <a:bodyPr vert="horz" lIns="75605" tIns="37802" rIns="75605" bIns="37802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488" b="1" dirty="0">
                <a:latin typeface="+mn-lt"/>
              </a:rPr>
              <a:t>c. YOUNG: mortality on waitlist</a:t>
            </a:r>
          </a:p>
        </p:txBody>
      </p:sp>
      <p:grpSp>
        <p:nvGrpSpPr>
          <p:cNvPr id="494" name="Group 493">
            <a:extLst>
              <a:ext uri="{FF2B5EF4-FFF2-40B4-BE49-F238E27FC236}">
                <a16:creationId xmlns:a16="http://schemas.microsoft.com/office/drawing/2014/main" id="{186BB619-C3BD-4D29-93F9-B32E519EF07A}"/>
              </a:ext>
            </a:extLst>
          </p:cNvPr>
          <p:cNvGrpSpPr>
            <a:grpSpLocks noChangeAspect="1"/>
          </p:cNvGrpSpPr>
          <p:nvPr/>
        </p:nvGrpSpPr>
        <p:grpSpPr>
          <a:xfrm>
            <a:off x="4908740" y="5416676"/>
            <a:ext cx="5148501" cy="3423047"/>
            <a:chOff x="0" y="0"/>
            <a:chExt cx="9144000" cy="6858000"/>
          </a:xfrm>
        </p:grpSpPr>
        <p:sp>
          <p:nvSpPr>
            <p:cNvPr id="495" name="rc3">
              <a:extLst>
                <a:ext uri="{FF2B5EF4-FFF2-40B4-BE49-F238E27FC236}">
                  <a16:creationId xmlns:a16="http://schemas.microsoft.com/office/drawing/2014/main" id="{EBE734CD-1C78-4807-E4DA-B3A1BC776390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96" name="rc4">
              <a:extLst>
                <a:ext uri="{FF2B5EF4-FFF2-40B4-BE49-F238E27FC236}">
                  <a16:creationId xmlns:a16="http://schemas.microsoft.com/office/drawing/2014/main" id="{2CB84440-C828-23F1-5DBA-FB64CF60B925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97" name="rc5">
              <a:extLst>
                <a:ext uri="{FF2B5EF4-FFF2-40B4-BE49-F238E27FC236}">
                  <a16:creationId xmlns:a16="http://schemas.microsoft.com/office/drawing/2014/main" id="{8BFC2D1E-FCF6-A051-A4BC-A43A4115B701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98" name="rc6">
              <a:extLst>
                <a:ext uri="{FF2B5EF4-FFF2-40B4-BE49-F238E27FC236}">
                  <a16:creationId xmlns:a16="http://schemas.microsoft.com/office/drawing/2014/main" id="{9DBBABA3-C898-88F5-4101-FB0A75C2436B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99" name="rc7">
              <a:extLst>
                <a:ext uri="{FF2B5EF4-FFF2-40B4-BE49-F238E27FC236}">
                  <a16:creationId xmlns:a16="http://schemas.microsoft.com/office/drawing/2014/main" id="{09FC7E80-740B-FF77-61CB-4210962BEE96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00" name="rc8">
              <a:extLst>
                <a:ext uri="{FF2B5EF4-FFF2-40B4-BE49-F238E27FC236}">
                  <a16:creationId xmlns:a16="http://schemas.microsoft.com/office/drawing/2014/main" id="{C0ED0B77-297B-A7CE-3CF8-397A1F1B772E}"/>
                </a:ext>
              </a:extLst>
            </p:cNvPr>
            <p:cNvSpPr/>
            <p:nvPr/>
          </p:nvSpPr>
          <p:spPr>
            <a:xfrm>
              <a:off x="69588" y="69589"/>
              <a:ext cx="9004820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01" name="pl18">
              <a:extLst>
                <a:ext uri="{FF2B5EF4-FFF2-40B4-BE49-F238E27FC236}">
                  <a16:creationId xmlns:a16="http://schemas.microsoft.com/office/drawing/2014/main" id="{C724E964-8ECA-EFC2-7D7A-10C1B168FB33}"/>
                </a:ext>
              </a:extLst>
            </p:cNvPr>
            <p:cNvSpPr/>
            <p:nvPr/>
          </p:nvSpPr>
          <p:spPr>
            <a:xfrm>
              <a:off x="776476" y="3534137"/>
              <a:ext cx="8228345" cy="0"/>
            </a:xfrm>
            <a:custGeom>
              <a:avLst/>
              <a:gdLst/>
              <a:ahLst/>
              <a:cxnLst/>
              <a:rect l="0" t="0" r="0" b="0"/>
              <a:pathLst>
                <a:path w="8228345">
                  <a:moveTo>
                    <a:pt x="0" y="0"/>
                  </a:moveTo>
                  <a:lnTo>
                    <a:pt x="8228345" y="0"/>
                  </a:lnTo>
                  <a:lnTo>
                    <a:pt x="8228345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02" name="pl27">
              <a:extLst>
                <a:ext uri="{FF2B5EF4-FFF2-40B4-BE49-F238E27FC236}">
                  <a16:creationId xmlns:a16="http://schemas.microsoft.com/office/drawing/2014/main" id="{65D01EF0-2039-1397-5C30-59A66E22FB17}"/>
                </a:ext>
              </a:extLst>
            </p:cNvPr>
            <p:cNvSpPr/>
            <p:nvPr/>
          </p:nvSpPr>
          <p:spPr>
            <a:xfrm>
              <a:off x="1150492" y="1513328"/>
              <a:ext cx="4354977" cy="2020809"/>
            </a:xfrm>
            <a:custGeom>
              <a:avLst/>
              <a:gdLst/>
              <a:ahLst/>
              <a:cxnLst/>
              <a:rect l="0" t="0" r="0" b="0"/>
              <a:pathLst>
                <a:path w="4354977" h="2020809">
                  <a:moveTo>
                    <a:pt x="0" y="2020809"/>
                  </a:moveTo>
                  <a:lnTo>
                    <a:pt x="51235" y="2020809"/>
                  </a:lnTo>
                  <a:lnTo>
                    <a:pt x="51235" y="1616647"/>
                  </a:lnTo>
                  <a:lnTo>
                    <a:pt x="61482" y="1616647"/>
                  </a:lnTo>
                  <a:lnTo>
                    <a:pt x="61482" y="1616647"/>
                  </a:lnTo>
                  <a:lnTo>
                    <a:pt x="184446" y="1616647"/>
                  </a:lnTo>
                  <a:lnTo>
                    <a:pt x="184446" y="1616647"/>
                  </a:lnTo>
                  <a:lnTo>
                    <a:pt x="2100636" y="1616647"/>
                  </a:lnTo>
                  <a:lnTo>
                    <a:pt x="2100636" y="1212485"/>
                  </a:lnTo>
                  <a:lnTo>
                    <a:pt x="3340523" y="1212485"/>
                  </a:lnTo>
                  <a:lnTo>
                    <a:pt x="3340523" y="808323"/>
                  </a:lnTo>
                  <a:lnTo>
                    <a:pt x="3863120" y="808323"/>
                  </a:lnTo>
                  <a:lnTo>
                    <a:pt x="3863120" y="808323"/>
                  </a:lnTo>
                  <a:lnTo>
                    <a:pt x="4027073" y="808323"/>
                  </a:lnTo>
                  <a:lnTo>
                    <a:pt x="4027073" y="808323"/>
                  </a:lnTo>
                  <a:lnTo>
                    <a:pt x="4354977" y="808323"/>
                  </a:lnTo>
                  <a:lnTo>
                    <a:pt x="4354977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03" name="pl28">
              <a:extLst>
                <a:ext uri="{FF2B5EF4-FFF2-40B4-BE49-F238E27FC236}">
                  <a16:creationId xmlns:a16="http://schemas.microsoft.com/office/drawing/2014/main" id="{3FC1DB03-38D3-8544-3767-E22EC9B03662}"/>
                </a:ext>
              </a:extLst>
            </p:cNvPr>
            <p:cNvSpPr/>
            <p:nvPr/>
          </p:nvSpPr>
          <p:spPr>
            <a:xfrm>
              <a:off x="1150492" y="2946265"/>
              <a:ext cx="7008951" cy="587871"/>
            </a:xfrm>
            <a:custGeom>
              <a:avLst/>
              <a:gdLst/>
              <a:ahLst/>
              <a:cxnLst/>
              <a:rect l="0" t="0" r="0" b="0"/>
              <a:pathLst>
                <a:path w="7008951" h="587871">
                  <a:moveTo>
                    <a:pt x="0" y="587871"/>
                  </a:moveTo>
                  <a:lnTo>
                    <a:pt x="61482" y="587871"/>
                  </a:lnTo>
                  <a:lnTo>
                    <a:pt x="61482" y="587871"/>
                  </a:lnTo>
                  <a:lnTo>
                    <a:pt x="71729" y="587871"/>
                  </a:lnTo>
                  <a:lnTo>
                    <a:pt x="71729" y="587871"/>
                  </a:lnTo>
                  <a:lnTo>
                    <a:pt x="112717" y="587871"/>
                  </a:lnTo>
                  <a:lnTo>
                    <a:pt x="112717" y="587871"/>
                  </a:lnTo>
                  <a:lnTo>
                    <a:pt x="266422" y="587871"/>
                  </a:lnTo>
                  <a:lnTo>
                    <a:pt x="266422" y="440903"/>
                  </a:lnTo>
                  <a:lnTo>
                    <a:pt x="286916" y="440903"/>
                  </a:lnTo>
                  <a:lnTo>
                    <a:pt x="286916" y="440903"/>
                  </a:lnTo>
                  <a:lnTo>
                    <a:pt x="430374" y="440903"/>
                  </a:lnTo>
                  <a:lnTo>
                    <a:pt x="430374" y="440903"/>
                  </a:lnTo>
                  <a:lnTo>
                    <a:pt x="522597" y="440903"/>
                  </a:lnTo>
                  <a:lnTo>
                    <a:pt x="522597" y="440903"/>
                  </a:lnTo>
                  <a:lnTo>
                    <a:pt x="840254" y="440903"/>
                  </a:lnTo>
                  <a:lnTo>
                    <a:pt x="840254" y="293935"/>
                  </a:lnTo>
                  <a:lnTo>
                    <a:pt x="942724" y="293935"/>
                  </a:lnTo>
                  <a:lnTo>
                    <a:pt x="942724" y="293935"/>
                  </a:lnTo>
                  <a:lnTo>
                    <a:pt x="1014453" y="293935"/>
                  </a:lnTo>
                  <a:lnTo>
                    <a:pt x="1014453" y="293935"/>
                  </a:lnTo>
                  <a:lnTo>
                    <a:pt x="1198899" y="293935"/>
                  </a:lnTo>
                  <a:lnTo>
                    <a:pt x="1198899" y="293935"/>
                  </a:lnTo>
                  <a:lnTo>
                    <a:pt x="1485815" y="293935"/>
                  </a:lnTo>
                  <a:lnTo>
                    <a:pt x="1485815" y="293935"/>
                  </a:lnTo>
                  <a:lnTo>
                    <a:pt x="1649767" y="293935"/>
                  </a:lnTo>
                  <a:lnTo>
                    <a:pt x="1649767" y="146967"/>
                  </a:lnTo>
                  <a:lnTo>
                    <a:pt x="1731743" y="146967"/>
                  </a:lnTo>
                  <a:lnTo>
                    <a:pt x="1731743" y="146967"/>
                  </a:lnTo>
                  <a:lnTo>
                    <a:pt x="1741990" y="146967"/>
                  </a:lnTo>
                  <a:lnTo>
                    <a:pt x="1741990" y="146967"/>
                  </a:lnTo>
                  <a:lnTo>
                    <a:pt x="2121130" y="146967"/>
                  </a:lnTo>
                  <a:lnTo>
                    <a:pt x="2121130" y="146967"/>
                  </a:lnTo>
                  <a:lnTo>
                    <a:pt x="2285082" y="146967"/>
                  </a:lnTo>
                  <a:lnTo>
                    <a:pt x="2285082" y="146967"/>
                  </a:lnTo>
                  <a:lnTo>
                    <a:pt x="2787185" y="146967"/>
                  </a:lnTo>
                  <a:lnTo>
                    <a:pt x="2787185" y="0"/>
                  </a:lnTo>
                  <a:lnTo>
                    <a:pt x="3217559" y="0"/>
                  </a:lnTo>
                  <a:lnTo>
                    <a:pt x="3217559" y="0"/>
                  </a:lnTo>
                  <a:lnTo>
                    <a:pt x="3279041" y="0"/>
                  </a:lnTo>
                  <a:lnTo>
                    <a:pt x="3279041" y="0"/>
                  </a:lnTo>
                  <a:lnTo>
                    <a:pt x="7008951" y="0"/>
                  </a:lnTo>
                  <a:lnTo>
                    <a:pt x="7008951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04" name="rc29">
              <a:extLst>
                <a:ext uri="{FF2B5EF4-FFF2-40B4-BE49-F238E27FC236}">
                  <a16:creationId xmlns:a16="http://schemas.microsoft.com/office/drawing/2014/main" id="{BE123888-1A6F-96B0-C35C-CF1C5C18C491}"/>
                </a:ext>
              </a:extLst>
            </p:cNvPr>
            <p:cNvSpPr/>
            <p:nvPr/>
          </p:nvSpPr>
          <p:spPr>
            <a:xfrm>
              <a:off x="776478" y="139178"/>
              <a:ext cx="7849778" cy="3554233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05" name="tx30">
              <a:extLst>
                <a:ext uri="{FF2B5EF4-FFF2-40B4-BE49-F238E27FC236}">
                  <a16:creationId xmlns:a16="http://schemas.microsoft.com/office/drawing/2014/main" id="{462350A4-6E17-50D2-58A8-12D157D09B66}"/>
                </a:ext>
              </a:extLst>
            </p:cNvPr>
            <p:cNvSpPr/>
            <p:nvPr/>
          </p:nvSpPr>
          <p:spPr>
            <a:xfrm>
              <a:off x="466667" y="3486760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506" name="tx31">
              <a:extLst>
                <a:ext uri="{FF2B5EF4-FFF2-40B4-BE49-F238E27FC236}">
                  <a16:creationId xmlns:a16="http://schemas.microsoft.com/office/drawing/2014/main" id="{338C4580-5C4B-0336-7F14-359523F870E2}"/>
                </a:ext>
              </a:extLst>
            </p:cNvPr>
            <p:cNvSpPr/>
            <p:nvPr/>
          </p:nvSpPr>
          <p:spPr>
            <a:xfrm>
              <a:off x="466667" y="2678436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507" name="tx32">
              <a:extLst>
                <a:ext uri="{FF2B5EF4-FFF2-40B4-BE49-F238E27FC236}">
                  <a16:creationId xmlns:a16="http://schemas.microsoft.com/office/drawing/2014/main" id="{FE4F2926-4F36-A887-C656-6F36AA446B74}"/>
                </a:ext>
              </a:extLst>
            </p:cNvPr>
            <p:cNvSpPr/>
            <p:nvPr/>
          </p:nvSpPr>
          <p:spPr>
            <a:xfrm>
              <a:off x="466667" y="1870113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 dirty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508" name="tx33">
              <a:extLst>
                <a:ext uri="{FF2B5EF4-FFF2-40B4-BE49-F238E27FC236}">
                  <a16:creationId xmlns:a16="http://schemas.microsoft.com/office/drawing/2014/main" id="{91A9CC78-A2DF-64F2-2039-3277153F5030}"/>
                </a:ext>
              </a:extLst>
            </p:cNvPr>
            <p:cNvSpPr/>
            <p:nvPr/>
          </p:nvSpPr>
          <p:spPr>
            <a:xfrm>
              <a:off x="466667" y="1061789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509" name="tx34">
              <a:extLst>
                <a:ext uri="{FF2B5EF4-FFF2-40B4-BE49-F238E27FC236}">
                  <a16:creationId xmlns:a16="http://schemas.microsoft.com/office/drawing/2014/main" id="{F0E8AA4B-2535-1FF4-4381-4D49641D802D}"/>
                </a:ext>
              </a:extLst>
            </p:cNvPr>
            <p:cNvSpPr/>
            <p:nvPr/>
          </p:nvSpPr>
          <p:spPr>
            <a:xfrm>
              <a:off x="466667" y="253465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0</a:t>
              </a:r>
            </a:p>
          </p:txBody>
        </p:sp>
        <p:sp>
          <p:nvSpPr>
            <p:cNvPr id="510" name="pl35">
              <a:extLst>
                <a:ext uri="{FF2B5EF4-FFF2-40B4-BE49-F238E27FC236}">
                  <a16:creationId xmlns:a16="http://schemas.microsoft.com/office/drawing/2014/main" id="{92821680-CE20-525A-101A-468ABB7C2DE6}"/>
                </a:ext>
              </a:extLst>
            </p:cNvPr>
            <p:cNvSpPr/>
            <p:nvPr/>
          </p:nvSpPr>
          <p:spPr>
            <a:xfrm>
              <a:off x="741682" y="353413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11" name="pl36">
              <a:extLst>
                <a:ext uri="{FF2B5EF4-FFF2-40B4-BE49-F238E27FC236}">
                  <a16:creationId xmlns:a16="http://schemas.microsoft.com/office/drawing/2014/main" id="{A7B14CB2-8C7B-A382-9029-53550473169F}"/>
                </a:ext>
              </a:extLst>
            </p:cNvPr>
            <p:cNvSpPr/>
            <p:nvPr/>
          </p:nvSpPr>
          <p:spPr>
            <a:xfrm>
              <a:off x="741682" y="2725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12" name="pl37">
              <a:extLst>
                <a:ext uri="{FF2B5EF4-FFF2-40B4-BE49-F238E27FC236}">
                  <a16:creationId xmlns:a16="http://schemas.microsoft.com/office/drawing/2014/main" id="{F8E7EF18-9AAE-BA73-5405-C5F81C12A9BF}"/>
                </a:ext>
              </a:extLst>
            </p:cNvPr>
            <p:cNvSpPr/>
            <p:nvPr/>
          </p:nvSpPr>
          <p:spPr>
            <a:xfrm>
              <a:off x="741682" y="19174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13" name="pl38">
              <a:extLst>
                <a:ext uri="{FF2B5EF4-FFF2-40B4-BE49-F238E27FC236}">
                  <a16:creationId xmlns:a16="http://schemas.microsoft.com/office/drawing/2014/main" id="{FEF54920-EB83-3010-CED6-564354EA6EA7}"/>
                </a:ext>
              </a:extLst>
            </p:cNvPr>
            <p:cNvSpPr/>
            <p:nvPr/>
          </p:nvSpPr>
          <p:spPr>
            <a:xfrm>
              <a:off x="741682" y="11091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14" name="pl39">
              <a:extLst>
                <a:ext uri="{FF2B5EF4-FFF2-40B4-BE49-F238E27FC236}">
                  <a16:creationId xmlns:a16="http://schemas.microsoft.com/office/drawing/2014/main" id="{05DA82E8-1DD9-C9AF-34B4-F27FD4EE783A}"/>
                </a:ext>
              </a:extLst>
            </p:cNvPr>
            <p:cNvSpPr/>
            <p:nvPr/>
          </p:nvSpPr>
          <p:spPr>
            <a:xfrm>
              <a:off x="741682" y="3008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15" name="pl40">
              <a:extLst>
                <a:ext uri="{FF2B5EF4-FFF2-40B4-BE49-F238E27FC236}">
                  <a16:creationId xmlns:a16="http://schemas.microsoft.com/office/drawing/2014/main" id="{9569D2FC-231B-3A74-4E10-4DBB75C992EF}"/>
                </a:ext>
              </a:extLst>
            </p:cNvPr>
            <p:cNvSpPr/>
            <p:nvPr/>
          </p:nvSpPr>
          <p:spPr>
            <a:xfrm>
              <a:off x="1150492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16" name="pl41">
              <a:extLst>
                <a:ext uri="{FF2B5EF4-FFF2-40B4-BE49-F238E27FC236}">
                  <a16:creationId xmlns:a16="http://schemas.microsoft.com/office/drawing/2014/main" id="{42310175-C783-E726-346F-C50376B87954}"/>
                </a:ext>
              </a:extLst>
            </p:cNvPr>
            <p:cNvSpPr/>
            <p:nvPr/>
          </p:nvSpPr>
          <p:spPr>
            <a:xfrm>
              <a:off x="3199893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17" name="pl42">
              <a:extLst>
                <a:ext uri="{FF2B5EF4-FFF2-40B4-BE49-F238E27FC236}">
                  <a16:creationId xmlns:a16="http://schemas.microsoft.com/office/drawing/2014/main" id="{10CA6C22-095B-4B80-3A71-ADB900DD02DC}"/>
                </a:ext>
              </a:extLst>
            </p:cNvPr>
            <p:cNvSpPr/>
            <p:nvPr/>
          </p:nvSpPr>
          <p:spPr>
            <a:xfrm>
              <a:off x="5249294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18" name="pl43">
              <a:extLst>
                <a:ext uri="{FF2B5EF4-FFF2-40B4-BE49-F238E27FC236}">
                  <a16:creationId xmlns:a16="http://schemas.microsoft.com/office/drawing/2014/main" id="{CC1FC947-B4C1-73F5-81BF-3B6E30C2969F}"/>
                </a:ext>
              </a:extLst>
            </p:cNvPr>
            <p:cNvSpPr/>
            <p:nvPr/>
          </p:nvSpPr>
          <p:spPr>
            <a:xfrm>
              <a:off x="7298695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19" name="tx44">
              <a:extLst>
                <a:ext uri="{FF2B5EF4-FFF2-40B4-BE49-F238E27FC236}">
                  <a16:creationId xmlns:a16="http://schemas.microsoft.com/office/drawing/2014/main" id="{1ACCA3CF-2D85-5B77-385B-3E0D064FE0B7}"/>
                </a:ext>
              </a:extLst>
            </p:cNvPr>
            <p:cNvSpPr/>
            <p:nvPr/>
          </p:nvSpPr>
          <p:spPr>
            <a:xfrm>
              <a:off x="1115176" y="3756509"/>
              <a:ext cx="70631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520" name="tx45">
              <a:extLst>
                <a:ext uri="{FF2B5EF4-FFF2-40B4-BE49-F238E27FC236}">
                  <a16:creationId xmlns:a16="http://schemas.microsoft.com/office/drawing/2014/main" id="{D54CA224-B843-AE0B-7000-FD07B3BEC18C}"/>
                </a:ext>
              </a:extLst>
            </p:cNvPr>
            <p:cNvSpPr/>
            <p:nvPr/>
          </p:nvSpPr>
          <p:spPr>
            <a:xfrm>
              <a:off x="3093946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521" name="tx46">
              <a:extLst>
                <a:ext uri="{FF2B5EF4-FFF2-40B4-BE49-F238E27FC236}">
                  <a16:creationId xmlns:a16="http://schemas.microsoft.com/office/drawing/2014/main" id="{4148B8C7-3FFF-3611-4561-3AB231B02E8E}"/>
                </a:ext>
              </a:extLst>
            </p:cNvPr>
            <p:cNvSpPr/>
            <p:nvPr/>
          </p:nvSpPr>
          <p:spPr>
            <a:xfrm>
              <a:off x="5143347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522" name="tx47">
              <a:extLst>
                <a:ext uri="{FF2B5EF4-FFF2-40B4-BE49-F238E27FC236}">
                  <a16:creationId xmlns:a16="http://schemas.microsoft.com/office/drawing/2014/main" id="{E61C73E8-5601-D34E-56BC-7A0097C786AE}"/>
                </a:ext>
              </a:extLst>
            </p:cNvPr>
            <p:cNvSpPr/>
            <p:nvPr/>
          </p:nvSpPr>
          <p:spPr>
            <a:xfrm>
              <a:off x="7192748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523" name="tx48">
              <a:extLst>
                <a:ext uri="{FF2B5EF4-FFF2-40B4-BE49-F238E27FC236}">
                  <a16:creationId xmlns:a16="http://schemas.microsoft.com/office/drawing/2014/main" id="{4C1E0250-8B69-FF33-DD29-4BE05B8CB791}"/>
                </a:ext>
              </a:extLst>
            </p:cNvPr>
            <p:cNvSpPr/>
            <p:nvPr/>
          </p:nvSpPr>
          <p:spPr>
            <a:xfrm>
              <a:off x="4081991" y="3878778"/>
              <a:ext cx="1617315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 to mortality (Days)</a:t>
              </a:r>
            </a:p>
          </p:txBody>
        </p:sp>
        <p:sp>
          <p:nvSpPr>
            <p:cNvPr id="524" name="rc50">
              <a:extLst>
                <a:ext uri="{FF2B5EF4-FFF2-40B4-BE49-F238E27FC236}">
                  <a16:creationId xmlns:a16="http://schemas.microsoft.com/office/drawing/2014/main" id="{4ED24382-FF13-FFA8-6507-AD9D9E1DA3B6}"/>
                </a:ext>
              </a:extLst>
            </p:cNvPr>
            <p:cNvSpPr/>
            <p:nvPr/>
          </p:nvSpPr>
          <p:spPr>
            <a:xfrm>
              <a:off x="4276688" y="4189554"/>
              <a:ext cx="1227921" cy="358634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525" name="rc51">
              <a:extLst>
                <a:ext uri="{FF2B5EF4-FFF2-40B4-BE49-F238E27FC236}">
                  <a16:creationId xmlns:a16="http://schemas.microsoft.com/office/drawing/2014/main" id="{23CEC824-54D5-F168-D3A8-C8876CFDC3D1}"/>
                </a:ext>
              </a:extLst>
            </p:cNvPr>
            <p:cNvSpPr/>
            <p:nvPr/>
          </p:nvSpPr>
          <p:spPr>
            <a:xfrm>
              <a:off x="4415866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526" name="pl52">
              <a:extLst>
                <a:ext uri="{FF2B5EF4-FFF2-40B4-BE49-F238E27FC236}">
                  <a16:creationId xmlns:a16="http://schemas.microsoft.com/office/drawing/2014/main" id="{1CBD43D4-8C28-170E-635C-DBD36E9C0E77}"/>
                </a:ext>
              </a:extLst>
            </p:cNvPr>
            <p:cNvSpPr/>
            <p:nvPr/>
          </p:nvSpPr>
          <p:spPr>
            <a:xfrm>
              <a:off x="4437812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27" name="rc53">
              <a:extLst>
                <a:ext uri="{FF2B5EF4-FFF2-40B4-BE49-F238E27FC236}">
                  <a16:creationId xmlns:a16="http://schemas.microsoft.com/office/drawing/2014/main" id="{96DAF51A-48B1-F110-A88E-4F3E17BFCF53}"/>
                </a:ext>
              </a:extLst>
            </p:cNvPr>
            <p:cNvSpPr/>
            <p:nvPr/>
          </p:nvSpPr>
          <p:spPr>
            <a:xfrm>
              <a:off x="4926900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528" name="pl54">
              <a:extLst>
                <a:ext uri="{FF2B5EF4-FFF2-40B4-BE49-F238E27FC236}">
                  <a16:creationId xmlns:a16="http://schemas.microsoft.com/office/drawing/2014/main" id="{F5438BCC-ECD6-F040-6930-BBE467D82B26}"/>
                </a:ext>
              </a:extLst>
            </p:cNvPr>
            <p:cNvSpPr/>
            <p:nvPr/>
          </p:nvSpPr>
          <p:spPr>
            <a:xfrm>
              <a:off x="4948846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29" name="tx55">
              <a:extLst>
                <a:ext uri="{FF2B5EF4-FFF2-40B4-BE49-F238E27FC236}">
                  <a16:creationId xmlns:a16="http://schemas.microsoft.com/office/drawing/2014/main" id="{9E846AC4-88E4-7A5F-82BD-6B721E6C0C9D}"/>
                </a:ext>
              </a:extLst>
            </p:cNvPr>
            <p:cNvSpPr/>
            <p:nvPr/>
          </p:nvSpPr>
          <p:spPr>
            <a:xfrm>
              <a:off x="4704911" y="4321929"/>
              <a:ext cx="162346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530" name="tx56">
              <a:extLst>
                <a:ext uri="{FF2B5EF4-FFF2-40B4-BE49-F238E27FC236}">
                  <a16:creationId xmlns:a16="http://schemas.microsoft.com/office/drawing/2014/main" id="{87B987A2-D2B7-13C4-0940-2E7ACEAC75D6}"/>
                </a:ext>
              </a:extLst>
            </p:cNvPr>
            <p:cNvSpPr/>
            <p:nvPr/>
          </p:nvSpPr>
          <p:spPr>
            <a:xfrm>
              <a:off x="5215945" y="4321929"/>
              <a:ext cx="218839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  <p:sp>
          <p:nvSpPr>
            <p:cNvPr id="531" name="rc57">
              <a:extLst>
                <a:ext uri="{FF2B5EF4-FFF2-40B4-BE49-F238E27FC236}">
                  <a16:creationId xmlns:a16="http://schemas.microsoft.com/office/drawing/2014/main" id="{70B97604-5D2F-B3C1-B478-C01CDC6C6462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32" name="rc58">
              <a:extLst>
                <a:ext uri="{FF2B5EF4-FFF2-40B4-BE49-F238E27FC236}">
                  <a16:creationId xmlns:a16="http://schemas.microsoft.com/office/drawing/2014/main" id="{AB98FD88-B2FD-ABB8-DEA9-FF22A3CCD546}"/>
                </a:ext>
              </a:extLst>
            </p:cNvPr>
            <p:cNvSpPr/>
            <p:nvPr/>
          </p:nvSpPr>
          <p:spPr>
            <a:xfrm>
              <a:off x="776476" y="4996549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533" name="tx59">
              <a:extLst>
                <a:ext uri="{FF2B5EF4-FFF2-40B4-BE49-F238E27FC236}">
                  <a16:creationId xmlns:a16="http://schemas.microsoft.com/office/drawing/2014/main" id="{CAFBB4A2-835C-5911-48AE-DF8150E3C0AE}"/>
                </a:ext>
              </a:extLst>
            </p:cNvPr>
            <p:cNvSpPr/>
            <p:nvPr/>
          </p:nvSpPr>
          <p:spPr>
            <a:xfrm>
              <a:off x="1115323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534" name="tx60">
              <a:extLst>
                <a:ext uri="{FF2B5EF4-FFF2-40B4-BE49-F238E27FC236}">
                  <a16:creationId xmlns:a16="http://schemas.microsoft.com/office/drawing/2014/main" id="{44E931DD-135D-CEFC-EC5E-B423E643244E}"/>
                </a:ext>
              </a:extLst>
            </p:cNvPr>
            <p:cNvSpPr/>
            <p:nvPr/>
          </p:nvSpPr>
          <p:spPr>
            <a:xfrm>
              <a:off x="1115323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535" name="tx61">
              <a:extLst>
                <a:ext uri="{FF2B5EF4-FFF2-40B4-BE49-F238E27FC236}">
                  <a16:creationId xmlns:a16="http://schemas.microsoft.com/office/drawing/2014/main" id="{E794D660-2314-22BE-1B0C-9E0DBB2BCB91}"/>
                </a:ext>
              </a:extLst>
            </p:cNvPr>
            <p:cNvSpPr/>
            <p:nvPr/>
          </p:nvSpPr>
          <p:spPr>
            <a:xfrm>
              <a:off x="3164724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536" name="tx62">
              <a:extLst>
                <a:ext uri="{FF2B5EF4-FFF2-40B4-BE49-F238E27FC236}">
                  <a16:creationId xmlns:a16="http://schemas.microsoft.com/office/drawing/2014/main" id="{C6B5FA2C-13F4-E4EE-EC17-BDCAA1DA24BA}"/>
                </a:ext>
              </a:extLst>
            </p:cNvPr>
            <p:cNvSpPr/>
            <p:nvPr/>
          </p:nvSpPr>
          <p:spPr>
            <a:xfrm>
              <a:off x="3164724" y="5134179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537" name="tx63">
              <a:extLst>
                <a:ext uri="{FF2B5EF4-FFF2-40B4-BE49-F238E27FC236}">
                  <a16:creationId xmlns:a16="http://schemas.microsoft.com/office/drawing/2014/main" id="{DBCF18FC-8229-F97F-7275-F77F26657697}"/>
                </a:ext>
              </a:extLst>
            </p:cNvPr>
            <p:cNvSpPr/>
            <p:nvPr/>
          </p:nvSpPr>
          <p:spPr>
            <a:xfrm>
              <a:off x="5214125" y="5437853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538" name="tx64">
              <a:extLst>
                <a:ext uri="{FF2B5EF4-FFF2-40B4-BE49-F238E27FC236}">
                  <a16:creationId xmlns:a16="http://schemas.microsoft.com/office/drawing/2014/main" id="{477E4315-BFA1-EAA4-6A92-0CD85E9A4C67}"/>
                </a:ext>
              </a:extLst>
            </p:cNvPr>
            <p:cNvSpPr/>
            <p:nvPr/>
          </p:nvSpPr>
          <p:spPr>
            <a:xfrm>
              <a:off x="5214125" y="5134117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539" name="tx65">
              <a:extLst>
                <a:ext uri="{FF2B5EF4-FFF2-40B4-BE49-F238E27FC236}">
                  <a16:creationId xmlns:a16="http://schemas.microsoft.com/office/drawing/2014/main" id="{D19CF2FA-8FFD-58FD-B9E5-D70FC1BB64DA}"/>
                </a:ext>
              </a:extLst>
            </p:cNvPr>
            <p:cNvSpPr/>
            <p:nvPr/>
          </p:nvSpPr>
          <p:spPr>
            <a:xfrm>
              <a:off x="7263526" y="5439829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540" name="tx66">
              <a:extLst>
                <a:ext uri="{FF2B5EF4-FFF2-40B4-BE49-F238E27FC236}">
                  <a16:creationId xmlns:a16="http://schemas.microsoft.com/office/drawing/2014/main" id="{35ECD6AB-16F0-B996-2235-09B641E257C5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541" name="tx67">
              <a:extLst>
                <a:ext uri="{FF2B5EF4-FFF2-40B4-BE49-F238E27FC236}">
                  <a16:creationId xmlns:a16="http://schemas.microsoft.com/office/drawing/2014/main" id="{1C337C93-68C8-2D97-5CA7-FACE59BD4EAD}"/>
                </a:ext>
              </a:extLst>
            </p:cNvPr>
            <p:cNvSpPr/>
            <p:nvPr/>
          </p:nvSpPr>
          <p:spPr>
            <a:xfrm>
              <a:off x="7263526" y="5439829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542" name="tx68">
              <a:extLst>
                <a:ext uri="{FF2B5EF4-FFF2-40B4-BE49-F238E27FC236}">
                  <a16:creationId xmlns:a16="http://schemas.microsoft.com/office/drawing/2014/main" id="{EA798FCE-D209-C9D2-48FC-EE3E80F24DC1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543" name="tx69">
              <a:extLst>
                <a:ext uri="{FF2B5EF4-FFF2-40B4-BE49-F238E27FC236}">
                  <a16:creationId xmlns:a16="http://schemas.microsoft.com/office/drawing/2014/main" id="{DCED72BB-D7F8-9C45-5B5E-87C08FA3F637}"/>
                </a:ext>
              </a:extLst>
            </p:cNvPr>
            <p:cNvSpPr/>
            <p:nvPr/>
          </p:nvSpPr>
          <p:spPr>
            <a:xfrm>
              <a:off x="325591" y="5438152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544" name="tx70">
              <a:extLst>
                <a:ext uri="{FF2B5EF4-FFF2-40B4-BE49-F238E27FC236}">
                  <a16:creationId xmlns:a16="http://schemas.microsoft.com/office/drawing/2014/main" id="{23511FB6-D415-C516-5989-484BB5D14EDA}"/>
                </a:ext>
              </a:extLst>
            </p:cNvPr>
            <p:cNvSpPr/>
            <p:nvPr/>
          </p:nvSpPr>
          <p:spPr>
            <a:xfrm>
              <a:off x="311638" y="5132811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545" name="tx71">
              <a:extLst>
                <a:ext uri="{FF2B5EF4-FFF2-40B4-BE49-F238E27FC236}">
                  <a16:creationId xmlns:a16="http://schemas.microsoft.com/office/drawing/2014/main" id="{5D1B026B-7684-6820-F4D0-5D8ED28C61C7}"/>
                </a:ext>
              </a:extLst>
            </p:cNvPr>
            <p:cNvSpPr/>
            <p:nvPr/>
          </p:nvSpPr>
          <p:spPr>
            <a:xfrm>
              <a:off x="776476" y="4827633"/>
              <a:ext cx="17452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546" name="rc72">
              <a:extLst>
                <a:ext uri="{FF2B5EF4-FFF2-40B4-BE49-F238E27FC236}">
                  <a16:creationId xmlns:a16="http://schemas.microsoft.com/office/drawing/2014/main" id="{8E5999AB-C528-8F56-53F2-6580ACA9C309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47" name="rc73">
              <a:extLst>
                <a:ext uri="{FF2B5EF4-FFF2-40B4-BE49-F238E27FC236}">
                  <a16:creationId xmlns:a16="http://schemas.microsoft.com/office/drawing/2014/main" id="{464A6AE7-5371-8FDF-68A0-53C12AFC2CA4}"/>
                </a:ext>
              </a:extLst>
            </p:cNvPr>
            <p:cNvSpPr/>
            <p:nvPr/>
          </p:nvSpPr>
          <p:spPr>
            <a:xfrm>
              <a:off x="776476" y="6081865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548" name="tx74">
              <a:extLst>
                <a:ext uri="{FF2B5EF4-FFF2-40B4-BE49-F238E27FC236}">
                  <a16:creationId xmlns:a16="http://schemas.microsoft.com/office/drawing/2014/main" id="{2B58CF62-C3B5-9366-4DC9-D4E40E16DE43}"/>
                </a:ext>
              </a:extLst>
            </p:cNvPr>
            <p:cNvSpPr/>
            <p:nvPr/>
          </p:nvSpPr>
          <p:spPr>
            <a:xfrm>
              <a:off x="1115323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549" name="tx75">
              <a:extLst>
                <a:ext uri="{FF2B5EF4-FFF2-40B4-BE49-F238E27FC236}">
                  <a16:creationId xmlns:a16="http://schemas.microsoft.com/office/drawing/2014/main" id="{8E5D7557-B2D4-5BA4-5DCD-F7FEE335AA53}"/>
                </a:ext>
              </a:extLst>
            </p:cNvPr>
            <p:cNvSpPr/>
            <p:nvPr/>
          </p:nvSpPr>
          <p:spPr>
            <a:xfrm>
              <a:off x="1080154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2</a:t>
              </a:r>
            </a:p>
          </p:txBody>
        </p:sp>
        <p:sp>
          <p:nvSpPr>
            <p:cNvPr id="550" name="tx76">
              <a:extLst>
                <a:ext uri="{FF2B5EF4-FFF2-40B4-BE49-F238E27FC236}">
                  <a16:creationId xmlns:a16="http://schemas.microsoft.com/office/drawing/2014/main" id="{BFD4F886-C09E-622A-FF03-67EC03438C77}"/>
                </a:ext>
              </a:extLst>
            </p:cNvPr>
            <p:cNvSpPr/>
            <p:nvPr/>
          </p:nvSpPr>
          <p:spPr>
            <a:xfrm>
              <a:off x="3164724" y="6523169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551" name="tx77">
              <a:extLst>
                <a:ext uri="{FF2B5EF4-FFF2-40B4-BE49-F238E27FC236}">
                  <a16:creationId xmlns:a16="http://schemas.microsoft.com/office/drawing/2014/main" id="{2FB98C90-4D5E-9A05-14D7-3D7B28C8CF7C}"/>
                </a:ext>
              </a:extLst>
            </p:cNvPr>
            <p:cNvSpPr/>
            <p:nvPr/>
          </p:nvSpPr>
          <p:spPr>
            <a:xfrm>
              <a:off x="3164724" y="6220978"/>
              <a:ext cx="70337" cy="8935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</a:t>
              </a:r>
            </a:p>
          </p:txBody>
        </p:sp>
        <p:sp>
          <p:nvSpPr>
            <p:cNvPr id="552" name="tx78">
              <a:extLst>
                <a:ext uri="{FF2B5EF4-FFF2-40B4-BE49-F238E27FC236}">
                  <a16:creationId xmlns:a16="http://schemas.microsoft.com/office/drawing/2014/main" id="{12122596-FE8A-B29D-31C7-DF3EF4292A6C}"/>
                </a:ext>
              </a:extLst>
            </p:cNvPr>
            <p:cNvSpPr/>
            <p:nvPr/>
          </p:nvSpPr>
          <p:spPr>
            <a:xfrm>
              <a:off x="5214125" y="6525145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553" name="tx79">
              <a:extLst>
                <a:ext uri="{FF2B5EF4-FFF2-40B4-BE49-F238E27FC236}">
                  <a16:creationId xmlns:a16="http://schemas.microsoft.com/office/drawing/2014/main" id="{D8779467-1C1F-2A8A-C47F-C709888AFE70}"/>
                </a:ext>
              </a:extLst>
            </p:cNvPr>
            <p:cNvSpPr/>
            <p:nvPr/>
          </p:nvSpPr>
          <p:spPr>
            <a:xfrm>
              <a:off x="5214125" y="6219434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554" name="tx80">
              <a:extLst>
                <a:ext uri="{FF2B5EF4-FFF2-40B4-BE49-F238E27FC236}">
                  <a16:creationId xmlns:a16="http://schemas.microsoft.com/office/drawing/2014/main" id="{75166E07-F653-4348-0B96-F6BDE78F0531}"/>
                </a:ext>
              </a:extLst>
            </p:cNvPr>
            <p:cNvSpPr/>
            <p:nvPr/>
          </p:nvSpPr>
          <p:spPr>
            <a:xfrm>
              <a:off x="7263526" y="6525145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555" name="tx81">
              <a:extLst>
                <a:ext uri="{FF2B5EF4-FFF2-40B4-BE49-F238E27FC236}">
                  <a16:creationId xmlns:a16="http://schemas.microsoft.com/office/drawing/2014/main" id="{D0123B29-4159-C390-6B1A-B35B71539EB2}"/>
                </a:ext>
              </a:extLst>
            </p:cNvPr>
            <p:cNvSpPr/>
            <p:nvPr/>
          </p:nvSpPr>
          <p:spPr>
            <a:xfrm>
              <a:off x="7263526" y="6219434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556" name="tx82">
              <a:extLst>
                <a:ext uri="{FF2B5EF4-FFF2-40B4-BE49-F238E27FC236}">
                  <a16:creationId xmlns:a16="http://schemas.microsoft.com/office/drawing/2014/main" id="{F1F3A8DE-104C-7D9D-2F5E-5FB5F8C56DDA}"/>
                </a:ext>
              </a:extLst>
            </p:cNvPr>
            <p:cNvSpPr/>
            <p:nvPr/>
          </p:nvSpPr>
          <p:spPr>
            <a:xfrm>
              <a:off x="325591" y="6523468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557" name="tx83">
              <a:extLst>
                <a:ext uri="{FF2B5EF4-FFF2-40B4-BE49-F238E27FC236}">
                  <a16:creationId xmlns:a16="http://schemas.microsoft.com/office/drawing/2014/main" id="{8E171A03-F266-C2AD-DC01-8C3B7FABD94A}"/>
                </a:ext>
              </a:extLst>
            </p:cNvPr>
            <p:cNvSpPr/>
            <p:nvPr/>
          </p:nvSpPr>
          <p:spPr>
            <a:xfrm>
              <a:off x="311638" y="6218127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558" name="tx84">
              <a:extLst>
                <a:ext uri="{FF2B5EF4-FFF2-40B4-BE49-F238E27FC236}">
                  <a16:creationId xmlns:a16="http://schemas.microsoft.com/office/drawing/2014/main" id="{D354EC32-0346-8089-068E-9F755D57BC96}"/>
                </a:ext>
              </a:extLst>
            </p:cNvPr>
            <p:cNvSpPr/>
            <p:nvPr/>
          </p:nvSpPr>
          <p:spPr>
            <a:xfrm>
              <a:off x="776476" y="5912949"/>
              <a:ext cx="23525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</p:grpSp>
      <p:sp>
        <p:nvSpPr>
          <p:cNvPr id="559" name="TextBox 558">
            <a:extLst>
              <a:ext uri="{FF2B5EF4-FFF2-40B4-BE49-F238E27FC236}">
                <a16:creationId xmlns:a16="http://schemas.microsoft.com/office/drawing/2014/main" id="{3821C0F3-175E-6741-16B5-3ADEAB34B8BA}"/>
              </a:ext>
            </a:extLst>
          </p:cNvPr>
          <p:cNvSpPr txBox="1"/>
          <p:nvPr/>
        </p:nvSpPr>
        <p:spPr>
          <a:xfrm>
            <a:off x="5513207" y="5604575"/>
            <a:ext cx="3142172" cy="6519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9" b="1" dirty="0">
                <a:latin typeface="Arial" panose="020B0604020202020204" pitchFamily="34" charset="0"/>
                <a:cs typeface="Arial" panose="020B0604020202020204" pitchFamily="34" charset="0"/>
              </a:rPr>
              <a:t>Potential Living Donor  Total   Event   HR (95% CI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No                                      8        4         Reference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Yes                                    22        4        0.33 (0.09 – 1.23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Gray K-Sample Test P-value: 0.1253        </a:t>
            </a:r>
          </a:p>
        </p:txBody>
      </p:sp>
      <p:sp>
        <p:nvSpPr>
          <p:cNvPr id="560" name="pl48">
            <a:extLst>
              <a:ext uri="{FF2B5EF4-FFF2-40B4-BE49-F238E27FC236}">
                <a16:creationId xmlns:a16="http://schemas.microsoft.com/office/drawing/2014/main" id="{87C6FACE-3C9F-1118-3BBA-F4D2EB256FED}"/>
              </a:ext>
            </a:extLst>
          </p:cNvPr>
          <p:cNvSpPr/>
          <p:nvPr/>
        </p:nvSpPr>
        <p:spPr>
          <a:xfrm>
            <a:off x="8575992" y="5916410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561" name="pl50">
            <a:extLst>
              <a:ext uri="{FF2B5EF4-FFF2-40B4-BE49-F238E27FC236}">
                <a16:creationId xmlns:a16="http://schemas.microsoft.com/office/drawing/2014/main" id="{DF907C42-A61D-6769-92F5-86A2459AF4C2}"/>
              </a:ext>
            </a:extLst>
          </p:cNvPr>
          <p:cNvSpPr/>
          <p:nvPr/>
        </p:nvSpPr>
        <p:spPr>
          <a:xfrm>
            <a:off x="8575992" y="6079364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562" name="tx47">
            <a:extLst>
              <a:ext uri="{FF2B5EF4-FFF2-40B4-BE49-F238E27FC236}">
                <a16:creationId xmlns:a16="http://schemas.microsoft.com/office/drawing/2014/main" id="{8245A6F4-9C2B-FAB3-FA7F-EA3601157992}"/>
              </a:ext>
            </a:extLst>
          </p:cNvPr>
          <p:cNvSpPr/>
          <p:nvPr/>
        </p:nvSpPr>
        <p:spPr>
          <a:xfrm rot="16200000">
            <a:off x="4575907" y="6318685"/>
            <a:ext cx="917105" cy="7613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992"/>
              </a:lnSpc>
            </a:pPr>
            <a:r>
              <a:rPr sz="992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rPr>
              <a:t>Cumulative Incidence</a:t>
            </a:r>
            <a:r>
              <a:rPr lang="en-US" sz="992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rPr>
              <a:t> of Mortality (%)</a:t>
            </a:r>
            <a:endParaRPr sz="992" dirty="0">
              <a:solidFill>
                <a:srgbClr val="000000">
                  <a:alpha val="100000"/>
                </a:srgbClr>
              </a:solidFill>
              <a:latin typeface="Arial"/>
              <a:cs typeface="Arial"/>
            </a:endParaRPr>
          </a:p>
        </p:txBody>
      </p:sp>
      <p:sp>
        <p:nvSpPr>
          <p:cNvPr id="564" name="TextBox 563">
            <a:extLst>
              <a:ext uri="{FF2B5EF4-FFF2-40B4-BE49-F238E27FC236}">
                <a16:creationId xmlns:a16="http://schemas.microsoft.com/office/drawing/2014/main" id="{463FD226-202C-B0B7-17BE-E5300A85A045}"/>
              </a:ext>
            </a:extLst>
          </p:cNvPr>
          <p:cNvSpPr txBox="1"/>
          <p:nvPr/>
        </p:nvSpPr>
        <p:spPr>
          <a:xfrm>
            <a:off x="6219001" y="5168458"/>
            <a:ext cx="2454903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d.  OLD: mortality on waitlist</a:t>
            </a:r>
            <a:endParaRPr lang="en-US" sz="1488" dirty="0"/>
          </a:p>
        </p:txBody>
      </p:sp>
      <p:grpSp>
        <p:nvGrpSpPr>
          <p:cNvPr id="565" name="Group 564">
            <a:extLst>
              <a:ext uri="{FF2B5EF4-FFF2-40B4-BE49-F238E27FC236}">
                <a16:creationId xmlns:a16="http://schemas.microsoft.com/office/drawing/2014/main" id="{CD8AF749-C10E-3593-6CC6-BF0A9CA95D30}"/>
              </a:ext>
            </a:extLst>
          </p:cNvPr>
          <p:cNvGrpSpPr>
            <a:grpSpLocks noChangeAspect="1"/>
          </p:cNvGrpSpPr>
          <p:nvPr/>
        </p:nvGrpSpPr>
        <p:grpSpPr>
          <a:xfrm>
            <a:off x="-50983" y="9125715"/>
            <a:ext cx="5179315" cy="3423047"/>
            <a:chOff x="0" y="0"/>
            <a:chExt cx="9144000" cy="6858000"/>
          </a:xfrm>
        </p:grpSpPr>
        <p:sp>
          <p:nvSpPr>
            <p:cNvPr id="566" name="rc3">
              <a:extLst>
                <a:ext uri="{FF2B5EF4-FFF2-40B4-BE49-F238E27FC236}">
                  <a16:creationId xmlns:a16="http://schemas.microsoft.com/office/drawing/2014/main" id="{4F129384-8DD5-8F04-D30C-71FEA555469A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67" name="rc4">
              <a:extLst>
                <a:ext uri="{FF2B5EF4-FFF2-40B4-BE49-F238E27FC236}">
                  <a16:creationId xmlns:a16="http://schemas.microsoft.com/office/drawing/2014/main" id="{8DAAA1F2-196E-A365-C05E-CC5D59D08B88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68" name="rc5">
              <a:extLst>
                <a:ext uri="{FF2B5EF4-FFF2-40B4-BE49-F238E27FC236}">
                  <a16:creationId xmlns:a16="http://schemas.microsoft.com/office/drawing/2014/main" id="{020BC430-8721-D2BD-ABB0-9E6495FDC0BE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69" name="rc6">
              <a:extLst>
                <a:ext uri="{FF2B5EF4-FFF2-40B4-BE49-F238E27FC236}">
                  <a16:creationId xmlns:a16="http://schemas.microsoft.com/office/drawing/2014/main" id="{DF94558D-B501-8E51-FF66-3C6615B9A52D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70" name="rc7">
              <a:extLst>
                <a:ext uri="{FF2B5EF4-FFF2-40B4-BE49-F238E27FC236}">
                  <a16:creationId xmlns:a16="http://schemas.microsoft.com/office/drawing/2014/main" id="{AD8F1A72-EA22-1103-66D9-32DE0E7297B1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71" name="rc8">
              <a:extLst>
                <a:ext uri="{FF2B5EF4-FFF2-40B4-BE49-F238E27FC236}">
                  <a16:creationId xmlns:a16="http://schemas.microsoft.com/office/drawing/2014/main" id="{3DD2F811-06D8-9E65-D713-546D58E96F82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72" name="rc9">
              <a:extLst>
                <a:ext uri="{FF2B5EF4-FFF2-40B4-BE49-F238E27FC236}">
                  <a16:creationId xmlns:a16="http://schemas.microsoft.com/office/drawing/2014/main" id="{380E3737-5BA7-4763-8570-DC8D650F2CC1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573" name="pl18">
              <a:extLst>
                <a:ext uri="{FF2B5EF4-FFF2-40B4-BE49-F238E27FC236}">
                  <a16:creationId xmlns:a16="http://schemas.microsoft.com/office/drawing/2014/main" id="{C9E2C22F-E32A-3CCC-EAA9-7BB5E42AB4F6}"/>
                </a:ext>
              </a:extLst>
            </p:cNvPr>
            <p:cNvSpPr/>
            <p:nvPr/>
          </p:nvSpPr>
          <p:spPr>
            <a:xfrm>
              <a:off x="776476" y="3534137"/>
              <a:ext cx="8228345" cy="0"/>
            </a:xfrm>
            <a:custGeom>
              <a:avLst/>
              <a:gdLst/>
              <a:ahLst/>
              <a:cxnLst/>
              <a:rect l="0" t="0" r="0" b="0"/>
              <a:pathLst>
                <a:path w="8228345">
                  <a:moveTo>
                    <a:pt x="0" y="0"/>
                  </a:moveTo>
                  <a:lnTo>
                    <a:pt x="8228345" y="0"/>
                  </a:lnTo>
                  <a:lnTo>
                    <a:pt x="8228345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74" name="pl23">
              <a:extLst>
                <a:ext uri="{FF2B5EF4-FFF2-40B4-BE49-F238E27FC236}">
                  <a16:creationId xmlns:a16="http://schemas.microsoft.com/office/drawing/2014/main" id="{47F14362-6B35-EBE5-DBF7-795BC07DA282}"/>
                </a:ext>
              </a:extLst>
            </p:cNvPr>
            <p:cNvSpPr/>
            <p:nvPr/>
          </p:nvSpPr>
          <p:spPr>
            <a:xfrm>
              <a:off x="1150492" y="139178"/>
              <a:ext cx="0" cy="3556623"/>
            </a:xfrm>
            <a:custGeom>
              <a:avLst/>
              <a:gdLst/>
              <a:ahLst/>
              <a:cxnLst/>
              <a:rect l="0" t="0" r="0" b="0"/>
              <a:pathLst>
                <a:path h="3556623">
                  <a:moveTo>
                    <a:pt x="0" y="35566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75" name="pl27">
              <a:extLst>
                <a:ext uri="{FF2B5EF4-FFF2-40B4-BE49-F238E27FC236}">
                  <a16:creationId xmlns:a16="http://schemas.microsoft.com/office/drawing/2014/main" id="{8E6D5CBD-3ADA-051A-9A78-1F412B616EF0}"/>
                </a:ext>
              </a:extLst>
            </p:cNvPr>
            <p:cNvSpPr/>
            <p:nvPr/>
          </p:nvSpPr>
          <p:spPr>
            <a:xfrm>
              <a:off x="1150492" y="2995254"/>
              <a:ext cx="4273001" cy="538882"/>
            </a:xfrm>
            <a:custGeom>
              <a:avLst/>
              <a:gdLst/>
              <a:ahLst/>
              <a:cxnLst/>
              <a:rect l="0" t="0" r="0" b="0"/>
              <a:pathLst>
                <a:path w="4273001" h="538882">
                  <a:moveTo>
                    <a:pt x="0" y="538882"/>
                  </a:moveTo>
                  <a:lnTo>
                    <a:pt x="317657" y="538882"/>
                  </a:lnTo>
                  <a:lnTo>
                    <a:pt x="317657" y="538882"/>
                  </a:lnTo>
                  <a:lnTo>
                    <a:pt x="1250134" y="538882"/>
                  </a:lnTo>
                  <a:lnTo>
                    <a:pt x="1250134" y="538882"/>
                  </a:lnTo>
                  <a:lnTo>
                    <a:pt x="2520763" y="538882"/>
                  </a:lnTo>
                  <a:lnTo>
                    <a:pt x="2520763" y="538882"/>
                  </a:lnTo>
                  <a:lnTo>
                    <a:pt x="3340523" y="538882"/>
                  </a:lnTo>
                  <a:lnTo>
                    <a:pt x="3340523" y="0"/>
                  </a:lnTo>
                  <a:lnTo>
                    <a:pt x="4273001" y="0"/>
                  </a:lnTo>
                  <a:lnTo>
                    <a:pt x="4273001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76" name="pl28">
              <a:extLst>
                <a:ext uri="{FF2B5EF4-FFF2-40B4-BE49-F238E27FC236}">
                  <a16:creationId xmlns:a16="http://schemas.microsoft.com/office/drawing/2014/main" id="{95F9BF5F-9236-ADC6-7181-8D62453403AB}"/>
                </a:ext>
              </a:extLst>
            </p:cNvPr>
            <p:cNvSpPr/>
            <p:nvPr/>
          </p:nvSpPr>
          <p:spPr>
            <a:xfrm>
              <a:off x="1150492" y="3275312"/>
              <a:ext cx="6301908" cy="258824"/>
            </a:xfrm>
            <a:custGeom>
              <a:avLst/>
              <a:gdLst/>
              <a:ahLst/>
              <a:cxnLst/>
              <a:rect l="0" t="0" r="0" b="0"/>
              <a:pathLst>
                <a:path w="6301908" h="258824">
                  <a:moveTo>
                    <a:pt x="0" y="258824"/>
                  </a:moveTo>
                  <a:lnTo>
                    <a:pt x="10247" y="258824"/>
                  </a:lnTo>
                  <a:lnTo>
                    <a:pt x="10247" y="258824"/>
                  </a:lnTo>
                  <a:lnTo>
                    <a:pt x="71729" y="258824"/>
                  </a:lnTo>
                  <a:lnTo>
                    <a:pt x="71729" y="258824"/>
                  </a:lnTo>
                  <a:lnTo>
                    <a:pt x="204940" y="258824"/>
                  </a:lnTo>
                  <a:lnTo>
                    <a:pt x="204940" y="258824"/>
                  </a:lnTo>
                  <a:lnTo>
                    <a:pt x="256175" y="258824"/>
                  </a:lnTo>
                  <a:lnTo>
                    <a:pt x="256175" y="258824"/>
                  </a:lnTo>
                  <a:lnTo>
                    <a:pt x="266422" y="258824"/>
                  </a:lnTo>
                  <a:lnTo>
                    <a:pt x="266422" y="209081"/>
                  </a:lnTo>
                  <a:lnTo>
                    <a:pt x="286916" y="209081"/>
                  </a:lnTo>
                  <a:lnTo>
                    <a:pt x="286916" y="209081"/>
                  </a:lnTo>
                  <a:lnTo>
                    <a:pt x="338151" y="209081"/>
                  </a:lnTo>
                  <a:lnTo>
                    <a:pt x="338151" y="159338"/>
                  </a:lnTo>
                  <a:lnTo>
                    <a:pt x="389386" y="159338"/>
                  </a:lnTo>
                  <a:lnTo>
                    <a:pt x="389386" y="159338"/>
                  </a:lnTo>
                  <a:lnTo>
                    <a:pt x="430374" y="159338"/>
                  </a:lnTo>
                  <a:lnTo>
                    <a:pt x="430374" y="159338"/>
                  </a:lnTo>
                  <a:lnTo>
                    <a:pt x="471362" y="159338"/>
                  </a:lnTo>
                  <a:lnTo>
                    <a:pt x="471362" y="159338"/>
                  </a:lnTo>
                  <a:lnTo>
                    <a:pt x="522597" y="159338"/>
                  </a:lnTo>
                  <a:lnTo>
                    <a:pt x="522597" y="159338"/>
                  </a:lnTo>
                  <a:lnTo>
                    <a:pt x="532844" y="159338"/>
                  </a:lnTo>
                  <a:lnTo>
                    <a:pt x="532844" y="159338"/>
                  </a:lnTo>
                  <a:lnTo>
                    <a:pt x="635314" y="159338"/>
                  </a:lnTo>
                  <a:lnTo>
                    <a:pt x="635314" y="159338"/>
                  </a:lnTo>
                  <a:lnTo>
                    <a:pt x="645561" y="159338"/>
                  </a:lnTo>
                  <a:lnTo>
                    <a:pt x="645561" y="159338"/>
                  </a:lnTo>
                  <a:lnTo>
                    <a:pt x="717290" y="159338"/>
                  </a:lnTo>
                  <a:lnTo>
                    <a:pt x="717290" y="159338"/>
                  </a:lnTo>
                  <a:lnTo>
                    <a:pt x="789019" y="159338"/>
                  </a:lnTo>
                  <a:lnTo>
                    <a:pt x="789019" y="159338"/>
                  </a:lnTo>
                  <a:lnTo>
                    <a:pt x="860748" y="159338"/>
                  </a:lnTo>
                  <a:lnTo>
                    <a:pt x="860748" y="159338"/>
                  </a:lnTo>
                  <a:lnTo>
                    <a:pt x="901736" y="159338"/>
                  </a:lnTo>
                  <a:lnTo>
                    <a:pt x="901736" y="159338"/>
                  </a:lnTo>
                  <a:lnTo>
                    <a:pt x="922230" y="159338"/>
                  </a:lnTo>
                  <a:lnTo>
                    <a:pt x="922230" y="159338"/>
                  </a:lnTo>
                  <a:lnTo>
                    <a:pt x="942724" y="159338"/>
                  </a:lnTo>
                  <a:lnTo>
                    <a:pt x="942724" y="159338"/>
                  </a:lnTo>
                  <a:lnTo>
                    <a:pt x="1004206" y="159338"/>
                  </a:lnTo>
                  <a:lnTo>
                    <a:pt x="1004206" y="159338"/>
                  </a:lnTo>
                  <a:lnTo>
                    <a:pt x="1065688" y="159338"/>
                  </a:lnTo>
                  <a:lnTo>
                    <a:pt x="1065688" y="159338"/>
                  </a:lnTo>
                  <a:lnTo>
                    <a:pt x="1116923" y="159338"/>
                  </a:lnTo>
                  <a:lnTo>
                    <a:pt x="1116923" y="159338"/>
                  </a:lnTo>
                  <a:lnTo>
                    <a:pt x="1157911" y="159338"/>
                  </a:lnTo>
                  <a:lnTo>
                    <a:pt x="1157911" y="159338"/>
                  </a:lnTo>
                  <a:lnTo>
                    <a:pt x="1198899" y="159338"/>
                  </a:lnTo>
                  <a:lnTo>
                    <a:pt x="1198899" y="159338"/>
                  </a:lnTo>
                  <a:lnTo>
                    <a:pt x="1250134" y="159338"/>
                  </a:lnTo>
                  <a:lnTo>
                    <a:pt x="1250134" y="159338"/>
                  </a:lnTo>
                  <a:lnTo>
                    <a:pt x="1291122" y="159338"/>
                  </a:lnTo>
                  <a:lnTo>
                    <a:pt x="1291122" y="159338"/>
                  </a:lnTo>
                  <a:lnTo>
                    <a:pt x="1332110" y="159338"/>
                  </a:lnTo>
                  <a:lnTo>
                    <a:pt x="1332110" y="107661"/>
                  </a:lnTo>
                  <a:lnTo>
                    <a:pt x="1444827" y="107661"/>
                  </a:lnTo>
                  <a:lnTo>
                    <a:pt x="1444827" y="107661"/>
                  </a:lnTo>
                  <a:lnTo>
                    <a:pt x="1547297" y="107661"/>
                  </a:lnTo>
                  <a:lnTo>
                    <a:pt x="1547297" y="107661"/>
                  </a:lnTo>
                  <a:lnTo>
                    <a:pt x="1588285" y="107661"/>
                  </a:lnTo>
                  <a:lnTo>
                    <a:pt x="1588285" y="107661"/>
                  </a:lnTo>
                  <a:lnTo>
                    <a:pt x="1711249" y="107661"/>
                  </a:lnTo>
                  <a:lnTo>
                    <a:pt x="1711249" y="107661"/>
                  </a:lnTo>
                  <a:lnTo>
                    <a:pt x="1731743" y="107661"/>
                  </a:lnTo>
                  <a:lnTo>
                    <a:pt x="1731743" y="107661"/>
                  </a:lnTo>
                  <a:lnTo>
                    <a:pt x="1762484" y="107661"/>
                  </a:lnTo>
                  <a:lnTo>
                    <a:pt x="1762484" y="107661"/>
                  </a:lnTo>
                  <a:lnTo>
                    <a:pt x="1936683" y="107661"/>
                  </a:lnTo>
                  <a:lnTo>
                    <a:pt x="1936683" y="107661"/>
                  </a:lnTo>
                  <a:lnTo>
                    <a:pt x="2244094" y="107661"/>
                  </a:lnTo>
                  <a:lnTo>
                    <a:pt x="2244094" y="53830"/>
                  </a:lnTo>
                  <a:lnTo>
                    <a:pt x="2285082" y="53830"/>
                  </a:lnTo>
                  <a:lnTo>
                    <a:pt x="2285082" y="53830"/>
                  </a:lnTo>
                  <a:lnTo>
                    <a:pt x="2367058" y="53830"/>
                  </a:lnTo>
                  <a:lnTo>
                    <a:pt x="2367058" y="53830"/>
                  </a:lnTo>
                  <a:lnTo>
                    <a:pt x="2408046" y="53830"/>
                  </a:lnTo>
                  <a:lnTo>
                    <a:pt x="2408046" y="53830"/>
                  </a:lnTo>
                  <a:lnTo>
                    <a:pt x="2418293" y="53830"/>
                  </a:lnTo>
                  <a:lnTo>
                    <a:pt x="2418293" y="53830"/>
                  </a:lnTo>
                  <a:lnTo>
                    <a:pt x="2725703" y="53830"/>
                  </a:lnTo>
                  <a:lnTo>
                    <a:pt x="2725703" y="53830"/>
                  </a:lnTo>
                  <a:lnTo>
                    <a:pt x="2787185" y="53830"/>
                  </a:lnTo>
                  <a:lnTo>
                    <a:pt x="2787185" y="0"/>
                  </a:lnTo>
                  <a:lnTo>
                    <a:pt x="3002372" y="0"/>
                  </a:lnTo>
                  <a:lnTo>
                    <a:pt x="3002372" y="0"/>
                  </a:lnTo>
                  <a:lnTo>
                    <a:pt x="3217559" y="0"/>
                  </a:lnTo>
                  <a:lnTo>
                    <a:pt x="3217559" y="0"/>
                  </a:lnTo>
                  <a:lnTo>
                    <a:pt x="3279041" y="0"/>
                  </a:lnTo>
                  <a:lnTo>
                    <a:pt x="3279041" y="0"/>
                  </a:lnTo>
                  <a:lnTo>
                    <a:pt x="3873367" y="0"/>
                  </a:lnTo>
                  <a:lnTo>
                    <a:pt x="3873367" y="0"/>
                  </a:lnTo>
                  <a:lnTo>
                    <a:pt x="3945096" y="0"/>
                  </a:lnTo>
                  <a:lnTo>
                    <a:pt x="3945096" y="0"/>
                  </a:lnTo>
                  <a:lnTo>
                    <a:pt x="4590658" y="0"/>
                  </a:lnTo>
                  <a:lnTo>
                    <a:pt x="4590658" y="0"/>
                  </a:lnTo>
                  <a:lnTo>
                    <a:pt x="4877574" y="0"/>
                  </a:lnTo>
                  <a:lnTo>
                    <a:pt x="4877574" y="0"/>
                  </a:lnTo>
                  <a:lnTo>
                    <a:pt x="5379677" y="0"/>
                  </a:lnTo>
                  <a:lnTo>
                    <a:pt x="5379677" y="0"/>
                  </a:lnTo>
                  <a:lnTo>
                    <a:pt x="6301908" y="0"/>
                  </a:lnTo>
                  <a:lnTo>
                    <a:pt x="6301908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77" name="rc29">
              <a:extLst>
                <a:ext uri="{FF2B5EF4-FFF2-40B4-BE49-F238E27FC236}">
                  <a16:creationId xmlns:a16="http://schemas.microsoft.com/office/drawing/2014/main" id="{F2246B98-08E1-87D5-4569-6DFFEA952295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78" name="tx30">
              <a:extLst>
                <a:ext uri="{FF2B5EF4-FFF2-40B4-BE49-F238E27FC236}">
                  <a16:creationId xmlns:a16="http://schemas.microsoft.com/office/drawing/2014/main" id="{C8FD19FA-8100-2639-B8DA-F5821229091A}"/>
                </a:ext>
              </a:extLst>
            </p:cNvPr>
            <p:cNvSpPr/>
            <p:nvPr/>
          </p:nvSpPr>
          <p:spPr>
            <a:xfrm>
              <a:off x="466667" y="3486760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579" name="tx31">
              <a:extLst>
                <a:ext uri="{FF2B5EF4-FFF2-40B4-BE49-F238E27FC236}">
                  <a16:creationId xmlns:a16="http://schemas.microsoft.com/office/drawing/2014/main" id="{53925A05-7B3F-BD41-086D-7DCC6D60A2D5}"/>
                </a:ext>
              </a:extLst>
            </p:cNvPr>
            <p:cNvSpPr/>
            <p:nvPr/>
          </p:nvSpPr>
          <p:spPr>
            <a:xfrm>
              <a:off x="466667" y="2678436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580" name="tx32">
              <a:extLst>
                <a:ext uri="{FF2B5EF4-FFF2-40B4-BE49-F238E27FC236}">
                  <a16:creationId xmlns:a16="http://schemas.microsoft.com/office/drawing/2014/main" id="{87863D9C-43CD-2AC8-3EEB-137C36AA0949}"/>
                </a:ext>
              </a:extLst>
            </p:cNvPr>
            <p:cNvSpPr/>
            <p:nvPr/>
          </p:nvSpPr>
          <p:spPr>
            <a:xfrm>
              <a:off x="466667" y="1870113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581" name="tx33">
              <a:extLst>
                <a:ext uri="{FF2B5EF4-FFF2-40B4-BE49-F238E27FC236}">
                  <a16:creationId xmlns:a16="http://schemas.microsoft.com/office/drawing/2014/main" id="{D005F09E-CAF9-A781-3EB3-461BFB18ADC3}"/>
                </a:ext>
              </a:extLst>
            </p:cNvPr>
            <p:cNvSpPr/>
            <p:nvPr/>
          </p:nvSpPr>
          <p:spPr>
            <a:xfrm>
              <a:off x="466667" y="1061789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582" name="tx34">
              <a:extLst>
                <a:ext uri="{FF2B5EF4-FFF2-40B4-BE49-F238E27FC236}">
                  <a16:creationId xmlns:a16="http://schemas.microsoft.com/office/drawing/2014/main" id="{59940F79-F7BD-C028-9604-7E14F2733A4D}"/>
                </a:ext>
              </a:extLst>
            </p:cNvPr>
            <p:cNvSpPr/>
            <p:nvPr/>
          </p:nvSpPr>
          <p:spPr>
            <a:xfrm>
              <a:off x="466667" y="253465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0</a:t>
              </a:r>
            </a:p>
          </p:txBody>
        </p:sp>
        <p:sp>
          <p:nvSpPr>
            <p:cNvPr id="583" name="pl35">
              <a:extLst>
                <a:ext uri="{FF2B5EF4-FFF2-40B4-BE49-F238E27FC236}">
                  <a16:creationId xmlns:a16="http://schemas.microsoft.com/office/drawing/2014/main" id="{9957F4BE-4E42-5D76-A149-EA3599E1C2B1}"/>
                </a:ext>
              </a:extLst>
            </p:cNvPr>
            <p:cNvSpPr/>
            <p:nvPr/>
          </p:nvSpPr>
          <p:spPr>
            <a:xfrm>
              <a:off x="741682" y="353413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84" name="pl36">
              <a:extLst>
                <a:ext uri="{FF2B5EF4-FFF2-40B4-BE49-F238E27FC236}">
                  <a16:creationId xmlns:a16="http://schemas.microsoft.com/office/drawing/2014/main" id="{3953C391-5999-9CB5-4A4F-170D786B9F57}"/>
                </a:ext>
              </a:extLst>
            </p:cNvPr>
            <p:cNvSpPr/>
            <p:nvPr/>
          </p:nvSpPr>
          <p:spPr>
            <a:xfrm>
              <a:off x="741682" y="2725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85" name="pl37">
              <a:extLst>
                <a:ext uri="{FF2B5EF4-FFF2-40B4-BE49-F238E27FC236}">
                  <a16:creationId xmlns:a16="http://schemas.microsoft.com/office/drawing/2014/main" id="{71000F47-10B3-6ED4-8E27-4F3C6A329630}"/>
                </a:ext>
              </a:extLst>
            </p:cNvPr>
            <p:cNvSpPr/>
            <p:nvPr/>
          </p:nvSpPr>
          <p:spPr>
            <a:xfrm>
              <a:off x="741682" y="19174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86" name="pl38">
              <a:extLst>
                <a:ext uri="{FF2B5EF4-FFF2-40B4-BE49-F238E27FC236}">
                  <a16:creationId xmlns:a16="http://schemas.microsoft.com/office/drawing/2014/main" id="{99B6CF1B-E1B6-D0CD-6667-AC5F45DAECE9}"/>
                </a:ext>
              </a:extLst>
            </p:cNvPr>
            <p:cNvSpPr/>
            <p:nvPr/>
          </p:nvSpPr>
          <p:spPr>
            <a:xfrm>
              <a:off x="741682" y="11091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87" name="pl39">
              <a:extLst>
                <a:ext uri="{FF2B5EF4-FFF2-40B4-BE49-F238E27FC236}">
                  <a16:creationId xmlns:a16="http://schemas.microsoft.com/office/drawing/2014/main" id="{D13B02F1-F514-7F09-8F42-727D2B7C8B0F}"/>
                </a:ext>
              </a:extLst>
            </p:cNvPr>
            <p:cNvSpPr/>
            <p:nvPr/>
          </p:nvSpPr>
          <p:spPr>
            <a:xfrm>
              <a:off x="741682" y="3008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88" name="pl40">
              <a:extLst>
                <a:ext uri="{FF2B5EF4-FFF2-40B4-BE49-F238E27FC236}">
                  <a16:creationId xmlns:a16="http://schemas.microsoft.com/office/drawing/2014/main" id="{A18F463D-A24E-B48C-2CD9-E06DC93787CD}"/>
                </a:ext>
              </a:extLst>
            </p:cNvPr>
            <p:cNvSpPr/>
            <p:nvPr/>
          </p:nvSpPr>
          <p:spPr>
            <a:xfrm>
              <a:off x="1150492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89" name="pl41">
              <a:extLst>
                <a:ext uri="{FF2B5EF4-FFF2-40B4-BE49-F238E27FC236}">
                  <a16:creationId xmlns:a16="http://schemas.microsoft.com/office/drawing/2014/main" id="{513029CE-4FFD-40DC-F33A-7DBF6874C18D}"/>
                </a:ext>
              </a:extLst>
            </p:cNvPr>
            <p:cNvSpPr/>
            <p:nvPr/>
          </p:nvSpPr>
          <p:spPr>
            <a:xfrm>
              <a:off x="3199893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90" name="pl42">
              <a:extLst>
                <a:ext uri="{FF2B5EF4-FFF2-40B4-BE49-F238E27FC236}">
                  <a16:creationId xmlns:a16="http://schemas.microsoft.com/office/drawing/2014/main" id="{5439FE12-9AC3-B4BF-26C5-5ADCFCFC3299}"/>
                </a:ext>
              </a:extLst>
            </p:cNvPr>
            <p:cNvSpPr/>
            <p:nvPr/>
          </p:nvSpPr>
          <p:spPr>
            <a:xfrm>
              <a:off x="5249294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91" name="pl43">
              <a:extLst>
                <a:ext uri="{FF2B5EF4-FFF2-40B4-BE49-F238E27FC236}">
                  <a16:creationId xmlns:a16="http://schemas.microsoft.com/office/drawing/2014/main" id="{C43F1DAA-85C0-3D1F-ABA6-875611A70A52}"/>
                </a:ext>
              </a:extLst>
            </p:cNvPr>
            <p:cNvSpPr/>
            <p:nvPr/>
          </p:nvSpPr>
          <p:spPr>
            <a:xfrm>
              <a:off x="7298695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92" name="tx44">
              <a:extLst>
                <a:ext uri="{FF2B5EF4-FFF2-40B4-BE49-F238E27FC236}">
                  <a16:creationId xmlns:a16="http://schemas.microsoft.com/office/drawing/2014/main" id="{22001EFF-607B-1320-F372-FF2961ABBA0D}"/>
                </a:ext>
              </a:extLst>
            </p:cNvPr>
            <p:cNvSpPr/>
            <p:nvPr/>
          </p:nvSpPr>
          <p:spPr>
            <a:xfrm>
              <a:off x="1115176" y="3756509"/>
              <a:ext cx="70631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593" name="tx45">
              <a:extLst>
                <a:ext uri="{FF2B5EF4-FFF2-40B4-BE49-F238E27FC236}">
                  <a16:creationId xmlns:a16="http://schemas.microsoft.com/office/drawing/2014/main" id="{43ADA6DA-C75F-F93B-F2E2-8EA33DB0FB9D}"/>
                </a:ext>
              </a:extLst>
            </p:cNvPr>
            <p:cNvSpPr/>
            <p:nvPr/>
          </p:nvSpPr>
          <p:spPr>
            <a:xfrm>
              <a:off x="3093946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594" name="tx46">
              <a:extLst>
                <a:ext uri="{FF2B5EF4-FFF2-40B4-BE49-F238E27FC236}">
                  <a16:creationId xmlns:a16="http://schemas.microsoft.com/office/drawing/2014/main" id="{45DD3FB7-E515-4AD0-157C-F544AB2801C9}"/>
                </a:ext>
              </a:extLst>
            </p:cNvPr>
            <p:cNvSpPr/>
            <p:nvPr/>
          </p:nvSpPr>
          <p:spPr>
            <a:xfrm>
              <a:off x="5143347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595" name="tx47">
              <a:extLst>
                <a:ext uri="{FF2B5EF4-FFF2-40B4-BE49-F238E27FC236}">
                  <a16:creationId xmlns:a16="http://schemas.microsoft.com/office/drawing/2014/main" id="{B8088233-DB29-9F76-D612-442E2B037A1F}"/>
                </a:ext>
              </a:extLst>
            </p:cNvPr>
            <p:cNvSpPr/>
            <p:nvPr/>
          </p:nvSpPr>
          <p:spPr>
            <a:xfrm>
              <a:off x="7192748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596" name="tx48">
              <a:extLst>
                <a:ext uri="{FF2B5EF4-FFF2-40B4-BE49-F238E27FC236}">
                  <a16:creationId xmlns:a16="http://schemas.microsoft.com/office/drawing/2014/main" id="{182B004F-E8CE-73DF-ACCE-09CC530B2D2F}"/>
                </a:ext>
              </a:extLst>
            </p:cNvPr>
            <p:cNvSpPr/>
            <p:nvPr/>
          </p:nvSpPr>
          <p:spPr>
            <a:xfrm>
              <a:off x="4081991" y="3878778"/>
              <a:ext cx="1617315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 to mortality (Days)</a:t>
              </a:r>
            </a:p>
          </p:txBody>
        </p:sp>
        <p:sp>
          <p:nvSpPr>
            <p:cNvPr id="597" name="rc50">
              <a:extLst>
                <a:ext uri="{FF2B5EF4-FFF2-40B4-BE49-F238E27FC236}">
                  <a16:creationId xmlns:a16="http://schemas.microsoft.com/office/drawing/2014/main" id="{68084A39-6C3D-2DE9-1A32-149B1154B508}"/>
                </a:ext>
              </a:extLst>
            </p:cNvPr>
            <p:cNvSpPr/>
            <p:nvPr/>
          </p:nvSpPr>
          <p:spPr>
            <a:xfrm>
              <a:off x="4276688" y="4189554"/>
              <a:ext cx="1227921" cy="358634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598" name="rc51">
              <a:extLst>
                <a:ext uri="{FF2B5EF4-FFF2-40B4-BE49-F238E27FC236}">
                  <a16:creationId xmlns:a16="http://schemas.microsoft.com/office/drawing/2014/main" id="{6DA2DD46-16C0-735A-DDAC-C7166EE89B98}"/>
                </a:ext>
              </a:extLst>
            </p:cNvPr>
            <p:cNvSpPr/>
            <p:nvPr/>
          </p:nvSpPr>
          <p:spPr>
            <a:xfrm>
              <a:off x="4415866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599" name="pl52">
              <a:extLst>
                <a:ext uri="{FF2B5EF4-FFF2-40B4-BE49-F238E27FC236}">
                  <a16:creationId xmlns:a16="http://schemas.microsoft.com/office/drawing/2014/main" id="{329C93A3-748E-2AC1-06C4-069221AB11F7}"/>
                </a:ext>
              </a:extLst>
            </p:cNvPr>
            <p:cNvSpPr/>
            <p:nvPr/>
          </p:nvSpPr>
          <p:spPr>
            <a:xfrm>
              <a:off x="4437812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00" name="rc53">
              <a:extLst>
                <a:ext uri="{FF2B5EF4-FFF2-40B4-BE49-F238E27FC236}">
                  <a16:creationId xmlns:a16="http://schemas.microsoft.com/office/drawing/2014/main" id="{D98B31E3-EA7E-6815-93B6-5276276AA553}"/>
                </a:ext>
              </a:extLst>
            </p:cNvPr>
            <p:cNvSpPr/>
            <p:nvPr/>
          </p:nvSpPr>
          <p:spPr>
            <a:xfrm>
              <a:off x="4926900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601" name="pl54">
              <a:extLst>
                <a:ext uri="{FF2B5EF4-FFF2-40B4-BE49-F238E27FC236}">
                  <a16:creationId xmlns:a16="http://schemas.microsoft.com/office/drawing/2014/main" id="{312F530A-6643-98B4-447D-6484ECF3F3D3}"/>
                </a:ext>
              </a:extLst>
            </p:cNvPr>
            <p:cNvSpPr/>
            <p:nvPr/>
          </p:nvSpPr>
          <p:spPr>
            <a:xfrm>
              <a:off x="4948846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02" name="tx55">
              <a:extLst>
                <a:ext uri="{FF2B5EF4-FFF2-40B4-BE49-F238E27FC236}">
                  <a16:creationId xmlns:a16="http://schemas.microsoft.com/office/drawing/2014/main" id="{9A7C7616-AB7E-D577-ED2E-926D427379B2}"/>
                </a:ext>
              </a:extLst>
            </p:cNvPr>
            <p:cNvSpPr/>
            <p:nvPr/>
          </p:nvSpPr>
          <p:spPr>
            <a:xfrm>
              <a:off x="4704911" y="4321929"/>
              <a:ext cx="162346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603" name="tx56">
              <a:extLst>
                <a:ext uri="{FF2B5EF4-FFF2-40B4-BE49-F238E27FC236}">
                  <a16:creationId xmlns:a16="http://schemas.microsoft.com/office/drawing/2014/main" id="{0CAD9BBE-7620-2B92-5F2A-2BFAD7619A41}"/>
                </a:ext>
              </a:extLst>
            </p:cNvPr>
            <p:cNvSpPr/>
            <p:nvPr/>
          </p:nvSpPr>
          <p:spPr>
            <a:xfrm>
              <a:off x="5215945" y="4321929"/>
              <a:ext cx="218839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  <p:sp>
          <p:nvSpPr>
            <p:cNvPr id="604" name="rc57">
              <a:extLst>
                <a:ext uri="{FF2B5EF4-FFF2-40B4-BE49-F238E27FC236}">
                  <a16:creationId xmlns:a16="http://schemas.microsoft.com/office/drawing/2014/main" id="{CDDA4EFE-3853-F79B-3283-13858C96D944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05" name="rc58">
              <a:extLst>
                <a:ext uri="{FF2B5EF4-FFF2-40B4-BE49-F238E27FC236}">
                  <a16:creationId xmlns:a16="http://schemas.microsoft.com/office/drawing/2014/main" id="{29F58942-5653-918F-7B79-C868DAE62A1C}"/>
                </a:ext>
              </a:extLst>
            </p:cNvPr>
            <p:cNvSpPr/>
            <p:nvPr/>
          </p:nvSpPr>
          <p:spPr>
            <a:xfrm>
              <a:off x="776476" y="4996549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606" name="tx59">
              <a:extLst>
                <a:ext uri="{FF2B5EF4-FFF2-40B4-BE49-F238E27FC236}">
                  <a16:creationId xmlns:a16="http://schemas.microsoft.com/office/drawing/2014/main" id="{E96A27D4-1554-4859-D5A4-622E43C3CD93}"/>
                </a:ext>
              </a:extLst>
            </p:cNvPr>
            <p:cNvSpPr/>
            <p:nvPr/>
          </p:nvSpPr>
          <p:spPr>
            <a:xfrm>
              <a:off x="1115323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07" name="tx60">
              <a:extLst>
                <a:ext uri="{FF2B5EF4-FFF2-40B4-BE49-F238E27FC236}">
                  <a16:creationId xmlns:a16="http://schemas.microsoft.com/office/drawing/2014/main" id="{D8A268AF-2666-C0F1-5DA4-A841554C151D}"/>
                </a:ext>
              </a:extLst>
            </p:cNvPr>
            <p:cNvSpPr/>
            <p:nvPr/>
          </p:nvSpPr>
          <p:spPr>
            <a:xfrm>
              <a:off x="1115323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608" name="tx61">
              <a:extLst>
                <a:ext uri="{FF2B5EF4-FFF2-40B4-BE49-F238E27FC236}">
                  <a16:creationId xmlns:a16="http://schemas.microsoft.com/office/drawing/2014/main" id="{4F8C8498-89DE-2F45-7F8E-4349CCCEAE43}"/>
                </a:ext>
              </a:extLst>
            </p:cNvPr>
            <p:cNvSpPr/>
            <p:nvPr/>
          </p:nvSpPr>
          <p:spPr>
            <a:xfrm>
              <a:off x="3164724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09" name="tx62">
              <a:extLst>
                <a:ext uri="{FF2B5EF4-FFF2-40B4-BE49-F238E27FC236}">
                  <a16:creationId xmlns:a16="http://schemas.microsoft.com/office/drawing/2014/main" id="{88E4B494-A910-EBF7-7910-4A46DA5C8CE8}"/>
                </a:ext>
              </a:extLst>
            </p:cNvPr>
            <p:cNvSpPr/>
            <p:nvPr/>
          </p:nvSpPr>
          <p:spPr>
            <a:xfrm>
              <a:off x="3164724" y="5132512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610" name="tx63">
              <a:extLst>
                <a:ext uri="{FF2B5EF4-FFF2-40B4-BE49-F238E27FC236}">
                  <a16:creationId xmlns:a16="http://schemas.microsoft.com/office/drawing/2014/main" id="{8B434DEB-7932-7139-2CBF-23A396E189C5}"/>
                </a:ext>
              </a:extLst>
            </p:cNvPr>
            <p:cNvSpPr/>
            <p:nvPr/>
          </p:nvSpPr>
          <p:spPr>
            <a:xfrm>
              <a:off x="5214125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611" name="tx64">
              <a:extLst>
                <a:ext uri="{FF2B5EF4-FFF2-40B4-BE49-F238E27FC236}">
                  <a16:creationId xmlns:a16="http://schemas.microsoft.com/office/drawing/2014/main" id="{22C19115-D16D-4901-F910-2F59A428CE50}"/>
                </a:ext>
              </a:extLst>
            </p:cNvPr>
            <p:cNvSpPr/>
            <p:nvPr/>
          </p:nvSpPr>
          <p:spPr>
            <a:xfrm>
              <a:off x="5214125" y="5134117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612" name="tx65">
              <a:extLst>
                <a:ext uri="{FF2B5EF4-FFF2-40B4-BE49-F238E27FC236}">
                  <a16:creationId xmlns:a16="http://schemas.microsoft.com/office/drawing/2014/main" id="{4C7B2D68-A2B0-5C5B-C080-3E9E0D5CFB1A}"/>
                </a:ext>
              </a:extLst>
            </p:cNvPr>
            <p:cNvSpPr/>
            <p:nvPr/>
          </p:nvSpPr>
          <p:spPr>
            <a:xfrm>
              <a:off x="7263526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613" name="tx66">
              <a:extLst>
                <a:ext uri="{FF2B5EF4-FFF2-40B4-BE49-F238E27FC236}">
                  <a16:creationId xmlns:a16="http://schemas.microsoft.com/office/drawing/2014/main" id="{10E0BB70-AAF2-33B3-3190-9F2B2456C6AD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14" name="tx67">
              <a:extLst>
                <a:ext uri="{FF2B5EF4-FFF2-40B4-BE49-F238E27FC236}">
                  <a16:creationId xmlns:a16="http://schemas.microsoft.com/office/drawing/2014/main" id="{95A8FCE7-9E7A-A947-2320-A74EAB873971}"/>
                </a:ext>
              </a:extLst>
            </p:cNvPr>
            <p:cNvSpPr/>
            <p:nvPr/>
          </p:nvSpPr>
          <p:spPr>
            <a:xfrm>
              <a:off x="7263526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615" name="tx68">
              <a:extLst>
                <a:ext uri="{FF2B5EF4-FFF2-40B4-BE49-F238E27FC236}">
                  <a16:creationId xmlns:a16="http://schemas.microsoft.com/office/drawing/2014/main" id="{7E37B524-467D-81B8-373C-751E8160B8D1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16" name="tx69">
              <a:extLst>
                <a:ext uri="{FF2B5EF4-FFF2-40B4-BE49-F238E27FC236}">
                  <a16:creationId xmlns:a16="http://schemas.microsoft.com/office/drawing/2014/main" id="{717B368F-B4D7-CE8E-B132-BA30AB0C9897}"/>
                </a:ext>
              </a:extLst>
            </p:cNvPr>
            <p:cNvSpPr/>
            <p:nvPr/>
          </p:nvSpPr>
          <p:spPr>
            <a:xfrm>
              <a:off x="325591" y="5438152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617" name="tx70">
              <a:extLst>
                <a:ext uri="{FF2B5EF4-FFF2-40B4-BE49-F238E27FC236}">
                  <a16:creationId xmlns:a16="http://schemas.microsoft.com/office/drawing/2014/main" id="{4D74EA48-8142-5810-A6B5-D2B9154CA0F4}"/>
                </a:ext>
              </a:extLst>
            </p:cNvPr>
            <p:cNvSpPr/>
            <p:nvPr/>
          </p:nvSpPr>
          <p:spPr>
            <a:xfrm>
              <a:off x="311638" y="5132811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618" name="tx71">
              <a:extLst>
                <a:ext uri="{FF2B5EF4-FFF2-40B4-BE49-F238E27FC236}">
                  <a16:creationId xmlns:a16="http://schemas.microsoft.com/office/drawing/2014/main" id="{7E215C90-A9BC-03EC-7393-22BA53E838D2}"/>
                </a:ext>
              </a:extLst>
            </p:cNvPr>
            <p:cNvSpPr/>
            <p:nvPr/>
          </p:nvSpPr>
          <p:spPr>
            <a:xfrm>
              <a:off x="776476" y="4827633"/>
              <a:ext cx="17452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619" name="rc72">
              <a:extLst>
                <a:ext uri="{FF2B5EF4-FFF2-40B4-BE49-F238E27FC236}">
                  <a16:creationId xmlns:a16="http://schemas.microsoft.com/office/drawing/2014/main" id="{42C01185-C5C6-F258-A5A5-5BEDF1E1B733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20" name="rc73">
              <a:extLst>
                <a:ext uri="{FF2B5EF4-FFF2-40B4-BE49-F238E27FC236}">
                  <a16:creationId xmlns:a16="http://schemas.microsoft.com/office/drawing/2014/main" id="{7FB88F08-5A87-0A5C-E719-2CC6F574C919}"/>
                </a:ext>
              </a:extLst>
            </p:cNvPr>
            <p:cNvSpPr/>
            <p:nvPr/>
          </p:nvSpPr>
          <p:spPr>
            <a:xfrm>
              <a:off x="776476" y="6081865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621" name="tx74">
              <a:extLst>
                <a:ext uri="{FF2B5EF4-FFF2-40B4-BE49-F238E27FC236}">
                  <a16:creationId xmlns:a16="http://schemas.microsoft.com/office/drawing/2014/main" id="{21DED075-3B80-A466-8888-77C391CDBB4C}"/>
                </a:ext>
              </a:extLst>
            </p:cNvPr>
            <p:cNvSpPr/>
            <p:nvPr/>
          </p:nvSpPr>
          <p:spPr>
            <a:xfrm>
              <a:off x="1115323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22" name="tx75">
              <a:extLst>
                <a:ext uri="{FF2B5EF4-FFF2-40B4-BE49-F238E27FC236}">
                  <a16:creationId xmlns:a16="http://schemas.microsoft.com/office/drawing/2014/main" id="{3B140631-BB7E-D386-DE83-D3D7B66AD206}"/>
                </a:ext>
              </a:extLst>
            </p:cNvPr>
            <p:cNvSpPr/>
            <p:nvPr/>
          </p:nvSpPr>
          <p:spPr>
            <a:xfrm>
              <a:off x="1080154" y="6217890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5</a:t>
              </a:r>
            </a:p>
          </p:txBody>
        </p:sp>
        <p:sp>
          <p:nvSpPr>
            <p:cNvPr id="623" name="tx76">
              <a:extLst>
                <a:ext uri="{FF2B5EF4-FFF2-40B4-BE49-F238E27FC236}">
                  <a16:creationId xmlns:a16="http://schemas.microsoft.com/office/drawing/2014/main" id="{A9D9C105-F9C7-5291-9665-CD167AE140BF}"/>
                </a:ext>
              </a:extLst>
            </p:cNvPr>
            <p:cNvSpPr/>
            <p:nvPr/>
          </p:nvSpPr>
          <p:spPr>
            <a:xfrm>
              <a:off x="3164724" y="6523169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624" name="tx77">
              <a:extLst>
                <a:ext uri="{FF2B5EF4-FFF2-40B4-BE49-F238E27FC236}">
                  <a16:creationId xmlns:a16="http://schemas.microsoft.com/office/drawing/2014/main" id="{0B460EB7-5E28-CC55-546D-96527F363A34}"/>
                </a:ext>
              </a:extLst>
            </p:cNvPr>
            <p:cNvSpPr/>
            <p:nvPr/>
          </p:nvSpPr>
          <p:spPr>
            <a:xfrm>
              <a:off x="3129555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4</a:t>
              </a:r>
            </a:p>
          </p:txBody>
        </p:sp>
        <p:sp>
          <p:nvSpPr>
            <p:cNvPr id="625" name="tx78">
              <a:extLst>
                <a:ext uri="{FF2B5EF4-FFF2-40B4-BE49-F238E27FC236}">
                  <a16:creationId xmlns:a16="http://schemas.microsoft.com/office/drawing/2014/main" id="{9FAD3CAA-FC22-6E34-2FDB-3A4C0FCE122A}"/>
                </a:ext>
              </a:extLst>
            </p:cNvPr>
            <p:cNvSpPr/>
            <p:nvPr/>
          </p:nvSpPr>
          <p:spPr>
            <a:xfrm>
              <a:off x="5214125" y="6524837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626" name="tx79">
              <a:extLst>
                <a:ext uri="{FF2B5EF4-FFF2-40B4-BE49-F238E27FC236}">
                  <a16:creationId xmlns:a16="http://schemas.microsoft.com/office/drawing/2014/main" id="{619D0996-7E7E-C373-FA55-0BF9DEDAF7DD}"/>
                </a:ext>
              </a:extLst>
            </p:cNvPr>
            <p:cNvSpPr/>
            <p:nvPr/>
          </p:nvSpPr>
          <p:spPr>
            <a:xfrm>
              <a:off x="5178956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1</a:t>
              </a:r>
            </a:p>
          </p:txBody>
        </p:sp>
        <p:sp>
          <p:nvSpPr>
            <p:cNvPr id="627" name="tx80">
              <a:extLst>
                <a:ext uri="{FF2B5EF4-FFF2-40B4-BE49-F238E27FC236}">
                  <a16:creationId xmlns:a16="http://schemas.microsoft.com/office/drawing/2014/main" id="{778849C6-B7EB-B247-6D5A-D26E36588501}"/>
                </a:ext>
              </a:extLst>
            </p:cNvPr>
            <p:cNvSpPr/>
            <p:nvPr/>
          </p:nvSpPr>
          <p:spPr>
            <a:xfrm>
              <a:off x="7263526" y="6524837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628" name="tx81">
              <a:extLst>
                <a:ext uri="{FF2B5EF4-FFF2-40B4-BE49-F238E27FC236}">
                  <a16:creationId xmlns:a16="http://schemas.microsoft.com/office/drawing/2014/main" id="{DF3CBDBC-3F19-B5D0-0460-6767F37F1C21}"/>
                </a:ext>
              </a:extLst>
            </p:cNvPr>
            <p:cNvSpPr/>
            <p:nvPr/>
          </p:nvSpPr>
          <p:spPr>
            <a:xfrm>
              <a:off x="7263526" y="6217890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629" name="tx82">
              <a:extLst>
                <a:ext uri="{FF2B5EF4-FFF2-40B4-BE49-F238E27FC236}">
                  <a16:creationId xmlns:a16="http://schemas.microsoft.com/office/drawing/2014/main" id="{70A93E65-DBF9-F49C-03FF-B23C9D996DAC}"/>
                </a:ext>
              </a:extLst>
            </p:cNvPr>
            <p:cNvSpPr/>
            <p:nvPr/>
          </p:nvSpPr>
          <p:spPr>
            <a:xfrm>
              <a:off x="325591" y="6523468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630" name="tx83">
              <a:extLst>
                <a:ext uri="{FF2B5EF4-FFF2-40B4-BE49-F238E27FC236}">
                  <a16:creationId xmlns:a16="http://schemas.microsoft.com/office/drawing/2014/main" id="{39EF4B98-F366-8A00-61B8-80862BA034DA}"/>
                </a:ext>
              </a:extLst>
            </p:cNvPr>
            <p:cNvSpPr/>
            <p:nvPr/>
          </p:nvSpPr>
          <p:spPr>
            <a:xfrm>
              <a:off x="311638" y="6218127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631" name="tx84">
              <a:extLst>
                <a:ext uri="{FF2B5EF4-FFF2-40B4-BE49-F238E27FC236}">
                  <a16:creationId xmlns:a16="http://schemas.microsoft.com/office/drawing/2014/main" id="{D8C9A40B-2C38-3DD2-38E3-3EF466B94CF0}"/>
                </a:ext>
              </a:extLst>
            </p:cNvPr>
            <p:cNvSpPr/>
            <p:nvPr/>
          </p:nvSpPr>
          <p:spPr>
            <a:xfrm>
              <a:off x="776476" y="5912949"/>
              <a:ext cx="23525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</p:grpSp>
      <p:sp>
        <p:nvSpPr>
          <p:cNvPr id="632" name="tx47">
            <a:extLst>
              <a:ext uri="{FF2B5EF4-FFF2-40B4-BE49-F238E27FC236}">
                <a16:creationId xmlns:a16="http://schemas.microsoft.com/office/drawing/2014/main" id="{D79719AA-0473-3941-9E71-16EDE0E7BB4E}"/>
              </a:ext>
            </a:extLst>
          </p:cNvPr>
          <p:cNvSpPr/>
          <p:nvPr/>
        </p:nvSpPr>
        <p:spPr>
          <a:xfrm rot="16200000">
            <a:off x="-340748" y="10176985"/>
            <a:ext cx="917105" cy="7613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992"/>
              </a:lnSpc>
            </a:pPr>
            <a:r>
              <a:rPr sz="992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rPr>
              <a:t>Cumulative Incidence</a:t>
            </a:r>
            <a:r>
              <a:rPr lang="en-US" sz="992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rPr>
              <a:t> of Mortality (%)</a:t>
            </a:r>
            <a:endParaRPr sz="992" dirty="0">
              <a:solidFill>
                <a:srgbClr val="000000">
                  <a:alpha val="100000"/>
                </a:srgbClr>
              </a:solidFill>
              <a:latin typeface="Arial"/>
              <a:cs typeface="Arial"/>
            </a:endParaRPr>
          </a:p>
        </p:txBody>
      </p:sp>
      <p:sp>
        <p:nvSpPr>
          <p:cNvPr id="633" name="TextBox 632">
            <a:extLst>
              <a:ext uri="{FF2B5EF4-FFF2-40B4-BE49-F238E27FC236}">
                <a16:creationId xmlns:a16="http://schemas.microsoft.com/office/drawing/2014/main" id="{A3C58AF9-8C15-1C78-6075-43FC89CE200B}"/>
              </a:ext>
            </a:extLst>
          </p:cNvPr>
          <p:cNvSpPr txBox="1"/>
          <p:nvPr/>
        </p:nvSpPr>
        <p:spPr>
          <a:xfrm>
            <a:off x="498916" y="9286687"/>
            <a:ext cx="3142172" cy="6519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9" b="1" dirty="0">
                <a:latin typeface="Arial" panose="020B0604020202020204" pitchFamily="34" charset="0"/>
                <a:cs typeface="Arial" panose="020B0604020202020204" pitchFamily="34" charset="0"/>
              </a:rPr>
              <a:t>Potential Living Donor  Total   Event   HR (95% CI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No                                      6          1        Reference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Yes                                    65        5        0.50 (0.07 – 3.52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Gray K-Sample Test P-value: 0.5331        </a:t>
            </a:r>
          </a:p>
        </p:txBody>
      </p:sp>
      <p:sp>
        <p:nvSpPr>
          <p:cNvPr id="634" name="pl48">
            <a:extLst>
              <a:ext uri="{FF2B5EF4-FFF2-40B4-BE49-F238E27FC236}">
                <a16:creationId xmlns:a16="http://schemas.microsoft.com/office/drawing/2014/main" id="{7B2FE4CD-6F8C-8897-09CF-C004ACE2FB98}"/>
              </a:ext>
            </a:extLst>
          </p:cNvPr>
          <p:cNvSpPr/>
          <p:nvPr/>
        </p:nvSpPr>
        <p:spPr>
          <a:xfrm>
            <a:off x="2908057" y="10186600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635" name="pl50">
            <a:extLst>
              <a:ext uri="{FF2B5EF4-FFF2-40B4-BE49-F238E27FC236}">
                <a16:creationId xmlns:a16="http://schemas.microsoft.com/office/drawing/2014/main" id="{C0233CD6-60EB-C897-4DC5-4DC848BAFAA5}"/>
              </a:ext>
            </a:extLst>
          </p:cNvPr>
          <p:cNvSpPr/>
          <p:nvPr/>
        </p:nvSpPr>
        <p:spPr>
          <a:xfrm>
            <a:off x="2900863" y="10349554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636" name="TextBox 635">
            <a:extLst>
              <a:ext uri="{FF2B5EF4-FFF2-40B4-BE49-F238E27FC236}">
                <a16:creationId xmlns:a16="http://schemas.microsoft.com/office/drawing/2014/main" id="{35878DB7-2189-892A-4D01-1D4B0A332DAF}"/>
              </a:ext>
            </a:extLst>
          </p:cNvPr>
          <p:cNvSpPr txBox="1"/>
          <p:nvPr/>
        </p:nvSpPr>
        <p:spPr>
          <a:xfrm>
            <a:off x="1304592" y="8868747"/>
            <a:ext cx="2730619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e. BMI &lt;25: mortality on waitlist</a:t>
            </a:r>
            <a:endParaRPr lang="en-US" sz="1488" dirty="0"/>
          </a:p>
        </p:txBody>
      </p:sp>
      <p:grpSp>
        <p:nvGrpSpPr>
          <p:cNvPr id="638" name="Group 637">
            <a:extLst>
              <a:ext uri="{FF2B5EF4-FFF2-40B4-BE49-F238E27FC236}">
                <a16:creationId xmlns:a16="http://schemas.microsoft.com/office/drawing/2014/main" id="{494329EE-9F46-BE04-1564-D697C3922E50}"/>
              </a:ext>
            </a:extLst>
          </p:cNvPr>
          <p:cNvGrpSpPr>
            <a:grpSpLocks noChangeAspect="1"/>
          </p:cNvGrpSpPr>
          <p:nvPr/>
        </p:nvGrpSpPr>
        <p:grpSpPr>
          <a:xfrm>
            <a:off x="5061932" y="9103777"/>
            <a:ext cx="4776497" cy="3571875"/>
            <a:chOff x="0" y="0"/>
            <a:chExt cx="9144000" cy="6858000"/>
          </a:xfrm>
        </p:grpSpPr>
        <p:sp>
          <p:nvSpPr>
            <p:cNvPr id="639" name="rc3">
              <a:extLst>
                <a:ext uri="{FF2B5EF4-FFF2-40B4-BE49-F238E27FC236}">
                  <a16:creationId xmlns:a16="http://schemas.microsoft.com/office/drawing/2014/main" id="{9EE3B3A9-DFA0-D17F-3336-9CFBBD876AEE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40" name="rc4">
              <a:extLst>
                <a:ext uri="{FF2B5EF4-FFF2-40B4-BE49-F238E27FC236}">
                  <a16:creationId xmlns:a16="http://schemas.microsoft.com/office/drawing/2014/main" id="{D7F57F2C-B740-7A20-654E-A83BD19BAEB4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41" name="rc5">
              <a:extLst>
                <a:ext uri="{FF2B5EF4-FFF2-40B4-BE49-F238E27FC236}">
                  <a16:creationId xmlns:a16="http://schemas.microsoft.com/office/drawing/2014/main" id="{3DD43E46-BC94-B62F-A203-EB0C4BB02838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42" name="rc6">
              <a:extLst>
                <a:ext uri="{FF2B5EF4-FFF2-40B4-BE49-F238E27FC236}">
                  <a16:creationId xmlns:a16="http://schemas.microsoft.com/office/drawing/2014/main" id="{6C3BAFC4-A334-14C8-5C4A-F62D782633C6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43" name="rc7">
              <a:extLst>
                <a:ext uri="{FF2B5EF4-FFF2-40B4-BE49-F238E27FC236}">
                  <a16:creationId xmlns:a16="http://schemas.microsoft.com/office/drawing/2014/main" id="{C58C535F-5E6C-7501-F9C4-51A2BD036F4D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44" name="rc8">
              <a:extLst>
                <a:ext uri="{FF2B5EF4-FFF2-40B4-BE49-F238E27FC236}">
                  <a16:creationId xmlns:a16="http://schemas.microsoft.com/office/drawing/2014/main" id="{8B20EE93-6AF5-D471-9B68-DB703C098629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45" name="rc9">
              <a:extLst>
                <a:ext uri="{FF2B5EF4-FFF2-40B4-BE49-F238E27FC236}">
                  <a16:creationId xmlns:a16="http://schemas.microsoft.com/office/drawing/2014/main" id="{AD561427-3CAF-8C90-073B-7DD5C73A42F6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646" name="pl18">
              <a:extLst>
                <a:ext uri="{FF2B5EF4-FFF2-40B4-BE49-F238E27FC236}">
                  <a16:creationId xmlns:a16="http://schemas.microsoft.com/office/drawing/2014/main" id="{8A264CF5-2AE2-EA67-BFEC-58DBC49C8F44}"/>
                </a:ext>
              </a:extLst>
            </p:cNvPr>
            <p:cNvSpPr/>
            <p:nvPr/>
          </p:nvSpPr>
          <p:spPr>
            <a:xfrm>
              <a:off x="776476" y="3534137"/>
              <a:ext cx="8228345" cy="0"/>
            </a:xfrm>
            <a:custGeom>
              <a:avLst/>
              <a:gdLst/>
              <a:ahLst/>
              <a:cxnLst/>
              <a:rect l="0" t="0" r="0" b="0"/>
              <a:pathLst>
                <a:path w="8228345">
                  <a:moveTo>
                    <a:pt x="0" y="0"/>
                  </a:moveTo>
                  <a:lnTo>
                    <a:pt x="8228345" y="0"/>
                  </a:lnTo>
                  <a:lnTo>
                    <a:pt x="8228345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47" name="pl23">
              <a:extLst>
                <a:ext uri="{FF2B5EF4-FFF2-40B4-BE49-F238E27FC236}">
                  <a16:creationId xmlns:a16="http://schemas.microsoft.com/office/drawing/2014/main" id="{FEBBBA5C-D2F5-79A8-BF5F-05E56A825CFF}"/>
                </a:ext>
              </a:extLst>
            </p:cNvPr>
            <p:cNvSpPr/>
            <p:nvPr/>
          </p:nvSpPr>
          <p:spPr>
            <a:xfrm>
              <a:off x="1150492" y="139178"/>
              <a:ext cx="0" cy="3556623"/>
            </a:xfrm>
            <a:custGeom>
              <a:avLst/>
              <a:gdLst/>
              <a:ahLst/>
              <a:cxnLst/>
              <a:rect l="0" t="0" r="0" b="0"/>
              <a:pathLst>
                <a:path h="3556623">
                  <a:moveTo>
                    <a:pt x="0" y="35566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48" name="pl27">
              <a:extLst>
                <a:ext uri="{FF2B5EF4-FFF2-40B4-BE49-F238E27FC236}">
                  <a16:creationId xmlns:a16="http://schemas.microsoft.com/office/drawing/2014/main" id="{1C3233A1-E0EF-6EA6-09A9-1DF0B13AB507}"/>
                </a:ext>
              </a:extLst>
            </p:cNvPr>
            <p:cNvSpPr/>
            <p:nvPr/>
          </p:nvSpPr>
          <p:spPr>
            <a:xfrm>
              <a:off x="1150492" y="2815627"/>
              <a:ext cx="4324236" cy="718509"/>
            </a:xfrm>
            <a:custGeom>
              <a:avLst/>
              <a:gdLst/>
              <a:ahLst/>
              <a:cxnLst/>
              <a:rect l="0" t="0" r="0" b="0"/>
              <a:pathLst>
                <a:path w="4324236" h="718509">
                  <a:moveTo>
                    <a:pt x="0" y="718509"/>
                  </a:moveTo>
                  <a:lnTo>
                    <a:pt x="61482" y="718509"/>
                  </a:lnTo>
                  <a:lnTo>
                    <a:pt x="61482" y="718509"/>
                  </a:lnTo>
                  <a:lnTo>
                    <a:pt x="71729" y="718509"/>
                  </a:lnTo>
                  <a:lnTo>
                    <a:pt x="71729" y="718509"/>
                  </a:lnTo>
                  <a:lnTo>
                    <a:pt x="389386" y="718509"/>
                  </a:lnTo>
                  <a:lnTo>
                    <a:pt x="389386" y="718509"/>
                  </a:lnTo>
                  <a:lnTo>
                    <a:pt x="1014453" y="718509"/>
                  </a:lnTo>
                  <a:lnTo>
                    <a:pt x="1014453" y="718509"/>
                  </a:lnTo>
                  <a:lnTo>
                    <a:pt x="2100636" y="718509"/>
                  </a:lnTo>
                  <a:lnTo>
                    <a:pt x="2100636" y="359254"/>
                  </a:lnTo>
                  <a:lnTo>
                    <a:pt x="2490022" y="359254"/>
                  </a:lnTo>
                  <a:lnTo>
                    <a:pt x="2490022" y="0"/>
                  </a:lnTo>
                  <a:lnTo>
                    <a:pt x="3074101" y="0"/>
                  </a:lnTo>
                  <a:lnTo>
                    <a:pt x="3074101" y="0"/>
                  </a:lnTo>
                  <a:lnTo>
                    <a:pt x="3863120" y="0"/>
                  </a:lnTo>
                  <a:lnTo>
                    <a:pt x="3863120" y="0"/>
                  </a:lnTo>
                  <a:lnTo>
                    <a:pt x="4324236" y="0"/>
                  </a:lnTo>
                  <a:lnTo>
                    <a:pt x="4324236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49" name="pl28">
              <a:extLst>
                <a:ext uri="{FF2B5EF4-FFF2-40B4-BE49-F238E27FC236}">
                  <a16:creationId xmlns:a16="http://schemas.microsoft.com/office/drawing/2014/main" id="{E7A9F4DA-A707-20F2-DEAD-496C11D282E8}"/>
                </a:ext>
              </a:extLst>
            </p:cNvPr>
            <p:cNvSpPr/>
            <p:nvPr/>
          </p:nvSpPr>
          <p:spPr>
            <a:xfrm>
              <a:off x="1150492" y="3318249"/>
              <a:ext cx="7265126" cy="215887"/>
            </a:xfrm>
            <a:custGeom>
              <a:avLst/>
              <a:gdLst/>
              <a:ahLst/>
              <a:cxnLst/>
              <a:rect l="0" t="0" r="0" b="0"/>
              <a:pathLst>
                <a:path w="7265126" h="215887">
                  <a:moveTo>
                    <a:pt x="0" y="215887"/>
                  </a:moveTo>
                  <a:lnTo>
                    <a:pt x="61482" y="215887"/>
                  </a:lnTo>
                  <a:lnTo>
                    <a:pt x="61482" y="215887"/>
                  </a:lnTo>
                  <a:lnTo>
                    <a:pt x="112717" y="215887"/>
                  </a:lnTo>
                  <a:lnTo>
                    <a:pt x="112717" y="215887"/>
                  </a:lnTo>
                  <a:lnTo>
                    <a:pt x="194693" y="215887"/>
                  </a:lnTo>
                  <a:lnTo>
                    <a:pt x="194693" y="215887"/>
                  </a:lnTo>
                  <a:lnTo>
                    <a:pt x="204940" y="215887"/>
                  </a:lnTo>
                  <a:lnTo>
                    <a:pt x="204940" y="215887"/>
                  </a:lnTo>
                  <a:lnTo>
                    <a:pt x="297163" y="215887"/>
                  </a:lnTo>
                  <a:lnTo>
                    <a:pt x="297163" y="215887"/>
                  </a:lnTo>
                  <a:lnTo>
                    <a:pt x="409880" y="215887"/>
                  </a:lnTo>
                  <a:lnTo>
                    <a:pt x="409880" y="215887"/>
                  </a:lnTo>
                  <a:lnTo>
                    <a:pt x="440621" y="215887"/>
                  </a:lnTo>
                  <a:lnTo>
                    <a:pt x="440621" y="143925"/>
                  </a:lnTo>
                  <a:lnTo>
                    <a:pt x="491856" y="143925"/>
                  </a:lnTo>
                  <a:lnTo>
                    <a:pt x="491856" y="143925"/>
                  </a:lnTo>
                  <a:lnTo>
                    <a:pt x="502103" y="143925"/>
                  </a:lnTo>
                  <a:lnTo>
                    <a:pt x="502103" y="143925"/>
                  </a:lnTo>
                  <a:lnTo>
                    <a:pt x="737784" y="143925"/>
                  </a:lnTo>
                  <a:lnTo>
                    <a:pt x="737784" y="143925"/>
                  </a:lnTo>
                  <a:lnTo>
                    <a:pt x="830007" y="143925"/>
                  </a:lnTo>
                  <a:lnTo>
                    <a:pt x="830007" y="143925"/>
                  </a:lnTo>
                  <a:lnTo>
                    <a:pt x="840254" y="143925"/>
                  </a:lnTo>
                  <a:lnTo>
                    <a:pt x="840254" y="71962"/>
                  </a:lnTo>
                  <a:lnTo>
                    <a:pt x="1034947" y="71962"/>
                  </a:lnTo>
                  <a:lnTo>
                    <a:pt x="1034947" y="71962"/>
                  </a:lnTo>
                  <a:lnTo>
                    <a:pt x="1096429" y="71962"/>
                  </a:lnTo>
                  <a:lnTo>
                    <a:pt x="1096429" y="71962"/>
                  </a:lnTo>
                  <a:lnTo>
                    <a:pt x="1168158" y="71962"/>
                  </a:lnTo>
                  <a:lnTo>
                    <a:pt x="1168158" y="71962"/>
                  </a:lnTo>
                  <a:lnTo>
                    <a:pt x="1178405" y="71962"/>
                  </a:lnTo>
                  <a:lnTo>
                    <a:pt x="1178405" y="71962"/>
                  </a:lnTo>
                  <a:lnTo>
                    <a:pt x="1280875" y="71962"/>
                  </a:lnTo>
                  <a:lnTo>
                    <a:pt x="1280875" y="71962"/>
                  </a:lnTo>
                  <a:lnTo>
                    <a:pt x="1434580" y="71962"/>
                  </a:lnTo>
                  <a:lnTo>
                    <a:pt x="1434580" y="71962"/>
                  </a:lnTo>
                  <a:lnTo>
                    <a:pt x="1485815" y="71962"/>
                  </a:lnTo>
                  <a:lnTo>
                    <a:pt x="1485815" y="71962"/>
                  </a:lnTo>
                  <a:lnTo>
                    <a:pt x="1649767" y="71962"/>
                  </a:lnTo>
                  <a:lnTo>
                    <a:pt x="1649767" y="0"/>
                  </a:lnTo>
                  <a:lnTo>
                    <a:pt x="1711249" y="0"/>
                  </a:lnTo>
                  <a:lnTo>
                    <a:pt x="1711249" y="0"/>
                  </a:lnTo>
                  <a:lnTo>
                    <a:pt x="1741990" y="0"/>
                  </a:lnTo>
                  <a:lnTo>
                    <a:pt x="1741990" y="0"/>
                  </a:lnTo>
                  <a:lnTo>
                    <a:pt x="1752237" y="0"/>
                  </a:lnTo>
                  <a:lnTo>
                    <a:pt x="1752237" y="0"/>
                  </a:lnTo>
                  <a:lnTo>
                    <a:pt x="1905942" y="0"/>
                  </a:lnTo>
                  <a:lnTo>
                    <a:pt x="1905942" y="0"/>
                  </a:lnTo>
                  <a:lnTo>
                    <a:pt x="1957177" y="0"/>
                  </a:lnTo>
                  <a:lnTo>
                    <a:pt x="1957177" y="0"/>
                  </a:lnTo>
                  <a:lnTo>
                    <a:pt x="2356811" y="0"/>
                  </a:lnTo>
                  <a:lnTo>
                    <a:pt x="2356811" y="0"/>
                  </a:lnTo>
                  <a:lnTo>
                    <a:pt x="2571998" y="0"/>
                  </a:lnTo>
                  <a:lnTo>
                    <a:pt x="2571998" y="0"/>
                  </a:lnTo>
                  <a:lnTo>
                    <a:pt x="2705209" y="0"/>
                  </a:lnTo>
                  <a:lnTo>
                    <a:pt x="2705209" y="0"/>
                  </a:lnTo>
                  <a:lnTo>
                    <a:pt x="2735950" y="0"/>
                  </a:lnTo>
                  <a:lnTo>
                    <a:pt x="2735950" y="0"/>
                  </a:lnTo>
                  <a:lnTo>
                    <a:pt x="2787185" y="0"/>
                  </a:lnTo>
                  <a:lnTo>
                    <a:pt x="2787185" y="0"/>
                  </a:lnTo>
                  <a:lnTo>
                    <a:pt x="3340523" y="0"/>
                  </a:lnTo>
                  <a:lnTo>
                    <a:pt x="3340523" y="0"/>
                  </a:lnTo>
                  <a:lnTo>
                    <a:pt x="3842626" y="0"/>
                  </a:lnTo>
                  <a:lnTo>
                    <a:pt x="3842626" y="0"/>
                  </a:lnTo>
                  <a:lnTo>
                    <a:pt x="3863120" y="0"/>
                  </a:lnTo>
                  <a:lnTo>
                    <a:pt x="3863120" y="0"/>
                  </a:lnTo>
                  <a:lnTo>
                    <a:pt x="4590658" y="0"/>
                  </a:lnTo>
                  <a:lnTo>
                    <a:pt x="4590658" y="0"/>
                  </a:lnTo>
                  <a:lnTo>
                    <a:pt x="5092761" y="0"/>
                  </a:lnTo>
                  <a:lnTo>
                    <a:pt x="5092761" y="0"/>
                  </a:lnTo>
                  <a:lnTo>
                    <a:pt x="5512888" y="0"/>
                  </a:lnTo>
                  <a:lnTo>
                    <a:pt x="5512888" y="0"/>
                  </a:lnTo>
                  <a:lnTo>
                    <a:pt x="6045733" y="0"/>
                  </a:lnTo>
                  <a:lnTo>
                    <a:pt x="6045733" y="0"/>
                  </a:lnTo>
                  <a:lnTo>
                    <a:pt x="6527342" y="0"/>
                  </a:lnTo>
                  <a:lnTo>
                    <a:pt x="6527342" y="0"/>
                  </a:lnTo>
                  <a:lnTo>
                    <a:pt x="7008951" y="0"/>
                  </a:lnTo>
                  <a:lnTo>
                    <a:pt x="7008951" y="0"/>
                  </a:lnTo>
                  <a:lnTo>
                    <a:pt x="7049939" y="0"/>
                  </a:lnTo>
                  <a:lnTo>
                    <a:pt x="7049939" y="0"/>
                  </a:lnTo>
                  <a:lnTo>
                    <a:pt x="7265126" y="0"/>
                  </a:lnTo>
                  <a:lnTo>
                    <a:pt x="7265126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50" name="rc29">
              <a:extLst>
                <a:ext uri="{FF2B5EF4-FFF2-40B4-BE49-F238E27FC236}">
                  <a16:creationId xmlns:a16="http://schemas.microsoft.com/office/drawing/2014/main" id="{C38953B5-A36C-F772-8202-608F6F8EC282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51" name="tx30">
              <a:extLst>
                <a:ext uri="{FF2B5EF4-FFF2-40B4-BE49-F238E27FC236}">
                  <a16:creationId xmlns:a16="http://schemas.microsoft.com/office/drawing/2014/main" id="{CC4D54A6-389B-343D-1FB5-721838D46C45}"/>
                </a:ext>
              </a:extLst>
            </p:cNvPr>
            <p:cNvSpPr/>
            <p:nvPr/>
          </p:nvSpPr>
          <p:spPr>
            <a:xfrm>
              <a:off x="466667" y="3486760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652" name="tx31">
              <a:extLst>
                <a:ext uri="{FF2B5EF4-FFF2-40B4-BE49-F238E27FC236}">
                  <a16:creationId xmlns:a16="http://schemas.microsoft.com/office/drawing/2014/main" id="{571E64A4-72C9-4CDA-8273-B54CD63682EF}"/>
                </a:ext>
              </a:extLst>
            </p:cNvPr>
            <p:cNvSpPr/>
            <p:nvPr/>
          </p:nvSpPr>
          <p:spPr>
            <a:xfrm>
              <a:off x="466667" y="2678436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653" name="tx32">
              <a:extLst>
                <a:ext uri="{FF2B5EF4-FFF2-40B4-BE49-F238E27FC236}">
                  <a16:creationId xmlns:a16="http://schemas.microsoft.com/office/drawing/2014/main" id="{29301A47-2B3E-69D1-34A6-8F04E8F9FCD9}"/>
                </a:ext>
              </a:extLst>
            </p:cNvPr>
            <p:cNvSpPr/>
            <p:nvPr/>
          </p:nvSpPr>
          <p:spPr>
            <a:xfrm>
              <a:off x="466667" y="1870113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654" name="tx33">
              <a:extLst>
                <a:ext uri="{FF2B5EF4-FFF2-40B4-BE49-F238E27FC236}">
                  <a16:creationId xmlns:a16="http://schemas.microsoft.com/office/drawing/2014/main" id="{644D4741-CAB3-C99F-AD14-7DC1A6ED14B1}"/>
                </a:ext>
              </a:extLst>
            </p:cNvPr>
            <p:cNvSpPr/>
            <p:nvPr/>
          </p:nvSpPr>
          <p:spPr>
            <a:xfrm>
              <a:off x="466667" y="1061789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655" name="tx34">
              <a:extLst>
                <a:ext uri="{FF2B5EF4-FFF2-40B4-BE49-F238E27FC236}">
                  <a16:creationId xmlns:a16="http://schemas.microsoft.com/office/drawing/2014/main" id="{20D5B36D-300B-005A-7150-8AD65960B5A1}"/>
                </a:ext>
              </a:extLst>
            </p:cNvPr>
            <p:cNvSpPr/>
            <p:nvPr/>
          </p:nvSpPr>
          <p:spPr>
            <a:xfrm>
              <a:off x="466667" y="253465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0</a:t>
              </a:r>
            </a:p>
          </p:txBody>
        </p:sp>
        <p:sp>
          <p:nvSpPr>
            <p:cNvPr id="656" name="pl35">
              <a:extLst>
                <a:ext uri="{FF2B5EF4-FFF2-40B4-BE49-F238E27FC236}">
                  <a16:creationId xmlns:a16="http://schemas.microsoft.com/office/drawing/2014/main" id="{5D62F1DA-2EED-7C92-EF69-B174E817AC4F}"/>
                </a:ext>
              </a:extLst>
            </p:cNvPr>
            <p:cNvSpPr/>
            <p:nvPr/>
          </p:nvSpPr>
          <p:spPr>
            <a:xfrm>
              <a:off x="741682" y="353413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57" name="pl36">
              <a:extLst>
                <a:ext uri="{FF2B5EF4-FFF2-40B4-BE49-F238E27FC236}">
                  <a16:creationId xmlns:a16="http://schemas.microsoft.com/office/drawing/2014/main" id="{90ED780F-7BF9-14A7-6201-77848E6B13BA}"/>
                </a:ext>
              </a:extLst>
            </p:cNvPr>
            <p:cNvSpPr/>
            <p:nvPr/>
          </p:nvSpPr>
          <p:spPr>
            <a:xfrm>
              <a:off x="741682" y="2725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58" name="pl37">
              <a:extLst>
                <a:ext uri="{FF2B5EF4-FFF2-40B4-BE49-F238E27FC236}">
                  <a16:creationId xmlns:a16="http://schemas.microsoft.com/office/drawing/2014/main" id="{8A59B16D-3D36-96F0-2AAC-1C7ABF9FAB31}"/>
                </a:ext>
              </a:extLst>
            </p:cNvPr>
            <p:cNvSpPr/>
            <p:nvPr/>
          </p:nvSpPr>
          <p:spPr>
            <a:xfrm>
              <a:off x="741682" y="19174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59" name="pl38">
              <a:extLst>
                <a:ext uri="{FF2B5EF4-FFF2-40B4-BE49-F238E27FC236}">
                  <a16:creationId xmlns:a16="http://schemas.microsoft.com/office/drawing/2014/main" id="{C8AB816E-832F-02EE-E49E-A69AF7F2347D}"/>
                </a:ext>
              </a:extLst>
            </p:cNvPr>
            <p:cNvSpPr/>
            <p:nvPr/>
          </p:nvSpPr>
          <p:spPr>
            <a:xfrm>
              <a:off x="741682" y="11091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60" name="pl39">
              <a:extLst>
                <a:ext uri="{FF2B5EF4-FFF2-40B4-BE49-F238E27FC236}">
                  <a16:creationId xmlns:a16="http://schemas.microsoft.com/office/drawing/2014/main" id="{DAA43CDA-464C-30D4-C6B1-CC475F2197C2}"/>
                </a:ext>
              </a:extLst>
            </p:cNvPr>
            <p:cNvSpPr/>
            <p:nvPr/>
          </p:nvSpPr>
          <p:spPr>
            <a:xfrm>
              <a:off x="741682" y="3008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61" name="pl40">
              <a:extLst>
                <a:ext uri="{FF2B5EF4-FFF2-40B4-BE49-F238E27FC236}">
                  <a16:creationId xmlns:a16="http://schemas.microsoft.com/office/drawing/2014/main" id="{4F0FE195-845C-C5B9-58A0-B8875049FE4F}"/>
                </a:ext>
              </a:extLst>
            </p:cNvPr>
            <p:cNvSpPr/>
            <p:nvPr/>
          </p:nvSpPr>
          <p:spPr>
            <a:xfrm>
              <a:off x="1150492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62" name="pl41">
              <a:extLst>
                <a:ext uri="{FF2B5EF4-FFF2-40B4-BE49-F238E27FC236}">
                  <a16:creationId xmlns:a16="http://schemas.microsoft.com/office/drawing/2014/main" id="{8DBD610A-6ED0-FECB-E1FE-D807246E055C}"/>
                </a:ext>
              </a:extLst>
            </p:cNvPr>
            <p:cNvSpPr/>
            <p:nvPr/>
          </p:nvSpPr>
          <p:spPr>
            <a:xfrm>
              <a:off x="3199893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63" name="pl42">
              <a:extLst>
                <a:ext uri="{FF2B5EF4-FFF2-40B4-BE49-F238E27FC236}">
                  <a16:creationId xmlns:a16="http://schemas.microsoft.com/office/drawing/2014/main" id="{8E47083D-6E9D-8ABD-F3C7-7D1711C5FBF8}"/>
                </a:ext>
              </a:extLst>
            </p:cNvPr>
            <p:cNvSpPr/>
            <p:nvPr/>
          </p:nvSpPr>
          <p:spPr>
            <a:xfrm>
              <a:off x="5249294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64" name="pl43">
              <a:extLst>
                <a:ext uri="{FF2B5EF4-FFF2-40B4-BE49-F238E27FC236}">
                  <a16:creationId xmlns:a16="http://schemas.microsoft.com/office/drawing/2014/main" id="{4A87689F-5CB5-8486-1427-B0506DECF233}"/>
                </a:ext>
              </a:extLst>
            </p:cNvPr>
            <p:cNvSpPr/>
            <p:nvPr/>
          </p:nvSpPr>
          <p:spPr>
            <a:xfrm>
              <a:off x="7298695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65" name="tx44">
              <a:extLst>
                <a:ext uri="{FF2B5EF4-FFF2-40B4-BE49-F238E27FC236}">
                  <a16:creationId xmlns:a16="http://schemas.microsoft.com/office/drawing/2014/main" id="{3F8AB22D-8375-0D8E-44A7-0E531A092927}"/>
                </a:ext>
              </a:extLst>
            </p:cNvPr>
            <p:cNvSpPr/>
            <p:nvPr/>
          </p:nvSpPr>
          <p:spPr>
            <a:xfrm>
              <a:off x="1115176" y="3756509"/>
              <a:ext cx="70631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66" name="tx45">
              <a:extLst>
                <a:ext uri="{FF2B5EF4-FFF2-40B4-BE49-F238E27FC236}">
                  <a16:creationId xmlns:a16="http://schemas.microsoft.com/office/drawing/2014/main" id="{0F1D1753-1C9D-4DD7-26C8-65525085EC52}"/>
                </a:ext>
              </a:extLst>
            </p:cNvPr>
            <p:cNvSpPr/>
            <p:nvPr/>
          </p:nvSpPr>
          <p:spPr>
            <a:xfrm>
              <a:off x="3093946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667" name="tx46">
              <a:extLst>
                <a:ext uri="{FF2B5EF4-FFF2-40B4-BE49-F238E27FC236}">
                  <a16:creationId xmlns:a16="http://schemas.microsoft.com/office/drawing/2014/main" id="{8E0ABBB1-19AA-C7A1-DF66-947F04B8FE7D}"/>
                </a:ext>
              </a:extLst>
            </p:cNvPr>
            <p:cNvSpPr/>
            <p:nvPr/>
          </p:nvSpPr>
          <p:spPr>
            <a:xfrm>
              <a:off x="5143347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668" name="tx47">
              <a:extLst>
                <a:ext uri="{FF2B5EF4-FFF2-40B4-BE49-F238E27FC236}">
                  <a16:creationId xmlns:a16="http://schemas.microsoft.com/office/drawing/2014/main" id="{81907F89-87BA-266B-3C56-335EE677E029}"/>
                </a:ext>
              </a:extLst>
            </p:cNvPr>
            <p:cNvSpPr/>
            <p:nvPr/>
          </p:nvSpPr>
          <p:spPr>
            <a:xfrm>
              <a:off x="7192748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669" name="tx48">
              <a:extLst>
                <a:ext uri="{FF2B5EF4-FFF2-40B4-BE49-F238E27FC236}">
                  <a16:creationId xmlns:a16="http://schemas.microsoft.com/office/drawing/2014/main" id="{F395F328-39AF-97E4-0196-F8355C7C7785}"/>
                </a:ext>
              </a:extLst>
            </p:cNvPr>
            <p:cNvSpPr/>
            <p:nvPr/>
          </p:nvSpPr>
          <p:spPr>
            <a:xfrm>
              <a:off x="4081991" y="3878778"/>
              <a:ext cx="1617315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 to mortality (Days)</a:t>
              </a:r>
            </a:p>
          </p:txBody>
        </p:sp>
        <p:sp>
          <p:nvSpPr>
            <p:cNvPr id="670" name="rc50">
              <a:extLst>
                <a:ext uri="{FF2B5EF4-FFF2-40B4-BE49-F238E27FC236}">
                  <a16:creationId xmlns:a16="http://schemas.microsoft.com/office/drawing/2014/main" id="{0FF7AFE7-AFA9-B4B4-2CDA-57A6EBF0CC45}"/>
                </a:ext>
              </a:extLst>
            </p:cNvPr>
            <p:cNvSpPr/>
            <p:nvPr/>
          </p:nvSpPr>
          <p:spPr>
            <a:xfrm>
              <a:off x="4276688" y="4189554"/>
              <a:ext cx="1227921" cy="358634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671" name="rc51">
              <a:extLst>
                <a:ext uri="{FF2B5EF4-FFF2-40B4-BE49-F238E27FC236}">
                  <a16:creationId xmlns:a16="http://schemas.microsoft.com/office/drawing/2014/main" id="{2922B8EF-74A3-275E-3DB0-C40A02178E99}"/>
                </a:ext>
              </a:extLst>
            </p:cNvPr>
            <p:cNvSpPr/>
            <p:nvPr/>
          </p:nvSpPr>
          <p:spPr>
            <a:xfrm>
              <a:off x="4415866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672" name="pl52">
              <a:extLst>
                <a:ext uri="{FF2B5EF4-FFF2-40B4-BE49-F238E27FC236}">
                  <a16:creationId xmlns:a16="http://schemas.microsoft.com/office/drawing/2014/main" id="{C3CA3312-3ACF-AF6B-513C-99113638420D}"/>
                </a:ext>
              </a:extLst>
            </p:cNvPr>
            <p:cNvSpPr/>
            <p:nvPr/>
          </p:nvSpPr>
          <p:spPr>
            <a:xfrm>
              <a:off x="4437812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73" name="rc53">
              <a:extLst>
                <a:ext uri="{FF2B5EF4-FFF2-40B4-BE49-F238E27FC236}">
                  <a16:creationId xmlns:a16="http://schemas.microsoft.com/office/drawing/2014/main" id="{E854EBE8-9FD8-5BFE-7A14-0F21649250D9}"/>
                </a:ext>
              </a:extLst>
            </p:cNvPr>
            <p:cNvSpPr/>
            <p:nvPr/>
          </p:nvSpPr>
          <p:spPr>
            <a:xfrm>
              <a:off x="4926900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674" name="pl54">
              <a:extLst>
                <a:ext uri="{FF2B5EF4-FFF2-40B4-BE49-F238E27FC236}">
                  <a16:creationId xmlns:a16="http://schemas.microsoft.com/office/drawing/2014/main" id="{960A94FF-8A8E-43F3-7C48-A857A4D56D4F}"/>
                </a:ext>
              </a:extLst>
            </p:cNvPr>
            <p:cNvSpPr/>
            <p:nvPr/>
          </p:nvSpPr>
          <p:spPr>
            <a:xfrm>
              <a:off x="4948846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75" name="tx55">
              <a:extLst>
                <a:ext uri="{FF2B5EF4-FFF2-40B4-BE49-F238E27FC236}">
                  <a16:creationId xmlns:a16="http://schemas.microsoft.com/office/drawing/2014/main" id="{186325CE-75E9-CD39-5F00-951A383B2CF3}"/>
                </a:ext>
              </a:extLst>
            </p:cNvPr>
            <p:cNvSpPr/>
            <p:nvPr/>
          </p:nvSpPr>
          <p:spPr>
            <a:xfrm>
              <a:off x="4704911" y="4321929"/>
              <a:ext cx="162346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676" name="tx56">
              <a:extLst>
                <a:ext uri="{FF2B5EF4-FFF2-40B4-BE49-F238E27FC236}">
                  <a16:creationId xmlns:a16="http://schemas.microsoft.com/office/drawing/2014/main" id="{1A34DBE5-1BA6-62CE-79A8-8EAD86154872}"/>
                </a:ext>
              </a:extLst>
            </p:cNvPr>
            <p:cNvSpPr/>
            <p:nvPr/>
          </p:nvSpPr>
          <p:spPr>
            <a:xfrm>
              <a:off x="5215945" y="4321929"/>
              <a:ext cx="218839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  <p:sp>
          <p:nvSpPr>
            <p:cNvPr id="677" name="rc57">
              <a:extLst>
                <a:ext uri="{FF2B5EF4-FFF2-40B4-BE49-F238E27FC236}">
                  <a16:creationId xmlns:a16="http://schemas.microsoft.com/office/drawing/2014/main" id="{3F5C257E-0A0B-E76A-1B19-56920AA66A11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78" name="rc58">
              <a:extLst>
                <a:ext uri="{FF2B5EF4-FFF2-40B4-BE49-F238E27FC236}">
                  <a16:creationId xmlns:a16="http://schemas.microsoft.com/office/drawing/2014/main" id="{806DBAC9-E9A0-29B5-138F-2DC1AF0480A9}"/>
                </a:ext>
              </a:extLst>
            </p:cNvPr>
            <p:cNvSpPr/>
            <p:nvPr/>
          </p:nvSpPr>
          <p:spPr>
            <a:xfrm>
              <a:off x="776476" y="4996549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679" name="tx59">
              <a:extLst>
                <a:ext uri="{FF2B5EF4-FFF2-40B4-BE49-F238E27FC236}">
                  <a16:creationId xmlns:a16="http://schemas.microsoft.com/office/drawing/2014/main" id="{57BDCE2D-90B5-3886-569B-425D16C84B9E}"/>
                </a:ext>
              </a:extLst>
            </p:cNvPr>
            <p:cNvSpPr/>
            <p:nvPr/>
          </p:nvSpPr>
          <p:spPr>
            <a:xfrm>
              <a:off x="1115323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80" name="tx60">
              <a:extLst>
                <a:ext uri="{FF2B5EF4-FFF2-40B4-BE49-F238E27FC236}">
                  <a16:creationId xmlns:a16="http://schemas.microsoft.com/office/drawing/2014/main" id="{BC73C82B-84C7-1F7B-5631-B010197BF0B2}"/>
                </a:ext>
              </a:extLst>
            </p:cNvPr>
            <p:cNvSpPr/>
            <p:nvPr/>
          </p:nvSpPr>
          <p:spPr>
            <a:xfrm>
              <a:off x="1115323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</a:t>
              </a:r>
            </a:p>
          </p:txBody>
        </p:sp>
        <p:sp>
          <p:nvSpPr>
            <p:cNvPr id="681" name="tx61">
              <a:extLst>
                <a:ext uri="{FF2B5EF4-FFF2-40B4-BE49-F238E27FC236}">
                  <a16:creationId xmlns:a16="http://schemas.microsoft.com/office/drawing/2014/main" id="{FCBA78E4-5511-60B8-98C7-AC8624622AF8}"/>
                </a:ext>
              </a:extLst>
            </p:cNvPr>
            <p:cNvSpPr/>
            <p:nvPr/>
          </p:nvSpPr>
          <p:spPr>
            <a:xfrm>
              <a:off x="3164724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82" name="tx62">
              <a:extLst>
                <a:ext uri="{FF2B5EF4-FFF2-40B4-BE49-F238E27FC236}">
                  <a16:creationId xmlns:a16="http://schemas.microsoft.com/office/drawing/2014/main" id="{D5B1A7F6-F01E-89F7-CB1E-DCCAD0BB74FC}"/>
                </a:ext>
              </a:extLst>
            </p:cNvPr>
            <p:cNvSpPr/>
            <p:nvPr/>
          </p:nvSpPr>
          <p:spPr>
            <a:xfrm>
              <a:off x="3164724" y="5134179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683" name="tx63">
              <a:extLst>
                <a:ext uri="{FF2B5EF4-FFF2-40B4-BE49-F238E27FC236}">
                  <a16:creationId xmlns:a16="http://schemas.microsoft.com/office/drawing/2014/main" id="{9978EFA7-BABB-A933-8015-BD9973C7128F}"/>
                </a:ext>
              </a:extLst>
            </p:cNvPr>
            <p:cNvSpPr/>
            <p:nvPr/>
          </p:nvSpPr>
          <p:spPr>
            <a:xfrm>
              <a:off x="5214125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684" name="tx64">
              <a:extLst>
                <a:ext uri="{FF2B5EF4-FFF2-40B4-BE49-F238E27FC236}">
                  <a16:creationId xmlns:a16="http://schemas.microsoft.com/office/drawing/2014/main" id="{8A4F39C7-24DB-A812-2F7D-3CB14A5BAE5F}"/>
                </a:ext>
              </a:extLst>
            </p:cNvPr>
            <p:cNvSpPr/>
            <p:nvPr/>
          </p:nvSpPr>
          <p:spPr>
            <a:xfrm>
              <a:off x="5214125" y="5134117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685" name="tx65">
              <a:extLst>
                <a:ext uri="{FF2B5EF4-FFF2-40B4-BE49-F238E27FC236}">
                  <a16:creationId xmlns:a16="http://schemas.microsoft.com/office/drawing/2014/main" id="{01A89915-D948-EF77-5289-AA54EFD1C507}"/>
                </a:ext>
              </a:extLst>
            </p:cNvPr>
            <p:cNvSpPr/>
            <p:nvPr/>
          </p:nvSpPr>
          <p:spPr>
            <a:xfrm>
              <a:off x="7263526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686" name="tx66">
              <a:extLst>
                <a:ext uri="{FF2B5EF4-FFF2-40B4-BE49-F238E27FC236}">
                  <a16:creationId xmlns:a16="http://schemas.microsoft.com/office/drawing/2014/main" id="{6E881C6E-711E-F2B6-F477-627B6263E41A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87" name="tx67">
              <a:extLst>
                <a:ext uri="{FF2B5EF4-FFF2-40B4-BE49-F238E27FC236}">
                  <a16:creationId xmlns:a16="http://schemas.microsoft.com/office/drawing/2014/main" id="{FF1017C6-C581-8403-C5B4-DBB3AD20B55E}"/>
                </a:ext>
              </a:extLst>
            </p:cNvPr>
            <p:cNvSpPr/>
            <p:nvPr/>
          </p:nvSpPr>
          <p:spPr>
            <a:xfrm>
              <a:off x="7263526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688" name="tx68">
              <a:extLst>
                <a:ext uri="{FF2B5EF4-FFF2-40B4-BE49-F238E27FC236}">
                  <a16:creationId xmlns:a16="http://schemas.microsoft.com/office/drawing/2014/main" id="{419F2682-9755-A96A-6C43-3A39E1176E8F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89" name="tx69">
              <a:extLst>
                <a:ext uri="{FF2B5EF4-FFF2-40B4-BE49-F238E27FC236}">
                  <a16:creationId xmlns:a16="http://schemas.microsoft.com/office/drawing/2014/main" id="{7C8B7C8F-C865-34F4-8AFA-235B7ED3C566}"/>
                </a:ext>
              </a:extLst>
            </p:cNvPr>
            <p:cNvSpPr/>
            <p:nvPr/>
          </p:nvSpPr>
          <p:spPr>
            <a:xfrm>
              <a:off x="325591" y="5438152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690" name="tx70">
              <a:extLst>
                <a:ext uri="{FF2B5EF4-FFF2-40B4-BE49-F238E27FC236}">
                  <a16:creationId xmlns:a16="http://schemas.microsoft.com/office/drawing/2014/main" id="{6D8ADF49-4380-DBAC-CE7E-96B0E0776158}"/>
                </a:ext>
              </a:extLst>
            </p:cNvPr>
            <p:cNvSpPr/>
            <p:nvPr/>
          </p:nvSpPr>
          <p:spPr>
            <a:xfrm>
              <a:off x="311638" y="5132811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691" name="tx71">
              <a:extLst>
                <a:ext uri="{FF2B5EF4-FFF2-40B4-BE49-F238E27FC236}">
                  <a16:creationId xmlns:a16="http://schemas.microsoft.com/office/drawing/2014/main" id="{123AEFF3-D9E6-98F3-B958-A3CD41B2F806}"/>
                </a:ext>
              </a:extLst>
            </p:cNvPr>
            <p:cNvSpPr/>
            <p:nvPr/>
          </p:nvSpPr>
          <p:spPr>
            <a:xfrm>
              <a:off x="776476" y="4827633"/>
              <a:ext cx="17452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692" name="rc72">
              <a:extLst>
                <a:ext uri="{FF2B5EF4-FFF2-40B4-BE49-F238E27FC236}">
                  <a16:creationId xmlns:a16="http://schemas.microsoft.com/office/drawing/2014/main" id="{277C4220-40AB-0C91-2806-6996CD7F9167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93" name="rc73">
              <a:extLst>
                <a:ext uri="{FF2B5EF4-FFF2-40B4-BE49-F238E27FC236}">
                  <a16:creationId xmlns:a16="http://schemas.microsoft.com/office/drawing/2014/main" id="{7D55473B-A253-B25B-7226-25AF77AFE889}"/>
                </a:ext>
              </a:extLst>
            </p:cNvPr>
            <p:cNvSpPr/>
            <p:nvPr/>
          </p:nvSpPr>
          <p:spPr>
            <a:xfrm>
              <a:off x="776476" y="6081865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694" name="tx74">
              <a:extLst>
                <a:ext uri="{FF2B5EF4-FFF2-40B4-BE49-F238E27FC236}">
                  <a16:creationId xmlns:a16="http://schemas.microsoft.com/office/drawing/2014/main" id="{1860A4E5-0BDF-315A-CD07-5E462074632B}"/>
                </a:ext>
              </a:extLst>
            </p:cNvPr>
            <p:cNvSpPr/>
            <p:nvPr/>
          </p:nvSpPr>
          <p:spPr>
            <a:xfrm>
              <a:off x="1115323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95" name="tx75">
              <a:extLst>
                <a:ext uri="{FF2B5EF4-FFF2-40B4-BE49-F238E27FC236}">
                  <a16:creationId xmlns:a16="http://schemas.microsoft.com/office/drawing/2014/main" id="{CC8CFA54-0608-6E47-B46A-53E588A3F207}"/>
                </a:ext>
              </a:extLst>
            </p:cNvPr>
            <p:cNvSpPr/>
            <p:nvPr/>
          </p:nvSpPr>
          <p:spPr>
            <a:xfrm>
              <a:off x="1080154" y="6217890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6</a:t>
              </a:r>
            </a:p>
          </p:txBody>
        </p:sp>
        <p:sp>
          <p:nvSpPr>
            <p:cNvPr id="696" name="tx76">
              <a:extLst>
                <a:ext uri="{FF2B5EF4-FFF2-40B4-BE49-F238E27FC236}">
                  <a16:creationId xmlns:a16="http://schemas.microsoft.com/office/drawing/2014/main" id="{6E2A560F-CE0D-D8C3-D929-9329A2539C91}"/>
                </a:ext>
              </a:extLst>
            </p:cNvPr>
            <p:cNvSpPr/>
            <p:nvPr/>
          </p:nvSpPr>
          <p:spPr>
            <a:xfrm>
              <a:off x="3164724" y="6523169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697" name="tx77">
              <a:extLst>
                <a:ext uri="{FF2B5EF4-FFF2-40B4-BE49-F238E27FC236}">
                  <a16:creationId xmlns:a16="http://schemas.microsoft.com/office/drawing/2014/main" id="{027FF78E-30A7-E5D6-6828-EA56C97B6E57}"/>
                </a:ext>
              </a:extLst>
            </p:cNvPr>
            <p:cNvSpPr/>
            <p:nvPr/>
          </p:nvSpPr>
          <p:spPr>
            <a:xfrm>
              <a:off x="3129555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1</a:t>
              </a:r>
            </a:p>
          </p:txBody>
        </p:sp>
        <p:sp>
          <p:nvSpPr>
            <p:cNvPr id="698" name="tx78">
              <a:extLst>
                <a:ext uri="{FF2B5EF4-FFF2-40B4-BE49-F238E27FC236}">
                  <a16:creationId xmlns:a16="http://schemas.microsoft.com/office/drawing/2014/main" id="{42CA9727-AB5F-14F6-F304-5B72B666D8C7}"/>
                </a:ext>
              </a:extLst>
            </p:cNvPr>
            <p:cNvSpPr/>
            <p:nvPr/>
          </p:nvSpPr>
          <p:spPr>
            <a:xfrm>
              <a:off x="5214125" y="6523169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699" name="tx79">
              <a:extLst>
                <a:ext uri="{FF2B5EF4-FFF2-40B4-BE49-F238E27FC236}">
                  <a16:creationId xmlns:a16="http://schemas.microsoft.com/office/drawing/2014/main" id="{35966AEA-6C70-2C0A-36CA-37E317D832CD}"/>
                </a:ext>
              </a:extLst>
            </p:cNvPr>
            <p:cNvSpPr/>
            <p:nvPr/>
          </p:nvSpPr>
          <p:spPr>
            <a:xfrm>
              <a:off x="5178956" y="6217828"/>
              <a:ext cx="140675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3</a:t>
              </a:r>
            </a:p>
          </p:txBody>
        </p:sp>
        <p:sp>
          <p:nvSpPr>
            <p:cNvPr id="700" name="tx80">
              <a:extLst>
                <a:ext uri="{FF2B5EF4-FFF2-40B4-BE49-F238E27FC236}">
                  <a16:creationId xmlns:a16="http://schemas.microsoft.com/office/drawing/2014/main" id="{01745F50-1FBE-0B36-939A-AD86858FCC6F}"/>
                </a:ext>
              </a:extLst>
            </p:cNvPr>
            <p:cNvSpPr/>
            <p:nvPr/>
          </p:nvSpPr>
          <p:spPr>
            <a:xfrm>
              <a:off x="7263526" y="6523169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701" name="tx81">
              <a:extLst>
                <a:ext uri="{FF2B5EF4-FFF2-40B4-BE49-F238E27FC236}">
                  <a16:creationId xmlns:a16="http://schemas.microsoft.com/office/drawing/2014/main" id="{E10D1C7C-581E-9FEF-2E4B-D22189C42325}"/>
                </a:ext>
              </a:extLst>
            </p:cNvPr>
            <p:cNvSpPr/>
            <p:nvPr/>
          </p:nvSpPr>
          <p:spPr>
            <a:xfrm>
              <a:off x="7263526" y="6217890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</a:t>
              </a:r>
            </a:p>
          </p:txBody>
        </p:sp>
        <p:sp>
          <p:nvSpPr>
            <p:cNvPr id="702" name="tx82">
              <a:extLst>
                <a:ext uri="{FF2B5EF4-FFF2-40B4-BE49-F238E27FC236}">
                  <a16:creationId xmlns:a16="http://schemas.microsoft.com/office/drawing/2014/main" id="{4A83FB9A-8C4E-9B58-29B9-4975D710ECF2}"/>
                </a:ext>
              </a:extLst>
            </p:cNvPr>
            <p:cNvSpPr/>
            <p:nvPr/>
          </p:nvSpPr>
          <p:spPr>
            <a:xfrm>
              <a:off x="325591" y="6523468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703" name="tx83">
              <a:extLst>
                <a:ext uri="{FF2B5EF4-FFF2-40B4-BE49-F238E27FC236}">
                  <a16:creationId xmlns:a16="http://schemas.microsoft.com/office/drawing/2014/main" id="{556D56FA-B2B6-1136-B6B5-96620667C7C8}"/>
                </a:ext>
              </a:extLst>
            </p:cNvPr>
            <p:cNvSpPr/>
            <p:nvPr/>
          </p:nvSpPr>
          <p:spPr>
            <a:xfrm>
              <a:off x="311638" y="6218127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704" name="tx84">
              <a:extLst>
                <a:ext uri="{FF2B5EF4-FFF2-40B4-BE49-F238E27FC236}">
                  <a16:creationId xmlns:a16="http://schemas.microsoft.com/office/drawing/2014/main" id="{031B41B2-659D-C461-5707-E7929700599B}"/>
                </a:ext>
              </a:extLst>
            </p:cNvPr>
            <p:cNvSpPr/>
            <p:nvPr/>
          </p:nvSpPr>
          <p:spPr>
            <a:xfrm>
              <a:off x="776476" y="5912949"/>
              <a:ext cx="23525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</p:grpSp>
      <p:sp>
        <p:nvSpPr>
          <p:cNvPr id="705" name="tx47">
            <a:extLst>
              <a:ext uri="{FF2B5EF4-FFF2-40B4-BE49-F238E27FC236}">
                <a16:creationId xmlns:a16="http://schemas.microsoft.com/office/drawing/2014/main" id="{75B1D800-705A-2C31-20BB-6B35C3DB5744}"/>
              </a:ext>
            </a:extLst>
          </p:cNvPr>
          <p:cNvSpPr/>
          <p:nvPr/>
        </p:nvSpPr>
        <p:spPr>
          <a:xfrm rot="16200000">
            <a:off x="4797288" y="10554012"/>
            <a:ext cx="917105" cy="76130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>
              <a:lnSpc>
                <a:spcPts val="992"/>
              </a:lnSpc>
            </a:pPr>
            <a:r>
              <a:rPr sz="992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rPr>
              <a:t>Cumulative Incidence</a:t>
            </a:r>
            <a:r>
              <a:rPr lang="en-US" sz="992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rPr>
              <a:t> of Mortality (%)</a:t>
            </a:r>
            <a:endParaRPr sz="992" dirty="0">
              <a:solidFill>
                <a:srgbClr val="000000">
                  <a:alpha val="100000"/>
                </a:srgbClr>
              </a:solidFill>
              <a:latin typeface="Arial"/>
              <a:cs typeface="Arial"/>
            </a:endParaRPr>
          </a:p>
        </p:txBody>
      </p:sp>
      <p:sp>
        <p:nvSpPr>
          <p:cNvPr id="706" name="TextBox 705">
            <a:extLst>
              <a:ext uri="{FF2B5EF4-FFF2-40B4-BE49-F238E27FC236}">
                <a16:creationId xmlns:a16="http://schemas.microsoft.com/office/drawing/2014/main" id="{C7E8980F-4413-E34D-C86C-33B6E495BE22}"/>
              </a:ext>
            </a:extLst>
          </p:cNvPr>
          <p:cNvSpPr txBox="1"/>
          <p:nvPr/>
        </p:nvSpPr>
        <p:spPr>
          <a:xfrm>
            <a:off x="5520276" y="9237875"/>
            <a:ext cx="3142172" cy="6519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9" b="1" dirty="0">
                <a:latin typeface="Arial" panose="020B0604020202020204" pitchFamily="34" charset="0"/>
                <a:cs typeface="Arial" panose="020B0604020202020204" pitchFamily="34" charset="0"/>
              </a:rPr>
              <a:t>Potential Living Donor  Total   Event   HR (95% CI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No                                      9          2        Reference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Yes                                    46        3      0.31 (0.06 – 1.66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Gray K-Sample Test P-value: 0.1828       </a:t>
            </a:r>
          </a:p>
        </p:txBody>
      </p:sp>
      <p:sp>
        <p:nvSpPr>
          <p:cNvPr id="707" name="pl48">
            <a:extLst>
              <a:ext uri="{FF2B5EF4-FFF2-40B4-BE49-F238E27FC236}">
                <a16:creationId xmlns:a16="http://schemas.microsoft.com/office/drawing/2014/main" id="{49F7291F-96A3-0078-8187-C931EAEAB6B0}"/>
              </a:ext>
            </a:extLst>
          </p:cNvPr>
          <p:cNvSpPr/>
          <p:nvPr/>
        </p:nvSpPr>
        <p:spPr>
          <a:xfrm>
            <a:off x="8190425" y="9600851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708" name="pl50">
            <a:extLst>
              <a:ext uri="{FF2B5EF4-FFF2-40B4-BE49-F238E27FC236}">
                <a16:creationId xmlns:a16="http://schemas.microsoft.com/office/drawing/2014/main" id="{531613FD-4FDB-5A08-9B21-3F95E63CD940}"/>
              </a:ext>
            </a:extLst>
          </p:cNvPr>
          <p:cNvSpPr/>
          <p:nvPr/>
        </p:nvSpPr>
        <p:spPr>
          <a:xfrm>
            <a:off x="8183231" y="9763805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709" name="TextBox 708">
            <a:extLst>
              <a:ext uri="{FF2B5EF4-FFF2-40B4-BE49-F238E27FC236}">
                <a16:creationId xmlns:a16="http://schemas.microsoft.com/office/drawing/2014/main" id="{98C5AB5F-519E-D75A-B8A1-8D4477BC5013}"/>
              </a:ext>
            </a:extLst>
          </p:cNvPr>
          <p:cNvSpPr txBox="1"/>
          <p:nvPr/>
        </p:nvSpPr>
        <p:spPr>
          <a:xfrm>
            <a:off x="6193562" y="8881724"/>
            <a:ext cx="2866234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f.  BMI &gt;= 25: mortality on waitlist</a:t>
            </a:r>
            <a:endParaRPr lang="en-US" sz="1488" dirty="0"/>
          </a:p>
        </p:txBody>
      </p:sp>
    </p:spTree>
    <p:extLst>
      <p:ext uri="{BB962C8B-B14F-4D97-AF65-F5344CB8AC3E}">
        <p14:creationId xmlns:p14="http://schemas.microsoft.com/office/powerpoint/2010/main" val="26735378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4" name="pl48">
            <a:extLst>
              <a:ext uri="{FF2B5EF4-FFF2-40B4-BE49-F238E27FC236}">
                <a16:creationId xmlns:a16="http://schemas.microsoft.com/office/drawing/2014/main" id="{A6272018-0631-2A89-D3A5-C14DD8FDD086}"/>
              </a:ext>
            </a:extLst>
          </p:cNvPr>
          <p:cNvSpPr>
            <a:spLocks noChangeAspect="1"/>
          </p:cNvSpPr>
          <p:nvPr/>
        </p:nvSpPr>
        <p:spPr>
          <a:xfrm>
            <a:off x="5475292" y="2030039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285" name="pl50">
            <a:extLst>
              <a:ext uri="{FF2B5EF4-FFF2-40B4-BE49-F238E27FC236}">
                <a16:creationId xmlns:a16="http://schemas.microsoft.com/office/drawing/2014/main" id="{48AA1383-98A6-ABB5-E10A-891F65ACA886}"/>
              </a:ext>
            </a:extLst>
          </p:cNvPr>
          <p:cNvSpPr>
            <a:spLocks noChangeAspect="1"/>
          </p:cNvSpPr>
          <p:nvPr/>
        </p:nvSpPr>
        <p:spPr>
          <a:xfrm>
            <a:off x="5475292" y="2156316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286" name="TextBox 285">
            <a:extLst>
              <a:ext uri="{FF2B5EF4-FFF2-40B4-BE49-F238E27FC236}">
                <a16:creationId xmlns:a16="http://schemas.microsoft.com/office/drawing/2014/main" id="{A75EA8EE-FE95-828D-9B7C-E1475333B3D1}"/>
              </a:ext>
            </a:extLst>
          </p:cNvPr>
          <p:cNvSpPr txBox="1"/>
          <p:nvPr/>
        </p:nvSpPr>
        <p:spPr>
          <a:xfrm>
            <a:off x="884556" y="1308268"/>
            <a:ext cx="3566875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88" b="1" dirty="0"/>
              <a:t>a. MALE: Liver-related mortality on waitlist</a:t>
            </a:r>
            <a:endParaRPr lang="en-US" sz="1488" dirty="0"/>
          </a:p>
        </p:txBody>
      </p:sp>
      <p:sp>
        <p:nvSpPr>
          <p:cNvPr id="424" name="TextBox 423">
            <a:extLst>
              <a:ext uri="{FF2B5EF4-FFF2-40B4-BE49-F238E27FC236}">
                <a16:creationId xmlns:a16="http://schemas.microsoft.com/office/drawing/2014/main" id="{D6ABF3E3-DFFB-F858-BC13-503F6981CBA7}"/>
              </a:ext>
            </a:extLst>
          </p:cNvPr>
          <p:cNvSpPr txBox="1"/>
          <p:nvPr/>
        </p:nvSpPr>
        <p:spPr>
          <a:xfrm>
            <a:off x="5778082" y="1284336"/>
            <a:ext cx="3799310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b.  FEMALE: Liver-related mortality on waitlist</a:t>
            </a:r>
            <a:endParaRPr lang="en-US" sz="1488" dirty="0"/>
          </a:p>
        </p:txBody>
      </p:sp>
      <p:sp>
        <p:nvSpPr>
          <p:cNvPr id="493" name="Title 1">
            <a:extLst>
              <a:ext uri="{FF2B5EF4-FFF2-40B4-BE49-F238E27FC236}">
                <a16:creationId xmlns:a16="http://schemas.microsoft.com/office/drawing/2014/main" id="{2D266D8C-F4F6-F5B2-39CF-BD655A44205A}"/>
              </a:ext>
            </a:extLst>
          </p:cNvPr>
          <p:cNvSpPr txBox="1">
            <a:spLocks/>
          </p:cNvSpPr>
          <p:nvPr/>
        </p:nvSpPr>
        <p:spPr>
          <a:xfrm>
            <a:off x="429118" y="5007109"/>
            <a:ext cx="4599151" cy="571493"/>
          </a:xfrm>
          <a:prstGeom prst="rect">
            <a:avLst/>
          </a:prstGeom>
        </p:spPr>
        <p:txBody>
          <a:bodyPr vert="horz" lIns="75605" tIns="37802" rIns="75605" bIns="37802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488" b="1" dirty="0">
                <a:latin typeface="+mn-lt"/>
              </a:rPr>
              <a:t>c. Age &lt;60: Liver-related mortality on waitlist</a:t>
            </a:r>
          </a:p>
        </p:txBody>
      </p:sp>
      <p:sp>
        <p:nvSpPr>
          <p:cNvPr id="564" name="TextBox 563">
            <a:extLst>
              <a:ext uri="{FF2B5EF4-FFF2-40B4-BE49-F238E27FC236}">
                <a16:creationId xmlns:a16="http://schemas.microsoft.com/office/drawing/2014/main" id="{463FD226-202C-B0B7-17BE-E5300A85A045}"/>
              </a:ext>
            </a:extLst>
          </p:cNvPr>
          <p:cNvSpPr txBox="1"/>
          <p:nvPr/>
        </p:nvSpPr>
        <p:spPr>
          <a:xfrm>
            <a:off x="5282546" y="5097614"/>
            <a:ext cx="3930307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d.  Age &gt;= 60: Liver-related mortality on waitlist</a:t>
            </a:r>
            <a:endParaRPr lang="en-US" sz="1488" dirty="0"/>
          </a:p>
        </p:txBody>
      </p:sp>
      <p:sp>
        <p:nvSpPr>
          <p:cNvPr id="636" name="TextBox 635">
            <a:extLst>
              <a:ext uri="{FF2B5EF4-FFF2-40B4-BE49-F238E27FC236}">
                <a16:creationId xmlns:a16="http://schemas.microsoft.com/office/drawing/2014/main" id="{35878DB7-2189-892A-4D01-1D4B0A332DAF}"/>
              </a:ext>
            </a:extLst>
          </p:cNvPr>
          <p:cNvSpPr txBox="1"/>
          <p:nvPr/>
        </p:nvSpPr>
        <p:spPr>
          <a:xfrm>
            <a:off x="850454" y="8897231"/>
            <a:ext cx="3768852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e. BMI &lt;25: Liver-related mortality on waitlist</a:t>
            </a:r>
            <a:endParaRPr lang="en-US" sz="1488" dirty="0"/>
          </a:p>
        </p:txBody>
      </p:sp>
      <p:sp>
        <p:nvSpPr>
          <p:cNvPr id="709" name="TextBox 708">
            <a:extLst>
              <a:ext uri="{FF2B5EF4-FFF2-40B4-BE49-F238E27FC236}">
                <a16:creationId xmlns:a16="http://schemas.microsoft.com/office/drawing/2014/main" id="{98C5AB5F-519E-D75A-B8A1-8D4477BC5013}"/>
              </a:ext>
            </a:extLst>
          </p:cNvPr>
          <p:cNvSpPr txBox="1"/>
          <p:nvPr/>
        </p:nvSpPr>
        <p:spPr>
          <a:xfrm>
            <a:off x="5681882" y="8909942"/>
            <a:ext cx="3904467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f.  BMI &gt;= 25: Liver-related mortality on waitlist</a:t>
            </a:r>
            <a:endParaRPr lang="en-US" sz="1488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75855D9C-09DD-4400-1259-92FA470F8ED0}"/>
              </a:ext>
            </a:extLst>
          </p:cNvPr>
          <p:cNvGrpSpPr>
            <a:grpSpLocks noChangeAspect="1"/>
          </p:cNvGrpSpPr>
          <p:nvPr/>
        </p:nvGrpSpPr>
        <p:grpSpPr>
          <a:xfrm>
            <a:off x="4873663" y="1593085"/>
            <a:ext cx="5492065" cy="3571875"/>
            <a:chOff x="0" y="0"/>
            <a:chExt cx="9144000" cy="6858000"/>
          </a:xfrm>
        </p:grpSpPr>
        <p:sp>
          <p:nvSpPr>
            <p:cNvPr id="3" name="rc3">
              <a:extLst>
                <a:ext uri="{FF2B5EF4-FFF2-40B4-BE49-F238E27FC236}">
                  <a16:creationId xmlns:a16="http://schemas.microsoft.com/office/drawing/2014/main" id="{F8C861DD-B2AB-29E1-8774-0CDF62C7FD64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" name="rc4">
              <a:extLst>
                <a:ext uri="{FF2B5EF4-FFF2-40B4-BE49-F238E27FC236}">
                  <a16:creationId xmlns:a16="http://schemas.microsoft.com/office/drawing/2014/main" id="{BD2502E8-5A65-76C7-DE6B-30473235A963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" name="rc5">
              <a:extLst>
                <a:ext uri="{FF2B5EF4-FFF2-40B4-BE49-F238E27FC236}">
                  <a16:creationId xmlns:a16="http://schemas.microsoft.com/office/drawing/2014/main" id="{97B97A2D-CAD9-1FFE-77A9-8B44396D5778}"/>
                </a:ext>
              </a:extLst>
            </p:cNvPr>
            <p:cNvSpPr/>
            <p:nvPr/>
          </p:nvSpPr>
          <p:spPr>
            <a:xfrm>
              <a:off x="69589" y="69590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" name="rc6">
              <a:extLst>
                <a:ext uri="{FF2B5EF4-FFF2-40B4-BE49-F238E27FC236}">
                  <a16:creationId xmlns:a16="http://schemas.microsoft.com/office/drawing/2014/main" id="{686F0F57-50CA-7DCF-0EA4-A069429D8512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" name="rc7">
              <a:extLst>
                <a:ext uri="{FF2B5EF4-FFF2-40B4-BE49-F238E27FC236}">
                  <a16:creationId xmlns:a16="http://schemas.microsoft.com/office/drawing/2014/main" id="{98546DA7-02EF-B40B-6E5C-8BB1551395F2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" name="rc8">
              <a:extLst>
                <a:ext uri="{FF2B5EF4-FFF2-40B4-BE49-F238E27FC236}">
                  <a16:creationId xmlns:a16="http://schemas.microsoft.com/office/drawing/2014/main" id="{E6DCED4C-2580-AD4C-E63D-CB0C7D950AD3}"/>
                </a:ext>
              </a:extLst>
            </p:cNvPr>
            <p:cNvSpPr/>
            <p:nvPr/>
          </p:nvSpPr>
          <p:spPr>
            <a:xfrm>
              <a:off x="69591" y="69590"/>
              <a:ext cx="8346029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" name="rc9">
              <a:extLst>
                <a:ext uri="{FF2B5EF4-FFF2-40B4-BE49-F238E27FC236}">
                  <a16:creationId xmlns:a16="http://schemas.microsoft.com/office/drawing/2014/main" id="{611A1DF7-49A8-79CD-67F1-B742D0131768}"/>
                </a:ext>
              </a:extLst>
            </p:cNvPr>
            <p:cNvSpPr/>
            <p:nvPr/>
          </p:nvSpPr>
          <p:spPr>
            <a:xfrm>
              <a:off x="776477" y="69731"/>
              <a:ext cx="7695181" cy="355662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10" name="pl18">
              <a:extLst>
                <a:ext uri="{FF2B5EF4-FFF2-40B4-BE49-F238E27FC236}">
                  <a16:creationId xmlns:a16="http://schemas.microsoft.com/office/drawing/2014/main" id="{FB163897-6833-56FE-8F96-B7872659DD9A}"/>
                </a:ext>
              </a:extLst>
            </p:cNvPr>
            <p:cNvSpPr/>
            <p:nvPr/>
          </p:nvSpPr>
          <p:spPr>
            <a:xfrm>
              <a:off x="776476" y="3534137"/>
              <a:ext cx="8228345" cy="0"/>
            </a:xfrm>
            <a:custGeom>
              <a:avLst/>
              <a:gdLst/>
              <a:ahLst/>
              <a:cxnLst/>
              <a:rect l="0" t="0" r="0" b="0"/>
              <a:pathLst>
                <a:path w="8228345">
                  <a:moveTo>
                    <a:pt x="0" y="0"/>
                  </a:moveTo>
                  <a:lnTo>
                    <a:pt x="8228345" y="0"/>
                  </a:lnTo>
                  <a:lnTo>
                    <a:pt x="8228345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11" name="pl23">
              <a:extLst>
                <a:ext uri="{FF2B5EF4-FFF2-40B4-BE49-F238E27FC236}">
                  <a16:creationId xmlns:a16="http://schemas.microsoft.com/office/drawing/2014/main" id="{588E1CE4-489D-58BD-5BAD-0D7E65E6166C}"/>
                </a:ext>
              </a:extLst>
            </p:cNvPr>
            <p:cNvSpPr/>
            <p:nvPr/>
          </p:nvSpPr>
          <p:spPr>
            <a:xfrm>
              <a:off x="1150492" y="139178"/>
              <a:ext cx="0" cy="3556623"/>
            </a:xfrm>
            <a:custGeom>
              <a:avLst/>
              <a:gdLst/>
              <a:ahLst/>
              <a:cxnLst/>
              <a:rect l="0" t="0" r="0" b="0"/>
              <a:pathLst>
                <a:path h="3556623">
                  <a:moveTo>
                    <a:pt x="0" y="35566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12" name="pl27">
              <a:extLst>
                <a:ext uri="{FF2B5EF4-FFF2-40B4-BE49-F238E27FC236}">
                  <a16:creationId xmlns:a16="http://schemas.microsoft.com/office/drawing/2014/main" id="{FB77AC0A-6BD0-7AA0-BBCA-1774EFEA5603}"/>
                </a:ext>
              </a:extLst>
            </p:cNvPr>
            <p:cNvSpPr/>
            <p:nvPr/>
          </p:nvSpPr>
          <p:spPr>
            <a:xfrm>
              <a:off x="1150492" y="2402484"/>
              <a:ext cx="4354977" cy="1131653"/>
            </a:xfrm>
            <a:custGeom>
              <a:avLst/>
              <a:gdLst/>
              <a:ahLst/>
              <a:cxnLst/>
              <a:rect l="0" t="0" r="0" b="0"/>
              <a:pathLst>
                <a:path w="4354977" h="1131653">
                  <a:moveTo>
                    <a:pt x="0" y="1131653"/>
                  </a:moveTo>
                  <a:lnTo>
                    <a:pt x="51235" y="1131653"/>
                  </a:lnTo>
                  <a:lnTo>
                    <a:pt x="51235" y="808323"/>
                  </a:lnTo>
                  <a:lnTo>
                    <a:pt x="71729" y="808323"/>
                  </a:lnTo>
                  <a:lnTo>
                    <a:pt x="71729" y="808323"/>
                  </a:lnTo>
                  <a:lnTo>
                    <a:pt x="1014453" y="808323"/>
                  </a:lnTo>
                  <a:lnTo>
                    <a:pt x="1014453" y="808323"/>
                  </a:lnTo>
                  <a:lnTo>
                    <a:pt x="1250134" y="808323"/>
                  </a:lnTo>
                  <a:lnTo>
                    <a:pt x="1250134" y="808323"/>
                  </a:lnTo>
                  <a:lnTo>
                    <a:pt x="2100636" y="808323"/>
                  </a:lnTo>
                  <a:lnTo>
                    <a:pt x="2100636" y="484994"/>
                  </a:lnTo>
                  <a:lnTo>
                    <a:pt x="3074101" y="484994"/>
                  </a:lnTo>
                  <a:lnTo>
                    <a:pt x="3074101" y="484994"/>
                  </a:lnTo>
                  <a:lnTo>
                    <a:pt x="3863120" y="484994"/>
                  </a:lnTo>
                  <a:lnTo>
                    <a:pt x="3863120" y="484994"/>
                  </a:lnTo>
                  <a:lnTo>
                    <a:pt x="4027073" y="484994"/>
                  </a:lnTo>
                  <a:lnTo>
                    <a:pt x="4027073" y="484994"/>
                  </a:lnTo>
                  <a:lnTo>
                    <a:pt x="4273001" y="484994"/>
                  </a:lnTo>
                  <a:lnTo>
                    <a:pt x="4273001" y="484994"/>
                  </a:lnTo>
                  <a:lnTo>
                    <a:pt x="4354977" y="484994"/>
                  </a:lnTo>
                  <a:lnTo>
                    <a:pt x="4354977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13" name="pl28">
              <a:extLst>
                <a:ext uri="{FF2B5EF4-FFF2-40B4-BE49-F238E27FC236}">
                  <a16:creationId xmlns:a16="http://schemas.microsoft.com/office/drawing/2014/main" id="{6252097D-9AAC-F1C1-2290-3D863BFB164E}"/>
                </a:ext>
              </a:extLst>
            </p:cNvPr>
            <p:cNvSpPr/>
            <p:nvPr/>
          </p:nvSpPr>
          <p:spPr>
            <a:xfrm>
              <a:off x="1150492" y="3452957"/>
              <a:ext cx="7265126" cy="81180"/>
            </a:xfrm>
            <a:custGeom>
              <a:avLst/>
              <a:gdLst/>
              <a:ahLst/>
              <a:cxnLst/>
              <a:rect l="0" t="0" r="0" b="0"/>
              <a:pathLst>
                <a:path w="7265126" h="81180">
                  <a:moveTo>
                    <a:pt x="0" y="81180"/>
                  </a:moveTo>
                  <a:lnTo>
                    <a:pt x="10247" y="81180"/>
                  </a:lnTo>
                  <a:lnTo>
                    <a:pt x="10247" y="81180"/>
                  </a:lnTo>
                  <a:lnTo>
                    <a:pt x="71729" y="81180"/>
                  </a:lnTo>
                  <a:lnTo>
                    <a:pt x="71729" y="81180"/>
                  </a:lnTo>
                  <a:lnTo>
                    <a:pt x="112717" y="81180"/>
                  </a:lnTo>
                  <a:lnTo>
                    <a:pt x="112717" y="81180"/>
                  </a:lnTo>
                  <a:lnTo>
                    <a:pt x="194693" y="81180"/>
                  </a:lnTo>
                  <a:lnTo>
                    <a:pt x="194693" y="81180"/>
                  </a:lnTo>
                  <a:lnTo>
                    <a:pt x="256175" y="81180"/>
                  </a:lnTo>
                  <a:lnTo>
                    <a:pt x="256175" y="81180"/>
                  </a:lnTo>
                  <a:lnTo>
                    <a:pt x="297163" y="81180"/>
                  </a:lnTo>
                  <a:lnTo>
                    <a:pt x="297163" y="81180"/>
                  </a:lnTo>
                  <a:lnTo>
                    <a:pt x="389386" y="81180"/>
                  </a:lnTo>
                  <a:lnTo>
                    <a:pt x="389386" y="81180"/>
                  </a:lnTo>
                  <a:lnTo>
                    <a:pt x="409880" y="81180"/>
                  </a:lnTo>
                  <a:lnTo>
                    <a:pt x="409880" y="81180"/>
                  </a:lnTo>
                  <a:lnTo>
                    <a:pt x="522597" y="81180"/>
                  </a:lnTo>
                  <a:lnTo>
                    <a:pt x="522597" y="81180"/>
                  </a:lnTo>
                  <a:lnTo>
                    <a:pt x="635314" y="81180"/>
                  </a:lnTo>
                  <a:lnTo>
                    <a:pt x="635314" y="81180"/>
                  </a:lnTo>
                  <a:lnTo>
                    <a:pt x="737784" y="81180"/>
                  </a:lnTo>
                  <a:lnTo>
                    <a:pt x="737784" y="81180"/>
                  </a:lnTo>
                  <a:lnTo>
                    <a:pt x="830007" y="81180"/>
                  </a:lnTo>
                  <a:lnTo>
                    <a:pt x="830007" y="81180"/>
                  </a:lnTo>
                  <a:lnTo>
                    <a:pt x="922230" y="81180"/>
                  </a:lnTo>
                  <a:lnTo>
                    <a:pt x="922230" y="81180"/>
                  </a:lnTo>
                  <a:lnTo>
                    <a:pt x="1004206" y="81180"/>
                  </a:lnTo>
                  <a:lnTo>
                    <a:pt x="1004206" y="81180"/>
                  </a:lnTo>
                  <a:lnTo>
                    <a:pt x="1014453" y="81180"/>
                  </a:lnTo>
                  <a:lnTo>
                    <a:pt x="1014453" y="81180"/>
                  </a:lnTo>
                  <a:lnTo>
                    <a:pt x="1034947" y="81180"/>
                  </a:lnTo>
                  <a:lnTo>
                    <a:pt x="1034947" y="81180"/>
                  </a:lnTo>
                  <a:lnTo>
                    <a:pt x="1065688" y="81180"/>
                  </a:lnTo>
                  <a:lnTo>
                    <a:pt x="1065688" y="81180"/>
                  </a:lnTo>
                  <a:lnTo>
                    <a:pt x="1157911" y="81180"/>
                  </a:lnTo>
                  <a:lnTo>
                    <a:pt x="1157911" y="81180"/>
                  </a:lnTo>
                  <a:lnTo>
                    <a:pt x="1198899" y="81180"/>
                  </a:lnTo>
                  <a:lnTo>
                    <a:pt x="1198899" y="81180"/>
                  </a:lnTo>
                  <a:lnTo>
                    <a:pt x="1444827" y="81180"/>
                  </a:lnTo>
                  <a:lnTo>
                    <a:pt x="1444827" y="81180"/>
                  </a:lnTo>
                  <a:lnTo>
                    <a:pt x="1588285" y="81180"/>
                  </a:lnTo>
                  <a:lnTo>
                    <a:pt x="1588285" y="81180"/>
                  </a:lnTo>
                  <a:lnTo>
                    <a:pt x="1649767" y="81180"/>
                  </a:lnTo>
                  <a:lnTo>
                    <a:pt x="1649767" y="0"/>
                  </a:lnTo>
                  <a:lnTo>
                    <a:pt x="1762484" y="0"/>
                  </a:lnTo>
                  <a:lnTo>
                    <a:pt x="1762484" y="0"/>
                  </a:lnTo>
                  <a:lnTo>
                    <a:pt x="1864954" y="0"/>
                  </a:lnTo>
                  <a:lnTo>
                    <a:pt x="1864954" y="0"/>
                  </a:lnTo>
                  <a:lnTo>
                    <a:pt x="1895695" y="0"/>
                  </a:lnTo>
                  <a:lnTo>
                    <a:pt x="1895695" y="0"/>
                  </a:lnTo>
                  <a:lnTo>
                    <a:pt x="2285082" y="0"/>
                  </a:lnTo>
                  <a:lnTo>
                    <a:pt x="2285082" y="0"/>
                  </a:lnTo>
                  <a:lnTo>
                    <a:pt x="2408046" y="0"/>
                  </a:lnTo>
                  <a:lnTo>
                    <a:pt x="2408046" y="0"/>
                  </a:lnTo>
                  <a:lnTo>
                    <a:pt x="2735950" y="0"/>
                  </a:lnTo>
                  <a:lnTo>
                    <a:pt x="2735950" y="0"/>
                  </a:lnTo>
                  <a:lnTo>
                    <a:pt x="3217559" y="0"/>
                  </a:lnTo>
                  <a:lnTo>
                    <a:pt x="3217559" y="0"/>
                  </a:lnTo>
                  <a:lnTo>
                    <a:pt x="3842626" y="0"/>
                  </a:lnTo>
                  <a:lnTo>
                    <a:pt x="3842626" y="0"/>
                  </a:lnTo>
                  <a:lnTo>
                    <a:pt x="3863120" y="0"/>
                  </a:lnTo>
                  <a:lnTo>
                    <a:pt x="3863120" y="0"/>
                  </a:lnTo>
                  <a:lnTo>
                    <a:pt x="3873367" y="0"/>
                  </a:lnTo>
                  <a:lnTo>
                    <a:pt x="3873367" y="0"/>
                  </a:lnTo>
                  <a:lnTo>
                    <a:pt x="5092761" y="0"/>
                  </a:lnTo>
                  <a:lnTo>
                    <a:pt x="5092761" y="0"/>
                  </a:lnTo>
                  <a:lnTo>
                    <a:pt x="5379677" y="0"/>
                  </a:lnTo>
                  <a:lnTo>
                    <a:pt x="5379677" y="0"/>
                  </a:lnTo>
                  <a:lnTo>
                    <a:pt x="7008951" y="0"/>
                  </a:lnTo>
                  <a:lnTo>
                    <a:pt x="7008951" y="0"/>
                  </a:lnTo>
                  <a:lnTo>
                    <a:pt x="7049939" y="0"/>
                  </a:lnTo>
                  <a:lnTo>
                    <a:pt x="7049939" y="0"/>
                  </a:lnTo>
                  <a:lnTo>
                    <a:pt x="7265126" y="0"/>
                  </a:lnTo>
                  <a:lnTo>
                    <a:pt x="7265126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14" name="rc29">
              <a:extLst>
                <a:ext uri="{FF2B5EF4-FFF2-40B4-BE49-F238E27FC236}">
                  <a16:creationId xmlns:a16="http://schemas.microsoft.com/office/drawing/2014/main" id="{9C10B3CF-6117-4809-2AB9-36A0BC08B123}"/>
                </a:ext>
              </a:extLst>
            </p:cNvPr>
            <p:cNvSpPr/>
            <p:nvPr/>
          </p:nvSpPr>
          <p:spPr>
            <a:xfrm>
              <a:off x="776477" y="139178"/>
              <a:ext cx="7666980" cy="3556622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15" name="tx30">
              <a:extLst>
                <a:ext uri="{FF2B5EF4-FFF2-40B4-BE49-F238E27FC236}">
                  <a16:creationId xmlns:a16="http://schemas.microsoft.com/office/drawing/2014/main" id="{BF483477-02E1-FF89-638B-E0F597290D0F}"/>
                </a:ext>
              </a:extLst>
            </p:cNvPr>
            <p:cNvSpPr/>
            <p:nvPr/>
          </p:nvSpPr>
          <p:spPr>
            <a:xfrm>
              <a:off x="466667" y="3486760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16" name="tx31">
              <a:extLst>
                <a:ext uri="{FF2B5EF4-FFF2-40B4-BE49-F238E27FC236}">
                  <a16:creationId xmlns:a16="http://schemas.microsoft.com/office/drawing/2014/main" id="{5C70B5D0-14BE-9384-7049-4E38FFA801FA}"/>
                </a:ext>
              </a:extLst>
            </p:cNvPr>
            <p:cNvSpPr/>
            <p:nvPr/>
          </p:nvSpPr>
          <p:spPr>
            <a:xfrm>
              <a:off x="466667" y="2678436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17" name="tx32">
              <a:extLst>
                <a:ext uri="{FF2B5EF4-FFF2-40B4-BE49-F238E27FC236}">
                  <a16:creationId xmlns:a16="http://schemas.microsoft.com/office/drawing/2014/main" id="{D8BB5276-5FCE-E88A-CA71-B3474929F275}"/>
                </a:ext>
              </a:extLst>
            </p:cNvPr>
            <p:cNvSpPr/>
            <p:nvPr/>
          </p:nvSpPr>
          <p:spPr>
            <a:xfrm>
              <a:off x="466667" y="1870113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18" name="tx33">
              <a:extLst>
                <a:ext uri="{FF2B5EF4-FFF2-40B4-BE49-F238E27FC236}">
                  <a16:creationId xmlns:a16="http://schemas.microsoft.com/office/drawing/2014/main" id="{F9A4109F-E2F9-5157-D8F7-9B386F46FE8F}"/>
                </a:ext>
              </a:extLst>
            </p:cNvPr>
            <p:cNvSpPr/>
            <p:nvPr/>
          </p:nvSpPr>
          <p:spPr>
            <a:xfrm>
              <a:off x="466667" y="1061789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19" name="tx34">
              <a:extLst>
                <a:ext uri="{FF2B5EF4-FFF2-40B4-BE49-F238E27FC236}">
                  <a16:creationId xmlns:a16="http://schemas.microsoft.com/office/drawing/2014/main" id="{CB125F7E-1D88-1390-56F0-2EFFE6611F29}"/>
                </a:ext>
              </a:extLst>
            </p:cNvPr>
            <p:cNvSpPr/>
            <p:nvPr/>
          </p:nvSpPr>
          <p:spPr>
            <a:xfrm>
              <a:off x="466667" y="253465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0</a:t>
              </a:r>
            </a:p>
          </p:txBody>
        </p:sp>
        <p:sp>
          <p:nvSpPr>
            <p:cNvPr id="20" name="pl35">
              <a:extLst>
                <a:ext uri="{FF2B5EF4-FFF2-40B4-BE49-F238E27FC236}">
                  <a16:creationId xmlns:a16="http://schemas.microsoft.com/office/drawing/2014/main" id="{50EB63BC-BB7F-DEAE-1AAC-EB0FFA19BC03}"/>
                </a:ext>
              </a:extLst>
            </p:cNvPr>
            <p:cNvSpPr/>
            <p:nvPr/>
          </p:nvSpPr>
          <p:spPr>
            <a:xfrm>
              <a:off x="741682" y="353413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1" name="pl36">
              <a:extLst>
                <a:ext uri="{FF2B5EF4-FFF2-40B4-BE49-F238E27FC236}">
                  <a16:creationId xmlns:a16="http://schemas.microsoft.com/office/drawing/2014/main" id="{64B3DC84-72C7-B042-670C-D076FAA563E7}"/>
                </a:ext>
              </a:extLst>
            </p:cNvPr>
            <p:cNvSpPr/>
            <p:nvPr/>
          </p:nvSpPr>
          <p:spPr>
            <a:xfrm>
              <a:off x="741682" y="2725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2" name="pl37">
              <a:extLst>
                <a:ext uri="{FF2B5EF4-FFF2-40B4-BE49-F238E27FC236}">
                  <a16:creationId xmlns:a16="http://schemas.microsoft.com/office/drawing/2014/main" id="{91AB1EC3-3920-9ABB-EC40-4672FCC7F194}"/>
                </a:ext>
              </a:extLst>
            </p:cNvPr>
            <p:cNvSpPr/>
            <p:nvPr/>
          </p:nvSpPr>
          <p:spPr>
            <a:xfrm>
              <a:off x="741682" y="19174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3" name="pl38">
              <a:extLst>
                <a:ext uri="{FF2B5EF4-FFF2-40B4-BE49-F238E27FC236}">
                  <a16:creationId xmlns:a16="http://schemas.microsoft.com/office/drawing/2014/main" id="{460741F0-C282-8769-ACBE-5C24D603DC5B}"/>
                </a:ext>
              </a:extLst>
            </p:cNvPr>
            <p:cNvSpPr/>
            <p:nvPr/>
          </p:nvSpPr>
          <p:spPr>
            <a:xfrm>
              <a:off x="741682" y="11091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4" name="pl39">
              <a:extLst>
                <a:ext uri="{FF2B5EF4-FFF2-40B4-BE49-F238E27FC236}">
                  <a16:creationId xmlns:a16="http://schemas.microsoft.com/office/drawing/2014/main" id="{17703C09-65F1-23BC-2CA3-23E2FC218A18}"/>
                </a:ext>
              </a:extLst>
            </p:cNvPr>
            <p:cNvSpPr/>
            <p:nvPr/>
          </p:nvSpPr>
          <p:spPr>
            <a:xfrm>
              <a:off x="741682" y="3008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5" name="pl40">
              <a:extLst>
                <a:ext uri="{FF2B5EF4-FFF2-40B4-BE49-F238E27FC236}">
                  <a16:creationId xmlns:a16="http://schemas.microsoft.com/office/drawing/2014/main" id="{D7997F72-1B21-C7E2-D49C-B27885E01733}"/>
                </a:ext>
              </a:extLst>
            </p:cNvPr>
            <p:cNvSpPr/>
            <p:nvPr/>
          </p:nvSpPr>
          <p:spPr>
            <a:xfrm>
              <a:off x="1150492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6" name="pl41">
              <a:extLst>
                <a:ext uri="{FF2B5EF4-FFF2-40B4-BE49-F238E27FC236}">
                  <a16:creationId xmlns:a16="http://schemas.microsoft.com/office/drawing/2014/main" id="{B40AC52F-6CC8-1633-F6A9-DA67133528B2}"/>
                </a:ext>
              </a:extLst>
            </p:cNvPr>
            <p:cNvSpPr/>
            <p:nvPr/>
          </p:nvSpPr>
          <p:spPr>
            <a:xfrm>
              <a:off x="3199893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7" name="pl42">
              <a:extLst>
                <a:ext uri="{FF2B5EF4-FFF2-40B4-BE49-F238E27FC236}">
                  <a16:creationId xmlns:a16="http://schemas.microsoft.com/office/drawing/2014/main" id="{7254DC6F-B6A8-D14C-F437-EC9F7F64DAF8}"/>
                </a:ext>
              </a:extLst>
            </p:cNvPr>
            <p:cNvSpPr/>
            <p:nvPr/>
          </p:nvSpPr>
          <p:spPr>
            <a:xfrm>
              <a:off x="5249294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8" name="pl43">
              <a:extLst>
                <a:ext uri="{FF2B5EF4-FFF2-40B4-BE49-F238E27FC236}">
                  <a16:creationId xmlns:a16="http://schemas.microsoft.com/office/drawing/2014/main" id="{E7BB9640-B409-440B-F76F-D209E8701A0A}"/>
                </a:ext>
              </a:extLst>
            </p:cNvPr>
            <p:cNvSpPr/>
            <p:nvPr/>
          </p:nvSpPr>
          <p:spPr>
            <a:xfrm>
              <a:off x="7298695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9" name="tx44">
              <a:extLst>
                <a:ext uri="{FF2B5EF4-FFF2-40B4-BE49-F238E27FC236}">
                  <a16:creationId xmlns:a16="http://schemas.microsoft.com/office/drawing/2014/main" id="{F7B0AF53-3639-39EA-DDD5-E099316AF0C9}"/>
                </a:ext>
              </a:extLst>
            </p:cNvPr>
            <p:cNvSpPr/>
            <p:nvPr/>
          </p:nvSpPr>
          <p:spPr>
            <a:xfrm>
              <a:off x="1115176" y="3756509"/>
              <a:ext cx="70631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0" name="tx45">
              <a:extLst>
                <a:ext uri="{FF2B5EF4-FFF2-40B4-BE49-F238E27FC236}">
                  <a16:creationId xmlns:a16="http://schemas.microsoft.com/office/drawing/2014/main" id="{9B809B57-934E-378C-25B3-ECB7F711E6EE}"/>
                </a:ext>
              </a:extLst>
            </p:cNvPr>
            <p:cNvSpPr/>
            <p:nvPr/>
          </p:nvSpPr>
          <p:spPr>
            <a:xfrm>
              <a:off x="3093946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31" name="tx46">
              <a:extLst>
                <a:ext uri="{FF2B5EF4-FFF2-40B4-BE49-F238E27FC236}">
                  <a16:creationId xmlns:a16="http://schemas.microsoft.com/office/drawing/2014/main" id="{25DB4D29-5F97-E31A-A7A1-F83E1EFC25D5}"/>
                </a:ext>
              </a:extLst>
            </p:cNvPr>
            <p:cNvSpPr/>
            <p:nvPr/>
          </p:nvSpPr>
          <p:spPr>
            <a:xfrm>
              <a:off x="5143347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32" name="tx47">
              <a:extLst>
                <a:ext uri="{FF2B5EF4-FFF2-40B4-BE49-F238E27FC236}">
                  <a16:creationId xmlns:a16="http://schemas.microsoft.com/office/drawing/2014/main" id="{CAF5BAE9-E1EC-AB49-E5C0-EB2FACCF9CA4}"/>
                </a:ext>
              </a:extLst>
            </p:cNvPr>
            <p:cNvSpPr/>
            <p:nvPr/>
          </p:nvSpPr>
          <p:spPr>
            <a:xfrm>
              <a:off x="7192748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33" name="tx48">
              <a:extLst>
                <a:ext uri="{FF2B5EF4-FFF2-40B4-BE49-F238E27FC236}">
                  <a16:creationId xmlns:a16="http://schemas.microsoft.com/office/drawing/2014/main" id="{4A0F302A-28CA-5461-926D-82B4E8FDB2A0}"/>
                </a:ext>
              </a:extLst>
            </p:cNvPr>
            <p:cNvSpPr/>
            <p:nvPr/>
          </p:nvSpPr>
          <p:spPr>
            <a:xfrm>
              <a:off x="3500046" y="3977900"/>
              <a:ext cx="2566019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 to Liver-Related Mortality (Days)</a:t>
              </a:r>
            </a:p>
          </p:txBody>
        </p:sp>
        <p:sp>
          <p:nvSpPr>
            <p:cNvPr id="34" name="tx49">
              <a:extLst>
                <a:ext uri="{FF2B5EF4-FFF2-40B4-BE49-F238E27FC236}">
                  <a16:creationId xmlns:a16="http://schemas.microsoft.com/office/drawing/2014/main" id="{377A4DDA-FC1E-7D00-EE90-AAEEB9E63E5A}"/>
                </a:ext>
              </a:extLst>
            </p:cNvPr>
            <p:cNvSpPr/>
            <p:nvPr/>
          </p:nvSpPr>
          <p:spPr>
            <a:xfrm rot="16200000">
              <a:off x="-1487151" y="1997727"/>
              <a:ext cx="3472681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868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umulative Incidence of Liver-Related Mortality (%)</a:t>
              </a:r>
            </a:p>
          </p:txBody>
        </p:sp>
        <p:sp>
          <p:nvSpPr>
            <p:cNvPr id="35" name="rc50">
              <a:extLst>
                <a:ext uri="{FF2B5EF4-FFF2-40B4-BE49-F238E27FC236}">
                  <a16:creationId xmlns:a16="http://schemas.microsoft.com/office/drawing/2014/main" id="{25AFDB7C-D413-37F2-6C72-7D80A1238983}"/>
                </a:ext>
              </a:extLst>
            </p:cNvPr>
            <p:cNvSpPr/>
            <p:nvPr/>
          </p:nvSpPr>
          <p:spPr>
            <a:xfrm>
              <a:off x="4276688" y="4189554"/>
              <a:ext cx="1227921" cy="358634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38" name="rc53">
              <a:extLst>
                <a:ext uri="{FF2B5EF4-FFF2-40B4-BE49-F238E27FC236}">
                  <a16:creationId xmlns:a16="http://schemas.microsoft.com/office/drawing/2014/main" id="{1F77C321-BD4B-F13F-D3BF-40DD72AEF911}"/>
                </a:ext>
              </a:extLst>
            </p:cNvPr>
            <p:cNvSpPr/>
            <p:nvPr/>
          </p:nvSpPr>
          <p:spPr>
            <a:xfrm>
              <a:off x="4926900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42" name="rc57">
              <a:extLst>
                <a:ext uri="{FF2B5EF4-FFF2-40B4-BE49-F238E27FC236}">
                  <a16:creationId xmlns:a16="http://schemas.microsoft.com/office/drawing/2014/main" id="{12417DB5-406D-2566-09B1-64896A0641B1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3" name="rc58">
              <a:extLst>
                <a:ext uri="{FF2B5EF4-FFF2-40B4-BE49-F238E27FC236}">
                  <a16:creationId xmlns:a16="http://schemas.microsoft.com/office/drawing/2014/main" id="{1DAD8EFE-2AE9-DE4D-688B-2B52AA1CD733}"/>
                </a:ext>
              </a:extLst>
            </p:cNvPr>
            <p:cNvSpPr/>
            <p:nvPr/>
          </p:nvSpPr>
          <p:spPr>
            <a:xfrm>
              <a:off x="776476" y="4996549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44" name="tx59">
              <a:extLst>
                <a:ext uri="{FF2B5EF4-FFF2-40B4-BE49-F238E27FC236}">
                  <a16:creationId xmlns:a16="http://schemas.microsoft.com/office/drawing/2014/main" id="{DF413BFF-7180-FA08-D9AF-9B097EB99593}"/>
                </a:ext>
              </a:extLst>
            </p:cNvPr>
            <p:cNvSpPr/>
            <p:nvPr/>
          </p:nvSpPr>
          <p:spPr>
            <a:xfrm>
              <a:off x="1115323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45" name="tx60">
              <a:extLst>
                <a:ext uri="{FF2B5EF4-FFF2-40B4-BE49-F238E27FC236}">
                  <a16:creationId xmlns:a16="http://schemas.microsoft.com/office/drawing/2014/main" id="{CCA3FF0B-4452-F673-129F-816E837FA2E9}"/>
                </a:ext>
              </a:extLst>
            </p:cNvPr>
            <p:cNvSpPr/>
            <p:nvPr/>
          </p:nvSpPr>
          <p:spPr>
            <a:xfrm>
              <a:off x="1080154" y="5132574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46" name="tx61">
              <a:extLst>
                <a:ext uri="{FF2B5EF4-FFF2-40B4-BE49-F238E27FC236}">
                  <a16:creationId xmlns:a16="http://schemas.microsoft.com/office/drawing/2014/main" id="{D769C4A3-A795-20B9-5BF8-4A5486445EF5}"/>
                </a:ext>
              </a:extLst>
            </p:cNvPr>
            <p:cNvSpPr/>
            <p:nvPr/>
          </p:nvSpPr>
          <p:spPr>
            <a:xfrm>
              <a:off x="3164724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47" name="tx62">
              <a:extLst>
                <a:ext uri="{FF2B5EF4-FFF2-40B4-BE49-F238E27FC236}">
                  <a16:creationId xmlns:a16="http://schemas.microsoft.com/office/drawing/2014/main" id="{2B5922AE-440A-42AE-A724-CA92054A17F4}"/>
                </a:ext>
              </a:extLst>
            </p:cNvPr>
            <p:cNvSpPr/>
            <p:nvPr/>
          </p:nvSpPr>
          <p:spPr>
            <a:xfrm>
              <a:off x="3164724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48" name="tx63">
              <a:extLst>
                <a:ext uri="{FF2B5EF4-FFF2-40B4-BE49-F238E27FC236}">
                  <a16:creationId xmlns:a16="http://schemas.microsoft.com/office/drawing/2014/main" id="{C0E609EC-38D2-9D54-70BE-1017E2816CEF}"/>
                </a:ext>
              </a:extLst>
            </p:cNvPr>
            <p:cNvSpPr/>
            <p:nvPr/>
          </p:nvSpPr>
          <p:spPr>
            <a:xfrm>
              <a:off x="5214125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49" name="tx64">
              <a:extLst>
                <a:ext uri="{FF2B5EF4-FFF2-40B4-BE49-F238E27FC236}">
                  <a16:creationId xmlns:a16="http://schemas.microsoft.com/office/drawing/2014/main" id="{9DA0911C-0702-C870-615F-0CDF8BC28480}"/>
                </a:ext>
              </a:extLst>
            </p:cNvPr>
            <p:cNvSpPr/>
            <p:nvPr/>
          </p:nvSpPr>
          <p:spPr>
            <a:xfrm>
              <a:off x="5214125" y="5134117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50" name="tx65">
              <a:extLst>
                <a:ext uri="{FF2B5EF4-FFF2-40B4-BE49-F238E27FC236}">
                  <a16:creationId xmlns:a16="http://schemas.microsoft.com/office/drawing/2014/main" id="{ADA776D0-53A3-C0FC-15A9-AF9F4A0EFA03}"/>
                </a:ext>
              </a:extLst>
            </p:cNvPr>
            <p:cNvSpPr/>
            <p:nvPr/>
          </p:nvSpPr>
          <p:spPr>
            <a:xfrm>
              <a:off x="7263526" y="5437853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51" name="tx66">
              <a:extLst>
                <a:ext uri="{FF2B5EF4-FFF2-40B4-BE49-F238E27FC236}">
                  <a16:creationId xmlns:a16="http://schemas.microsoft.com/office/drawing/2014/main" id="{CCF6184E-F91D-2B94-9964-3AF94323BCA3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52" name="tx67">
              <a:extLst>
                <a:ext uri="{FF2B5EF4-FFF2-40B4-BE49-F238E27FC236}">
                  <a16:creationId xmlns:a16="http://schemas.microsoft.com/office/drawing/2014/main" id="{824900F1-7EB5-BFAE-EEC8-3067C1F0915F}"/>
                </a:ext>
              </a:extLst>
            </p:cNvPr>
            <p:cNvSpPr/>
            <p:nvPr/>
          </p:nvSpPr>
          <p:spPr>
            <a:xfrm>
              <a:off x="7263526" y="5437853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53" name="tx68">
              <a:extLst>
                <a:ext uri="{FF2B5EF4-FFF2-40B4-BE49-F238E27FC236}">
                  <a16:creationId xmlns:a16="http://schemas.microsoft.com/office/drawing/2014/main" id="{C186E18A-022B-6B4A-9AD2-64989793342F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54" name="tx69">
              <a:extLst>
                <a:ext uri="{FF2B5EF4-FFF2-40B4-BE49-F238E27FC236}">
                  <a16:creationId xmlns:a16="http://schemas.microsoft.com/office/drawing/2014/main" id="{528A76D5-8D15-1AD9-860A-2614984323B9}"/>
                </a:ext>
              </a:extLst>
            </p:cNvPr>
            <p:cNvSpPr/>
            <p:nvPr/>
          </p:nvSpPr>
          <p:spPr>
            <a:xfrm>
              <a:off x="325591" y="5438152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55" name="tx70">
              <a:extLst>
                <a:ext uri="{FF2B5EF4-FFF2-40B4-BE49-F238E27FC236}">
                  <a16:creationId xmlns:a16="http://schemas.microsoft.com/office/drawing/2014/main" id="{4869A3B8-E04F-347B-CC7B-138F82087CFD}"/>
                </a:ext>
              </a:extLst>
            </p:cNvPr>
            <p:cNvSpPr/>
            <p:nvPr/>
          </p:nvSpPr>
          <p:spPr>
            <a:xfrm>
              <a:off x="311638" y="5132811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56" name="tx71">
              <a:extLst>
                <a:ext uri="{FF2B5EF4-FFF2-40B4-BE49-F238E27FC236}">
                  <a16:creationId xmlns:a16="http://schemas.microsoft.com/office/drawing/2014/main" id="{13521853-C985-8161-798D-5F32342D64E8}"/>
                </a:ext>
              </a:extLst>
            </p:cNvPr>
            <p:cNvSpPr/>
            <p:nvPr/>
          </p:nvSpPr>
          <p:spPr>
            <a:xfrm>
              <a:off x="776476" y="4827633"/>
              <a:ext cx="17452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57" name="rc72">
              <a:extLst>
                <a:ext uri="{FF2B5EF4-FFF2-40B4-BE49-F238E27FC236}">
                  <a16:creationId xmlns:a16="http://schemas.microsoft.com/office/drawing/2014/main" id="{8B0B9BF3-3BC9-1D9B-F456-60DB454393F7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8" name="rc73">
              <a:extLst>
                <a:ext uri="{FF2B5EF4-FFF2-40B4-BE49-F238E27FC236}">
                  <a16:creationId xmlns:a16="http://schemas.microsoft.com/office/drawing/2014/main" id="{24D7E83F-6C5E-2A9E-D1C4-343DA3133D2E}"/>
                </a:ext>
              </a:extLst>
            </p:cNvPr>
            <p:cNvSpPr/>
            <p:nvPr/>
          </p:nvSpPr>
          <p:spPr>
            <a:xfrm>
              <a:off x="776476" y="6081865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59" name="tx74">
              <a:extLst>
                <a:ext uri="{FF2B5EF4-FFF2-40B4-BE49-F238E27FC236}">
                  <a16:creationId xmlns:a16="http://schemas.microsoft.com/office/drawing/2014/main" id="{193AE481-A38B-631F-6DAE-31E6FF56C632}"/>
                </a:ext>
              </a:extLst>
            </p:cNvPr>
            <p:cNvSpPr/>
            <p:nvPr/>
          </p:nvSpPr>
          <p:spPr>
            <a:xfrm>
              <a:off x="1115323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0" name="tx75">
              <a:extLst>
                <a:ext uri="{FF2B5EF4-FFF2-40B4-BE49-F238E27FC236}">
                  <a16:creationId xmlns:a16="http://schemas.microsoft.com/office/drawing/2014/main" id="{94F5E989-50D5-7A13-1CBB-FA6E02FDA491}"/>
                </a:ext>
              </a:extLst>
            </p:cNvPr>
            <p:cNvSpPr/>
            <p:nvPr/>
          </p:nvSpPr>
          <p:spPr>
            <a:xfrm>
              <a:off x="1080154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1</a:t>
              </a:r>
            </a:p>
          </p:txBody>
        </p:sp>
        <p:sp>
          <p:nvSpPr>
            <p:cNvPr id="61" name="tx76">
              <a:extLst>
                <a:ext uri="{FF2B5EF4-FFF2-40B4-BE49-F238E27FC236}">
                  <a16:creationId xmlns:a16="http://schemas.microsoft.com/office/drawing/2014/main" id="{0F174DA6-CBC7-F923-2C1B-38BF2B0C957C}"/>
                </a:ext>
              </a:extLst>
            </p:cNvPr>
            <p:cNvSpPr/>
            <p:nvPr/>
          </p:nvSpPr>
          <p:spPr>
            <a:xfrm>
              <a:off x="3164724" y="6524775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62" name="tx77">
              <a:extLst>
                <a:ext uri="{FF2B5EF4-FFF2-40B4-BE49-F238E27FC236}">
                  <a16:creationId xmlns:a16="http://schemas.microsoft.com/office/drawing/2014/main" id="{A736B531-E465-51F8-7B05-23EC1E579055}"/>
                </a:ext>
              </a:extLst>
            </p:cNvPr>
            <p:cNvSpPr/>
            <p:nvPr/>
          </p:nvSpPr>
          <p:spPr>
            <a:xfrm>
              <a:off x="3129555" y="6217890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6</a:t>
              </a:r>
            </a:p>
          </p:txBody>
        </p:sp>
        <p:sp>
          <p:nvSpPr>
            <p:cNvPr id="63" name="tx78">
              <a:extLst>
                <a:ext uri="{FF2B5EF4-FFF2-40B4-BE49-F238E27FC236}">
                  <a16:creationId xmlns:a16="http://schemas.microsoft.com/office/drawing/2014/main" id="{4180907F-4C63-2F8A-8D3A-B581BF696A21}"/>
                </a:ext>
              </a:extLst>
            </p:cNvPr>
            <p:cNvSpPr/>
            <p:nvPr/>
          </p:nvSpPr>
          <p:spPr>
            <a:xfrm>
              <a:off x="5214125" y="6524775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563" name="tx79">
              <a:extLst>
                <a:ext uri="{FF2B5EF4-FFF2-40B4-BE49-F238E27FC236}">
                  <a16:creationId xmlns:a16="http://schemas.microsoft.com/office/drawing/2014/main" id="{E5ADECD1-E7E7-4F66-3904-324ED7B27086}"/>
                </a:ext>
              </a:extLst>
            </p:cNvPr>
            <p:cNvSpPr/>
            <p:nvPr/>
          </p:nvSpPr>
          <p:spPr>
            <a:xfrm>
              <a:off x="5214125" y="6217890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</a:t>
              </a:r>
            </a:p>
          </p:txBody>
        </p:sp>
        <p:sp>
          <p:nvSpPr>
            <p:cNvPr id="637" name="tx80">
              <a:extLst>
                <a:ext uri="{FF2B5EF4-FFF2-40B4-BE49-F238E27FC236}">
                  <a16:creationId xmlns:a16="http://schemas.microsoft.com/office/drawing/2014/main" id="{8F3961A4-5A7C-98D6-DC8E-421E1993E254}"/>
                </a:ext>
              </a:extLst>
            </p:cNvPr>
            <p:cNvSpPr/>
            <p:nvPr/>
          </p:nvSpPr>
          <p:spPr>
            <a:xfrm>
              <a:off x="7263526" y="6524775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192" name="tx81">
              <a:extLst>
                <a:ext uri="{FF2B5EF4-FFF2-40B4-BE49-F238E27FC236}">
                  <a16:creationId xmlns:a16="http://schemas.microsoft.com/office/drawing/2014/main" id="{62A333EA-A047-DF0B-B452-8AF77A5EF98C}"/>
                </a:ext>
              </a:extLst>
            </p:cNvPr>
            <p:cNvSpPr/>
            <p:nvPr/>
          </p:nvSpPr>
          <p:spPr>
            <a:xfrm>
              <a:off x="7263526" y="6220978"/>
              <a:ext cx="70337" cy="8935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</a:t>
              </a:r>
            </a:p>
          </p:txBody>
        </p:sp>
        <p:sp>
          <p:nvSpPr>
            <p:cNvPr id="193" name="tx82">
              <a:extLst>
                <a:ext uri="{FF2B5EF4-FFF2-40B4-BE49-F238E27FC236}">
                  <a16:creationId xmlns:a16="http://schemas.microsoft.com/office/drawing/2014/main" id="{8FA6D05C-9EE4-9C94-F39C-0A25C89083E5}"/>
                </a:ext>
              </a:extLst>
            </p:cNvPr>
            <p:cNvSpPr/>
            <p:nvPr/>
          </p:nvSpPr>
          <p:spPr>
            <a:xfrm>
              <a:off x="325591" y="6523468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194" name="tx83">
              <a:extLst>
                <a:ext uri="{FF2B5EF4-FFF2-40B4-BE49-F238E27FC236}">
                  <a16:creationId xmlns:a16="http://schemas.microsoft.com/office/drawing/2014/main" id="{B0E2A680-8F28-B176-6F0C-6F194ECAB6CE}"/>
                </a:ext>
              </a:extLst>
            </p:cNvPr>
            <p:cNvSpPr/>
            <p:nvPr/>
          </p:nvSpPr>
          <p:spPr>
            <a:xfrm>
              <a:off x="311638" y="6218127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195" name="tx84">
              <a:extLst>
                <a:ext uri="{FF2B5EF4-FFF2-40B4-BE49-F238E27FC236}">
                  <a16:creationId xmlns:a16="http://schemas.microsoft.com/office/drawing/2014/main" id="{BA5CFE35-F84C-14D5-C789-FD532F92CB5F}"/>
                </a:ext>
              </a:extLst>
            </p:cNvPr>
            <p:cNvSpPr/>
            <p:nvPr/>
          </p:nvSpPr>
          <p:spPr>
            <a:xfrm>
              <a:off x="776476" y="5912949"/>
              <a:ext cx="23525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</p:grpSp>
      <p:sp>
        <p:nvSpPr>
          <p:cNvPr id="196" name="TextBox 195">
            <a:extLst>
              <a:ext uri="{FF2B5EF4-FFF2-40B4-BE49-F238E27FC236}">
                <a16:creationId xmlns:a16="http://schemas.microsoft.com/office/drawing/2014/main" id="{16DB54BF-7290-2DAA-4569-F9C582692305}"/>
              </a:ext>
            </a:extLst>
          </p:cNvPr>
          <p:cNvSpPr txBox="1"/>
          <p:nvPr/>
        </p:nvSpPr>
        <p:spPr>
          <a:xfrm>
            <a:off x="5576142" y="1829178"/>
            <a:ext cx="3125335" cy="6519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9" b="1" dirty="0">
                <a:latin typeface="Arial" panose="020B0604020202020204" pitchFamily="34" charset="0"/>
                <a:cs typeface="Arial" panose="020B0604020202020204" pitchFamily="34" charset="0"/>
              </a:rPr>
              <a:t>Potential Living Donor Total   Event   HR (95% CI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No                                     10       3          Reference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Yes                                    41       1       0.07 (0.01 – 0.69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Gray K-Sample Test P-value: 0.0041     </a:t>
            </a:r>
          </a:p>
        </p:txBody>
      </p:sp>
      <p:sp>
        <p:nvSpPr>
          <p:cNvPr id="199" name="pl48">
            <a:extLst>
              <a:ext uri="{FF2B5EF4-FFF2-40B4-BE49-F238E27FC236}">
                <a16:creationId xmlns:a16="http://schemas.microsoft.com/office/drawing/2014/main" id="{2AF2AD9C-4173-C53E-2D0E-CEE4A843F602}"/>
              </a:ext>
            </a:extLst>
          </p:cNvPr>
          <p:cNvSpPr/>
          <p:nvPr/>
        </p:nvSpPr>
        <p:spPr>
          <a:xfrm>
            <a:off x="5470144" y="2072548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200" name="pl50">
            <a:extLst>
              <a:ext uri="{FF2B5EF4-FFF2-40B4-BE49-F238E27FC236}">
                <a16:creationId xmlns:a16="http://schemas.microsoft.com/office/drawing/2014/main" id="{36A1C2C6-00A7-45FC-9E83-30E1FCA613E5}"/>
              </a:ext>
            </a:extLst>
          </p:cNvPr>
          <p:cNvSpPr/>
          <p:nvPr/>
        </p:nvSpPr>
        <p:spPr>
          <a:xfrm>
            <a:off x="5470144" y="2204665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grpSp>
        <p:nvGrpSpPr>
          <p:cNvPr id="201" name="Group 200">
            <a:extLst>
              <a:ext uri="{FF2B5EF4-FFF2-40B4-BE49-F238E27FC236}">
                <a16:creationId xmlns:a16="http://schemas.microsoft.com/office/drawing/2014/main" id="{C68EA477-A72E-D830-8441-90E71B7D30C8}"/>
              </a:ext>
            </a:extLst>
          </p:cNvPr>
          <p:cNvGrpSpPr>
            <a:grpSpLocks noChangeAspect="1"/>
          </p:cNvGrpSpPr>
          <p:nvPr/>
        </p:nvGrpSpPr>
        <p:grpSpPr>
          <a:xfrm>
            <a:off x="195440" y="1631910"/>
            <a:ext cx="4719770" cy="3571875"/>
            <a:chOff x="0" y="0"/>
            <a:chExt cx="9144000" cy="6858000"/>
          </a:xfrm>
        </p:grpSpPr>
        <p:sp>
          <p:nvSpPr>
            <p:cNvPr id="202" name="rc3">
              <a:extLst>
                <a:ext uri="{FF2B5EF4-FFF2-40B4-BE49-F238E27FC236}">
                  <a16:creationId xmlns:a16="http://schemas.microsoft.com/office/drawing/2014/main" id="{FF9C5C8F-7018-80BF-868D-2ACBC2F306E4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03" name="rc4">
              <a:extLst>
                <a:ext uri="{FF2B5EF4-FFF2-40B4-BE49-F238E27FC236}">
                  <a16:creationId xmlns:a16="http://schemas.microsoft.com/office/drawing/2014/main" id="{25C70ECF-124B-AC53-44CB-8F4AF868E1B3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04" name="rc5">
              <a:extLst>
                <a:ext uri="{FF2B5EF4-FFF2-40B4-BE49-F238E27FC236}">
                  <a16:creationId xmlns:a16="http://schemas.microsoft.com/office/drawing/2014/main" id="{69AF6DA9-F5DA-0FA3-AFC9-7C43177144A3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05" name="rc6">
              <a:extLst>
                <a:ext uri="{FF2B5EF4-FFF2-40B4-BE49-F238E27FC236}">
                  <a16:creationId xmlns:a16="http://schemas.microsoft.com/office/drawing/2014/main" id="{BD88B20F-6A46-283C-23BB-24F794E90E98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06" name="rc7">
              <a:extLst>
                <a:ext uri="{FF2B5EF4-FFF2-40B4-BE49-F238E27FC236}">
                  <a16:creationId xmlns:a16="http://schemas.microsoft.com/office/drawing/2014/main" id="{399B4DAB-3091-963B-E7B6-9006EB0640A1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07" name="rc8">
              <a:extLst>
                <a:ext uri="{FF2B5EF4-FFF2-40B4-BE49-F238E27FC236}">
                  <a16:creationId xmlns:a16="http://schemas.microsoft.com/office/drawing/2014/main" id="{243473F8-70BD-C393-25D1-08DC72C4B186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08" name="rc9">
              <a:extLst>
                <a:ext uri="{FF2B5EF4-FFF2-40B4-BE49-F238E27FC236}">
                  <a16:creationId xmlns:a16="http://schemas.microsoft.com/office/drawing/2014/main" id="{0F112161-EBC4-4535-D0B9-44668045C9ED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209" name="pl18">
              <a:extLst>
                <a:ext uri="{FF2B5EF4-FFF2-40B4-BE49-F238E27FC236}">
                  <a16:creationId xmlns:a16="http://schemas.microsoft.com/office/drawing/2014/main" id="{36AD16A9-A333-5F5A-ABA7-91A37984030D}"/>
                </a:ext>
              </a:extLst>
            </p:cNvPr>
            <p:cNvSpPr/>
            <p:nvPr/>
          </p:nvSpPr>
          <p:spPr>
            <a:xfrm>
              <a:off x="776476" y="3534137"/>
              <a:ext cx="8228345" cy="0"/>
            </a:xfrm>
            <a:custGeom>
              <a:avLst/>
              <a:gdLst/>
              <a:ahLst/>
              <a:cxnLst/>
              <a:rect l="0" t="0" r="0" b="0"/>
              <a:pathLst>
                <a:path w="8228345">
                  <a:moveTo>
                    <a:pt x="0" y="0"/>
                  </a:moveTo>
                  <a:lnTo>
                    <a:pt x="8228345" y="0"/>
                  </a:lnTo>
                  <a:lnTo>
                    <a:pt x="8228345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10" name="pl23">
              <a:extLst>
                <a:ext uri="{FF2B5EF4-FFF2-40B4-BE49-F238E27FC236}">
                  <a16:creationId xmlns:a16="http://schemas.microsoft.com/office/drawing/2014/main" id="{97CF273F-756B-FA33-F1ED-A3054B286BA4}"/>
                </a:ext>
              </a:extLst>
            </p:cNvPr>
            <p:cNvSpPr/>
            <p:nvPr/>
          </p:nvSpPr>
          <p:spPr>
            <a:xfrm>
              <a:off x="1150492" y="139178"/>
              <a:ext cx="0" cy="3556623"/>
            </a:xfrm>
            <a:custGeom>
              <a:avLst/>
              <a:gdLst/>
              <a:ahLst/>
              <a:cxnLst/>
              <a:rect l="0" t="0" r="0" b="0"/>
              <a:pathLst>
                <a:path h="3556623">
                  <a:moveTo>
                    <a:pt x="0" y="35566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11" name="pl27">
              <a:extLst>
                <a:ext uri="{FF2B5EF4-FFF2-40B4-BE49-F238E27FC236}">
                  <a16:creationId xmlns:a16="http://schemas.microsoft.com/office/drawing/2014/main" id="{9A026F7C-C6A9-1BF5-F105-47DF7E31FA42}"/>
                </a:ext>
              </a:extLst>
            </p:cNvPr>
            <p:cNvSpPr/>
            <p:nvPr/>
          </p:nvSpPr>
          <p:spPr>
            <a:xfrm>
              <a:off x="1150492" y="2263914"/>
              <a:ext cx="6209685" cy="1270222"/>
            </a:xfrm>
            <a:custGeom>
              <a:avLst/>
              <a:gdLst/>
              <a:ahLst/>
              <a:cxnLst/>
              <a:rect l="0" t="0" r="0" b="0"/>
              <a:pathLst>
                <a:path w="6209685" h="1270222">
                  <a:moveTo>
                    <a:pt x="0" y="1270222"/>
                  </a:moveTo>
                  <a:lnTo>
                    <a:pt x="61482" y="1270222"/>
                  </a:lnTo>
                  <a:lnTo>
                    <a:pt x="61482" y="1270222"/>
                  </a:lnTo>
                  <a:lnTo>
                    <a:pt x="184446" y="1270222"/>
                  </a:lnTo>
                  <a:lnTo>
                    <a:pt x="184446" y="1270222"/>
                  </a:lnTo>
                  <a:lnTo>
                    <a:pt x="317657" y="1270222"/>
                  </a:lnTo>
                  <a:lnTo>
                    <a:pt x="317657" y="1270222"/>
                  </a:lnTo>
                  <a:lnTo>
                    <a:pt x="389386" y="1270222"/>
                  </a:lnTo>
                  <a:lnTo>
                    <a:pt x="389386" y="1270222"/>
                  </a:lnTo>
                  <a:lnTo>
                    <a:pt x="440621" y="1270222"/>
                  </a:lnTo>
                  <a:lnTo>
                    <a:pt x="440621" y="1068141"/>
                  </a:lnTo>
                  <a:lnTo>
                    <a:pt x="809513" y="1068141"/>
                  </a:lnTo>
                  <a:lnTo>
                    <a:pt x="809513" y="866061"/>
                  </a:lnTo>
                  <a:lnTo>
                    <a:pt x="1619026" y="866061"/>
                  </a:lnTo>
                  <a:lnTo>
                    <a:pt x="1619026" y="866061"/>
                  </a:lnTo>
                  <a:lnTo>
                    <a:pt x="1834213" y="866061"/>
                  </a:lnTo>
                  <a:lnTo>
                    <a:pt x="1834213" y="866061"/>
                  </a:lnTo>
                  <a:lnTo>
                    <a:pt x="2490022" y="866061"/>
                  </a:lnTo>
                  <a:lnTo>
                    <a:pt x="2490022" y="606242"/>
                  </a:lnTo>
                  <a:lnTo>
                    <a:pt x="2520763" y="606242"/>
                  </a:lnTo>
                  <a:lnTo>
                    <a:pt x="2520763" y="606242"/>
                  </a:lnTo>
                  <a:lnTo>
                    <a:pt x="3340523" y="606242"/>
                  </a:lnTo>
                  <a:lnTo>
                    <a:pt x="3340523" y="346424"/>
                  </a:lnTo>
                  <a:lnTo>
                    <a:pt x="4324236" y="346424"/>
                  </a:lnTo>
                  <a:lnTo>
                    <a:pt x="4324236" y="346424"/>
                  </a:lnTo>
                  <a:lnTo>
                    <a:pt x="4672634" y="346424"/>
                  </a:lnTo>
                  <a:lnTo>
                    <a:pt x="4672634" y="0"/>
                  </a:lnTo>
                  <a:lnTo>
                    <a:pt x="6209685" y="0"/>
                  </a:lnTo>
                  <a:lnTo>
                    <a:pt x="6209685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12" name="pl28">
              <a:extLst>
                <a:ext uri="{FF2B5EF4-FFF2-40B4-BE49-F238E27FC236}">
                  <a16:creationId xmlns:a16="http://schemas.microsoft.com/office/drawing/2014/main" id="{D7F4048A-A66F-4FA1-5199-826DC9C66ECA}"/>
                </a:ext>
              </a:extLst>
            </p:cNvPr>
            <p:cNvSpPr/>
            <p:nvPr/>
          </p:nvSpPr>
          <p:spPr>
            <a:xfrm>
              <a:off x="1150492" y="3269826"/>
              <a:ext cx="6527342" cy="264310"/>
            </a:xfrm>
            <a:custGeom>
              <a:avLst/>
              <a:gdLst/>
              <a:ahLst/>
              <a:cxnLst/>
              <a:rect l="0" t="0" r="0" b="0"/>
              <a:pathLst>
                <a:path w="6527342" h="264310">
                  <a:moveTo>
                    <a:pt x="0" y="264310"/>
                  </a:moveTo>
                  <a:lnTo>
                    <a:pt x="10247" y="264310"/>
                  </a:lnTo>
                  <a:lnTo>
                    <a:pt x="10247" y="264310"/>
                  </a:lnTo>
                  <a:lnTo>
                    <a:pt x="61482" y="264310"/>
                  </a:lnTo>
                  <a:lnTo>
                    <a:pt x="61482" y="264310"/>
                  </a:lnTo>
                  <a:lnTo>
                    <a:pt x="204940" y="264310"/>
                  </a:lnTo>
                  <a:lnTo>
                    <a:pt x="204940" y="264310"/>
                  </a:lnTo>
                  <a:lnTo>
                    <a:pt x="266422" y="264310"/>
                  </a:lnTo>
                  <a:lnTo>
                    <a:pt x="266422" y="221736"/>
                  </a:lnTo>
                  <a:lnTo>
                    <a:pt x="286916" y="221736"/>
                  </a:lnTo>
                  <a:lnTo>
                    <a:pt x="286916" y="221736"/>
                  </a:lnTo>
                  <a:lnTo>
                    <a:pt x="338151" y="221736"/>
                  </a:lnTo>
                  <a:lnTo>
                    <a:pt x="338151" y="179162"/>
                  </a:lnTo>
                  <a:lnTo>
                    <a:pt x="389386" y="179162"/>
                  </a:lnTo>
                  <a:lnTo>
                    <a:pt x="389386" y="179162"/>
                  </a:lnTo>
                  <a:lnTo>
                    <a:pt x="430374" y="179162"/>
                  </a:lnTo>
                  <a:lnTo>
                    <a:pt x="430374" y="179162"/>
                  </a:lnTo>
                  <a:lnTo>
                    <a:pt x="440621" y="179162"/>
                  </a:lnTo>
                  <a:lnTo>
                    <a:pt x="440621" y="136588"/>
                  </a:lnTo>
                  <a:lnTo>
                    <a:pt x="471362" y="136588"/>
                  </a:lnTo>
                  <a:lnTo>
                    <a:pt x="471362" y="136588"/>
                  </a:lnTo>
                  <a:lnTo>
                    <a:pt x="491856" y="136588"/>
                  </a:lnTo>
                  <a:lnTo>
                    <a:pt x="491856" y="136588"/>
                  </a:lnTo>
                  <a:lnTo>
                    <a:pt x="502103" y="136588"/>
                  </a:lnTo>
                  <a:lnTo>
                    <a:pt x="502103" y="136588"/>
                  </a:lnTo>
                  <a:lnTo>
                    <a:pt x="532844" y="136588"/>
                  </a:lnTo>
                  <a:lnTo>
                    <a:pt x="532844" y="136588"/>
                  </a:lnTo>
                  <a:lnTo>
                    <a:pt x="635314" y="136588"/>
                  </a:lnTo>
                  <a:lnTo>
                    <a:pt x="635314" y="136588"/>
                  </a:lnTo>
                  <a:lnTo>
                    <a:pt x="645561" y="136588"/>
                  </a:lnTo>
                  <a:lnTo>
                    <a:pt x="645561" y="136588"/>
                  </a:lnTo>
                  <a:lnTo>
                    <a:pt x="717290" y="136588"/>
                  </a:lnTo>
                  <a:lnTo>
                    <a:pt x="717290" y="136588"/>
                  </a:lnTo>
                  <a:lnTo>
                    <a:pt x="789019" y="136588"/>
                  </a:lnTo>
                  <a:lnTo>
                    <a:pt x="789019" y="136588"/>
                  </a:lnTo>
                  <a:lnTo>
                    <a:pt x="840254" y="136588"/>
                  </a:lnTo>
                  <a:lnTo>
                    <a:pt x="840254" y="136588"/>
                  </a:lnTo>
                  <a:lnTo>
                    <a:pt x="860748" y="136588"/>
                  </a:lnTo>
                  <a:lnTo>
                    <a:pt x="860748" y="136588"/>
                  </a:lnTo>
                  <a:lnTo>
                    <a:pt x="901736" y="136588"/>
                  </a:lnTo>
                  <a:lnTo>
                    <a:pt x="901736" y="136588"/>
                  </a:lnTo>
                  <a:lnTo>
                    <a:pt x="942724" y="136588"/>
                  </a:lnTo>
                  <a:lnTo>
                    <a:pt x="942724" y="136588"/>
                  </a:lnTo>
                  <a:lnTo>
                    <a:pt x="1065688" y="136588"/>
                  </a:lnTo>
                  <a:lnTo>
                    <a:pt x="1065688" y="136588"/>
                  </a:lnTo>
                  <a:lnTo>
                    <a:pt x="1096429" y="136588"/>
                  </a:lnTo>
                  <a:lnTo>
                    <a:pt x="1096429" y="136588"/>
                  </a:lnTo>
                  <a:lnTo>
                    <a:pt x="1116923" y="136588"/>
                  </a:lnTo>
                  <a:lnTo>
                    <a:pt x="1116923" y="136588"/>
                  </a:lnTo>
                  <a:lnTo>
                    <a:pt x="1157911" y="136588"/>
                  </a:lnTo>
                  <a:lnTo>
                    <a:pt x="1157911" y="136588"/>
                  </a:lnTo>
                  <a:lnTo>
                    <a:pt x="1168158" y="136588"/>
                  </a:lnTo>
                  <a:lnTo>
                    <a:pt x="1168158" y="136588"/>
                  </a:lnTo>
                  <a:lnTo>
                    <a:pt x="1178405" y="136588"/>
                  </a:lnTo>
                  <a:lnTo>
                    <a:pt x="1178405" y="136588"/>
                  </a:lnTo>
                  <a:lnTo>
                    <a:pt x="1250134" y="136588"/>
                  </a:lnTo>
                  <a:lnTo>
                    <a:pt x="1250134" y="136588"/>
                  </a:lnTo>
                  <a:lnTo>
                    <a:pt x="1280875" y="136588"/>
                  </a:lnTo>
                  <a:lnTo>
                    <a:pt x="1280875" y="136588"/>
                  </a:lnTo>
                  <a:lnTo>
                    <a:pt x="1291122" y="136588"/>
                  </a:lnTo>
                  <a:lnTo>
                    <a:pt x="1291122" y="136588"/>
                  </a:lnTo>
                  <a:lnTo>
                    <a:pt x="1332110" y="136588"/>
                  </a:lnTo>
                  <a:lnTo>
                    <a:pt x="1332110" y="93327"/>
                  </a:lnTo>
                  <a:lnTo>
                    <a:pt x="1434580" y="93327"/>
                  </a:lnTo>
                  <a:lnTo>
                    <a:pt x="1434580" y="93327"/>
                  </a:lnTo>
                  <a:lnTo>
                    <a:pt x="1485815" y="93327"/>
                  </a:lnTo>
                  <a:lnTo>
                    <a:pt x="1485815" y="93327"/>
                  </a:lnTo>
                  <a:lnTo>
                    <a:pt x="1547297" y="93327"/>
                  </a:lnTo>
                  <a:lnTo>
                    <a:pt x="1547297" y="93327"/>
                  </a:lnTo>
                  <a:lnTo>
                    <a:pt x="1711249" y="93327"/>
                  </a:lnTo>
                  <a:lnTo>
                    <a:pt x="1711249" y="93327"/>
                  </a:lnTo>
                  <a:lnTo>
                    <a:pt x="1731743" y="93327"/>
                  </a:lnTo>
                  <a:lnTo>
                    <a:pt x="1731743" y="93327"/>
                  </a:lnTo>
                  <a:lnTo>
                    <a:pt x="1741990" y="93327"/>
                  </a:lnTo>
                  <a:lnTo>
                    <a:pt x="1741990" y="93327"/>
                  </a:lnTo>
                  <a:lnTo>
                    <a:pt x="1752237" y="93327"/>
                  </a:lnTo>
                  <a:lnTo>
                    <a:pt x="1752237" y="93327"/>
                  </a:lnTo>
                  <a:lnTo>
                    <a:pt x="1905942" y="93327"/>
                  </a:lnTo>
                  <a:lnTo>
                    <a:pt x="1905942" y="93327"/>
                  </a:lnTo>
                  <a:lnTo>
                    <a:pt x="1936683" y="93327"/>
                  </a:lnTo>
                  <a:lnTo>
                    <a:pt x="1936683" y="93327"/>
                  </a:lnTo>
                  <a:lnTo>
                    <a:pt x="1957177" y="93327"/>
                  </a:lnTo>
                  <a:lnTo>
                    <a:pt x="1957177" y="93327"/>
                  </a:lnTo>
                  <a:lnTo>
                    <a:pt x="2121130" y="93327"/>
                  </a:lnTo>
                  <a:lnTo>
                    <a:pt x="2121130" y="93327"/>
                  </a:lnTo>
                  <a:lnTo>
                    <a:pt x="2244094" y="93327"/>
                  </a:lnTo>
                  <a:lnTo>
                    <a:pt x="2244094" y="47482"/>
                  </a:lnTo>
                  <a:lnTo>
                    <a:pt x="2356811" y="47482"/>
                  </a:lnTo>
                  <a:lnTo>
                    <a:pt x="2356811" y="47482"/>
                  </a:lnTo>
                  <a:lnTo>
                    <a:pt x="2367058" y="47482"/>
                  </a:lnTo>
                  <a:lnTo>
                    <a:pt x="2367058" y="47482"/>
                  </a:lnTo>
                  <a:lnTo>
                    <a:pt x="2418293" y="47482"/>
                  </a:lnTo>
                  <a:lnTo>
                    <a:pt x="2418293" y="47482"/>
                  </a:lnTo>
                  <a:lnTo>
                    <a:pt x="2571998" y="47482"/>
                  </a:lnTo>
                  <a:lnTo>
                    <a:pt x="2571998" y="47482"/>
                  </a:lnTo>
                  <a:lnTo>
                    <a:pt x="2705209" y="47482"/>
                  </a:lnTo>
                  <a:lnTo>
                    <a:pt x="2705209" y="47482"/>
                  </a:lnTo>
                  <a:lnTo>
                    <a:pt x="2725703" y="47482"/>
                  </a:lnTo>
                  <a:lnTo>
                    <a:pt x="2725703" y="47482"/>
                  </a:lnTo>
                  <a:lnTo>
                    <a:pt x="2787185" y="47482"/>
                  </a:lnTo>
                  <a:lnTo>
                    <a:pt x="2787185" y="0"/>
                  </a:lnTo>
                  <a:lnTo>
                    <a:pt x="3002372" y="0"/>
                  </a:lnTo>
                  <a:lnTo>
                    <a:pt x="3002372" y="0"/>
                  </a:lnTo>
                  <a:lnTo>
                    <a:pt x="3279041" y="0"/>
                  </a:lnTo>
                  <a:lnTo>
                    <a:pt x="3279041" y="0"/>
                  </a:lnTo>
                  <a:lnTo>
                    <a:pt x="3340523" y="0"/>
                  </a:lnTo>
                  <a:lnTo>
                    <a:pt x="3340523" y="0"/>
                  </a:lnTo>
                  <a:lnTo>
                    <a:pt x="3945096" y="0"/>
                  </a:lnTo>
                  <a:lnTo>
                    <a:pt x="3945096" y="0"/>
                  </a:lnTo>
                  <a:lnTo>
                    <a:pt x="4590658" y="0"/>
                  </a:lnTo>
                  <a:lnTo>
                    <a:pt x="4590658" y="0"/>
                  </a:lnTo>
                  <a:lnTo>
                    <a:pt x="4877574" y="0"/>
                  </a:lnTo>
                  <a:lnTo>
                    <a:pt x="4877574" y="0"/>
                  </a:lnTo>
                  <a:lnTo>
                    <a:pt x="5512888" y="0"/>
                  </a:lnTo>
                  <a:lnTo>
                    <a:pt x="5512888" y="0"/>
                  </a:lnTo>
                  <a:lnTo>
                    <a:pt x="5994498" y="0"/>
                  </a:lnTo>
                  <a:lnTo>
                    <a:pt x="5994498" y="0"/>
                  </a:lnTo>
                  <a:lnTo>
                    <a:pt x="6045733" y="0"/>
                  </a:lnTo>
                  <a:lnTo>
                    <a:pt x="6045733" y="0"/>
                  </a:lnTo>
                  <a:lnTo>
                    <a:pt x="6301908" y="0"/>
                  </a:lnTo>
                  <a:lnTo>
                    <a:pt x="6301908" y="0"/>
                  </a:lnTo>
                  <a:lnTo>
                    <a:pt x="6527342" y="0"/>
                  </a:lnTo>
                  <a:lnTo>
                    <a:pt x="6527342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13" name="rc29">
              <a:extLst>
                <a:ext uri="{FF2B5EF4-FFF2-40B4-BE49-F238E27FC236}">
                  <a16:creationId xmlns:a16="http://schemas.microsoft.com/office/drawing/2014/main" id="{4FB817D9-8C2A-B679-D0DB-410E49451FF1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14" name="tx30">
              <a:extLst>
                <a:ext uri="{FF2B5EF4-FFF2-40B4-BE49-F238E27FC236}">
                  <a16:creationId xmlns:a16="http://schemas.microsoft.com/office/drawing/2014/main" id="{7CB162EA-38A4-BD54-672C-AF919E4CCBA8}"/>
                </a:ext>
              </a:extLst>
            </p:cNvPr>
            <p:cNvSpPr/>
            <p:nvPr/>
          </p:nvSpPr>
          <p:spPr>
            <a:xfrm>
              <a:off x="466667" y="3486760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215" name="tx31">
              <a:extLst>
                <a:ext uri="{FF2B5EF4-FFF2-40B4-BE49-F238E27FC236}">
                  <a16:creationId xmlns:a16="http://schemas.microsoft.com/office/drawing/2014/main" id="{B3AF7BFB-86C5-53EB-6EE0-99C739DF52E9}"/>
                </a:ext>
              </a:extLst>
            </p:cNvPr>
            <p:cNvSpPr/>
            <p:nvPr/>
          </p:nvSpPr>
          <p:spPr>
            <a:xfrm>
              <a:off x="466667" y="2678436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216" name="tx32">
              <a:extLst>
                <a:ext uri="{FF2B5EF4-FFF2-40B4-BE49-F238E27FC236}">
                  <a16:creationId xmlns:a16="http://schemas.microsoft.com/office/drawing/2014/main" id="{A0EFFAF7-1A61-04E0-8B70-4AD066467A34}"/>
                </a:ext>
              </a:extLst>
            </p:cNvPr>
            <p:cNvSpPr/>
            <p:nvPr/>
          </p:nvSpPr>
          <p:spPr>
            <a:xfrm>
              <a:off x="466667" y="1870113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217" name="tx33">
              <a:extLst>
                <a:ext uri="{FF2B5EF4-FFF2-40B4-BE49-F238E27FC236}">
                  <a16:creationId xmlns:a16="http://schemas.microsoft.com/office/drawing/2014/main" id="{4BAE51D7-4683-A2D3-4CA3-ED3A23D0E4D3}"/>
                </a:ext>
              </a:extLst>
            </p:cNvPr>
            <p:cNvSpPr/>
            <p:nvPr/>
          </p:nvSpPr>
          <p:spPr>
            <a:xfrm>
              <a:off x="466667" y="1061789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218" name="tx34">
              <a:extLst>
                <a:ext uri="{FF2B5EF4-FFF2-40B4-BE49-F238E27FC236}">
                  <a16:creationId xmlns:a16="http://schemas.microsoft.com/office/drawing/2014/main" id="{3CEE376D-6B26-D02C-4A42-06CBB357B443}"/>
                </a:ext>
              </a:extLst>
            </p:cNvPr>
            <p:cNvSpPr/>
            <p:nvPr/>
          </p:nvSpPr>
          <p:spPr>
            <a:xfrm>
              <a:off x="466667" y="253465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0</a:t>
              </a:r>
            </a:p>
          </p:txBody>
        </p:sp>
        <p:sp>
          <p:nvSpPr>
            <p:cNvPr id="287" name="pl35">
              <a:extLst>
                <a:ext uri="{FF2B5EF4-FFF2-40B4-BE49-F238E27FC236}">
                  <a16:creationId xmlns:a16="http://schemas.microsoft.com/office/drawing/2014/main" id="{D86D7A19-6EA3-FF6C-A183-444CA96F19CA}"/>
                </a:ext>
              </a:extLst>
            </p:cNvPr>
            <p:cNvSpPr/>
            <p:nvPr/>
          </p:nvSpPr>
          <p:spPr>
            <a:xfrm>
              <a:off x="741682" y="353413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88" name="pl36">
              <a:extLst>
                <a:ext uri="{FF2B5EF4-FFF2-40B4-BE49-F238E27FC236}">
                  <a16:creationId xmlns:a16="http://schemas.microsoft.com/office/drawing/2014/main" id="{2729FCFF-8B8C-80FC-8AF8-126A746755C4}"/>
                </a:ext>
              </a:extLst>
            </p:cNvPr>
            <p:cNvSpPr/>
            <p:nvPr/>
          </p:nvSpPr>
          <p:spPr>
            <a:xfrm>
              <a:off x="741682" y="2725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89" name="pl37">
              <a:extLst>
                <a:ext uri="{FF2B5EF4-FFF2-40B4-BE49-F238E27FC236}">
                  <a16:creationId xmlns:a16="http://schemas.microsoft.com/office/drawing/2014/main" id="{FE27F405-31F4-59F7-FEC0-A805C8E279A5}"/>
                </a:ext>
              </a:extLst>
            </p:cNvPr>
            <p:cNvSpPr/>
            <p:nvPr/>
          </p:nvSpPr>
          <p:spPr>
            <a:xfrm>
              <a:off x="741682" y="19174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90" name="pl38">
              <a:extLst>
                <a:ext uri="{FF2B5EF4-FFF2-40B4-BE49-F238E27FC236}">
                  <a16:creationId xmlns:a16="http://schemas.microsoft.com/office/drawing/2014/main" id="{C6A1A0C7-0536-4E42-5CA0-0B3EE6DD16ED}"/>
                </a:ext>
              </a:extLst>
            </p:cNvPr>
            <p:cNvSpPr/>
            <p:nvPr/>
          </p:nvSpPr>
          <p:spPr>
            <a:xfrm>
              <a:off x="741682" y="11091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91" name="pl39">
              <a:extLst>
                <a:ext uri="{FF2B5EF4-FFF2-40B4-BE49-F238E27FC236}">
                  <a16:creationId xmlns:a16="http://schemas.microsoft.com/office/drawing/2014/main" id="{D890CFFB-2968-E3F6-31C4-2207A9015D4D}"/>
                </a:ext>
              </a:extLst>
            </p:cNvPr>
            <p:cNvSpPr/>
            <p:nvPr/>
          </p:nvSpPr>
          <p:spPr>
            <a:xfrm>
              <a:off x="741682" y="3008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92" name="pl40">
              <a:extLst>
                <a:ext uri="{FF2B5EF4-FFF2-40B4-BE49-F238E27FC236}">
                  <a16:creationId xmlns:a16="http://schemas.microsoft.com/office/drawing/2014/main" id="{BE697C9D-6F8E-30AB-55E1-95DDB1A84AD2}"/>
                </a:ext>
              </a:extLst>
            </p:cNvPr>
            <p:cNvSpPr/>
            <p:nvPr/>
          </p:nvSpPr>
          <p:spPr>
            <a:xfrm>
              <a:off x="1150492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93" name="pl41">
              <a:extLst>
                <a:ext uri="{FF2B5EF4-FFF2-40B4-BE49-F238E27FC236}">
                  <a16:creationId xmlns:a16="http://schemas.microsoft.com/office/drawing/2014/main" id="{B7D821F6-1148-A999-0F2E-D08EFF1EA2A3}"/>
                </a:ext>
              </a:extLst>
            </p:cNvPr>
            <p:cNvSpPr/>
            <p:nvPr/>
          </p:nvSpPr>
          <p:spPr>
            <a:xfrm>
              <a:off x="3199893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94" name="pl42">
              <a:extLst>
                <a:ext uri="{FF2B5EF4-FFF2-40B4-BE49-F238E27FC236}">
                  <a16:creationId xmlns:a16="http://schemas.microsoft.com/office/drawing/2014/main" id="{61C4A159-D0C4-4E75-B525-9300503E04D0}"/>
                </a:ext>
              </a:extLst>
            </p:cNvPr>
            <p:cNvSpPr/>
            <p:nvPr/>
          </p:nvSpPr>
          <p:spPr>
            <a:xfrm>
              <a:off x="5249294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95" name="pl43">
              <a:extLst>
                <a:ext uri="{FF2B5EF4-FFF2-40B4-BE49-F238E27FC236}">
                  <a16:creationId xmlns:a16="http://schemas.microsoft.com/office/drawing/2014/main" id="{A059FC31-EF03-8E66-150E-3EA6C1D33B2C}"/>
                </a:ext>
              </a:extLst>
            </p:cNvPr>
            <p:cNvSpPr/>
            <p:nvPr/>
          </p:nvSpPr>
          <p:spPr>
            <a:xfrm>
              <a:off x="7298695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96" name="tx44">
              <a:extLst>
                <a:ext uri="{FF2B5EF4-FFF2-40B4-BE49-F238E27FC236}">
                  <a16:creationId xmlns:a16="http://schemas.microsoft.com/office/drawing/2014/main" id="{211791F3-F8A7-0F9E-CCA3-0BAA7E93F2DE}"/>
                </a:ext>
              </a:extLst>
            </p:cNvPr>
            <p:cNvSpPr/>
            <p:nvPr/>
          </p:nvSpPr>
          <p:spPr>
            <a:xfrm>
              <a:off x="1115176" y="3756509"/>
              <a:ext cx="70631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97" name="tx45">
              <a:extLst>
                <a:ext uri="{FF2B5EF4-FFF2-40B4-BE49-F238E27FC236}">
                  <a16:creationId xmlns:a16="http://schemas.microsoft.com/office/drawing/2014/main" id="{2F9CDEF7-DA45-CA79-9AF0-43662359A472}"/>
                </a:ext>
              </a:extLst>
            </p:cNvPr>
            <p:cNvSpPr/>
            <p:nvPr/>
          </p:nvSpPr>
          <p:spPr>
            <a:xfrm>
              <a:off x="3093946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298" name="tx46">
              <a:extLst>
                <a:ext uri="{FF2B5EF4-FFF2-40B4-BE49-F238E27FC236}">
                  <a16:creationId xmlns:a16="http://schemas.microsoft.com/office/drawing/2014/main" id="{938E9C68-DB42-68D9-7016-CEE3C7D0DE9D}"/>
                </a:ext>
              </a:extLst>
            </p:cNvPr>
            <p:cNvSpPr/>
            <p:nvPr/>
          </p:nvSpPr>
          <p:spPr>
            <a:xfrm>
              <a:off x="5143347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299" name="tx47">
              <a:extLst>
                <a:ext uri="{FF2B5EF4-FFF2-40B4-BE49-F238E27FC236}">
                  <a16:creationId xmlns:a16="http://schemas.microsoft.com/office/drawing/2014/main" id="{2362487E-BD6F-5B42-248A-D81977918788}"/>
                </a:ext>
              </a:extLst>
            </p:cNvPr>
            <p:cNvSpPr/>
            <p:nvPr/>
          </p:nvSpPr>
          <p:spPr>
            <a:xfrm>
              <a:off x="7192748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300" name="tx48">
              <a:extLst>
                <a:ext uri="{FF2B5EF4-FFF2-40B4-BE49-F238E27FC236}">
                  <a16:creationId xmlns:a16="http://schemas.microsoft.com/office/drawing/2014/main" id="{E558BCC0-20DF-240A-5746-0C2CA3D127A0}"/>
                </a:ext>
              </a:extLst>
            </p:cNvPr>
            <p:cNvSpPr/>
            <p:nvPr/>
          </p:nvSpPr>
          <p:spPr>
            <a:xfrm>
              <a:off x="3607639" y="3878778"/>
              <a:ext cx="2566020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 to Liver-Related Mortality (Days)</a:t>
              </a:r>
            </a:p>
          </p:txBody>
        </p:sp>
        <p:sp>
          <p:nvSpPr>
            <p:cNvPr id="301" name="tx49">
              <a:extLst>
                <a:ext uri="{FF2B5EF4-FFF2-40B4-BE49-F238E27FC236}">
                  <a16:creationId xmlns:a16="http://schemas.microsoft.com/office/drawing/2014/main" id="{2631C6A1-89A7-BA5B-391F-8E3A78134B65}"/>
                </a:ext>
              </a:extLst>
            </p:cNvPr>
            <p:cNvSpPr/>
            <p:nvPr/>
          </p:nvSpPr>
          <p:spPr>
            <a:xfrm rot="16200000">
              <a:off x="-1398655" y="1989552"/>
              <a:ext cx="3472681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09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umulative Incidence of Liver-Related Mortality (%)</a:t>
              </a:r>
            </a:p>
          </p:txBody>
        </p:sp>
        <p:sp>
          <p:nvSpPr>
            <p:cNvPr id="302" name="rc50">
              <a:extLst>
                <a:ext uri="{FF2B5EF4-FFF2-40B4-BE49-F238E27FC236}">
                  <a16:creationId xmlns:a16="http://schemas.microsoft.com/office/drawing/2014/main" id="{0E0C5775-21CC-D3BF-C0AC-38AAFC5E08F9}"/>
                </a:ext>
              </a:extLst>
            </p:cNvPr>
            <p:cNvSpPr/>
            <p:nvPr/>
          </p:nvSpPr>
          <p:spPr>
            <a:xfrm>
              <a:off x="4276688" y="4189554"/>
              <a:ext cx="1227921" cy="358634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309" name="rc57">
              <a:extLst>
                <a:ext uri="{FF2B5EF4-FFF2-40B4-BE49-F238E27FC236}">
                  <a16:creationId xmlns:a16="http://schemas.microsoft.com/office/drawing/2014/main" id="{C6E5C5C9-6AC3-FA20-E102-A8536BAA4ED8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10" name="rc58">
              <a:extLst>
                <a:ext uri="{FF2B5EF4-FFF2-40B4-BE49-F238E27FC236}">
                  <a16:creationId xmlns:a16="http://schemas.microsoft.com/office/drawing/2014/main" id="{74327090-0974-F77A-1519-1A60EC647BB8}"/>
                </a:ext>
              </a:extLst>
            </p:cNvPr>
            <p:cNvSpPr/>
            <p:nvPr/>
          </p:nvSpPr>
          <p:spPr>
            <a:xfrm>
              <a:off x="776476" y="4996549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311" name="tx59">
              <a:extLst>
                <a:ext uri="{FF2B5EF4-FFF2-40B4-BE49-F238E27FC236}">
                  <a16:creationId xmlns:a16="http://schemas.microsoft.com/office/drawing/2014/main" id="{BCB399AA-785A-2F64-0DE6-1D324450B37D}"/>
                </a:ext>
              </a:extLst>
            </p:cNvPr>
            <p:cNvSpPr/>
            <p:nvPr/>
          </p:nvSpPr>
          <p:spPr>
            <a:xfrm>
              <a:off x="1115323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12" name="tx60">
              <a:extLst>
                <a:ext uri="{FF2B5EF4-FFF2-40B4-BE49-F238E27FC236}">
                  <a16:creationId xmlns:a16="http://schemas.microsoft.com/office/drawing/2014/main" id="{D99BBA4C-760E-1266-C734-3B7445F60BCC}"/>
                </a:ext>
              </a:extLst>
            </p:cNvPr>
            <p:cNvSpPr/>
            <p:nvPr/>
          </p:nvSpPr>
          <p:spPr>
            <a:xfrm>
              <a:off x="1080154" y="5132574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6</a:t>
              </a:r>
            </a:p>
          </p:txBody>
        </p:sp>
        <p:sp>
          <p:nvSpPr>
            <p:cNvPr id="313" name="tx61">
              <a:extLst>
                <a:ext uri="{FF2B5EF4-FFF2-40B4-BE49-F238E27FC236}">
                  <a16:creationId xmlns:a16="http://schemas.microsoft.com/office/drawing/2014/main" id="{2F18E948-0BAA-3CD7-83A3-968E98F814F4}"/>
                </a:ext>
              </a:extLst>
            </p:cNvPr>
            <p:cNvSpPr/>
            <p:nvPr/>
          </p:nvSpPr>
          <p:spPr>
            <a:xfrm>
              <a:off x="3164724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314" name="tx62">
              <a:extLst>
                <a:ext uri="{FF2B5EF4-FFF2-40B4-BE49-F238E27FC236}">
                  <a16:creationId xmlns:a16="http://schemas.microsoft.com/office/drawing/2014/main" id="{A677AFB2-2DEE-AFD7-69CB-6F548033E86C}"/>
                </a:ext>
              </a:extLst>
            </p:cNvPr>
            <p:cNvSpPr/>
            <p:nvPr/>
          </p:nvSpPr>
          <p:spPr>
            <a:xfrm>
              <a:off x="3164724" y="5135661"/>
              <a:ext cx="70337" cy="8935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</a:t>
              </a:r>
            </a:p>
          </p:txBody>
        </p:sp>
        <p:sp>
          <p:nvSpPr>
            <p:cNvPr id="315" name="tx63">
              <a:extLst>
                <a:ext uri="{FF2B5EF4-FFF2-40B4-BE49-F238E27FC236}">
                  <a16:creationId xmlns:a16="http://schemas.microsoft.com/office/drawing/2014/main" id="{A179C133-66CF-F55F-0942-BEADE1CE1499}"/>
                </a:ext>
              </a:extLst>
            </p:cNvPr>
            <p:cNvSpPr/>
            <p:nvPr/>
          </p:nvSpPr>
          <p:spPr>
            <a:xfrm>
              <a:off x="5214125" y="5439829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316" name="tx64">
              <a:extLst>
                <a:ext uri="{FF2B5EF4-FFF2-40B4-BE49-F238E27FC236}">
                  <a16:creationId xmlns:a16="http://schemas.microsoft.com/office/drawing/2014/main" id="{EF3FF5B6-2C43-C497-871D-A9EB95AFE394}"/>
                </a:ext>
              </a:extLst>
            </p:cNvPr>
            <p:cNvSpPr/>
            <p:nvPr/>
          </p:nvSpPr>
          <p:spPr>
            <a:xfrm>
              <a:off x="5214125" y="5134488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317" name="tx65">
              <a:extLst>
                <a:ext uri="{FF2B5EF4-FFF2-40B4-BE49-F238E27FC236}">
                  <a16:creationId xmlns:a16="http://schemas.microsoft.com/office/drawing/2014/main" id="{338525B2-6B08-B2B1-C5F1-4AE26B7F5DC6}"/>
                </a:ext>
              </a:extLst>
            </p:cNvPr>
            <p:cNvSpPr/>
            <p:nvPr/>
          </p:nvSpPr>
          <p:spPr>
            <a:xfrm>
              <a:off x="7263526" y="5439520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318" name="tx66">
              <a:extLst>
                <a:ext uri="{FF2B5EF4-FFF2-40B4-BE49-F238E27FC236}">
                  <a16:creationId xmlns:a16="http://schemas.microsoft.com/office/drawing/2014/main" id="{A67AD056-CCE4-6BAD-F684-DF8B884ADD25}"/>
                </a:ext>
              </a:extLst>
            </p:cNvPr>
            <p:cNvSpPr/>
            <p:nvPr/>
          </p:nvSpPr>
          <p:spPr>
            <a:xfrm>
              <a:off x="7263526" y="5134117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319" name="tx67">
              <a:extLst>
                <a:ext uri="{FF2B5EF4-FFF2-40B4-BE49-F238E27FC236}">
                  <a16:creationId xmlns:a16="http://schemas.microsoft.com/office/drawing/2014/main" id="{880D3B23-834B-35DB-EA1D-77537EC0CA88}"/>
                </a:ext>
              </a:extLst>
            </p:cNvPr>
            <p:cNvSpPr/>
            <p:nvPr/>
          </p:nvSpPr>
          <p:spPr>
            <a:xfrm>
              <a:off x="325591" y="5438152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710" name="tx68">
              <a:extLst>
                <a:ext uri="{FF2B5EF4-FFF2-40B4-BE49-F238E27FC236}">
                  <a16:creationId xmlns:a16="http://schemas.microsoft.com/office/drawing/2014/main" id="{3A78B710-86C2-B626-7199-67F73CEFAD3C}"/>
                </a:ext>
              </a:extLst>
            </p:cNvPr>
            <p:cNvSpPr/>
            <p:nvPr/>
          </p:nvSpPr>
          <p:spPr>
            <a:xfrm>
              <a:off x="311638" y="5132811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711" name="tx69">
              <a:extLst>
                <a:ext uri="{FF2B5EF4-FFF2-40B4-BE49-F238E27FC236}">
                  <a16:creationId xmlns:a16="http://schemas.microsoft.com/office/drawing/2014/main" id="{B4BC31C8-99D4-07CD-746C-4569779F6A9B}"/>
                </a:ext>
              </a:extLst>
            </p:cNvPr>
            <p:cNvSpPr/>
            <p:nvPr/>
          </p:nvSpPr>
          <p:spPr>
            <a:xfrm>
              <a:off x="776476" y="4827633"/>
              <a:ext cx="17452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712" name="rc70">
              <a:extLst>
                <a:ext uri="{FF2B5EF4-FFF2-40B4-BE49-F238E27FC236}">
                  <a16:creationId xmlns:a16="http://schemas.microsoft.com/office/drawing/2014/main" id="{091491D7-05CD-9A99-2A9B-3D4AD94B0ADC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13" name="rc71">
              <a:extLst>
                <a:ext uri="{FF2B5EF4-FFF2-40B4-BE49-F238E27FC236}">
                  <a16:creationId xmlns:a16="http://schemas.microsoft.com/office/drawing/2014/main" id="{CF94B836-10DB-037B-1F3D-92C75BA62834}"/>
                </a:ext>
              </a:extLst>
            </p:cNvPr>
            <p:cNvSpPr/>
            <p:nvPr/>
          </p:nvSpPr>
          <p:spPr>
            <a:xfrm>
              <a:off x="776476" y="6081865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714" name="tx72">
              <a:extLst>
                <a:ext uri="{FF2B5EF4-FFF2-40B4-BE49-F238E27FC236}">
                  <a16:creationId xmlns:a16="http://schemas.microsoft.com/office/drawing/2014/main" id="{185FBAFA-EF2D-61E1-1E2E-11CD8D037D7A}"/>
                </a:ext>
              </a:extLst>
            </p:cNvPr>
            <p:cNvSpPr/>
            <p:nvPr/>
          </p:nvSpPr>
          <p:spPr>
            <a:xfrm>
              <a:off x="1115323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715" name="tx73">
              <a:extLst>
                <a:ext uri="{FF2B5EF4-FFF2-40B4-BE49-F238E27FC236}">
                  <a16:creationId xmlns:a16="http://schemas.microsoft.com/office/drawing/2014/main" id="{764AFD58-E980-7115-8CD7-DC29913F32BC}"/>
                </a:ext>
              </a:extLst>
            </p:cNvPr>
            <p:cNvSpPr/>
            <p:nvPr/>
          </p:nvSpPr>
          <p:spPr>
            <a:xfrm>
              <a:off x="1080154" y="6220978"/>
              <a:ext cx="140675" cy="8935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7</a:t>
              </a:r>
            </a:p>
          </p:txBody>
        </p:sp>
        <p:sp>
          <p:nvSpPr>
            <p:cNvPr id="716" name="tx74">
              <a:extLst>
                <a:ext uri="{FF2B5EF4-FFF2-40B4-BE49-F238E27FC236}">
                  <a16:creationId xmlns:a16="http://schemas.microsoft.com/office/drawing/2014/main" id="{6CEDCF59-BE15-DB3D-26B7-84D16648B310}"/>
                </a:ext>
              </a:extLst>
            </p:cNvPr>
            <p:cNvSpPr/>
            <p:nvPr/>
          </p:nvSpPr>
          <p:spPr>
            <a:xfrm>
              <a:off x="3164724" y="6525145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717" name="tx75">
              <a:extLst>
                <a:ext uri="{FF2B5EF4-FFF2-40B4-BE49-F238E27FC236}">
                  <a16:creationId xmlns:a16="http://schemas.microsoft.com/office/drawing/2014/main" id="{FE7938E8-0731-57CE-EEFE-8E58170B25C4}"/>
                </a:ext>
              </a:extLst>
            </p:cNvPr>
            <p:cNvSpPr/>
            <p:nvPr/>
          </p:nvSpPr>
          <p:spPr>
            <a:xfrm>
              <a:off x="3129555" y="6217828"/>
              <a:ext cx="140675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2</a:t>
              </a:r>
            </a:p>
          </p:txBody>
        </p:sp>
        <p:sp>
          <p:nvSpPr>
            <p:cNvPr id="718" name="tx76">
              <a:extLst>
                <a:ext uri="{FF2B5EF4-FFF2-40B4-BE49-F238E27FC236}">
                  <a16:creationId xmlns:a16="http://schemas.microsoft.com/office/drawing/2014/main" id="{59EFA3B0-511F-3256-A4DB-C3F328057DB4}"/>
                </a:ext>
              </a:extLst>
            </p:cNvPr>
            <p:cNvSpPr/>
            <p:nvPr/>
          </p:nvSpPr>
          <p:spPr>
            <a:xfrm>
              <a:off x="5214125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719" name="tx77">
              <a:extLst>
                <a:ext uri="{FF2B5EF4-FFF2-40B4-BE49-F238E27FC236}">
                  <a16:creationId xmlns:a16="http://schemas.microsoft.com/office/drawing/2014/main" id="{1E975B5B-43A4-D5ED-8F9E-E11DD4F2405E}"/>
                </a:ext>
              </a:extLst>
            </p:cNvPr>
            <p:cNvSpPr/>
            <p:nvPr/>
          </p:nvSpPr>
          <p:spPr>
            <a:xfrm>
              <a:off x="5178956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7</a:t>
              </a:r>
            </a:p>
          </p:txBody>
        </p:sp>
        <p:sp>
          <p:nvSpPr>
            <p:cNvPr id="720" name="tx78">
              <a:extLst>
                <a:ext uri="{FF2B5EF4-FFF2-40B4-BE49-F238E27FC236}">
                  <a16:creationId xmlns:a16="http://schemas.microsoft.com/office/drawing/2014/main" id="{390574AC-B753-2759-C08B-16B160297E12}"/>
                </a:ext>
              </a:extLst>
            </p:cNvPr>
            <p:cNvSpPr/>
            <p:nvPr/>
          </p:nvSpPr>
          <p:spPr>
            <a:xfrm>
              <a:off x="7263526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721" name="tx79">
              <a:extLst>
                <a:ext uri="{FF2B5EF4-FFF2-40B4-BE49-F238E27FC236}">
                  <a16:creationId xmlns:a16="http://schemas.microsoft.com/office/drawing/2014/main" id="{2B3E5FE1-79CE-62B8-C892-429B43E08F35}"/>
                </a:ext>
              </a:extLst>
            </p:cNvPr>
            <p:cNvSpPr/>
            <p:nvPr/>
          </p:nvSpPr>
          <p:spPr>
            <a:xfrm>
              <a:off x="7228357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1</a:t>
              </a:r>
            </a:p>
          </p:txBody>
        </p:sp>
        <p:sp>
          <p:nvSpPr>
            <p:cNvPr id="722" name="tx80">
              <a:extLst>
                <a:ext uri="{FF2B5EF4-FFF2-40B4-BE49-F238E27FC236}">
                  <a16:creationId xmlns:a16="http://schemas.microsoft.com/office/drawing/2014/main" id="{C245E1BC-58F3-7DCB-923E-38F0C5818BF7}"/>
                </a:ext>
              </a:extLst>
            </p:cNvPr>
            <p:cNvSpPr/>
            <p:nvPr/>
          </p:nvSpPr>
          <p:spPr>
            <a:xfrm>
              <a:off x="325591" y="6523468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723" name="tx81">
              <a:extLst>
                <a:ext uri="{FF2B5EF4-FFF2-40B4-BE49-F238E27FC236}">
                  <a16:creationId xmlns:a16="http://schemas.microsoft.com/office/drawing/2014/main" id="{3B0554F6-9224-6797-2136-5C080FEB7DC4}"/>
                </a:ext>
              </a:extLst>
            </p:cNvPr>
            <p:cNvSpPr/>
            <p:nvPr/>
          </p:nvSpPr>
          <p:spPr>
            <a:xfrm>
              <a:off x="311638" y="6218127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724" name="tx82">
              <a:extLst>
                <a:ext uri="{FF2B5EF4-FFF2-40B4-BE49-F238E27FC236}">
                  <a16:creationId xmlns:a16="http://schemas.microsoft.com/office/drawing/2014/main" id="{E3EDEE3E-97EC-B481-68A3-2572151213E2}"/>
                </a:ext>
              </a:extLst>
            </p:cNvPr>
            <p:cNvSpPr/>
            <p:nvPr/>
          </p:nvSpPr>
          <p:spPr>
            <a:xfrm>
              <a:off x="776476" y="5912949"/>
              <a:ext cx="23525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</p:grpSp>
      <p:sp>
        <p:nvSpPr>
          <p:cNvPr id="725" name="TextBox 724">
            <a:extLst>
              <a:ext uri="{FF2B5EF4-FFF2-40B4-BE49-F238E27FC236}">
                <a16:creationId xmlns:a16="http://schemas.microsoft.com/office/drawing/2014/main" id="{CCA2B49D-8E33-69BB-3478-F3F6A2263C2E}"/>
              </a:ext>
            </a:extLst>
          </p:cNvPr>
          <p:cNvSpPr txBox="1"/>
          <p:nvPr/>
        </p:nvSpPr>
        <p:spPr>
          <a:xfrm>
            <a:off x="817791" y="1801036"/>
            <a:ext cx="3125335" cy="6519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9" b="1" dirty="0">
                <a:latin typeface="Arial" panose="020B0604020202020204" pitchFamily="34" charset="0"/>
                <a:cs typeface="Arial" panose="020B0604020202020204" pitchFamily="34" charset="0"/>
              </a:rPr>
              <a:t>Potential Living Donor Total   Event   HR (95% CI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No                                     16       5          Reference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Yes                                    77      6       0.23 (0.07 – 0.72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Gray K-Sample Test P-value: 0.0041     </a:t>
            </a:r>
          </a:p>
        </p:txBody>
      </p:sp>
      <p:sp>
        <p:nvSpPr>
          <p:cNvPr id="726" name="pl48">
            <a:extLst>
              <a:ext uri="{FF2B5EF4-FFF2-40B4-BE49-F238E27FC236}">
                <a16:creationId xmlns:a16="http://schemas.microsoft.com/office/drawing/2014/main" id="{0D34E790-4BD7-701E-3208-3376448D9AD5}"/>
              </a:ext>
            </a:extLst>
          </p:cNvPr>
          <p:cNvSpPr/>
          <p:nvPr/>
        </p:nvSpPr>
        <p:spPr>
          <a:xfrm>
            <a:off x="740958" y="2043746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727" name="pl50">
            <a:extLst>
              <a:ext uri="{FF2B5EF4-FFF2-40B4-BE49-F238E27FC236}">
                <a16:creationId xmlns:a16="http://schemas.microsoft.com/office/drawing/2014/main" id="{1497962D-2D56-8329-8462-D5FB6E6D7DAB}"/>
              </a:ext>
            </a:extLst>
          </p:cNvPr>
          <p:cNvSpPr/>
          <p:nvPr/>
        </p:nvSpPr>
        <p:spPr>
          <a:xfrm>
            <a:off x="751977" y="2204665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grpSp>
        <p:nvGrpSpPr>
          <p:cNvPr id="728" name="Group 727">
            <a:extLst>
              <a:ext uri="{FF2B5EF4-FFF2-40B4-BE49-F238E27FC236}">
                <a16:creationId xmlns:a16="http://schemas.microsoft.com/office/drawing/2014/main" id="{3BA7A3B5-FAB1-CD0C-EB7D-6D9A1CAD4ACB}"/>
              </a:ext>
            </a:extLst>
          </p:cNvPr>
          <p:cNvGrpSpPr>
            <a:grpSpLocks noChangeAspect="1"/>
          </p:cNvGrpSpPr>
          <p:nvPr/>
        </p:nvGrpSpPr>
        <p:grpSpPr>
          <a:xfrm>
            <a:off x="81012" y="5387144"/>
            <a:ext cx="4772660" cy="3571875"/>
            <a:chOff x="0" y="0"/>
            <a:chExt cx="9144000" cy="6858000"/>
          </a:xfrm>
        </p:grpSpPr>
        <p:sp>
          <p:nvSpPr>
            <p:cNvPr id="729" name="rc3">
              <a:extLst>
                <a:ext uri="{FF2B5EF4-FFF2-40B4-BE49-F238E27FC236}">
                  <a16:creationId xmlns:a16="http://schemas.microsoft.com/office/drawing/2014/main" id="{9901C177-212A-03CE-36A3-662AA192C313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30" name="rc4">
              <a:extLst>
                <a:ext uri="{FF2B5EF4-FFF2-40B4-BE49-F238E27FC236}">
                  <a16:creationId xmlns:a16="http://schemas.microsoft.com/office/drawing/2014/main" id="{51E75EF9-4373-DB9F-A9C3-3FD3464187AE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31" name="rc5">
              <a:extLst>
                <a:ext uri="{FF2B5EF4-FFF2-40B4-BE49-F238E27FC236}">
                  <a16:creationId xmlns:a16="http://schemas.microsoft.com/office/drawing/2014/main" id="{1B45D4C9-319D-ADF7-4781-0FB54A14045F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32" name="rc6">
              <a:extLst>
                <a:ext uri="{FF2B5EF4-FFF2-40B4-BE49-F238E27FC236}">
                  <a16:creationId xmlns:a16="http://schemas.microsoft.com/office/drawing/2014/main" id="{41539153-F044-EA6E-93FC-9FB14BA29536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33" name="rc7">
              <a:extLst>
                <a:ext uri="{FF2B5EF4-FFF2-40B4-BE49-F238E27FC236}">
                  <a16:creationId xmlns:a16="http://schemas.microsoft.com/office/drawing/2014/main" id="{B1DBBCF9-DF8F-F58C-DED7-12DB90889F1F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34" name="rc9">
              <a:extLst>
                <a:ext uri="{FF2B5EF4-FFF2-40B4-BE49-F238E27FC236}">
                  <a16:creationId xmlns:a16="http://schemas.microsoft.com/office/drawing/2014/main" id="{663318D4-4FD5-6CB7-8131-BC81AF337659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735" name="pl18">
              <a:extLst>
                <a:ext uri="{FF2B5EF4-FFF2-40B4-BE49-F238E27FC236}">
                  <a16:creationId xmlns:a16="http://schemas.microsoft.com/office/drawing/2014/main" id="{DDC6AE54-05DE-D6CB-9BCC-A83868067F73}"/>
                </a:ext>
              </a:extLst>
            </p:cNvPr>
            <p:cNvSpPr/>
            <p:nvPr/>
          </p:nvSpPr>
          <p:spPr>
            <a:xfrm>
              <a:off x="776476" y="3534137"/>
              <a:ext cx="8228345" cy="0"/>
            </a:xfrm>
            <a:custGeom>
              <a:avLst/>
              <a:gdLst/>
              <a:ahLst/>
              <a:cxnLst/>
              <a:rect l="0" t="0" r="0" b="0"/>
              <a:pathLst>
                <a:path w="8228345">
                  <a:moveTo>
                    <a:pt x="0" y="0"/>
                  </a:moveTo>
                  <a:lnTo>
                    <a:pt x="8228345" y="0"/>
                  </a:lnTo>
                  <a:lnTo>
                    <a:pt x="8228345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36" name="pl23">
              <a:extLst>
                <a:ext uri="{FF2B5EF4-FFF2-40B4-BE49-F238E27FC236}">
                  <a16:creationId xmlns:a16="http://schemas.microsoft.com/office/drawing/2014/main" id="{CCA69840-571D-484C-CB22-29C887B6B11E}"/>
                </a:ext>
              </a:extLst>
            </p:cNvPr>
            <p:cNvSpPr/>
            <p:nvPr/>
          </p:nvSpPr>
          <p:spPr>
            <a:xfrm>
              <a:off x="1150492" y="139178"/>
              <a:ext cx="0" cy="3556623"/>
            </a:xfrm>
            <a:custGeom>
              <a:avLst/>
              <a:gdLst/>
              <a:ahLst/>
              <a:cxnLst/>
              <a:rect l="0" t="0" r="0" b="0"/>
              <a:pathLst>
                <a:path h="3556623">
                  <a:moveTo>
                    <a:pt x="0" y="35566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37" name="pl27">
              <a:extLst>
                <a:ext uri="{FF2B5EF4-FFF2-40B4-BE49-F238E27FC236}">
                  <a16:creationId xmlns:a16="http://schemas.microsoft.com/office/drawing/2014/main" id="{4B3483E4-9697-9D76-6F98-1F9474D45292}"/>
                </a:ext>
              </a:extLst>
            </p:cNvPr>
            <p:cNvSpPr/>
            <p:nvPr/>
          </p:nvSpPr>
          <p:spPr>
            <a:xfrm>
              <a:off x="1150492" y="2650968"/>
              <a:ext cx="6209685" cy="883168"/>
            </a:xfrm>
            <a:custGeom>
              <a:avLst/>
              <a:gdLst/>
              <a:ahLst/>
              <a:cxnLst/>
              <a:rect l="0" t="0" r="0" b="0"/>
              <a:pathLst>
                <a:path w="6209685" h="883168">
                  <a:moveTo>
                    <a:pt x="0" y="883168"/>
                  </a:moveTo>
                  <a:lnTo>
                    <a:pt x="71729" y="883168"/>
                  </a:lnTo>
                  <a:lnTo>
                    <a:pt x="71729" y="883168"/>
                  </a:lnTo>
                  <a:lnTo>
                    <a:pt x="317657" y="883168"/>
                  </a:lnTo>
                  <a:lnTo>
                    <a:pt x="317657" y="883168"/>
                  </a:lnTo>
                  <a:lnTo>
                    <a:pt x="389386" y="883168"/>
                  </a:lnTo>
                  <a:lnTo>
                    <a:pt x="389386" y="883168"/>
                  </a:lnTo>
                  <a:lnTo>
                    <a:pt x="440621" y="883168"/>
                  </a:lnTo>
                  <a:lnTo>
                    <a:pt x="440621" y="703540"/>
                  </a:lnTo>
                  <a:lnTo>
                    <a:pt x="809513" y="703540"/>
                  </a:lnTo>
                  <a:lnTo>
                    <a:pt x="809513" y="523913"/>
                  </a:lnTo>
                  <a:lnTo>
                    <a:pt x="1014453" y="523913"/>
                  </a:lnTo>
                  <a:lnTo>
                    <a:pt x="1014453" y="523913"/>
                  </a:lnTo>
                  <a:lnTo>
                    <a:pt x="1250134" y="523913"/>
                  </a:lnTo>
                  <a:lnTo>
                    <a:pt x="1250134" y="523913"/>
                  </a:lnTo>
                  <a:lnTo>
                    <a:pt x="1619026" y="523913"/>
                  </a:lnTo>
                  <a:lnTo>
                    <a:pt x="1619026" y="523913"/>
                  </a:lnTo>
                  <a:lnTo>
                    <a:pt x="1834213" y="523913"/>
                  </a:lnTo>
                  <a:lnTo>
                    <a:pt x="1834213" y="523913"/>
                  </a:lnTo>
                  <a:lnTo>
                    <a:pt x="2490022" y="523913"/>
                  </a:lnTo>
                  <a:lnTo>
                    <a:pt x="2490022" y="299379"/>
                  </a:lnTo>
                  <a:lnTo>
                    <a:pt x="2520763" y="299379"/>
                  </a:lnTo>
                  <a:lnTo>
                    <a:pt x="2520763" y="299379"/>
                  </a:lnTo>
                  <a:lnTo>
                    <a:pt x="3074101" y="299379"/>
                  </a:lnTo>
                  <a:lnTo>
                    <a:pt x="3074101" y="299379"/>
                  </a:lnTo>
                  <a:lnTo>
                    <a:pt x="4273001" y="299379"/>
                  </a:lnTo>
                  <a:lnTo>
                    <a:pt x="4273001" y="299379"/>
                  </a:lnTo>
                  <a:lnTo>
                    <a:pt x="4324236" y="299379"/>
                  </a:lnTo>
                  <a:lnTo>
                    <a:pt x="4324236" y="299379"/>
                  </a:lnTo>
                  <a:lnTo>
                    <a:pt x="4672634" y="299379"/>
                  </a:lnTo>
                  <a:lnTo>
                    <a:pt x="4672634" y="0"/>
                  </a:lnTo>
                  <a:lnTo>
                    <a:pt x="6209685" y="0"/>
                  </a:lnTo>
                  <a:lnTo>
                    <a:pt x="6209685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38" name="pl28">
              <a:extLst>
                <a:ext uri="{FF2B5EF4-FFF2-40B4-BE49-F238E27FC236}">
                  <a16:creationId xmlns:a16="http://schemas.microsoft.com/office/drawing/2014/main" id="{9C313998-FEE3-9B54-A709-7D06D17FF25F}"/>
                </a:ext>
              </a:extLst>
            </p:cNvPr>
            <p:cNvSpPr/>
            <p:nvPr/>
          </p:nvSpPr>
          <p:spPr>
            <a:xfrm>
              <a:off x="1150492" y="3393425"/>
              <a:ext cx="7265126" cy="140711"/>
            </a:xfrm>
            <a:custGeom>
              <a:avLst/>
              <a:gdLst/>
              <a:ahLst/>
              <a:cxnLst/>
              <a:rect l="0" t="0" r="0" b="0"/>
              <a:pathLst>
                <a:path w="7265126" h="140711">
                  <a:moveTo>
                    <a:pt x="0" y="140711"/>
                  </a:moveTo>
                  <a:lnTo>
                    <a:pt x="10247" y="140711"/>
                  </a:lnTo>
                  <a:lnTo>
                    <a:pt x="10247" y="140711"/>
                  </a:lnTo>
                  <a:lnTo>
                    <a:pt x="194693" y="140711"/>
                  </a:lnTo>
                  <a:lnTo>
                    <a:pt x="194693" y="140711"/>
                  </a:lnTo>
                  <a:lnTo>
                    <a:pt x="204940" y="140711"/>
                  </a:lnTo>
                  <a:lnTo>
                    <a:pt x="204940" y="140711"/>
                  </a:lnTo>
                  <a:lnTo>
                    <a:pt x="256175" y="140711"/>
                  </a:lnTo>
                  <a:lnTo>
                    <a:pt x="256175" y="140711"/>
                  </a:lnTo>
                  <a:lnTo>
                    <a:pt x="297163" y="140711"/>
                  </a:lnTo>
                  <a:lnTo>
                    <a:pt x="297163" y="140711"/>
                  </a:lnTo>
                  <a:lnTo>
                    <a:pt x="338151" y="140711"/>
                  </a:lnTo>
                  <a:lnTo>
                    <a:pt x="338151" y="106657"/>
                  </a:lnTo>
                  <a:lnTo>
                    <a:pt x="389386" y="106657"/>
                  </a:lnTo>
                  <a:lnTo>
                    <a:pt x="389386" y="106657"/>
                  </a:lnTo>
                  <a:lnTo>
                    <a:pt x="409880" y="106657"/>
                  </a:lnTo>
                  <a:lnTo>
                    <a:pt x="409880" y="106657"/>
                  </a:lnTo>
                  <a:lnTo>
                    <a:pt x="440621" y="106657"/>
                  </a:lnTo>
                  <a:lnTo>
                    <a:pt x="440621" y="72202"/>
                  </a:lnTo>
                  <a:lnTo>
                    <a:pt x="471362" y="72202"/>
                  </a:lnTo>
                  <a:lnTo>
                    <a:pt x="471362" y="72202"/>
                  </a:lnTo>
                  <a:lnTo>
                    <a:pt x="491856" y="72202"/>
                  </a:lnTo>
                  <a:lnTo>
                    <a:pt x="491856" y="72202"/>
                  </a:lnTo>
                  <a:lnTo>
                    <a:pt x="502103" y="72202"/>
                  </a:lnTo>
                  <a:lnTo>
                    <a:pt x="502103" y="72202"/>
                  </a:lnTo>
                  <a:lnTo>
                    <a:pt x="532844" y="72202"/>
                  </a:lnTo>
                  <a:lnTo>
                    <a:pt x="532844" y="72202"/>
                  </a:lnTo>
                  <a:lnTo>
                    <a:pt x="635314" y="72202"/>
                  </a:lnTo>
                  <a:lnTo>
                    <a:pt x="635314" y="72202"/>
                  </a:lnTo>
                  <a:lnTo>
                    <a:pt x="645561" y="72202"/>
                  </a:lnTo>
                  <a:lnTo>
                    <a:pt x="645561" y="72202"/>
                  </a:lnTo>
                  <a:lnTo>
                    <a:pt x="717290" y="72202"/>
                  </a:lnTo>
                  <a:lnTo>
                    <a:pt x="717290" y="72202"/>
                  </a:lnTo>
                  <a:lnTo>
                    <a:pt x="737784" y="72202"/>
                  </a:lnTo>
                  <a:lnTo>
                    <a:pt x="737784" y="72202"/>
                  </a:lnTo>
                  <a:lnTo>
                    <a:pt x="789019" y="72202"/>
                  </a:lnTo>
                  <a:lnTo>
                    <a:pt x="789019" y="72202"/>
                  </a:lnTo>
                  <a:lnTo>
                    <a:pt x="830007" y="72202"/>
                  </a:lnTo>
                  <a:lnTo>
                    <a:pt x="830007" y="72202"/>
                  </a:lnTo>
                  <a:lnTo>
                    <a:pt x="860748" y="72202"/>
                  </a:lnTo>
                  <a:lnTo>
                    <a:pt x="860748" y="72202"/>
                  </a:lnTo>
                  <a:lnTo>
                    <a:pt x="901736" y="72202"/>
                  </a:lnTo>
                  <a:lnTo>
                    <a:pt x="901736" y="72202"/>
                  </a:lnTo>
                  <a:lnTo>
                    <a:pt x="922230" y="72202"/>
                  </a:lnTo>
                  <a:lnTo>
                    <a:pt x="922230" y="72202"/>
                  </a:lnTo>
                  <a:lnTo>
                    <a:pt x="1004206" y="72202"/>
                  </a:lnTo>
                  <a:lnTo>
                    <a:pt x="1004206" y="72202"/>
                  </a:lnTo>
                  <a:lnTo>
                    <a:pt x="1034947" y="72202"/>
                  </a:lnTo>
                  <a:lnTo>
                    <a:pt x="1034947" y="72202"/>
                  </a:lnTo>
                  <a:lnTo>
                    <a:pt x="1065688" y="72202"/>
                  </a:lnTo>
                  <a:lnTo>
                    <a:pt x="1065688" y="72202"/>
                  </a:lnTo>
                  <a:lnTo>
                    <a:pt x="1096429" y="72202"/>
                  </a:lnTo>
                  <a:lnTo>
                    <a:pt x="1096429" y="72202"/>
                  </a:lnTo>
                  <a:lnTo>
                    <a:pt x="1116923" y="72202"/>
                  </a:lnTo>
                  <a:lnTo>
                    <a:pt x="1116923" y="72202"/>
                  </a:lnTo>
                  <a:lnTo>
                    <a:pt x="1157911" y="72202"/>
                  </a:lnTo>
                  <a:lnTo>
                    <a:pt x="1157911" y="72202"/>
                  </a:lnTo>
                  <a:lnTo>
                    <a:pt x="1168158" y="72202"/>
                  </a:lnTo>
                  <a:lnTo>
                    <a:pt x="1168158" y="72202"/>
                  </a:lnTo>
                  <a:lnTo>
                    <a:pt x="1178405" y="72202"/>
                  </a:lnTo>
                  <a:lnTo>
                    <a:pt x="1178405" y="72202"/>
                  </a:lnTo>
                  <a:lnTo>
                    <a:pt x="1250134" y="72202"/>
                  </a:lnTo>
                  <a:lnTo>
                    <a:pt x="1250134" y="72202"/>
                  </a:lnTo>
                  <a:lnTo>
                    <a:pt x="1280875" y="72202"/>
                  </a:lnTo>
                  <a:lnTo>
                    <a:pt x="1280875" y="72202"/>
                  </a:lnTo>
                  <a:lnTo>
                    <a:pt x="1291122" y="72202"/>
                  </a:lnTo>
                  <a:lnTo>
                    <a:pt x="1291122" y="72202"/>
                  </a:lnTo>
                  <a:lnTo>
                    <a:pt x="1332110" y="72202"/>
                  </a:lnTo>
                  <a:lnTo>
                    <a:pt x="1332110" y="37311"/>
                  </a:lnTo>
                  <a:lnTo>
                    <a:pt x="1434580" y="37311"/>
                  </a:lnTo>
                  <a:lnTo>
                    <a:pt x="1434580" y="37311"/>
                  </a:lnTo>
                  <a:lnTo>
                    <a:pt x="1444827" y="37311"/>
                  </a:lnTo>
                  <a:lnTo>
                    <a:pt x="1444827" y="37311"/>
                  </a:lnTo>
                  <a:lnTo>
                    <a:pt x="1547297" y="37311"/>
                  </a:lnTo>
                  <a:lnTo>
                    <a:pt x="1547297" y="37311"/>
                  </a:lnTo>
                  <a:lnTo>
                    <a:pt x="1588285" y="37311"/>
                  </a:lnTo>
                  <a:lnTo>
                    <a:pt x="1588285" y="37311"/>
                  </a:lnTo>
                  <a:lnTo>
                    <a:pt x="1711249" y="37311"/>
                  </a:lnTo>
                  <a:lnTo>
                    <a:pt x="1711249" y="37311"/>
                  </a:lnTo>
                  <a:lnTo>
                    <a:pt x="1752237" y="37311"/>
                  </a:lnTo>
                  <a:lnTo>
                    <a:pt x="1752237" y="37311"/>
                  </a:lnTo>
                  <a:lnTo>
                    <a:pt x="1762484" y="37311"/>
                  </a:lnTo>
                  <a:lnTo>
                    <a:pt x="1762484" y="37311"/>
                  </a:lnTo>
                  <a:lnTo>
                    <a:pt x="1864954" y="37311"/>
                  </a:lnTo>
                  <a:lnTo>
                    <a:pt x="1864954" y="37311"/>
                  </a:lnTo>
                  <a:lnTo>
                    <a:pt x="1895695" y="37311"/>
                  </a:lnTo>
                  <a:lnTo>
                    <a:pt x="1895695" y="37311"/>
                  </a:lnTo>
                  <a:lnTo>
                    <a:pt x="1905942" y="37311"/>
                  </a:lnTo>
                  <a:lnTo>
                    <a:pt x="1905942" y="37311"/>
                  </a:lnTo>
                  <a:lnTo>
                    <a:pt x="1936683" y="37311"/>
                  </a:lnTo>
                  <a:lnTo>
                    <a:pt x="1936683" y="37311"/>
                  </a:lnTo>
                  <a:lnTo>
                    <a:pt x="1957177" y="37311"/>
                  </a:lnTo>
                  <a:lnTo>
                    <a:pt x="1957177" y="37311"/>
                  </a:lnTo>
                  <a:lnTo>
                    <a:pt x="2244094" y="37311"/>
                  </a:lnTo>
                  <a:lnTo>
                    <a:pt x="2244094" y="0"/>
                  </a:lnTo>
                  <a:lnTo>
                    <a:pt x="2356811" y="0"/>
                  </a:lnTo>
                  <a:lnTo>
                    <a:pt x="2356811" y="0"/>
                  </a:lnTo>
                  <a:lnTo>
                    <a:pt x="2367058" y="0"/>
                  </a:lnTo>
                  <a:lnTo>
                    <a:pt x="2367058" y="0"/>
                  </a:lnTo>
                  <a:lnTo>
                    <a:pt x="2408046" y="0"/>
                  </a:lnTo>
                  <a:lnTo>
                    <a:pt x="2408046" y="0"/>
                  </a:lnTo>
                  <a:lnTo>
                    <a:pt x="2418293" y="0"/>
                  </a:lnTo>
                  <a:lnTo>
                    <a:pt x="2418293" y="0"/>
                  </a:lnTo>
                  <a:lnTo>
                    <a:pt x="2571998" y="0"/>
                  </a:lnTo>
                  <a:lnTo>
                    <a:pt x="2571998" y="0"/>
                  </a:lnTo>
                  <a:lnTo>
                    <a:pt x="2705209" y="0"/>
                  </a:lnTo>
                  <a:lnTo>
                    <a:pt x="2705209" y="0"/>
                  </a:lnTo>
                  <a:lnTo>
                    <a:pt x="2725703" y="0"/>
                  </a:lnTo>
                  <a:lnTo>
                    <a:pt x="2725703" y="0"/>
                  </a:lnTo>
                  <a:lnTo>
                    <a:pt x="2735950" y="0"/>
                  </a:lnTo>
                  <a:lnTo>
                    <a:pt x="2735950" y="0"/>
                  </a:lnTo>
                  <a:lnTo>
                    <a:pt x="2787185" y="0"/>
                  </a:lnTo>
                  <a:lnTo>
                    <a:pt x="2787185" y="0"/>
                  </a:lnTo>
                  <a:lnTo>
                    <a:pt x="3002372" y="0"/>
                  </a:lnTo>
                  <a:lnTo>
                    <a:pt x="3002372" y="0"/>
                  </a:lnTo>
                  <a:lnTo>
                    <a:pt x="3340523" y="0"/>
                  </a:lnTo>
                  <a:lnTo>
                    <a:pt x="3340523" y="0"/>
                  </a:lnTo>
                  <a:lnTo>
                    <a:pt x="3842626" y="0"/>
                  </a:lnTo>
                  <a:lnTo>
                    <a:pt x="3842626" y="0"/>
                  </a:lnTo>
                  <a:lnTo>
                    <a:pt x="3863120" y="0"/>
                  </a:lnTo>
                  <a:lnTo>
                    <a:pt x="3863120" y="0"/>
                  </a:lnTo>
                  <a:lnTo>
                    <a:pt x="3873367" y="0"/>
                  </a:lnTo>
                  <a:lnTo>
                    <a:pt x="3873367" y="0"/>
                  </a:lnTo>
                  <a:lnTo>
                    <a:pt x="3945096" y="0"/>
                  </a:lnTo>
                  <a:lnTo>
                    <a:pt x="3945096" y="0"/>
                  </a:lnTo>
                  <a:lnTo>
                    <a:pt x="4590658" y="0"/>
                  </a:lnTo>
                  <a:lnTo>
                    <a:pt x="4590658" y="0"/>
                  </a:lnTo>
                  <a:lnTo>
                    <a:pt x="4877574" y="0"/>
                  </a:lnTo>
                  <a:lnTo>
                    <a:pt x="4877574" y="0"/>
                  </a:lnTo>
                  <a:lnTo>
                    <a:pt x="5092761" y="0"/>
                  </a:lnTo>
                  <a:lnTo>
                    <a:pt x="5092761" y="0"/>
                  </a:lnTo>
                  <a:lnTo>
                    <a:pt x="5379677" y="0"/>
                  </a:lnTo>
                  <a:lnTo>
                    <a:pt x="5379677" y="0"/>
                  </a:lnTo>
                  <a:lnTo>
                    <a:pt x="5512888" y="0"/>
                  </a:lnTo>
                  <a:lnTo>
                    <a:pt x="5512888" y="0"/>
                  </a:lnTo>
                  <a:lnTo>
                    <a:pt x="5994498" y="0"/>
                  </a:lnTo>
                  <a:lnTo>
                    <a:pt x="5994498" y="0"/>
                  </a:lnTo>
                  <a:lnTo>
                    <a:pt x="6045733" y="0"/>
                  </a:lnTo>
                  <a:lnTo>
                    <a:pt x="6045733" y="0"/>
                  </a:lnTo>
                  <a:lnTo>
                    <a:pt x="6301908" y="0"/>
                  </a:lnTo>
                  <a:lnTo>
                    <a:pt x="6301908" y="0"/>
                  </a:lnTo>
                  <a:lnTo>
                    <a:pt x="6527342" y="0"/>
                  </a:lnTo>
                  <a:lnTo>
                    <a:pt x="6527342" y="0"/>
                  </a:lnTo>
                  <a:lnTo>
                    <a:pt x="7049939" y="0"/>
                  </a:lnTo>
                  <a:lnTo>
                    <a:pt x="7049939" y="0"/>
                  </a:lnTo>
                  <a:lnTo>
                    <a:pt x="7265126" y="0"/>
                  </a:lnTo>
                  <a:lnTo>
                    <a:pt x="7265126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39" name="rc29">
              <a:extLst>
                <a:ext uri="{FF2B5EF4-FFF2-40B4-BE49-F238E27FC236}">
                  <a16:creationId xmlns:a16="http://schemas.microsoft.com/office/drawing/2014/main" id="{53583E9B-48DC-F5A9-C9AA-FAE511FBFD34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40" name="tx30">
              <a:extLst>
                <a:ext uri="{FF2B5EF4-FFF2-40B4-BE49-F238E27FC236}">
                  <a16:creationId xmlns:a16="http://schemas.microsoft.com/office/drawing/2014/main" id="{51B2B912-5FAB-2ED2-8E37-8249B991C851}"/>
                </a:ext>
              </a:extLst>
            </p:cNvPr>
            <p:cNvSpPr/>
            <p:nvPr/>
          </p:nvSpPr>
          <p:spPr>
            <a:xfrm>
              <a:off x="466667" y="3486760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741" name="tx31">
              <a:extLst>
                <a:ext uri="{FF2B5EF4-FFF2-40B4-BE49-F238E27FC236}">
                  <a16:creationId xmlns:a16="http://schemas.microsoft.com/office/drawing/2014/main" id="{E3D3A573-4493-DFCD-8FB5-F2E369797D1C}"/>
                </a:ext>
              </a:extLst>
            </p:cNvPr>
            <p:cNvSpPr/>
            <p:nvPr/>
          </p:nvSpPr>
          <p:spPr>
            <a:xfrm>
              <a:off x="466667" y="2678436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742" name="tx32">
              <a:extLst>
                <a:ext uri="{FF2B5EF4-FFF2-40B4-BE49-F238E27FC236}">
                  <a16:creationId xmlns:a16="http://schemas.microsoft.com/office/drawing/2014/main" id="{DB0F6734-560E-B37B-DDDE-E688913932CA}"/>
                </a:ext>
              </a:extLst>
            </p:cNvPr>
            <p:cNvSpPr/>
            <p:nvPr/>
          </p:nvSpPr>
          <p:spPr>
            <a:xfrm>
              <a:off x="466667" y="1870113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743" name="tx33">
              <a:extLst>
                <a:ext uri="{FF2B5EF4-FFF2-40B4-BE49-F238E27FC236}">
                  <a16:creationId xmlns:a16="http://schemas.microsoft.com/office/drawing/2014/main" id="{73316AEE-3253-5076-779A-8C1B264D114B}"/>
                </a:ext>
              </a:extLst>
            </p:cNvPr>
            <p:cNvSpPr/>
            <p:nvPr/>
          </p:nvSpPr>
          <p:spPr>
            <a:xfrm>
              <a:off x="466667" y="1061789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744" name="tx34">
              <a:extLst>
                <a:ext uri="{FF2B5EF4-FFF2-40B4-BE49-F238E27FC236}">
                  <a16:creationId xmlns:a16="http://schemas.microsoft.com/office/drawing/2014/main" id="{09FE6B4C-0C76-6ECC-1D44-03448FE349FB}"/>
                </a:ext>
              </a:extLst>
            </p:cNvPr>
            <p:cNvSpPr/>
            <p:nvPr/>
          </p:nvSpPr>
          <p:spPr>
            <a:xfrm>
              <a:off x="466667" y="253465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0</a:t>
              </a:r>
            </a:p>
          </p:txBody>
        </p:sp>
        <p:sp>
          <p:nvSpPr>
            <p:cNvPr id="745" name="pl35">
              <a:extLst>
                <a:ext uri="{FF2B5EF4-FFF2-40B4-BE49-F238E27FC236}">
                  <a16:creationId xmlns:a16="http://schemas.microsoft.com/office/drawing/2014/main" id="{9957BFA5-E5AA-144A-8BDE-ED7B1C815066}"/>
                </a:ext>
              </a:extLst>
            </p:cNvPr>
            <p:cNvSpPr/>
            <p:nvPr/>
          </p:nvSpPr>
          <p:spPr>
            <a:xfrm>
              <a:off x="741682" y="353413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46" name="pl36">
              <a:extLst>
                <a:ext uri="{FF2B5EF4-FFF2-40B4-BE49-F238E27FC236}">
                  <a16:creationId xmlns:a16="http://schemas.microsoft.com/office/drawing/2014/main" id="{A809200F-9B88-343F-8A6D-7EAEDF876D08}"/>
                </a:ext>
              </a:extLst>
            </p:cNvPr>
            <p:cNvSpPr/>
            <p:nvPr/>
          </p:nvSpPr>
          <p:spPr>
            <a:xfrm>
              <a:off x="741682" y="2725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47" name="pl37">
              <a:extLst>
                <a:ext uri="{FF2B5EF4-FFF2-40B4-BE49-F238E27FC236}">
                  <a16:creationId xmlns:a16="http://schemas.microsoft.com/office/drawing/2014/main" id="{7E359A26-1667-3B3B-ED44-E83EA16CDC4A}"/>
                </a:ext>
              </a:extLst>
            </p:cNvPr>
            <p:cNvSpPr/>
            <p:nvPr/>
          </p:nvSpPr>
          <p:spPr>
            <a:xfrm>
              <a:off x="741682" y="19174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48" name="pl38">
              <a:extLst>
                <a:ext uri="{FF2B5EF4-FFF2-40B4-BE49-F238E27FC236}">
                  <a16:creationId xmlns:a16="http://schemas.microsoft.com/office/drawing/2014/main" id="{DE1D52F0-3A44-E7BB-1A76-2C1F5416EB4E}"/>
                </a:ext>
              </a:extLst>
            </p:cNvPr>
            <p:cNvSpPr/>
            <p:nvPr/>
          </p:nvSpPr>
          <p:spPr>
            <a:xfrm>
              <a:off x="741682" y="11091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49" name="pl39">
              <a:extLst>
                <a:ext uri="{FF2B5EF4-FFF2-40B4-BE49-F238E27FC236}">
                  <a16:creationId xmlns:a16="http://schemas.microsoft.com/office/drawing/2014/main" id="{7634DD32-4D57-E131-8AEE-643DD622401D}"/>
                </a:ext>
              </a:extLst>
            </p:cNvPr>
            <p:cNvSpPr/>
            <p:nvPr/>
          </p:nvSpPr>
          <p:spPr>
            <a:xfrm>
              <a:off x="741682" y="3008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50" name="pl40">
              <a:extLst>
                <a:ext uri="{FF2B5EF4-FFF2-40B4-BE49-F238E27FC236}">
                  <a16:creationId xmlns:a16="http://schemas.microsoft.com/office/drawing/2014/main" id="{D0CB8834-625D-EEAD-E5CC-932F4138E897}"/>
                </a:ext>
              </a:extLst>
            </p:cNvPr>
            <p:cNvSpPr/>
            <p:nvPr/>
          </p:nvSpPr>
          <p:spPr>
            <a:xfrm>
              <a:off x="1150492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51" name="pl41">
              <a:extLst>
                <a:ext uri="{FF2B5EF4-FFF2-40B4-BE49-F238E27FC236}">
                  <a16:creationId xmlns:a16="http://schemas.microsoft.com/office/drawing/2014/main" id="{67E25955-E074-4763-3BB6-19EE57885A28}"/>
                </a:ext>
              </a:extLst>
            </p:cNvPr>
            <p:cNvSpPr/>
            <p:nvPr/>
          </p:nvSpPr>
          <p:spPr>
            <a:xfrm>
              <a:off x="3199893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52" name="pl42">
              <a:extLst>
                <a:ext uri="{FF2B5EF4-FFF2-40B4-BE49-F238E27FC236}">
                  <a16:creationId xmlns:a16="http://schemas.microsoft.com/office/drawing/2014/main" id="{8EBE8679-1849-97B5-FDEE-5283AE54A37F}"/>
                </a:ext>
              </a:extLst>
            </p:cNvPr>
            <p:cNvSpPr/>
            <p:nvPr/>
          </p:nvSpPr>
          <p:spPr>
            <a:xfrm>
              <a:off x="5249294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53" name="pl43">
              <a:extLst>
                <a:ext uri="{FF2B5EF4-FFF2-40B4-BE49-F238E27FC236}">
                  <a16:creationId xmlns:a16="http://schemas.microsoft.com/office/drawing/2014/main" id="{DE31436C-3A11-01BD-1A7B-2AD2A1E1CE11}"/>
                </a:ext>
              </a:extLst>
            </p:cNvPr>
            <p:cNvSpPr/>
            <p:nvPr/>
          </p:nvSpPr>
          <p:spPr>
            <a:xfrm>
              <a:off x="7298695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54" name="tx44">
              <a:extLst>
                <a:ext uri="{FF2B5EF4-FFF2-40B4-BE49-F238E27FC236}">
                  <a16:creationId xmlns:a16="http://schemas.microsoft.com/office/drawing/2014/main" id="{A7940959-99A7-0F4B-48D4-C9200B110FBF}"/>
                </a:ext>
              </a:extLst>
            </p:cNvPr>
            <p:cNvSpPr/>
            <p:nvPr/>
          </p:nvSpPr>
          <p:spPr>
            <a:xfrm>
              <a:off x="1115176" y="3756509"/>
              <a:ext cx="70631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755" name="tx45">
              <a:extLst>
                <a:ext uri="{FF2B5EF4-FFF2-40B4-BE49-F238E27FC236}">
                  <a16:creationId xmlns:a16="http://schemas.microsoft.com/office/drawing/2014/main" id="{E4428CF3-811C-0622-31B3-A9EAAFEDFF1E}"/>
                </a:ext>
              </a:extLst>
            </p:cNvPr>
            <p:cNvSpPr/>
            <p:nvPr/>
          </p:nvSpPr>
          <p:spPr>
            <a:xfrm>
              <a:off x="3093946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756" name="tx46">
              <a:extLst>
                <a:ext uri="{FF2B5EF4-FFF2-40B4-BE49-F238E27FC236}">
                  <a16:creationId xmlns:a16="http://schemas.microsoft.com/office/drawing/2014/main" id="{940295CD-1365-239E-E6FB-3BEDA1EB57FC}"/>
                </a:ext>
              </a:extLst>
            </p:cNvPr>
            <p:cNvSpPr/>
            <p:nvPr/>
          </p:nvSpPr>
          <p:spPr>
            <a:xfrm>
              <a:off x="5143347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757" name="tx47">
              <a:extLst>
                <a:ext uri="{FF2B5EF4-FFF2-40B4-BE49-F238E27FC236}">
                  <a16:creationId xmlns:a16="http://schemas.microsoft.com/office/drawing/2014/main" id="{9CAFD279-FBD5-8B64-16B3-668F5E33FB1C}"/>
                </a:ext>
              </a:extLst>
            </p:cNvPr>
            <p:cNvSpPr/>
            <p:nvPr/>
          </p:nvSpPr>
          <p:spPr>
            <a:xfrm>
              <a:off x="7192748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758" name="tx48">
              <a:extLst>
                <a:ext uri="{FF2B5EF4-FFF2-40B4-BE49-F238E27FC236}">
                  <a16:creationId xmlns:a16="http://schemas.microsoft.com/office/drawing/2014/main" id="{564272E6-52CB-A14F-6FDC-A2010A5C0865}"/>
                </a:ext>
              </a:extLst>
            </p:cNvPr>
            <p:cNvSpPr/>
            <p:nvPr/>
          </p:nvSpPr>
          <p:spPr>
            <a:xfrm>
              <a:off x="3607639" y="3878778"/>
              <a:ext cx="2566020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 to Liver-Related Mortality (Days)</a:t>
              </a:r>
            </a:p>
          </p:txBody>
        </p:sp>
        <p:sp>
          <p:nvSpPr>
            <p:cNvPr id="759" name="tx49">
              <a:extLst>
                <a:ext uri="{FF2B5EF4-FFF2-40B4-BE49-F238E27FC236}">
                  <a16:creationId xmlns:a16="http://schemas.microsoft.com/office/drawing/2014/main" id="{340021AD-1F0D-5EA4-82ED-B5CE740EFAB8}"/>
                </a:ext>
              </a:extLst>
            </p:cNvPr>
            <p:cNvSpPr/>
            <p:nvPr/>
          </p:nvSpPr>
          <p:spPr>
            <a:xfrm rot="16200000">
              <a:off x="-1410295" y="2138411"/>
              <a:ext cx="3472681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umulative Incidence of Liver-Related Mortality (%)</a:t>
              </a:r>
            </a:p>
          </p:txBody>
        </p:sp>
        <p:sp>
          <p:nvSpPr>
            <p:cNvPr id="760" name="rc53">
              <a:extLst>
                <a:ext uri="{FF2B5EF4-FFF2-40B4-BE49-F238E27FC236}">
                  <a16:creationId xmlns:a16="http://schemas.microsoft.com/office/drawing/2014/main" id="{70A24564-BFDC-34D3-27E0-339FE056AA02}"/>
                </a:ext>
              </a:extLst>
            </p:cNvPr>
            <p:cNvSpPr/>
            <p:nvPr/>
          </p:nvSpPr>
          <p:spPr>
            <a:xfrm>
              <a:off x="4926900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 dirty="0"/>
            </a:p>
          </p:txBody>
        </p:sp>
        <p:sp>
          <p:nvSpPr>
            <p:cNvPr id="761" name="tx55">
              <a:extLst>
                <a:ext uri="{FF2B5EF4-FFF2-40B4-BE49-F238E27FC236}">
                  <a16:creationId xmlns:a16="http://schemas.microsoft.com/office/drawing/2014/main" id="{87851A18-DAF2-7DDC-E6E5-803F504EFE36}"/>
                </a:ext>
              </a:extLst>
            </p:cNvPr>
            <p:cNvSpPr/>
            <p:nvPr/>
          </p:nvSpPr>
          <p:spPr>
            <a:xfrm>
              <a:off x="4704911" y="4321929"/>
              <a:ext cx="162346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endParaRPr sz="827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endParaRPr>
            </a:p>
          </p:txBody>
        </p:sp>
        <p:sp>
          <p:nvSpPr>
            <p:cNvPr id="762" name="tx56">
              <a:extLst>
                <a:ext uri="{FF2B5EF4-FFF2-40B4-BE49-F238E27FC236}">
                  <a16:creationId xmlns:a16="http://schemas.microsoft.com/office/drawing/2014/main" id="{B95BF94C-5AA7-229F-85B1-BDD9BCFC84C3}"/>
                </a:ext>
              </a:extLst>
            </p:cNvPr>
            <p:cNvSpPr/>
            <p:nvPr/>
          </p:nvSpPr>
          <p:spPr>
            <a:xfrm>
              <a:off x="5215945" y="4321929"/>
              <a:ext cx="218839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endParaRPr sz="827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endParaRPr>
            </a:p>
          </p:txBody>
        </p:sp>
        <p:sp>
          <p:nvSpPr>
            <p:cNvPr id="763" name="rc57">
              <a:extLst>
                <a:ext uri="{FF2B5EF4-FFF2-40B4-BE49-F238E27FC236}">
                  <a16:creationId xmlns:a16="http://schemas.microsoft.com/office/drawing/2014/main" id="{B448F182-4CBA-A308-4A32-EC38B188FE8D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64" name="rc58">
              <a:extLst>
                <a:ext uri="{FF2B5EF4-FFF2-40B4-BE49-F238E27FC236}">
                  <a16:creationId xmlns:a16="http://schemas.microsoft.com/office/drawing/2014/main" id="{B47F669A-AA7B-1A47-202F-F9D3DD8D2D0B}"/>
                </a:ext>
              </a:extLst>
            </p:cNvPr>
            <p:cNvSpPr/>
            <p:nvPr/>
          </p:nvSpPr>
          <p:spPr>
            <a:xfrm>
              <a:off x="776476" y="4996549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765" name="tx59">
              <a:extLst>
                <a:ext uri="{FF2B5EF4-FFF2-40B4-BE49-F238E27FC236}">
                  <a16:creationId xmlns:a16="http://schemas.microsoft.com/office/drawing/2014/main" id="{D7CFB374-6534-6809-5A18-C8E4A39894AB}"/>
                </a:ext>
              </a:extLst>
            </p:cNvPr>
            <p:cNvSpPr/>
            <p:nvPr/>
          </p:nvSpPr>
          <p:spPr>
            <a:xfrm>
              <a:off x="1115323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766" name="tx60">
              <a:extLst>
                <a:ext uri="{FF2B5EF4-FFF2-40B4-BE49-F238E27FC236}">
                  <a16:creationId xmlns:a16="http://schemas.microsoft.com/office/drawing/2014/main" id="{E7A51ABC-7116-3027-6134-BFD79F2D7EAD}"/>
                </a:ext>
              </a:extLst>
            </p:cNvPr>
            <p:cNvSpPr/>
            <p:nvPr/>
          </p:nvSpPr>
          <p:spPr>
            <a:xfrm>
              <a:off x="1080154" y="5132574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8</a:t>
              </a:r>
            </a:p>
          </p:txBody>
        </p:sp>
        <p:sp>
          <p:nvSpPr>
            <p:cNvPr id="767" name="tx61">
              <a:extLst>
                <a:ext uri="{FF2B5EF4-FFF2-40B4-BE49-F238E27FC236}">
                  <a16:creationId xmlns:a16="http://schemas.microsoft.com/office/drawing/2014/main" id="{45FFB5AC-158D-6621-AA5B-D13C75C1D7D6}"/>
                </a:ext>
              </a:extLst>
            </p:cNvPr>
            <p:cNvSpPr/>
            <p:nvPr/>
          </p:nvSpPr>
          <p:spPr>
            <a:xfrm>
              <a:off x="3164724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320" name="tx62">
              <a:extLst>
                <a:ext uri="{FF2B5EF4-FFF2-40B4-BE49-F238E27FC236}">
                  <a16:creationId xmlns:a16="http://schemas.microsoft.com/office/drawing/2014/main" id="{9D3D54CE-ADEB-0FC9-3558-3A3E16233BDC}"/>
                </a:ext>
              </a:extLst>
            </p:cNvPr>
            <p:cNvSpPr/>
            <p:nvPr/>
          </p:nvSpPr>
          <p:spPr>
            <a:xfrm>
              <a:off x="3164724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321" name="tx63">
              <a:extLst>
                <a:ext uri="{FF2B5EF4-FFF2-40B4-BE49-F238E27FC236}">
                  <a16:creationId xmlns:a16="http://schemas.microsoft.com/office/drawing/2014/main" id="{90C90EEB-2481-B8FF-8199-AF729C3B9D54}"/>
                </a:ext>
              </a:extLst>
            </p:cNvPr>
            <p:cNvSpPr/>
            <p:nvPr/>
          </p:nvSpPr>
          <p:spPr>
            <a:xfrm>
              <a:off x="5214125" y="5437853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322" name="tx64">
              <a:extLst>
                <a:ext uri="{FF2B5EF4-FFF2-40B4-BE49-F238E27FC236}">
                  <a16:creationId xmlns:a16="http://schemas.microsoft.com/office/drawing/2014/main" id="{28491894-A3B7-35E5-7244-F89A55866FDD}"/>
                </a:ext>
              </a:extLst>
            </p:cNvPr>
            <p:cNvSpPr/>
            <p:nvPr/>
          </p:nvSpPr>
          <p:spPr>
            <a:xfrm>
              <a:off x="5214125" y="5134179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323" name="tx65">
              <a:extLst>
                <a:ext uri="{FF2B5EF4-FFF2-40B4-BE49-F238E27FC236}">
                  <a16:creationId xmlns:a16="http://schemas.microsoft.com/office/drawing/2014/main" id="{32540CF8-B3BF-FA5D-D795-6CFDBE5D2EEE}"/>
                </a:ext>
              </a:extLst>
            </p:cNvPr>
            <p:cNvSpPr/>
            <p:nvPr/>
          </p:nvSpPr>
          <p:spPr>
            <a:xfrm>
              <a:off x="7263526" y="5439829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324" name="tx66">
              <a:extLst>
                <a:ext uri="{FF2B5EF4-FFF2-40B4-BE49-F238E27FC236}">
                  <a16:creationId xmlns:a16="http://schemas.microsoft.com/office/drawing/2014/main" id="{E30FCB9E-3AAD-17E5-8483-1E2F7159B54C}"/>
                </a:ext>
              </a:extLst>
            </p:cNvPr>
            <p:cNvSpPr/>
            <p:nvPr/>
          </p:nvSpPr>
          <p:spPr>
            <a:xfrm>
              <a:off x="7263526" y="5134117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325" name="tx67">
              <a:extLst>
                <a:ext uri="{FF2B5EF4-FFF2-40B4-BE49-F238E27FC236}">
                  <a16:creationId xmlns:a16="http://schemas.microsoft.com/office/drawing/2014/main" id="{D611E0B7-CF88-1F41-4141-CE553C00E0E5}"/>
                </a:ext>
              </a:extLst>
            </p:cNvPr>
            <p:cNvSpPr/>
            <p:nvPr/>
          </p:nvSpPr>
          <p:spPr>
            <a:xfrm>
              <a:off x="325591" y="5438152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326" name="tx68">
              <a:extLst>
                <a:ext uri="{FF2B5EF4-FFF2-40B4-BE49-F238E27FC236}">
                  <a16:creationId xmlns:a16="http://schemas.microsoft.com/office/drawing/2014/main" id="{F7D2E0AE-5511-9763-C9C7-91300500A054}"/>
                </a:ext>
              </a:extLst>
            </p:cNvPr>
            <p:cNvSpPr/>
            <p:nvPr/>
          </p:nvSpPr>
          <p:spPr>
            <a:xfrm>
              <a:off x="311638" y="5132811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327" name="tx69">
              <a:extLst>
                <a:ext uri="{FF2B5EF4-FFF2-40B4-BE49-F238E27FC236}">
                  <a16:creationId xmlns:a16="http://schemas.microsoft.com/office/drawing/2014/main" id="{12379E7A-20FA-2F48-F945-6598E121CC5F}"/>
                </a:ext>
              </a:extLst>
            </p:cNvPr>
            <p:cNvSpPr/>
            <p:nvPr/>
          </p:nvSpPr>
          <p:spPr>
            <a:xfrm>
              <a:off x="776476" y="4827633"/>
              <a:ext cx="17452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328" name="rc70">
              <a:extLst>
                <a:ext uri="{FF2B5EF4-FFF2-40B4-BE49-F238E27FC236}">
                  <a16:creationId xmlns:a16="http://schemas.microsoft.com/office/drawing/2014/main" id="{774D5F19-B224-6A56-27FD-043BDBF6EF83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29" name="rc71">
              <a:extLst>
                <a:ext uri="{FF2B5EF4-FFF2-40B4-BE49-F238E27FC236}">
                  <a16:creationId xmlns:a16="http://schemas.microsoft.com/office/drawing/2014/main" id="{8739AC2A-EBEB-9A98-385C-EF57455B7034}"/>
                </a:ext>
              </a:extLst>
            </p:cNvPr>
            <p:cNvSpPr/>
            <p:nvPr/>
          </p:nvSpPr>
          <p:spPr>
            <a:xfrm>
              <a:off x="776476" y="6081865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330" name="tx72">
              <a:extLst>
                <a:ext uri="{FF2B5EF4-FFF2-40B4-BE49-F238E27FC236}">
                  <a16:creationId xmlns:a16="http://schemas.microsoft.com/office/drawing/2014/main" id="{8B1279B8-6681-FBB0-9B34-0E7C2D0B7094}"/>
                </a:ext>
              </a:extLst>
            </p:cNvPr>
            <p:cNvSpPr/>
            <p:nvPr/>
          </p:nvSpPr>
          <p:spPr>
            <a:xfrm>
              <a:off x="1115323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31" name="tx73">
              <a:extLst>
                <a:ext uri="{FF2B5EF4-FFF2-40B4-BE49-F238E27FC236}">
                  <a16:creationId xmlns:a16="http://schemas.microsoft.com/office/drawing/2014/main" id="{124D2D39-3E48-604B-A399-A4AF74D19758}"/>
                </a:ext>
              </a:extLst>
            </p:cNvPr>
            <p:cNvSpPr/>
            <p:nvPr/>
          </p:nvSpPr>
          <p:spPr>
            <a:xfrm>
              <a:off x="1080154" y="6217890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6</a:t>
              </a:r>
            </a:p>
          </p:txBody>
        </p:sp>
        <p:sp>
          <p:nvSpPr>
            <p:cNvPr id="332" name="tx74">
              <a:extLst>
                <a:ext uri="{FF2B5EF4-FFF2-40B4-BE49-F238E27FC236}">
                  <a16:creationId xmlns:a16="http://schemas.microsoft.com/office/drawing/2014/main" id="{5CC888F4-BD66-1277-2365-E344D94F966E}"/>
                </a:ext>
              </a:extLst>
            </p:cNvPr>
            <p:cNvSpPr/>
            <p:nvPr/>
          </p:nvSpPr>
          <p:spPr>
            <a:xfrm>
              <a:off x="3164724" y="6523169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333" name="tx75">
              <a:extLst>
                <a:ext uri="{FF2B5EF4-FFF2-40B4-BE49-F238E27FC236}">
                  <a16:creationId xmlns:a16="http://schemas.microsoft.com/office/drawing/2014/main" id="{E227704D-82E9-A8DD-31E6-8368E300530C}"/>
                </a:ext>
              </a:extLst>
            </p:cNvPr>
            <p:cNvSpPr/>
            <p:nvPr/>
          </p:nvSpPr>
          <p:spPr>
            <a:xfrm>
              <a:off x="3129555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1</a:t>
              </a:r>
            </a:p>
          </p:txBody>
        </p:sp>
        <p:sp>
          <p:nvSpPr>
            <p:cNvPr id="334" name="tx76">
              <a:extLst>
                <a:ext uri="{FF2B5EF4-FFF2-40B4-BE49-F238E27FC236}">
                  <a16:creationId xmlns:a16="http://schemas.microsoft.com/office/drawing/2014/main" id="{0EE3496A-FE0E-08C2-39AB-D544B8A5DE16}"/>
                </a:ext>
              </a:extLst>
            </p:cNvPr>
            <p:cNvSpPr/>
            <p:nvPr/>
          </p:nvSpPr>
          <p:spPr>
            <a:xfrm>
              <a:off x="5214125" y="6525145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335" name="tx77">
              <a:extLst>
                <a:ext uri="{FF2B5EF4-FFF2-40B4-BE49-F238E27FC236}">
                  <a16:creationId xmlns:a16="http://schemas.microsoft.com/office/drawing/2014/main" id="{C5AB5D30-0CC3-DD16-76DC-A07EF60663E9}"/>
                </a:ext>
              </a:extLst>
            </p:cNvPr>
            <p:cNvSpPr/>
            <p:nvPr/>
          </p:nvSpPr>
          <p:spPr>
            <a:xfrm>
              <a:off x="5178956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4</a:t>
              </a:r>
            </a:p>
          </p:txBody>
        </p:sp>
        <p:sp>
          <p:nvSpPr>
            <p:cNvPr id="336" name="tx78">
              <a:extLst>
                <a:ext uri="{FF2B5EF4-FFF2-40B4-BE49-F238E27FC236}">
                  <a16:creationId xmlns:a16="http://schemas.microsoft.com/office/drawing/2014/main" id="{20F7555C-D4BA-BA5F-2E2E-D5145F9D843B}"/>
                </a:ext>
              </a:extLst>
            </p:cNvPr>
            <p:cNvSpPr/>
            <p:nvPr/>
          </p:nvSpPr>
          <p:spPr>
            <a:xfrm>
              <a:off x="7263526" y="6525145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337" name="tx79">
              <a:extLst>
                <a:ext uri="{FF2B5EF4-FFF2-40B4-BE49-F238E27FC236}">
                  <a16:creationId xmlns:a16="http://schemas.microsoft.com/office/drawing/2014/main" id="{9874453E-A36D-C94B-971B-2D0137D76845}"/>
                </a:ext>
              </a:extLst>
            </p:cNvPr>
            <p:cNvSpPr/>
            <p:nvPr/>
          </p:nvSpPr>
          <p:spPr>
            <a:xfrm>
              <a:off x="7228357" y="6217890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6</a:t>
              </a:r>
            </a:p>
          </p:txBody>
        </p:sp>
        <p:sp>
          <p:nvSpPr>
            <p:cNvPr id="338" name="tx80">
              <a:extLst>
                <a:ext uri="{FF2B5EF4-FFF2-40B4-BE49-F238E27FC236}">
                  <a16:creationId xmlns:a16="http://schemas.microsoft.com/office/drawing/2014/main" id="{EFDC5A12-9434-A3EA-127D-779B2435719F}"/>
                </a:ext>
              </a:extLst>
            </p:cNvPr>
            <p:cNvSpPr/>
            <p:nvPr/>
          </p:nvSpPr>
          <p:spPr>
            <a:xfrm>
              <a:off x="325591" y="6523468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339" name="tx81">
              <a:extLst>
                <a:ext uri="{FF2B5EF4-FFF2-40B4-BE49-F238E27FC236}">
                  <a16:creationId xmlns:a16="http://schemas.microsoft.com/office/drawing/2014/main" id="{D9FEA4EE-8093-2094-C7C4-D1CA159F1CF1}"/>
                </a:ext>
              </a:extLst>
            </p:cNvPr>
            <p:cNvSpPr/>
            <p:nvPr/>
          </p:nvSpPr>
          <p:spPr>
            <a:xfrm>
              <a:off x="311638" y="6218127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340" name="tx82">
              <a:extLst>
                <a:ext uri="{FF2B5EF4-FFF2-40B4-BE49-F238E27FC236}">
                  <a16:creationId xmlns:a16="http://schemas.microsoft.com/office/drawing/2014/main" id="{A4CA75C3-FCC6-94BB-79D9-DBC21F3A1174}"/>
                </a:ext>
              </a:extLst>
            </p:cNvPr>
            <p:cNvSpPr/>
            <p:nvPr/>
          </p:nvSpPr>
          <p:spPr>
            <a:xfrm>
              <a:off x="776476" y="5912949"/>
              <a:ext cx="23525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</p:grpSp>
      <p:sp>
        <p:nvSpPr>
          <p:cNvPr id="341" name="TextBox 340">
            <a:extLst>
              <a:ext uri="{FF2B5EF4-FFF2-40B4-BE49-F238E27FC236}">
                <a16:creationId xmlns:a16="http://schemas.microsoft.com/office/drawing/2014/main" id="{15ACB8AE-8302-9677-8C2D-6FCCF9AD4977}"/>
              </a:ext>
            </a:extLst>
          </p:cNvPr>
          <p:cNvSpPr txBox="1"/>
          <p:nvPr/>
        </p:nvSpPr>
        <p:spPr>
          <a:xfrm>
            <a:off x="672800" y="5493984"/>
            <a:ext cx="3125335" cy="6519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9" b="1" dirty="0">
                <a:latin typeface="Arial" panose="020B0604020202020204" pitchFamily="34" charset="0"/>
                <a:cs typeface="Arial" panose="020B0604020202020204" pitchFamily="34" charset="0"/>
              </a:rPr>
              <a:t>Potential Living Donor Total   Event   HR (95% CI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No                                     18       4         Reference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Yes                                    96       4       0.17 (0.04 – 0.69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Gray K-Sample Test P-value: 0.005     </a:t>
            </a:r>
          </a:p>
        </p:txBody>
      </p:sp>
      <p:sp>
        <p:nvSpPr>
          <p:cNvPr id="342" name="pl48">
            <a:extLst>
              <a:ext uri="{FF2B5EF4-FFF2-40B4-BE49-F238E27FC236}">
                <a16:creationId xmlns:a16="http://schemas.microsoft.com/office/drawing/2014/main" id="{B5613A5E-DA9C-1BEB-B8C6-0D82A8C079DB}"/>
              </a:ext>
            </a:extLst>
          </p:cNvPr>
          <p:cNvSpPr/>
          <p:nvPr/>
        </p:nvSpPr>
        <p:spPr>
          <a:xfrm>
            <a:off x="541173" y="5718082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343" name="pl50">
            <a:extLst>
              <a:ext uri="{FF2B5EF4-FFF2-40B4-BE49-F238E27FC236}">
                <a16:creationId xmlns:a16="http://schemas.microsoft.com/office/drawing/2014/main" id="{685E7614-2738-29FF-E747-8F80B0CB753D}"/>
              </a:ext>
            </a:extLst>
          </p:cNvPr>
          <p:cNvSpPr/>
          <p:nvPr/>
        </p:nvSpPr>
        <p:spPr>
          <a:xfrm>
            <a:off x="541173" y="5879001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grpSp>
        <p:nvGrpSpPr>
          <p:cNvPr id="344" name="Group 343">
            <a:extLst>
              <a:ext uri="{FF2B5EF4-FFF2-40B4-BE49-F238E27FC236}">
                <a16:creationId xmlns:a16="http://schemas.microsoft.com/office/drawing/2014/main" id="{C8B111C5-BDAC-4901-1D06-5CDCA8EF1E25}"/>
              </a:ext>
            </a:extLst>
          </p:cNvPr>
          <p:cNvGrpSpPr>
            <a:grpSpLocks noChangeAspect="1"/>
          </p:cNvGrpSpPr>
          <p:nvPr/>
        </p:nvGrpSpPr>
        <p:grpSpPr>
          <a:xfrm>
            <a:off x="4918557" y="5423388"/>
            <a:ext cx="4876256" cy="3571875"/>
            <a:chOff x="0" y="0"/>
            <a:chExt cx="9144000" cy="6858000"/>
          </a:xfrm>
        </p:grpSpPr>
        <p:sp>
          <p:nvSpPr>
            <p:cNvPr id="345" name="rc3">
              <a:extLst>
                <a:ext uri="{FF2B5EF4-FFF2-40B4-BE49-F238E27FC236}">
                  <a16:creationId xmlns:a16="http://schemas.microsoft.com/office/drawing/2014/main" id="{9D1B0EAF-6495-CFD3-A27E-D26C93376369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46" name="rc4">
              <a:extLst>
                <a:ext uri="{FF2B5EF4-FFF2-40B4-BE49-F238E27FC236}">
                  <a16:creationId xmlns:a16="http://schemas.microsoft.com/office/drawing/2014/main" id="{136F84C3-2636-9B4E-9B48-5C402B5F380D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47" name="rc5">
              <a:extLst>
                <a:ext uri="{FF2B5EF4-FFF2-40B4-BE49-F238E27FC236}">
                  <a16:creationId xmlns:a16="http://schemas.microsoft.com/office/drawing/2014/main" id="{200CD82E-3C89-2DC1-7F22-62BE9825A30B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48" name="rc6">
              <a:extLst>
                <a:ext uri="{FF2B5EF4-FFF2-40B4-BE49-F238E27FC236}">
                  <a16:creationId xmlns:a16="http://schemas.microsoft.com/office/drawing/2014/main" id="{4899582D-AC93-CDE6-BDB2-6AEF25C6C721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49" name="rc7">
              <a:extLst>
                <a:ext uri="{FF2B5EF4-FFF2-40B4-BE49-F238E27FC236}">
                  <a16:creationId xmlns:a16="http://schemas.microsoft.com/office/drawing/2014/main" id="{97730E40-AB1C-9FB3-7A86-1FECCCD237D8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50" name="rc8">
              <a:extLst>
                <a:ext uri="{FF2B5EF4-FFF2-40B4-BE49-F238E27FC236}">
                  <a16:creationId xmlns:a16="http://schemas.microsoft.com/office/drawing/2014/main" id="{153124AB-529E-BD44-0389-6CD530BC577A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51" name="pl18">
              <a:extLst>
                <a:ext uri="{FF2B5EF4-FFF2-40B4-BE49-F238E27FC236}">
                  <a16:creationId xmlns:a16="http://schemas.microsoft.com/office/drawing/2014/main" id="{470B63B1-BF6B-B8B9-11EE-4C680461B446}"/>
                </a:ext>
              </a:extLst>
            </p:cNvPr>
            <p:cNvSpPr/>
            <p:nvPr/>
          </p:nvSpPr>
          <p:spPr>
            <a:xfrm>
              <a:off x="776476" y="3534137"/>
              <a:ext cx="8228345" cy="0"/>
            </a:xfrm>
            <a:custGeom>
              <a:avLst/>
              <a:gdLst/>
              <a:ahLst/>
              <a:cxnLst/>
              <a:rect l="0" t="0" r="0" b="0"/>
              <a:pathLst>
                <a:path w="8228345">
                  <a:moveTo>
                    <a:pt x="0" y="0"/>
                  </a:moveTo>
                  <a:lnTo>
                    <a:pt x="8228345" y="0"/>
                  </a:lnTo>
                  <a:lnTo>
                    <a:pt x="8228345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52" name="pl23">
              <a:extLst>
                <a:ext uri="{FF2B5EF4-FFF2-40B4-BE49-F238E27FC236}">
                  <a16:creationId xmlns:a16="http://schemas.microsoft.com/office/drawing/2014/main" id="{DA96AA08-BF62-3322-9B11-CBC571B27E2D}"/>
                </a:ext>
              </a:extLst>
            </p:cNvPr>
            <p:cNvSpPr/>
            <p:nvPr/>
          </p:nvSpPr>
          <p:spPr>
            <a:xfrm>
              <a:off x="1150492" y="139178"/>
              <a:ext cx="0" cy="3556623"/>
            </a:xfrm>
            <a:custGeom>
              <a:avLst/>
              <a:gdLst/>
              <a:ahLst/>
              <a:cxnLst/>
              <a:rect l="0" t="0" r="0" b="0"/>
              <a:pathLst>
                <a:path h="3556623">
                  <a:moveTo>
                    <a:pt x="0" y="35566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23" name="pl27">
              <a:extLst>
                <a:ext uri="{FF2B5EF4-FFF2-40B4-BE49-F238E27FC236}">
                  <a16:creationId xmlns:a16="http://schemas.microsoft.com/office/drawing/2014/main" id="{9537B1E5-D161-B785-0B35-CF084878A81E}"/>
                </a:ext>
              </a:extLst>
            </p:cNvPr>
            <p:cNvSpPr/>
            <p:nvPr/>
          </p:nvSpPr>
          <p:spPr>
            <a:xfrm>
              <a:off x="1150492" y="1513328"/>
              <a:ext cx="4354977" cy="2020809"/>
            </a:xfrm>
            <a:custGeom>
              <a:avLst/>
              <a:gdLst/>
              <a:ahLst/>
              <a:cxnLst/>
              <a:rect l="0" t="0" r="0" b="0"/>
              <a:pathLst>
                <a:path w="4354977" h="2020809">
                  <a:moveTo>
                    <a:pt x="0" y="2020809"/>
                  </a:moveTo>
                  <a:lnTo>
                    <a:pt x="51235" y="2020809"/>
                  </a:lnTo>
                  <a:lnTo>
                    <a:pt x="51235" y="1616647"/>
                  </a:lnTo>
                  <a:lnTo>
                    <a:pt x="61482" y="1616647"/>
                  </a:lnTo>
                  <a:lnTo>
                    <a:pt x="61482" y="1616647"/>
                  </a:lnTo>
                  <a:lnTo>
                    <a:pt x="184446" y="1616647"/>
                  </a:lnTo>
                  <a:lnTo>
                    <a:pt x="184446" y="1616647"/>
                  </a:lnTo>
                  <a:lnTo>
                    <a:pt x="2100636" y="1616647"/>
                  </a:lnTo>
                  <a:lnTo>
                    <a:pt x="2100636" y="1212485"/>
                  </a:lnTo>
                  <a:lnTo>
                    <a:pt x="3340523" y="1212485"/>
                  </a:lnTo>
                  <a:lnTo>
                    <a:pt x="3340523" y="808323"/>
                  </a:lnTo>
                  <a:lnTo>
                    <a:pt x="3863120" y="808323"/>
                  </a:lnTo>
                  <a:lnTo>
                    <a:pt x="3863120" y="808323"/>
                  </a:lnTo>
                  <a:lnTo>
                    <a:pt x="4027073" y="808323"/>
                  </a:lnTo>
                  <a:lnTo>
                    <a:pt x="4027073" y="808323"/>
                  </a:lnTo>
                  <a:lnTo>
                    <a:pt x="4354977" y="808323"/>
                  </a:lnTo>
                  <a:lnTo>
                    <a:pt x="4354977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68" name="pl28">
              <a:extLst>
                <a:ext uri="{FF2B5EF4-FFF2-40B4-BE49-F238E27FC236}">
                  <a16:creationId xmlns:a16="http://schemas.microsoft.com/office/drawing/2014/main" id="{90FD12C9-C356-79E8-A55B-D291695A20BB}"/>
                </a:ext>
              </a:extLst>
            </p:cNvPr>
            <p:cNvSpPr/>
            <p:nvPr/>
          </p:nvSpPr>
          <p:spPr>
            <a:xfrm>
              <a:off x="1150492" y="3093233"/>
              <a:ext cx="7008951" cy="440903"/>
            </a:xfrm>
            <a:custGeom>
              <a:avLst/>
              <a:gdLst/>
              <a:ahLst/>
              <a:cxnLst/>
              <a:rect l="0" t="0" r="0" b="0"/>
              <a:pathLst>
                <a:path w="7008951" h="440903">
                  <a:moveTo>
                    <a:pt x="0" y="440903"/>
                  </a:moveTo>
                  <a:lnTo>
                    <a:pt x="61482" y="440903"/>
                  </a:lnTo>
                  <a:lnTo>
                    <a:pt x="61482" y="440903"/>
                  </a:lnTo>
                  <a:lnTo>
                    <a:pt x="71729" y="440903"/>
                  </a:lnTo>
                  <a:lnTo>
                    <a:pt x="71729" y="440903"/>
                  </a:lnTo>
                  <a:lnTo>
                    <a:pt x="112717" y="440903"/>
                  </a:lnTo>
                  <a:lnTo>
                    <a:pt x="112717" y="440903"/>
                  </a:lnTo>
                  <a:lnTo>
                    <a:pt x="266422" y="440903"/>
                  </a:lnTo>
                  <a:lnTo>
                    <a:pt x="266422" y="293935"/>
                  </a:lnTo>
                  <a:lnTo>
                    <a:pt x="286916" y="293935"/>
                  </a:lnTo>
                  <a:lnTo>
                    <a:pt x="286916" y="293935"/>
                  </a:lnTo>
                  <a:lnTo>
                    <a:pt x="430374" y="293935"/>
                  </a:lnTo>
                  <a:lnTo>
                    <a:pt x="430374" y="293935"/>
                  </a:lnTo>
                  <a:lnTo>
                    <a:pt x="522597" y="293935"/>
                  </a:lnTo>
                  <a:lnTo>
                    <a:pt x="522597" y="293935"/>
                  </a:lnTo>
                  <a:lnTo>
                    <a:pt x="840254" y="293935"/>
                  </a:lnTo>
                  <a:lnTo>
                    <a:pt x="840254" y="293935"/>
                  </a:lnTo>
                  <a:lnTo>
                    <a:pt x="942724" y="293935"/>
                  </a:lnTo>
                  <a:lnTo>
                    <a:pt x="942724" y="293935"/>
                  </a:lnTo>
                  <a:lnTo>
                    <a:pt x="1014453" y="293935"/>
                  </a:lnTo>
                  <a:lnTo>
                    <a:pt x="1014453" y="293935"/>
                  </a:lnTo>
                  <a:lnTo>
                    <a:pt x="1198899" y="293935"/>
                  </a:lnTo>
                  <a:lnTo>
                    <a:pt x="1198899" y="293935"/>
                  </a:lnTo>
                  <a:lnTo>
                    <a:pt x="1485815" y="293935"/>
                  </a:lnTo>
                  <a:lnTo>
                    <a:pt x="1485815" y="293935"/>
                  </a:lnTo>
                  <a:lnTo>
                    <a:pt x="1649767" y="293935"/>
                  </a:lnTo>
                  <a:lnTo>
                    <a:pt x="1649767" y="146967"/>
                  </a:lnTo>
                  <a:lnTo>
                    <a:pt x="1731743" y="146967"/>
                  </a:lnTo>
                  <a:lnTo>
                    <a:pt x="1731743" y="146967"/>
                  </a:lnTo>
                  <a:lnTo>
                    <a:pt x="1741990" y="146967"/>
                  </a:lnTo>
                  <a:lnTo>
                    <a:pt x="1741990" y="146967"/>
                  </a:lnTo>
                  <a:lnTo>
                    <a:pt x="2121130" y="146967"/>
                  </a:lnTo>
                  <a:lnTo>
                    <a:pt x="2121130" y="146967"/>
                  </a:lnTo>
                  <a:lnTo>
                    <a:pt x="2285082" y="146967"/>
                  </a:lnTo>
                  <a:lnTo>
                    <a:pt x="2285082" y="146967"/>
                  </a:lnTo>
                  <a:lnTo>
                    <a:pt x="2787185" y="146967"/>
                  </a:lnTo>
                  <a:lnTo>
                    <a:pt x="2787185" y="0"/>
                  </a:lnTo>
                  <a:lnTo>
                    <a:pt x="3217559" y="0"/>
                  </a:lnTo>
                  <a:lnTo>
                    <a:pt x="3217559" y="0"/>
                  </a:lnTo>
                  <a:lnTo>
                    <a:pt x="3279041" y="0"/>
                  </a:lnTo>
                  <a:lnTo>
                    <a:pt x="3279041" y="0"/>
                  </a:lnTo>
                  <a:lnTo>
                    <a:pt x="7008951" y="0"/>
                  </a:lnTo>
                  <a:lnTo>
                    <a:pt x="7008951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69" name="rc29">
              <a:extLst>
                <a:ext uri="{FF2B5EF4-FFF2-40B4-BE49-F238E27FC236}">
                  <a16:creationId xmlns:a16="http://schemas.microsoft.com/office/drawing/2014/main" id="{C2C3CE0C-6B5A-FAD6-D89B-79032C910FD4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70" name="tx30">
              <a:extLst>
                <a:ext uri="{FF2B5EF4-FFF2-40B4-BE49-F238E27FC236}">
                  <a16:creationId xmlns:a16="http://schemas.microsoft.com/office/drawing/2014/main" id="{6C6D0047-5434-90F9-067A-B1C6074B229C}"/>
                </a:ext>
              </a:extLst>
            </p:cNvPr>
            <p:cNvSpPr/>
            <p:nvPr/>
          </p:nvSpPr>
          <p:spPr>
            <a:xfrm>
              <a:off x="466667" y="3486760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771" name="tx31">
              <a:extLst>
                <a:ext uri="{FF2B5EF4-FFF2-40B4-BE49-F238E27FC236}">
                  <a16:creationId xmlns:a16="http://schemas.microsoft.com/office/drawing/2014/main" id="{231B87A5-C351-7004-8B0C-7F07F00AE1C6}"/>
                </a:ext>
              </a:extLst>
            </p:cNvPr>
            <p:cNvSpPr/>
            <p:nvPr/>
          </p:nvSpPr>
          <p:spPr>
            <a:xfrm>
              <a:off x="466667" y="2678436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772" name="tx32">
              <a:extLst>
                <a:ext uri="{FF2B5EF4-FFF2-40B4-BE49-F238E27FC236}">
                  <a16:creationId xmlns:a16="http://schemas.microsoft.com/office/drawing/2014/main" id="{AF9DF0E7-7704-A356-64F5-797E0399041A}"/>
                </a:ext>
              </a:extLst>
            </p:cNvPr>
            <p:cNvSpPr/>
            <p:nvPr/>
          </p:nvSpPr>
          <p:spPr>
            <a:xfrm>
              <a:off x="466667" y="1870113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773" name="tx33">
              <a:extLst>
                <a:ext uri="{FF2B5EF4-FFF2-40B4-BE49-F238E27FC236}">
                  <a16:creationId xmlns:a16="http://schemas.microsoft.com/office/drawing/2014/main" id="{CD2744C2-E91E-13E2-B470-C56A1B6F31D2}"/>
                </a:ext>
              </a:extLst>
            </p:cNvPr>
            <p:cNvSpPr/>
            <p:nvPr/>
          </p:nvSpPr>
          <p:spPr>
            <a:xfrm>
              <a:off x="466667" y="1061789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774" name="tx34">
              <a:extLst>
                <a:ext uri="{FF2B5EF4-FFF2-40B4-BE49-F238E27FC236}">
                  <a16:creationId xmlns:a16="http://schemas.microsoft.com/office/drawing/2014/main" id="{A244304B-89D0-B260-F00D-D33825E91C56}"/>
                </a:ext>
              </a:extLst>
            </p:cNvPr>
            <p:cNvSpPr/>
            <p:nvPr/>
          </p:nvSpPr>
          <p:spPr>
            <a:xfrm>
              <a:off x="466667" y="253465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0</a:t>
              </a:r>
            </a:p>
          </p:txBody>
        </p:sp>
        <p:sp>
          <p:nvSpPr>
            <p:cNvPr id="775" name="pl35">
              <a:extLst>
                <a:ext uri="{FF2B5EF4-FFF2-40B4-BE49-F238E27FC236}">
                  <a16:creationId xmlns:a16="http://schemas.microsoft.com/office/drawing/2014/main" id="{AABB6F0D-5A4C-C417-C86E-1AD9DF160386}"/>
                </a:ext>
              </a:extLst>
            </p:cNvPr>
            <p:cNvSpPr/>
            <p:nvPr/>
          </p:nvSpPr>
          <p:spPr>
            <a:xfrm>
              <a:off x="741682" y="353413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76" name="pl36">
              <a:extLst>
                <a:ext uri="{FF2B5EF4-FFF2-40B4-BE49-F238E27FC236}">
                  <a16:creationId xmlns:a16="http://schemas.microsoft.com/office/drawing/2014/main" id="{6B358813-5EEB-7113-EC81-A1BB917F0C78}"/>
                </a:ext>
              </a:extLst>
            </p:cNvPr>
            <p:cNvSpPr/>
            <p:nvPr/>
          </p:nvSpPr>
          <p:spPr>
            <a:xfrm>
              <a:off x="741682" y="2725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77" name="pl37">
              <a:extLst>
                <a:ext uri="{FF2B5EF4-FFF2-40B4-BE49-F238E27FC236}">
                  <a16:creationId xmlns:a16="http://schemas.microsoft.com/office/drawing/2014/main" id="{A14D989B-BEB9-787A-513E-9E061BFFB320}"/>
                </a:ext>
              </a:extLst>
            </p:cNvPr>
            <p:cNvSpPr/>
            <p:nvPr/>
          </p:nvSpPr>
          <p:spPr>
            <a:xfrm>
              <a:off x="741682" y="19174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78" name="pl38">
              <a:extLst>
                <a:ext uri="{FF2B5EF4-FFF2-40B4-BE49-F238E27FC236}">
                  <a16:creationId xmlns:a16="http://schemas.microsoft.com/office/drawing/2014/main" id="{D0F81F1A-5588-3699-6ABD-EDE7B8BF6C42}"/>
                </a:ext>
              </a:extLst>
            </p:cNvPr>
            <p:cNvSpPr/>
            <p:nvPr/>
          </p:nvSpPr>
          <p:spPr>
            <a:xfrm>
              <a:off x="741682" y="11091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79" name="pl39">
              <a:extLst>
                <a:ext uri="{FF2B5EF4-FFF2-40B4-BE49-F238E27FC236}">
                  <a16:creationId xmlns:a16="http://schemas.microsoft.com/office/drawing/2014/main" id="{F1444C13-18A2-4F83-5B1E-F22F4C11B951}"/>
                </a:ext>
              </a:extLst>
            </p:cNvPr>
            <p:cNvSpPr/>
            <p:nvPr/>
          </p:nvSpPr>
          <p:spPr>
            <a:xfrm>
              <a:off x="741682" y="3008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80" name="pl40">
              <a:extLst>
                <a:ext uri="{FF2B5EF4-FFF2-40B4-BE49-F238E27FC236}">
                  <a16:creationId xmlns:a16="http://schemas.microsoft.com/office/drawing/2014/main" id="{5E076CF7-E23B-4636-1432-15DEB67D4286}"/>
                </a:ext>
              </a:extLst>
            </p:cNvPr>
            <p:cNvSpPr/>
            <p:nvPr/>
          </p:nvSpPr>
          <p:spPr>
            <a:xfrm>
              <a:off x="1150492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81" name="pl41">
              <a:extLst>
                <a:ext uri="{FF2B5EF4-FFF2-40B4-BE49-F238E27FC236}">
                  <a16:creationId xmlns:a16="http://schemas.microsoft.com/office/drawing/2014/main" id="{BF9B18D2-04E3-1ECB-0378-8AA978B5314A}"/>
                </a:ext>
              </a:extLst>
            </p:cNvPr>
            <p:cNvSpPr/>
            <p:nvPr/>
          </p:nvSpPr>
          <p:spPr>
            <a:xfrm>
              <a:off x="3199893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82" name="pl42">
              <a:extLst>
                <a:ext uri="{FF2B5EF4-FFF2-40B4-BE49-F238E27FC236}">
                  <a16:creationId xmlns:a16="http://schemas.microsoft.com/office/drawing/2014/main" id="{07E34828-F0A1-3E4D-A91A-2E90788C942B}"/>
                </a:ext>
              </a:extLst>
            </p:cNvPr>
            <p:cNvSpPr/>
            <p:nvPr/>
          </p:nvSpPr>
          <p:spPr>
            <a:xfrm>
              <a:off x="5249294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83" name="pl43">
              <a:extLst>
                <a:ext uri="{FF2B5EF4-FFF2-40B4-BE49-F238E27FC236}">
                  <a16:creationId xmlns:a16="http://schemas.microsoft.com/office/drawing/2014/main" id="{0D042528-852E-24A9-8A8B-A51C1E85F62D}"/>
                </a:ext>
              </a:extLst>
            </p:cNvPr>
            <p:cNvSpPr/>
            <p:nvPr/>
          </p:nvSpPr>
          <p:spPr>
            <a:xfrm>
              <a:off x="7298695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84" name="tx44">
              <a:extLst>
                <a:ext uri="{FF2B5EF4-FFF2-40B4-BE49-F238E27FC236}">
                  <a16:creationId xmlns:a16="http://schemas.microsoft.com/office/drawing/2014/main" id="{A683E725-E38C-B3F4-7F04-B31D78F6DF3C}"/>
                </a:ext>
              </a:extLst>
            </p:cNvPr>
            <p:cNvSpPr/>
            <p:nvPr/>
          </p:nvSpPr>
          <p:spPr>
            <a:xfrm>
              <a:off x="1115176" y="3756509"/>
              <a:ext cx="70631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785" name="tx45">
              <a:extLst>
                <a:ext uri="{FF2B5EF4-FFF2-40B4-BE49-F238E27FC236}">
                  <a16:creationId xmlns:a16="http://schemas.microsoft.com/office/drawing/2014/main" id="{9A3A7E38-C684-AB6D-4FA0-2255F3ABC20A}"/>
                </a:ext>
              </a:extLst>
            </p:cNvPr>
            <p:cNvSpPr/>
            <p:nvPr/>
          </p:nvSpPr>
          <p:spPr>
            <a:xfrm>
              <a:off x="3093946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786" name="tx46">
              <a:extLst>
                <a:ext uri="{FF2B5EF4-FFF2-40B4-BE49-F238E27FC236}">
                  <a16:creationId xmlns:a16="http://schemas.microsoft.com/office/drawing/2014/main" id="{80F48D8C-6C18-4496-B016-4F06FFB14C85}"/>
                </a:ext>
              </a:extLst>
            </p:cNvPr>
            <p:cNvSpPr/>
            <p:nvPr/>
          </p:nvSpPr>
          <p:spPr>
            <a:xfrm>
              <a:off x="5143347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787" name="tx47">
              <a:extLst>
                <a:ext uri="{FF2B5EF4-FFF2-40B4-BE49-F238E27FC236}">
                  <a16:creationId xmlns:a16="http://schemas.microsoft.com/office/drawing/2014/main" id="{0BBFEFB2-B7C4-58C7-53A6-C62770218DF8}"/>
                </a:ext>
              </a:extLst>
            </p:cNvPr>
            <p:cNvSpPr/>
            <p:nvPr/>
          </p:nvSpPr>
          <p:spPr>
            <a:xfrm>
              <a:off x="7192748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788" name="tx48">
              <a:extLst>
                <a:ext uri="{FF2B5EF4-FFF2-40B4-BE49-F238E27FC236}">
                  <a16:creationId xmlns:a16="http://schemas.microsoft.com/office/drawing/2014/main" id="{4E021EC7-28FA-6121-662C-A229C9A1AF6A}"/>
                </a:ext>
              </a:extLst>
            </p:cNvPr>
            <p:cNvSpPr/>
            <p:nvPr/>
          </p:nvSpPr>
          <p:spPr>
            <a:xfrm>
              <a:off x="3607639" y="3878778"/>
              <a:ext cx="2566020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 to Liver-Related Mortality (Days)</a:t>
              </a:r>
            </a:p>
          </p:txBody>
        </p:sp>
        <p:sp>
          <p:nvSpPr>
            <p:cNvPr id="789" name="tx49">
              <a:extLst>
                <a:ext uri="{FF2B5EF4-FFF2-40B4-BE49-F238E27FC236}">
                  <a16:creationId xmlns:a16="http://schemas.microsoft.com/office/drawing/2014/main" id="{FA6D12DA-C171-745C-3EAA-3A0452FAF248}"/>
                </a:ext>
              </a:extLst>
            </p:cNvPr>
            <p:cNvSpPr/>
            <p:nvPr/>
          </p:nvSpPr>
          <p:spPr>
            <a:xfrm rot="16200000">
              <a:off x="-1400969" y="2094288"/>
              <a:ext cx="3472681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umulative Incidence of Liver-Related Mortality (%)</a:t>
              </a:r>
            </a:p>
          </p:txBody>
        </p:sp>
        <p:sp>
          <p:nvSpPr>
            <p:cNvPr id="790" name="tx55">
              <a:extLst>
                <a:ext uri="{FF2B5EF4-FFF2-40B4-BE49-F238E27FC236}">
                  <a16:creationId xmlns:a16="http://schemas.microsoft.com/office/drawing/2014/main" id="{31009817-243F-D5C8-A0EC-774EEE22ABD1}"/>
                </a:ext>
              </a:extLst>
            </p:cNvPr>
            <p:cNvSpPr/>
            <p:nvPr/>
          </p:nvSpPr>
          <p:spPr>
            <a:xfrm>
              <a:off x="4704911" y="4321929"/>
              <a:ext cx="162346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endParaRPr sz="827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endParaRPr>
            </a:p>
          </p:txBody>
        </p:sp>
        <p:sp>
          <p:nvSpPr>
            <p:cNvPr id="791" name="rc57">
              <a:extLst>
                <a:ext uri="{FF2B5EF4-FFF2-40B4-BE49-F238E27FC236}">
                  <a16:creationId xmlns:a16="http://schemas.microsoft.com/office/drawing/2014/main" id="{6C2874B0-5708-2769-E06D-C8BC955110E2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92" name="rc58">
              <a:extLst>
                <a:ext uri="{FF2B5EF4-FFF2-40B4-BE49-F238E27FC236}">
                  <a16:creationId xmlns:a16="http://schemas.microsoft.com/office/drawing/2014/main" id="{D849B2B1-2FE1-EAF1-DBB5-00BC501CC2B4}"/>
                </a:ext>
              </a:extLst>
            </p:cNvPr>
            <p:cNvSpPr/>
            <p:nvPr/>
          </p:nvSpPr>
          <p:spPr>
            <a:xfrm>
              <a:off x="776476" y="4996549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793" name="tx59">
              <a:extLst>
                <a:ext uri="{FF2B5EF4-FFF2-40B4-BE49-F238E27FC236}">
                  <a16:creationId xmlns:a16="http://schemas.microsoft.com/office/drawing/2014/main" id="{3CD361DE-E87E-54D6-9918-E575D995AD07}"/>
                </a:ext>
              </a:extLst>
            </p:cNvPr>
            <p:cNvSpPr/>
            <p:nvPr/>
          </p:nvSpPr>
          <p:spPr>
            <a:xfrm>
              <a:off x="1115323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794" name="tx60">
              <a:extLst>
                <a:ext uri="{FF2B5EF4-FFF2-40B4-BE49-F238E27FC236}">
                  <a16:creationId xmlns:a16="http://schemas.microsoft.com/office/drawing/2014/main" id="{0AA37DA3-BF70-655D-2C5E-105443C7E09B}"/>
                </a:ext>
              </a:extLst>
            </p:cNvPr>
            <p:cNvSpPr/>
            <p:nvPr/>
          </p:nvSpPr>
          <p:spPr>
            <a:xfrm>
              <a:off x="1115323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795" name="tx61">
              <a:extLst>
                <a:ext uri="{FF2B5EF4-FFF2-40B4-BE49-F238E27FC236}">
                  <a16:creationId xmlns:a16="http://schemas.microsoft.com/office/drawing/2014/main" id="{2267BF9F-F32C-B9D6-DAC8-8D245B2EEA53}"/>
                </a:ext>
              </a:extLst>
            </p:cNvPr>
            <p:cNvSpPr/>
            <p:nvPr/>
          </p:nvSpPr>
          <p:spPr>
            <a:xfrm>
              <a:off x="3164724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796" name="tx62">
              <a:extLst>
                <a:ext uri="{FF2B5EF4-FFF2-40B4-BE49-F238E27FC236}">
                  <a16:creationId xmlns:a16="http://schemas.microsoft.com/office/drawing/2014/main" id="{6B5ACBAA-E540-1943-87B8-4C07D344892F}"/>
                </a:ext>
              </a:extLst>
            </p:cNvPr>
            <p:cNvSpPr/>
            <p:nvPr/>
          </p:nvSpPr>
          <p:spPr>
            <a:xfrm>
              <a:off x="3164724" y="5134179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797" name="tx63">
              <a:extLst>
                <a:ext uri="{FF2B5EF4-FFF2-40B4-BE49-F238E27FC236}">
                  <a16:creationId xmlns:a16="http://schemas.microsoft.com/office/drawing/2014/main" id="{F581926E-71FB-47D4-6D23-5DE4B4ABDBA2}"/>
                </a:ext>
              </a:extLst>
            </p:cNvPr>
            <p:cNvSpPr/>
            <p:nvPr/>
          </p:nvSpPr>
          <p:spPr>
            <a:xfrm>
              <a:off x="5214125" y="5437853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798" name="tx64">
              <a:extLst>
                <a:ext uri="{FF2B5EF4-FFF2-40B4-BE49-F238E27FC236}">
                  <a16:creationId xmlns:a16="http://schemas.microsoft.com/office/drawing/2014/main" id="{3983F4CE-25F3-8F94-D1DD-89426436B495}"/>
                </a:ext>
              </a:extLst>
            </p:cNvPr>
            <p:cNvSpPr/>
            <p:nvPr/>
          </p:nvSpPr>
          <p:spPr>
            <a:xfrm>
              <a:off x="5214125" y="5134117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799" name="tx65">
              <a:extLst>
                <a:ext uri="{FF2B5EF4-FFF2-40B4-BE49-F238E27FC236}">
                  <a16:creationId xmlns:a16="http://schemas.microsoft.com/office/drawing/2014/main" id="{336A5DEB-79AB-14BC-AE55-54BA6E771903}"/>
                </a:ext>
              </a:extLst>
            </p:cNvPr>
            <p:cNvSpPr/>
            <p:nvPr/>
          </p:nvSpPr>
          <p:spPr>
            <a:xfrm>
              <a:off x="7263526" y="5439829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800" name="tx66">
              <a:extLst>
                <a:ext uri="{FF2B5EF4-FFF2-40B4-BE49-F238E27FC236}">
                  <a16:creationId xmlns:a16="http://schemas.microsoft.com/office/drawing/2014/main" id="{72C28C87-8E22-A166-351D-8411DFFCECD5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801" name="tx67">
              <a:extLst>
                <a:ext uri="{FF2B5EF4-FFF2-40B4-BE49-F238E27FC236}">
                  <a16:creationId xmlns:a16="http://schemas.microsoft.com/office/drawing/2014/main" id="{2212FE44-F42E-ABDE-4F78-9199BA9774F6}"/>
                </a:ext>
              </a:extLst>
            </p:cNvPr>
            <p:cNvSpPr/>
            <p:nvPr/>
          </p:nvSpPr>
          <p:spPr>
            <a:xfrm>
              <a:off x="7263526" y="5439829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802" name="tx68">
              <a:extLst>
                <a:ext uri="{FF2B5EF4-FFF2-40B4-BE49-F238E27FC236}">
                  <a16:creationId xmlns:a16="http://schemas.microsoft.com/office/drawing/2014/main" id="{60468872-2C93-AF00-0858-D426137CD753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803" name="tx69">
              <a:extLst>
                <a:ext uri="{FF2B5EF4-FFF2-40B4-BE49-F238E27FC236}">
                  <a16:creationId xmlns:a16="http://schemas.microsoft.com/office/drawing/2014/main" id="{DBB4FED1-9510-C7C4-4C58-1FE0635DECDB}"/>
                </a:ext>
              </a:extLst>
            </p:cNvPr>
            <p:cNvSpPr/>
            <p:nvPr/>
          </p:nvSpPr>
          <p:spPr>
            <a:xfrm>
              <a:off x="325591" y="5438152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804" name="tx70">
              <a:extLst>
                <a:ext uri="{FF2B5EF4-FFF2-40B4-BE49-F238E27FC236}">
                  <a16:creationId xmlns:a16="http://schemas.microsoft.com/office/drawing/2014/main" id="{5FA08E1B-686A-5C68-4DB1-86D347A93181}"/>
                </a:ext>
              </a:extLst>
            </p:cNvPr>
            <p:cNvSpPr/>
            <p:nvPr/>
          </p:nvSpPr>
          <p:spPr>
            <a:xfrm>
              <a:off x="311638" y="5132811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805" name="tx71">
              <a:extLst>
                <a:ext uri="{FF2B5EF4-FFF2-40B4-BE49-F238E27FC236}">
                  <a16:creationId xmlns:a16="http://schemas.microsoft.com/office/drawing/2014/main" id="{1993FF32-C13F-F153-E8CD-BCF053B96D07}"/>
                </a:ext>
              </a:extLst>
            </p:cNvPr>
            <p:cNvSpPr/>
            <p:nvPr/>
          </p:nvSpPr>
          <p:spPr>
            <a:xfrm>
              <a:off x="776476" y="4827633"/>
              <a:ext cx="17452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806" name="rc72">
              <a:extLst>
                <a:ext uri="{FF2B5EF4-FFF2-40B4-BE49-F238E27FC236}">
                  <a16:creationId xmlns:a16="http://schemas.microsoft.com/office/drawing/2014/main" id="{62913516-9E4C-0254-92B8-B5890B017632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07" name="rc73">
              <a:extLst>
                <a:ext uri="{FF2B5EF4-FFF2-40B4-BE49-F238E27FC236}">
                  <a16:creationId xmlns:a16="http://schemas.microsoft.com/office/drawing/2014/main" id="{02C3F873-191D-4CE5-5B22-9DAACFFE5CDF}"/>
                </a:ext>
              </a:extLst>
            </p:cNvPr>
            <p:cNvSpPr/>
            <p:nvPr/>
          </p:nvSpPr>
          <p:spPr>
            <a:xfrm>
              <a:off x="776476" y="6081865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808" name="tx74">
              <a:extLst>
                <a:ext uri="{FF2B5EF4-FFF2-40B4-BE49-F238E27FC236}">
                  <a16:creationId xmlns:a16="http://schemas.microsoft.com/office/drawing/2014/main" id="{55ECED2E-87BA-CEB3-6776-837560806531}"/>
                </a:ext>
              </a:extLst>
            </p:cNvPr>
            <p:cNvSpPr/>
            <p:nvPr/>
          </p:nvSpPr>
          <p:spPr>
            <a:xfrm>
              <a:off x="1115323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809" name="tx75">
              <a:extLst>
                <a:ext uri="{FF2B5EF4-FFF2-40B4-BE49-F238E27FC236}">
                  <a16:creationId xmlns:a16="http://schemas.microsoft.com/office/drawing/2014/main" id="{2389F506-9C00-1584-75E4-E77306EEDEE2}"/>
                </a:ext>
              </a:extLst>
            </p:cNvPr>
            <p:cNvSpPr/>
            <p:nvPr/>
          </p:nvSpPr>
          <p:spPr>
            <a:xfrm>
              <a:off x="1080154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2</a:t>
              </a:r>
            </a:p>
          </p:txBody>
        </p:sp>
        <p:sp>
          <p:nvSpPr>
            <p:cNvPr id="810" name="tx76">
              <a:extLst>
                <a:ext uri="{FF2B5EF4-FFF2-40B4-BE49-F238E27FC236}">
                  <a16:creationId xmlns:a16="http://schemas.microsoft.com/office/drawing/2014/main" id="{6C25FC1F-3775-A550-1B9A-EAEBCC6B697C}"/>
                </a:ext>
              </a:extLst>
            </p:cNvPr>
            <p:cNvSpPr/>
            <p:nvPr/>
          </p:nvSpPr>
          <p:spPr>
            <a:xfrm>
              <a:off x="3164724" y="6524775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811" name="tx77">
              <a:extLst>
                <a:ext uri="{FF2B5EF4-FFF2-40B4-BE49-F238E27FC236}">
                  <a16:creationId xmlns:a16="http://schemas.microsoft.com/office/drawing/2014/main" id="{FAC6BC3B-4840-8899-87C4-659AF0E5E5C7}"/>
                </a:ext>
              </a:extLst>
            </p:cNvPr>
            <p:cNvSpPr/>
            <p:nvPr/>
          </p:nvSpPr>
          <p:spPr>
            <a:xfrm>
              <a:off x="3164724" y="6220978"/>
              <a:ext cx="70337" cy="8935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</a:t>
              </a:r>
            </a:p>
          </p:txBody>
        </p:sp>
        <p:sp>
          <p:nvSpPr>
            <p:cNvPr id="812" name="tx78">
              <a:extLst>
                <a:ext uri="{FF2B5EF4-FFF2-40B4-BE49-F238E27FC236}">
                  <a16:creationId xmlns:a16="http://schemas.microsoft.com/office/drawing/2014/main" id="{7ED7C721-0DDE-2DC5-B890-7DB1CF2A6291}"/>
                </a:ext>
              </a:extLst>
            </p:cNvPr>
            <p:cNvSpPr/>
            <p:nvPr/>
          </p:nvSpPr>
          <p:spPr>
            <a:xfrm>
              <a:off x="5214125" y="6523169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813" name="tx79">
              <a:extLst>
                <a:ext uri="{FF2B5EF4-FFF2-40B4-BE49-F238E27FC236}">
                  <a16:creationId xmlns:a16="http://schemas.microsoft.com/office/drawing/2014/main" id="{8065C2D4-0C88-1708-A7E4-8AF28E5957AA}"/>
                </a:ext>
              </a:extLst>
            </p:cNvPr>
            <p:cNvSpPr/>
            <p:nvPr/>
          </p:nvSpPr>
          <p:spPr>
            <a:xfrm>
              <a:off x="5214125" y="6219434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814" name="tx80">
              <a:extLst>
                <a:ext uri="{FF2B5EF4-FFF2-40B4-BE49-F238E27FC236}">
                  <a16:creationId xmlns:a16="http://schemas.microsoft.com/office/drawing/2014/main" id="{9E88B9B1-041F-FFBC-A995-B2FB6CBD43CE}"/>
                </a:ext>
              </a:extLst>
            </p:cNvPr>
            <p:cNvSpPr/>
            <p:nvPr/>
          </p:nvSpPr>
          <p:spPr>
            <a:xfrm>
              <a:off x="7263526" y="6523169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815" name="tx81">
              <a:extLst>
                <a:ext uri="{FF2B5EF4-FFF2-40B4-BE49-F238E27FC236}">
                  <a16:creationId xmlns:a16="http://schemas.microsoft.com/office/drawing/2014/main" id="{ECF5FBBE-CDC0-0BDD-2B0C-D6862B15E75C}"/>
                </a:ext>
              </a:extLst>
            </p:cNvPr>
            <p:cNvSpPr/>
            <p:nvPr/>
          </p:nvSpPr>
          <p:spPr>
            <a:xfrm>
              <a:off x="7263526" y="6219434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816" name="tx82">
              <a:extLst>
                <a:ext uri="{FF2B5EF4-FFF2-40B4-BE49-F238E27FC236}">
                  <a16:creationId xmlns:a16="http://schemas.microsoft.com/office/drawing/2014/main" id="{9564A472-3A8A-0EBC-5682-152C991023AA}"/>
                </a:ext>
              </a:extLst>
            </p:cNvPr>
            <p:cNvSpPr/>
            <p:nvPr/>
          </p:nvSpPr>
          <p:spPr>
            <a:xfrm>
              <a:off x="325591" y="6523468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817" name="tx83">
              <a:extLst>
                <a:ext uri="{FF2B5EF4-FFF2-40B4-BE49-F238E27FC236}">
                  <a16:creationId xmlns:a16="http://schemas.microsoft.com/office/drawing/2014/main" id="{6122504E-E02A-119F-607C-5D52C2896335}"/>
                </a:ext>
              </a:extLst>
            </p:cNvPr>
            <p:cNvSpPr/>
            <p:nvPr/>
          </p:nvSpPr>
          <p:spPr>
            <a:xfrm>
              <a:off x="311638" y="6218127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818" name="tx84">
              <a:extLst>
                <a:ext uri="{FF2B5EF4-FFF2-40B4-BE49-F238E27FC236}">
                  <a16:creationId xmlns:a16="http://schemas.microsoft.com/office/drawing/2014/main" id="{16FFCA2E-76F7-6AED-6F82-A9DBD9C13E0E}"/>
                </a:ext>
              </a:extLst>
            </p:cNvPr>
            <p:cNvSpPr/>
            <p:nvPr/>
          </p:nvSpPr>
          <p:spPr>
            <a:xfrm>
              <a:off x="776476" y="5912949"/>
              <a:ext cx="23525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</p:grpSp>
      <p:sp>
        <p:nvSpPr>
          <p:cNvPr id="819" name="TextBox 818">
            <a:extLst>
              <a:ext uri="{FF2B5EF4-FFF2-40B4-BE49-F238E27FC236}">
                <a16:creationId xmlns:a16="http://schemas.microsoft.com/office/drawing/2014/main" id="{2439E0D6-DF60-70EF-8AAA-85E6A4BAC3B6}"/>
              </a:ext>
            </a:extLst>
          </p:cNvPr>
          <p:cNvSpPr txBox="1"/>
          <p:nvPr/>
        </p:nvSpPr>
        <p:spPr>
          <a:xfrm>
            <a:off x="5596338" y="5568416"/>
            <a:ext cx="3125335" cy="6519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9" b="1" dirty="0">
                <a:latin typeface="Arial" panose="020B0604020202020204" pitchFamily="34" charset="0"/>
                <a:cs typeface="Arial" panose="020B0604020202020204" pitchFamily="34" charset="0"/>
              </a:rPr>
              <a:t>Potential Living Donor  Total   Event   HR (95% CI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No                                     8           4         Reference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Yes                                   22          3       0.24 (0.06 – 0.99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Gray K-Sample Test P-value: 0.0583     </a:t>
            </a:r>
          </a:p>
        </p:txBody>
      </p:sp>
      <p:sp>
        <p:nvSpPr>
          <p:cNvPr id="820" name="pl48">
            <a:extLst>
              <a:ext uri="{FF2B5EF4-FFF2-40B4-BE49-F238E27FC236}">
                <a16:creationId xmlns:a16="http://schemas.microsoft.com/office/drawing/2014/main" id="{A7669D52-45DA-566A-B7E9-783EAC0B5D60}"/>
              </a:ext>
            </a:extLst>
          </p:cNvPr>
          <p:cNvSpPr/>
          <p:nvPr/>
        </p:nvSpPr>
        <p:spPr>
          <a:xfrm>
            <a:off x="5464711" y="5792514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821" name="pl50">
            <a:extLst>
              <a:ext uri="{FF2B5EF4-FFF2-40B4-BE49-F238E27FC236}">
                <a16:creationId xmlns:a16="http://schemas.microsoft.com/office/drawing/2014/main" id="{F59973DE-6A72-3114-0C97-7CD01C87E1B1}"/>
              </a:ext>
            </a:extLst>
          </p:cNvPr>
          <p:cNvSpPr/>
          <p:nvPr/>
        </p:nvSpPr>
        <p:spPr>
          <a:xfrm>
            <a:off x="5464711" y="5953433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grpSp>
        <p:nvGrpSpPr>
          <p:cNvPr id="893" name="Group 892">
            <a:extLst>
              <a:ext uri="{FF2B5EF4-FFF2-40B4-BE49-F238E27FC236}">
                <a16:creationId xmlns:a16="http://schemas.microsoft.com/office/drawing/2014/main" id="{C6AFF3E1-3E4E-5B4F-DDAF-D4A3EBEE00FB}"/>
              </a:ext>
            </a:extLst>
          </p:cNvPr>
          <p:cNvGrpSpPr>
            <a:grpSpLocks noChangeAspect="1"/>
          </p:cNvGrpSpPr>
          <p:nvPr/>
        </p:nvGrpSpPr>
        <p:grpSpPr>
          <a:xfrm>
            <a:off x="73442" y="9182473"/>
            <a:ext cx="4742633" cy="3571875"/>
            <a:chOff x="0" y="0"/>
            <a:chExt cx="9144000" cy="6858000"/>
          </a:xfrm>
        </p:grpSpPr>
        <p:sp>
          <p:nvSpPr>
            <p:cNvPr id="894" name="rc3">
              <a:extLst>
                <a:ext uri="{FF2B5EF4-FFF2-40B4-BE49-F238E27FC236}">
                  <a16:creationId xmlns:a16="http://schemas.microsoft.com/office/drawing/2014/main" id="{ECDF6283-AA48-1AB9-9007-5C416E15F079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95" name="rc4">
              <a:extLst>
                <a:ext uri="{FF2B5EF4-FFF2-40B4-BE49-F238E27FC236}">
                  <a16:creationId xmlns:a16="http://schemas.microsoft.com/office/drawing/2014/main" id="{C4700E10-AFC4-84B9-717F-080B0981AFB2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96" name="rc5">
              <a:extLst>
                <a:ext uri="{FF2B5EF4-FFF2-40B4-BE49-F238E27FC236}">
                  <a16:creationId xmlns:a16="http://schemas.microsoft.com/office/drawing/2014/main" id="{49EA3A2F-C410-883B-8FF6-37A2C76F9892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97" name="rc6">
              <a:extLst>
                <a:ext uri="{FF2B5EF4-FFF2-40B4-BE49-F238E27FC236}">
                  <a16:creationId xmlns:a16="http://schemas.microsoft.com/office/drawing/2014/main" id="{73DD3CD4-D671-0C38-02E5-7F579B64B37B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98" name="rc7">
              <a:extLst>
                <a:ext uri="{FF2B5EF4-FFF2-40B4-BE49-F238E27FC236}">
                  <a16:creationId xmlns:a16="http://schemas.microsoft.com/office/drawing/2014/main" id="{D9E67B68-66C8-128A-A233-9BC69B12683C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99" name="rc8">
              <a:extLst>
                <a:ext uri="{FF2B5EF4-FFF2-40B4-BE49-F238E27FC236}">
                  <a16:creationId xmlns:a16="http://schemas.microsoft.com/office/drawing/2014/main" id="{1457A8B4-3F91-C58A-E43D-987D095693DD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00" name="rc9">
              <a:extLst>
                <a:ext uri="{FF2B5EF4-FFF2-40B4-BE49-F238E27FC236}">
                  <a16:creationId xmlns:a16="http://schemas.microsoft.com/office/drawing/2014/main" id="{479C2CC8-0A4E-1596-2BD9-CA4E6F96A01C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901" name="pl18">
              <a:extLst>
                <a:ext uri="{FF2B5EF4-FFF2-40B4-BE49-F238E27FC236}">
                  <a16:creationId xmlns:a16="http://schemas.microsoft.com/office/drawing/2014/main" id="{1A5C6014-1669-F3B1-11C3-9E52E3058431}"/>
                </a:ext>
              </a:extLst>
            </p:cNvPr>
            <p:cNvSpPr/>
            <p:nvPr/>
          </p:nvSpPr>
          <p:spPr>
            <a:xfrm>
              <a:off x="776476" y="3534137"/>
              <a:ext cx="8228345" cy="0"/>
            </a:xfrm>
            <a:custGeom>
              <a:avLst/>
              <a:gdLst/>
              <a:ahLst/>
              <a:cxnLst/>
              <a:rect l="0" t="0" r="0" b="0"/>
              <a:pathLst>
                <a:path w="8228345">
                  <a:moveTo>
                    <a:pt x="0" y="0"/>
                  </a:moveTo>
                  <a:lnTo>
                    <a:pt x="8228345" y="0"/>
                  </a:lnTo>
                  <a:lnTo>
                    <a:pt x="8228345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02" name="pl23">
              <a:extLst>
                <a:ext uri="{FF2B5EF4-FFF2-40B4-BE49-F238E27FC236}">
                  <a16:creationId xmlns:a16="http://schemas.microsoft.com/office/drawing/2014/main" id="{0D90E58E-B5A3-3DF7-E294-D456BB850A7C}"/>
                </a:ext>
              </a:extLst>
            </p:cNvPr>
            <p:cNvSpPr/>
            <p:nvPr/>
          </p:nvSpPr>
          <p:spPr>
            <a:xfrm>
              <a:off x="1150492" y="139178"/>
              <a:ext cx="0" cy="3556623"/>
            </a:xfrm>
            <a:custGeom>
              <a:avLst/>
              <a:gdLst/>
              <a:ahLst/>
              <a:cxnLst/>
              <a:rect l="0" t="0" r="0" b="0"/>
              <a:pathLst>
                <a:path h="3556623">
                  <a:moveTo>
                    <a:pt x="0" y="35566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03" name="pl27">
              <a:extLst>
                <a:ext uri="{FF2B5EF4-FFF2-40B4-BE49-F238E27FC236}">
                  <a16:creationId xmlns:a16="http://schemas.microsoft.com/office/drawing/2014/main" id="{E2D95E96-5110-E093-52E3-3716EF1BCB9C}"/>
                </a:ext>
              </a:extLst>
            </p:cNvPr>
            <p:cNvSpPr/>
            <p:nvPr/>
          </p:nvSpPr>
          <p:spPr>
            <a:xfrm>
              <a:off x="1150492" y="2995254"/>
              <a:ext cx="4273001" cy="538882"/>
            </a:xfrm>
            <a:custGeom>
              <a:avLst/>
              <a:gdLst/>
              <a:ahLst/>
              <a:cxnLst/>
              <a:rect l="0" t="0" r="0" b="0"/>
              <a:pathLst>
                <a:path w="4273001" h="538882">
                  <a:moveTo>
                    <a:pt x="0" y="538882"/>
                  </a:moveTo>
                  <a:lnTo>
                    <a:pt x="317657" y="538882"/>
                  </a:lnTo>
                  <a:lnTo>
                    <a:pt x="317657" y="538882"/>
                  </a:lnTo>
                  <a:lnTo>
                    <a:pt x="1250134" y="538882"/>
                  </a:lnTo>
                  <a:lnTo>
                    <a:pt x="1250134" y="538882"/>
                  </a:lnTo>
                  <a:lnTo>
                    <a:pt x="2520763" y="538882"/>
                  </a:lnTo>
                  <a:lnTo>
                    <a:pt x="2520763" y="538882"/>
                  </a:lnTo>
                  <a:lnTo>
                    <a:pt x="3340523" y="538882"/>
                  </a:lnTo>
                  <a:lnTo>
                    <a:pt x="3340523" y="0"/>
                  </a:lnTo>
                  <a:lnTo>
                    <a:pt x="4273001" y="0"/>
                  </a:lnTo>
                  <a:lnTo>
                    <a:pt x="4273001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04" name="pl28">
              <a:extLst>
                <a:ext uri="{FF2B5EF4-FFF2-40B4-BE49-F238E27FC236}">
                  <a16:creationId xmlns:a16="http://schemas.microsoft.com/office/drawing/2014/main" id="{B07C4BAC-5C11-1768-ECE4-8BCD32F30B98}"/>
                </a:ext>
              </a:extLst>
            </p:cNvPr>
            <p:cNvSpPr/>
            <p:nvPr/>
          </p:nvSpPr>
          <p:spPr>
            <a:xfrm>
              <a:off x="1150492" y="3275312"/>
              <a:ext cx="6301908" cy="258824"/>
            </a:xfrm>
            <a:custGeom>
              <a:avLst/>
              <a:gdLst/>
              <a:ahLst/>
              <a:cxnLst/>
              <a:rect l="0" t="0" r="0" b="0"/>
              <a:pathLst>
                <a:path w="6301908" h="258824">
                  <a:moveTo>
                    <a:pt x="0" y="258824"/>
                  </a:moveTo>
                  <a:lnTo>
                    <a:pt x="10247" y="258824"/>
                  </a:lnTo>
                  <a:lnTo>
                    <a:pt x="10247" y="258824"/>
                  </a:lnTo>
                  <a:lnTo>
                    <a:pt x="71729" y="258824"/>
                  </a:lnTo>
                  <a:lnTo>
                    <a:pt x="71729" y="258824"/>
                  </a:lnTo>
                  <a:lnTo>
                    <a:pt x="204940" y="258824"/>
                  </a:lnTo>
                  <a:lnTo>
                    <a:pt x="204940" y="258824"/>
                  </a:lnTo>
                  <a:lnTo>
                    <a:pt x="256175" y="258824"/>
                  </a:lnTo>
                  <a:lnTo>
                    <a:pt x="256175" y="258824"/>
                  </a:lnTo>
                  <a:lnTo>
                    <a:pt x="266422" y="258824"/>
                  </a:lnTo>
                  <a:lnTo>
                    <a:pt x="266422" y="209081"/>
                  </a:lnTo>
                  <a:lnTo>
                    <a:pt x="286916" y="209081"/>
                  </a:lnTo>
                  <a:lnTo>
                    <a:pt x="286916" y="209081"/>
                  </a:lnTo>
                  <a:lnTo>
                    <a:pt x="338151" y="209081"/>
                  </a:lnTo>
                  <a:lnTo>
                    <a:pt x="338151" y="159338"/>
                  </a:lnTo>
                  <a:lnTo>
                    <a:pt x="389386" y="159338"/>
                  </a:lnTo>
                  <a:lnTo>
                    <a:pt x="389386" y="159338"/>
                  </a:lnTo>
                  <a:lnTo>
                    <a:pt x="430374" y="159338"/>
                  </a:lnTo>
                  <a:lnTo>
                    <a:pt x="430374" y="159338"/>
                  </a:lnTo>
                  <a:lnTo>
                    <a:pt x="471362" y="159338"/>
                  </a:lnTo>
                  <a:lnTo>
                    <a:pt x="471362" y="159338"/>
                  </a:lnTo>
                  <a:lnTo>
                    <a:pt x="522597" y="159338"/>
                  </a:lnTo>
                  <a:lnTo>
                    <a:pt x="522597" y="159338"/>
                  </a:lnTo>
                  <a:lnTo>
                    <a:pt x="532844" y="159338"/>
                  </a:lnTo>
                  <a:lnTo>
                    <a:pt x="532844" y="159338"/>
                  </a:lnTo>
                  <a:lnTo>
                    <a:pt x="635314" y="159338"/>
                  </a:lnTo>
                  <a:lnTo>
                    <a:pt x="635314" y="159338"/>
                  </a:lnTo>
                  <a:lnTo>
                    <a:pt x="645561" y="159338"/>
                  </a:lnTo>
                  <a:lnTo>
                    <a:pt x="645561" y="159338"/>
                  </a:lnTo>
                  <a:lnTo>
                    <a:pt x="717290" y="159338"/>
                  </a:lnTo>
                  <a:lnTo>
                    <a:pt x="717290" y="159338"/>
                  </a:lnTo>
                  <a:lnTo>
                    <a:pt x="789019" y="159338"/>
                  </a:lnTo>
                  <a:lnTo>
                    <a:pt x="789019" y="159338"/>
                  </a:lnTo>
                  <a:lnTo>
                    <a:pt x="860748" y="159338"/>
                  </a:lnTo>
                  <a:lnTo>
                    <a:pt x="860748" y="159338"/>
                  </a:lnTo>
                  <a:lnTo>
                    <a:pt x="901736" y="159338"/>
                  </a:lnTo>
                  <a:lnTo>
                    <a:pt x="901736" y="159338"/>
                  </a:lnTo>
                  <a:lnTo>
                    <a:pt x="922230" y="159338"/>
                  </a:lnTo>
                  <a:lnTo>
                    <a:pt x="922230" y="159338"/>
                  </a:lnTo>
                  <a:lnTo>
                    <a:pt x="942724" y="159338"/>
                  </a:lnTo>
                  <a:lnTo>
                    <a:pt x="942724" y="159338"/>
                  </a:lnTo>
                  <a:lnTo>
                    <a:pt x="1004206" y="159338"/>
                  </a:lnTo>
                  <a:lnTo>
                    <a:pt x="1004206" y="159338"/>
                  </a:lnTo>
                  <a:lnTo>
                    <a:pt x="1065688" y="159338"/>
                  </a:lnTo>
                  <a:lnTo>
                    <a:pt x="1065688" y="159338"/>
                  </a:lnTo>
                  <a:lnTo>
                    <a:pt x="1116923" y="159338"/>
                  </a:lnTo>
                  <a:lnTo>
                    <a:pt x="1116923" y="159338"/>
                  </a:lnTo>
                  <a:lnTo>
                    <a:pt x="1157911" y="159338"/>
                  </a:lnTo>
                  <a:lnTo>
                    <a:pt x="1157911" y="159338"/>
                  </a:lnTo>
                  <a:lnTo>
                    <a:pt x="1198899" y="159338"/>
                  </a:lnTo>
                  <a:lnTo>
                    <a:pt x="1198899" y="159338"/>
                  </a:lnTo>
                  <a:lnTo>
                    <a:pt x="1250134" y="159338"/>
                  </a:lnTo>
                  <a:lnTo>
                    <a:pt x="1250134" y="159338"/>
                  </a:lnTo>
                  <a:lnTo>
                    <a:pt x="1291122" y="159338"/>
                  </a:lnTo>
                  <a:lnTo>
                    <a:pt x="1291122" y="159338"/>
                  </a:lnTo>
                  <a:lnTo>
                    <a:pt x="1332110" y="159338"/>
                  </a:lnTo>
                  <a:lnTo>
                    <a:pt x="1332110" y="107661"/>
                  </a:lnTo>
                  <a:lnTo>
                    <a:pt x="1444827" y="107661"/>
                  </a:lnTo>
                  <a:lnTo>
                    <a:pt x="1444827" y="107661"/>
                  </a:lnTo>
                  <a:lnTo>
                    <a:pt x="1547297" y="107661"/>
                  </a:lnTo>
                  <a:lnTo>
                    <a:pt x="1547297" y="107661"/>
                  </a:lnTo>
                  <a:lnTo>
                    <a:pt x="1588285" y="107661"/>
                  </a:lnTo>
                  <a:lnTo>
                    <a:pt x="1588285" y="107661"/>
                  </a:lnTo>
                  <a:lnTo>
                    <a:pt x="1711249" y="107661"/>
                  </a:lnTo>
                  <a:lnTo>
                    <a:pt x="1711249" y="107661"/>
                  </a:lnTo>
                  <a:lnTo>
                    <a:pt x="1731743" y="107661"/>
                  </a:lnTo>
                  <a:lnTo>
                    <a:pt x="1731743" y="107661"/>
                  </a:lnTo>
                  <a:lnTo>
                    <a:pt x="1762484" y="107661"/>
                  </a:lnTo>
                  <a:lnTo>
                    <a:pt x="1762484" y="107661"/>
                  </a:lnTo>
                  <a:lnTo>
                    <a:pt x="1936683" y="107661"/>
                  </a:lnTo>
                  <a:lnTo>
                    <a:pt x="1936683" y="107661"/>
                  </a:lnTo>
                  <a:lnTo>
                    <a:pt x="2244094" y="107661"/>
                  </a:lnTo>
                  <a:lnTo>
                    <a:pt x="2244094" y="53830"/>
                  </a:lnTo>
                  <a:lnTo>
                    <a:pt x="2285082" y="53830"/>
                  </a:lnTo>
                  <a:lnTo>
                    <a:pt x="2285082" y="53830"/>
                  </a:lnTo>
                  <a:lnTo>
                    <a:pt x="2367058" y="53830"/>
                  </a:lnTo>
                  <a:lnTo>
                    <a:pt x="2367058" y="53830"/>
                  </a:lnTo>
                  <a:lnTo>
                    <a:pt x="2408046" y="53830"/>
                  </a:lnTo>
                  <a:lnTo>
                    <a:pt x="2408046" y="53830"/>
                  </a:lnTo>
                  <a:lnTo>
                    <a:pt x="2418293" y="53830"/>
                  </a:lnTo>
                  <a:lnTo>
                    <a:pt x="2418293" y="53830"/>
                  </a:lnTo>
                  <a:lnTo>
                    <a:pt x="2725703" y="53830"/>
                  </a:lnTo>
                  <a:lnTo>
                    <a:pt x="2725703" y="53830"/>
                  </a:lnTo>
                  <a:lnTo>
                    <a:pt x="2787185" y="53830"/>
                  </a:lnTo>
                  <a:lnTo>
                    <a:pt x="2787185" y="0"/>
                  </a:lnTo>
                  <a:lnTo>
                    <a:pt x="3002372" y="0"/>
                  </a:lnTo>
                  <a:lnTo>
                    <a:pt x="3002372" y="0"/>
                  </a:lnTo>
                  <a:lnTo>
                    <a:pt x="3217559" y="0"/>
                  </a:lnTo>
                  <a:lnTo>
                    <a:pt x="3217559" y="0"/>
                  </a:lnTo>
                  <a:lnTo>
                    <a:pt x="3279041" y="0"/>
                  </a:lnTo>
                  <a:lnTo>
                    <a:pt x="3279041" y="0"/>
                  </a:lnTo>
                  <a:lnTo>
                    <a:pt x="3873367" y="0"/>
                  </a:lnTo>
                  <a:lnTo>
                    <a:pt x="3873367" y="0"/>
                  </a:lnTo>
                  <a:lnTo>
                    <a:pt x="3945096" y="0"/>
                  </a:lnTo>
                  <a:lnTo>
                    <a:pt x="3945096" y="0"/>
                  </a:lnTo>
                  <a:lnTo>
                    <a:pt x="4590658" y="0"/>
                  </a:lnTo>
                  <a:lnTo>
                    <a:pt x="4590658" y="0"/>
                  </a:lnTo>
                  <a:lnTo>
                    <a:pt x="4877574" y="0"/>
                  </a:lnTo>
                  <a:lnTo>
                    <a:pt x="4877574" y="0"/>
                  </a:lnTo>
                  <a:lnTo>
                    <a:pt x="5379677" y="0"/>
                  </a:lnTo>
                  <a:lnTo>
                    <a:pt x="5379677" y="0"/>
                  </a:lnTo>
                  <a:lnTo>
                    <a:pt x="6301908" y="0"/>
                  </a:lnTo>
                  <a:lnTo>
                    <a:pt x="6301908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05" name="rc29">
              <a:extLst>
                <a:ext uri="{FF2B5EF4-FFF2-40B4-BE49-F238E27FC236}">
                  <a16:creationId xmlns:a16="http://schemas.microsoft.com/office/drawing/2014/main" id="{759CDB23-F896-A51C-0189-345A2D1FCFC9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06" name="tx30">
              <a:extLst>
                <a:ext uri="{FF2B5EF4-FFF2-40B4-BE49-F238E27FC236}">
                  <a16:creationId xmlns:a16="http://schemas.microsoft.com/office/drawing/2014/main" id="{A46B3A7C-43F4-74C3-D7D7-ED702D319232}"/>
                </a:ext>
              </a:extLst>
            </p:cNvPr>
            <p:cNvSpPr/>
            <p:nvPr/>
          </p:nvSpPr>
          <p:spPr>
            <a:xfrm>
              <a:off x="466667" y="3486760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907" name="tx31">
              <a:extLst>
                <a:ext uri="{FF2B5EF4-FFF2-40B4-BE49-F238E27FC236}">
                  <a16:creationId xmlns:a16="http://schemas.microsoft.com/office/drawing/2014/main" id="{2A4468CA-663B-A6BA-DD2B-F3EF9B11B652}"/>
                </a:ext>
              </a:extLst>
            </p:cNvPr>
            <p:cNvSpPr/>
            <p:nvPr/>
          </p:nvSpPr>
          <p:spPr>
            <a:xfrm>
              <a:off x="466667" y="2678436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908" name="tx32">
              <a:extLst>
                <a:ext uri="{FF2B5EF4-FFF2-40B4-BE49-F238E27FC236}">
                  <a16:creationId xmlns:a16="http://schemas.microsoft.com/office/drawing/2014/main" id="{0A84D6FB-38B9-83FD-4956-E148E23A9E37}"/>
                </a:ext>
              </a:extLst>
            </p:cNvPr>
            <p:cNvSpPr/>
            <p:nvPr/>
          </p:nvSpPr>
          <p:spPr>
            <a:xfrm>
              <a:off x="466667" y="1870113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909" name="tx33">
              <a:extLst>
                <a:ext uri="{FF2B5EF4-FFF2-40B4-BE49-F238E27FC236}">
                  <a16:creationId xmlns:a16="http://schemas.microsoft.com/office/drawing/2014/main" id="{CD06883A-51EC-5603-7E15-5F57CB00CE08}"/>
                </a:ext>
              </a:extLst>
            </p:cNvPr>
            <p:cNvSpPr/>
            <p:nvPr/>
          </p:nvSpPr>
          <p:spPr>
            <a:xfrm>
              <a:off x="466667" y="1061789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910" name="tx34">
              <a:extLst>
                <a:ext uri="{FF2B5EF4-FFF2-40B4-BE49-F238E27FC236}">
                  <a16:creationId xmlns:a16="http://schemas.microsoft.com/office/drawing/2014/main" id="{A2CBC6E8-A5A8-D8FA-E9CE-CFB720605D59}"/>
                </a:ext>
              </a:extLst>
            </p:cNvPr>
            <p:cNvSpPr/>
            <p:nvPr/>
          </p:nvSpPr>
          <p:spPr>
            <a:xfrm>
              <a:off x="466667" y="253465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0</a:t>
              </a:r>
            </a:p>
          </p:txBody>
        </p:sp>
        <p:sp>
          <p:nvSpPr>
            <p:cNvPr id="911" name="pl35">
              <a:extLst>
                <a:ext uri="{FF2B5EF4-FFF2-40B4-BE49-F238E27FC236}">
                  <a16:creationId xmlns:a16="http://schemas.microsoft.com/office/drawing/2014/main" id="{397D6136-8C54-5F84-EA82-8F73358CAFB4}"/>
                </a:ext>
              </a:extLst>
            </p:cNvPr>
            <p:cNvSpPr/>
            <p:nvPr/>
          </p:nvSpPr>
          <p:spPr>
            <a:xfrm>
              <a:off x="741682" y="353413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12" name="pl36">
              <a:extLst>
                <a:ext uri="{FF2B5EF4-FFF2-40B4-BE49-F238E27FC236}">
                  <a16:creationId xmlns:a16="http://schemas.microsoft.com/office/drawing/2014/main" id="{6AD3BCCF-04F5-E17A-1FCA-B233456B396E}"/>
                </a:ext>
              </a:extLst>
            </p:cNvPr>
            <p:cNvSpPr/>
            <p:nvPr/>
          </p:nvSpPr>
          <p:spPr>
            <a:xfrm>
              <a:off x="741682" y="2725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13" name="pl37">
              <a:extLst>
                <a:ext uri="{FF2B5EF4-FFF2-40B4-BE49-F238E27FC236}">
                  <a16:creationId xmlns:a16="http://schemas.microsoft.com/office/drawing/2014/main" id="{7F73791D-1223-6075-2FAF-1791EF9318FC}"/>
                </a:ext>
              </a:extLst>
            </p:cNvPr>
            <p:cNvSpPr/>
            <p:nvPr/>
          </p:nvSpPr>
          <p:spPr>
            <a:xfrm>
              <a:off x="741682" y="19174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14" name="pl38">
              <a:extLst>
                <a:ext uri="{FF2B5EF4-FFF2-40B4-BE49-F238E27FC236}">
                  <a16:creationId xmlns:a16="http://schemas.microsoft.com/office/drawing/2014/main" id="{0AA0576F-ADAD-A748-F808-AC39237FC4DD}"/>
                </a:ext>
              </a:extLst>
            </p:cNvPr>
            <p:cNvSpPr/>
            <p:nvPr/>
          </p:nvSpPr>
          <p:spPr>
            <a:xfrm>
              <a:off x="741682" y="11091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15" name="pl39">
              <a:extLst>
                <a:ext uri="{FF2B5EF4-FFF2-40B4-BE49-F238E27FC236}">
                  <a16:creationId xmlns:a16="http://schemas.microsoft.com/office/drawing/2014/main" id="{F1BAC26B-8B89-4B96-D6B1-807FA88D2AD5}"/>
                </a:ext>
              </a:extLst>
            </p:cNvPr>
            <p:cNvSpPr/>
            <p:nvPr/>
          </p:nvSpPr>
          <p:spPr>
            <a:xfrm>
              <a:off x="741682" y="3008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16" name="pl40">
              <a:extLst>
                <a:ext uri="{FF2B5EF4-FFF2-40B4-BE49-F238E27FC236}">
                  <a16:creationId xmlns:a16="http://schemas.microsoft.com/office/drawing/2014/main" id="{E1478D03-2931-70F4-716E-F4D7BD1B9200}"/>
                </a:ext>
              </a:extLst>
            </p:cNvPr>
            <p:cNvSpPr/>
            <p:nvPr/>
          </p:nvSpPr>
          <p:spPr>
            <a:xfrm>
              <a:off x="1150492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17" name="pl41">
              <a:extLst>
                <a:ext uri="{FF2B5EF4-FFF2-40B4-BE49-F238E27FC236}">
                  <a16:creationId xmlns:a16="http://schemas.microsoft.com/office/drawing/2014/main" id="{0154D226-A3AF-5C0D-B671-502412892587}"/>
                </a:ext>
              </a:extLst>
            </p:cNvPr>
            <p:cNvSpPr/>
            <p:nvPr/>
          </p:nvSpPr>
          <p:spPr>
            <a:xfrm>
              <a:off x="3199893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18" name="pl42">
              <a:extLst>
                <a:ext uri="{FF2B5EF4-FFF2-40B4-BE49-F238E27FC236}">
                  <a16:creationId xmlns:a16="http://schemas.microsoft.com/office/drawing/2014/main" id="{F8F0C4D0-6CFD-671A-8BEB-72952D2D7F10}"/>
                </a:ext>
              </a:extLst>
            </p:cNvPr>
            <p:cNvSpPr/>
            <p:nvPr/>
          </p:nvSpPr>
          <p:spPr>
            <a:xfrm>
              <a:off x="5249294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19" name="pl43">
              <a:extLst>
                <a:ext uri="{FF2B5EF4-FFF2-40B4-BE49-F238E27FC236}">
                  <a16:creationId xmlns:a16="http://schemas.microsoft.com/office/drawing/2014/main" id="{4DC28F61-6A29-F35D-E88E-FD18E1E60AFA}"/>
                </a:ext>
              </a:extLst>
            </p:cNvPr>
            <p:cNvSpPr/>
            <p:nvPr/>
          </p:nvSpPr>
          <p:spPr>
            <a:xfrm>
              <a:off x="7298695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20" name="tx44">
              <a:extLst>
                <a:ext uri="{FF2B5EF4-FFF2-40B4-BE49-F238E27FC236}">
                  <a16:creationId xmlns:a16="http://schemas.microsoft.com/office/drawing/2014/main" id="{9D80F09C-8727-CB6F-81C6-C64926AE8C2E}"/>
                </a:ext>
              </a:extLst>
            </p:cNvPr>
            <p:cNvSpPr/>
            <p:nvPr/>
          </p:nvSpPr>
          <p:spPr>
            <a:xfrm>
              <a:off x="1115176" y="3756509"/>
              <a:ext cx="70631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921" name="tx45">
              <a:extLst>
                <a:ext uri="{FF2B5EF4-FFF2-40B4-BE49-F238E27FC236}">
                  <a16:creationId xmlns:a16="http://schemas.microsoft.com/office/drawing/2014/main" id="{CA9A9DA0-F914-CEC6-CFF2-1F2A1D46F5D3}"/>
                </a:ext>
              </a:extLst>
            </p:cNvPr>
            <p:cNvSpPr/>
            <p:nvPr/>
          </p:nvSpPr>
          <p:spPr>
            <a:xfrm>
              <a:off x="3093946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922" name="tx46">
              <a:extLst>
                <a:ext uri="{FF2B5EF4-FFF2-40B4-BE49-F238E27FC236}">
                  <a16:creationId xmlns:a16="http://schemas.microsoft.com/office/drawing/2014/main" id="{CC066A1D-68F7-62A2-3A51-676DF9E4F6EC}"/>
                </a:ext>
              </a:extLst>
            </p:cNvPr>
            <p:cNvSpPr/>
            <p:nvPr/>
          </p:nvSpPr>
          <p:spPr>
            <a:xfrm>
              <a:off x="5143347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923" name="tx47">
              <a:extLst>
                <a:ext uri="{FF2B5EF4-FFF2-40B4-BE49-F238E27FC236}">
                  <a16:creationId xmlns:a16="http://schemas.microsoft.com/office/drawing/2014/main" id="{CB2ED92F-C64D-AA80-F258-F39BBB2B2DAC}"/>
                </a:ext>
              </a:extLst>
            </p:cNvPr>
            <p:cNvSpPr/>
            <p:nvPr/>
          </p:nvSpPr>
          <p:spPr>
            <a:xfrm>
              <a:off x="7192748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924" name="tx48">
              <a:extLst>
                <a:ext uri="{FF2B5EF4-FFF2-40B4-BE49-F238E27FC236}">
                  <a16:creationId xmlns:a16="http://schemas.microsoft.com/office/drawing/2014/main" id="{90B8A8E3-B144-27AA-3633-D2929F24BB54}"/>
                </a:ext>
              </a:extLst>
            </p:cNvPr>
            <p:cNvSpPr/>
            <p:nvPr/>
          </p:nvSpPr>
          <p:spPr>
            <a:xfrm>
              <a:off x="3607639" y="3878778"/>
              <a:ext cx="2566020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 to Liver-Related Mortality (Days)</a:t>
              </a:r>
            </a:p>
          </p:txBody>
        </p:sp>
        <p:sp>
          <p:nvSpPr>
            <p:cNvPr id="925" name="tx49">
              <a:extLst>
                <a:ext uri="{FF2B5EF4-FFF2-40B4-BE49-F238E27FC236}">
                  <a16:creationId xmlns:a16="http://schemas.microsoft.com/office/drawing/2014/main" id="{59120421-85E5-3814-7F78-8BEA0C1B1AFC}"/>
                </a:ext>
              </a:extLst>
            </p:cNvPr>
            <p:cNvSpPr/>
            <p:nvPr/>
          </p:nvSpPr>
          <p:spPr>
            <a:xfrm rot="-5400000">
              <a:off x="-1388133" y="1845978"/>
              <a:ext cx="3472681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umulative Incidence of Liver-Related Mortality (%)</a:t>
              </a:r>
            </a:p>
          </p:txBody>
        </p:sp>
        <p:sp>
          <p:nvSpPr>
            <p:cNvPr id="926" name="rc50">
              <a:extLst>
                <a:ext uri="{FF2B5EF4-FFF2-40B4-BE49-F238E27FC236}">
                  <a16:creationId xmlns:a16="http://schemas.microsoft.com/office/drawing/2014/main" id="{FF43DE6E-2E3F-75D0-35AE-AE4BA64F70DE}"/>
                </a:ext>
              </a:extLst>
            </p:cNvPr>
            <p:cNvSpPr/>
            <p:nvPr/>
          </p:nvSpPr>
          <p:spPr>
            <a:xfrm>
              <a:off x="4276688" y="4189554"/>
              <a:ext cx="1227921" cy="358634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927" name="rc51">
              <a:extLst>
                <a:ext uri="{FF2B5EF4-FFF2-40B4-BE49-F238E27FC236}">
                  <a16:creationId xmlns:a16="http://schemas.microsoft.com/office/drawing/2014/main" id="{AB571F9B-9652-90EF-9B9B-C0F5049A08C3}"/>
                </a:ext>
              </a:extLst>
            </p:cNvPr>
            <p:cNvSpPr/>
            <p:nvPr/>
          </p:nvSpPr>
          <p:spPr>
            <a:xfrm>
              <a:off x="4415866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928" name="pl52">
              <a:extLst>
                <a:ext uri="{FF2B5EF4-FFF2-40B4-BE49-F238E27FC236}">
                  <a16:creationId xmlns:a16="http://schemas.microsoft.com/office/drawing/2014/main" id="{FE07C7DC-05BD-F13E-1AFC-2354871FCF4E}"/>
                </a:ext>
              </a:extLst>
            </p:cNvPr>
            <p:cNvSpPr/>
            <p:nvPr/>
          </p:nvSpPr>
          <p:spPr>
            <a:xfrm>
              <a:off x="4437812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29" name="rc53">
              <a:extLst>
                <a:ext uri="{FF2B5EF4-FFF2-40B4-BE49-F238E27FC236}">
                  <a16:creationId xmlns:a16="http://schemas.microsoft.com/office/drawing/2014/main" id="{6DF6464A-CF93-2015-9823-BE04E4E51642}"/>
                </a:ext>
              </a:extLst>
            </p:cNvPr>
            <p:cNvSpPr/>
            <p:nvPr/>
          </p:nvSpPr>
          <p:spPr>
            <a:xfrm>
              <a:off x="4926900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930" name="pl54">
              <a:extLst>
                <a:ext uri="{FF2B5EF4-FFF2-40B4-BE49-F238E27FC236}">
                  <a16:creationId xmlns:a16="http://schemas.microsoft.com/office/drawing/2014/main" id="{80BEFBE6-5A88-6C87-25B8-6412728C7ED9}"/>
                </a:ext>
              </a:extLst>
            </p:cNvPr>
            <p:cNvSpPr/>
            <p:nvPr/>
          </p:nvSpPr>
          <p:spPr>
            <a:xfrm>
              <a:off x="4948846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31" name="tx55">
              <a:extLst>
                <a:ext uri="{FF2B5EF4-FFF2-40B4-BE49-F238E27FC236}">
                  <a16:creationId xmlns:a16="http://schemas.microsoft.com/office/drawing/2014/main" id="{C078BB81-BFB6-5437-0CE4-41AD833C785F}"/>
                </a:ext>
              </a:extLst>
            </p:cNvPr>
            <p:cNvSpPr/>
            <p:nvPr/>
          </p:nvSpPr>
          <p:spPr>
            <a:xfrm>
              <a:off x="4704911" y="4321929"/>
              <a:ext cx="162346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932" name="tx56">
              <a:extLst>
                <a:ext uri="{FF2B5EF4-FFF2-40B4-BE49-F238E27FC236}">
                  <a16:creationId xmlns:a16="http://schemas.microsoft.com/office/drawing/2014/main" id="{53012230-76D8-1C41-00BC-B74D0A4F8C0B}"/>
                </a:ext>
              </a:extLst>
            </p:cNvPr>
            <p:cNvSpPr/>
            <p:nvPr/>
          </p:nvSpPr>
          <p:spPr>
            <a:xfrm>
              <a:off x="5215945" y="4321929"/>
              <a:ext cx="218839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  <p:sp>
          <p:nvSpPr>
            <p:cNvPr id="933" name="rc57">
              <a:extLst>
                <a:ext uri="{FF2B5EF4-FFF2-40B4-BE49-F238E27FC236}">
                  <a16:creationId xmlns:a16="http://schemas.microsoft.com/office/drawing/2014/main" id="{6F42E589-CBCE-C3E0-14A9-417FDDA490B4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34" name="rc58">
              <a:extLst>
                <a:ext uri="{FF2B5EF4-FFF2-40B4-BE49-F238E27FC236}">
                  <a16:creationId xmlns:a16="http://schemas.microsoft.com/office/drawing/2014/main" id="{409BDF46-877C-68DB-FFDC-C36AA66508E6}"/>
                </a:ext>
              </a:extLst>
            </p:cNvPr>
            <p:cNvSpPr/>
            <p:nvPr/>
          </p:nvSpPr>
          <p:spPr>
            <a:xfrm>
              <a:off x="776476" y="4996549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935" name="tx59">
              <a:extLst>
                <a:ext uri="{FF2B5EF4-FFF2-40B4-BE49-F238E27FC236}">
                  <a16:creationId xmlns:a16="http://schemas.microsoft.com/office/drawing/2014/main" id="{AE490AF1-72B0-92BA-07ED-D7439BC54430}"/>
                </a:ext>
              </a:extLst>
            </p:cNvPr>
            <p:cNvSpPr/>
            <p:nvPr/>
          </p:nvSpPr>
          <p:spPr>
            <a:xfrm>
              <a:off x="1115323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936" name="tx60">
              <a:extLst>
                <a:ext uri="{FF2B5EF4-FFF2-40B4-BE49-F238E27FC236}">
                  <a16:creationId xmlns:a16="http://schemas.microsoft.com/office/drawing/2014/main" id="{384DB429-ED76-50BC-F338-B436090E89C7}"/>
                </a:ext>
              </a:extLst>
            </p:cNvPr>
            <p:cNvSpPr/>
            <p:nvPr/>
          </p:nvSpPr>
          <p:spPr>
            <a:xfrm>
              <a:off x="1115323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937" name="tx61">
              <a:extLst>
                <a:ext uri="{FF2B5EF4-FFF2-40B4-BE49-F238E27FC236}">
                  <a16:creationId xmlns:a16="http://schemas.microsoft.com/office/drawing/2014/main" id="{8FB04CC1-99EE-8D55-2443-4779B1776084}"/>
                </a:ext>
              </a:extLst>
            </p:cNvPr>
            <p:cNvSpPr/>
            <p:nvPr/>
          </p:nvSpPr>
          <p:spPr>
            <a:xfrm>
              <a:off x="3164724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938" name="tx62">
              <a:extLst>
                <a:ext uri="{FF2B5EF4-FFF2-40B4-BE49-F238E27FC236}">
                  <a16:creationId xmlns:a16="http://schemas.microsoft.com/office/drawing/2014/main" id="{0A432F07-957C-02E0-7BAA-CF7EBE994C3D}"/>
                </a:ext>
              </a:extLst>
            </p:cNvPr>
            <p:cNvSpPr/>
            <p:nvPr/>
          </p:nvSpPr>
          <p:spPr>
            <a:xfrm>
              <a:off x="3164724" y="5132512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939" name="tx63">
              <a:extLst>
                <a:ext uri="{FF2B5EF4-FFF2-40B4-BE49-F238E27FC236}">
                  <a16:creationId xmlns:a16="http://schemas.microsoft.com/office/drawing/2014/main" id="{366CEEF2-9E69-F1EB-B1B2-14394C584E69}"/>
                </a:ext>
              </a:extLst>
            </p:cNvPr>
            <p:cNvSpPr/>
            <p:nvPr/>
          </p:nvSpPr>
          <p:spPr>
            <a:xfrm>
              <a:off x="5214125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940" name="tx64">
              <a:extLst>
                <a:ext uri="{FF2B5EF4-FFF2-40B4-BE49-F238E27FC236}">
                  <a16:creationId xmlns:a16="http://schemas.microsoft.com/office/drawing/2014/main" id="{B5D53342-2AB1-AACA-5FD5-2614A95408A5}"/>
                </a:ext>
              </a:extLst>
            </p:cNvPr>
            <p:cNvSpPr/>
            <p:nvPr/>
          </p:nvSpPr>
          <p:spPr>
            <a:xfrm>
              <a:off x="5214125" y="5134117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941" name="tx65">
              <a:extLst>
                <a:ext uri="{FF2B5EF4-FFF2-40B4-BE49-F238E27FC236}">
                  <a16:creationId xmlns:a16="http://schemas.microsoft.com/office/drawing/2014/main" id="{3BBFF99B-A45E-1CA5-F488-E3BAB5F71161}"/>
                </a:ext>
              </a:extLst>
            </p:cNvPr>
            <p:cNvSpPr/>
            <p:nvPr/>
          </p:nvSpPr>
          <p:spPr>
            <a:xfrm>
              <a:off x="7263526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942" name="tx66">
              <a:extLst>
                <a:ext uri="{FF2B5EF4-FFF2-40B4-BE49-F238E27FC236}">
                  <a16:creationId xmlns:a16="http://schemas.microsoft.com/office/drawing/2014/main" id="{CCF3C220-C905-0E91-D8B1-252253A6466D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943" name="tx67">
              <a:extLst>
                <a:ext uri="{FF2B5EF4-FFF2-40B4-BE49-F238E27FC236}">
                  <a16:creationId xmlns:a16="http://schemas.microsoft.com/office/drawing/2014/main" id="{ACA630F5-DAC2-C0D0-CDE9-BABA50958842}"/>
                </a:ext>
              </a:extLst>
            </p:cNvPr>
            <p:cNvSpPr/>
            <p:nvPr/>
          </p:nvSpPr>
          <p:spPr>
            <a:xfrm>
              <a:off x="7263526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944" name="tx68">
              <a:extLst>
                <a:ext uri="{FF2B5EF4-FFF2-40B4-BE49-F238E27FC236}">
                  <a16:creationId xmlns:a16="http://schemas.microsoft.com/office/drawing/2014/main" id="{4A042723-1AAC-8240-9C3F-B599B622DD19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945" name="tx69">
              <a:extLst>
                <a:ext uri="{FF2B5EF4-FFF2-40B4-BE49-F238E27FC236}">
                  <a16:creationId xmlns:a16="http://schemas.microsoft.com/office/drawing/2014/main" id="{AF7B3982-377C-E92A-134B-25CD120B46D5}"/>
                </a:ext>
              </a:extLst>
            </p:cNvPr>
            <p:cNvSpPr/>
            <p:nvPr/>
          </p:nvSpPr>
          <p:spPr>
            <a:xfrm>
              <a:off x="325591" y="5438152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946" name="tx70">
              <a:extLst>
                <a:ext uri="{FF2B5EF4-FFF2-40B4-BE49-F238E27FC236}">
                  <a16:creationId xmlns:a16="http://schemas.microsoft.com/office/drawing/2014/main" id="{9B99AD4E-4309-EB8B-B91A-3CA59510AE89}"/>
                </a:ext>
              </a:extLst>
            </p:cNvPr>
            <p:cNvSpPr/>
            <p:nvPr/>
          </p:nvSpPr>
          <p:spPr>
            <a:xfrm>
              <a:off x="311638" y="5132811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947" name="tx71">
              <a:extLst>
                <a:ext uri="{FF2B5EF4-FFF2-40B4-BE49-F238E27FC236}">
                  <a16:creationId xmlns:a16="http://schemas.microsoft.com/office/drawing/2014/main" id="{01D5E519-8CE2-0BEB-8355-6BE4149DED78}"/>
                </a:ext>
              </a:extLst>
            </p:cNvPr>
            <p:cNvSpPr/>
            <p:nvPr/>
          </p:nvSpPr>
          <p:spPr>
            <a:xfrm>
              <a:off x="776476" y="4827633"/>
              <a:ext cx="17452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948" name="rc72">
              <a:extLst>
                <a:ext uri="{FF2B5EF4-FFF2-40B4-BE49-F238E27FC236}">
                  <a16:creationId xmlns:a16="http://schemas.microsoft.com/office/drawing/2014/main" id="{32B3DB1E-1F26-1E2A-FA35-DB15E3A572B9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49" name="rc73">
              <a:extLst>
                <a:ext uri="{FF2B5EF4-FFF2-40B4-BE49-F238E27FC236}">
                  <a16:creationId xmlns:a16="http://schemas.microsoft.com/office/drawing/2014/main" id="{DFDB42E0-50A3-B017-FC01-37444E7F29A8}"/>
                </a:ext>
              </a:extLst>
            </p:cNvPr>
            <p:cNvSpPr/>
            <p:nvPr/>
          </p:nvSpPr>
          <p:spPr>
            <a:xfrm>
              <a:off x="776476" y="6081865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950" name="tx74">
              <a:extLst>
                <a:ext uri="{FF2B5EF4-FFF2-40B4-BE49-F238E27FC236}">
                  <a16:creationId xmlns:a16="http://schemas.microsoft.com/office/drawing/2014/main" id="{5505B3EC-DD90-CB35-332D-282FA643FEA3}"/>
                </a:ext>
              </a:extLst>
            </p:cNvPr>
            <p:cNvSpPr/>
            <p:nvPr/>
          </p:nvSpPr>
          <p:spPr>
            <a:xfrm>
              <a:off x="1115323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951" name="tx75">
              <a:extLst>
                <a:ext uri="{FF2B5EF4-FFF2-40B4-BE49-F238E27FC236}">
                  <a16:creationId xmlns:a16="http://schemas.microsoft.com/office/drawing/2014/main" id="{0C377DB8-1063-4BA4-9EB5-230E49E6B869}"/>
                </a:ext>
              </a:extLst>
            </p:cNvPr>
            <p:cNvSpPr/>
            <p:nvPr/>
          </p:nvSpPr>
          <p:spPr>
            <a:xfrm>
              <a:off x="1080154" y="6217890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5</a:t>
              </a:r>
            </a:p>
          </p:txBody>
        </p:sp>
        <p:sp>
          <p:nvSpPr>
            <p:cNvPr id="952" name="tx76">
              <a:extLst>
                <a:ext uri="{FF2B5EF4-FFF2-40B4-BE49-F238E27FC236}">
                  <a16:creationId xmlns:a16="http://schemas.microsoft.com/office/drawing/2014/main" id="{935F96AE-5F87-56A1-1354-2F07B3C15FD1}"/>
                </a:ext>
              </a:extLst>
            </p:cNvPr>
            <p:cNvSpPr/>
            <p:nvPr/>
          </p:nvSpPr>
          <p:spPr>
            <a:xfrm>
              <a:off x="3164724" y="6523169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953" name="tx77">
              <a:extLst>
                <a:ext uri="{FF2B5EF4-FFF2-40B4-BE49-F238E27FC236}">
                  <a16:creationId xmlns:a16="http://schemas.microsoft.com/office/drawing/2014/main" id="{F531165F-6D8B-EA3E-6CC3-1A05BF2B67E2}"/>
                </a:ext>
              </a:extLst>
            </p:cNvPr>
            <p:cNvSpPr/>
            <p:nvPr/>
          </p:nvSpPr>
          <p:spPr>
            <a:xfrm>
              <a:off x="3129555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4</a:t>
              </a:r>
            </a:p>
          </p:txBody>
        </p:sp>
        <p:sp>
          <p:nvSpPr>
            <p:cNvPr id="954" name="tx78">
              <a:extLst>
                <a:ext uri="{FF2B5EF4-FFF2-40B4-BE49-F238E27FC236}">
                  <a16:creationId xmlns:a16="http://schemas.microsoft.com/office/drawing/2014/main" id="{319AEF8C-5CCE-629B-2F8F-DD15445F8943}"/>
                </a:ext>
              </a:extLst>
            </p:cNvPr>
            <p:cNvSpPr/>
            <p:nvPr/>
          </p:nvSpPr>
          <p:spPr>
            <a:xfrm>
              <a:off x="5214125" y="6524837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955" name="tx79">
              <a:extLst>
                <a:ext uri="{FF2B5EF4-FFF2-40B4-BE49-F238E27FC236}">
                  <a16:creationId xmlns:a16="http://schemas.microsoft.com/office/drawing/2014/main" id="{37A80F91-2032-1D80-01BA-CB65116B6B0E}"/>
                </a:ext>
              </a:extLst>
            </p:cNvPr>
            <p:cNvSpPr/>
            <p:nvPr/>
          </p:nvSpPr>
          <p:spPr>
            <a:xfrm>
              <a:off x="5178956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1</a:t>
              </a:r>
            </a:p>
          </p:txBody>
        </p:sp>
        <p:sp>
          <p:nvSpPr>
            <p:cNvPr id="956" name="tx80">
              <a:extLst>
                <a:ext uri="{FF2B5EF4-FFF2-40B4-BE49-F238E27FC236}">
                  <a16:creationId xmlns:a16="http://schemas.microsoft.com/office/drawing/2014/main" id="{07A5BBC7-83BE-E849-FB40-FFC738A68183}"/>
                </a:ext>
              </a:extLst>
            </p:cNvPr>
            <p:cNvSpPr/>
            <p:nvPr/>
          </p:nvSpPr>
          <p:spPr>
            <a:xfrm>
              <a:off x="7263526" y="6524837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957" name="tx81">
              <a:extLst>
                <a:ext uri="{FF2B5EF4-FFF2-40B4-BE49-F238E27FC236}">
                  <a16:creationId xmlns:a16="http://schemas.microsoft.com/office/drawing/2014/main" id="{6377AAA5-FE34-F643-1DA1-8E7065646EE3}"/>
                </a:ext>
              </a:extLst>
            </p:cNvPr>
            <p:cNvSpPr/>
            <p:nvPr/>
          </p:nvSpPr>
          <p:spPr>
            <a:xfrm>
              <a:off x="7263526" y="6217890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958" name="tx82">
              <a:extLst>
                <a:ext uri="{FF2B5EF4-FFF2-40B4-BE49-F238E27FC236}">
                  <a16:creationId xmlns:a16="http://schemas.microsoft.com/office/drawing/2014/main" id="{E3FA698D-1543-02EF-4F94-68E1769DED14}"/>
                </a:ext>
              </a:extLst>
            </p:cNvPr>
            <p:cNvSpPr/>
            <p:nvPr/>
          </p:nvSpPr>
          <p:spPr>
            <a:xfrm>
              <a:off x="325591" y="6523468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959" name="tx83">
              <a:extLst>
                <a:ext uri="{FF2B5EF4-FFF2-40B4-BE49-F238E27FC236}">
                  <a16:creationId xmlns:a16="http://schemas.microsoft.com/office/drawing/2014/main" id="{DF097348-FE7A-8A64-B18D-EE940008C84E}"/>
                </a:ext>
              </a:extLst>
            </p:cNvPr>
            <p:cNvSpPr/>
            <p:nvPr/>
          </p:nvSpPr>
          <p:spPr>
            <a:xfrm>
              <a:off x="311638" y="6218127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960" name="tx84">
              <a:extLst>
                <a:ext uri="{FF2B5EF4-FFF2-40B4-BE49-F238E27FC236}">
                  <a16:creationId xmlns:a16="http://schemas.microsoft.com/office/drawing/2014/main" id="{A52F158E-57A1-105F-884C-9D165EA8F391}"/>
                </a:ext>
              </a:extLst>
            </p:cNvPr>
            <p:cNvSpPr/>
            <p:nvPr/>
          </p:nvSpPr>
          <p:spPr>
            <a:xfrm>
              <a:off x="776476" y="5912949"/>
              <a:ext cx="23525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</p:grpSp>
      <p:sp>
        <p:nvSpPr>
          <p:cNvPr id="961" name="TextBox 960">
            <a:extLst>
              <a:ext uri="{FF2B5EF4-FFF2-40B4-BE49-F238E27FC236}">
                <a16:creationId xmlns:a16="http://schemas.microsoft.com/office/drawing/2014/main" id="{90D3CE28-C45B-C47A-BB12-FAD1C85DE88E}"/>
              </a:ext>
            </a:extLst>
          </p:cNvPr>
          <p:cNvSpPr txBox="1"/>
          <p:nvPr/>
        </p:nvSpPr>
        <p:spPr>
          <a:xfrm>
            <a:off x="837402" y="9389127"/>
            <a:ext cx="3125335" cy="6519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9" b="1" dirty="0">
                <a:latin typeface="Arial" panose="020B0604020202020204" pitchFamily="34" charset="0"/>
                <a:cs typeface="Arial" panose="020B0604020202020204" pitchFamily="34" charset="0"/>
              </a:rPr>
              <a:t>Potential Living Donor  Total   Event   HR (95% CI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No                                     6           1         Reference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Yes                                   65          5       0.50 (0.07 – 3.52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Gray K-Sample Test P-value: 0.5331    </a:t>
            </a:r>
          </a:p>
        </p:txBody>
      </p:sp>
      <p:sp>
        <p:nvSpPr>
          <p:cNvPr id="962" name="pl48">
            <a:extLst>
              <a:ext uri="{FF2B5EF4-FFF2-40B4-BE49-F238E27FC236}">
                <a16:creationId xmlns:a16="http://schemas.microsoft.com/office/drawing/2014/main" id="{9C16F73A-B721-0ABD-C8C4-7EC72FD63843}"/>
              </a:ext>
            </a:extLst>
          </p:cNvPr>
          <p:cNvSpPr/>
          <p:nvPr/>
        </p:nvSpPr>
        <p:spPr>
          <a:xfrm>
            <a:off x="664206" y="9612943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963" name="pl50">
            <a:extLst>
              <a:ext uri="{FF2B5EF4-FFF2-40B4-BE49-F238E27FC236}">
                <a16:creationId xmlns:a16="http://schemas.microsoft.com/office/drawing/2014/main" id="{098E82F7-FE4C-F212-0B65-CCC42B502507}"/>
              </a:ext>
            </a:extLst>
          </p:cNvPr>
          <p:cNvSpPr/>
          <p:nvPr/>
        </p:nvSpPr>
        <p:spPr>
          <a:xfrm>
            <a:off x="664206" y="9773862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grpSp>
        <p:nvGrpSpPr>
          <p:cNvPr id="964" name="Group 963">
            <a:extLst>
              <a:ext uri="{FF2B5EF4-FFF2-40B4-BE49-F238E27FC236}">
                <a16:creationId xmlns:a16="http://schemas.microsoft.com/office/drawing/2014/main" id="{D1A2F503-81E1-8238-936D-90A25D08C536}"/>
              </a:ext>
            </a:extLst>
          </p:cNvPr>
          <p:cNvGrpSpPr>
            <a:grpSpLocks noChangeAspect="1"/>
          </p:cNvGrpSpPr>
          <p:nvPr/>
        </p:nvGrpSpPr>
        <p:grpSpPr>
          <a:xfrm>
            <a:off x="4839254" y="9198656"/>
            <a:ext cx="4722295" cy="3571875"/>
            <a:chOff x="0" y="0"/>
            <a:chExt cx="9144000" cy="6858000"/>
          </a:xfrm>
        </p:grpSpPr>
        <p:sp>
          <p:nvSpPr>
            <p:cNvPr id="965" name="rc3">
              <a:extLst>
                <a:ext uri="{FF2B5EF4-FFF2-40B4-BE49-F238E27FC236}">
                  <a16:creationId xmlns:a16="http://schemas.microsoft.com/office/drawing/2014/main" id="{4A102764-BE1E-1870-B226-7CAB1623001D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66" name="rc4">
              <a:extLst>
                <a:ext uri="{FF2B5EF4-FFF2-40B4-BE49-F238E27FC236}">
                  <a16:creationId xmlns:a16="http://schemas.microsoft.com/office/drawing/2014/main" id="{F92991AC-E013-608E-9684-EFA36393E654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67" name="rc5">
              <a:extLst>
                <a:ext uri="{FF2B5EF4-FFF2-40B4-BE49-F238E27FC236}">
                  <a16:creationId xmlns:a16="http://schemas.microsoft.com/office/drawing/2014/main" id="{74FE9A02-3DD2-740A-BA09-7CBA39A5C22A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68" name="rc6">
              <a:extLst>
                <a:ext uri="{FF2B5EF4-FFF2-40B4-BE49-F238E27FC236}">
                  <a16:creationId xmlns:a16="http://schemas.microsoft.com/office/drawing/2014/main" id="{A710FA8E-068C-5F1B-CB42-05D54BC7ADE2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69" name="rc7">
              <a:extLst>
                <a:ext uri="{FF2B5EF4-FFF2-40B4-BE49-F238E27FC236}">
                  <a16:creationId xmlns:a16="http://schemas.microsoft.com/office/drawing/2014/main" id="{FBD13852-358F-EB15-55E7-FBF4C13B60B9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70" name="rc8">
              <a:extLst>
                <a:ext uri="{FF2B5EF4-FFF2-40B4-BE49-F238E27FC236}">
                  <a16:creationId xmlns:a16="http://schemas.microsoft.com/office/drawing/2014/main" id="{CDB574D2-1620-EB97-7AED-991029184876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71" name="rc9">
              <a:extLst>
                <a:ext uri="{FF2B5EF4-FFF2-40B4-BE49-F238E27FC236}">
                  <a16:creationId xmlns:a16="http://schemas.microsoft.com/office/drawing/2014/main" id="{60AA3A45-5280-3096-256F-A9A528FF6B9F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972" name="pl18">
              <a:extLst>
                <a:ext uri="{FF2B5EF4-FFF2-40B4-BE49-F238E27FC236}">
                  <a16:creationId xmlns:a16="http://schemas.microsoft.com/office/drawing/2014/main" id="{54058BDB-07B7-6C9B-BB14-8480D0158D08}"/>
                </a:ext>
              </a:extLst>
            </p:cNvPr>
            <p:cNvSpPr/>
            <p:nvPr/>
          </p:nvSpPr>
          <p:spPr>
            <a:xfrm>
              <a:off x="776476" y="3534137"/>
              <a:ext cx="8228345" cy="0"/>
            </a:xfrm>
            <a:custGeom>
              <a:avLst/>
              <a:gdLst/>
              <a:ahLst/>
              <a:cxnLst/>
              <a:rect l="0" t="0" r="0" b="0"/>
              <a:pathLst>
                <a:path w="8228345">
                  <a:moveTo>
                    <a:pt x="0" y="0"/>
                  </a:moveTo>
                  <a:lnTo>
                    <a:pt x="8228345" y="0"/>
                  </a:lnTo>
                  <a:lnTo>
                    <a:pt x="8228345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73" name="pl23">
              <a:extLst>
                <a:ext uri="{FF2B5EF4-FFF2-40B4-BE49-F238E27FC236}">
                  <a16:creationId xmlns:a16="http://schemas.microsoft.com/office/drawing/2014/main" id="{816B68AA-FBE1-0F43-4606-9BAE52F21286}"/>
                </a:ext>
              </a:extLst>
            </p:cNvPr>
            <p:cNvSpPr/>
            <p:nvPr/>
          </p:nvSpPr>
          <p:spPr>
            <a:xfrm>
              <a:off x="1150492" y="139178"/>
              <a:ext cx="0" cy="3556623"/>
            </a:xfrm>
            <a:custGeom>
              <a:avLst/>
              <a:gdLst/>
              <a:ahLst/>
              <a:cxnLst/>
              <a:rect l="0" t="0" r="0" b="0"/>
              <a:pathLst>
                <a:path h="3556623">
                  <a:moveTo>
                    <a:pt x="0" y="35566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74" name="pl27">
              <a:extLst>
                <a:ext uri="{FF2B5EF4-FFF2-40B4-BE49-F238E27FC236}">
                  <a16:creationId xmlns:a16="http://schemas.microsoft.com/office/drawing/2014/main" id="{452B1A53-746B-78B6-FBC2-F54E061F032E}"/>
                </a:ext>
              </a:extLst>
            </p:cNvPr>
            <p:cNvSpPr/>
            <p:nvPr/>
          </p:nvSpPr>
          <p:spPr>
            <a:xfrm>
              <a:off x="1150492" y="2815627"/>
              <a:ext cx="4324236" cy="718509"/>
            </a:xfrm>
            <a:custGeom>
              <a:avLst/>
              <a:gdLst/>
              <a:ahLst/>
              <a:cxnLst/>
              <a:rect l="0" t="0" r="0" b="0"/>
              <a:pathLst>
                <a:path w="4324236" h="718509">
                  <a:moveTo>
                    <a:pt x="0" y="718509"/>
                  </a:moveTo>
                  <a:lnTo>
                    <a:pt x="61482" y="718509"/>
                  </a:lnTo>
                  <a:lnTo>
                    <a:pt x="61482" y="718509"/>
                  </a:lnTo>
                  <a:lnTo>
                    <a:pt x="71729" y="718509"/>
                  </a:lnTo>
                  <a:lnTo>
                    <a:pt x="71729" y="718509"/>
                  </a:lnTo>
                  <a:lnTo>
                    <a:pt x="389386" y="718509"/>
                  </a:lnTo>
                  <a:lnTo>
                    <a:pt x="389386" y="718509"/>
                  </a:lnTo>
                  <a:lnTo>
                    <a:pt x="1014453" y="718509"/>
                  </a:lnTo>
                  <a:lnTo>
                    <a:pt x="1014453" y="718509"/>
                  </a:lnTo>
                  <a:lnTo>
                    <a:pt x="2100636" y="718509"/>
                  </a:lnTo>
                  <a:lnTo>
                    <a:pt x="2100636" y="359254"/>
                  </a:lnTo>
                  <a:lnTo>
                    <a:pt x="2490022" y="359254"/>
                  </a:lnTo>
                  <a:lnTo>
                    <a:pt x="2490022" y="0"/>
                  </a:lnTo>
                  <a:lnTo>
                    <a:pt x="3074101" y="0"/>
                  </a:lnTo>
                  <a:lnTo>
                    <a:pt x="3074101" y="0"/>
                  </a:lnTo>
                  <a:lnTo>
                    <a:pt x="3863120" y="0"/>
                  </a:lnTo>
                  <a:lnTo>
                    <a:pt x="3863120" y="0"/>
                  </a:lnTo>
                  <a:lnTo>
                    <a:pt x="4324236" y="0"/>
                  </a:lnTo>
                  <a:lnTo>
                    <a:pt x="4324236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75" name="pl28">
              <a:extLst>
                <a:ext uri="{FF2B5EF4-FFF2-40B4-BE49-F238E27FC236}">
                  <a16:creationId xmlns:a16="http://schemas.microsoft.com/office/drawing/2014/main" id="{5DCC0514-C263-B61B-AB01-C7368A3712E6}"/>
                </a:ext>
              </a:extLst>
            </p:cNvPr>
            <p:cNvSpPr/>
            <p:nvPr/>
          </p:nvSpPr>
          <p:spPr>
            <a:xfrm>
              <a:off x="1150492" y="3390212"/>
              <a:ext cx="7265126" cy="143925"/>
            </a:xfrm>
            <a:custGeom>
              <a:avLst/>
              <a:gdLst/>
              <a:ahLst/>
              <a:cxnLst/>
              <a:rect l="0" t="0" r="0" b="0"/>
              <a:pathLst>
                <a:path w="7265126" h="143925">
                  <a:moveTo>
                    <a:pt x="0" y="143925"/>
                  </a:moveTo>
                  <a:lnTo>
                    <a:pt x="61482" y="143925"/>
                  </a:lnTo>
                  <a:lnTo>
                    <a:pt x="61482" y="143925"/>
                  </a:lnTo>
                  <a:lnTo>
                    <a:pt x="112717" y="143925"/>
                  </a:lnTo>
                  <a:lnTo>
                    <a:pt x="112717" y="143925"/>
                  </a:lnTo>
                  <a:lnTo>
                    <a:pt x="194693" y="143925"/>
                  </a:lnTo>
                  <a:lnTo>
                    <a:pt x="194693" y="143925"/>
                  </a:lnTo>
                  <a:lnTo>
                    <a:pt x="204940" y="143925"/>
                  </a:lnTo>
                  <a:lnTo>
                    <a:pt x="204940" y="143925"/>
                  </a:lnTo>
                  <a:lnTo>
                    <a:pt x="297163" y="143925"/>
                  </a:lnTo>
                  <a:lnTo>
                    <a:pt x="297163" y="143925"/>
                  </a:lnTo>
                  <a:lnTo>
                    <a:pt x="409880" y="143925"/>
                  </a:lnTo>
                  <a:lnTo>
                    <a:pt x="409880" y="143925"/>
                  </a:lnTo>
                  <a:lnTo>
                    <a:pt x="440621" y="143925"/>
                  </a:lnTo>
                  <a:lnTo>
                    <a:pt x="440621" y="71962"/>
                  </a:lnTo>
                  <a:lnTo>
                    <a:pt x="491856" y="71962"/>
                  </a:lnTo>
                  <a:lnTo>
                    <a:pt x="491856" y="71962"/>
                  </a:lnTo>
                  <a:lnTo>
                    <a:pt x="502103" y="71962"/>
                  </a:lnTo>
                  <a:lnTo>
                    <a:pt x="502103" y="71962"/>
                  </a:lnTo>
                  <a:lnTo>
                    <a:pt x="737784" y="71962"/>
                  </a:lnTo>
                  <a:lnTo>
                    <a:pt x="737784" y="71962"/>
                  </a:lnTo>
                  <a:lnTo>
                    <a:pt x="830007" y="71962"/>
                  </a:lnTo>
                  <a:lnTo>
                    <a:pt x="830007" y="71962"/>
                  </a:lnTo>
                  <a:lnTo>
                    <a:pt x="840254" y="71962"/>
                  </a:lnTo>
                  <a:lnTo>
                    <a:pt x="840254" y="71962"/>
                  </a:lnTo>
                  <a:lnTo>
                    <a:pt x="1034947" y="71962"/>
                  </a:lnTo>
                  <a:lnTo>
                    <a:pt x="1034947" y="71962"/>
                  </a:lnTo>
                  <a:lnTo>
                    <a:pt x="1096429" y="71962"/>
                  </a:lnTo>
                  <a:lnTo>
                    <a:pt x="1096429" y="71962"/>
                  </a:lnTo>
                  <a:lnTo>
                    <a:pt x="1168158" y="71962"/>
                  </a:lnTo>
                  <a:lnTo>
                    <a:pt x="1168158" y="71962"/>
                  </a:lnTo>
                  <a:lnTo>
                    <a:pt x="1178405" y="71962"/>
                  </a:lnTo>
                  <a:lnTo>
                    <a:pt x="1178405" y="71962"/>
                  </a:lnTo>
                  <a:lnTo>
                    <a:pt x="1280875" y="71962"/>
                  </a:lnTo>
                  <a:lnTo>
                    <a:pt x="1280875" y="71962"/>
                  </a:lnTo>
                  <a:lnTo>
                    <a:pt x="1434580" y="71962"/>
                  </a:lnTo>
                  <a:lnTo>
                    <a:pt x="1434580" y="71962"/>
                  </a:lnTo>
                  <a:lnTo>
                    <a:pt x="1485815" y="71962"/>
                  </a:lnTo>
                  <a:lnTo>
                    <a:pt x="1485815" y="71962"/>
                  </a:lnTo>
                  <a:lnTo>
                    <a:pt x="1649767" y="71962"/>
                  </a:lnTo>
                  <a:lnTo>
                    <a:pt x="1649767" y="0"/>
                  </a:lnTo>
                  <a:lnTo>
                    <a:pt x="1711249" y="0"/>
                  </a:lnTo>
                  <a:lnTo>
                    <a:pt x="1711249" y="0"/>
                  </a:lnTo>
                  <a:lnTo>
                    <a:pt x="1741990" y="0"/>
                  </a:lnTo>
                  <a:lnTo>
                    <a:pt x="1741990" y="0"/>
                  </a:lnTo>
                  <a:lnTo>
                    <a:pt x="1752237" y="0"/>
                  </a:lnTo>
                  <a:lnTo>
                    <a:pt x="1752237" y="0"/>
                  </a:lnTo>
                  <a:lnTo>
                    <a:pt x="1905942" y="0"/>
                  </a:lnTo>
                  <a:lnTo>
                    <a:pt x="1905942" y="0"/>
                  </a:lnTo>
                  <a:lnTo>
                    <a:pt x="1957177" y="0"/>
                  </a:lnTo>
                  <a:lnTo>
                    <a:pt x="1957177" y="0"/>
                  </a:lnTo>
                  <a:lnTo>
                    <a:pt x="2356811" y="0"/>
                  </a:lnTo>
                  <a:lnTo>
                    <a:pt x="2356811" y="0"/>
                  </a:lnTo>
                  <a:lnTo>
                    <a:pt x="2571998" y="0"/>
                  </a:lnTo>
                  <a:lnTo>
                    <a:pt x="2571998" y="0"/>
                  </a:lnTo>
                  <a:lnTo>
                    <a:pt x="2705209" y="0"/>
                  </a:lnTo>
                  <a:lnTo>
                    <a:pt x="2705209" y="0"/>
                  </a:lnTo>
                  <a:lnTo>
                    <a:pt x="2735950" y="0"/>
                  </a:lnTo>
                  <a:lnTo>
                    <a:pt x="2735950" y="0"/>
                  </a:lnTo>
                  <a:lnTo>
                    <a:pt x="2787185" y="0"/>
                  </a:lnTo>
                  <a:lnTo>
                    <a:pt x="2787185" y="0"/>
                  </a:lnTo>
                  <a:lnTo>
                    <a:pt x="3340523" y="0"/>
                  </a:lnTo>
                  <a:lnTo>
                    <a:pt x="3340523" y="0"/>
                  </a:lnTo>
                  <a:lnTo>
                    <a:pt x="3842626" y="0"/>
                  </a:lnTo>
                  <a:lnTo>
                    <a:pt x="3842626" y="0"/>
                  </a:lnTo>
                  <a:lnTo>
                    <a:pt x="3863120" y="0"/>
                  </a:lnTo>
                  <a:lnTo>
                    <a:pt x="3863120" y="0"/>
                  </a:lnTo>
                  <a:lnTo>
                    <a:pt x="4590658" y="0"/>
                  </a:lnTo>
                  <a:lnTo>
                    <a:pt x="4590658" y="0"/>
                  </a:lnTo>
                  <a:lnTo>
                    <a:pt x="5092761" y="0"/>
                  </a:lnTo>
                  <a:lnTo>
                    <a:pt x="5092761" y="0"/>
                  </a:lnTo>
                  <a:lnTo>
                    <a:pt x="5512888" y="0"/>
                  </a:lnTo>
                  <a:lnTo>
                    <a:pt x="5512888" y="0"/>
                  </a:lnTo>
                  <a:lnTo>
                    <a:pt x="6045733" y="0"/>
                  </a:lnTo>
                  <a:lnTo>
                    <a:pt x="6045733" y="0"/>
                  </a:lnTo>
                  <a:lnTo>
                    <a:pt x="6527342" y="0"/>
                  </a:lnTo>
                  <a:lnTo>
                    <a:pt x="6527342" y="0"/>
                  </a:lnTo>
                  <a:lnTo>
                    <a:pt x="7008951" y="0"/>
                  </a:lnTo>
                  <a:lnTo>
                    <a:pt x="7008951" y="0"/>
                  </a:lnTo>
                  <a:lnTo>
                    <a:pt x="7049939" y="0"/>
                  </a:lnTo>
                  <a:lnTo>
                    <a:pt x="7049939" y="0"/>
                  </a:lnTo>
                  <a:lnTo>
                    <a:pt x="7265126" y="0"/>
                  </a:lnTo>
                  <a:lnTo>
                    <a:pt x="7265126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76" name="rc29">
              <a:extLst>
                <a:ext uri="{FF2B5EF4-FFF2-40B4-BE49-F238E27FC236}">
                  <a16:creationId xmlns:a16="http://schemas.microsoft.com/office/drawing/2014/main" id="{D32F110A-4B3F-114B-5AFC-B64FA796BBCB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77" name="tx30">
              <a:extLst>
                <a:ext uri="{FF2B5EF4-FFF2-40B4-BE49-F238E27FC236}">
                  <a16:creationId xmlns:a16="http://schemas.microsoft.com/office/drawing/2014/main" id="{B080257D-21EC-AE86-17DC-078645D3C381}"/>
                </a:ext>
              </a:extLst>
            </p:cNvPr>
            <p:cNvSpPr/>
            <p:nvPr/>
          </p:nvSpPr>
          <p:spPr>
            <a:xfrm>
              <a:off x="466667" y="3486760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978" name="tx31">
              <a:extLst>
                <a:ext uri="{FF2B5EF4-FFF2-40B4-BE49-F238E27FC236}">
                  <a16:creationId xmlns:a16="http://schemas.microsoft.com/office/drawing/2014/main" id="{20AE6FC2-5C2B-89F0-7F2F-F0667516244F}"/>
                </a:ext>
              </a:extLst>
            </p:cNvPr>
            <p:cNvSpPr/>
            <p:nvPr/>
          </p:nvSpPr>
          <p:spPr>
            <a:xfrm>
              <a:off x="466667" y="2678436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979" name="tx32">
              <a:extLst>
                <a:ext uri="{FF2B5EF4-FFF2-40B4-BE49-F238E27FC236}">
                  <a16:creationId xmlns:a16="http://schemas.microsoft.com/office/drawing/2014/main" id="{059F39D4-7881-5B04-E7DF-7F0E2613E0A3}"/>
                </a:ext>
              </a:extLst>
            </p:cNvPr>
            <p:cNvSpPr/>
            <p:nvPr/>
          </p:nvSpPr>
          <p:spPr>
            <a:xfrm>
              <a:off x="466667" y="1870113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980" name="tx33">
              <a:extLst>
                <a:ext uri="{FF2B5EF4-FFF2-40B4-BE49-F238E27FC236}">
                  <a16:creationId xmlns:a16="http://schemas.microsoft.com/office/drawing/2014/main" id="{D8AC5B09-7BC9-F583-7DA3-588CCBD86F82}"/>
                </a:ext>
              </a:extLst>
            </p:cNvPr>
            <p:cNvSpPr/>
            <p:nvPr/>
          </p:nvSpPr>
          <p:spPr>
            <a:xfrm>
              <a:off x="466667" y="1061789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981" name="tx34">
              <a:extLst>
                <a:ext uri="{FF2B5EF4-FFF2-40B4-BE49-F238E27FC236}">
                  <a16:creationId xmlns:a16="http://schemas.microsoft.com/office/drawing/2014/main" id="{B27DD044-3308-0D2C-5C61-BD5ABCCA1EF1}"/>
                </a:ext>
              </a:extLst>
            </p:cNvPr>
            <p:cNvSpPr/>
            <p:nvPr/>
          </p:nvSpPr>
          <p:spPr>
            <a:xfrm>
              <a:off x="466667" y="253465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0</a:t>
              </a:r>
            </a:p>
          </p:txBody>
        </p:sp>
        <p:sp>
          <p:nvSpPr>
            <p:cNvPr id="982" name="pl35">
              <a:extLst>
                <a:ext uri="{FF2B5EF4-FFF2-40B4-BE49-F238E27FC236}">
                  <a16:creationId xmlns:a16="http://schemas.microsoft.com/office/drawing/2014/main" id="{60458690-FA91-D0F7-3F79-715251C1FB99}"/>
                </a:ext>
              </a:extLst>
            </p:cNvPr>
            <p:cNvSpPr/>
            <p:nvPr/>
          </p:nvSpPr>
          <p:spPr>
            <a:xfrm>
              <a:off x="741682" y="353413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83" name="pl36">
              <a:extLst>
                <a:ext uri="{FF2B5EF4-FFF2-40B4-BE49-F238E27FC236}">
                  <a16:creationId xmlns:a16="http://schemas.microsoft.com/office/drawing/2014/main" id="{E11BB13B-9F22-5E08-0E87-657FA2BB3FFD}"/>
                </a:ext>
              </a:extLst>
            </p:cNvPr>
            <p:cNvSpPr/>
            <p:nvPr/>
          </p:nvSpPr>
          <p:spPr>
            <a:xfrm>
              <a:off x="741682" y="2725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84" name="pl37">
              <a:extLst>
                <a:ext uri="{FF2B5EF4-FFF2-40B4-BE49-F238E27FC236}">
                  <a16:creationId xmlns:a16="http://schemas.microsoft.com/office/drawing/2014/main" id="{249E8AB2-E1B7-8402-6D23-F23726F3D53A}"/>
                </a:ext>
              </a:extLst>
            </p:cNvPr>
            <p:cNvSpPr/>
            <p:nvPr/>
          </p:nvSpPr>
          <p:spPr>
            <a:xfrm>
              <a:off x="741682" y="19174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85" name="pl38">
              <a:extLst>
                <a:ext uri="{FF2B5EF4-FFF2-40B4-BE49-F238E27FC236}">
                  <a16:creationId xmlns:a16="http://schemas.microsoft.com/office/drawing/2014/main" id="{E2D7A845-B68A-E18D-11E6-93736D40B527}"/>
                </a:ext>
              </a:extLst>
            </p:cNvPr>
            <p:cNvSpPr/>
            <p:nvPr/>
          </p:nvSpPr>
          <p:spPr>
            <a:xfrm>
              <a:off x="741682" y="11091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86" name="pl39">
              <a:extLst>
                <a:ext uri="{FF2B5EF4-FFF2-40B4-BE49-F238E27FC236}">
                  <a16:creationId xmlns:a16="http://schemas.microsoft.com/office/drawing/2014/main" id="{ED499F8F-EEA4-4657-E46D-3B3A2E6ECCE0}"/>
                </a:ext>
              </a:extLst>
            </p:cNvPr>
            <p:cNvSpPr/>
            <p:nvPr/>
          </p:nvSpPr>
          <p:spPr>
            <a:xfrm>
              <a:off x="741682" y="3008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87" name="pl40">
              <a:extLst>
                <a:ext uri="{FF2B5EF4-FFF2-40B4-BE49-F238E27FC236}">
                  <a16:creationId xmlns:a16="http://schemas.microsoft.com/office/drawing/2014/main" id="{88F79DFD-C8F2-2869-04ED-6E270BA6DD91}"/>
                </a:ext>
              </a:extLst>
            </p:cNvPr>
            <p:cNvSpPr/>
            <p:nvPr/>
          </p:nvSpPr>
          <p:spPr>
            <a:xfrm>
              <a:off x="1150492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88" name="pl41">
              <a:extLst>
                <a:ext uri="{FF2B5EF4-FFF2-40B4-BE49-F238E27FC236}">
                  <a16:creationId xmlns:a16="http://schemas.microsoft.com/office/drawing/2014/main" id="{1C4DEB93-6C45-0473-53EC-FD5CC96FCBD5}"/>
                </a:ext>
              </a:extLst>
            </p:cNvPr>
            <p:cNvSpPr/>
            <p:nvPr/>
          </p:nvSpPr>
          <p:spPr>
            <a:xfrm>
              <a:off x="3199893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89" name="pl42">
              <a:extLst>
                <a:ext uri="{FF2B5EF4-FFF2-40B4-BE49-F238E27FC236}">
                  <a16:creationId xmlns:a16="http://schemas.microsoft.com/office/drawing/2014/main" id="{9BF2A25A-8BA9-EBEC-E837-9AC4A6873A24}"/>
                </a:ext>
              </a:extLst>
            </p:cNvPr>
            <p:cNvSpPr/>
            <p:nvPr/>
          </p:nvSpPr>
          <p:spPr>
            <a:xfrm>
              <a:off x="5249294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90" name="pl43">
              <a:extLst>
                <a:ext uri="{FF2B5EF4-FFF2-40B4-BE49-F238E27FC236}">
                  <a16:creationId xmlns:a16="http://schemas.microsoft.com/office/drawing/2014/main" id="{9B22F6A7-40B7-CD44-FE19-DD71A45CC49A}"/>
                </a:ext>
              </a:extLst>
            </p:cNvPr>
            <p:cNvSpPr/>
            <p:nvPr/>
          </p:nvSpPr>
          <p:spPr>
            <a:xfrm>
              <a:off x="7298695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991" name="tx44">
              <a:extLst>
                <a:ext uri="{FF2B5EF4-FFF2-40B4-BE49-F238E27FC236}">
                  <a16:creationId xmlns:a16="http://schemas.microsoft.com/office/drawing/2014/main" id="{30115CA4-5B9F-D41C-85DE-065CDB665623}"/>
                </a:ext>
              </a:extLst>
            </p:cNvPr>
            <p:cNvSpPr/>
            <p:nvPr/>
          </p:nvSpPr>
          <p:spPr>
            <a:xfrm>
              <a:off x="1115176" y="3756509"/>
              <a:ext cx="70631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992" name="tx45">
              <a:extLst>
                <a:ext uri="{FF2B5EF4-FFF2-40B4-BE49-F238E27FC236}">
                  <a16:creationId xmlns:a16="http://schemas.microsoft.com/office/drawing/2014/main" id="{751BB2AA-50F8-0D7A-24B5-FE9AABD606C2}"/>
                </a:ext>
              </a:extLst>
            </p:cNvPr>
            <p:cNvSpPr/>
            <p:nvPr/>
          </p:nvSpPr>
          <p:spPr>
            <a:xfrm>
              <a:off x="3093946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993" name="tx46">
              <a:extLst>
                <a:ext uri="{FF2B5EF4-FFF2-40B4-BE49-F238E27FC236}">
                  <a16:creationId xmlns:a16="http://schemas.microsoft.com/office/drawing/2014/main" id="{DCE49B59-6464-7625-E40E-2CEA5CAB0C63}"/>
                </a:ext>
              </a:extLst>
            </p:cNvPr>
            <p:cNvSpPr/>
            <p:nvPr/>
          </p:nvSpPr>
          <p:spPr>
            <a:xfrm>
              <a:off x="5143347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994" name="tx47">
              <a:extLst>
                <a:ext uri="{FF2B5EF4-FFF2-40B4-BE49-F238E27FC236}">
                  <a16:creationId xmlns:a16="http://schemas.microsoft.com/office/drawing/2014/main" id="{BF94E377-9DEB-FC56-2D04-2CECA6CEF088}"/>
                </a:ext>
              </a:extLst>
            </p:cNvPr>
            <p:cNvSpPr/>
            <p:nvPr/>
          </p:nvSpPr>
          <p:spPr>
            <a:xfrm>
              <a:off x="7192748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995" name="tx48">
              <a:extLst>
                <a:ext uri="{FF2B5EF4-FFF2-40B4-BE49-F238E27FC236}">
                  <a16:creationId xmlns:a16="http://schemas.microsoft.com/office/drawing/2014/main" id="{32526538-08F5-3FDB-445D-994954483851}"/>
                </a:ext>
              </a:extLst>
            </p:cNvPr>
            <p:cNvSpPr/>
            <p:nvPr/>
          </p:nvSpPr>
          <p:spPr>
            <a:xfrm>
              <a:off x="3607639" y="3878778"/>
              <a:ext cx="2566020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 to Liver-Related Mortality (Days)</a:t>
              </a:r>
            </a:p>
          </p:txBody>
        </p:sp>
        <p:sp>
          <p:nvSpPr>
            <p:cNvPr id="996" name="tx49">
              <a:extLst>
                <a:ext uri="{FF2B5EF4-FFF2-40B4-BE49-F238E27FC236}">
                  <a16:creationId xmlns:a16="http://schemas.microsoft.com/office/drawing/2014/main" id="{D8A4AD9D-C685-8BE8-E1CB-D95425F8213E}"/>
                </a:ext>
              </a:extLst>
            </p:cNvPr>
            <p:cNvSpPr/>
            <p:nvPr/>
          </p:nvSpPr>
          <p:spPr>
            <a:xfrm rot="16200000">
              <a:off x="-1437197" y="2168297"/>
              <a:ext cx="3472681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umulative Incidence of Liver-Related Mortality (%)</a:t>
              </a:r>
            </a:p>
          </p:txBody>
        </p:sp>
        <p:sp>
          <p:nvSpPr>
            <p:cNvPr id="997" name="rc50">
              <a:extLst>
                <a:ext uri="{FF2B5EF4-FFF2-40B4-BE49-F238E27FC236}">
                  <a16:creationId xmlns:a16="http://schemas.microsoft.com/office/drawing/2014/main" id="{81AA0C0B-AE12-7337-FCB5-5249B83EE532}"/>
                </a:ext>
              </a:extLst>
            </p:cNvPr>
            <p:cNvSpPr/>
            <p:nvPr/>
          </p:nvSpPr>
          <p:spPr>
            <a:xfrm>
              <a:off x="4276688" y="4189554"/>
              <a:ext cx="1227921" cy="358634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998" name="rc51">
              <a:extLst>
                <a:ext uri="{FF2B5EF4-FFF2-40B4-BE49-F238E27FC236}">
                  <a16:creationId xmlns:a16="http://schemas.microsoft.com/office/drawing/2014/main" id="{E4E3B46E-A4E1-0598-7C2A-2E2C87F734E6}"/>
                </a:ext>
              </a:extLst>
            </p:cNvPr>
            <p:cNvSpPr/>
            <p:nvPr/>
          </p:nvSpPr>
          <p:spPr>
            <a:xfrm>
              <a:off x="4415866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999" name="pl52">
              <a:extLst>
                <a:ext uri="{FF2B5EF4-FFF2-40B4-BE49-F238E27FC236}">
                  <a16:creationId xmlns:a16="http://schemas.microsoft.com/office/drawing/2014/main" id="{4E78008B-7BCA-B506-1562-B59CD71F52E1}"/>
                </a:ext>
              </a:extLst>
            </p:cNvPr>
            <p:cNvSpPr/>
            <p:nvPr/>
          </p:nvSpPr>
          <p:spPr>
            <a:xfrm>
              <a:off x="4437812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1000" name="rc53">
              <a:extLst>
                <a:ext uri="{FF2B5EF4-FFF2-40B4-BE49-F238E27FC236}">
                  <a16:creationId xmlns:a16="http://schemas.microsoft.com/office/drawing/2014/main" id="{E4B9E0EB-2CB4-755A-7795-AD206F845FAA}"/>
                </a:ext>
              </a:extLst>
            </p:cNvPr>
            <p:cNvSpPr/>
            <p:nvPr/>
          </p:nvSpPr>
          <p:spPr>
            <a:xfrm>
              <a:off x="4926900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1001" name="pl54">
              <a:extLst>
                <a:ext uri="{FF2B5EF4-FFF2-40B4-BE49-F238E27FC236}">
                  <a16:creationId xmlns:a16="http://schemas.microsoft.com/office/drawing/2014/main" id="{D7EF102F-8C29-608A-B9FD-5A0A6D18224C}"/>
                </a:ext>
              </a:extLst>
            </p:cNvPr>
            <p:cNvSpPr/>
            <p:nvPr/>
          </p:nvSpPr>
          <p:spPr>
            <a:xfrm>
              <a:off x="4948846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1002" name="tx55">
              <a:extLst>
                <a:ext uri="{FF2B5EF4-FFF2-40B4-BE49-F238E27FC236}">
                  <a16:creationId xmlns:a16="http://schemas.microsoft.com/office/drawing/2014/main" id="{18D10AE8-CC02-5BA0-83C5-2E35B040B262}"/>
                </a:ext>
              </a:extLst>
            </p:cNvPr>
            <p:cNvSpPr/>
            <p:nvPr/>
          </p:nvSpPr>
          <p:spPr>
            <a:xfrm>
              <a:off x="4704911" y="4321929"/>
              <a:ext cx="162346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1003" name="tx56">
              <a:extLst>
                <a:ext uri="{FF2B5EF4-FFF2-40B4-BE49-F238E27FC236}">
                  <a16:creationId xmlns:a16="http://schemas.microsoft.com/office/drawing/2014/main" id="{DCF33969-5B5A-61BC-ECA9-F0C7F18B0EBF}"/>
                </a:ext>
              </a:extLst>
            </p:cNvPr>
            <p:cNvSpPr/>
            <p:nvPr/>
          </p:nvSpPr>
          <p:spPr>
            <a:xfrm>
              <a:off x="5215945" y="4321929"/>
              <a:ext cx="218839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  <p:sp>
          <p:nvSpPr>
            <p:cNvPr id="1004" name="rc57">
              <a:extLst>
                <a:ext uri="{FF2B5EF4-FFF2-40B4-BE49-F238E27FC236}">
                  <a16:creationId xmlns:a16="http://schemas.microsoft.com/office/drawing/2014/main" id="{23789F7F-C0CD-7919-94DF-B284EE3331E3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1005" name="rc58">
              <a:extLst>
                <a:ext uri="{FF2B5EF4-FFF2-40B4-BE49-F238E27FC236}">
                  <a16:creationId xmlns:a16="http://schemas.microsoft.com/office/drawing/2014/main" id="{C5313F71-23D6-A870-CBDA-0F854EF6C1DA}"/>
                </a:ext>
              </a:extLst>
            </p:cNvPr>
            <p:cNvSpPr/>
            <p:nvPr/>
          </p:nvSpPr>
          <p:spPr>
            <a:xfrm>
              <a:off x="776476" y="4996549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1006" name="tx59">
              <a:extLst>
                <a:ext uri="{FF2B5EF4-FFF2-40B4-BE49-F238E27FC236}">
                  <a16:creationId xmlns:a16="http://schemas.microsoft.com/office/drawing/2014/main" id="{DA0AEE73-18C7-80EE-7EF5-D416F637627F}"/>
                </a:ext>
              </a:extLst>
            </p:cNvPr>
            <p:cNvSpPr/>
            <p:nvPr/>
          </p:nvSpPr>
          <p:spPr>
            <a:xfrm>
              <a:off x="1115323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007" name="tx60">
              <a:extLst>
                <a:ext uri="{FF2B5EF4-FFF2-40B4-BE49-F238E27FC236}">
                  <a16:creationId xmlns:a16="http://schemas.microsoft.com/office/drawing/2014/main" id="{0C0B34CD-B7D9-9EB4-5B19-0CE31ADECFD4}"/>
                </a:ext>
              </a:extLst>
            </p:cNvPr>
            <p:cNvSpPr/>
            <p:nvPr/>
          </p:nvSpPr>
          <p:spPr>
            <a:xfrm>
              <a:off x="1115323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</a:t>
              </a:r>
            </a:p>
          </p:txBody>
        </p:sp>
        <p:sp>
          <p:nvSpPr>
            <p:cNvPr id="1008" name="tx61">
              <a:extLst>
                <a:ext uri="{FF2B5EF4-FFF2-40B4-BE49-F238E27FC236}">
                  <a16:creationId xmlns:a16="http://schemas.microsoft.com/office/drawing/2014/main" id="{7974A29B-8B2E-7ED4-F7E6-93AA300E3896}"/>
                </a:ext>
              </a:extLst>
            </p:cNvPr>
            <p:cNvSpPr/>
            <p:nvPr/>
          </p:nvSpPr>
          <p:spPr>
            <a:xfrm>
              <a:off x="3164724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009" name="tx62">
              <a:extLst>
                <a:ext uri="{FF2B5EF4-FFF2-40B4-BE49-F238E27FC236}">
                  <a16:creationId xmlns:a16="http://schemas.microsoft.com/office/drawing/2014/main" id="{B6F954FE-D694-E3A4-11E5-2B4C5806A419}"/>
                </a:ext>
              </a:extLst>
            </p:cNvPr>
            <p:cNvSpPr/>
            <p:nvPr/>
          </p:nvSpPr>
          <p:spPr>
            <a:xfrm>
              <a:off x="3164724" y="5134179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1010" name="tx63">
              <a:extLst>
                <a:ext uri="{FF2B5EF4-FFF2-40B4-BE49-F238E27FC236}">
                  <a16:creationId xmlns:a16="http://schemas.microsoft.com/office/drawing/2014/main" id="{2DC8A844-8AEB-FF54-0989-565E0A3472D4}"/>
                </a:ext>
              </a:extLst>
            </p:cNvPr>
            <p:cNvSpPr/>
            <p:nvPr/>
          </p:nvSpPr>
          <p:spPr>
            <a:xfrm>
              <a:off x="5214125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011" name="tx64">
              <a:extLst>
                <a:ext uri="{FF2B5EF4-FFF2-40B4-BE49-F238E27FC236}">
                  <a16:creationId xmlns:a16="http://schemas.microsoft.com/office/drawing/2014/main" id="{27AC0602-0376-5D70-6AA7-48910F142679}"/>
                </a:ext>
              </a:extLst>
            </p:cNvPr>
            <p:cNvSpPr/>
            <p:nvPr/>
          </p:nvSpPr>
          <p:spPr>
            <a:xfrm>
              <a:off x="5214125" y="5134117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1012" name="tx65">
              <a:extLst>
                <a:ext uri="{FF2B5EF4-FFF2-40B4-BE49-F238E27FC236}">
                  <a16:creationId xmlns:a16="http://schemas.microsoft.com/office/drawing/2014/main" id="{F9FBB79F-36CF-EF2C-DCD6-8E95CB46D07C}"/>
                </a:ext>
              </a:extLst>
            </p:cNvPr>
            <p:cNvSpPr/>
            <p:nvPr/>
          </p:nvSpPr>
          <p:spPr>
            <a:xfrm>
              <a:off x="7263526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013" name="tx66">
              <a:extLst>
                <a:ext uri="{FF2B5EF4-FFF2-40B4-BE49-F238E27FC236}">
                  <a16:creationId xmlns:a16="http://schemas.microsoft.com/office/drawing/2014/main" id="{3C7CFCF6-B426-A74C-311C-A4AED3A0B0BD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014" name="tx67">
              <a:extLst>
                <a:ext uri="{FF2B5EF4-FFF2-40B4-BE49-F238E27FC236}">
                  <a16:creationId xmlns:a16="http://schemas.microsoft.com/office/drawing/2014/main" id="{CDD2FA4F-BA0C-E14A-1072-6B8628644225}"/>
                </a:ext>
              </a:extLst>
            </p:cNvPr>
            <p:cNvSpPr/>
            <p:nvPr/>
          </p:nvSpPr>
          <p:spPr>
            <a:xfrm>
              <a:off x="7263526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015" name="tx68">
              <a:extLst>
                <a:ext uri="{FF2B5EF4-FFF2-40B4-BE49-F238E27FC236}">
                  <a16:creationId xmlns:a16="http://schemas.microsoft.com/office/drawing/2014/main" id="{64699C03-9E76-8914-9C4A-5CE202941B92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016" name="tx69">
              <a:extLst>
                <a:ext uri="{FF2B5EF4-FFF2-40B4-BE49-F238E27FC236}">
                  <a16:creationId xmlns:a16="http://schemas.microsoft.com/office/drawing/2014/main" id="{359EF84F-10B6-E3F3-6BD7-08C236A40830}"/>
                </a:ext>
              </a:extLst>
            </p:cNvPr>
            <p:cNvSpPr/>
            <p:nvPr/>
          </p:nvSpPr>
          <p:spPr>
            <a:xfrm>
              <a:off x="325591" y="5438152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1017" name="tx70">
              <a:extLst>
                <a:ext uri="{FF2B5EF4-FFF2-40B4-BE49-F238E27FC236}">
                  <a16:creationId xmlns:a16="http://schemas.microsoft.com/office/drawing/2014/main" id="{C0BD6D2E-E2D4-1CE7-A70D-D2306FD482AF}"/>
                </a:ext>
              </a:extLst>
            </p:cNvPr>
            <p:cNvSpPr/>
            <p:nvPr/>
          </p:nvSpPr>
          <p:spPr>
            <a:xfrm>
              <a:off x="311638" y="5132811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1018" name="tx71">
              <a:extLst>
                <a:ext uri="{FF2B5EF4-FFF2-40B4-BE49-F238E27FC236}">
                  <a16:creationId xmlns:a16="http://schemas.microsoft.com/office/drawing/2014/main" id="{0199A920-8AF8-BC83-C30B-DA079A2818D8}"/>
                </a:ext>
              </a:extLst>
            </p:cNvPr>
            <p:cNvSpPr/>
            <p:nvPr/>
          </p:nvSpPr>
          <p:spPr>
            <a:xfrm>
              <a:off x="776476" y="4827633"/>
              <a:ext cx="17452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1019" name="rc72">
              <a:extLst>
                <a:ext uri="{FF2B5EF4-FFF2-40B4-BE49-F238E27FC236}">
                  <a16:creationId xmlns:a16="http://schemas.microsoft.com/office/drawing/2014/main" id="{22EE1193-BBBC-DE29-B860-BA290B169A36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1020" name="rc73">
              <a:extLst>
                <a:ext uri="{FF2B5EF4-FFF2-40B4-BE49-F238E27FC236}">
                  <a16:creationId xmlns:a16="http://schemas.microsoft.com/office/drawing/2014/main" id="{8ADDAFA4-79C7-E887-9529-3400BA31F247}"/>
                </a:ext>
              </a:extLst>
            </p:cNvPr>
            <p:cNvSpPr/>
            <p:nvPr/>
          </p:nvSpPr>
          <p:spPr>
            <a:xfrm>
              <a:off x="776476" y="6081865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1021" name="tx74">
              <a:extLst>
                <a:ext uri="{FF2B5EF4-FFF2-40B4-BE49-F238E27FC236}">
                  <a16:creationId xmlns:a16="http://schemas.microsoft.com/office/drawing/2014/main" id="{339B9003-D9AA-6BDF-CE05-7F08A84A354B}"/>
                </a:ext>
              </a:extLst>
            </p:cNvPr>
            <p:cNvSpPr/>
            <p:nvPr/>
          </p:nvSpPr>
          <p:spPr>
            <a:xfrm>
              <a:off x="1115323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022" name="tx75">
              <a:extLst>
                <a:ext uri="{FF2B5EF4-FFF2-40B4-BE49-F238E27FC236}">
                  <a16:creationId xmlns:a16="http://schemas.microsoft.com/office/drawing/2014/main" id="{148921DD-6152-BFDE-21D6-45B5536B4E73}"/>
                </a:ext>
              </a:extLst>
            </p:cNvPr>
            <p:cNvSpPr/>
            <p:nvPr/>
          </p:nvSpPr>
          <p:spPr>
            <a:xfrm>
              <a:off x="1080154" y="6217890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6</a:t>
              </a:r>
            </a:p>
          </p:txBody>
        </p:sp>
        <p:sp>
          <p:nvSpPr>
            <p:cNvPr id="1023" name="tx76">
              <a:extLst>
                <a:ext uri="{FF2B5EF4-FFF2-40B4-BE49-F238E27FC236}">
                  <a16:creationId xmlns:a16="http://schemas.microsoft.com/office/drawing/2014/main" id="{9B0477F1-82E1-35B9-F6CC-9C948A1A60A6}"/>
                </a:ext>
              </a:extLst>
            </p:cNvPr>
            <p:cNvSpPr/>
            <p:nvPr/>
          </p:nvSpPr>
          <p:spPr>
            <a:xfrm>
              <a:off x="3164724" y="6524775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024" name="tx77">
              <a:extLst>
                <a:ext uri="{FF2B5EF4-FFF2-40B4-BE49-F238E27FC236}">
                  <a16:creationId xmlns:a16="http://schemas.microsoft.com/office/drawing/2014/main" id="{672AA5FD-566E-135A-503E-E1E228ECA7E6}"/>
                </a:ext>
              </a:extLst>
            </p:cNvPr>
            <p:cNvSpPr/>
            <p:nvPr/>
          </p:nvSpPr>
          <p:spPr>
            <a:xfrm>
              <a:off x="3129555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1</a:t>
              </a:r>
            </a:p>
          </p:txBody>
        </p:sp>
        <p:sp>
          <p:nvSpPr>
            <p:cNvPr id="1025" name="tx78">
              <a:extLst>
                <a:ext uri="{FF2B5EF4-FFF2-40B4-BE49-F238E27FC236}">
                  <a16:creationId xmlns:a16="http://schemas.microsoft.com/office/drawing/2014/main" id="{EF1E4CCB-F0F6-9F43-77CD-FF8598D8C41D}"/>
                </a:ext>
              </a:extLst>
            </p:cNvPr>
            <p:cNvSpPr/>
            <p:nvPr/>
          </p:nvSpPr>
          <p:spPr>
            <a:xfrm>
              <a:off x="5214125" y="6524775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026" name="tx79">
              <a:extLst>
                <a:ext uri="{FF2B5EF4-FFF2-40B4-BE49-F238E27FC236}">
                  <a16:creationId xmlns:a16="http://schemas.microsoft.com/office/drawing/2014/main" id="{882A119E-8FAE-A55A-DF97-988F6BDF49F6}"/>
                </a:ext>
              </a:extLst>
            </p:cNvPr>
            <p:cNvSpPr/>
            <p:nvPr/>
          </p:nvSpPr>
          <p:spPr>
            <a:xfrm>
              <a:off x="5178956" y="6217828"/>
              <a:ext cx="140675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3</a:t>
              </a:r>
            </a:p>
          </p:txBody>
        </p:sp>
        <p:sp>
          <p:nvSpPr>
            <p:cNvPr id="1027" name="tx80">
              <a:extLst>
                <a:ext uri="{FF2B5EF4-FFF2-40B4-BE49-F238E27FC236}">
                  <a16:creationId xmlns:a16="http://schemas.microsoft.com/office/drawing/2014/main" id="{16242548-4E88-675C-9C00-D2404E366642}"/>
                </a:ext>
              </a:extLst>
            </p:cNvPr>
            <p:cNvSpPr/>
            <p:nvPr/>
          </p:nvSpPr>
          <p:spPr>
            <a:xfrm>
              <a:off x="7263526" y="6524775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028" name="tx81">
              <a:extLst>
                <a:ext uri="{FF2B5EF4-FFF2-40B4-BE49-F238E27FC236}">
                  <a16:creationId xmlns:a16="http://schemas.microsoft.com/office/drawing/2014/main" id="{64569769-C0A6-AEB4-FAC9-7C5994D0F957}"/>
                </a:ext>
              </a:extLst>
            </p:cNvPr>
            <p:cNvSpPr/>
            <p:nvPr/>
          </p:nvSpPr>
          <p:spPr>
            <a:xfrm>
              <a:off x="7263526" y="6217890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</a:t>
              </a:r>
            </a:p>
          </p:txBody>
        </p:sp>
        <p:sp>
          <p:nvSpPr>
            <p:cNvPr id="1029" name="tx82">
              <a:extLst>
                <a:ext uri="{FF2B5EF4-FFF2-40B4-BE49-F238E27FC236}">
                  <a16:creationId xmlns:a16="http://schemas.microsoft.com/office/drawing/2014/main" id="{BEF2DE30-1EBA-4F3D-9A97-83F398170786}"/>
                </a:ext>
              </a:extLst>
            </p:cNvPr>
            <p:cNvSpPr/>
            <p:nvPr/>
          </p:nvSpPr>
          <p:spPr>
            <a:xfrm>
              <a:off x="325591" y="6523468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1030" name="tx83">
              <a:extLst>
                <a:ext uri="{FF2B5EF4-FFF2-40B4-BE49-F238E27FC236}">
                  <a16:creationId xmlns:a16="http://schemas.microsoft.com/office/drawing/2014/main" id="{08BE8133-868F-84DB-86DA-273B8FE92FE8}"/>
                </a:ext>
              </a:extLst>
            </p:cNvPr>
            <p:cNvSpPr/>
            <p:nvPr/>
          </p:nvSpPr>
          <p:spPr>
            <a:xfrm>
              <a:off x="311638" y="6218127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1031" name="tx84">
              <a:extLst>
                <a:ext uri="{FF2B5EF4-FFF2-40B4-BE49-F238E27FC236}">
                  <a16:creationId xmlns:a16="http://schemas.microsoft.com/office/drawing/2014/main" id="{D12019DC-7769-C636-2D92-50C910AB82B5}"/>
                </a:ext>
              </a:extLst>
            </p:cNvPr>
            <p:cNvSpPr/>
            <p:nvPr/>
          </p:nvSpPr>
          <p:spPr>
            <a:xfrm>
              <a:off x="776476" y="5912949"/>
              <a:ext cx="23525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</p:grpSp>
      <p:sp>
        <p:nvSpPr>
          <p:cNvPr id="1032" name="TextBox 1031">
            <a:extLst>
              <a:ext uri="{FF2B5EF4-FFF2-40B4-BE49-F238E27FC236}">
                <a16:creationId xmlns:a16="http://schemas.microsoft.com/office/drawing/2014/main" id="{60C50383-DCDA-AFF3-43C1-99EDD2ABCFD0}"/>
              </a:ext>
            </a:extLst>
          </p:cNvPr>
          <p:cNvSpPr txBox="1"/>
          <p:nvPr/>
        </p:nvSpPr>
        <p:spPr>
          <a:xfrm>
            <a:off x="5346112" y="9290675"/>
            <a:ext cx="3125335" cy="6519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9" b="1" dirty="0">
                <a:latin typeface="Arial" panose="020B0604020202020204" pitchFamily="34" charset="0"/>
                <a:cs typeface="Arial" panose="020B0604020202020204" pitchFamily="34" charset="0"/>
              </a:rPr>
              <a:t>Potential Living Donor  Total   Event   HR (95% CI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No                                     9           2         Reference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Yes                                   46          2       0.20 (0.03 – 1.32)</a:t>
            </a:r>
          </a:p>
          <a:p>
            <a:r>
              <a:rPr lang="en-US" sz="909" dirty="0">
                <a:latin typeface="Arial" panose="020B0604020202020204" pitchFamily="34" charset="0"/>
                <a:cs typeface="Arial" panose="020B0604020202020204" pitchFamily="34" charset="0"/>
              </a:rPr>
              <a:t>Gray K-Sample Test P-value: 0.847    </a:t>
            </a:r>
          </a:p>
        </p:txBody>
      </p:sp>
      <p:sp>
        <p:nvSpPr>
          <p:cNvPr id="1033" name="pl48">
            <a:extLst>
              <a:ext uri="{FF2B5EF4-FFF2-40B4-BE49-F238E27FC236}">
                <a16:creationId xmlns:a16="http://schemas.microsoft.com/office/drawing/2014/main" id="{31A842D5-6F08-9DE7-AA63-0E0C04AC9BD7}"/>
              </a:ext>
            </a:extLst>
          </p:cNvPr>
          <p:cNvSpPr/>
          <p:nvPr/>
        </p:nvSpPr>
        <p:spPr>
          <a:xfrm>
            <a:off x="5231259" y="9521008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1034" name="pl50">
            <a:extLst>
              <a:ext uri="{FF2B5EF4-FFF2-40B4-BE49-F238E27FC236}">
                <a16:creationId xmlns:a16="http://schemas.microsoft.com/office/drawing/2014/main" id="{372BA102-07B2-E1A2-DF66-A1A4D3ABB2C8}"/>
              </a:ext>
            </a:extLst>
          </p:cNvPr>
          <p:cNvSpPr/>
          <p:nvPr/>
        </p:nvSpPr>
        <p:spPr>
          <a:xfrm>
            <a:off x="5238912" y="9660326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</p:spTree>
    <p:extLst>
      <p:ext uri="{BB962C8B-B14F-4D97-AF65-F5344CB8AC3E}">
        <p14:creationId xmlns:p14="http://schemas.microsoft.com/office/powerpoint/2010/main" val="17113288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" name="TextBox 285">
            <a:extLst>
              <a:ext uri="{FF2B5EF4-FFF2-40B4-BE49-F238E27FC236}">
                <a16:creationId xmlns:a16="http://schemas.microsoft.com/office/drawing/2014/main" id="{A75EA8EE-FE95-828D-9B7C-E1475333B3D1}"/>
              </a:ext>
            </a:extLst>
          </p:cNvPr>
          <p:cNvSpPr txBox="1"/>
          <p:nvPr/>
        </p:nvSpPr>
        <p:spPr>
          <a:xfrm>
            <a:off x="859907" y="1308268"/>
            <a:ext cx="3616183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88" b="1" dirty="0"/>
              <a:t>a. MALE: Incidence of transplant on waitlist</a:t>
            </a:r>
            <a:endParaRPr lang="en-US" sz="1488" dirty="0"/>
          </a:p>
        </p:txBody>
      </p:sp>
      <p:sp>
        <p:nvSpPr>
          <p:cNvPr id="424" name="TextBox 423">
            <a:extLst>
              <a:ext uri="{FF2B5EF4-FFF2-40B4-BE49-F238E27FC236}">
                <a16:creationId xmlns:a16="http://schemas.microsoft.com/office/drawing/2014/main" id="{D6ABF3E3-DFFB-F858-BC13-503F6981CBA7}"/>
              </a:ext>
            </a:extLst>
          </p:cNvPr>
          <p:cNvSpPr txBox="1"/>
          <p:nvPr/>
        </p:nvSpPr>
        <p:spPr>
          <a:xfrm>
            <a:off x="5645318" y="1308268"/>
            <a:ext cx="3848618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b.  FEMALE: Incidence of transplant on waitlist</a:t>
            </a:r>
            <a:endParaRPr lang="en-US" sz="1488" dirty="0"/>
          </a:p>
        </p:txBody>
      </p:sp>
      <p:sp>
        <p:nvSpPr>
          <p:cNvPr id="493" name="Title 1">
            <a:extLst>
              <a:ext uri="{FF2B5EF4-FFF2-40B4-BE49-F238E27FC236}">
                <a16:creationId xmlns:a16="http://schemas.microsoft.com/office/drawing/2014/main" id="{2D266D8C-F4F6-F5B2-39CF-BD655A44205A}"/>
              </a:ext>
            </a:extLst>
          </p:cNvPr>
          <p:cNvSpPr txBox="1">
            <a:spLocks/>
          </p:cNvSpPr>
          <p:nvPr/>
        </p:nvSpPr>
        <p:spPr>
          <a:xfrm>
            <a:off x="429118" y="5007109"/>
            <a:ext cx="4599151" cy="571493"/>
          </a:xfrm>
          <a:prstGeom prst="rect">
            <a:avLst/>
          </a:prstGeom>
        </p:spPr>
        <p:txBody>
          <a:bodyPr vert="horz" lIns="75605" tIns="37802" rIns="75605" bIns="37802" rtlCol="0" anchor="ctr"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488" b="1" dirty="0">
                <a:latin typeface="+mn-lt"/>
              </a:rPr>
              <a:t>c. Age &lt;60: Incidence of transplant on waitlist</a:t>
            </a:r>
          </a:p>
        </p:txBody>
      </p:sp>
      <p:sp>
        <p:nvSpPr>
          <p:cNvPr id="564" name="TextBox 563">
            <a:extLst>
              <a:ext uri="{FF2B5EF4-FFF2-40B4-BE49-F238E27FC236}">
                <a16:creationId xmlns:a16="http://schemas.microsoft.com/office/drawing/2014/main" id="{463FD226-202C-B0B7-17BE-E5300A85A045}"/>
              </a:ext>
            </a:extLst>
          </p:cNvPr>
          <p:cNvSpPr txBox="1"/>
          <p:nvPr/>
        </p:nvSpPr>
        <p:spPr>
          <a:xfrm>
            <a:off x="5282545" y="5097614"/>
            <a:ext cx="3979616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d.  Age &gt;= 60: Incidence of transplant on waitlist</a:t>
            </a:r>
            <a:endParaRPr lang="en-US" sz="1488" dirty="0"/>
          </a:p>
        </p:txBody>
      </p:sp>
      <p:sp>
        <p:nvSpPr>
          <p:cNvPr id="636" name="TextBox 635">
            <a:extLst>
              <a:ext uri="{FF2B5EF4-FFF2-40B4-BE49-F238E27FC236}">
                <a16:creationId xmlns:a16="http://schemas.microsoft.com/office/drawing/2014/main" id="{35878DB7-2189-892A-4D01-1D4B0A332DAF}"/>
              </a:ext>
            </a:extLst>
          </p:cNvPr>
          <p:cNvSpPr txBox="1"/>
          <p:nvPr/>
        </p:nvSpPr>
        <p:spPr>
          <a:xfrm>
            <a:off x="850455" y="8897231"/>
            <a:ext cx="3818161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e. BMI &lt;25: Incidence of transplant on waitlist</a:t>
            </a:r>
            <a:endParaRPr lang="en-US" sz="1488" dirty="0"/>
          </a:p>
        </p:txBody>
      </p:sp>
      <p:sp>
        <p:nvSpPr>
          <p:cNvPr id="709" name="TextBox 708">
            <a:extLst>
              <a:ext uri="{FF2B5EF4-FFF2-40B4-BE49-F238E27FC236}">
                <a16:creationId xmlns:a16="http://schemas.microsoft.com/office/drawing/2014/main" id="{98C5AB5F-519E-D75A-B8A1-8D4477BC5013}"/>
              </a:ext>
            </a:extLst>
          </p:cNvPr>
          <p:cNvSpPr txBox="1"/>
          <p:nvPr/>
        </p:nvSpPr>
        <p:spPr>
          <a:xfrm>
            <a:off x="5449391" y="8897231"/>
            <a:ext cx="3953775" cy="3213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88" b="1" dirty="0"/>
              <a:t>f.  BMI &gt;= 25: Incidence of transplant on waitlist</a:t>
            </a:r>
            <a:endParaRPr lang="en-US" sz="1488" dirty="0"/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33985CAF-A0B7-5BEE-50E7-C7884A53879F}"/>
              </a:ext>
            </a:extLst>
          </p:cNvPr>
          <p:cNvGrpSpPr>
            <a:grpSpLocks noChangeAspect="1"/>
          </p:cNvGrpSpPr>
          <p:nvPr/>
        </p:nvGrpSpPr>
        <p:grpSpPr>
          <a:xfrm>
            <a:off x="4890843" y="1574826"/>
            <a:ext cx="4760664" cy="3571875"/>
            <a:chOff x="0" y="0"/>
            <a:chExt cx="9144000" cy="6858000"/>
          </a:xfrm>
        </p:grpSpPr>
        <p:sp>
          <p:nvSpPr>
            <p:cNvPr id="37" name="rc3">
              <a:extLst>
                <a:ext uri="{FF2B5EF4-FFF2-40B4-BE49-F238E27FC236}">
                  <a16:creationId xmlns:a16="http://schemas.microsoft.com/office/drawing/2014/main" id="{D5C55CD4-3A7B-0839-81BE-19216C1154D4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9" name="rc4">
              <a:extLst>
                <a:ext uri="{FF2B5EF4-FFF2-40B4-BE49-F238E27FC236}">
                  <a16:creationId xmlns:a16="http://schemas.microsoft.com/office/drawing/2014/main" id="{9CC8E42E-B869-7B5D-9DF0-5BF6409BC2DB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0" name="rc5">
              <a:extLst>
                <a:ext uri="{FF2B5EF4-FFF2-40B4-BE49-F238E27FC236}">
                  <a16:creationId xmlns:a16="http://schemas.microsoft.com/office/drawing/2014/main" id="{14261A6C-7F37-4848-B978-26661DA79B9A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1" name="rc6">
              <a:extLst>
                <a:ext uri="{FF2B5EF4-FFF2-40B4-BE49-F238E27FC236}">
                  <a16:creationId xmlns:a16="http://schemas.microsoft.com/office/drawing/2014/main" id="{2B2303DC-DAEE-39C0-A480-BA15826F1110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197" name="rc7">
              <a:extLst>
                <a:ext uri="{FF2B5EF4-FFF2-40B4-BE49-F238E27FC236}">
                  <a16:creationId xmlns:a16="http://schemas.microsoft.com/office/drawing/2014/main" id="{4182CCE8-AE4D-832C-FF5C-C4F6EA569A49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198" name="rc8">
              <a:extLst>
                <a:ext uri="{FF2B5EF4-FFF2-40B4-BE49-F238E27FC236}">
                  <a16:creationId xmlns:a16="http://schemas.microsoft.com/office/drawing/2014/main" id="{EE20DC89-E2EC-2D8B-B6A2-1913E8A3D452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19" name="rc9">
              <a:extLst>
                <a:ext uri="{FF2B5EF4-FFF2-40B4-BE49-F238E27FC236}">
                  <a16:creationId xmlns:a16="http://schemas.microsoft.com/office/drawing/2014/main" id="{D674AA60-B4FC-89B7-0B15-A0CBA850384B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220" name="pl18">
              <a:extLst>
                <a:ext uri="{FF2B5EF4-FFF2-40B4-BE49-F238E27FC236}">
                  <a16:creationId xmlns:a16="http://schemas.microsoft.com/office/drawing/2014/main" id="{BD3713D8-B847-EBF6-78FA-FEBC17445AE7}"/>
                </a:ext>
              </a:extLst>
            </p:cNvPr>
            <p:cNvSpPr/>
            <p:nvPr/>
          </p:nvSpPr>
          <p:spPr>
            <a:xfrm>
              <a:off x="776476" y="3534137"/>
              <a:ext cx="8228345" cy="0"/>
            </a:xfrm>
            <a:custGeom>
              <a:avLst/>
              <a:gdLst/>
              <a:ahLst/>
              <a:cxnLst/>
              <a:rect l="0" t="0" r="0" b="0"/>
              <a:pathLst>
                <a:path w="8228345">
                  <a:moveTo>
                    <a:pt x="0" y="0"/>
                  </a:moveTo>
                  <a:lnTo>
                    <a:pt x="8228345" y="0"/>
                  </a:lnTo>
                  <a:lnTo>
                    <a:pt x="8228345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21" name="pl23">
              <a:extLst>
                <a:ext uri="{FF2B5EF4-FFF2-40B4-BE49-F238E27FC236}">
                  <a16:creationId xmlns:a16="http://schemas.microsoft.com/office/drawing/2014/main" id="{E2131614-3E68-28A3-A766-BC17EBA71ACC}"/>
                </a:ext>
              </a:extLst>
            </p:cNvPr>
            <p:cNvSpPr/>
            <p:nvPr/>
          </p:nvSpPr>
          <p:spPr>
            <a:xfrm>
              <a:off x="1150492" y="139178"/>
              <a:ext cx="0" cy="3556623"/>
            </a:xfrm>
            <a:custGeom>
              <a:avLst/>
              <a:gdLst/>
              <a:ahLst/>
              <a:cxnLst/>
              <a:rect l="0" t="0" r="0" b="0"/>
              <a:pathLst>
                <a:path h="3556623">
                  <a:moveTo>
                    <a:pt x="0" y="35566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22" name="pl27">
              <a:extLst>
                <a:ext uri="{FF2B5EF4-FFF2-40B4-BE49-F238E27FC236}">
                  <a16:creationId xmlns:a16="http://schemas.microsoft.com/office/drawing/2014/main" id="{071B3E68-8344-1636-074F-E7D9440411A3}"/>
                </a:ext>
              </a:extLst>
            </p:cNvPr>
            <p:cNvSpPr/>
            <p:nvPr/>
          </p:nvSpPr>
          <p:spPr>
            <a:xfrm>
              <a:off x="1150492" y="1432495"/>
              <a:ext cx="4354977" cy="2101641"/>
            </a:xfrm>
            <a:custGeom>
              <a:avLst/>
              <a:gdLst/>
              <a:ahLst/>
              <a:cxnLst/>
              <a:rect l="0" t="0" r="0" b="0"/>
              <a:pathLst>
                <a:path w="4354977" h="2101641">
                  <a:moveTo>
                    <a:pt x="0" y="2101641"/>
                  </a:moveTo>
                  <a:lnTo>
                    <a:pt x="51235" y="2101641"/>
                  </a:lnTo>
                  <a:lnTo>
                    <a:pt x="51235" y="2101641"/>
                  </a:lnTo>
                  <a:lnTo>
                    <a:pt x="71729" y="2101641"/>
                  </a:lnTo>
                  <a:lnTo>
                    <a:pt x="71729" y="1778311"/>
                  </a:lnTo>
                  <a:lnTo>
                    <a:pt x="1014453" y="1778311"/>
                  </a:lnTo>
                  <a:lnTo>
                    <a:pt x="1014453" y="1454982"/>
                  </a:lnTo>
                  <a:lnTo>
                    <a:pt x="1250134" y="1454982"/>
                  </a:lnTo>
                  <a:lnTo>
                    <a:pt x="1250134" y="1131653"/>
                  </a:lnTo>
                  <a:lnTo>
                    <a:pt x="2100636" y="1131653"/>
                  </a:lnTo>
                  <a:lnTo>
                    <a:pt x="2100636" y="1131653"/>
                  </a:lnTo>
                  <a:lnTo>
                    <a:pt x="3074101" y="1131653"/>
                  </a:lnTo>
                  <a:lnTo>
                    <a:pt x="3074101" y="808323"/>
                  </a:lnTo>
                  <a:lnTo>
                    <a:pt x="3863120" y="808323"/>
                  </a:lnTo>
                  <a:lnTo>
                    <a:pt x="3863120" y="484994"/>
                  </a:lnTo>
                  <a:lnTo>
                    <a:pt x="4027073" y="484994"/>
                  </a:lnTo>
                  <a:lnTo>
                    <a:pt x="4027073" y="484994"/>
                  </a:lnTo>
                  <a:lnTo>
                    <a:pt x="4273001" y="484994"/>
                  </a:lnTo>
                  <a:lnTo>
                    <a:pt x="4273001" y="0"/>
                  </a:lnTo>
                  <a:lnTo>
                    <a:pt x="4354977" y="0"/>
                  </a:lnTo>
                  <a:lnTo>
                    <a:pt x="4354977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23" name="pl28">
              <a:extLst>
                <a:ext uri="{FF2B5EF4-FFF2-40B4-BE49-F238E27FC236}">
                  <a16:creationId xmlns:a16="http://schemas.microsoft.com/office/drawing/2014/main" id="{0A092532-09B9-4858-04B8-7323EBB5A736}"/>
                </a:ext>
              </a:extLst>
            </p:cNvPr>
            <p:cNvSpPr/>
            <p:nvPr/>
          </p:nvSpPr>
          <p:spPr>
            <a:xfrm>
              <a:off x="1150492" y="865045"/>
              <a:ext cx="7265126" cy="2669091"/>
            </a:xfrm>
            <a:custGeom>
              <a:avLst/>
              <a:gdLst/>
              <a:ahLst/>
              <a:cxnLst/>
              <a:rect l="0" t="0" r="0" b="0"/>
              <a:pathLst>
                <a:path w="7265126" h="2669091">
                  <a:moveTo>
                    <a:pt x="0" y="2669091"/>
                  </a:moveTo>
                  <a:lnTo>
                    <a:pt x="10247" y="2669091"/>
                  </a:lnTo>
                  <a:lnTo>
                    <a:pt x="10247" y="2590230"/>
                  </a:lnTo>
                  <a:lnTo>
                    <a:pt x="71729" y="2590230"/>
                  </a:lnTo>
                  <a:lnTo>
                    <a:pt x="71729" y="2511369"/>
                  </a:lnTo>
                  <a:lnTo>
                    <a:pt x="112717" y="2511369"/>
                  </a:lnTo>
                  <a:lnTo>
                    <a:pt x="112717" y="2432509"/>
                  </a:lnTo>
                  <a:lnTo>
                    <a:pt x="194693" y="2432509"/>
                  </a:lnTo>
                  <a:lnTo>
                    <a:pt x="194693" y="2353648"/>
                  </a:lnTo>
                  <a:lnTo>
                    <a:pt x="256175" y="2353648"/>
                  </a:lnTo>
                  <a:lnTo>
                    <a:pt x="256175" y="2274787"/>
                  </a:lnTo>
                  <a:lnTo>
                    <a:pt x="297163" y="2274787"/>
                  </a:lnTo>
                  <a:lnTo>
                    <a:pt x="297163" y="2195926"/>
                  </a:lnTo>
                  <a:lnTo>
                    <a:pt x="389386" y="2195926"/>
                  </a:lnTo>
                  <a:lnTo>
                    <a:pt x="389386" y="2195926"/>
                  </a:lnTo>
                  <a:lnTo>
                    <a:pt x="409880" y="2195926"/>
                  </a:lnTo>
                  <a:lnTo>
                    <a:pt x="409880" y="2114746"/>
                  </a:lnTo>
                  <a:lnTo>
                    <a:pt x="522597" y="2114746"/>
                  </a:lnTo>
                  <a:lnTo>
                    <a:pt x="522597" y="2033565"/>
                  </a:lnTo>
                  <a:lnTo>
                    <a:pt x="635314" y="2033565"/>
                  </a:lnTo>
                  <a:lnTo>
                    <a:pt x="635314" y="1952385"/>
                  </a:lnTo>
                  <a:lnTo>
                    <a:pt x="737784" y="1952385"/>
                  </a:lnTo>
                  <a:lnTo>
                    <a:pt x="737784" y="1871205"/>
                  </a:lnTo>
                  <a:lnTo>
                    <a:pt x="830007" y="1871205"/>
                  </a:lnTo>
                  <a:lnTo>
                    <a:pt x="830007" y="1790025"/>
                  </a:lnTo>
                  <a:lnTo>
                    <a:pt x="922230" y="1790025"/>
                  </a:lnTo>
                  <a:lnTo>
                    <a:pt x="922230" y="1708844"/>
                  </a:lnTo>
                  <a:lnTo>
                    <a:pt x="1004206" y="1708844"/>
                  </a:lnTo>
                  <a:lnTo>
                    <a:pt x="1004206" y="1627664"/>
                  </a:lnTo>
                  <a:lnTo>
                    <a:pt x="1014453" y="1627664"/>
                  </a:lnTo>
                  <a:lnTo>
                    <a:pt x="1014453" y="1546484"/>
                  </a:lnTo>
                  <a:lnTo>
                    <a:pt x="1034947" y="1546484"/>
                  </a:lnTo>
                  <a:lnTo>
                    <a:pt x="1034947" y="1465304"/>
                  </a:lnTo>
                  <a:lnTo>
                    <a:pt x="1065688" y="1465304"/>
                  </a:lnTo>
                  <a:lnTo>
                    <a:pt x="1065688" y="1384123"/>
                  </a:lnTo>
                  <a:lnTo>
                    <a:pt x="1157911" y="1384123"/>
                  </a:lnTo>
                  <a:lnTo>
                    <a:pt x="1157911" y="1302943"/>
                  </a:lnTo>
                  <a:lnTo>
                    <a:pt x="1198899" y="1302943"/>
                  </a:lnTo>
                  <a:lnTo>
                    <a:pt x="1198899" y="1221763"/>
                  </a:lnTo>
                  <a:lnTo>
                    <a:pt x="1444827" y="1221763"/>
                  </a:lnTo>
                  <a:lnTo>
                    <a:pt x="1444827" y="1140582"/>
                  </a:lnTo>
                  <a:lnTo>
                    <a:pt x="1588285" y="1140582"/>
                  </a:lnTo>
                  <a:lnTo>
                    <a:pt x="1588285" y="1059402"/>
                  </a:lnTo>
                  <a:lnTo>
                    <a:pt x="1649767" y="1059402"/>
                  </a:lnTo>
                  <a:lnTo>
                    <a:pt x="1649767" y="1059402"/>
                  </a:lnTo>
                  <a:lnTo>
                    <a:pt x="1762484" y="1059402"/>
                  </a:lnTo>
                  <a:lnTo>
                    <a:pt x="1762484" y="978222"/>
                  </a:lnTo>
                  <a:lnTo>
                    <a:pt x="1864954" y="978222"/>
                  </a:lnTo>
                  <a:lnTo>
                    <a:pt x="1864954" y="897042"/>
                  </a:lnTo>
                  <a:lnTo>
                    <a:pt x="1895695" y="897042"/>
                  </a:lnTo>
                  <a:lnTo>
                    <a:pt x="1895695" y="897042"/>
                  </a:lnTo>
                  <a:lnTo>
                    <a:pt x="2285082" y="897042"/>
                  </a:lnTo>
                  <a:lnTo>
                    <a:pt x="2285082" y="810788"/>
                  </a:lnTo>
                  <a:lnTo>
                    <a:pt x="2408046" y="810788"/>
                  </a:lnTo>
                  <a:lnTo>
                    <a:pt x="2408046" y="724533"/>
                  </a:lnTo>
                  <a:lnTo>
                    <a:pt x="2735950" y="724533"/>
                  </a:lnTo>
                  <a:lnTo>
                    <a:pt x="2735950" y="638279"/>
                  </a:lnTo>
                  <a:lnTo>
                    <a:pt x="3217559" y="638279"/>
                  </a:lnTo>
                  <a:lnTo>
                    <a:pt x="3217559" y="552025"/>
                  </a:lnTo>
                  <a:lnTo>
                    <a:pt x="3842626" y="552025"/>
                  </a:lnTo>
                  <a:lnTo>
                    <a:pt x="3842626" y="465771"/>
                  </a:lnTo>
                  <a:lnTo>
                    <a:pt x="3863120" y="465771"/>
                  </a:lnTo>
                  <a:lnTo>
                    <a:pt x="3863120" y="379517"/>
                  </a:lnTo>
                  <a:lnTo>
                    <a:pt x="3873367" y="379517"/>
                  </a:lnTo>
                  <a:lnTo>
                    <a:pt x="3873367" y="293263"/>
                  </a:lnTo>
                  <a:lnTo>
                    <a:pt x="5092761" y="293263"/>
                  </a:lnTo>
                  <a:lnTo>
                    <a:pt x="5092761" y="207009"/>
                  </a:lnTo>
                  <a:lnTo>
                    <a:pt x="5379677" y="207009"/>
                  </a:lnTo>
                  <a:lnTo>
                    <a:pt x="5379677" y="120755"/>
                  </a:lnTo>
                  <a:lnTo>
                    <a:pt x="7008951" y="120755"/>
                  </a:lnTo>
                  <a:lnTo>
                    <a:pt x="7008951" y="120755"/>
                  </a:lnTo>
                  <a:lnTo>
                    <a:pt x="7049939" y="120755"/>
                  </a:lnTo>
                  <a:lnTo>
                    <a:pt x="7049939" y="120755"/>
                  </a:lnTo>
                  <a:lnTo>
                    <a:pt x="7265126" y="120755"/>
                  </a:lnTo>
                  <a:lnTo>
                    <a:pt x="7265126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24" name="rc29">
              <a:extLst>
                <a:ext uri="{FF2B5EF4-FFF2-40B4-BE49-F238E27FC236}">
                  <a16:creationId xmlns:a16="http://schemas.microsoft.com/office/drawing/2014/main" id="{C053282A-C425-33E3-A90E-58C21DACCD8B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25" name="tx30">
              <a:extLst>
                <a:ext uri="{FF2B5EF4-FFF2-40B4-BE49-F238E27FC236}">
                  <a16:creationId xmlns:a16="http://schemas.microsoft.com/office/drawing/2014/main" id="{8A277383-CF60-EA4A-55D5-9A3219D5D372}"/>
                </a:ext>
              </a:extLst>
            </p:cNvPr>
            <p:cNvSpPr/>
            <p:nvPr/>
          </p:nvSpPr>
          <p:spPr>
            <a:xfrm>
              <a:off x="466667" y="3486760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226" name="tx31">
              <a:extLst>
                <a:ext uri="{FF2B5EF4-FFF2-40B4-BE49-F238E27FC236}">
                  <a16:creationId xmlns:a16="http://schemas.microsoft.com/office/drawing/2014/main" id="{24AE4497-8E4B-693C-D8FF-C3BB7FD13E44}"/>
                </a:ext>
              </a:extLst>
            </p:cNvPr>
            <p:cNvSpPr/>
            <p:nvPr/>
          </p:nvSpPr>
          <p:spPr>
            <a:xfrm>
              <a:off x="466667" y="2678436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227" name="tx32">
              <a:extLst>
                <a:ext uri="{FF2B5EF4-FFF2-40B4-BE49-F238E27FC236}">
                  <a16:creationId xmlns:a16="http://schemas.microsoft.com/office/drawing/2014/main" id="{1AF06F05-CB37-33AA-2DAF-DDC3C6136784}"/>
                </a:ext>
              </a:extLst>
            </p:cNvPr>
            <p:cNvSpPr/>
            <p:nvPr/>
          </p:nvSpPr>
          <p:spPr>
            <a:xfrm>
              <a:off x="466667" y="1870113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228" name="tx33">
              <a:extLst>
                <a:ext uri="{FF2B5EF4-FFF2-40B4-BE49-F238E27FC236}">
                  <a16:creationId xmlns:a16="http://schemas.microsoft.com/office/drawing/2014/main" id="{2CDE5CDC-9161-4AE7-FF27-F92900ACF8EB}"/>
                </a:ext>
              </a:extLst>
            </p:cNvPr>
            <p:cNvSpPr/>
            <p:nvPr/>
          </p:nvSpPr>
          <p:spPr>
            <a:xfrm>
              <a:off x="466667" y="1061789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229" name="tx34">
              <a:extLst>
                <a:ext uri="{FF2B5EF4-FFF2-40B4-BE49-F238E27FC236}">
                  <a16:creationId xmlns:a16="http://schemas.microsoft.com/office/drawing/2014/main" id="{96C32A10-E77B-90BD-7A55-C6DB82F50385}"/>
                </a:ext>
              </a:extLst>
            </p:cNvPr>
            <p:cNvSpPr/>
            <p:nvPr/>
          </p:nvSpPr>
          <p:spPr>
            <a:xfrm>
              <a:off x="466667" y="253465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0</a:t>
              </a:r>
            </a:p>
          </p:txBody>
        </p:sp>
        <p:sp>
          <p:nvSpPr>
            <p:cNvPr id="230" name="pl35">
              <a:extLst>
                <a:ext uri="{FF2B5EF4-FFF2-40B4-BE49-F238E27FC236}">
                  <a16:creationId xmlns:a16="http://schemas.microsoft.com/office/drawing/2014/main" id="{AA3C4E13-B23E-3094-7C54-A35BC71C4C14}"/>
                </a:ext>
              </a:extLst>
            </p:cNvPr>
            <p:cNvSpPr/>
            <p:nvPr/>
          </p:nvSpPr>
          <p:spPr>
            <a:xfrm>
              <a:off x="741682" y="353413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31" name="pl36">
              <a:extLst>
                <a:ext uri="{FF2B5EF4-FFF2-40B4-BE49-F238E27FC236}">
                  <a16:creationId xmlns:a16="http://schemas.microsoft.com/office/drawing/2014/main" id="{E50E1978-9CB0-580E-E5C9-E2F4888EA76F}"/>
                </a:ext>
              </a:extLst>
            </p:cNvPr>
            <p:cNvSpPr/>
            <p:nvPr/>
          </p:nvSpPr>
          <p:spPr>
            <a:xfrm>
              <a:off x="741682" y="2725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32" name="pl37">
              <a:extLst>
                <a:ext uri="{FF2B5EF4-FFF2-40B4-BE49-F238E27FC236}">
                  <a16:creationId xmlns:a16="http://schemas.microsoft.com/office/drawing/2014/main" id="{E04BF05B-8190-A909-3046-4C5F05B00659}"/>
                </a:ext>
              </a:extLst>
            </p:cNvPr>
            <p:cNvSpPr/>
            <p:nvPr/>
          </p:nvSpPr>
          <p:spPr>
            <a:xfrm>
              <a:off x="741682" y="19174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33" name="pl38">
              <a:extLst>
                <a:ext uri="{FF2B5EF4-FFF2-40B4-BE49-F238E27FC236}">
                  <a16:creationId xmlns:a16="http://schemas.microsoft.com/office/drawing/2014/main" id="{2CF6BBD5-EDE5-151A-1BB1-BFDCCA6C00AC}"/>
                </a:ext>
              </a:extLst>
            </p:cNvPr>
            <p:cNvSpPr/>
            <p:nvPr/>
          </p:nvSpPr>
          <p:spPr>
            <a:xfrm>
              <a:off x="741682" y="11091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34" name="pl39">
              <a:extLst>
                <a:ext uri="{FF2B5EF4-FFF2-40B4-BE49-F238E27FC236}">
                  <a16:creationId xmlns:a16="http://schemas.microsoft.com/office/drawing/2014/main" id="{A2EA6B5D-66CE-93ED-FD1A-A4B90A4D222C}"/>
                </a:ext>
              </a:extLst>
            </p:cNvPr>
            <p:cNvSpPr/>
            <p:nvPr/>
          </p:nvSpPr>
          <p:spPr>
            <a:xfrm>
              <a:off x="741682" y="3008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35" name="pl40">
              <a:extLst>
                <a:ext uri="{FF2B5EF4-FFF2-40B4-BE49-F238E27FC236}">
                  <a16:creationId xmlns:a16="http://schemas.microsoft.com/office/drawing/2014/main" id="{54B4C74F-DEAF-F208-E01A-46598AD75F75}"/>
                </a:ext>
              </a:extLst>
            </p:cNvPr>
            <p:cNvSpPr/>
            <p:nvPr/>
          </p:nvSpPr>
          <p:spPr>
            <a:xfrm>
              <a:off x="1150492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36" name="pl41">
              <a:extLst>
                <a:ext uri="{FF2B5EF4-FFF2-40B4-BE49-F238E27FC236}">
                  <a16:creationId xmlns:a16="http://schemas.microsoft.com/office/drawing/2014/main" id="{480AE3B4-F560-75D1-2BDB-7E06F628D49A}"/>
                </a:ext>
              </a:extLst>
            </p:cNvPr>
            <p:cNvSpPr/>
            <p:nvPr/>
          </p:nvSpPr>
          <p:spPr>
            <a:xfrm>
              <a:off x="3199893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37" name="pl42">
              <a:extLst>
                <a:ext uri="{FF2B5EF4-FFF2-40B4-BE49-F238E27FC236}">
                  <a16:creationId xmlns:a16="http://schemas.microsoft.com/office/drawing/2014/main" id="{EBBB30BA-068E-1088-1378-5001BED9F0E3}"/>
                </a:ext>
              </a:extLst>
            </p:cNvPr>
            <p:cNvSpPr/>
            <p:nvPr/>
          </p:nvSpPr>
          <p:spPr>
            <a:xfrm>
              <a:off x="5249294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38" name="pl43">
              <a:extLst>
                <a:ext uri="{FF2B5EF4-FFF2-40B4-BE49-F238E27FC236}">
                  <a16:creationId xmlns:a16="http://schemas.microsoft.com/office/drawing/2014/main" id="{7D5C65E0-D9B5-0A2E-5107-B9692CD98A4B}"/>
                </a:ext>
              </a:extLst>
            </p:cNvPr>
            <p:cNvSpPr/>
            <p:nvPr/>
          </p:nvSpPr>
          <p:spPr>
            <a:xfrm>
              <a:off x="7298695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39" name="tx44">
              <a:extLst>
                <a:ext uri="{FF2B5EF4-FFF2-40B4-BE49-F238E27FC236}">
                  <a16:creationId xmlns:a16="http://schemas.microsoft.com/office/drawing/2014/main" id="{E03A42EB-6590-8DDB-2305-1F401E41510B}"/>
                </a:ext>
              </a:extLst>
            </p:cNvPr>
            <p:cNvSpPr/>
            <p:nvPr/>
          </p:nvSpPr>
          <p:spPr>
            <a:xfrm>
              <a:off x="1115176" y="3756509"/>
              <a:ext cx="70631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40" name="tx45">
              <a:extLst>
                <a:ext uri="{FF2B5EF4-FFF2-40B4-BE49-F238E27FC236}">
                  <a16:creationId xmlns:a16="http://schemas.microsoft.com/office/drawing/2014/main" id="{64B65272-DA04-47B8-9421-EB7504CB0ADD}"/>
                </a:ext>
              </a:extLst>
            </p:cNvPr>
            <p:cNvSpPr/>
            <p:nvPr/>
          </p:nvSpPr>
          <p:spPr>
            <a:xfrm>
              <a:off x="3093946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241" name="tx46">
              <a:extLst>
                <a:ext uri="{FF2B5EF4-FFF2-40B4-BE49-F238E27FC236}">
                  <a16:creationId xmlns:a16="http://schemas.microsoft.com/office/drawing/2014/main" id="{F34B0EC9-F916-4B5C-E06F-142500F6B5EA}"/>
                </a:ext>
              </a:extLst>
            </p:cNvPr>
            <p:cNvSpPr/>
            <p:nvPr/>
          </p:nvSpPr>
          <p:spPr>
            <a:xfrm>
              <a:off x="5143347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242" name="tx47">
              <a:extLst>
                <a:ext uri="{FF2B5EF4-FFF2-40B4-BE49-F238E27FC236}">
                  <a16:creationId xmlns:a16="http://schemas.microsoft.com/office/drawing/2014/main" id="{CCBE2CBE-6052-B02C-EC51-4E406C7ABA3B}"/>
                </a:ext>
              </a:extLst>
            </p:cNvPr>
            <p:cNvSpPr/>
            <p:nvPr/>
          </p:nvSpPr>
          <p:spPr>
            <a:xfrm>
              <a:off x="7192748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243" name="tx48">
              <a:extLst>
                <a:ext uri="{FF2B5EF4-FFF2-40B4-BE49-F238E27FC236}">
                  <a16:creationId xmlns:a16="http://schemas.microsoft.com/office/drawing/2014/main" id="{258BD977-90D2-0A58-B63C-58D55558AAC0}"/>
                </a:ext>
              </a:extLst>
            </p:cNvPr>
            <p:cNvSpPr/>
            <p:nvPr/>
          </p:nvSpPr>
          <p:spPr>
            <a:xfrm>
              <a:off x="4009884" y="3878778"/>
              <a:ext cx="1761529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 to Transplant (Days)</a:t>
              </a:r>
            </a:p>
          </p:txBody>
        </p:sp>
        <p:sp>
          <p:nvSpPr>
            <p:cNvPr id="244" name="tx49">
              <a:extLst>
                <a:ext uri="{FF2B5EF4-FFF2-40B4-BE49-F238E27FC236}">
                  <a16:creationId xmlns:a16="http://schemas.microsoft.com/office/drawing/2014/main" id="{674D43E9-6D18-8AAF-2E4D-6C18830D9F4F}"/>
                </a:ext>
              </a:extLst>
            </p:cNvPr>
            <p:cNvSpPr/>
            <p:nvPr/>
          </p:nvSpPr>
          <p:spPr>
            <a:xfrm rot="-5400000">
              <a:off x="-985888" y="1845978"/>
              <a:ext cx="2668190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umulative Incidence of Transplant (%)</a:t>
              </a:r>
            </a:p>
          </p:txBody>
        </p:sp>
        <p:sp>
          <p:nvSpPr>
            <p:cNvPr id="245" name="rc50">
              <a:extLst>
                <a:ext uri="{FF2B5EF4-FFF2-40B4-BE49-F238E27FC236}">
                  <a16:creationId xmlns:a16="http://schemas.microsoft.com/office/drawing/2014/main" id="{D78AED22-AAFF-2D6A-E55A-5D72F320ED27}"/>
                </a:ext>
              </a:extLst>
            </p:cNvPr>
            <p:cNvSpPr/>
            <p:nvPr/>
          </p:nvSpPr>
          <p:spPr>
            <a:xfrm>
              <a:off x="4276688" y="4189554"/>
              <a:ext cx="1227921" cy="358634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246" name="rc51">
              <a:extLst>
                <a:ext uri="{FF2B5EF4-FFF2-40B4-BE49-F238E27FC236}">
                  <a16:creationId xmlns:a16="http://schemas.microsoft.com/office/drawing/2014/main" id="{B26E209D-032F-AFFA-9BE3-65016B518591}"/>
                </a:ext>
              </a:extLst>
            </p:cNvPr>
            <p:cNvSpPr/>
            <p:nvPr/>
          </p:nvSpPr>
          <p:spPr>
            <a:xfrm>
              <a:off x="4415866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247" name="pl52">
              <a:extLst>
                <a:ext uri="{FF2B5EF4-FFF2-40B4-BE49-F238E27FC236}">
                  <a16:creationId xmlns:a16="http://schemas.microsoft.com/office/drawing/2014/main" id="{E6763A74-2D77-604E-8295-B71FFC31A174}"/>
                </a:ext>
              </a:extLst>
            </p:cNvPr>
            <p:cNvSpPr/>
            <p:nvPr/>
          </p:nvSpPr>
          <p:spPr>
            <a:xfrm>
              <a:off x="4437812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48" name="rc53">
              <a:extLst>
                <a:ext uri="{FF2B5EF4-FFF2-40B4-BE49-F238E27FC236}">
                  <a16:creationId xmlns:a16="http://schemas.microsoft.com/office/drawing/2014/main" id="{44A75B42-9260-0AB0-25D8-8E5FE4DDB64B}"/>
                </a:ext>
              </a:extLst>
            </p:cNvPr>
            <p:cNvSpPr/>
            <p:nvPr/>
          </p:nvSpPr>
          <p:spPr>
            <a:xfrm>
              <a:off x="4926900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249" name="pl54">
              <a:extLst>
                <a:ext uri="{FF2B5EF4-FFF2-40B4-BE49-F238E27FC236}">
                  <a16:creationId xmlns:a16="http://schemas.microsoft.com/office/drawing/2014/main" id="{1B1B3CD4-8F8B-42BE-4D01-5BCD4697D9D5}"/>
                </a:ext>
              </a:extLst>
            </p:cNvPr>
            <p:cNvSpPr/>
            <p:nvPr/>
          </p:nvSpPr>
          <p:spPr>
            <a:xfrm>
              <a:off x="4948846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50" name="tx55">
              <a:extLst>
                <a:ext uri="{FF2B5EF4-FFF2-40B4-BE49-F238E27FC236}">
                  <a16:creationId xmlns:a16="http://schemas.microsoft.com/office/drawing/2014/main" id="{3AABE7CF-7B75-2489-6F8C-A8A7EF82E699}"/>
                </a:ext>
              </a:extLst>
            </p:cNvPr>
            <p:cNvSpPr/>
            <p:nvPr/>
          </p:nvSpPr>
          <p:spPr>
            <a:xfrm>
              <a:off x="4704911" y="4321929"/>
              <a:ext cx="162346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251" name="tx56">
              <a:extLst>
                <a:ext uri="{FF2B5EF4-FFF2-40B4-BE49-F238E27FC236}">
                  <a16:creationId xmlns:a16="http://schemas.microsoft.com/office/drawing/2014/main" id="{E0D3F1CB-9B78-2E8F-1348-7A248616636F}"/>
                </a:ext>
              </a:extLst>
            </p:cNvPr>
            <p:cNvSpPr/>
            <p:nvPr/>
          </p:nvSpPr>
          <p:spPr>
            <a:xfrm>
              <a:off x="5215945" y="4321929"/>
              <a:ext cx="218839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  <p:sp>
          <p:nvSpPr>
            <p:cNvPr id="252" name="rc57">
              <a:extLst>
                <a:ext uri="{FF2B5EF4-FFF2-40B4-BE49-F238E27FC236}">
                  <a16:creationId xmlns:a16="http://schemas.microsoft.com/office/drawing/2014/main" id="{7597E5A6-75BA-011D-B555-FBDB13827AD9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53" name="rc58">
              <a:extLst>
                <a:ext uri="{FF2B5EF4-FFF2-40B4-BE49-F238E27FC236}">
                  <a16:creationId xmlns:a16="http://schemas.microsoft.com/office/drawing/2014/main" id="{49F9D570-9942-C1A6-E950-F72BE18AA441}"/>
                </a:ext>
              </a:extLst>
            </p:cNvPr>
            <p:cNvSpPr/>
            <p:nvPr/>
          </p:nvSpPr>
          <p:spPr>
            <a:xfrm>
              <a:off x="776476" y="4996549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254" name="tx59">
              <a:extLst>
                <a:ext uri="{FF2B5EF4-FFF2-40B4-BE49-F238E27FC236}">
                  <a16:creationId xmlns:a16="http://schemas.microsoft.com/office/drawing/2014/main" id="{644B97B6-1DD6-46D8-E57B-A9131492C38D}"/>
                </a:ext>
              </a:extLst>
            </p:cNvPr>
            <p:cNvSpPr/>
            <p:nvPr/>
          </p:nvSpPr>
          <p:spPr>
            <a:xfrm>
              <a:off x="1115323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55" name="tx60">
              <a:extLst>
                <a:ext uri="{FF2B5EF4-FFF2-40B4-BE49-F238E27FC236}">
                  <a16:creationId xmlns:a16="http://schemas.microsoft.com/office/drawing/2014/main" id="{64DA7757-22B0-02C5-93F4-111EF45F6EB4}"/>
                </a:ext>
              </a:extLst>
            </p:cNvPr>
            <p:cNvSpPr/>
            <p:nvPr/>
          </p:nvSpPr>
          <p:spPr>
            <a:xfrm>
              <a:off x="1080154" y="5132574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256" name="tx61">
              <a:extLst>
                <a:ext uri="{FF2B5EF4-FFF2-40B4-BE49-F238E27FC236}">
                  <a16:creationId xmlns:a16="http://schemas.microsoft.com/office/drawing/2014/main" id="{4E1BA382-FB17-36E1-C1C3-958ADBE67110}"/>
                </a:ext>
              </a:extLst>
            </p:cNvPr>
            <p:cNvSpPr/>
            <p:nvPr/>
          </p:nvSpPr>
          <p:spPr>
            <a:xfrm>
              <a:off x="3164724" y="5437853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257" name="tx62">
              <a:extLst>
                <a:ext uri="{FF2B5EF4-FFF2-40B4-BE49-F238E27FC236}">
                  <a16:creationId xmlns:a16="http://schemas.microsoft.com/office/drawing/2014/main" id="{EC459704-E5CE-25D3-4F57-F81B6C344E59}"/>
                </a:ext>
              </a:extLst>
            </p:cNvPr>
            <p:cNvSpPr/>
            <p:nvPr/>
          </p:nvSpPr>
          <p:spPr>
            <a:xfrm>
              <a:off x="3164724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258" name="tx63">
              <a:extLst>
                <a:ext uri="{FF2B5EF4-FFF2-40B4-BE49-F238E27FC236}">
                  <a16:creationId xmlns:a16="http://schemas.microsoft.com/office/drawing/2014/main" id="{4E3B1F02-6291-24D6-B1B1-FCDA9655EB24}"/>
                </a:ext>
              </a:extLst>
            </p:cNvPr>
            <p:cNvSpPr/>
            <p:nvPr/>
          </p:nvSpPr>
          <p:spPr>
            <a:xfrm>
              <a:off x="5214125" y="5439520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259" name="tx64">
              <a:extLst>
                <a:ext uri="{FF2B5EF4-FFF2-40B4-BE49-F238E27FC236}">
                  <a16:creationId xmlns:a16="http://schemas.microsoft.com/office/drawing/2014/main" id="{AAF8950F-F9DF-1D25-C7DA-F8F8AA215173}"/>
                </a:ext>
              </a:extLst>
            </p:cNvPr>
            <p:cNvSpPr/>
            <p:nvPr/>
          </p:nvSpPr>
          <p:spPr>
            <a:xfrm>
              <a:off x="5214125" y="5134117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260" name="tx65">
              <a:extLst>
                <a:ext uri="{FF2B5EF4-FFF2-40B4-BE49-F238E27FC236}">
                  <a16:creationId xmlns:a16="http://schemas.microsoft.com/office/drawing/2014/main" id="{EB45E362-BA00-0C19-A91C-E32FC5B128AD}"/>
                </a:ext>
              </a:extLst>
            </p:cNvPr>
            <p:cNvSpPr/>
            <p:nvPr/>
          </p:nvSpPr>
          <p:spPr>
            <a:xfrm>
              <a:off x="7263526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261" name="tx66">
              <a:extLst>
                <a:ext uri="{FF2B5EF4-FFF2-40B4-BE49-F238E27FC236}">
                  <a16:creationId xmlns:a16="http://schemas.microsoft.com/office/drawing/2014/main" id="{090E93F0-91F6-D07B-60D9-0FFE4DFFE4AF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62" name="tx67">
              <a:extLst>
                <a:ext uri="{FF2B5EF4-FFF2-40B4-BE49-F238E27FC236}">
                  <a16:creationId xmlns:a16="http://schemas.microsoft.com/office/drawing/2014/main" id="{59366635-6D00-6D76-7852-6DCC3D131DCB}"/>
                </a:ext>
              </a:extLst>
            </p:cNvPr>
            <p:cNvSpPr/>
            <p:nvPr/>
          </p:nvSpPr>
          <p:spPr>
            <a:xfrm>
              <a:off x="7263526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263" name="tx68">
              <a:extLst>
                <a:ext uri="{FF2B5EF4-FFF2-40B4-BE49-F238E27FC236}">
                  <a16:creationId xmlns:a16="http://schemas.microsoft.com/office/drawing/2014/main" id="{6149A768-60E7-E5E1-D072-5D5EEFB0D938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64" name="tx69">
              <a:extLst>
                <a:ext uri="{FF2B5EF4-FFF2-40B4-BE49-F238E27FC236}">
                  <a16:creationId xmlns:a16="http://schemas.microsoft.com/office/drawing/2014/main" id="{A03B39FE-3C7E-8DF4-BC8F-C8D44624CF62}"/>
                </a:ext>
              </a:extLst>
            </p:cNvPr>
            <p:cNvSpPr/>
            <p:nvPr/>
          </p:nvSpPr>
          <p:spPr>
            <a:xfrm>
              <a:off x="325591" y="5438152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265" name="tx70">
              <a:extLst>
                <a:ext uri="{FF2B5EF4-FFF2-40B4-BE49-F238E27FC236}">
                  <a16:creationId xmlns:a16="http://schemas.microsoft.com/office/drawing/2014/main" id="{469B578F-BCF1-28BE-8FA8-46ED274EAD2E}"/>
                </a:ext>
              </a:extLst>
            </p:cNvPr>
            <p:cNvSpPr/>
            <p:nvPr/>
          </p:nvSpPr>
          <p:spPr>
            <a:xfrm>
              <a:off x="311638" y="5132811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266" name="tx71">
              <a:extLst>
                <a:ext uri="{FF2B5EF4-FFF2-40B4-BE49-F238E27FC236}">
                  <a16:creationId xmlns:a16="http://schemas.microsoft.com/office/drawing/2014/main" id="{9FD3662A-B641-07A2-9971-C9819B05FC43}"/>
                </a:ext>
              </a:extLst>
            </p:cNvPr>
            <p:cNvSpPr/>
            <p:nvPr/>
          </p:nvSpPr>
          <p:spPr>
            <a:xfrm>
              <a:off x="776476" y="4827633"/>
              <a:ext cx="17452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267" name="rc72">
              <a:extLst>
                <a:ext uri="{FF2B5EF4-FFF2-40B4-BE49-F238E27FC236}">
                  <a16:creationId xmlns:a16="http://schemas.microsoft.com/office/drawing/2014/main" id="{3EAA9E00-C927-BA70-9ED4-5E755059E96A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268" name="rc73">
              <a:extLst>
                <a:ext uri="{FF2B5EF4-FFF2-40B4-BE49-F238E27FC236}">
                  <a16:creationId xmlns:a16="http://schemas.microsoft.com/office/drawing/2014/main" id="{864D24E2-44C0-B51E-FEB0-E2D0275D8ADC}"/>
                </a:ext>
              </a:extLst>
            </p:cNvPr>
            <p:cNvSpPr/>
            <p:nvPr/>
          </p:nvSpPr>
          <p:spPr>
            <a:xfrm>
              <a:off x="776476" y="6081865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269" name="tx74">
              <a:extLst>
                <a:ext uri="{FF2B5EF4-FFF2-40B4-BE49-F238E27FC236}">
                  <a16:creationId xmlns:a16="http://schemas.microsoft.com/office/drawing/2014/main" id="{FC2636BD-6D51-7402-562F-5D51FE64E075}"/>
                </a:ext>
              </a:extLst>
            </p:cNvPr>
            <p:cNvSpPr/>
            <p:nvPr/>
          </p:nvSpPr>
          <p:spPr>
            <a:xfrm>
              <a:off x="1115323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70" name="tx75">
              <a:extLst>
                <a:ext uri="{FF2B5EF4-FFF2-40B4-BE49-F238E27FC236}">
                  <a16:creationId xmlns:a16="http://schemas.microsoft.com/office/drawing/2014/main" id="{18C3C7AE-CFC1-C418-6FC4-1D565DDBA323}"/>
                </a:ext>
              </a:extLst>
            </p:cNvPr>
            <p:cNvSpPr/>
            <p:nvPr/>
          </p:nvSpPr>
          <p:spPr>
            <a:xfrm>
              <a:off x="1080154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1</a:t>
              </a:r>
            </a:p>
          </p:txBody>
        </p:sp>
        <p:sp>
          <p:nvSpPr>
            <p:cNvPr id="271" name="tx76">
              <a:extLst>
                <a:ext uri="{FF2B5EF4-FFF2-40B4-BE49-F238E27FC236}">
                  <a16:creationId xmlns:a16="http://schemas.microsoft.com/office/drawing/2014/main" id="{65FA263F-B7D4-3AA5-396F-866E14560C30}"/>
                </a:ext>
              </a:extLst>
            </p:cNvPr>
            <p:cNvSpPr/>
            <p:nvPr/>
          </p:nvSpPr>
          <p:spPr>
            <a:xfrm>
              <a:off x="3129555" y="6524775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2</a:t>
              </a:r>
            </a:p>
          </p:txBody>
        </p:sp>
        <p:sp>
          <p:nvSpPr>
            <p:cNvPr id="272" name="tx77">
              <a:extLst>
                <a:ext uri="{FF2B5EF4-FFF2-40B4-BE49-F238E27FC236}">
                  <a16:creationId xmlns:a16="http://schemas.microsoft.com/office/drawing/2014/main" id="{5C9F914A-83D7-9160-FA80-C6C4DDFB24F3}"/>
                </a:ext>
              </a:extLst>
            </p:cNvPr>
            <p:cNvSpPr/>
            <p:nvPr/>
          </p:nvSpPr>
          <p:spPr>
            <a:xfrm>
              <a:off x="3129555" y="6217890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6</a:t>
              </a:r>
            </a:p>
          </p:txBody>
        </p:sp>
        <p:sp>
          <p:nvSpPr>
            <p:cNvPr id="273" name="tx78">
              <a:extLst>
                <a:ext uri="{FF2B5EF4-FFF2-40B4-BE49-F238E27FC236}">
                  <a16:creationId xmlns:a16="http://schemas.microsoft.com/office/drawing/2014/main" id="{8E336109-32D8-4476-E97B-FE452EF0E9D0}"/>
                </a:ext>
              </a:extLst>
            </p:cNvPr>
            <p:cNvSpPr/>
            <p:nvPr/>
          </p:nvSpPr>
          <p:spPr>
            <a:xfrm>
              <a:off x="5178956" y="6523231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9</a:t>
              </a:r>
            </a:p>
          </p:txBody>
        </p:sp>
        <p:sp>
          <p:nvSpPr>
            <p:cNvPr id="274" name="tx79">
              <a:extLst>
                <a:ext uri="{FF2B5EF4-FFF2-40B4-BE49-F238E27FC236}">
                  <a16:creationId xmlns:a16="http://schemas.microsoft.com/office/drawing/2014/main" id="{F3364B00-86A5-CA25-241F-57DF0F21AE73}"/>
                </a:ext>
              </a:extLst>
            </p:cNvPr>
            <p:cNvSpPr/>
            <p:nvPr/>
          </p:nvSpPr>
          <p:spPr>
            <a:xfrm>
              <a:off x="5214125" y="6217890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</a:t>
              </a:r>
            </a:p>
          </p:txBody>
        </p:sp>
        <p:sp>
          <p:nvSpPr>
            <p:cNvPr id="275" name="tx80">
              <a:extLst>
                <a:ext uri="{FF2B5EF4-FFF2-40B4-BE49-F238E27FC236}">
                  <a16:creationId xmlns:a16="http://schemas.microsoft.com/office/drawing/2014/main" id="{FAC8DE91-1E6E-7D78-2D67-279F41B73279}"/>
                </a:ext>
              </a:extLst>
            </p:cNvPr>
            <p:cNvSpPr/>
            <p:nvPr/>
          </p:nvSpPr>
          <p:spPr>
            <a:xfrm>
              <a:off x="7228357" y="6523169"/>
              <a:ext cx="140675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1</a:t>
              </a:r>
            </a:p>
          </p:txBody>
        </p:sp>
        <p:sp>
          <p:nvSpPr>
            <p:cNvPr id="276" name="tx81">
              <a:extLst>
                <a:ext uri="{FF2B5EF4-FFF2-40B4-BE49-F238E27FC236}">
                  <a16:creationId xmlns:a16="http://schemas.microsoft.com/office/drawing/2014/main" id="{BCA5B2FC-2E9C-830B-4ACA-34A97BB0339D}"/>
                </a:ext>
              </a:extLst>
            </p:cNvPr>
            <p:cNvSpPr/>
            <p:nvPr/>
          </p:nvSpPr>
          <p:spPr>
            <a:xfrm>
              <a:off x="7263526" y="6220978"/>
              <a:ext cx="70337" cy="8935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</a:t>
              </a:r>
            </a:p>
          </p:txBody>
        </p:sp>
        <p:sp>
          <p:nvSpPr>
            <p:cNvPr id="277" name="tx82">
              <a:extLst>
                <a:ext uri="{FF2B5EF4-FFF2-40B4-BE49-F238E27FC236}">
                  <a16:creationId xmlns:a16="http://schemas.microsoft.com/office/drawing/2014/main" id="{EAA1117D-564D-E095-F321-DD401DFE9FE4}"/>
                </a:ext>
              </a:extLst>
            </p:cNvPr>
            <p:cNvSpPr/>
            <p:nvPr/>
          </p:nvSpPr>
          <p:spPr>
            <a:xfrm>
              <a:off x="325591" y="6523468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278" name="tx83">
              <a:extLst>
                <a:ext uri="{FF2B5EF4-FFF2-40B4-BE49-F238E27FC236}">
                  <a16:creationId xmlns:a16="http://schemas.microsoft.com/office/drawing/2014/main" id="{139F2701-9CF0-6477-242B-B084F749FEC6}"/>
                </a:ext>
              </a:extLst>
            </p:cNvPr>
            <p:cNvSpPr/>
            <p:nvPr/>
          </p:nvSpPr>
          <p:spPr>
            <a:xfrm>
              <a:off x="311638" y="6218127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279" name="tx84">
              <a:extLst>
                <a:ext uri="{FF2B5EF4-FFF2-40B4-BE49-F238E27FC236}">
                  <a16:creationId xmlns:a16="http://schemas.microsoft.com/office/drawing/2014/main" id="{18F1C607-4184-9EAC-84D2-AF201BBA9A34}"/>
                </a:ext>
              </a:extLst>
            </p:cNvPr>
            <p:cNvSpPr/>
            <p:nvPr/>
          </p:nvSpPr>
          <p:spPr>
            <a:xfrm>
              <a:off x="776476" y="5912949"/>
              <a:ext cx="23525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</p:grpSp>
      <p:sp>
        <p:nvSpPr>
          <p:cNvPr id="280" name="TextBox 279">
            <a:extLst>
              <a:ext uri="{FF2B5EF4-FFF2-40B4-BE49-F238E27FC236}">
                <a16:creationId xmlns:a16="http://schemas.microsoft.com/office/drawing/2014/main" id="{0B724F2E-34FA-2973-DF55-9A38E0C4DD16}"/>
              </a:ext>
            </a:extLst>
          </p:cNvPr>
          <p:cNvSpPr txBox="1"/>
          <p:nvPr/>
        </p:nvSpPr>
        <p:spPr>
          <a:xfrm>
            <a:off x="5475876" y="1740105"/>
            <a:ext cx="2877987" cy="7287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7" b="1" dirty="0">
                <a:latin typeface="Arial" panose="020B0604020202020204" pitchFamily="34" charset="0"/>
                <a:cs typeface="Arial" panose="020B0604020202020204" pitchFamily="34" charset="0"/>
              </a:rPr>
              <a:t>Potential Living Donor Total   Event   HR (95% CI)</a:t>
            </a:r>
          </a:p>
          <a:p>
            <a:r>
              <a:rPr lang="en-US" sz="827" dirty="0">
                <a:latin typeface="Arial" panose="020B0604020202020204" pitchFamily="34" charset="0"/>
                <a:cs typeface="Arial" panose="020B0604020202020204" pitchFamily="34" charset="0"/>
              </a:rPr>
              <a:t>No                                     10         6         Reference</a:t>
            </a:r>
          </a:p>
          <a:p>
            <a:r>
              <a:rPr lang="en-US" sz="827" dirty="0">
                <a:latin typeface="Arial" panose="020B0604020202020204" pitchFamily="34" charset="0"/>
                <a:cs typeface="Arial" panose="020B0604020202020204" pitchFamily="34" charset="0"/>
              </a:rPr>
              <a:t>Yes                                    41        31       1.80 (0.79 – 4.09)</a:t>
            </a:r>
          </a:p>
          <a:p>
            <a:r>
              <a:rPr lang="en-US" sz="827" dirty="0">
                <a:latin typeface="Arial" panose="020B0604020202020204" pitchFamily="34" charset="0"/>
                <a:cs typeface="Arial" panose="020B0604020202020204" pitchFamily="34" charset="0"/>
              </a:rPr>
              <a:t>Gray K-Sample Test P-value: 0.2757</a:t>
            </a:r>
          </a:p>
        </p:txBody>
      </p:sp>
      <p:sp>
        <p:nvSpPr>
          <p:cNvPr id="281" name="pl48">
            <a:extLst>
              <a:ext uri="{FF2B5EF4-FFF2-40B4-BE49-F238E27FC236}">
                <a16:creationId xmlns:a16="http://schemas.microsoft.com/office/drawing/2014/main" id="{4DF9033F-C0F3-176C-80BD-C4AE905FC809}"/>
              </a:ext>
            </a:extLst>
          </p:cNvPr>
          <p:cNvSpPr/>
          <p:nvPr/>
        </p:nvSpPr>
        <p:spPr>
          <a:xfrm>
            <a:off x="2744082" y="2002920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282" name="pl50">
            <a:extLst>
              <a:ext uri="{FF2B5EF4-FFF2-40B4-BE49-F238E27FC236}">
                <a16:creationId xmlns:a16="http://schemas.microsoft.com/office/drawing/2014/main" id="{6D4E9F13-631D-D3C7-EFB5-9B4E9599ECBF}"/>
              </a:ext>
            </a:extLst>
          </p:cNvPr>
          <p:cNvSpPr/>
          <p:nvPr/>
        </p:nvSpPr>
        <p:spPr>
          <a:xfrm>
            <a:off x="2758554" y="2149445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grpSp>
        <p:nvGrpSpPr>
          <p:cNvPr id="283" name="Group 282">
            <a:extLst>
              <a:ext uri="{FF2B5EF4-FFF2-40B4-BE49-F238E27FC236}">
                <a16:creationId xmlns:a16="http://schemas.microsoft.com/office/drawing/2014/main" id="{E026F1CB-A214-009D-A5E6-4576CB484A38}"/>
              </a:ext>
            </a:extLst>
          </p:cNvPr>
          <p:cNvGrpSpPr>
            <a:grpSpLocks noChangeAspect="1"/>
          </p:cNvGrpSpPr>
          <p:nvPr/>
        </p:nvGrpSpPr>
        <p:grpSpPr>
          <a:xfrm>
            <a:off x="97374" y="1582296"/>
            <a:ext cx="4614334" cy="3571875"/>
            <a:chOff x="0" y="0"/>
            <a:chExt cx="9144000" cy="6858000"/>
          </a:xfrm>
        </p:grpSpPr>
        <p:sp>
          <p:nvSpPr>
            <p:cNvPr id="303" name="rc3">
              <a:extLst>
                <a:ext uri="{FF2B5EF4-FFF2-40B4-BE49-F238E27FC236}">
                  <a16:creationId xmlns:a16="http://schemas.microsoft.com/office/drawing/2014/main" id="{C49CFA44-02AE-4F77-F4C7-BF4CF399FBAD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04" name="rc4">
              <a:extLst>
                <a:ext uri="{FF2B5EF4-FFF2-40B4-BE49-F238E27FC236}">
                  <a16:creationId xmlns:a16="http://schemas.microsoft.com/office/drawing/2014/main" id="{325FDC16-25A3-069C-A523-2AAFD2BD1443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05" name="rc5">
              <a:extLst>
                <a:ext uri="{FF2B5EF4-FFF2-40B4-BE49-F238E27FC236}">
                  <a16:creationId xmlns:a16="http://schemas.microsoft.com/office/drawing/2014/main" id="{3E655C59-072A-1E75-F364-57C6F5641328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06" name="rc6">
              <a:extLst>
                <a:ext uri="{FF2B5EF4-FFF2-40B4-BE49-F238E27FC236}">
                  <a16:creationId xmlns:a16="http://schemas.microsoft.com/office/drawing/2014/main" id="{646D238C-873A-F1F1-48C9-F5E96E370AC2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07" name="rc7">
              <a:extLst>
                <a:ext uri="{FF2B5EF4-FFF2-40B4-BE49-F238E27FC236}">
                  <a16:creationId xmlns:a16="http://schemas.microsoft.com/office/drawing/2014/main" id="{C1434FC7-6718-45CD-64B2-090F0DF5D291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08" name="rc8">
              <a:extLst>
                <a:ext uri="{FF2B5EF4-FFF2-40B4-BE49-F238E27FC236}">
                  <a16:creationId xmlns:a16="http://schemas.microsoft.com/office/drawing/2014/main" id="{BDE578F8-0DF1-0F6F-EAA3-5B426019242F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53" name="rc9">
              <a:extLst>
                <a:ext uri="{FF2B5EF4-FFF2-40B4-BE49-F238E27FC236}">
                  <a16:creationId xmlns:a16="http://schemas.microsoft.com/office/drawing/2014/main" id="{C3D5337C-2522-9D88-2C32-60F3143981BF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354" name="pl18">
              <a:extLst>
                <a:ext uri="{FF2B5EF4-FFF2-40B4-BE49-F238E27FC236}">
                  <a16:creationId xmlns:a16="http://schemas.microsoft.com/office/drawing/2014/main" id="{607FC622-259C-E82D-C47A-E3FE9309DDED}"/>
                </a:ext>
              </a:extLst>
            </p:cNvPr>
            <p:cNvSpPr/>
            <p:nvPr/>
          </p:nvSpPr>
          <p:spPr>
            <a:xfrm>
              <a:off x="776476" y="3534137"/>
              <a:ext cx="8228345" cy="0"/>
            </a:xfrm>
            <a:custGeom>
              <a:avLst/>
              <a:gdLst/>
              <a:ahLst/>
              <a:cxnLst/>
              <a:rect l="0" t="0" r="0" b="0"/>
              <a:pathLst>
                <a:path w="8228345">
                  <a:moveTo>
                    <a:pt x="0" y="0"/>
                  </a:moveTo>
                  <a:lnTo>
                    <a:pt x="8228345" y="0"/>
                  </a:lnTo>
                  <a:lnTo>
                    <a:pt x="8228345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55" name="pl23">
              <a:extLst>
                <a:ext uri="{FF2B5EF4-FFF2-40B4-BE49-F238E27FC236}">
                  <a16:creationId xmlns:a16="http://schemas.microsoft.com/office/drawing/2014/main" id="{59B33B2F-83C0-51DF-9F05-648E91BB29EA}"/>
                </a:ext>
              </a:extLst>
            </p:cNvPr>
            <p:cNvSpPr/>
            <p:nvPr/>
          </p:nvSpPr>
          <p:spPr>
            <a:xfrm>
              <a:off x="1150492" y="139178"/>
              <a:ext cx="0" cy="3556623"/>
            </a:xfrm>
            <a:custGeom>
              <a:avLst/>
              <a:gdLst/>
              <a:ahLst/>
              <a:cxnLst/>
              <a:rect l="0" t="0" r="0" b="0"/>
              <a:pathLst>
                <a:path h="3556623">
                  <a:moveTo>
                    <a:pt x="0" y="35566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56" name="pl27">
              <a:extLst>
                <a:ext uri="{FF2B5EF4-FFF2-40B4-BE49-F238E27FC236}">
                  <a16:creationId xmlns:a16="http://schemas.microsoft.com/office/drawing/2014/main" id="{EA6CE1CC-9665-FF53-FB67-F134C9E65364}"/>
                </a:ext>
              </a:extLst>
            </p:cNvPr>
            <p:cNvSpPr/>
            <p:nvPr/>
          </p:nvSpPr>
          <p:spPr>
            <a:xfrm>
              <a:off x="1150492" y="2263914"/>
              <a:ext cx="6209685" cy="1270222"/>
            </a:xfrm>
            <a:custGeom>
              <a:avLst/>
              <a:gdLst/>
              <a:ahLst/>
              <a:cxnLst/>
              <a:rect l="0" t="0" r="0" b="0"/>
              <a:pathLst>
                <a:path w="6209685" h="1270222">
                  <a:moveTo>
                    <a:pt x="0" y="1270222"/>
                  </a:moveTo>
                  <a:lnTo>
                    <a:pt x="61482" y="1270222"/>
                  </a:lnTo>
                  <a:lnTo>
                    <a:pt x="61482" y="1068141"/>
                  </a:lnTo>
                  <a:lnTo>
                    <a:pt x="184446" y="1068141"/>
                  </a:lnTo>
                  <a:lnTo>
                    <a:pt x="184446" y="866061"/>
                  </a:lnTo>
                  <a:lnTo>
                    <a:pt x="317657" y="866061"/>
                  </a:lnTo>
                  <a:lnTo>
                    <a:pt x="317657" y="461899"/>
                  </a:lnTo>
                  <a:lnTo>
                    <a:pt x="389386" y="461899"/>
                  </a:lnTo>
                  <a:lnTo>
                    <a:pt x="389386" y="259818"/>
                  </a:lnTo>
                  <a:lnTo>
                    <a:pt x="440621" y="259818"/>
                  </a:lnTo>
                  <a:lnTo>
                    <a:pt x="440621" y="259818"/>
                  </a:lnTo>
                  <a:lnTo>
                    <a:pt x="809513" y="259818"/>
                  </a:lnTo>
                  <a:lnTo>
                    <a:pt x="809513" y="259818"/>
                  </a:lnTo>
                  <a:lnTo>
                    <a:pt x="1619026" y="259818"/>
                  </a:lnTo>
                  <a:lnTo>
                    <a:pt x="1619026" y="259818"/>
                  </a:lnTo>
                  <a:lnTo>
                    <a:pt x="1834213" y="259818"/>
                  </a:lnTo>
                  <a:lnTo>
                    <a:pt x="1834213" y="259818"/>
                  </a:lnTo>
                  <a:lnTo>
                    <a:pt x="2490022" y="259818"/>
                  </a:lnTo>
                  <a:lnTo>
                    <a:pt x="2490022" y="259818"/>
                  </a:lnTo>
                  <a:lnTo>
                    <a:pt x="2520763" y="259818"/>
                  </a:lnTo>
                  <a:lnTo>
                    <a:pt x="2520763" y="0"/>
                  </a:lnTo>
                  <a:lnTo>
                    <a:pt x="3340523" y="0"/>
                  </a:lnTo>
                  <a:lnTo>
                    <a:pt x="3340523" y="0"/>
                  </a:lnTo>
                  <a:lnTo>
                    <a:pt x="4324236" y="0"/>
                  </a:lnTo>
                  <a:lnTo>
                    <a:pt x="4324236" y="0"/>
                  </a:lnTo>
                  <a:lnTo>
                    <a:pt x="4672634" y="0"/>
                  </a:lnTo>
                  <a:lnTo>
                    <a:pt x="4672634" y="0"/>
                  </a:lnTo>
                  <a:lnTo>
                    <a:pt x="6209685" y="0"/>
                  </a:lnTo>
                  <a:lnTo>
                    <a:pt x="6209685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57" name="pl28">
              <a:extLst>
                <a:ext uri="{FF2B5EF4-FFF2-40B4-BE49-F238E27FC236}">
                  <a16:creationId xmlns:a16="http://schemas.microsoft.com/office/drawing/2014/main" id="{EF142C34-2B95-816D-67FC-BB50B0A975CF}"/>
                </a:ext>
              </a:extLst>
            </p:cNvPr>
            <p:cNvSpPr/>
            <p:nvPr/>
          </p:nvSpPr>
          <p:spPr>
            <a:xfrm>
              <a:off x="1150492" y="1200502"/>
              <a:ext cx="6527342" cy="2333634"/>
            </a:xfrm>
            <a:custGeom>
              <a:avLst/>
              <a:gdLst/>
              <a:ahLst/>
              <a:cxnLst/>
              <a:rect l="0" t="0" r="0" b="0"/>
              <a:pathLst>
                <a:path w="6527342" h="2333634">
                  <a:moveTo>
                    <a:pt x="0" y="2333634"/>
                  </a:moveTo>
                  <a:lnTo>
                    <a:pt x="10247" y="2333634"/>
                  </a:lnTo>
                  <a:lnTo>
                    <a:pt x="10247" y="2291643"/>
                  </a:lnTo>
                  <a:lnTo>
                    <a:pt x="61482" y="2291643"/>
                  </a:lnTo>
                  <a:lnTo>
                    <a:pt x="61482" y="2249652"/>
                  </a:lnTo>
                  <a:lnTo>
                    <a:pt x="204940" y="2249652"/>
                  </a:lnTo>
                  <a:lnTo>
                    <a:pt x="204940" y="2165671"/>
                  </a:lnTo>
                  <a:lnTo>
                    <a:pt x="266422" y="2165671"/>
                  </a:lnTo>
                  <a:lnTo>
                    <a:pt x="266422" y="2165671"/>
                  </a:lnTo>
                  <a:lnTo>
                    <a:pt x="286916" y="2165671"/>
                  </a:lnTo>
                  <a:lnTo>
                    <a:pt x="286916" y="2123097"/>
                  </a:lnTo>
                  <a:lnTo>
                    <a:pt x="338151" y="2123097"/>
                  </a:lnTo>
                  <a:lnTo>
                    <a:pt x="338151" y="2123097"/>
                  </a:lnTo>
                  <a:lnTo>
                    <a:pt x="389386" y="2123097"/>
                  </a:lnTo>
                  <a:lnTo>
                    <a:pt x="389386" y="2080523"/>
                  </a:lnTo>
                  <a:lnTo>
                    <a:pt x="430374" y="2080523"/>
                  </a:lnTo>
                  <a:lnTo>
                    <a:pt x="430374" y="2037948"/>
                  </a:lnTo>
                  <a:lnTo>
                    <a:pt x="440621" y="2037948"/>
                  </a:lnTo>
                  <a:lnTo>
                    <a:pt x="440621" y="2037948"/>
                  </a:lnTo>
                  <a:lnTo>
                    <a:pt x="471362" y="2037948"/>
                  </a:lnTo>
                  <a:lnTo>
                    <a:pt x="471362" y="1995374"/>
                  </a:lnTo>
                  <a:lnTo>
                    <a:pt x="491856" y="1995374"/>
                  </a:lnTo>
                  <a:lnTo>
                    <a:pt x="491856" y="1952800"/>
                  </a:lnTo>
                  <a:lnTo>
                    <a:pt x="502103" y="1952800"/>
                  </a:lnTo>
                  <a:lnTo>
                    <a:pt x="502103" y="1910226"/>
                  </a:lnTo>
                  <a:lnTo>
                    <a:pt x="532844" y="1910226"/>
                  </a:lnTo>
                  <a:lnTo>
                    <a:pt x="532844" y="1910226"/>
                  </a:lnTo>
                  <a:lnTo>
                    <a:pt x="635314" y="1910226"/>
                  </a:lnTo>
                  <a:lnTo>
                    <a:pt x="635314" y="1866966"/>
                  </a:lnTo>
                  <a:lnTo>
                    <a:pt x="645561" y="1866966"/>
                  </a:lnTo>
                  <a:lnTo>
                    <a:pt x="645561" y="1823705"/>
                  </a:lnTo>
                  <a:lnTo>
                    <a:pt x="717290" y="1823705"/>
                  </a:lnTo>
                  <a:lnTo>
                    <a:pt x="717290" y="1780444"/>
                  </a:lnTo>
                  <a:lnTo>
                    <a:pt x="789019" y="1780444"/>
                  </a:lnTo>
                  <a:lnTo>
                    <a:pt x="789019" y="1737183"/>
                  </a:lnTo>
                  <a:lnTo>
                    <a:pt x="840254" y="1737183"/>
                  </a:lnTo>
                  <a:lnTo>
                    <a:pt x="840254" y="1737183"/>
                  </a:lnTo>
                  <a:lnTo>
                    <a:pt x="860748" y="1737183"/>
                  </a:lnTo>
                  <a:lnTo>
                    <a:pt x="860748" y="1693923"/>
                  </a:lnTo>
                  <a:lnTo>
                    <a:pt x="901736" y="1693923"/>
                  </a:lnTo>
                  <a:lnTo>
                    <a:pt x="901736" y="1607401"/>
                  </a:lnTo>
                  <a:lnTo>
                    <a:pt x="942724" y="1607401"/>
                  </a:lnTo>
                  <a:lnTo>
                    <a:pt x="942724" y="1564141"/>
                  </a:lnTo>
                  <a:lnTo>
                    <a:pt x="1065688" y="1564141"/>
                  </a:lnTo>
                  <a:lnTo>
                    <a:pt x="1065688" y="1520880"/>
                  </a:lnTo>
                  <a:lnTo>
                    <a:pt x="1096429" y="1520880"/>
                  </a:lnTo>
                  <a:lnTo>
                    <a:pt x="1096429" y="1477619"/>
                  </a:lnTo>
                  <a:lnTo>
                    <a:pt x="1116923" y="1477619"/>
                  </a:lnTo>
                  <a:lnTo>
                    <a:pt x="1116923" y="1434358"/>
                  </a:lnTo>
                  <a:lnTo>
                    <a:pt x="1157911" y="1434358"/>
                  </a:lnTo>
                  <a:lnTo>
                    <a:pt x="1157911" y="1391098"/>
                  </a:lnTo>
                  <a:lnTo>
                    <a:pt x="1168158" y="1391098"/>
                  </a:lnTo>
                  <a:lnTo>
                    <a:pt x="1168158" y="1347837"/>
                  </a:lnTo>
                  <a:lnTo>
                    <a:pt x="1178405" y="1347837"/>
                  </a:lnTo>
                  <a:lnTo>
                    <a:pt x="1178405" y="1304576"/>
                  </a:lnTo>
                  <a:lnTo>
                    <a:pt x="1250134" y="1304576"/>
                  </a:lnTo>
                  <a:lnTo>
                    <a:pt x="1250134" y="1261315"/>
                  </a:lnTo>
                  <a:lnTo>
                    <a:pt x="1280875" y="1261315"/>
                  </a:lnTo>
                  <a:lnTo>
                    <a:pt x="1280875" y="1218055"/>
                  </a:lnTo>
                  <a:lnTo>
                    <a:pt x="1291122" y="1218055"/>
                  </a:lnTo>
                  <a:lnTo>
                    <a:pt x="1291122" y="1174794"/>
                  </a:lnTo>
                  <a:lnTo>
                    <a:pt x="1332110" y="1174794"/>
                  </a:lnTo>
                  <a:lnTo>
                    <a:pt x="1332110" y="1174794"/>
                  </a:lnTo>
                  <a:lnTo>
                    <a:pt x="1434580" y="1174794"/>
                  </a:lnTo>
                  <a:lnTo>
                    <a:pt x="1434580" y="1131533"/>
                  </a:lnTo>
                  <a:lnTo>
                    <a:pt x="1485815" y="1131533"/>
                  </a:lnTo>
                  <a:lnTo>
                    <a:pt x="1485815" y="1088273"/>
                  </a:lnTo>
                  <a:lnTo>
                    <a:pt x="1547297" y="1088273"/>
                  </a:lnTo>
                  <a:lnTo>
                    <a:pt x="1547297" y="1045012"/>
                  </a:lnTo>
                  <a:lnTo>
                    <a:pt x="1711249" y="1045012"/>
                  </a:lnTo>
                  <a:lnTo>
                    <a:pt x="1711249" y="958490"/>
                  </a:lnTo>
                  <a:lnTo>
                    <a:pt x="1731743" y="958490"/>
                  </a:lnTo>
                  <a:lnTo>
                    <a:pt x="1731743" y="915230"/>
                  </a:lnTo>
                  <a:lnTo>
                    <a:pt x="1741990" y="915230"/>
                  </a:lnTo>
                  <a:lnTo>
                    <a:pt x="1741990" y="871969"/>
                  </a:lnTo>
                  <a:lnTo>
                    <a:pt x="1752237" y="871969"/>
                  </a:lnTo>
                  <a:lnTo>
                    <a:pt x="1752237" y="871969"/>
                  </a:lnTo>
                  <a:lnTo>
                    <a:pt x="1905942" y="871969"/>
                  </a:lnTo>
                  <a:lnTo>
                    <a:pt x="1905942" y="827472"/>
                  </a:lnTo>
                  <a:lnTo>
                    <a:pt x="1936683" y="827472"/>
                  </a:lnTo>
                  <a:lnTo>
                    <a:pt x="1936683" y="827472"/>
                  </a:lnTo>
                  <a:lnTo>
                    <a:pt x="1957177" y="827472"/>
                  </a:lnTo>
                  <a:lnTo>
                    <a:pt x="1957177" y="781627"/>
                  </a:lnTo>
                  <a:lnTo>
                    <a:pt x="2121130" y="781627"/>
                  </a:lnTo>
                  <a:lnTo>
                    <a:pt x="2121130" y="735782"/>
                  </a:lnTo>
                  <a:lnTo>
                    <a:pt x="2244094" y="735782"/>
                  </a:lnTo>
                  <a:lnTo>
                    <a:pt x="2244094" y="689937"/>
                  </a:lnTo>
                  <a:lnTo>
                    <a:pt x="2356811" y="689937"/>
                  </a:lnTo>
                  <a:lnTo>
                    <a:pt x="2356811" y="689937"/>
                  </a:lnTo>
                  <a:lnTo>
                    <a:pt x="2367058" y="689937"/>
                  </a:lnTo>
                  <a:lnTo>
                    <a:pt x="2367058" y="642454"/>
                  </a:lnTo>
                  <a:lnTo>
                    <a:pt x="2418293" y="642454"/>
                  </a:lnTo>
                  <a:lnTo>
                    <a:pt x="2418293" y="594972"/>
                  </a:lnTo>
                  <a:lnTo>
                    <a:pt x="2571998" y="594972"/>
                  </a:lnTo>
                  <a:lnTo>
                    <a:pt x="2571998" y="547490"/>
                  </a:lnTo>
                  <a:lnTo>
                    <a:pt x="2705209" y="547490"/>
                  </a:lnTo>
                  <a:lnTo>
                    <a:pt x="2705209" y="500007"/>
                  </a:lnTo>
                  <a:lnTo>
                    <a:pt x="2725703" y="500007"/>
                  </a:lnTo>
                  <a:lnTo>
                    <a:pt x="2725703" y="452525"/>
                  </a:lnTo>
                  <a:lnTo>
                    <a:pt x="2787185" y="452525"/>
                  </a:lnTo>
                  <a:lnTo>
                    <a:pt x="2787185" y="405042"/>
                  </a:lnTo>
                  <a:lnTo>
                    <a:pt x="3002372" y="405042"/>
                  </a:lnTo>
                  <a:lnTo>
                    <a:pt x="3002372" y="357560"/>
                  </a:lnTo>
                  <a:lnTo>
                    <a:pt x="3279041" y="357560"/>
                  </a:lnTo>
                  <a:lnTo>
                    <a:pt x="3279041" y="357560"/>
                  </a:lnTo>
                  <a:lnTo>
                    <a:pt x="3340523" y="357560"/>
                  </a:lnTo>
                  <a:lnTo>
                    <a:pt x="3340523" y="307578"/>
                  </a:lnTo>
                  <a:lnTo>
                    <a:pt x="3945096" y="307578"/>
                  </a:lnTo>
                  <a:lnTo>
                    <a:pt x="3945096" y="257597"/>
                  </a:lnTo>
                  <a:lnTo>
                    <a:pt x="4590658" y="257597"/>
                  </a:lnTo>
                  <a:lnTo>
                    <a:pt x="4590658" y="157634"/>
                  </a:lnTo>
                  <a:lnTo>
                    <a:pt x="4877574" y="157634"/>
                  </a:lnTo>
                  <a:lnTo>
                    <a:pt x="4877574" y="107652"/>
                  </a:lnTo>
                  <a:lnTo>
                    <a:pt x="5512888" y="107652"/>
                  </a:lnTo>
                  <a:lnTo>
                    <a:pt x="5512888" y="107652"/>
                  </a:lnTo>
                  <a:lnTo>
                    <a:pt x="5994498" y="107652"/>
                  </a:lnTo>
                  <a:lnTo>
                    <a:pt x="5994498" y="53826"/>
                  </a:lnTo>
                  <a:lnTo>
                    <a:pt x="6045733" y="53826"/>
                  </a:lnTo>
                  <a:lnTo>
                    <a:pt x="6045733" y="0"/>
                  </a:lnTo>
                  <a:lnTo>
                    <a:pt x="6301908" y="0"/>
                  </a:lnTo>
                  <a:lnTo>
                    <a:pt x="6301908" y="0"/>
                  </a:lnTo>
                  <a:lnTo>
                    <a:pt x="6527342" y="0"/>
                  </a:lnTo>
                  <a:lnTo>
                    <a:pt x="6527342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58" name="rc29">
              <a:extLst>
                <a:ext uri="{FF2B5EF4-FFF2-40B4-BE49-F238E27FC236}">
                  <a16:creationId xmlns:a16="http://schemas.microsoft.com/office/drawing/2014/main" id="{9E62908F-587B-AB81-FCA2-A7117ADBF39F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59" name="tx30">
              <a:extLst>
                <a:ext uri="{FF2B5EF4-FFF2-40B4-BE49-F238E27FC236}">
                  <a16:creationId xmlns:a16="http://schemas.microsoft.com/office/drawing/2014/main" id="{3CDDAF6D-8F6C-27A8-5FD9-8915E3AE7AF7}"/>
                </a:ext>
              </a:extLst>
            </p:cNvPr>
            <p:cNvSpPr/>
            <p:nvPr/>
          </p:nvSpPr>
          <p:spPr>
            <a:xfrm>
              <a:off x="466667" y="3486760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360" name="tx31">
              <a:extLst>
                <a:ext uri="{FF2B5EF4-FFF2-40B4-BE49-F238E27FC236}">
                  <a16:creationId xmlns:a16="http://schemas.microsoft.com/office/drawing/2014/main" id="{E4B6F224-F782-AB38-EDB0-6062D3832E7B}"/>
                </a:ext>
              </a:extLst>
            </p:cNvPr>
            <p:cNvSpPr/>
            <p:nvPr/>
          </p:nvSpPr>
          <p:spPr>
            <a:xfrm>
              <a:off x="466667" y="2678436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361" name="tx32">
              <a:extLst>
                <a:ext uri="{FF2B5EF4-FFF2-40B4-BE49-F238E27FC236}">
                  <a16:creationId xmlns:a16="http://schemas.microsoft.com/office/drawing/2014/main" id="{FD3F8E88-9AB8-EAAE-1074-54843B23A375}"/>
                </a:ext>
              </a:extLst>
            </p:cNvPr>
            <p:cNvSpPr/>
            <p:nvPr/>
          </p:nvSpPr>
          <p:spPr>
            <a:xfrm>
              <a:off x="466667" y="1870113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362" name="tx33">
              <a:extLst>
                <a:ext uri="{FF2B5EF4-FFF2-40B4-BE49-F238E27FC236}">
                  <a16:creationId xmlns:a16="http://schemas.microsoft.com/office/drawing/2014/main" id="{63FF0EF2-B4F2-25BC-A00D-B6EF2B3CEFA3}"/>
                </a:ext>
              </a:extLst>
            </p:cNvPr>
            <p:cNvSpPr/>
            <p:nvPr/>
          </p:nvSpPr>
          <p:spPr>
            <a:xfrm>
              <a:off x="466667" y="1061789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363" name="tx34">
              <a:extLst>
                <a:ext uri="{FF2B5EF4-FFF2-40B4-BE49-F238E27FC236}">
                  <a16:creationId xmlns:a16="http://schemas.microsoft.com/office/drawing/2014/main" id="{DAE65779-F183-C5DA-8F7A-CAC465E8C3F2}"/>
                </a:ext>
              </a:extLst>
            </p:cNvPr>
            <p:cNvSpPr/>
            <p:nvPr/>
          </p:nvSpPr>
          <p:spPr>
            <a:xfrm>
              <a:off x="466667" y="253465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0</a:t>
              </a:r>
            </a:p>
          </p:txBody>
        </p:sp>
        <p:sp>
          <p:nvSpPr>
            <p:cNvPr id="364" name="pl35">
              <a:extLst>
                <a:ext uri="{FF2B5EF4-FFF2-40B4-BE49-F238E27FC236}">
                  <a16:creationId xmlns:a16="http://schemas.microsoft.com/office/drawing/2014/main" id="{0CDF44DC-8B6B-334D-7CCF-9CECF3DD3D07}"/>
                </a:ext>
              </a:extLst>
            </p:cNvPr>
            <p:cNvSpPr/>
            <p:nvPr/>
          </p:nvSpPr>
          <p:spPr>
            <a:xfrm>
              <a:off x="741682" y="353413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65" name="pl36">
              <a:extLst>
                <a:ext uri="{FF2B5EF4-FFF2-40B4-BE49-F238E27FC236}">
                  <a16:creationId xmlns:a16="http://schemas.microsoft.com/office/drawing/2014/main" id="{2A556187-0032-9765-3303-A85843717C78}"/>
                </a:ext>
              </a:extLst>
            </p:cNvPr>
            <p:cNvSpPr/>
            <p:nvPr/>
          </p:nvSpPr>
          <p:spPr>
            <a:xfrm>
              <a:off x="741682" y="2725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66" name="pl37">
              <a:extLst>
                <a:ext uri="{FF2B5EF4-FFF2-40B4-BE49-F238E27FC236}">
                  <a16:creationId xmlns:a16="http://schemas.microsoft.com/office/drawing/2014/main" id="{D4CCF4E1-C0BC-2E14-356A-C6EA7CFE58D9}"/>
                </a:ext>
              </a:extLst>
            </p:cNvPr>
            <p:cNvSpPr/>
            <p:nvPr/>
          </p:nvSpPr>
          <p:spPr>
            <a:xfrm>
              <a:off x="741682" y="19174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67" name="pl38">
              <a:extLst>
                <a:ext uri="{FF2B5EF4-FFF2-40B4-BE49-F238E27FC236}">
                  <a16:creationId xmlns:a16="http://schemas.microsoft.com/office/drawing/2014/main" id="{088BAB81-5BC0-1495-F868-9536138504D6}"/>
                </a:ext>
              </a:extLst>
            </p:cNvPr>
            <p:cNvSpPr/>
            <p:nvPr/>
          </p:nvSpPr>
          <p:spPr>
            <a:xfrm>
              <a:off x="741682" y="11091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68" name="pl39">
              <a:extLst>
                <a:ext uri="{FF2B5EF4-FFF2-40B4-BE49-F238E27FC236}">
                  <a16:creationId xmlns:a16="http://schemas.microsoft.com/office/drawing/2014/main" id="{EAF00863-94BA-ECE9-9341-053EC804855C}"/>
                </a:ext>
              </a:extLst>
            </p:cNvPr>
            <p:cNvSpPr/>
            <p:nvPr/>
          </p:nvSpPr>
          <p:spPr>
            <a:xfrm>
              <a:off x="741682" y="3008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69" name="pl40">
              <a:extLst>
                <a:ext uri="{FF2B5EF4-FFF2-40B4-BE49-F238E27FC236}">
                  <a16:creationId xmlns:a16="http://schemas.microsoft.com/office/drawing/2014/main" id="{6AF579BC-B4AC-2452-42C7-45EBB233E9A3}"/>
                </a:ext>
              </a:extLst>
            </p:cNvPr>
            <p:cNvSpPr/>
            <p:nvPr/>
          </p:nvSpPr>
          <p:spPr>
            <a:xfrm>
              <a:off x="1150492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70" name="pl41">
              <a:extLst>
                <a:ext uri="{FF2B5EF4-FFF2-40B4-BE49-F238E27FC236}">
                  <a16:creationId xmlns:a16="http://schemas.microsoft.com/office/drawing/2014/main" id="{A8F86FFA-AA1F-6650-06B6-6767777DDCC2}"/>
                </a:ext>
              </a:extLst>
            </p:cNvPr>
            <p:cNvSpPr/>
            <p:nvPr/>
          </p:nvSpPr>
          <p:spPr>
            <a:xfrm>
              <a:off x="3199893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71" name="pl42">
              <a:extLst>
                <a:ext uri="{FF2B5EF4-FFF2-40B4-BE49-F238E27FC236}">
                  <a16:creationId xmlns:a16="http://schemas.microsoft.com/office/drawing/2014/main" id="{6F56B5B0-F93F-BBCF-0EBA-25184B1D6BEC}"/>
                </a:ext>
              </a:extLst>
            </p:cNvPr>
            <p:cNvSpPr/>
            <p:nvPr/>
          </p:nvSpPr>
          <p:spPr>
            <a:xfrm>
              <a:off x="5249294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72" name="pl43">
              <a:extLst>
                <a:ext uri="{FF2B5EF4-FFF2-40B4-BE49-F238E27FC236}">
                  <a16:creationId xmlns:a16="http://schemas.microsoft.com/office/drawing/2014/main" id="{1900DF33-E1C4-2A2B-C5A6-5D0D8DE0CC39}"/>
                </a:ext>
              </a:extLst>
            </p:cNvPr>
            <p:cNvSpPr/>
            <p:nvPr/>
          </p:nvSpPr>
          <p:spPr>
            <a:xfrm>
              <a:off x="7298695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73" name="tx44">
              <a:extLst>
                <a:ext uri="{FF2B5EF4-FFF2-40B4-BE49-F238E27FC236}">
                  <a16:creationId xmlns:a16="http://schemas.microsoft.com/office/drawing/2014/main" id="{81FDD461-E85A-6DC3-C8BC-008685119D4A}"/>
                </a:ext>
              </a:extLst>
            </p:cNvPr>
            <p:cNvSpPr/>
            <p:nvPr/>
          </p:nvSpPr>
          <p:spPr>
            <a:xfrm>
              <a:off x="1115176" y="3756509"/>
              <a:ext cx="70631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74" name="tx45">
              <a:extLst>
                <a:ext uri="{FF2B5EF4-FFF2-40B4-BE49-F238E27FC236}">
                  <a16:creationId xmlns:a16="http://schemas.microsoft.com/office/drawing/2014/main" id="{11C72CDB-CC4E-D2B8-92A2-7559652A3125}"/>
                </a:ext>
              </a:extLst>
            </p:cNvPr>
            <p:cNvSpPr/>
            <p:nvPr/>
          </p:nvSpPr>
          <p:spPr>
            <a:xfrm>
              <a:off x="3093946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375" name="tx46">
              <a:extLst>
                <a:ext uri="{FF2B5EF4-FFF2-40B4-BE49-F238E27FC236}">
                  <a16:creationId xmlns:a16="http://schemas.microsoft.com/office/drawing/2014/main" id="{D3DBE425-285E-9BCB-F35F-6F870BCD4339}"/>
                </a:ext>
              </a:extLst>
            </p:cNvPr>
            <p:cNvSpPr/>
            <p:nvPr/>
          </p:nvSpPr>
          <p:spPr>
            <a:xfrm>
              <a:off x="5143347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376" name="tx47">
              <a:extLst>
                <a:ext uri="{FF2B5EF4-FFF2-40B4-BE49-F238E27FC236}">
                  <a16:creationId xmlns:a16="http://schemas.microsoft.com/office/drawing/2014/main" id="{0FE64D32-085B-0139-06C7-A87FB6CD138A}"/>
                </a:ext>
              </a:extLst>
            </p:cNvPr>
            <p:cNvSpPr/>
            <p:nvPr/>
          </p:nvSpPr>
          <p:spPr>
            <a:xfrm>
              <a:off x="7192748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377" name="tx48">
              <a:extLst>
                <a:ext uri="{FF2B5EF4-FFF2-40B4-BE49-F238E27FC236}">
                  <a16:creationId xmlns:a16="http://schemas.microsoft.com/office/drawing/2014/main" id="{9FD14639-05F0-B98A-7307-FF5FBC699E80}"/>
                </a:ext>
              </a:extLst>
            </p:cNvPr>
            <p:cNvSpPr/>
            <p:nvPr/>
          </p:nvSpPr>
          <p:spPr>
            <a:xfrm>
              <a:off x="4009884" y="3878778"/>
              <a:ext cx="1761529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 to Transplant (Days)</a:t>
              </a:r>
            </a:p>
          </p:txBody>
        </p:sp>
        <p:sp>
          <p:nvSpPr>
            <p:cNvPr id="378" name="tx49">
              <a:extLst>
                <a:ext uri="{FF2B5EF4-FFF2-40B4-BE49-F238E27FC236}">
                  <a16:creationId xmlns:a16="http://schemas.microsoft.com/office/drawing/2014/main" id="{A3B0A9DD-70D3-6934-E831-EC7F0B21AF25}"/>
                </a:ext>
              </a:extLst>
            </p:cNvPr>
            <p:cNvSpPr/>
            <p:nvPr/>
          </p:nvSpPr>
          <p:spPr>
            <a:xfrm rot="-5400000">
              <a:off x="-985888" y="1845978"/>
              <a:ext cx="2668190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umulative Incidence of Transplant (%)</a:t>
              </a:r>
            </a:p>
          </p:txBody>
        </p:sp>
        <p:sp>
          <p:nvSpPr>
            <p:cNvPr id="379" name="rc50">
              <a:extLst>
                <a:ext uri="{FF2B5EF4-FFF2-40B4-BE49-F238E27FC236}">
                  <a16:creationId xmlns:a16="http://schemas.microsoft.com/office/drawing/2014/main" id="{CC167395-6912-2F6C-857A-940E996BB825}"/>
                </a:ext>
              </a:extLst>
            </p:cNvPr>
            <p:cNvSpPr/>
            <p:nvPr/>
          </p:nvSpPr>
          <p:spPr>
            <a:xfrm>
              <a:off x="4276688" y="4189554"/>
              <a:ext cx="1227921" cy="358634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380" name="rc51">
              <a:extLst>
                <a:ext uri="{FF2B5EF4-FFF2-40B4-BE49-F238E27FC236}">
                  <a16:creationId xmlns:a16="http://schemas.microsoft.com/office/drawing/2014/main" id="{9C8BDD28-4DBF-A800-C663-4959AFB8FAF7}"/>
                </a:ext>
              </a:extLst>
            </p:cNvPr>
            <p:cNvSpPr/>
            <p:nvPr/>
          </p:nvSpPr>
          <p:spPr>
            <a:xfrm>
              <a:off x="4415866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381" name="pl52">
              <a:extLst>
                <a:ext uri="{FF2B5EF4-FFF2-40B4-BE49-F238E27FC236}">
                  <a16:creationId xmlns:a16="http://schemas.microsoft.com/office/drawing/2014/main" id="{7BD7D414-73C4-C144-3926-840BEA85EEF1}"/>
                </a:ext>
              </a:extLst>
            </p:cNvPr>
            <p:cNvSpPr/>
            <p:nvPr/>
          </p:nvSpPr>
          <p:spPr>
            <a:xfrm>
              <a:off x="4437812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82" name="rc53">
              <a:extLst>
                <a:ext uri="{FF2B5EF4-FFF2-40B4-BE49-F238E27FC236}">
                  <a16:creationId xmlns:a16="http://schemas.microsoft.com/office/drawing/2014/main" id="{669BA4FC-F07D-B197-1277-293AFDE5B9A4}"/>
                </a:ext>
              </a:extLst>
            </p:cNvPr>
            <p:cNvSpPr/>
            <p:nvPr/>
          </p:nvSpPr>
          <p:spPr>
            <a:xfrm>
              <a:off x="4926900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383" name="pl54">
              <a:extLst>
                <a:ext uri="{FF2B5EF4-FFF2-40B4-BE49-F238E27FC236}">
                  <a16:creationId xmlns:a16="http://schemas.microsoft.com/office/drawing/2014/main" id="{F2C16BDB-9A41-55CD-6A59-57B8DAF1C5F6}"/>
                </a:ext>
              </a:extLst>
            </p:cNvPr>
            <p:cNvSpPr/>
            <p:nvPr/>
          </p:nvSpPr>
          <p:spPr>
            <a:xfrm>
              <a:off x="4948846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84" name="tx55">
              <a:extLst>
                <a:ext uri="{FF2B5EF4-FFF2-40B4-BE49-F238E27FC236}">
                  <a16:creationId xmlns:a16="http://schemas.microsoft.com/office/drawing/2014/main" id="{C0AFFCB1-3808-4459-4730-4AC9E0F4B72E}"/>
                </a:ext>
              </a:extLst>
            </p:cNvPr>
            <p:cNvSpPr/>
            <p:nvPr/>
          </p:nvSpPr>
          <p:spPr>
            <a:xfrm>
              <a:off x="4704911" y="4321929"/>
              <a:ext cx="162346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385" name="tx56">
              <a:extLst>
                <a:ext uri="{FF2B5EF4-FFF2-40B4-BE49-F238E27FC236}">
                  <a16:creationId xmlns:a16="http://schemas.microsoft.com/office/drawing/2014/main" id="{50966C73-0ADF-3C76-2259-89CAA1F1A2BD}"/>
                </a:ext>
              </a:extLst>
            </p:cNvPr>
            <p:cNvSpPr/>
            <p:nvPr/>
          </p:nvSpPr>
          <p:spPr>
            <a:xfrm>
              <a:off x="5215945" y="4321929"/>
              <a:ext cx="218839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  <p:sp>
          <p:nvSpPr>
            <p:cNvPr id="386" name="rc57">
              <a:extLst>
                <a:ext uri="{FF2B5EF4-FFF2-40B4-BE49-F238E27FC236}">
                  <a16:creationId xmlns:a16="http://schemas.microsoft.com/office/drawing/2014/main" id="{CA7050C1-221E-5F97-782B-88E01EEA7D4B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387" name="rc58">
              <a:extLst>
                <a:ext uri="{FF2B5EF4-FFF2-40B4-BE49-F238E27FC236}">
                  <a16:creationId xmlns:a16="http://schemas.microsoft.com/office/drawing/2014/main" id="{30E42ADE-6151-121F-7AE9-EEBD8FBF873F}"/>
                </a:ext>
              </a:extLst>
            </p:cNvPr>
            <p:cNvSpPr/>
            <p:nvPr/>
          </p:nvSpPr>
          <p:spPr>
            <a:xfrm>
              <a:off x="776476" y="4996549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388" name="tx59">
              <a:extLst>
                <a:ext uri="{FF2B5EF4-FFF2-40B4-BE49-F238E27FC236}">
                  <a16:creationId xmlns:a16="http://schemas.microsoft.com/office/drawing/2014/main" id="{40C7F340-B5D6-8BEE-C2FD-EDB67068733C}"/>
                </a:ext>
              </a:extLst>
            </p:cNvPr>
            <p:cNvSpPr/>
            <p:nvPr/>
          </p:nvSpPr>
          <p:spPr>
            <a:xfrm>
              <a:off x="1115323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89" name="tx60">
              <a:extLst>
                <a:ext uri="{FF2B5EF4-FFF2-40B4-BE49-F238E27FC236}">
                  <a16:creationId xmlns:a16="http://schemas.microsoft.com/office/drawing/2014/main" id="{7D2C2F3F-7D3C-1166-3B00-74DB3E6E2939}"/>
                </a:ext>
              </a:extLst>
            </p:cNvPr>
            <p:cNvSpPr/>
            <p:nvPr/>
          </p:nvSpPr>
          <p:spPr>
            <a:xfrm>
              <a:off x="1080154" y="5132574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6</a:t>
              </a:r>
            </a:p>
          </p:txBody>
        </p:sp>
        <p:sp>
          <p:nvSpPr>
            <p:cNvPr id="390" name="tx61">
              <a:extLst>
                <a:ext uri="{FF2B5EF4-FFF2-40B4-BE49-F238E27FC236}">
                  <a16:creationId xmlns:a16="http://schemas.microsoft.com/office/drawing/2014/main" id="{53527B8C-9CF7-22C6-09F8-244C5CA2B0E4}"/>
                </a:ext>
              </a:extLst>
            </p:cNvPr>
            <p:cNvSpPr/>
            <p:nvPr/>
          </p:nvSpPr>
          <p:spPr>
            <a:xfrm>
              <a:off x="3164724" y="5439520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391" name="tx62">
              <a:extLst>
                <a:ext uri="{FF2B5EF4-FFF2-40B4-BE49-F238E27FC236}">
                  <a16:creationId xmlns:a16="http://schemas.microsoft.com/office/drawing/2014/main" id="{F1E12BD9-5EB6-D112-0A6D-B42645F6479E}"/>
                </a:ext>
              </a:extLst>
            </p:cNvPr>
            <p:cNvSpPr/>
            <p:nvPr/>
          </p:nvSpPr>
          <p:spPr>
            <a:xfrm>
              <a:off x="3164724" y="5135661"/>
              <a:ext cx="70337" cy="8935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</a:t>
              </a:r>
            </a:p>
          </p:txBody>
        </p:sp>
        <p:sp>
          <p:nvSpPr>
            <p:cNvPr id="392" name="tx63">
              <a:extLst>
                <a:ext uri="{FF2B5EF4-FFF2-40B4-BE49-F238E27FC236}">
                  <a16:creationId xmlns:a16="http://schemas.microsoft.com/office/drawing/2014/main" id="{FF9C9BD4-E514-3466-5734-E4299209AE7D}"/>
                </a:ext>
              </a:extLst>
            </p:cNvPr>
            <p:cNvSpPr/>
            <p:nvPr/>
          </p:nvSpPr>
          <p:spPr>
            <a:xfrm>
              <a:off x="5214125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393" name="tx64">
              <a:extLst>
                <a:ext uri="{FF2B5EF4-FFF2-40B4-BE49-F238E27FC236}">
                  <a16:creationId xmlns:a16="http://schemas.microsoft.com/office/drawing/2014/main" id="{80B351F7-1AEC-D369-9BEE-EE04AB6354F1}"/>
                </a:ext>
              </a:extLst>
            </p:cNvPr>
            <p:cNvSpPr/>
            <p:nvPr/>
          </p:nvSpPr>
          <p:spPr>
            <a:xfrm>
              <a:off x="5214125" y="5134488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394" name="tx65">
              <a:extLst>
                <a:ext uri="{FF2B5EF4-FFF2-40B4-BE49-F238E27FC236}">
                  <a16:creationId xmlns:a16="http://schemas.microsoft.com/office/drawing/2014/main" id="{AD440A88-E059-BAB0-AACF-023106781706}"/>
                </a:ext>
              </a:extLst>
            </p:cNvPr>
            <p:cNvSpPr/>
            <p:nvPr/>
          </p:nvSpPr>
          <p:spPr>
            <a:xfrm>
              <a:off x="7263526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395" name="tx66">
              <a:extLst>
                <a:ext uri="{FF2B5EF4-FFF2-40B4-BE49-F238E27FC236}">
                  <a16:creationId xmlns:a16="http://schemas.microsoft.com/office/drawing/2014/main" id="{A73730B7-56FE-B374-E659-03B617986BCE}"/>
                </a:ext>
              </a:extLst>
            </p:cNvPr>
            <p:cNvSpPr/>
            <p:nvPr/>
          </p:nvSpPr>
          <p:spPr>
            <a:xfrm>
              <a:off x="7263526" y="5134117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396" name="tx67">
              <a:extLst>
                <a:ext uri="{FF2B5EF4-FFF2-40B4-BE49-F238E27FC236}">
                  <a16:creationId xmlns:a16="http://schemas.microsoft.com/office/drawing/2014/main" id="{B12CEF90-5DFC-9832-0EAB-C0DAEDAB6857}"/>
                </a:ext>
              </a:extLst>
            </p:cNvPr>
            <p:cNvSpPr/>
            <p:nvPr/>
          </p:nvSpPr>
          <p:spPr>
            <a:xfrm>
              <a:off x="325591" y="5438152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397" name="tx68">
              <a:extLst>
                <a:ext uri="{FF2B5EF4-FFF2-40B4-BE49-F238E27FC236}">
                  <a16:creationId xmlns:a16="http://schemas.microsoft.com/office/drawing/2014/main" id="{64464D9C-EE8F-FE0F-3DC3-FFDA81ED537A}"/>
                </a:ext>
              </a:extLst>
            </p:cNvPr>
            <p:cNvSpPr/>
            <p:nvPr/>
          </p:nvSpPr>
          <p:spPr>
            <a:xfrm>
              <a:off x="311638" y="5132811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398" name="tx69">
              <a:extLst>
                <a:ext uri="{FF2B5EF4-FFF2-40B4-BE49-F238E27FC236}">
                  <a16:creationId xmlns:a16="http://schemas.microsoft.com/office/drawing/2014/main" id="{861B19CE-7A12-F435-1F54-FFF9ABB3BE81}"/>
                </a:ext>
              </a:extLst>
            </p:cNvPr>
            <p:cNvSpPr/>
            <p:nvPr/>
          </p:nvSpPr>
          <p:spPr>
            <a:xfrm>
              <a:off x="776476" y="4827633"/>
              <a:ext cx="17452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399" name="rc70">
              <a:extLst>
                <a:ext uri="{FF2B5EF4-FFF2-40B4-BE49-F238E27FC236}">
                  <a16:creationId xmlns:a16="http://schemas.microsoft.com/office/drawing/2014/main" id="{0EC65DC3-B58E-33B3-E730-24E6C49E65A9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00" name="rc71">
              <a:extLst>
                <a:ext uri="{FF2B5EF4-FFF2-40B4-BE49-F238E27FC236}">
                  <a16:creationId xmlns:a16="http://schemas.microsoft.com/office/drawing/2014/main" id="{F98F5EFE-DC97-AD04-46A1-30282347C2AF}"/>
                </a:ext>
              </a:extLst>
            </p:cNvPr>
            <p:cNvSpPr/>
            <p:nvPr/>
          </p:nvSpPr>
          <p:spPr>
            <a:xfrm>
              <a:off x="776476" y="6081865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401" name="tx72">
              <a:extLst>
                <a:ext uri="{FF2B5EF4-FFF2-40B4-BE49-F238E27FC236}">
                  <a16:creationId xmlns:a16="http://schemas.microsoft.com/office/drawing/2014/main" id="{57B26AAF-0FB9-8B50-3330-6E2107DEB5BA}"/>
                </a:ext>
              </a:extLst>
            </p:cNvPr>
            <p:cNvSpPr/>
            <p:nvPr/>
          </p:nvSpPr>
          <p:spPr>
            <a:xfrm>
              <a:off x="1115323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402" name="tx73">
              <a:extLst>
                <a:ext uri="{FF2B5EF4-FFF2-40B4-BE49-F238E27FC236}">
                  <a16:creationId xmlns:a16="http://schemas.microsoft.com/office/drawing/2014/main" id="{7FF110FE-4634-47C3-FA69-9EA9BDA11C68}"/>
                </a:ext>
              </a:extLst>
            </p:cNvPr>
            <p:cNvSpPr/>
            <p:nvPr/>
          </p:nvSpPr>
          <p:spPr>
            <a:xfrm>
              <a:off x="1080154" y="6220978"/>
              <a:ext cx="140675" cy="8935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7</a:t>
              </a:r>
            </a:p>
          </p:txBody>
        </p:sp>
        <p:sp>
          <p:nvSpPr>
            <p:cNvPr id="403" name="tx74">
              <a:extLst>
                <a:ext uri="{FF2B5EF4-FFF2-40B4-BE49-F238E27FC236}">
                  <a16:creationId xmlns:a16="http://schemas.microsoft.com/office/drawing/2014/main" id="{46CE8C5D-C5B8-AF38-F9E2-A498A26DA39D}"/>
                </a:ext>
              </a:extLst>
            </p:cNvPr>
            <p:cNvSpPr/>
            <p:nvPr/>
          </p:nvSpPr>
          <p:spPr>
            <a:xfrm>
              <a:off x="3129555" y="6523169"/>
              <a:ext cx="140675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6</a:t>
              </a:r>
            </a:p>
          </p:txBody>
        </p:sp>
        <p:sp>
          <p:nvSpPr>
            <p:cNvPr id="404" name="tx75">
              <a:extLst>
                <a:ext uri="{FF2B5EF4-FFF2-40B4-BE49-F238E27FC236}">
                  <a16:creationId xmlns:a16="http://schemas.microsoft.com/office/drawing/2014/main" id="{08B1AFE8-7320-235D-28AE-83EBBF3AC8B9}"/>
                </a:ext>
              </a:extLst>
            </p:cNvPr>
            <p:cNvSpPr/>
            <p:nvPr/>
          </p:nvSpPr>
          <p:spPr>
            <a:xfrm>
              <a:off x="3129555" y="6217828"/>
              <a:ext cx="140675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2</a:t>
              </a:r>
            </a:p>
          </p:txBody>
        </p:sp>
        <p:sp>
          <p:nvSpPr>
            <p:cNvPr id="405" name="tx76">
              <a:extLst>
                <a:ext uri="{FF2B5EF4-FFF2-40B4-BE49-F238E27FC236}">
                  <a16:creationId xmlns:a16="http://schemas.microsoft.com/office/drawing/2014/main" id="{13448CAC-3426-E75F-3679-B0AFEC37B240}"/>
                </a:ext>
              </a:extLst>
            </p:cNvPr>
            <p:cNvSpPr/>
            <p:nvPr/>
          </p:nvSpPr>
          <p:spPr>
            <a:xfrm>
              <a:off x="5178956" y="6525145"/>
              <a:ext cx="140675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7</a:t>
              </a:r>
            </a:p>
          </p:txBody>
        </p:sp>
        <p:sp>
          <p:nvSpPr>
            <p:cNvPr id="406" name="tx77">
              <a:extLst>
                <a:ext uri="{FF2B5EF4-FFF2-40B4-BE49-F238E27FC236}">
                  <a16:creationId xmlns:a16="http://schemas.microsoft.com/office/drawing/2014/main" id="{B9C19F52-5E08-EB7F-A648-E4BAA6055C78}"/>
                </a:ext>
              </a:extLst>
            </p:cNvPr>
            <p:cNvSpPr/>
            <p:nvPr/>
          </p:nvSpPr>
          <p:spPr>
            <a:xfrm>
              <a:off x="5178956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7</a:t>
              </a:r>
            </a:p>
          </p:txBody>
        </p:sp>
        <p:sp>
          <p:nvSpPr>
            <p:cNvPr id="407" name="tx78">
              <a:extLst>
                <a:ext uri="{FF2B5EF4-FFF2-40B4-BE49-F238E27FC236}">
                  <a16:creationId xmlns:a16="http://schemas.microsoft.com/office/drawing/2014/main" id="{3122AF55-4552-72BB-DE1D-41DF8B4C3055}"/>
                </a:ext>
              </a:extLst>
            </p:cNvPr>
            <p:cNvSpPr/>
            <p:nvPr/>
          </p:nvSpPr>
          <p:spPr>
            <a:xfrm>
              <a:off x="7228357" y="6523231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2</a:t>
              </a:r>
            </a:p>
          </p:txBody>
        </p:sp>
        <p:sp>
          <p:nvSpPr>
            <p:cNvPr id="408" name="tx79">
              <a:extLst>
                <a:ext uri="{FF2B5EF4-FFF2-40B4-BE49-F238E27FC236}">
                  <a16:creationId xmlns:a16="http://schemas.microsoft.com/office/drawing/2014/main" id="{F23E2292-CE97-6AD7-4910-898703D6D1C5}"/>
                </a:ext>
              </a:extLst>
            </p:cNvPr>
            <p:cNvSpPr/>
            <p:nvPr/>
          </p:nvSpPr>
          <p:spPr>
            <a:xfrm>
              <a:off x="7228357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1</a:t>
              </a:r>
            </a:p>
          </p:txBody>
        </p:sp>
        <p:sp>
          <p:nvSpPr>
            <p:cNvPr id="409" name="tx80">
              <a:extLst>
                <a:ext uri="{FF2B5EF4-FFF2-40B4-BE49-F238E27FC236}">
                  <a16:creationId xmlns:a16="http://schemas.microsoft.com/office/drawing/2014/main" id="{57572DD9-6B50-C34F-7070-3281454E22DD}"/>
                </a:ext>
              </a:extLst>
            </p:cNvPr>
            <p:cNvSpPr/>
            <p:nvPr/>
          </p:nvSpPr>
          <p:spPr>
            <a:xfrm>
              <a:off x="325591" y="6523468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410" name="tx81">
              <a:extLst>
                <a:ext uri="{FF2B5EF4-FFF2-40B4-BE49-F238E27FC236}">
                  <a16:creationId xmlns:a16="http://schemas.microsoft.com/office/drawing/2014/main" id="{67FC7F88-ABB6-ECB9-1336-F3B8908D675D}"/>
                </a:ext>
              </a:extLst>
            </p:cNvPr>
            <p:cNvSpPr/>
            <p:nvPr/>
          </p:nvSpPr>
          <p:spPr>
            <a:xfrm>
              <a:off x="311638" y="6218127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411" name="tx82">
              <a:extLst>
                <a:ext uri="{FF2B5EF4-FFF2-40B4-BE49-F238E27FC236}">
                  <a16:creationId xmlns:a16="http://schemas.microsoft.com/office/drawing/2014/main" id="{F4D20517-B560-16E2-25A6-A5FAFDCBADEA}"/>
                </a:ext>
              </a:extLst>
            </p:cNvPr>
            <p:cNvSpPr/>
            <p:nvPr/>
          </p:nvSpPr>
          <p:spPr>
            <a:xfrm>
              <a:off x="776476" y="5912949"/>
              <a:ext cx="23525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</p:grpSp>
      <p:sp>
        <p:nvSpPr>
          <p:cNvPr id="412" name="TextBox 411">
            <a:extLst>
              <a:ext uri="{FF2B5EF4-FFF2-40B4-BE49-F238E27FC236}">
                <a16:creationId xmlns:a16="http://schemas.microsoft.com/office/drawing/2014/main" id="{F064A627-6860-3947-ACA6-A096651A98C6}"/>
              </a:ext>
            </a:extLst>
          </p:cNvPr>
          <p:cNvSpPr txBox="1"/>
          <p:nvPr/>
        </p:nvSpPr>
        <p:spPr>
          <a:xfrm>
            <a:off x="937668" y="1810048"/>
            <a:ext cx="2877987" cy="7287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7" b="1" dirty="0">
                <a:latin typeface="Arial" panose="020B0604020202020204" pitchFamily="34" charset="0"/>
                <a:cs typeface="Arial" panose="020B0604020202020204" pitchFamily="34" charset="0"/>
              </a:rPr>
              <a:t>Potential Living Donor Total   Event   HR (95% CI)</a:t>
            </a:r>
          </a:p>
          <a:p>
            <a:r>
              <a:rPr lang="en-US" sz="827" dirty="0">
                <a:latin typeface="Arial" panose="020B0604020202020204" pitchFamily="34" charset="0"/>
                <a:cs typeface="Arial" panose="020B0604020202020204" pitchFamily="34" charset="0"/>
              </a:rPr>
              <a:t>No                                     16         6         Reference</a:t>
            </a:r>
          </a:p>
          <a:p>
            <a:r>
              <a:rPr lang="en-US" sz="827" dirty="0">
                <a:latin typeface="Arial" panose="020B0604020202020204" pitchFamily="34" charset="0"/>
                <a:cs typeface="Arial" panose="020B0604020202020204" pitchFamily="34" charset="0"/>
              </a:rPr>
              <a:t>Yes                                    77        52       1.93 (0.74 – 5.06)</a:t>
            </a:r>
          </a:p>
          <a:p>
            <a:r>
              <a:rPr lang="en-US" sz="827" dirty="0">
                <a:latin typeface="Arial" panose="020B0604020202020204" pitchFamily="34" charset="0"/>
                <a:cs typeface="Arial" panose="020B0604020202020204" pitchFamily="34" charset="0"/>
              </a:rPr>
              <a:t>Gray K-Sample Test P-value: 0.1345  </a:t>
            </a:r>
          </a:p>
        </p:txBody>
      </p:sp>
      <p:sp>
        <p:nvSpPr>
          <p:cNvPr id="413" name="pl48">
            <a:extLst>
              <a:ext uri="{FF2B5EF4-FFF2-40B4-BE49-F238E27FC236}">
                <a16:creationId xmlns:a16="http://schemas.microsoft.com/office/drawing/2014/main" id="{5DD66FFF-4B3B-7607-D9F2-107E3F45F7CB}"/>
              </a:ext>
            </a:extLst>
          </p:cNvPr>
          <p:cNvSpPr/>
          <p:nvPr/>
        </p:nvSpPr>
        <p:spPr>
          <a:xfrm>
            <a:off x="759033" y="2029746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414" name="pl50">
            <a:extLst>
              <a:ext uri="{FF2B5EF4-FFF2-40B4-BE49-F238E27FC236}">
                <a16:creationId xmlns:a16="http://schemas.microsoft.com/office/drawing/2014/main" id="{0EDA6388-9519-9C60-3F65-C47F606E9232}"/>
              </a:ext>
            </a:extLst>
          </p:cNvPr>
          <p:cNvSpPr/>
          <p:nvPr/>
        </p:nvSpPr>
        <p:spPr>
          <a:xfrm>
            <a:off x="773505" y="2176272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grpSp>
        <p:nvGrpSpPr>
          <p:cNvPr id="415" name="Group 414">
            <a:extLst>
              <a:ext uri="{FF2B5EF4-FFF2-40B4-BE49-F238E27FC236}">
                <a16:creationId xmlns:a16="http://schemas.microsoft.com/office/drawing/2014/main" id="{103CA7A6-78B8-C52B-E3AB-26235E3C9612}"/>
              </a:ext>
            </a:extLst>
          </p:cNvPr>
          <p:cNvGrpSpPr>
            <a:grpSpLocks noChangeAspect="1"/>
          </p:cNvGrpSpPr>
          <p:nvPr/>
        </p:nvGrpSpPr>
        <p:grpSpPr>
          <a:xfrm>
            <a:off x="173913" y="5390443"/>
            <a:ext cx="4677322" cy="3571875"/>
            <a:chOff x="0" y="0"/>
            <a:chExt cx="9144000" cy="6858000"/>
          </a:xfrm>
        </p:grpSpPr>
        <p:sp>
          <p:nvSpPr>
            <p:cNvPr id="416" name="rc3">
              <a:extLst>
                <a:ext uri="{FF2B5EF4-FFF2-40B4-BE49-F238E27FC236}">
                  <a16:creationId xmlns:a16="http://schemas.microsoft.com/office/drawing/2014/main" id="{E863B303-BAD2-95C4-3162-8FC01553EB9D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17" name="rc4">
              <a:extLst>
                <a:ext uri="{FF2B5EF4-FFF2-40B4-BE49-F238E27FC236}">
                  <a16:creationId xmlns:a16="http://schemas.microsoft.com/office/drawing/2014/main" id="{4EFFCCF2-43E7-7499-7D79-943B8263213A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18" name="rc5">
              <a:extLst>
                <a:ext uri="{FF2B5EF4-FFF2-40B4-BE49-F238E27FC236}">
                  <a16:creationId xmlns:a16="http://schemas.microsoft.com/office/drawing/2014/main" id="{73250BD5-7E0A-2838-ED71-49D2EA88CB1F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19" name="rc6">
              <a:extLst>
                <a:ext uri="{FF2B5EF4-FFF2-40B4-BE49-F238E27FC236}">
                  <a16:creationId xmlns:a16="http://schemas.microsoft.com/office/drawing/2014/main" id="{EFB84397-FE6A-BB08-C15A-AB0E6866434E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20" name="rc7">
              <a:extLst>
                <a:ext uri="{FF2B5EF4-FFF2-40B4-BE49-F238E27FC236}">
                  <a16:creationId xmlns:a16="http://schemas.microsoft.com/office/drawing/2014/main" id="{376418C0-1028-2DE3-7BA3-149956BF63B5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21" name="rc8">
              <a:extLst>
                <a:ext uri="{FF2B5EF4-FFF2-40B4-BE49-F238E27FC236}">
                  <a16:creationId xmlns:a16="http://schemas.microsoft.com/office/drawing/2014/main" id="{7356CC66-31D8-CE58-DEB3-C3243327A03D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22" name="pl18">
              <a:extLst>
                <a:ext uri="{FF2B5EF4-FFF2-40B4-BE49-F238E27FC236}">
                  <a16:creationId xmlns:a16="http://schemas.microsoft.com/office/drawing/2014/main" id="{9F7081A0-6926-A65C-0645-0856E52B4D50}"/>
                </a:ext>
              </a:extLst>
            </p:cNvPr>
            <p:cNvSpPr/>
            <p:nvPr/>
          </p:nvSpPr>
          <p:spPr>
            <a:xfrm>
              <a:off x="776476" y="3534137"/>
              <a:ext cx="8228345" cy="0"/>
            </a:xfrm>
            <a:custGeom>
              <a:avLst/>
              <a:gdLst/>
              <a:ahLst/>
              <a:cxnLst/>
              <a:rect l="0" t="0" r="0" b="0"/>
              <a:pathLst>
                <a:path w="8228345">
                  <a:moveTo>
                    <a:pt x="0" y="0"/>
                  </a:moveTo>
                  <a:lnTo>
                    <a:pt x="8228345" y="0"/>
                  </a:lnTo>
                  <a:lnTo>
                    <a:pt x="8228345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25" name="pl23">
              <a:extLst>
                <a:ext uri="{FF2B5EF4-FFF2-40B4-BE49-F238E27FC236}">
                  <a16:creationId xmlns:a16="http://schemas.microsoft.com/office/drawing/2014/main" id="{62312CC6-4657-7F65-2DB6-1C585B0E8EC5}"/>
                </a:ext>
              </a:extLst>
            </p:cNvPr>
            <p:cNvSpPr/>
            <p:nvPr/>
          </p:nvSpPr>
          <p:spPr>
            <a:xfrm>
              <a:off x="1150492" y="139178"/>
              <a:ext cx="0" cy="3556623"/>
            </a:xfrm>
            <a:custGeom>
              <a:avLst/>
              <a:gdLst/>
              <a:ahLst/>
              <a:cxnLst/>
              <a:rect l="0" t="0" r="0" b="0"/>
              <a:pathLst>
                <a:path h="3556623">
                  <a:moveTo>
                    <a:pt x="0" y="35566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26" name="pl27">
              <a:extLst>
                <a:ext uri="{FF2B5EF4-FFF2-40B4-BE49-F238E27FC236}">
                  <a16:creationId xmlns:a16="http://schemas.microsoft.com/office/drawing/2014/main" id="{667C4FEC-3C52-60A1-344C-2702BF5D6147}"/>
                </a:ext>
              </a:extLst>
            </p:cNvPr>
            <p:cNvSpPr/>
            <p:nvPr/>
          </p:nvSpPr>
          <p:spPr>
            <a:xfrm>
              <a:off x="1150492" y="1782769"/>
              <a:ext cx="6209685" cy="1751367"/>
            </a:xfrm>
            <a:custGeom>
              <a:avLst/>
              <a:gdLst/>
              <a:ahLst/>
              <a:cxnLst/>
              <a:rect l="0" t="0" r="0" b="0"/>
              <a:pathLst>
                <a:path w="6209685" h="1751367">
                  <a:moveTo>
                    <a:pt x="0" y="1751367"/>
                  </a:moveTo>
                  <a:lnTo>
                    <a:pt x="71729" y="1751367"/>
                  </a:lnTo>
                  <a:lnTo>
                    <a:pt x="71729" y="1571740"/>
                  </a:lnTo>
                  <a:lnTo>
                    <a:pt x="317657" y="1571740"/>
                  </a:lnTo>
                  <a:lnTo>
                    <a:pt x="317657" y="1212485"/>
                  </a:lnTo>
                  <a:lnTo>
                    <a:pt x="389386" y="1212485"/>
                  </a:lnTo>
                  <a:lnTo>
                    <a:pt x="389386" y="1032857"/>
                  </a:lnTo>
                  <a:lnTo>
                    <a:pt x="440621" y="1032857"/>
                  </a:lnTo>
                  <a:lnTo>
                    <a:pt x="440621" y="1032857"/>
                  </a:lnTo>
                  <a:lnTo>
                    <a:pt x="809513" y="1032857"/>
                  </a:lnTo>
                  <a:lnTo>
                    <a:pt x="809513" y="1032857"/>
                  </a:lnTo>
                  <a:lnTo>
                    <a:pt x="1014453" y="1032857"/>
                  </a:lnTo>
                  <a:lnTo>
                    <a:pt x="1014453" y="853230"/>
                  </a:lnTo>
                  <a:lnTo>
                    <a:pt x="1250134" y="853230"/>
                  </a:lnTo>
                  <a:lnTo>
                    <a:pt x="1250134" y="673603"/>
                  </a:lnTo>
                  <a:lnTo>
                    <a:pt x="1619026" y="673603"/>
                  </a:lnTo>
                  <a:lnTo>
                    <a:pt x="1619026" y="673603"/>
                  </a:lnTo>
                  <a:lnTo>
                    <a:pt x="1834213" y="673603"/>
                  </a:lnTo>
                  <a:lnTo>
                    <a:pt x="1834213" y="673603"/>
                  </a:lnTo>
                  <a:lnTo>
                    <a:pt x="2490022" y="673603"/>
                  </a:lnTo>
                  <a:lnTo>
                    <a:pt x="2490022" y="673603"/>
                  </a:lnTo>
                  <a:lnTo>
                    <a:pt x="2520763" y="673603"/>
                  </a:lnTo>
                  <a:lnTo>
                    <a:pt x="2520763" y="449068"/>
                  </a:lnTo>
                  <a:lnTo>
                    <a:pt x="3074101" y="449068"/>
                  </a:lnTo>
                  <a:lnTo>
                    <a:pt x="3074101" y="224534"/>
                  </a:lnTo>
                  <a:lnTo>
                    <a:pt x="4273001" y="224534"/>
                  </a:lnTo>
                  <a:lnTo>
                    <a:pt x="4273001" y="0"/>
                  </a:lnTo>
                  <a:lnTo>
                    <a:pt x="4324236" y="0"/>
                  </a:lnTo>
                  <a:lnTo>
                    <a:pt x="4324236" y="0"/>
                  </a:lnTo>
                  <a:lnTo>
                    <a:pt x="4672634" y="0"/>
                  </a:lnTo>
                  <a:lnTo>
                    <a:pt x="4672634" y="0"/>
                  </a:lnTo>
                  <a:lnTo>
                    <a:pt x="6209685" y="0"/>
                  </a:lnTo>
                  <a:lnTo>
                    <a:pt x="6209685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27" name="pl28">
              <a:extLst>
                <a:ext uri="{FF2B5EF4-FFF2-40B4-BE49-F238E27FC236}">
                  <a16:creationId xmlns:a16="http://schemas.microsoft.com/office/drawing/2014/main" id="{BBCD1498-B09F-B0ED-F42A-0480B0F0E87F}"/>
                </a:ext>
              </a:extLst>
            </p:cNvPr>
            <p:cNvSpPr/>
            <p:nvPr/>
          </p:nvSpPr>
          <p:spPr>
            <a:xfrm>
              <a:off x="1150492" y="1038531"/>
              <a:ext cx="7265126" cy="2495605"/>
            </a:xfrm>
            <a:custGeom>
              <a:avLst/>
              <a:gdLst/>
              <a:ahLst/>
              <a:cxnLst/>
              <a:rect l="0" t="0" r="0" b="0"/>
              <a:pathLst>
                <a:path w="7265126" h="2495605">
                  <a:moveTo>
                    <a:pt x="0" y="2495605"/>
                  </a:moveTo>
                  <a:lnTo>
                    <a:pt x="10247" y="2495605"/>
                  </a:lnTo>
                  <a:lnTo>
                    <a:pt x="10247" y="2428245"/>
                  </a:lnTo>
                  <a:lnTo>
                    <a:pt x="194693" y="2428245"/>
                  </a:lnTo>
                  <a:lnTo>
                    <a:pt x="194693" y="2394565"/>
                  </a:lnTo>
                  <a:lnTo>
                    <a:pt x="204940" y="2394565"/>
                  </a:lnTo>
                  <a:lnTo>
                    <a:pt x="204940" y="2327205"/>
                  </a:lnTo>
                  <a:lnTo>
                    <a:pt x="256175" y="2327205"/>
                  </a:lnTo>
                  <a:lnTo>
                    <a:pt x="256175" y="2293150"/>
                  </a:lnTo>
                  <a:lnTo>
                    <a:pt x="297163" y="2293150"/>
                  </a:lnTo>
                  <a:lnTo>
                    <a:pt x="297163" y="2259096"/>
                  </a:lnTo>
                  <a:lnTo>
                    <a:pt x="338151" y="2259096"/>
                  </a:lnTo>
                  <a:lnTo>
                    <a:pt x="338151" y="2259096"/>
                  </a:lnTo>
                  <a:lnTo>
                    <a:pt x="389386" y="2259096"/>
                  </a:lnTo>
                  <a:lnTo>
                    <a:pt x="389386" y="2225041"/>
                  </a:lnTo>
                  <a:lnTo>
                    <a:pt x="409880" y="2225041"/>
                  </a:lnTo>
                  <a:lnTo>
                    <a:pt x="409880" y="2190586"/>
                  </a:lnTo>
                  <a:lnTo>
                    <a:pt x="440621" y="2190586"/>
                  </a:lnTo>
                  <a:lnTo>
                    <a:pt x="440621" y="2190586"/>
                  </a:lnTo>
                  <a:lnTo>
                    <a:pt x="471362" y="2190586"/>
                  </a:lnTo>
                  <a:lnTo>
                    <a:pt x="471362" y="2156131"/>
                  </a:lnTo>
                  <a:lnTo>
                    <a:pt x="491856" y="2156131"/>
                  </a:lnTo>
                  <a:lnTo>
                    <a:pt x="491856" y="2121676"/>
                  </a:lnTo>
                  <a:lnTo>
                    <a:pt x="502103" y="2121676"/>
                  </a:lnTo>
                  <a:lnTo>
                    <a:pt x="502103" y="2087221"/>
                  </a:lnTo>
                  <a:lnTo>
                    <a:pt x="532844" y="2087221"/>
                  </a:lnTo>
                  <a:lnTo>
                    <a:pt x="532844" y="2087221"/>
                  </a:lnTo>
                  <a:lnTo>
                    <a:pt x="635314" y="2087221"/>
                  </a:lnTo>
                  <a:lnTo>
                    <a:pt x="635314" y="2017439"/>
                  </a:lnTo>
                  <a:lnTo>
                    <a:pt x="645561" y="2017439"/>
                  </a:lnTo>
                  <a:lnTo>
                    <a:pt x="645561" y="1982548"/>
                  </a:lnTo>
                  <a:lnTo>
                    <a:pt x="717290" y="1982548"/>
                  </a:lnTo>
                  <a:lnTo>
                    <a:pt x="717290" y="1947657"/>
                  </a:lnTo>
                  <a:lnTo>
                    <a:pt x="737784" y="1947657"/>
                  </a:lnTo>
                  <a:lnTo>
                    <a:pt x="737784" y="1912766"/>
                  </a:lnTo>
                  <a:lnTo>
                    <a:pt x="789019" y="1912766"/>
                  </a:lnTo>
                  <a:lnTo>
                    <a:pt x="789019" y="1877874"/>
                  </a:lnTo>
                  <a:lnTo>
                    <a:pt x="830007" y="1877874"/>
                  </a:lnTo>
                  <a:lnTo>
                    <a:pt x="830007" y="1842983"/>
                  </a:lnTo>
                  <a:lnTo>
                    <a:pt x="860748" y="1842983"/>
                  </a:lnTo>
                  <a:lnTo>
                    <a:pt x="860748" y="1808092"/>
                  </a:lnTo>
                  <a:lnTo>
                    <a:pt x="901736" y="1808092"/>
                  </a:lnTo>
                  <a:lnTo>
                    <a:pt x="901736" y="1738310"/>
                  </a:lnTo>
                  <a:lnTo>
                    <a:pt x="922230" y="1738310"/>
                  </a:lnTo>
                  <a:lnTo>
                    <a:pt x="922230" y="1703419"/>
                  </a:lnTo>
                  <a:lnTo>
                    <a:pt x="1004206" y="1703419"/>
                  </a:lnTo>
                  <a:lnTo>
                    <a:pt x="1004206" y="1668527"/>
                  </a:lnTo>
                  <a:lnTo>
                    <a:pt x="1034947" y="1668527"/>
                  </a:lnTo>
                  <a:lnTo>
                    <a:pt x="1034947" y="1633636"/>
                  </a:lnTo>
                  <a:lnTo>
                    <a:pt x="1065688" y="1633636"/>
                  </a:lnTo>
                  <a:lnTo>
                    <a:pt x="1065688" y="1563854"/>
                  </a:lnTo>
                  <a:lnTo>
                    <a:pt x="1096429" y="1563854"/>
                  </a:lnTo>
                  <a:lnTo>
                    <a:pt x="1096429" y="1528963"/>
                  </a:lnTo>
                  <a:lnTo>
                    <a:pt x="1116923" y="1528963"/>
                  </a:lnTo>
                  <a:lnTo>
                    <a:pt x="1116923" y="1494072"/>
                  </a:lnTo>
                  <a:lnTo>
                    <a:pt x="1157911" y="1494072"/>
                  </a:lnTo>
                  <a:lnTo>
                    <a:pt x="1157911" y="1424289"/>
                  </a:lnTo>
                  <a:lnTo>
                    <a:pt x="1168158" y="1424289"/>
                  </a:lnTo>
                  <a:lnTo>
                    <a:pt x="1168158" y="1389398"/>
                  </a:lnTo>
                  <a:lnTo>
                    <a:pt x="1178405" y="1389398"/>
                  </a:lnTo>
                  <a:lnTo>
                    <a:pt x="1178405" y="1354507"/>
                  </a:lnTo>
                  <a:lnTo>
                    <a:pt x="1250134" y="1354507"/>
                  </a:lnTo>
                  <a:lnTo>
                    <a:pt x="1250134" y="1319616"/>
                  </a:lnTo>
                  <a:lnTo>
                    <a:pt x="1280875" y="1319616"/>
                  </a:lnTo>
                  <a:lnTo>
                    <a:pt x="1280875" y="1284725"/>
                  </a:lnTo>
                  <a:lnTo>
                    <a:pt x="1291122" y="1284725"/>
                  </a:lnTo>
                  <a:lnTo>
                    <a:pt x="1291122" y="1249834"/>
                  </a:lnTo>
                  <a:lnTo>
                    <a:pt x="1332110" y="1249834"/>
                  </a:lnTo>
                  <a:lnTo>
                    <a:pt x="1332110" y="1249834"/>
                  </a:lnTo>
                  <a:lnTo>
                    <a:pt x="1434580" y="1249834"/>
                  </a:lnTo>
                  <a:lnTo>
                    <a:pt x="1434580" y="1214942"/>
                  </a:lnTo>
                  <a:lnTo>
                    <a:pt x="1444827" y="1214942"/>
                  </a:lnTo>
                  <a:lnTo>
                    <a:pt x="1444827" y="1180051"/>
                  </a:lnTo>
                  <a:lnTo>
                    <a:pt x="1547297" y="1180051"/>
                  </a:lnTo>
                  <a:lnTo>
                    <a:pt x="1547297" y="1145160"/>
                  </a:lnTo>
                  <a:lnTo>
                    <a:pt x="1588285" y="1145160"/>
                  </a:lnTo>
                  <a:lnTo>
                    <a:pt x="1588285" y="1110269"/>
                  </a:lnTo>
                  <a:lnTo>
                    <a:pt x="1711249" y="1110269"/>
                  </a:lnTo>
                  <a:lnTo>
                    <a:pt x="1711249" y="1040487"/>
                  </a:lnTo>
                  <a:lnTo>
                    <a:pt x="1752237" y="1040487"/>
                  </a:lnTo>
                  <a:lnTo>
                    <a:pt x="1752237" y="1040487"/>
                  </a:lnTo>
                  <a:lnTo>
                    <a:pt x="1762484" y="1040487"/>
                  </a:lnTo>
                  <a:lnTo>
                    <a:pt x="1762484" y="1004853"/>
                  </a:lnTo>
                  <a:lnTo>
                    <a:pt x="1864954" y="1004853"/>
                  </a:lnTo>
                  <a:lnTo>
                    <a:pt x="1864954" y="969220"/>
                  </a:lnTo>
                  <a:lnTo>
                    <a:pt x="1895695" y="969220"/>
                  </a:lnTo>
                  <a:lnTo>
                    <a:pt x="1895695" y="969220"/>
                  </a:lnTo>
                  <a:lnTo>
                    <a:pt x="1905942" y="969220"/>
                  </a:lnTo>
                  <a:lnTo>
                    <a:pt x="1905942" y="932776"/>
                  </a:lnTo>
                  <a:lnTo>
                    <a:pt x="1936683" y="932776"/>
                  </a:lnTo>
                  <a:lnTo>
                    <a:pt x="1936683" y="932776"/>
                  </a:lnTo>
                  <a:lnTo>
                    <a:pt x="1957177" y="932776"/>
                  </a:lnTo>
                  <a:lnTo>
                    <a:pt x="1957177" y="895465"/>
                  </a:lnTo>
                  <a:lnTo>
                    <a:pt x="2244094" y="895465"/>
                  </a:lnTo>
                  <a:lnTo>
                    <a:pt x="2244094" y="858154"/>
                  </a:lnTo>
                  <a:lnTo>
                    <a:pt x="2356811" y="858154"/>
                  </a:lnTo>
                  <a:lnTo>
                    <a:pt x="2356811" y="858154"/>
                  </a:lnTo>
                  <a:lnTo>
                    <a:pt x="2367058" y="858154"/>
                  </a:lnTo>
                  <a:lnTo>
                    <a:pt x="2367058" y="819861"/>
                  </a:lnTo>
                  <a:lnTo>
                    <a:pt x="2408046" y="819861"/>
                  </a:lnTo>
                  <a:lnTo>
                    <a:pt x="2408046" y="781568"/>
                  </a:lnTo>
                  <a:lnTo>
                    <a:pt x="2418293" y="781568"/>
                  </a:lnTo>
                  <a:lnTo>
                    <a:pt x="2418293" y="743275"/>
                  </a:lnTo>
                  <a:lnTo>
                    <a:pt x="2571998" y="743275"/>
                  </a:lnTo>
                  <a:lnTo>
                    <a:pt x="2571998" y="704982"/>
                  </a:lnTo>
                  <a:lnTo>
                    <a:pt x="2705209" y="704982"/>
                  </a:lnTo>
                  <a:lnTo>
                    <a:pt x="2705209" y="666689"/>
                  </a:lnTo>
                  <a:lnTo>
                    <a:pt x="2725703" y="666689"/>
                  </a:lnTo>
                  <a:lnTo>
                    <a:pt x="2725703" y="628396"/>
                  </a:lnTo>
                  <a:lnTo>
                    <a:pt x="2735950" y="628396"/>
                  </a:lnTo>
                  <a:lnTo>
                    <a:pt x="2735950" y="590104"/>
                  </a:lnTo>
                  <a:lnTo>
                    <a:pt x="2787185" y="590104"/>
                  </a:lnTo>
                  <a:lnTo>
                    <a:pt x="2787185" y="551811"/>
                  </a:lnTo>
                  <a:lnTo>
                    <a:pt x="3002372" y="551811"/>
                  </a:lnTo>
                  <a:lnTo>
                    <a:pt x="3002372" y="513518"/>
                  </a:lnTo>
                  <a:lnTo>
                    <a:pt x="3340523" y="513518"/>
                  </a:lnTo>
                  <a:lnTo>
                    <a:pt x="3340523" y="475225"/>
                  </a:lnTo>
                  <a:lnTo>
                    <a:pt x="3842626" y="475225"/>
                  </a:lnTo>
                  <a:lnTo>
                    <a:pt x="3842626" y="436932"/>
                  </a:lnTo>
                  <a:lnTo>
                    <a:pt x="3863120" y="436932"/>
                  </a:lnTo>
                  <a:lnTo>
                    <a:pt x="3863120" y="398639"/>
                  </a:lnTo>
                  <a:lnTo>
                    <a:pt x="3873367" y="398639"/>
                  </a:lnTo>
                  <a:lnTo>
                    <a:pt x="3873367" y="360346"/>
                  </a:lnTo>
                  <a:lnTo>
                    <a:pt x="3945096" y="360346"/>
                  </a:lnTo>
                  <a:lnTo>
                    <a:pt x="3945096" y="322053"/>
                  </a:lnTo>
                  <a:lnTo>
                    <a:pt x="4590658" y="322053"/>
                  </a:lnTo>
                  <a:lnTo>
                    <a:pt x="4590658" y="245467"/>
                  </a:lnTo>
                  <a:lnTo>
                    <a:pt x="4877574" y="245467"/>
                  </a:lnTo>
                  <a:lnTo>
                    <a:pt x="4877574" y="207174"/>
                  </a:lnTo>
                  <a:lnTo>
                    <a:pt x="5092761" y="207174"/>
                  </a:lnTo>
                  <a:lnTo>
                    <a:pt x="5092761" y="168881"/>
                  </a:lnTo>
                  <a:lnTo>
                    <a:pt x="5379677" y="168881"/>
                  </a:lnTo>
                  <a:lnTo>
                    <a:pt x="5379677" y="130588"/>
                  </a:lnTo>
                  <a:lnTo>
                    <a:pt x="5512888" y="130588"/>
                  </a:lnTo>
                  <a:lnTo>
                    <a:pt x="5512888" y="130588"/>
                  </a:lnTo>
                  <a:lnTo>
                    <a:pt x="5994498" y="130588"/>
                  </a:lnTo>
                  <a:lnTo>
                    <a:pt x="5994498" y="90168"/>
                  </a:lnTo>
                  <a:lnTo>
                    <a:pt x="6045733" y="90168"/>
                  </a:lnTo>
                  <a:lnTo>
                    <a:pt x="6045733" y="49748"/>
                  </a:lnTo>
                  <a:lnTo>
                    <a:pt x="6301908" y="49748"/>
                  </a:lnTo>
                  <a:lnTo>
                    <a:pt x="6301908" y="49748"/>
                  </a:lnTo>
                  <a:lnTo>
                    <a:pt x="6527342" y="49748"/>
                  </a:lnTo>
                  <a:lnTo>
                    <a:pt x="6527342" y="49748"/>
                  </a:lnTo>
                  <a:lnTo>
                    <a:pt x="7049939" y="49748"/>
                  </a:lnTo>
                  <a:lnTo>
                    <a:pt x="7049939" y="49748"/>
                  </a:lnTo>
                  <a:lnTo>
                    <a:pt x="7265126" y="49748"/>
                  </a:lnTo>
                  <a:lnTo>
                    <a:pt x="7265126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28" name="rc29">
              <a:extLst>
                <a:ext uri="{FF2B5EF4-FFF2-40B4-BE49-F238E27FC236}">
                  <a16:creationId xmlns:a16="http://schemas.microsoft.com/office/drawing/2014/main" id="{B38C7BFB-4FE3-33E2-A841-20F4D6C6FC04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29" name="tx30">
              <a:extLst>
                <a:ext uri="{FF2B5EF4-FFF2-40B4-BE49-F238E27FC236}">
                  <a16:creationId xmlns:a16="http://schemas.microsoft.com/office/drawing/2014/main" id="{01679372-E5C8-E3A6-D15C-D540B6273481}"/>
                </a:ext>
              </a:extLst>
            </p:cNvPr>
            <p:cNvSpPr/>
            <p:nvPr/>
          </p:nvSpPr>
          <p:spPr>
            <a:xfrm>
              <a:off x="466667" y="3486760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430" name="tx31">
              <a:extLst>
                <a:ext uri="{FF2B5EF4-FFF2-40B4-BE49-F238E27FC236}">
                  <a16:creationId xmlns:a16="http://schemas.microsoft.com/office/drawing/2014/main" id="{9906D77C-E8B0-F1E9-03E8-96C7DB15F7A2}"/>
                </a:ext>
              </a:extLst>
            </p:cNvPr>
            <p:cNvSpPr/>
            <p:nvPr/>
          </p:nvSpPr>
          <p:spPr>
            <a:xfrm>
              <a:off x="466667" y="2678436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431" name="tx32">
              <a:extLst>
                <a:ext uri="{FF2B5EF4-FFF2-40B4-BE49-F238E27FC236}">
                  <a16:creationId xmlns:a16="http://schemas.microsoft.com/office/drawing/2014/main" id="{468F680E-1168-9AC4-89E2-38DD93593BF2}"/>
                </a:ext>
              </a:extLst>
            </p:cNvPr>
            <p:cNvSpPr/>
            <p:nvPr/>
          </p:nvSpPr>
          <p:spPr>
            <a:xfrm>
              <a:off x="466667" y="1870113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432" name="tx33">
              <a:extLst>
                <a:ext uri="{FF2B5EF4-FFF2-40B4-BE49-F238E27FC236}">
                  <a16:creationId xmlns:a16="http://schemas.microsoft.com/office/drawing/2014/main" id="{789DA596-B8CB-5F47-6832-847DAFDD6226}"/>
                </a:ext>
              </a:extLst>
            </p:cNvPr>
            <p:cNvSpPr/>
            <p:nvPr/>
          </p:nvSpPr>
          <p:spPr>
            <a:xfrm>
              <a:off x="466667" y="1061789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433" name="tx34">
              <a:extLst>
                <a:ext uri="{FF2B5EF4-FFF2-40B4-BE49-F238E27FC236}">
                  <a16:creationId xmlns:a16="http://schemas.microsoft.com/office/drawing/2014/main" id="{6DF6F55C-07AE-BD7D-7F41-48459E375C1F}"/>
                </a:ext>
              </a:extLst>
            </p:cNvPr>
            <p:cNvSpPr/>
            <p:nvPr/>
          </p:nvSpPr>
          <p:spPr>
            <a:xfrm>
              <a:off x="466667" y="253465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0</a:t>
              </a:r>
            </a:p>
          </p:txBody>
        </p:sp>
        <p:sp>
          <p:nvSpPr>
            <p:cNvPr id="434" name="pl35">
              <a:extLst>
                <a:ext uri="{FF2B5EF4-FFF2-40B4-BE49-F238E27FC236}">
                  <a16:creationId xmlns:a16="http://schemas.microsoft.com/office/drawing/2014/main" id="{758AB3A0-CFE7-D50E-5797-6C7E9BD84966}"/>
                </a:ext>
              </a:extLst>
            </p:cNvPr>
            <p:cNvSpPr/>
            <p:nvPr/>
          </p:nvSpPr>
          <p:spPr>
            <a:xfrm>
              <a:off x="741682" y="353413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35" name="pl36">
              <a:extLst>
                <a:ext uri="{FF2B5EF4-FFF2-40B4-BE49-F238E27FC236}">
                  <a16:creationId xmlns:a16="http://schemas.microsoft.com/office/drawing/2014/main" id="{E9697A08-5591-204A-DF46-991C8566BFDF}"/>
                </a:ext>
              </a:extLst>
            </p:cNvPr>
            <p:cNvSpPr/>
            <p:nvPr/>
          </p:nvSpPr>
          <p:spPr>
            <a:xfrm>
              <a:off x="741682" y="2725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36" name="pl37">
              <a:extLst>
                <a:ext uri="{FF2B5EF4-FFF2-40B4-BE49-F238E27FC236}">
                  <a16:creationId xmlns:a16="http://schemas.microsoft.com/office/drawing/2014/main" id="{05E3B53C-F6FD-411F-BD3D-9550513ED485}"/>
                </a:ext>
              </a:extLst>
            </p:cNvPr>
            <p:cNvSpPr/>
            <p:nvPr/>
          </p:nvSpPr>
          <p:spPr>
            <a:xfrm>
              <a:off x="741682" y="19174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37" name="pl38">
              <a:extLst>
                <a:ext uri="{FF2B5EF4-FFF2-40B4-BE49-F238E27FC236}">
                  <a16:creationId xmlns:a16="http://schemas.microsoft.com/office/drawing/2014/main" id="{BD1A7F3B-C5EB-1653-F41D-FFB7C0749F94}"/>
                </a:ext>
              </a:extLst>
            </p:cNvPr>
            <p:cNvSpPr/>
            <p:nvPr/>
          </p:nvSpPr>
          <p:spPr>
            <a:xfrm>
              <a:off x="741682" y="11091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38" name="pl39">
              <a:extLst>
                <a:ext uri="{FF2B5EF4-FFF2-40B4-BE49-F238E27FC236}">
                  <a16:creationId xmlns:a16="http://schemas.microsoft.com/office/drawing/2014/main" id="{10A49A7C-38D7-2509-AEA8-0FDBFCC54FEE}"/>
                </a:ext>
              </a:extLst>
            </p:cNvPr>
            <p:cNvSpPr/>
            <p:nvPr/>
          </p:nvSpPr>
          <p:spPr>
            <a:xfrm>
              <a:off x="741682" y="3008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39" name="pl40">
              <a:extLst>
                <a:ext uri="{FF2B5EF4-FFF2-40B4-BE49-F238E27FC236}">
                  <a16:creationId xmlns:a16="http://schemas.microsoft.com/office/drawing/2014/main" id="{4B08E4E0-49AF-1BC7-4774-8C4BB22501D8}"/>
                </a:ext>
              </a:extLst>
            </p:cNvPr>
            <p:cNvSpPr/>
            <p:nvPr/>
          </p:nvSpPr>
          <p:spPr>
            <a:xfrm>
              <a:off x="1150492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40" name="pl41">
              <a:extLst>
                <a:ext uri="{FF2B5EF4-FFF2-40B4-BE49-F238E27FC236}">
                  <a16:creationId xmlns:a16="http://schemas.microsoft.com/office/drawing/2014/main" id="{6169185C-4D17-8831-133C-5F71FFC89B26}"/>
                </a:ext>
              </a:extLst>
            </p:cNvPr>
            <p:cNvSpPr/>
            <p:nvPr/>
          </p:nvSpPr>
          <p:spPr>
            <a:xfrm>
              <a:off x="3199893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41" name="pl42">
              <a:extLst>
                <a:ext uri="{FF2B5EF4-FFF2-40B4-BE49-F238E27FC236}">
                  <a16:creationId xmlns:a16="http://schemas.microsoft.com/office/drawing/2014/main" id="{68B9A99A-C10B-273F-D6C2-715886BF8550}"/>
                </a:ext>
              </a:extLst>
            </p:cNvPr>
            <p:cNvSpPr/>
            <p:nvPr/>
          </p:nvSpPr>
          <p:spPr>
            <a:xfrm>
              <a:off x="5249294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42" name="pl43">
              <a:extLst>
                <a:ext uri="{FF2B5EF4-FFF2-40B4-BE49-F238E27FC236}">
                  <a16:creationId xmlns:a16="http://schemas.microsoft.com/office/drawing/2014/main" id="{27002975-C03E-9332-5970-31E0AB90DEB9}"/>
                </a:ext>
              </a:extLst>
            </p:cNvPr>
            <p:cNvSpPr/>
            <p:nvPr/>
          </p:nvSpPr>
          <p:spPr>
            <a:xfrm>
              <a:off x="7298695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43" name="tx44">
              <a:extLst>
                <a:ext uri="{FF2B5EF4-FFF2-40B4-BE49-F238E27FC236}">
                  <a16:creationId xmlns:a16="http://schemas.microsoft.com/office/drawing/2014/main" id="{C984ACE8-0816-4206-F04C-C49EB7BE1A84}"/>
                </a:ext>
              </a:extLst>
            </p:cNvPr>
            <p:cNvSpPr/>
            <p:nvPr/>
          </p:nvSpPr>
          <p:spPr>
            <a:xfrm>
              <a:off x="1115176" y="3756509"/>
              <a:ext cx="70631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444" name="tx45">
              <a:extLst>
                <a:ext uri="{FF2B5EF4-FFF2-40B4-BE49-F238E27FC236}">
                  <a16:creationId xmlns:a16="http://schemas.microsoft.com/office/drawing/2014/main" id="{4E9F3BA3-2E48-D373-B213-25D34772048C}"/>
                </a:ext>
              </a:extLst>
            </p:cNvPr>
            <p:cNvSpPr/>
            <p:nvPr/>
          </p:nvSpPr>
          <p:spPr>
            <a:xfrm>
              <a:off x="3093946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445" name="tx46">
              <a:extLst>
                <a:ext uri="{FF2B5EF4-FFF2-40B4-BE49-F238E27FC236}">
                  <a16:creationId xmlns:a16="http://schemas.microsoft.com/office/drawing/2014/main" id="{9C03479F-9695-DB93-5B73-8FD89539D98E}"/>
                </a:ext>
              </a:extLst>
            </p:cNvPr>
            <p:cNvSpPr/>
            <p:nvPr/>
          </p:nvSpPr>
          <p:spPr>
            <a:xfrm>
              <a:off x="5143347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446" name="tx47">
              <a:extLst>
                <a:ext uri="{FF2B5EF4-FFF2-40B4-BE49-F238E27FC236}">
                  <a16:creationId xmlns:a16="http://schemas.microsoft.com/office/drawing/2014/main" id="{419A89F3-C3E0-BE5E-0B0F-AEC848F5C571}"/>
                </a:ext>
              </a:extLst>
            </p:cNvPr>
            <p:cNvSpPr/>
            <p:nvPr/>
          </p:nvSpPr>
          <p:spPr>
            <a:xfrm>
              <a:off x="7192748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447" name="tx48">
              <a:extLst>
                <a:ext uri="{FF2B5EF4-FFF2-40B4-BE49-F238E27FC236}">
                  <a16:creationId xmlns:a16="http://schemas.microsoft.com/office/drawing/2014/main" id="{544FCFFB-DA39-340B-EC0F-F05A160A2393}"/>
                </a:ext>
              </a:extLst>
            </p:cNvPr>
            <p:cNvSpPr/>
            <p:nvPr/>
          </p:nvSpPr>
          <p:spPr>
            <a:xfrm>
              <a:off x="4009884" y="3878778"/>
              <a:ext cx="1761529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 to Transplant (Days)</a:t>
              </a:r>
            </a:p>
          </p:txBody>
        </p:sp>
        <p:sp>
          <p:nvSpPr>
            <p:cNvPr id="448" name="tx49">
              <a:extLst>
                <a:ext uri="{FF2B5EF4-FFF2-40B4-BE49-F238E27FC236}">
                  <a16:creationId xmlns:a16="http://schemas.microsoft.com/office/drawing/2014/main" id="{AE9B9592-11C8-C80A-1F90-9D5E2774C77D}"/>
                </a:ext>
              </a:extLst>
            </p:cNvPr>
            <p:cNvSpPr/>
            <p:nvPr/>
          </p:nvSpPr>
          <p:spPr>
            <a:xfrm rot="-5400000">
              <a:off x="-985888" y="1845978"/>
              <a:ext cx="2668190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umulative Incidence of Transplant (%)</a:t>
              </a:r>
            </a:p>
          </p:txBody>
        </p:sp>
        <p:sp>
          <p:nvSpPr>
            <p:cNvPr id="449" name="rc50">
              <a:extLst>
                <a:ext uri="{FF2B5EF4-FFF2-40B4-BE49-F238E27FC236}">
                  <a16:creationId xmlns:a16="http://schemas.microsoft.com/office/drawing/2014/main" id="{873C67C2-E1F9-6C1B-8566-32CD1B1CFBF8}"/>
                </a:ext>
              </a:extLst>
            </p:cNvPr>
            <p:cNvSpPr/>
            <p:nvPr/>
          </p:nvSpPr>
          <p:spPr>
            <a:xfrm>
              <a:off x="4276688" y="4189554"/>
              <a:ext cx="1227921" cy="358634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450" name="rc51">
              <a:extLst>
                <a:ext uri="{FF2B5EF4-FFF2-40B4-BE49-F238E27FC236}">
                  <a16:creationId xmlns:a16="http://schemas.microsoft.com/office/drawing/2014/main" id="{FFF1CEC2-30FB-B46B-E13C-F9439604326E}"/>
                </a:ext>
              </a:extLst>
            </p:cNvPr>
            <p:cNvSpPr/>
            <p:nvPr/>
          </p:nvSpPr>
          <p:spPr>
            <a:xfrm>
              <a:off x="4415866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451" name="pl52">
              <a:extLst>
                <a:ext uri="{FF2B5EF4-FFF2-40B4-BE49-F238E27FC236}">
                  <a16:creationId xmlns:a16="http://schemas.microsoft.com/office/drawing/2014/main" id="{D812F990-241C-476C-B1FC-43F2511263BA}"/>
                </a:ext>
              </a:extLst>
            </p:cNvPr>
            <p:cNvSpPr/>
            <p:nvPr/>
          </p:nvSpPr>
          <p:spPr>
            <a:xfrm>
              <a:off x="4437812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52" name="rc53">
              <a:extLst>
                <a:ext uri="{FF2B5EF4-FFF2-40B4-BE49-F238E27FC236}">
                  <a16:creationId xmlns:a16="http://schemas.microsoft.com/office/drawing/2014/main" id="{0C5525D6-9691-0005-FEB2-E675B183201B}"/>
                </a:ext>
              </a:extLst>
            </p:cNvPr>
            <p:cNvSpPr/>
            <p:nvPr/>
          </p:nvSpPr>
          <p:spPr>
            <a:xfrm>
              <a:off x="4926900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453" name="pl54">
              <a:extLst>
                <a:ext uri="{FF2B5EF4-FFF2-40B4-BE49-F238E27FC236}">
                  <a16:creationId xmlns:a16="http://schemas.microsoft.com/office/drawing/2014/main" id="{0BFFAB43-8533-FA94-537E-9297266477DF}"/>
                </a:ext>
              </a:extLst>
            </p:cNvPr>
            <p:cNvSpPr/>
            <p:nvPr/>
          </p:nvSpPr>
          <p:spPr>
            <a:xfrm>
              <a:off x="4948846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54" name="tx55">
              <a:extLst>
                <a:ext uri="{FF2B5EF4-FFF2-40B4-BE49-F238E27FC236}">
                  <a16:creationId xmlns:a16="http://schemas.microsoft.com/office/drawing/2014/main" id="{0D45F64B-9274-4EEE-BD9A-F9F3AAE01178}"/>
                </a:ext>
              </a:extLst>
            </p:cNvPr>
            <p:cNvSpPr/>
            <p:nvPr/>
          </p:nvSpPr>
          <p:spPr>
            <a:xfrm>
              <a:off x="4704911" y="4321929"/>
              <a:ext cx="162346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455" name="tx56">
              <a:extLst>
                <a:ext uri="{FF2B5EF4-FFF2-40B4-BE49-F238E27FC236}">
                  <a16:creationId xmlns:a16="http://schemas.microsoft.com/office/drawing/2014/main" id="{A3718E9C-3402-4CBC-91EF-2A112B4F32B7}"/>
                </a:ext>
              </a:extLst>
            </p:cNvPr>
            <p:cNvSpPr/>
            <p:nvPr/>
          </p:nvSpPr>
          <p:spPr>
            <a:xfrm>
              <a:off x="5215945" y="4321929"/>
              <a:ext cx="218839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  <p:sp>
          <p:nvSpPr>
            <p:cNvPr id="456" name="rc57">
              <a:extLst>
                <a:ext uri="{FF2B5EF4-FFF2-40B4-BE49-F238E27FC236}">
                  <a16:creationId xmlns:a16="http://schemas.microsoft.com/office/drawing/2014/main" id="{DA2E8BF9-FD42-54CC-E42A-9563D63C3C67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57" name="rc58">
              <a:extLst>
                <a:ext uri="{FF2B5EF4-FFF2-40B4-BE49-F238E27FC236}">
                  <a16:creationId xmlns:a16="http://schemas.microsoft.com/office/drawing/2014/main" id="{5D2B18FA-6425-9557-015C-CB94D0D62F99}"/>
                </a:ext>
              </a:extLst>
            </p:cNvPr>
            <p:cNvSpPr/>
            <p:nvPr/>
          </p:nvSpPr>
          <p:spPr>
            <a:xfrm>
              <a:off x="776476" y="4996549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458" name="tx59">
              <a:extLst>
                <a:ext uri="{FF2B5EF4-FFF2-40B4-BE49-F238E27FC236}">
                  <a16:creationId xmlns:a16="http://schemas.microsoft.com/office/drawing/2014/main" id="{CEDCD3EA-8B35-6588-C9E1-AF2F96EF12D1}"/>
                </a:ext>
              </a:extLst>
            </p:cNvPr>
            <p:cNvSpPr/>
            <p:nvPr/>
          </p:nvSpPr>
          <p:spPr>
            <a:xfrm>
              <a:off x="1115323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459" name="tx60">
              <a:extLst>
                <a:ext uri="{FF2B5EF4-FFF2-40B4-BE49-F238E27FC236}">
                  <a16:creationId xmlns:a16="http://schemas.microsoft.com/office/drawing/2014/main" id="{3BF31392-A285-D1B9-CBCC-BD71B9D9BD8A}"/>
                </a:ext>
              </a:extLst>
            </p:cNvPr>
            <p:cNvSpPr/>
            <p:nvPr/>
          </p:nvSpPr>
          <p:spPr>
            <a:xfrm>
              <a:off x="1080154" y="5132574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8</a:t>
              </a:r>
            </a:p>
          </p:txBody>
        </p:sp>
        <p:sp>
          <p:nvSpPr>
            <p:cNvPr id="460" name="tx61">
              <a:extLst>
                <a:ext uri="{FF2B5EF4-FFF2-40B4-BE49-F238E27FC236}">
                  <a16:creationId xmlns:a16="http://schemas.microsoft.com/office/drawing/2014/main" id="{AF44CDE7-99DD-3F9B-EC99-7DC15C238EE6}"/>
                </a:ext>
              </a:extLst>
            </p:cNvPr>
            <p:cNvSpPr/>
            <p:nvPr/>
          </p:nvSpPr>
          <p:spPr>
            <a:xfrm>
              <a:off x="3164724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461" name="tx62">
              <a:extLst>
                <a:ext uri="{FF2B5EF4-FFF2-40B4-BE49-F238E27FC236}">
                  <a16:creationId xmlns:a16="http://schemas.microsoft.com/office/drawing/2014/main" id="{535FF189-172D-29D4-4589-45E7ECA385C3}"/>
                </a:ext>
              </a:extLst>
            </p:cNvPr>
            <p:cNvSpPr/>
            <p:nvPr/>
          </p:nvSpPr>
          <p:spPr>
            <a:xfrm>
              <a:off x="3164724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462" name="tx63">
              <a:extLst>
                <a:ext uri="{FF2B5EF4-FFF2-40B4-BE49-F238E27FC236}">
                  <a16:creationId xmlns:a16="http://schemas.microsoft.com/office/drawing/2014/main" id="{9C668084-E64F-6F7D-DFD6-FDF42A8CD6CB}"/>
                </a:ext>
              </a:extLst>
            </p:cNvPr>
            <p:cNvSpPr/>
            <p:nvPr/>
          </p:nvSpPr>
          <p:spPr>
            <a:xfrm>
              <a:off x="5214125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463" name="tx64">
              <a:extLst>
                <a:ext uri="{FF2B5EF4-FFF2-40B4-BE49-F238E27FC236}">
                  <a16:creationId xmlns:a16="http://schemas.microsoft.com/office/drawing/2014/main" id="{9B0EDC51-E215-E800-1D2B-3B0D038067E6}"/>
                </a:ext>
              </a:extLst>
            </p:cNvPr>
            <p:cNvSpPr/>
            <p:nvPr/>
          </p:nvSpPr>
          <p:spPr>
            <a:xfrm>
              <a:off x="5214125" y="5134179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464" name="tx65">
              <a:extLst>
                <a:ext uri="{FF2B5EF4-FFF2-40B4-BE49-F238E27FC236}">
                  <a16:creationId xmlns:a16="http://schemas.microsoft.com/office/drawing/2014/main" id="{41F94CF6-46E1-F3D3-75DA-11015FF266F4}"/>
                </a:ext>
              </a:extLst>
            </p:cNvPr>
            <p:cNvSpPr/>
            <p:nvPr/>
          </p:nvSpPr>
          <p:spPr>
            <a:xfrm>
              <a:off x="7263526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</a:t>
              </a:r>
            </a:p>
          </p:txBody>
        </p:sp>
        <p:sp>
          <p:nvSpPr>
            <p:cNvPr id="465" name="tx66">
              <a:extLst>
                <a:ext uri="{FF2B5EF4-FFF2-40B4-BE49-F238E27FC236}">
                  <a16:creationId xmlns:a16="http://schemas.microsoft.com/office/drawing/2014/main" id="{3E577F04-52D7-997A-C22E-12588D9E0B0C}"/>
                </a:ext>
              </a:extLst>
            </p:cNvPr>
            <p:cNvSpPr/>
            <p:nvPr/>
          </p:nvSpPr>
          <p:spPr>
            <a:xfrm>
              <a:off x="7263526" y="5134117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466" name="tx67">
              <a:extLst>
                <a:ext uri="{FF2B5EF4-FFF2-40B4-BE49-F238E27FC236}">
                  <a16:creationId xmlns:a16="http://schemas.microsoft.com/office/drawing/2014/main" id="{E8403BA9-8641-5871-1F44-9D8626E7E9E9}"/>
                </a:ext>
              </a:extLst>
            </p:cNvPr>
            <p:cNvSpPr/>
            <p:nvPr/>
          </p:nvSpPr>
          <p:spPr>
            <a:xfrm>
              <a:off x="325591" y="5438152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467" name="tx68">
              <a:extLst>
                <a:ext uri="{FF2B5EF4-FFF2-40B4-BE49-F238E27FC236}">
                  <a16:creationId xmlns:a16="http://schemas.microsoft.com/office/drawing/2014/main" id="{6CFC9E7E-3CB9-1BEE-7386-9D96875820C0}"/>
                </a:ext>
              </a:extLst>
            </p:cNvPr>
            <p:cNvSpPr/>
            <p:nvPr/>
          </p:nvSpPr>
          <p:spPr>
            <a:xfrm>
              <a:off x="311638" y="5132811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468" name="tx69">
              <a:extLst>
                <a:ext uri="{FF2B5EF4-FFF2-40B4-BE49-F238E27FC236}">
                  <a16:creationId xmlns:a16="http://schemas.microsoft.com/office/drawing/2014/main" id="{83DBEFB9-98B9-113E-3A01-783AB8198778}"/>
                </a:ext>
              </a:extLst>
            </p:cNvPr>
            <p:cNvSpPr/>
            <p:nvPr/>
          </p:nvSpPr>
          <p:spPr>
            <a:xfrm>
              <a:off x="776476" y="4827633"/>
              <a:ext cx="17452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469" name="rc70">
              <a:extLst>
                <a:ext uri="{FF2B5EF4-FFF2-40B4-BE49-F238E27FC236}">
                  <a16:creationId xmlns:a16="http://schemas.microsoft.com/office/drawing/2014/main" id="{2DBE45CB-EA31-AA42-233A-ADAD59CF3947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70" name="rc71">
              <a:extLst>
                <a:ext uri="{FF2B5EF4-FFF2-40B4-BE49-F238E27FC236}">
                  <a16:creationId xmlns:a16="http://schemas.microsoft.com/office/drawing/2014/main" id="{C9DF87F9-B676-C191-6989-500116B63D27}"/>
                </a:ext>
              </a:extLst>
            </p:cNvPr>
            <p:cNvSpPr/>
            <p:nvPr/>
          </p:nvSpPr>
          <p:spPr>
            <a:xfrm>
              <a:off x="776476" y="6081865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471" name="tx72">
              <a:extLst>
                <a:ext uri="{FF2B5EF4-FFF2-40B4-BE49-F238E27FC236}">
                  <a16:creationId xmlns:a16="http://schemas.microsoft.com/office/drawing/2014/main" id="{BA9914E7-AAAF-1EB4-26F1-5C4BDCC1A0D0}"/>
                </a:ext>
              </a:extLst>
            </p:cNvPr>
            <p:cNvSpPr/>
            <p:nvPr/>
          </p:nvSpPr>
          <p:spPr>
            <a:xfrm>
              <a:off x="1115323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472" name="tx73">
              <a:extLst>
                <a:ext uri="{FF2B5EF4-FFF2-40B4-BE49-F238E27FC236}">
                  <a16:creationId xmlns:a16="http://schemas.microsoft.com/office/drawing/2014/main" id="{A880C5E8-7F43-B470-5B84-D0A44E8D2869}"/>
                </a:ext>
              </a:extLst>
            </p:cNvPr>
            <p:cNvSpPr/>
            <p:nvPr/>
          </p:nvSpPr>
          <p:spPr>
            <a:xfrm>
              <a:off x="1080154" y="6217890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6</a:t>
              </a:r>
            </a:p>
          </p:txBody>
        </p:sp>
        <p:sp>
          <p:nvSpPr>
            <p:cNvPr id="473" name="tx74">
              <a:extLst>
                <a:ext uri="{FF2B5EF4-FFF2-40B4-BE49-F238E27FC236}">
                  <a16:creationId xmlns:a16="http://schemas.microsoft.com/office/drawing/2014/main" id="{103A158E-DF4D-21D7-AD0C-9CA743B0B263}"/>
                </a:ext>
              </a:extLst>
            </p:cNvPr>
            <p:cNvSpPr/>
            <p:nvPr/>
          </p:nvSpPr>
          <p:spPr>
            <a:xfrm>
              <a:off x="3129555" y="6523231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6</a:t>
              </a:r>
            </a:p>
          </p:txBody>
        </p:sp>
        <p:sp>
          <p:nvSpPr>
            <p:cNvPr id="474" name="tx75">
              <a:extLst>
                <a:ext uri="{FF2B5EF4-FFF2-40B4-BE49-F238E27FC236}">
                  <a16:creationId xmlns:a16="http://schemas.microsoft.com/office/drawing/2014/main" id="{0D965D3F-034E-17CF-5786-71E3C3BFA3F1}"/>
                </a:ext>
              </a:extLst>
            </p:cNvPr>
            <p:cNvSpPr/>
            <p:nvPr/>
          </p:nvSpPr>
          <p:spPr>
            <a:xfrm>
              <a:off x="3129555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1</a:t>
              </a:r>
            </a:p>
          </p:txBody>
        </p:sp>
        <p:sp>
          <p:nvSpPr>
            <p:cNvPr id="475" name="tx76">
              <a:extLst>
                <a:ext uri="{FF2B5EF4-FFF2-40B4-BE49-F238E27FC236}">
                  <a16:creationId xmlns:a16="http://schemas.microsoft.com/office/drawing/2014/main" id="{E2F28E8A-17A0-85A3-043D-2090AB2F7E29}"/>
                </a:ext>
              </a:extLst>
            </p:cNvPr>
            <p:cNvSpPr/>
            <p:nvPr/>
          </p:nvSpPr>
          <p:spPr>
            <a:xfrm>
              <a:off x="5178956" y="6523231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1</a:t>
              </a:r>
            </a:p>
          </p:txBody>
        </p:sp>
        <p:sp>
          <p:nvSpPr>
            <p:cNvPr id="476" name="tx77">
              <a:extLst>
                <a:ext uri="{FF2B5EF4-FFF2-40B4-BE49-F238E27FC236}">
                  <a16:creationId xmlns:a16="http://schemas.microsoft.com/office/drawing/2014/main" id="{FE9EBA56-5717-1467-F1A4-3C81E9A09859}"/>
                </a:ext>
              </a:extLst>
            </p:cNvPr>
            <p:cNvSpPr/>
            <p:nvPr/>
          </p:nvSpPr>
          <p:spPr>
            <a:xfrm>
              <a:off x="5178956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4</a:t>
              </a:r>
            </a:p>
          </p:txBody>
        </p:sp>
        <p:sp>
          <p:nvSpPr>
            <p:cNvPr id="477" name="tx78">
              <a:extLst>
                <a:ext uri="{FF2B5EF4-FFF2-40B4-BE49-F238E27FC236}">
                  <a16:creationId xmlns:a16="http://schemas.microsoft.com/office/drawing/2014/main" id="{5F879D8F-2B71-1091-646D-7DFAEAFD21B1}"/>
                </a:ext>
              </a:extLst>
            </p:cNvPr>
            <p:cNvSpPr/>
            <p:nvPr/>
          </p:nvSpPr>
          <p:spPr>
            <a:xfrm>
              <a:off x="7228357" y="6523231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8</a:t>
              </a:r>
            </a:p>
          </p:txBody>
        </p:sp>
        <p:sp>
          <p:nvSpPr>
            <p:cNvPr id="478" name="tx79">
              <a:extLst>
                <a:ext uri="{FF2B5EF4-FFF2-40B4-BE49-F238E27FC236}">
                  <a16:creationId xmlns:a16="http://schemas.microsoft.com/office/drawing/2014/main" id="{E9EE2101-FDC6-7C82-0620-85CC6DC6D59D}"/>
                </a:ext>
              </a:extLst>
            </p:cNvPr>
            <p:cNvSpPr/>
            <p:nvPr/>
          </p:nvSpPr>
          <p:spPr>
            <a:xfrm>
              <a:off x="7228357" y="6217890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6</a:t>
              </a:r>
            </a:p>
          </p:txBody>
        </p:sp>
        <p:sp>
          <p:nvSpPr>
            <p:cNvPr id="479" name="tx80">
              <a:extLst>
                <a:ext uri="{FF2B5EF4-FFF2-40B4-BE49-F238E27FC236}">
                  <a16:creationId xmlns:a16="http://schemas.microsoft.com/office/drawing/2014/main" id="{1BE89726-4C7D-8CC4-CFF1-E7912E572204}"/>
                </a:ext>
              </a:extLst>
            </p:cNvPr>
            <p:cNvSpPr/>
            <p:nvPr/>
          </p:nvSpPr>
          <p:spPr>
            <a:xfrm>
              <a:off x="325591" y="6523468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480" name="tx81">
              <a:extLst>
                <a:ext uri="{FF2B5EF4-FFF2-40B4-BE49-F238E27FC236}">
                  <a16:creationId xmlns:a16="http://schemas.microsoft.com/office/drawing/2014/main" id="{FC33A980-D296-C367-0F32-6CC58F14CFD7}"/>
                </a:ext>
              </a:extLst>
            </p:cNvPr>
            <p:cNvSpPr/>
            <p:nvPr/>
          </p:nvSpPr>
          <p:spPr>
            <a:xfrm>
              <a:off x="311638" y="6218127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481" name="tx82">
              <a:extLst>
                <a:ext uri="{FF2B5EF4-FFF2-40B4-BE49-F238E27FC236}">
                  <a16:creationId xmlns:a16="http://schemas.microsoft.com/office/drawing/2014/main" id="{CFC3ACF6-A4C2-BB43-D7FC-6A59F75CDCE8}"/>
                </a:ext>
              </a:extLst>
            </p:cNvPr>
            <p:cNvSpPr/>
            <p:nvPr/>
          </p:nvSpPr>
          <p:spPr>
            <a:xfrm>
              <a:off x="776476" y="5912949"/>
              <a:ext cx="23525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</p:grpSp>
      <p:sp>
        <p:nvSpPr>
          <p:cNvPr id="482" name="TextBox 481">
            <a:extLst>
              <a:ext uri="{FF2B5EF4-FFF2-40B4-BE49-F238E27FC236}">
                <a16:creationId xmlns:a16="http://schemas.microsoft.com/office/drawing/2014/main" id="{3453FFA5-71A7-976A-BFAA-4E648EA922CE}"/>
              </a:ext>
            </a:extLst>
          </p:cNvPr>
          <p:cNvSpPr txBox="1"/>
          <p:nvPr/>
        </p:nvSpPr>
        <p:spPr>
          <a:xfrm>
            <a:off x="879430" y="5539862"/>
            <a:ext cx="3001129" cy="6014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7" b="1" dirty="0">
                <a:latin typeface="Arial" panose="020B0604020202020204" pitchFamily="34" charset="0"/>
                <a:cs typeface="Arial" panose="020B0604020202020204" pitchFamily="34" charset="0"/>
              </a:rPr>
              <a:t>Potential Living Donor  Total   Event   HR (95% CI)</a:t>
            </a:r>
          </a:p>
          <a:p>
            <a:r>
              <a:rPr lang="en-US" sz="827" dirty="0">
                <a:latin typeface="Arial" panose="020B0604020202020204" pitchFamily="34" charset="0"/>
                <a:cs typeface="Arial" panose="020B0604020202020204" pitchFamily="34" charset="0"/>
              </a:rPr>
              <a:t>No                                      18         9         Reference</a:t>
            </a:r>
          </a:p>
          <a:p>
            <a:r>
              <a:rPr lang="en-US" sz="827" dirty="0">
                <a:latin typeface="Arial" panose="020B0604020202020204" pitchFamily="34" charset="0"/>
                <a:cs typeface="Arial" panose="020B0604020202020204" pitchFamily="34" charset="0"/>
              </a:rPr>
              <a:t>Yes                                     96        68       1.61 (0.77 – 3.37)</a:t>
            </a:r>
          </a:p>
          <a:p>
            <a:r>
              <a:rPr lang="en-US" sz="827" dirty="0">
                <a:latin typeface="Arial" panose="020B0604020202020204" pitchFamily="34" charset="0"/>
                <a:cs typeface="Arial" panose="020B0604020202020204" pitchFamily="34" charset="0"/>
              </a:rPr>
              <a:t>Gray K-Sample Test P-value: 0.1989  </a:t>
            </a:r>
          </a:p>
        </p:txBody>
      </p:sp>
      <p:sp>
        <p:nvSpPr>
          <p:cNvPr id="483" name="pl48">
            <a:extLst>
              <a:ext uri="{FF2B5EF4-FFF2-40B4-BE49-F238E27FC236}">
                <a16:creationId xmlns:a16="http://schemas.microsoft.com/office/drawing/2014/main" id="{FEFAB084-2A7F-D656-7184-0D2FF7CF9093}"/>
              </a:ext>
            </a:extLst>
          </p:cNvPr>
          <p:cNvSpPr/>
          <p:nvPr/>
        </p:nvSpPr>
        <p:spPr>
          <a:xfrm>
            <a:off x="743965" y="5765463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484" name="pl50">
            <a:extLst>
              <a:ext uri="{FF2B5EF4-FFF2-40B4-BE49-F238E27FC236}">
                <a16:creationId xmlns:a16="http://schemas.microsoft.com/office/drawing/2014/main" id="{5320A13F-4065-E9C9-DA76-CC941D2040C4}"/>
              </a:ext>
            </a:extLst>
          </p:cNvPr>
          <p:cNvSpPr/>
          <p:nvPr/>
        </p:nvSpPr>
        <p:spPr>
          <a:xfrm>
            <a:off x="732310" y="5859606"/>
            <a:ext cx="126502" cy="37802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grpSp>
        <p:nvGrpSpPr>
          <p:cNvPr id="485" name="Group 484">
            <a:extLst>
              <a:ext uri="{FF2B5EF4-FFF2-40B4-BE49-F238E27FC236}">
                <a16:creationId xmlns:a16="http://schemas.microsoft.com/office/drawing/2014/main" id="{FF0724B0-F582-2174-8FCE-C28B1E514D06}"/>
              </a:ext>
            </a:extLst>
          </p:cNvPr>
          <p:cNvGrpSpPr>
            <a:grpSpLocks noChangeAspect="1"/>
          </p:cNvGrpSpPr>
          <p:nvPr/>
        </p:nvGrpSpPr>
        <p:grpSpPr>
          <a:xfrm>
            <a:off x="4833580" y="5402987"/>
            <a:ext cx="4817929" cy="3571875"/>
            <a:chOff x="0" y="0"/>
            <a:chExt cx="9144000" cy="6858000"/>
          </a:xfrm>
        </p:grpSpPr>
        <p:sp>
          <p:nvSpPr>
            <p:cNvPr id="486" name="rc3">
              <a:extLst>
                <a:ext uri="{FF2B5EF4-FFF2-40B4-BE49-F238E27FC236}">
                  <a16:creationId xmlns:a16="http://schemas.microsoft.com/office/drawing/2014/main" id="{4450E87E-EAC3-F9F5-7EA6-127FEA3C0511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87" name="rc4">
              <a:extLst>
                <a:ext uri="{FF2B5EF4-FFF2-40B4-BE49-F238E27FC236}">
                  <a16:creationId xmlns:a16="http://schemas.microsoft.com/office/drawing/2014/main" id="{24876C33-A171-426C-1008-066A2B4F00D6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88" name="rc5">
              <a:extLst>
                <a:ext uri="{FF2B5EF4-FFF2-40B4-BE49-F238E27FC236}">
                  <a16:creationId xmlns:a16="http://schemas.microsoft.com/office/drawing/2014/main" id="{9222EC21-A61D-D772-77FB-BF680F2369CB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89" name="rc6">
              <a:extLst>
                <a:ext uri="{FF2B5EF4-FFF2-40B4-BE49-F238E27FC236}">
                  <a16:creationId xmlns:a16="http://schemas.microsoft.com/office/drawing/2014/main" id="{25EBF76A-CB2B-9351-47EC-CB6BFE2B1A2A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90" name="rc7">
              <a:extLst>
                <a:ext uri="{FF2B5EF4-FFF2-40B4-BE49-F238E27FC236}">
                  <a16:creationId xmlns:a16="http://schemas.microsoft.com/office/drawing/2014/main" id="{AD9FFDA5-2466-890E-293B-F2E3340DA0C9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91" name="rc8">
              <a:extLst>
                <a:ext uri="{FF2B5EF4-FFF2-40B4-BE49-F238E27FC236}">
                  <a16:creationId xmlns:a16="http://schemas.microsoft.com/office/drawing/2014/main" id="{9220FB16-0332-F0F4-9FEA-F07DC6D272B4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92" name="rc9">
              <a:extLst>
                <a:ext uri="{FF2B5EF4-FFF2-40B4-BE49-F238E27FC236}">
                  <a16:creationId xmlns:a16="http://schemas.microsoft.com/office/drawing/2014/main" id="{1D1E1514-0266-CB18-D03F-085501A01DD2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494" name="pl18">
              <a:extLst>
                <a:ext uri="{FF2B5EF4-FFF2-40B4-BE49-F238E27FC236}">
                  <a16:creationId xmlns:a16="http://schemas.microsoft.com/office/drawing/2014/main" id="{18BFFD6F-86A0-D087-E7C5-8B41221202DD}"/>
                </a:ext>
              </a:extLst>
            </p:cNvPr>
            <p:cNvSpPr/>
            <p:nvPr/>
          </p:nvSpPr>
          <p:spPr>
            <a:xfrm>
              <a:off x="776476" y="3534137"/>
              <a:ext cx="8228345" cy="0"/>
            </a:xfrm>
            <a:custGeom>
              <a:avLst/>
              <a:gdLst/>
              <a:ahLst/>
              <a:cxnLst/>
              <a:rect l="0" t="0" r="0" b="0"/>
              <a:pathLst>
                <a:path w="8228345">
                  <a:moveTo>
                    <a:pt x="0" y="0"/>
                  </a:moveTo>
                  <a:lnTo>
                    <a:pt x="8228345" y="0"/>
                  </a:lnTo>
                  <a:lnTo>
                    <a:pt x="8228345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95" name="pl23">
              <a:extLst>
                <a:ext uri="{FF2B5EF4-FFF2-40B4-BE49-F238E27FC236}">
                  <a16:creationId xmlns:a16="http://schemas.microsoft.com/office/drawing/2014/main" id="{2402A13D-43B9-A5AB-E869-C52427D3D91F}"/>
                </a:ext>
              </a:extLst>
            </p:cNvPr>
            <p:cNvSpPr/>
            <p:nvPr/>
          </p:nvSpPr>
          <p:spPr>
            <a:xfrm>
              <a:off x="1150492" y="139178"/>
              <a:ext cx="0" cy="3556623"/>
            </a:xfrm>
            <a:custGeom>
              <a:avLst/>
              <a:gdLst/>
              <a:ahLst/>
              <a:cxnLst/>
              <a:rect l="0" t="0" r="0" b="0"/>
              <a:pathLst>
                <a:path h="3556623">
                  <a:moveTo>
                    <a:pt x="0" y="35566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96" name="pl27">
              <a:extLst>
                <a:ext uri="{FF2B5EF4-FFF2-40B4-BE49-F238E27FC236}">
                  <a16:creationId xmlns:a16="http://schemas.microsoft.com/office/drawing/2014/main" id="{833CB56B-87CB-E95B-CE5C-145C0366A1EA}"/>
                </a:ext>
              </a:extLst>
            </p:cNvPr>
            <p:cNvSpPr/>
            <p:nvPr/>
          </p:nvSpPr>
          <p:spPr>
            <a:xfrm>
              <a:off x="1150492" y="2321651"/>
              <a:ext cx="4354977" cy="1212485"/>
            </a:xfrm>
            <a:custGeom>
              <a:avLst/>
              <a:gdLst/>
              <a:ahLst/>
              <a:cxnLst/>
              <a:rect l="0" t="0" r="0" b="0"/>
              <a:pathLst>
                <a:path w="4354977" h="1212485">
                  <a:moveTo>
                    <a:pt x="0" y="1212485"/>
                  </a:moveTo>
                  <a:lnTo>
                    <a:pt x="51235" y="1212485"/>
                  </a:lnTo>
                  <a:lnTo>
                    <a:pt x="51235" y="1212485"/>
                  </a:lnTo>
                  <a:lnTo>
                    <a:pt x="61482" y="1212485"/>
                  </a:lnTo>
                  <a:lnTo>
                    <a:pt x="61482" y="808323"/>
                  </a:lnTo>
                  <a:lnTo>
                    <a:pt x="184446" y="808323"/>
                  </a:lnTo>
                  <a:lnTo>
                    <a:pt x="184446" y="404161"/>
                  </a:lnTo>
                  <a:lnTo>
                    <a:pt x="2100636" y="404161"/>
                  </a:lnTo>
                  <a:lnTo>
                    <a:pt x="2100636" y="404161"/>
                  </a:lnTo>
                  <a:lnTo>
                    <a:pt x="3340523" y="404161"/>
                  </a:lnTo>
                  <a:lnTo>
                    <a:pt x="3340523" y="404161"/>
                  </a:lnTo>
                  <a:lnTo>
                    <a:pt x="3863120" y="404161"/>
                  </a:lnTo>
                  <a:lnTo>
                    <a:pt x="3863120" y="0"/>
                  </a:lnTo>
                  <a:lnTo>
                    <a:pt x="4027073" y="0"/>
                  </a:lnTo>
                  <a:lnTo>
                    <a:pt x="4027073" y="0"/>
                  </a:lnTo>
                  <a:lnTo>
                    <a:pt x="4354977" y="0"/>
                  </a:lnTo>
                  <a:lnTo>
                    <a:pt x="4354977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97" name="pl28">
              <a:extLst>
                <a:ext uri="{FF2B5EF4-FFF2-40B4-BE49-F238E27FC236}">
                  <a16:creationId xmlns:a16="http://schemas.microsoft.com/office/drawing/2014/main" id="{ABBEEB8C-BB9B-2481-27FC-9022E74CCD8D}"/>
                </a:ext>
              </a:extLst>
            </p:cNvPr>
            <p:cNvSpPr/>
            <p:nvPr/>
          </p:nvSpPr>
          <p:spPr>
            <a:xfrm>
              <a:off x="1150492" y="1329618"/>
              <a:ext cx="7008951" cy="2204518"/>
            </a:xfrm>
            <a:custGeom>
              <a:avLst/>
              <a:gdLst/>
              <a:ahLst/>
              <a:cxnLst/>
              <a:rect l="0" t="0" r="0" b="0"/>
              <a:pathLst>
                <a:path w="7008951" h="2204518">
                  <a:moveTo>
                    <a:pt x="0" y="2204518"/>
                  </a:moveTo>
                  <a:lnTo>
                    <a:pt x="61482" y="2204518"/>
                  </a:lnTo>
                  <a:lnTo>
                    <a:pt x="61482" y="2057551"/>
                  </a:lnTo>
                  <a:lnTo>
                    <a:pt x="71729" y="2057551"/>
                  </a:lnTo>
                  <a:lnTo>
                    <a:pt x="71729" y="1910583"/>
                  </a:lnTo>
                  <a:lnTo>
                    <a:pt x="112717" y="1910583"/>
                  </a:lnTo>
                  <a:lnTo>
                    <a:pt x="112717" y="1763615"/>
                  </a:lnTo>
                  <a:lnTo>
                    <a:pt x="266422" y="1763615"/>
                  </a:lnTo>
                  <a:lnTo>
                    <a:pt x="266422" y="1763615"/>
                  </a:lnTo>
                  <a:lnTo>
                    <a:pt x="286916" y="1763615"/>
                  </a:lnTo>
                  <a:lnTo>
                    <a:pt x="286916" y="1616647"/>
                  </a:lnTo>
                  <a:lnTo>
                    <a:pt x="430374" y="1616647"/>
                  </a:lnTo>
                  <a:lnTo>
                    <a:pt x="430374" y="1469679"/>
                  </a:lnTo>
                  <a:lnTo>
                    <a:pt x="522597" y="1469679"/>
                  </a:lnTo>
                  <a:lnTo>
                    <a:pt x="522597" y="1322711"/>
                  </a:lnTo>
                  <a:lnTo>
                    <a:pt x="840254" y="1322711"/>
                  </a:lnTo>
                  <a:lnTo>
                    <a:pt x="840254" y="1322711"/>
                  </a:lnTo>
                  <a:lnTo>
                    <a:pt x="942724" y="1322711"/>
                  </a:lnTo>
                  <a:lnTo>
                    <a:pt x="942724" y="1175743"/>
                  </a:lnTo>
                  <a:lnTo>
                    <a:pt x="1014453" y="1175743"/>
                  </a:lnTo>
                  <a:lnTo>
                    <a:pt x="1014453" y="1028775"/>
                  </a:lnTo>
                  <a:lnTo>
                    <a:pt x="1198899" y="1028775"/>
                  </a:lnTo>
                  <a:lnTo>
                    <a:pt x="1198899" y="881807"/>
                  </a:lnTo>
                  <a:lnTo>
                    <a:pt x="1485815" y="881807"/>
                  </a:lnTo>
                  <a:lnTo>
                    <a:pt x="1485815" y="734839"/>
                  </a:lnTo>
                  <a:lnTo>
                    <a:pt x="1649767" y="734839"/>
                  </a:lnTo>
                  <a:lnTo>
                    <a:pt x="1649767" y="734839"/>
                  </a:lnTo>
                  <a:lnTo>
                    <a:pt x="1731743" y="734839"/>
                  </a:lnTo>
                  <a:lnTo>
                    <a:pt x="1731743" y="587871"/>
                  </a:lnTo>
                  <a:lnTo>
                    <a:pt x="1741990" y="587871"/>
                  </a:lnTo>
                  <a:lnTo>
                    <a:pt x="1741990" y="440903"/>
                  </a:lnTo>
                  <a:lnTo>
                    <a:pt x="2121130" y="440903"/>
                  </a:lnTo>
                  <a:lnTo>
                    <a:pt x="2121130" y="293935"/>
                  </a:lnTo>
                  <a:lnTo>
                    <a:pt x="2285082" y="293935"/>
                  </a:lnTo>
                  <a:lnTo>
                    <a:pt x="2285082" y="146967"/>
                  </a:lnTo>
                  <a:lnTo>
                    <a:pt x="2787185" y="146967"/>
                  </a:lnTo>
                  <a:lnTo>
                    <a:pt x="2787185" y="146967"/>
                  </a:lnTo>
                  <a:lnTo>
                    <a:pt x="3217559" y="146967"/>
                  </a:lnTo>
                  <a:lnTo>
                    <a:pt x="3217559" y="0"/>
                  </a:lnTo>
                  <a:lnTo>
                    <a:pt x="3279041" y="0"/>
                  </a:lnTo>
                  <a:lnTo>
                    <a:pt x="3279041" y="0"/>
                  </a:lnTo>
                  <a:lnTo>
                    <a:pt x="7008951" y="0"/>
                  </a:lnTo>
                  <a:lnTo>
                    <a:pt x="7008951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98" name="rc29">
              <a:extLst>
                <a:ext uri="{FF2B5EF4-FFF2-40B4-BE49-F238E27FC236}">
                  <a16:creationId xmlns:a16="http://schemas.microsoft.com/office/drawing/2014/main" id="{BAC640E2-C073-99A8-9C22-1AE89EC74860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499" name="tx30">
              <a:extLst>
                <a:ext uri="{FF2B5EF4-FFF2-40B4-BE49-F238E27FC236}">
                  <a16:creationId xmlns:a16="http://schemas.microsoft.com/office/drawing/2014/main" id="{2361C2A3-FDBD-A122-52CE-A6CC0400767D}"/>
                </a:ext>
              </a:extLst>
            </p:cNvPr>
            <p:cNvSpPr/>
            <p:nvPr/>
          </p:nvSpPr>
          <p:spPr>
            <a:xfrm>
              <a:off x="466667" y="3486760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500" name="tx31">
              <a:extLst>
                <a:ext uri="{FF2B5EF4-FFF2-40B4-BE49-F238E27FC236}">
                  <a16:creationId xmlns:a16="http://schemas.microsoft.com/office/drawing/2014/main" id="{F42E5DF2-4BF6-E1F7-8035-2B174136898D}"/>
                </a:ext>
              </a:extLst>
            </p:cNvPr>
            <p:cNvSpPr/>
            <p:nvPr/>
          </p:nvSpPr>
          <p:spPr>
            <a:xfrm>
              <a:off x="466667" y="2678436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501" name="tx32">
              <a:extLst>
                <a:ext uri="{FF2B5EF4-FFF2-40B4-BE49-F238E27FC236}">
                  <a16:creationId xmlns:a16="http://schemas.microsoft.com/office/drawing/2014/main" id="{0133870D-77EF-9BA5-73F1-1BC579D26BA6}"/>
                </a:ext>
              </a:extLst>
            </p:cNvPr>
            <p:cNvSpPr/>
            <p:nvPr/>
          </p:nvSpPr>
          <p:spPr>
            <a:xfrm>
              <a:off x="466667" y="1870113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502" name="tx33">
              <a:extLst>
                <a:ext uri="{FF2B5EF4-FFF2-40B4-BE49-F238E27FC236}">
                  <a16:creationId xmlns:a16="http://schemas.microsoft.com/office/drawing/2014/main" id="{E2A648DB-A41F-CD7E-A0B5-2B082FAF6DB9}"/>
                </a:ext>
              </a:extLst>
            </p:cNvPr>
            <p:cNvSpPr/>
            <p:nvPr/>
          </p:nvSpPr>
          <p:spPr>
            <a:xfrm>
              <a:off x="466667" y="1061789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503" name="tx34">
              <a:extLst>
                <a:ext uri="{FF2B5EF4-FFF2-40B4-BE49-F238E27FC236}">
                  <a16:creationId xmlns:a16="http://schemas.microsoft.com/office/drawing/2014/main" id="{5C137C45-40A1-2898-0AC3-EB8CD33A7836}"/>
                </a:ext>
              </a:extLst>
            </p:cNvPr>
            <p:cNvSpPr/>
            <p:nvPr/>
          </p:nvSpPr>
          <p:spPr>
            <a:xfrm>
              <a:off x="466667" y="253465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0</a:t>
              </a:r>
            </a:p>
          </p:txBody>
        </p:sp>
        <p:sp>
          <p:nvSpPr>
            <p:cNvPr id="504" name="pl35">
              <a:extLst>
                <a:ext uri="{FF2B5EF4-FFF2-40B4-BE49-F238E27FC236}">
                  <a16:creationId xmlns:a16="http://schemas.microsoft.com/office/drawing/2014/main" id="{5F874E55-0C35-ED21-9ADF-4B189E1A3DF9}"/>
                </a:ext>
              </a:extLst>
            </p:cNvPr>
            <p:cNvSpPr/>
            <p:nvPr/>
          </p:nvSpPr>
          <p:spPr>
            <a:xfrm>
              <a:off x="741682" y="353413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05" name="pl36">
              <a:extLst>
                <a:ext uri="{FF2B5EF4-FFF2-40B4-BE49-F238E27FC236}">
                  <a16:creationId xmlns:a16="http://schemas.microsoft.com/office/drawing/2014/main" id="{CCCA07C8-49E7-B6E9-2E07-9588C78E84EF}"/>
                </a:ext>
              </a:extLst>
            </p:cNvPr>
            <p:cNvSpPr/>
            <p:nvPr/>
          </p:nvSpPr>
          <p:spPr>
            <a:xfrm>
              <a:off x="741682" y="2725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06" name="pl37">
              <a:extLst>
                <a:ext uri="{FF2B5EF4-FFF2-40B4-BE49-F238E27FC236}">
                  <a16:creationId xmlns:a16="http://schemas.microsoft.com/office/drawing/2014/main" id="{23E8CFFF-F35F-368D-2C22-41C9ADD7E81C}"/>
                </a:ext>
              </a:extLst>
            </p:cNvPr>
            <p:cNvSpPr/>
            <p:nvPr/>
          </p:nvSpPr>
          <p:spPr>
            <a:xfrm>
              <a:off x="741682" y="19174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07" name="pl38">
              <a:extLst>
                <a:ext uri="{FF2B5EF4-FFF2-40B4-BE49-F238E27FC236}">
                  <a16:creationId xmlns:a16="http://schemas.microsoft.com/office/drawing/2014/main" id="{8B8180CC-9E1B-BC34-A666-8B0B82CFFE3C}"/>
                </a:ext>
              </a:extLst>
            </p:cNvPr>
            <p:cNvSpPr/>
            <p:nvPr/>
          </p:nvSpPr>
          <p:spPr>
            <a:xfrm>
              <a:off x="741682" y="11091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08" name="pl39">
              <a:extLst>
                <a:ext uri="{FF2B5EF4-FFF2-40B4-BE49-F238E27FC236}">
                  <a16:creationId xmlns:a16="http://schemas.microsoft.com/office/drawing/2014/main" id="{C4E0BDDD-7F6D-5984-A284-34F3E351F5AF}"/>
                </a:ext>
              </a:extLst>
            </p:cNvPr>
            <p:cNvSpPr/>
            <p:nvPr/>
          </p:nvSpPr>
          <p:spPr>
            <a:xfrm>
              <a:off x="741682" y="3008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09" name="pl40">
              <a:extLst>
                <a:ext uri="{FF2B5EF4-FFF2-40B4-BE49-F238E27FC236}">
                  <a16:creationId xmlns:a16="http://schemas.microsoft.com/office/drawing/2014/main" id="{8A7B3A4B-0EBB-92AD-0403-7B9D6317D192}"/>
                </a:ext>
              </a:extLst>
            </p:cNvPr>
            <p:cNvSpPr/>
            <p:nvPr/>
          </p:nvSpPr>
          <p:spPr>
            <a:xfrm>
              <a:off x="1150492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10" name="pl41">
              <a:extLst>
                <a:ext uri="{FF2B5EF4-FFF2-40B4-BE49-F238E27FC236}">
                  <a16:creationId xmlns:a16="http://schemas.microsoft.com/office/drawing/2014/main" id="{4BACBCC8-6748-828D-8B81-10957D962A4C}"/>
                </a:ext>
              </a:extLst>
            </p:cNvPr>
            <p:cNvSpPr/>
            <p:nvPr/>
          </p:nvSpPr>
          <p:spPr>
            <a:xfrm>
              <a:off x="3199893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11" name="pl42">
              <a:extLst>
                <a:ext uri="{FF2B5EF4-FFF2-40B4-BE49-F238E27FC236}">
                  <a16:creationId xmlns:a16="http://schemas.microsoft.com/office/drawing/2014/main" id="{BA9EC688-B8FA-F3BC-1836-BBF9D025B7DD}"/>
                </a:ext>
              </a:extLst>
            </p:cNvPr>
            <p:cNvSpPr/>
            <p:nvPr/>
          </p:nvSpPr>
          <p:spPr>
            <a:xfrm>
              <a:off x="5249294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12" name="pl43">
              <a:extLst>
                <a:ext uri="{FF2B5EF4-FFF2-40B4-BE49-F238E27FC236}">
                  <a16:creationId xmlns:a16="http://schemas.microsoft.com/office/drawing/2014/main" id="{94A4EC4D-2578-3076-7FF5-E35438AEDC4C}"/>
                </a:ext>
              </a:extLst>
            </p:cNvPr>
            <p:cNvSpPr/>
            <p:nvPr/>
          </p:nvSpPr>
          <p:spPr>
            <a:xfrm>
              <a:off x="7298695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13" name="tx44">
              <a:extLst>
                <a:ext uri="{FF2B5EF4-FFF2-40B4-BE49-F238E27FC236}">
                  <a16:creationId xmlns:a16="http://schemas.microsoft.com/office/drawing/2014/main" id="{8E541198-1CC6-804F-83EC-4EEF330F7BA7}"/>
                </a:ext>
              </a:extLst>
            </p:cNvPr>
            <p:cNvSpPr/>
            <p:nvPr/>
          </p:nvSpPr>
          <p:spPr>
            <a:xfrm>
              <a:off x="1115176" y="3756509"/>
              <a:ext cx="70631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514" name="tx45">
              <a:extLst>
                <a:ext uri="{FF2B5EF4-FFF2-40B4-BE49-F238E27FC236}">
                  <a16:creationId xmlns:a16="http://schemas.microsoft.com/office/drawing/2014/main" id="{80D5500C-46EB-CAD8-1108-FB8F7FAB20AA}"/>
                </a:ext>
              </a:extLst>
            </p:cNvPr>
            <p:cNvSpPr/>
            <p:nvPr/>
          </p:nvSpPr>
          <p:spPr>
            <a:xfrm>
              <a:off x="3093946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515" name="tx46">
              <a:extLst>
                <a:ext uri="{FF2B5EF4-FFF2-40B4-BE49-F238E27FC236}">
                  <a16:creationId xmlns:a16="http://schemas.microsoft.com/office/drawing/2014/main" id="{D6C0FC73-9166-6E29-AFD5-D5F69112EEAB}"/>
                </a:ext>
              </a:extLst>
            </p:cNvPr>
            <p:cNvSpPr/>
            <p:nvPr/>
          </p:nvSpPr>
          <p:spPr>
            <a:xfrm>
              <a:off x="5143347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516" name="tx47">
              <a:extLst>
                <a:ext uri="{FF2B5EF4-FFF2-40B4-BE49-F238E27FC236}">
                  <a16:creationId xmlns:a16="http://schemas.microsoft.com/office/drawing/2014/main" id="{D92B691C-EC4D-F87F-F0E4-689B9C45896A}"/>
                </a:ext>
              </a:extLst>
            </p:cNvPr>
            <p:cNvSpPr/>
            <p:nvPr/>
          </p:nvSpPr>
          <p:spPr>
            <a:xfrm>
              <a:off x="7192748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517" name="tx48">
              <a:extLst>
                <a:ext uri="{FF2B5EF4-FFF2-40B4-BE49-F238E27FC236}">
                  <a16:creationId xmlns:a16="http://schemas.microsoft.com/office/drawing/2014/main" id="{4A281FDC-6966-48AF-2624-B5E8314BF037}"/>
                </a:ext>
              </a:extLst>
            </p:cNvPr>
            <p:cNvSpPr/>
            <p:nvPr/>
          </p:nvSpPr>
          <p:spPr>
            <a:xfrm>
              <a:off x="4009884" y="3878778"/>
              <a:ext cx="1761529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 to Transplant (Days)</a:t>
              </a:r>
            </a:p>
          </p:txBody>
        </p:sp>
        <p:sp>
          <p:nvSpPr>
            <p:cNvPr id="518" name="tx49">
              <a:extLst>
                <a:ext uri="{FF2B5EF4-FFF2-40B4-BE49-F238E27FC236}">
                  <a16:creationId xmlns:a16="http://schemas.microsoft.com/office/drawing/2014/main" id="{4F00F597-9C82-AC77-02EB-0D79E8B8E0D2}"/>
                </a:ext>
              </a:extLst>
            </p:cNvPr>
            <p:cNvSpPr/>
            <p:nvPr/>
          </p:nvSpPr>
          <p:spPr>
            <a:xfrm rot="-5400000">
              <a:off x="-985888" y="1845978"/>
              <a:ext cx="2668190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umulative Incidence of Transplant (%)</a:t>
              </a:r>
            </a:p>
          </p:txBody>
        </p:sp>
        <p:sp>
          <p:nvSpPr>
            <p:cNvPr id="519" name="rc50">
              <a:extLst>
                <a:ext uri="{FF2B5EF4-FFF2-40B4-BE49-F238E27FC236}">
                  <a16:creationId xmlns:a16="http://schemas.microsoft.com/office/drawing/2014/main" id="{9B596702-371A-4790-9127-672BB7B15FCC}"/>
                </a:ext>
              </a:extLst>
            </p:cNvPr>
            <p:cNvSpPr/>
            <p:nvPr/>
          </p:nvSpPr>
          <p:spPr>
            <a:xfrm>
              <a:off x="4276688" y="4189554"/>
              <a:ext cx="1227921" cy="358634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520" name="rc51">
              <a:extLst>
                <a:ext uri="{FF2B5EF4-FFF2-40B4-BE49-F238E27FC236}">
                  <a16:creationId xmlns:a16="http://schemas.microsoft.com/office/drawing/2014/main" id="{0A6C3291-69DD-5184-A975-BEAC53A65BE6}"/>
                </a:ext>
              </a:extLst>
            </p:cNvPr>
            <p:cNvSpPr/>
            <p:nvPr/>
          </p:nvSpPr>
          <p:spPr>
            <a:xfrm>
              <a:off x="4415866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521" name="pl52">
              <a:extLst>
                <a:ext uri="{FF2B5EF4-FFF2-40B4-BE49-F238E27FC236}">
                  <a16:creationId xmlns:a16="http://schemas.microsoft.com/office/drawing/2014/main" id="{A63C05B6-378F-C3D6-E0DF-FBA5005497C7}"/>
                </a:ext>
              </a:extLst>
            </p:cNvPr>
            <p:cNvSpPr/>
            <p:nvPr/>
          </p:nvSpPr>
          <p:spPr>
            <a:xfrm>
              <a:off x="4437812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22" name="rc53">
              <a:extLst>
                <a:ext uri="{FF2B5EF4-FFF2-40B4-BE49-F238E27FC236}">
                  <a16:creationId xmlns:a16="http://schemas.microsoft.com/office/drawing/2014/main" id="{43C8D1B2-8413-BD3E-9246-A078C6FD28BD}"/>
                </a:ext>
              </a:extLst>
            </p:cNvPr>
            <p:cNvSpPr/>
            <p:nvPr/>
          </p:nvSpPr>
          <p:spPr>
            <a:xfrm>
              <a:off x="4926900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523" name="pl54">
              <a:extLst>
                <a:ext uri="{FF2B5EF4-FFF2-40B4-BE49-F238E27FC236}">
                  <a16:creationId xmlns:a16="http://schemas.microsoft.com/office/drawing/2014/main" id="{7CA8FB02-9101-DB68-4DB9-73E520E762B5}"/>
                </a:ext>
              </a:extLst>
            </p:cNvPr>
            <p:cNvSpPr/>
            <p:nvPr/>
          </p:nvSpPr>
          <p:spPr>
            <a:xfrm>
              <a:off x="4948846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24" name="tx55">
              <a:extLst>
                <a:ext uri="{FF2B5EF4-FFF2-40B4-BE49-F238E27FC236}">
                  <a16:creationId xmlns:a16="http://schemas.microsoft.com/office/drawing/2014/main" id="{2785E574-FE31-C9CF-0E3C-3CF65C7719D5}"/>
                </a:ext>
              </a:extLst>
            </p:cNvPr>
            <p:cNvSpPr/>
            <p:nvPr/>
          </p:nvSpPr>
          <p:spPr>
            <a:xfrm>
              <a:off x="4704911" y="4321929"/>
              <a:ext cx="162346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525" name="tx56">
              <a:extLst>
                <a:ext uri="{FF2B5EF4-FFF2-40B4-BE49-F238E27FC236}">
                  <a16:creationId xmlns:a16="http://schemas.microsoft.com/office/drawing/2014/main" id="{7D68A483-8F5E-BA67-4EE1-2A8E64D5B508}"/>
                </a:ext>
              </a:extLst>
            </p:cNvPr>
            <p:cNvSpPr/>
            <p:nvPr/>
          </p:nvSpPr>
          <p:spPr>
            <a:xfrm>
              <a:off x="5215945" y="4321929"/>
              <a:ext cx="218839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  <p:sp>
          <p:nvSpPr>
            <p:cNvPr id="526" name="rc57">
              <a:extLst>
                <a:ext uri="{FF2B5EF4-FFF2-40B4-BE49-F238E27FC236}">
                  <a16:creationId xmlns:a16="http://schemas.microsoft.com/office/drawing/2014/main" id="{BA19A17A-6AC3-19BE-0F2D-3625DF3AEA4D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27" name="rc58">
              <a:extLst>
                <a:ext uri="{FF2B5EF4-FFF2-40B4-BE49-F238E27FC236}">
                  <a16:creationId xmlns:a16="http://schemas.microsoft.com/office/drawing/2014/main" id="{BED0A01C-69DF-6774-8D02-3E64896FEE9E}"/>
                </a:ext>
              </a:extLst>
            </p:cNvPr>
            <p:cNvSpPr/>
            <p:nvPr/>
          </p:nvSpPr>
          <p:spPr>
            <a:xfrm>
              <a:off x="776476" y="4996549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528" name="tx59">
              <a:extLst>
                <a:ext uri="{FF2B5EF4-FFF2-40B4-BE49-F238E27FC236}">
                  <a16:creationId xmlns:a16="http://schemas.microsoft.com/office/drawing/2014/main" id="{240FDD75-2718-16D6-A73D-BD3E471A68EC}"/>
                </a:ext>
              </a:extLst>
            </p:cNvPr>
            <p:cNvSpPr/>
            <p:nvPr/>
          </p:nvSpPr>
          <p:spPr>
            <a:xfrm>
              <a:off x="1115323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529" name="tx60">
              <a:extLst>
                <a:ext uri="{FF2B5EF4-FFF2-40B4-BE49-F238E27FC236}">
                  <a16:creationId xmlns:a16="http://schemas.microsoft.com/office/drawing/2014/main" id="{36585442-A16D-F317-43CA-B7D318D7B7FA}"/>
                </a:ext>
              </a:extLst>
            </p:cNvPr>
            <p:cNvSpPr/>
            <p:nvPr/>
          </p:nvSpPr>
          <p:spPr>
            <a:xfrm>
              <a:off x="1115323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530" name="tx61">
              <a:extLst>
                <a:ext uri="{FF2B5EF4-FFF2-40B4-BE49-F238E27FC236}">
                  <a16:creationId xmlns:a16="http://schemas.microsoft.com/office/drawing/2014/main" id="{26F252C1-83F2-1731-B2EB-30233A404C17}"/>
                </a:ext>
              </a:extLst>
            </p:cNvPr>
            <p:cNvSpPr/>
            <p:nvPr/>
          </p:nvSpPr>
          <p:spPr>
            <a:xfrm>
              <a:off x="3164724" y="5439459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531" name="tx62">
              <a:extLst>
                <a:ext uri="{FF2B5EF4-FFF2-40B4-BE49-F238E27FC236}">
                  <a16:creationId xmlns:a16="http://schemas.microsoft.com/office/drawing/2014/main" id="{FFB9184C-DEC1-DEC4-4A30-E0A7D366553F}"/>
                </a:ext>
              </a:extLst>
            </p:cNvPr>
            <p:cNvSpPr/>
            <p:nvPr/>
          </p:nvSpPr>
          <p:spPr>
            <a:xfrm>
              <a:off x="3164724" y="5134179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532" name="tx63">
              <a:extLst>
                <a:ext uri="{FF2B5EF4-FFF2-40B4-BE49-F238E27FC236}">
                  <a16:creationId xmlns:a16="http://schemas.microsoft.com/office/drawing/2014/main" id="{F0AFA6B2-C7D5-00DD-879C-24F7EC63267E}"/>
                </a:ext>
              </a:extLst>
            </p:cNvPr>
            <p:cNvSpPr/>
            <p:nvPr/>
          </p:nvSpPr>
          <p:spPr>
            <a:xfrm>
              <a:off x="5214125" y="5437853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533" name="tx64">
              <a:extLst>
                <a:ext uri="{FF2B5EF4-FFF2-40B4-BE49-F238E27FC236}">
                  <a16:creationId xmlns:a16="http://schemas.microsoft.com/office/drawing/2014/main" id="{59D8299C-620C-B098-0FE5-9FAE8401FE94}"/>
                </a:ext>
              </a:extLst>
            </p:cNvPr>
            <p:cNvSpPr/>
            <p:nvPr/>
          </p:nvSpPr>
          <p:spPr>
            <a:xfrm>
              <a:off x="5214125" y="5134117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534" name="tx65">
              <a:extLst>
                <a:ext uri="{FF2B5EF4-FFF2-40B4-BE49-F238E27FC236}">
                  <a16:creationId xmlns:a16="http://schemas.microsoft.com/office/drawing/2014/main" id="{2F6A22D0-A652-133C-69E4-8909D3AF65AF}"/>
                </a:ext>
              </a:extLst>
            </p:cNvPr>
            <p:cNvSpPr/>
            <p:nvPr/>
          </p:nvSpPr>
          <p:spPr>
            <a:xfrm>
              <a:off x="7263526" y="5437853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535" name="tx66">
              <a:extLst>
                <a:ext uri="{FF2B5EF4-FFF2-40B4-BE49-F238E27FC236}">
                  <a16:creationId xmlns:a16="http://schemas.microsoft.com/office/drawing/2014/main" id="{55858AD3-2829-D169-EEF6-25A90B1CB7DF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536" name="tx67">
              <a:extLst>
                <a:ext uri="{FF2B5EF4-FFF2-40B4-BE49-F238E27FC236}">
                  <a16:creationId xmlns:a16="http://schemas.microsoft.com/office/drawing/2014/main" id="{7ECCB252-52FA-0151-944B-67C10327AAB4}"/>
                </a:ext>
              </a:extLst>
            </p:cNvPr>
            <p:cNvSpPr/>
            <p:nvPr/>
          </p:nvSpPr>
          <p:spPr>
            <a:xfrm>
              <a:off x="7263526" y="5437853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537" name="tx68">
              <a:extLst>
                <a:ext uri="{FF2B5EF4-FFF2-40B4-BE49-F238E27FC236}">
                  <a16:creationId xmlns:a16="http://schemas.microsoft.com/office/drawing/2014/main" id="{A0D76EA0-FCF5-DFC4-1E00-58BB1EE9A916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538" name="tx69">
              <a:extLst>
                <a:ext uri="{FF2B5EF4-FFF2-40B4-BE49-F238E27FC236}">
                  <a16:creationId xmlns:a16="http://schemas.microsoft.com/office/drawing/2014/main" id="{4AC16C69-BAF7-0490-9023-B1BB7CFC91C9}"/>
                </a:ext>
              </a:extLst>
            </p:cNvPr>
            <p:cNvSpPr/>
            <p:nvPr/>
          </p:nvSpPr>
          <p:spPr>
            <a:xfrm>
              <a:off x="325591" y="5438152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539" name="tx70">
              <a:extLst>
                <a:ext uri="{FF2B5EF4-FFF2-40B4-BE49-F238E27FC236}">
                  <a16:creationId xmlns:a16="http://schemas.microsoft.com/office/drawing/2014/main" id="{571DAC6F-5594-E207-7FA7-C3F84ADC2802}"/>
                </a:ext>
              </a:extLst>
            </p:cNvPr>
            <p:cNvSpPr/>
            <p:nvPr/>
          </p:nvSpPr>
          <p:spPr>
            <a:xfrm>
              <a:off x="311638" y="5132811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540" name="tx71">
              <a:extLst>
                <a:ext uri="{FF2B5EF4-FFF2-40B4-BE49-F238E27FC236}">
                  <a16:creationId xmlns:a16="http://schemas.microsoft.com/office/drawing/2014/main" id="{86BE37DB-BA41-B3C6-EC1E-7473F488BBD9}"/>
                </a:ext>
              </a:extLst>
            </p:cNvPr>
            <p:cNvSpPr/>
            <p:nvPr/>
          </p:nvSpPr>
          <p:spPr>
            <a:xfrm>
              <a:off x="776476" y="4827633"/>
              <a:ext cx="17452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541" name="rc72">
              <a:extLst>
                <a:ext uri="{FF2B5EF4-FFF2-40B4-BE49-F238E27FC236}">
                  <a16:creationId xmlns:a16="http://schemas.microsoft.com/office/drawing/2014/main" id="{31B401D7-8629-BB3A-B875-C204EF9B55FE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42" name="rc73">
              <a:extLst>
                <a:ext uri="{FF2B5EF4-FFF2-40B4-BE49-F238E27FC236}">
                  <a16:creationId xmlns:a16="http://schemas.microsoft.com/office/drawing/2014/main" id="{5D9E5605-C3C3-A5DF-C9F9-248440F1E34D}"/>
                </a:ext>
              </a:extLst>
            </p:cNvPr>
            <p:cNvSpPr/>
            <p:nvPr/>
          </p:nvSpPr>
          <p:spPr>
            <a:xfrm>
              <a:off x="776476" y="6081865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543" name="tx74">
              <a:extLst>
                <a:ext uri="{FF2B5EF4-FFF2-40B4-BE49-F238E27FC236}">
                  <a16:creationId xmlns:a16="http://schemas.microsoft.com/office/drawing/2014/main" id="{3A60283F-C9CB-F7C7-C8BB-9AC1C189C29C}"/>
                </a:ext>
              </a:extLst>
            </p:cNvPr>
            <p:cNvSpPr/>
            <p:nvPr/>
          </p:nvSpPr>
          <p:spPr>
            <a:xfrm>
              <a:off x="1115323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544" name="tx75">
              <a:extLst>
                <a:ext uri="{FF2B5EF4-FFF2-40B4-BE49-F238E27FC236}">
                  <a16:creationId xmlns:a16="http://schemas.microsoft.com/office/drawing/2014/main" id="{658AB107-1CF8-B137-DC3B-FFD242FC3918}"/>
                </a:ext>
              </a:extLst>
            </p:cNvPr>
            <p:cNvSpPr/>
            <p:nvPr/>
          </p:nvSpPr>
          <p:spPr>
            <a:xfrm>
              <a:off x="1080154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2</a:t>
              </a:r>
            </a:p>
          </p:txBody>
        </p:sp>
        <p:sp>
          <p:nvSpPr>
            <p:cNvPr id="545" name="tx76">
              <a:extLst>
                <a:ext uri="{FF2B5EF4-FFF2-40B4-BE49-F238E27FC236}">
                  <a16:creationId xmlns:a16="http://schemas.microsoft.com/office/drawing/2014/main" id="{CDAF673F-AFC1-1CA9-733A-D199082C14DB}"/>
                </a:ext>
              </a:extLst>
            </p:cNvPr>
            <p:cNvSpPr/>
            <p:nvPr/>
          </p:nvSpPr>
          <p:spPr>
            <a:xfrm>
              <a:off x="3129555" y="6524775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2</a:t>
              </a:r>
            </a:p>
          </p:txBody>
        </p:sp>
        <p:sp>
          <p:nvSpPr>
            <p:cNvPr id="546" name="tx77">
              <a:extLst>
                <a:ext uri="{FF2B5EF4-FFF2-40B4-BE49-F238E27FC236}">
                  <a16:creationId xmlns:a16="http://schemas.microsoft.com/office/drawing/2014/main" id="{1762252F-2BEB-BECF-8587-8B19FAB50262}"/>
                </a:ext>
              </a:extLst>
            </p:cNvPr>
            <p:cNvSpPr/>
            <p:nvPr/>
          </p:nvSpPr>
          <p:spPr>
            <a:xfrm>
              <a:off x="3164724" y="6220978"/>
              <a:ext cx="70337" cy="8935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</a:t>
              </a:r>
            </a:p>
          </p:txBody>
        </p:sp>
        <p:sp>
          <p:nvSpPr>
            <p:cNvPr id="547" name="tx78">
              <a:extLst>
                <a:ext uri="{FF2B5EF4-FFF2-40B4-BE49-F238E27FC236}">
                  <a16:creationId xmlns:a16="http://schemas.microsoft.com/office/drawing/2014/main" id="{6E3E73A4-1AE5-3323-C874-A129441C984A}"/>
                </a:ext>
              </a:extLst>
            </p:cNvPr>
            <p:cNvSpPr/>
            <p:nvPr/>
          </p:nvSpPr>
          <p:spPr>
            <a:xfrm>
              <a:off x="5178956" y="6523231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5</a:t>
              </a:r>
            </a:p>
          </p:txBody>
        </p:sp>
        <p:sp>
          <p:nvSpPr>
            <p:cNvPr id="548" name="tx79">
              <a:extLst>
                <a:ext uri="{FF2B5EF4-FFF2-40B4-BE49-F238E27FC236}">
                  <a16:creationId xmlns:a16="http://schemas.microsoft.com/office/drawing/2014/main" id="{5551E9B3-6B8B-7D16-F3C9-93888EE60751}"/>
                </a:ext>
              </a:extLst>
            </p:cNvPr>
            <p:cNvSpPr/>
            <p:nvPr/>
          </p:nvSpPr>
          <p:spPr>
            <a:xfrm>
              <a:off x="5214125" y="6219434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549" name="tx80">
              <a:extLst>
                <a:ext uri="{FF2B5EF4-FFF2-40B4-BE49-F238E27FC236}">
                  <a16:creationId xmlns:a16="http://schemas.microsoft.com/office/drawing/2014/main" id="{0AEB6FA9-FD21-4BBA-76C5-A14300F07FE7}"/>
                </a:ext>
              </a:extLst>
            </p:cNvPr>
            <p:cNvSpPr/>
            <p:nvPr/>
          </p:nvSpPr>
          <p:spPr>
            <a:xfrm>
              <a:off x="7228357" y="6523231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5</a:t>
              </a:r>
            </a:p>
          </p:txBody>
        </p:sp>
        <p:sp>
          <p:nvSpPr>
            <p:cNvPr id="550" name="tx81">
              <a:extLst>
                <a:ext uri="{FF2B5EF4-FFF2-40B4-BE49-F238E27FC236}">
                  <a16:creationId xmlns:a16="http://schemas.microsoft.com/office/drawing/2014/main" id="{C20E267B-191D-B1F3-E426-0B8B4AE00C5E}"/>
                </a:ext>
              </a:extLst>
            </p:cNvPr>
            <p:cNvSpPr/>
            <p:nvPr/>
          </p:nvSpPr>
          <p:spPr>
            <a:xfrm>
              <a:off x="7263526" y="6219434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551" name="tx82">
              <a:extLst>
                <a:ext uri="{FF2B5EF4-FFF2-40B4-BE49-F238E27FC236}">
                  <a16:creationId xmlns:a16="http://schemas.microsoft.com/office/drawing/2014/main" id="{1FC22E38-E710-2777-902B-BE214252BA33}"/>
                </a:ext>
              </a:extLst>
            </p:cNvPr>
            <p:cNvSpPr/>
            <p:nvPr/>
          </p:nvSpPr>
          <p:spPr>
            <a:xfrm>
              <a:off x="325591" y="6523468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552" name="tx83">
              <a:extLst>
                <a:ext uri="{FF2B5EF4-FFF2-40B4-BE49-F238E27FC236}">
                  <a16:creationId xmlns:a16="http://schemas.microsoft.com/office/drawing/2014/main" id="{DAEB2B86-1667-28CC-955F-BC5A439E1CCB}"/>
                </a:ext>
              </a:extLst>
            </p:cNvPr>
            <p:cNvSpPr/>
            <p:nvPr/>
          </p:nvSpPr>
          <p:spPr>
            <a:xfrm>
              <a:off x="311638" y="6218127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553" name="tx84">
              <a:extLst>
                <a:ext uri="{FF2B5EF4-FFF2-40B4-BE49-F238E27FC236}">
                  <a16:creationId xmlns:a16="http://schemas.microsoft.com/office/drawing/2014/main" id="{14B31A29-0757-1A6A-FB65-811FD47F2AA4}"/>
                </a:ext>
              </a:extLst>
            </p:cNvPr>
            <p:cNvSpPr/>
            <p:nvPr/>
          </p:nvSpPr>
          <p:spPr>
            <a:xfrm>
              <a:off x="776476" y="5912949"/>
              <a:ext cx="23525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</p:grpSp>
      <p:sp>
        <p:nvSpPr>
          <p:cNvPr id="554" name="TextBox 553">
            <a:extLst>
              <a:ext uri="{FF2B5EF4-FFF2-40B4-BE49-F238E27FC236}">
                <a16:creationId xmlns:a16="http://schemas.microsoft.com/office/drawing/2014/main" id="{5FA3F8D6-1F14-E53D-4DC2-E6033A5B98F1}"/>
              </a:ext>
            </a:extLst>
          </p:cNvPr>
          <p:cNvSpPr txBox="1"/>
          <p:nvPr/>
        </p:nvSpPr>
        <p:spPr>
          <a:xfrm>
            <a:off x="5426925" y="5516300"/>
            <a:ext cx="2877987" cy="6014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7" b="1" dirty="0">
                <a:latin typeface="Arial" panose="020B0604020202020204" pitchFamily="34" charset="0"/>
                <a:cs typeface="Arial" panose="020B0604020202020204" pitchFamily="34" charset="0"/>
              </a:rPr>
              <a:t>Potential Living Donor Total   Event   HR (95% CI)</a:t>
            </a:r>
          </a:p>
          <a:p>
            <a:r>
              <a:rPr lang="en-US" sz="827" dirty="0">
                <a:latin typeface="Arial" panose="020B0604020202020204" pitchFamily="34" charset="0"/>
                <a:cs typeface="Arial" panose="020B0604020202020204" pitchFamily="34" charset="0"/>
              </a:rPr>
              <a:t>No                                      8         3         Reference</a:t>
            </a:r>
          </a:p>
          <a:p>
            <a:r>
              <a:rPr lang="en-US" sz="827" dirty="0">
                <a:latin typeface="Arial" panose="020B0604020202020204" pitchFamily="34" charset="0"/>
                <a:cs typeface="Arial" panose="020B0604020202020204" pitchFamily="34" charset="0"/>
              </a:rPr>
              <a:t>Yes                                    22       15       2.32 (0.65 – 8.33)</a:t>
            </a:r>
          </a:p>
          <a:p>
            <a:r>
              <a:rPr lang="en-US" sz="827" dirty="0">
                <a:latin typeface="Arial" panose="020B0604020202020204" pitchFamily="34" charset="0"/>
                <a:cs typeface="Arial" panose="020B0604020202020204" pitchFamily="34" charset="0"/>
              </a:rPr>
              <a:t>Gray K-Sample Test P-value: 0.1672  </a:t>
            </a:r>
          </a:p>
        </p:txBody>
      </p:sp>
      <p:sp>
        <p:nvSpPr>
          <p:cNvPr id="555" name="pl48">
            <a:extLst>
              <a:ext uri="{FF2B5EF4-FFF2-40B4-BE49-F238E27FC236}">
                <a16:creationId xmlns:a16="http://schemas.microsoft.com/office/drawing/2014/main" id="{121BA836-2EDF-DC36-A2D2-E2C1E9863546}"/>
              </a:ext>
            </a:extLst>
          </p:cNvPr>
          <p:cNvSpPr/>
          <p:nvPr/>
        </p:nvSpPr>
        <p:spPr>
          <a:xfrm>
            <a:off x="5271540" y="5722627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556" name="pl50">
            <a:extLst>
              <a:ext uri="{FF2B5EF4-FFF2-40B4-BE49-F238E27FC236}">
                <a16:creationId xmlns:a16="http://schemas.microsoft.com/office/drawing/2014/main" id="{C8F9BE3C-CB18-F988-E317-4EDEF0F640D9}"/>
              </a:ext>
            </a:extLst>
          </p:cNvPr>
          <p:cNvSpPr/>
          <p:nvPr/>
        </p:nvSpPr>
        <p:spPr>
          <a:xfrm>
            <a:off x="5295300" y="5875924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grpSp>
        <p:nvGrpSpPr>
          <p:cNvPr id="557" name="Group 556">
            <a:extLst>
              <a:ext uri="{FF2B5EF4-FFF2-40B4-BE49-F238E27FC236}">
                <a16:creationId xmlns:a16="http://schemas.microsoft.com/office/drawing/2014/main" id="{3B3E3C75-A6E7-A68C-430A-BE7F148EF113}"/>
              </a:ext>
            </a:extLst>
          </p:cNvPr>
          <p:cNvGrpSpPr>
            <a:grpSpLocks noChangeAspect="1"/>
          </p:cNvGrpSpPr>
          <p:nvPr/>
        </p:nvGrpSpPr>
        <p:grpSpPr>
          <a:xfrm>
            <a:off x="0" y="9215953"/>
            <a:ext cx="4754682" cy="3571875"/>
            <a:chOff x="0" y="0"/>
            <a:chExt cx="9144000" cy="6858000"/>
          </a:xfrm>
        </p:grpSpPr>
        <p:sp>
          <p:nvSpPr>
            <p:cNvPr id="558" name="rc3">
              <a:extLst>
                <a:ext uri="{FF2B5EF4-FFF2-40B4-BE49-F238E27FC236}">
                  <a16:creationId xmlns:a16="http://schemas.microsoft.com/office/drawing/2014/main" id="{B72F98CE-E785-86D7-39D3-66B13F00A9FE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59" name="rc4">
              <a:extLst>
                <a:ext uri="{FF2B5EF4-FFF2-40B4-BE49-F238E27FC236}">
                  <a16:creationId xmlns:a16="http://schemas.microsoft.com/office/drawing/2014/main" id="{13A5F7E5-6387-85BD-DF45-522CEE40A3F1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60" name="rc5">
              <a:extLst>
                <a:ext uri="{FF2B5EF4-FFF2-40B4-BE49-F238E27FC236}">
                  <a16:creationId xmlns:a16="http://schemas.microsoft.com/office/drawing/2014/main" id="{E8AA1956-2194-F4C0-8BDF-E6A062CD526B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61" name="rc6">
              <a:extLst>
                <a:ext uri="{FF2B5EF4-FFF2-40B4-BE49-F238E27FC236}">
                  <a16:creationId xmlns:a16="http://schemas.microsoft.com/office/drawing/2014/main" id="{30396C8C-7F00-C939-4062-1EC69DBC4D09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62" name="rc7">
              <a:extLst>
                <a:ext uri="{FF2B5EF4-FFF2-40B4-BE49-F238E27FC236}">
                  <a16:creationId xmlns:a16="http://schemas.microsoft.com/office/drawing/2014/main" id="{17F4A5DC-D854-90F4-97D5-7A17B99D4237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65" name="rc8">
              <a:extLst>
                <a:ext uri="{FF2B5EF4-FFF2-40B4-BE49-F238E27FC236}">
                  <a16:creationId xmlns:a16="http://schemas.microsoft.com/office/drawing/2014/main" id="{F8B3D2D7-043D-0427-FAA2-E173786F5AEF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66" name="rc9">
              <a:extLst>
                <a:ext uri="{FF2B5EF4-FFF2-40B4-BE49-F238E27FC236}">
                  <a16:creationId xmlns:a16="http://schemas.microsoft.com/office/drawing/2014/main" id="{E829BB96-6840-330F-D93E-E855D6DEB035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567" name="pl18">
              <a:extLst>
                <a:ext uri="{FF2B5EF4-FFF2-40B4-BE49-F238E27FC236}">
                  <a16:creationId xmlns:a16="http://schemas.microsoft.com/office/drawing/2014/main" id="{83F33157-CDD0-1905-5CAD-83EE5C33D396}"/>
                </a:ext>
              </a:extLst>
            </p:cNvPr>
            <p:cNvSpPr/>
            <p:nvPr/>
          </p:nvSpPr>
          <p:spPr>
            <a:xfrm>
              <a:off x="776476" y="3534137"/>
              <a:ext cx="8228345" cy="0"/>
            </a:xfrm>
            <a:custGeom>
              <a:avLst/>
              <a:gdLst/>
              <a:ahLst/>
              <a:cxnLst/>
              <a:rect l="0" t="0" r="0" b="0"/>
              <a:pathLst>
                <a:path w="8228345">
                  <a:moveTo>
                    <a:pt x="0" y="0"/>
                  </a:moveTo>
                  <a:lnTo>
                    <a:pt x="8228345" y="0"/>
                  </a:lnTo>
                  <a:lnTo>
                    <a:pt x="8228345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68" name="pl23">
              <a:extLst>
                <a:ext uri="{FF2B5EF4-FFF2-40B4-BE49-F238E27FC236}">
                  <a16:creationId xmlns:a16="http://schemas.microsoft.com/office/drawing/2014/main" id="{B516B2A1-1CE6-A77F-B988-1D1A2D33E415}"/>
                </a:ext>
              </a:extLst>
            </p:cNvPr>
            <p:cNvSpPr/>
            <p:nvPr/>
          </p:nvSpPr>
          <p:spPr>
            <a:xfrm>
              <a:off x="1150492" y="139178"/>
              <a:ext cx="0" cy="3556623"/>
            </a:xfrm>
            <a:custGeom>
              <a:avLst/>
              <a:gdLst/>
              <a:ahLst/>
              <a:cxnLst/>
              <a:rect l="0" t="0" r="0" b="0"/>
              <a:pathLst>
                <a:path h="3556623">
                  <a:moveTo>
                    <a:pt x="0" y="35566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69" name="pl27">
              <a:extLst>
                <a:ext uri="{FF2B5EF4-FFF2-40B4-BE49-F238E27FC236}">
                  <a16:creationId xmlns:a16="http://schemas.microsoft.com/office/drawing/2014/main" id="{8633359D-9F78-2E9C-9ACA-681B4FFADB4A}"/>
                </a:ext>
              </a:extLst>
            </p:cNvPr>
            <p:cNvSpPr/>
            <p:nvPr/>
          </p:nvSpPr>
          <p:spPr>
            <a:xfrm>
              <a:off x="1150492" y="839725"/>
              <a:ext cx="4273001" cy="2694412"/>
            </a:xfrm>
            <a:custGeom>
              <a:avLst/>
              <a:gdLst/>
              <a:ahLst/>
              <a:cxnLst/>
              <a:rect l="0" t="0" r="0" b="0"/>
              <a:pathLst>
                <a:path w="4273001" h="2694412">
                  <a:moveTo>
                    <a:pt x="0" y="2694412"/>
                  </a:moveTo>
                  <a:lnTo>
                    <a:pt x="317657" y="2694412"/>
                  </a:lnTo>
                  <a:lnTo>
                    <a:pt x="317657" y="1616647"/>
                  </a:lnTo>
                  <a:lnTo>
                    <a:pt x="1250134" y="1616647"/>
                  </a:lnTo>
                  <a:lnTo>
                    <a:pt x="1250134" y="1077764"/>
                  </a:lnTo>
                  <a:lnTo>
                    <a:pt x="2520763" y="1077764"/>
                  </a:lnTo>
                  <a:lnTo>
                    <a:pt x="2520763" y="538882"/>
                  </a:lnTo>
                  <a:lnTo>
                    <a:pt x="3340523" y="538882"/>
                  </a:lnTo>
                  <a:lnTo>
                    <a:pt x="3340523" y="538882"/>
                  </a:lnTo>
                  <a:lnTo>
                    <a:pt x="4273001" y="538882"/>
                  </a:lnTo>
                  <a:lnTo>
                    <a:pt x="4273001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70" name="pl28">
              <a:extLst>
                <a:ext uri="{FF2B5EF4-FFF2-40B4-BE49-F238E27FC236}">
                  <a16:creationId xmlns:a16="http://schemas.microsoft.com/office/drawing/2014/main" id="{99FBE6AF-0E5F-0D91-69C4-0ABABB29C6E2}"/>
                </a:ext>
              </a:extLst>
            </p:cNvPr>
            <p:cNvSpPr/>
            <p:nvPr/>
          </p:nvSpPr>
          <p:spPr>
            <a:xfrm>
              <a:off x="1150492" y="1023439"/>
              <a:ext cx="6301908" cy="2510697"/>
            </a:xfrm>
            <a:custGeom>
              <a:avLst/>
              <a:gdLst/>
              <a:ahLst/>
              <a:cxnLst/>
              <a:rect l="0" t="0" r="0" b="0"/>
              <a:pathLst>
                <a:path w="6301908" h="2510697">
                  <a:moveTo>
                    <a:pt x="0" y="2510697"/>
                  </a:moveTo>
                  <a:lnTo>
                    <a:pt x="10247" y="2510697"/>
                  </a:lnTo>
                  <a:lnTo>
                    <a:pt x="10247" y="2411211"/>
                  </a:lnTo>
                  <a:lnTo>
                    <a:pt x="71729" y="2411211"/>
                  </a:lnTo>
                  <a:lnTo>
                    <a:pt x="71729" y="2361468"/>
                  </a:lnTo>
                  <a:lnTo>
                    <a:pt x="204940" y="2361468"/>
                  </a:lnTo>
                  <a:lnTo>
                    <a:pt x="204940" y="2261982"/>
                  </a:lnTo>
                  <a:lnTo>
                    <a:pt x="256175" y="2261982"/>
                  </a:lnTo>
                  <a:lnTo>
                    <a:pt x="256175" y="2212239"/>
                  </a:lnTo>
                  <a:lnTo>
                    <a:pt x="266422" y="2212239"/>
                  </a:lnTo>
                  <a:lnTo>
                    <a:pt x="266422" y="2212239"/>
                  </a:lnTo>
                  <a:lnTo>
                    <a:pt x="286916" y="2212239"/>
                  </a:lnTo>
                  <a:lnTo>
                    <a:pt x="286916" y="2162496"/>
                  </a:lnTo>
                  <a:lnTo>
                    <a:pt x="338151" y="2162496"/>
                  </a:lnTo>
                  <a:lnTo>
                    <a:pt x="338151" y="2162496"/>
                  </a:lnTo>
                  <a:lnTo>
                    <a:pt x="389386" y="2162496"/>
                  </a:lnTo>
                  <a:lnTo>
                    <a:pt x="389386" y="2112753"/>
                  </a:lnTo>
                  <a:lnTo>
                    <a:pt x="430374" y="2112753"/>
                  </a:lnTo>
                  <a:lnTo>
                    <a:pt x="430374" y="2062089"/>
                  </a:lnTo>
                  <a:lnTo>
                    <a:pt x="471362" y="2062089"/>
                  </a:lnTo>
                  <a:lnTo>
                    <a:pt x="471362" y="2011425"/>
                  </a:lnTo>
                  <a:lnTo>
                    <a:pt x="522597" y="2011425"/>
                  </a:lnTo>
                  <a:lnTo>
                    <a:pt x="522597" y="1960761"/>
                  </a:lnTo>
                  <a:lnTo>
                    <a:pt x="532844" y="1960761"/>
                  </a:lnTo>
                  <a:lnTo>
                    <a:pt x="532844" y="1960761"/>
                  </a:lnTo>
                  <a:lnTo>
                    <a:pt x="635314" y="1960761"/>
                  </a:lnTo>
                  <a:lnTo>
                    <a:pt x="635314" y="1857406"/>
                  </a:lnTo>
                  <a:lnTo>
                    <a:pt x="645561" y="1857406"/>
                  </a:lnTo>
                  <a:lnTo>
                    <a:pt x="645561" y="1805729"/>
                  </a:lnTo>
                  <a:lnTo>
                    <a:pt x="717290" y="1805729"/>
                  </a:lnTo>
                  <a:lnTo>
                    <a:pt x="717290" y="1754051"/>
                  </a:lnTo>
                  <a:lnTo>
                    <a:pt x="789019" y="1754051"/>
                  </a:lnTo>
                  <a:lnTo>
                    <a:pt x="789019" y="1702374"/>
                  </a:lnTo>
                  <a:lnTo>
                    <a:pt x="860748" y="1702374"/>
                  </a:lnTo>
                  <a:lnTo>
                    <a:pt x="860748" y="1650696"/>
                  </a:lnTo>
                  <a:lnTo>
                    <a:pt x="901736" y="1650696"/>
                  </a:lnTo>
                  <a:lnTo>
                    <a:pt x="901736" y="1547341"/>
                  </a:lnTo>
                  <a:lnTo>
                    <a:pt x="922230" y="1547341"/>
                  </a:lnTo>
                  <a:lnTo>
                    <a:pt x="922230" y="1495664"/>
                  </a:lnTo>
                  <a:lnTo>
                    <a:pt x="942724" y="1495664"/>
                  </a:lnTo>
                  <a:lnTo>
                    <a:pt x="942724" y="1443986"/>
                  </a:lnTo>
                  <a:lnTo>
                    <a:pt x="1004206" y="1443986"/>
                  </a:lnTo>
                  <a:lnTo>
                    <a:pt x="1004206" y="1392309"/>
                  </a:lnTo>
                  <a:lnTo>
                    <a:pt x="1065688" y="1392309"/>
                  </a:lnTo>
                  <a:lnTo>
                    <a:pt x="1065688" y="1288954"/>
                  </a:lnTo>
                  <a:lnTo>
                    <a:pt x="1116923" y="1288954"/>
                  </a:lnTo>
                  <a:lnTo>
                    <a:pt x="1116923" y="1237277"/>
                  </a:lnTo>
                  <a:lnTo>
                    <a:pt x="1157911" y="1237277"/>
                  </a:lnTo>
                  <a:lnTo>
                    <a:pt x="1157911" y="1185599"/>
                  </a:lnTo>
                  <a:lnTo>
                    <a:pt x="1198899" y="1185599"/>
                  </a:lnTo>
                  <a:lnTo>
                    <a:pt x="1198899" y="1133922"/>
                  </a:lnTo>
                  <a:lnTo>
                    <a:pt x="1250134" y="1133922"/>
                  </a:lnTo>
                  <a:lnTo>
                    <a:pt x="1250134" y="1082244"/>
                  </a:lnTo>
                  <a:lnTo>
                    <a:pt x="1291122" y="1082244"/>
                  </a:lnTo>
                  <a:lnTo>
                    <a:pt x="1291122" y="1030567"/>
                  </a:lnTo>
                  <a:lnTo>
                    <a:pt x="1332110" y="1030567"/>
                  </a:lnTo>
                  <a:lnTo>
                    <a:pt x="1332110" y="1030567"/>
                  </a:lnTo>
                  <a:lnTo>
                    <a:pt x="1444827" y="1030567"/>
                  </a:lnTo>
                  <a:lnTo>
                    <a:pt x="1444827" y="978890"/>
                  </a:lnTo>
                  <a:lnTo>
                    <a:pt x="1547297" y="978890"/>
                  </a:lnTo>
                  <a:lnTo>
                    <a:pt x="1547297" y="927212"/>
                  </a:lnTo>
                  <a:lnTo>
                    <a:pt x="1588285" y="927212"/>
                  </a:lnTo>
                  <a:lnTo>
                    <a:pt x="1588285" y="875535"/>
                  </a:lnTo>
                  <a:lnTo>
                    <a:pt x="1711249" y="875535"/>
                  </a:lnTo>
                  <a:lnTo>
                    <a:pt x="1711249" y="823857"/>
                  </a:lnTo>
                  <a:lnTo>
                    <a:pt x="1731743" y="823857"/>
                  </a:lnTo>
                  <a:lnTo>
                    <a:pt x="1731743" y="772180"/>
                  </a:lnTo>
                  <a:lnTo>
                    <a:pt x="1762484" y="772180"/>
                  </a:lnTo>
                  <a:lnTo>
                    <a:pt x="1762484" y="720502"/>
                  </a:lnTo>
                  <a:lnTo>
                    <a:pt x="1936683" y="720502"/>
                  </a:lnTo>
                  <a:lnTo>
                    <a:pt x="1936683" y="720502"/>
                  </a:lnTo>
                  <a:lnTo>
                    <a:pt x="2244094" y="720502"/>
                  </a:lnTo>
                  <a:lnTo>
                    <a:pt x="2244094" y="666672"/>
                  </a:lnTo>
                  <a:lnTo>
                    <a:pt x="2285082" y="666672"/>
                  </a:lnTo>
                  <a:lnTo>
                    <a:pt x="2285082" y="612841"/>
                  </a:lnTo>
                  <a:lnTo>
                    <a:pt x="2367058" y="612841"/>
                  </a:lnTo>
                  <a:lnTo>
                    <a:pt x="2367058" y="559010"/>
                  </a:lnTo>
                  <a:lnTo>
                    <a:pt x="2408046" y="559010"/>
                  </a:lnTo>
                  <a:lnTo>
                    <a:pt x="2408046" y="505180"/>
                  </a:lnTo>
                  <a:lnTo>
                    <a:pt x="2418293" y="505180"/>
                  </a:lnTo>
                  <a:lnTo>
                    <a:pt x="2418293" y="451349"/>
                  </a:lnTo>
                  <a:lnTo>
                    <a:pt x="2725703" y="451349"/>
                  </a:lnTo>
                  <a:lnTo>
                    <a:pt x="2725703" y="397518"/>
                  </a:lnTo>
                  <a:lnTo>
                    <a:pt x="2787185" y="397518"/>
                  </a:lnTo>
                  <a:lnTo>
                    <a:pt x="2787185" y="397518"/>
                  </a:lnTo>
                  <a:lnTo>
                    <a:pt x="3002372" y="397518"/>
                  </a:lnTo>
                  <a:lnTo>
                    <a:pt x="3002372" y="343688"/>
                  </a:lnTo>
                  <a:lnTo>
                    <a:pt x="3217559" y="343688"/>
                  </a:lnTo>
                  <a:lnTo>
                    <a:pt x="3217559" y="289857"/>
                  </a:lnTo>
                  <a:lnTo>
                    <a:pt x="3279041" y="289857"/>
                  </a:lnTo>
                  <a:lnTo>
                    <a:pt x="3279041" y="289857"/>
                  </a:lnTo>
                  <a:lnTo>
                    <a:pt x="3873367" y="289857"/>
                  </a:lnTo>
                  <a:lnTo>
                    <a:pt x="3873367" y="231885"/>
                  </a:lnTo>
                  <a:lnTo>
                    <a:pt x="3945096" y="231885"/>
                  </a:lnTo>
                  <a:lnTo>
                    <a:pt x="3945096" y="173914"/>
                  </a:lnTo>
                  <a:lnTo>
                    <a:pt x="4590658" y="173914"/>
                  </a:lnTo>
                  <a:lnTo>
                    <a:pt x="4590658" y="115942"/>
                  </a:lnTo>
                  <a:lnTo>
                    <a:pt x="4877574" y="115942"/>
                  </a:lnTo>
                  <a:lnTo>
                    <a:pt x="4877574" y="57971"/>
                  </a:lnTo>
                  <a:lnTo>
                    <a:pt x="5379677" y="57971"/>
                  </a:lnTo>
                  <a:lnTo>
                    <a:pt x="5379677" y="0"/>
                  </a:lnTo>
                  <a:lnTo>
                    <a:pt x="6301908" y="0"/>
                  </a:lnTo>
                  <a:lnTo>
                    <a:pt x="6301908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71" name="rc29">
              <a:extLst>
                <a:ext uri="{FF2B5EF4-FFF2-40B4-BE49-F238E27FC236}">
                  <a16:creationId xmlns:a16="http://schemas.microsoft.com/office/drawing/2014/main" id="{359BA068-D467-E14B-516A-19EBEA73F2CD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72" name="tx30">
              <a:extLst>
                <a:ext uri="{FF2B5EF4-FFF2-40B4-BE49-F238E27FC236}">
                  <a16:creationId xmlns:a16="http://schemas.microsoft.com/office/drawing/2014/main" id="{70EBD756-8E92-D6A9-B848-F78CDB45F681}"/>
                </a:ext>
              </a:extLst>
            </p:cNvPr>
            <p:cNvSpPr/>
            <p:nvPr/>
          </p:nvSpPr>
          <p:spPr>
            <a:xfrm>
              <a:off x="466667" y="3486760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573" name="tx31">
              <a:extLst>
                <a:ext uri="{FF2B5EF4-FFF2-40B4-BE49-F238E27FC236}">
                  <a16:creationId xmlns:a16="http://schemas.microsoft.com/office/drawing/2014/main" id="{A1A0C36B-B7FE-D710-A436-F58E4D686FB3}"/>
                </a:ext>
              </a:extLst>
            </p:cNvPr>
            <p:cNvSpPr/>
            <p:nvPr/>
          </p:nvSpPr>
          <p:spPr>
            <a:xfrm>
              <a:off x="466667" y="2678436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574" name="tx32">
              <a:extLst>
                <a:ext uri="{FF2B5EF4-FFF2-40B4-BE49-F238E27FC236}">
                  <a16:creationId xmlns:a16="http://schemas.microsoft.com/office/drawing/2014/main" id="{8E459C32-F8AA-A763-4B34-EDED12541ADC}"/>
                </a:ext>
              </a:extLst>
            </p:cNvPr>
            <p:cNvSpPr/>
            <p:nvPr/>
          </p:nvSpPr>
          <p:spPr>
            <a:xfrm>
              <a:off x="466667" y="1870113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575" name="tx33">
              <a:extLst>
                <a:ext uri="{FF2B5EF4-FFF2-40B4-BE49-F238E27FC236}">
                  <a16:creationId xmlns:a16="http://schemas.microsoft.com/office/drawing/2014/main" id="{E4D2BBEB-7688-867A-FBDD-D5CEEE743416}"/>
                </a:ext>
              </a:extLst>
            </p:cNvPr>
            <p:cNvSpPr/>
            <p:nvPr/>
          </p:nvSpPr>
          <p:spPr>
            <a:xfrm>
              <a:off x="466667" y="1061789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576" name="tx34">
              <a:extLst>
                <a:ext uri="{FF2B5EF4-FFF2-40B4-BE49-F238E27FC236}">
                  <a16:creationId xmlns:a16="http://schemas.microsoft.com/office/drawing/2014/main" id="{A4559054-A336-736E-A630-ED3FFC551B7D}"/>
                </a:ext>
              </a:extLst>
            </p:cNvPr>
            <p:cNvSpPr/>
            <p:nvPr/>
          </p:nvSpPr>
          <p:spPr>
            <a:xfrm>
              <a:off x="466667" y="253465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0</a:t>
              </a:r>
            </a:p>
          </p:txBody>
        </p:sp>
        <p:sp>
          <p:nvSpPr>
            <p:cNvPr id="577" name="pl35">
              <a:extLst>
                <a:ext uri="{FF2B5EF4-FFF2-40B4-BE49-F238E27FC236}">
                  <a16:creationId xmlns:a16="http://schemas.microsoft.com/office/drawing/2014/main" id="{220A2430-4339-978C-BC2F-3AFCBCBB6715}"/>
                </a:ext>
              </a:extLst>
            </p:cNvPr>
            <p:cNvSpPr/>
            <p:nvPr/>
          </p:nvSpPr>
          <p:spPr>
            <a:xfrm>
              <a:off x="741682" y="353413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78" name="pl36">
              <a:extLst>
                <a:ext uri="{FF2B5EF4-FFF2-40B4-BE49-F238E27FC236}">
                  <a16:creationId xmlns:a16="http://schemas.microsoft.com/office/drawing/2014/main" id="{798BDFD4-46F8-CDF0-16FB-4165F7DABF1F}"/>
                </a:ext>
              </a:extLst>
            </p:cNvPr>
            <p:cNvSpPr/>
            <p:nvPr/>
          </p:nvSpPr>
          <p:spPr>
            <a:xfrm>
              <a:off x="741682" y="2725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79" name="pl37">
              <a:extLst>
                <a:ext uri="{FF2B5EF4-FFF2-40B4-BE49-F238E27FC236}">
                  <a16:creationId xmlns:a16="http://schemas.microsoft.com/office/drawing/2014/main" id="{A45E32F5-3F8E-08C5-057F-A293E086ACB8}"/>
                </a:ext>
              </a:extLst>
            </p:cNvPr>
            <p:cNvSpPr/>
            <p:nvPr/>
          </p:nvSpPr>
          <p:spPr>
            <a:xfrm>
              <a:off x="741682" y="19174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80" name="pl38">
              <a:extLst>
                <a:ext uri="{FF2B5EF4-FFF2-40B4-BE49-F238E27FC236}">
                  <a16:creationId xmlns:a16="http://schemas.microsoft.com/office/drawing/2014/main" id="{A43CAC4E-3052-31FB-EB3B-29290D8A1BBC}"/>
                </a:ext>
              </a:extLst>
            </p:cNvPr>
            <p:cNvSpPr/>
            <p:nvPr/>
          </p:nvSpPr>
          <p:spPr>
            <a:xfrm>
              <a:off x="741682" y="11091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81" name="pl39">
              <a:extLst>
                <a:ext uri="{FF2B5EF4-FFF2-40B4-BE49-F238E27FC236}">
                  <a16:creationId xmlns:a16="http://schemas.microsoft.com/office/drawing/2014/main" id="{9B9C3B2C-8A91-DF88-8ED9-ACC0BC8590EF}"/>
                </a:ext>
              </a:extLst>
            </p:cNvPr>
            <p:cNvSpPr/>
            <p:nvPr/>
          </p:nvSpPr>
          <p:spPr>
            <a:xfrm>
              <a:off x="741682" y="3008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82" name="pl40">
              <a:extLst>
                <a:ext uri="{FF2B5EF4-FFF2-40B4-BE49-F238E27FC236}">
                  <a16:creationId xmlns:a16="http://schemas.microsoft.com/office/drawing/2014/main" id="{C0F0E42D-266C-5E75-BB3D-8A4ADA762CA3}"/>
                </a:ext>
              </a:extLst>
            </p:cNvPr>
            <p:cNvSpPr/>
            <p:nvPr/>
          </p:nvSpPr>
          <p:spPr>
            <a:xfrm>
              <a:off x="1150492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83" name="pl41">
              <a:extLst>
                <a:ext uri="{FF2B5EF4-FFF2-40B4-BE49-F238E27FC236}">
                  <a16:creationId xmlns:a16="http://schemas.microsoft.com/office/drawing/2014/main" id="{541DC337-B08C-DA63-907E-AFFD5277E532}"/>
                </a:ext>
              </a:extLst>
            </p:cNvPr>
            <p:cNvSpPr/>
            <p:nvPr/>
          </p:nvSpPr>
          <p:spPr>
            <a:xfrm>
              <a:off x="3199893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84" name="pl42">
              <a:extLst>
                <a:ext uri="{FF2B5EF4-FFF2-40B4-BE49-F238E27FC236}">
                  <a16:creationId xmlns:a16="http://schemas.microsoft.com/office/drawing/2014/main" id="{81F734DC-ECAD-0F5A-AEA2-D431FF78EE69}"/>
                </a:ext>
              </a:extLst>
            </p:cNvPr>
            <p:cNvSpPr/>
            <p:nvPr/>
          </p:nvSpPr>
          <p:spPr>
            <a:xfrm>
              <a:off x="5249294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85" name="pl43">
              <a:extLst>
                <a:ext uri="{FF2B5EF4-FFF2-40B4-BE49-F238E27FC236}">
                  <a16:creationId xmlns:a16="http://schemas.microsoft.com/office/drawing/2014/main" id="{906442E7-16A8-7D84-BA48-3C63806C4E1F}"/>
                </a:ext>
              </a:extLst>
            </p:cNvPr>
            <p:cNvSpPr/>
            <p:nvPr/>
          </p:nvSpPr>
          <p:spPr>
            <a:xfrm>
              <a:off x="7298695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86" name="tx44">
              <a:extLst>
                <a:ext uri="{FF2B5EF4-FFF2-40B4-BE49-F238E27FC236}">
                  <a16:creationId xmlns:a16="http://schemas.microsoft.com/office/drawing/2014/main" id="{89AEC945-E3FD-1B39-1FF3-2A44D55689B4}"/>
                </a:ext>
              </a:extLst>
            </p:cNvPr>
            <p:cNvSpPr/>
            <p:nvPr/>
          </p:nvSpPr>
          <p:spPr>
            <a:xfrm>
              <a:off x="1115176" y="3756509"/>
              <a:ext cx="70631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587" name="tx45">
              <a:extLst>
                <a:ext uri="{FF2B5EF4-FFF2-40B4-BE49-F238E27FC236}">
                  <a16:creationId xmlns:a16="http://schemas.microsoft.com/office/drawing/2014/main" id="{72770AEF-6337-9DF4-7B6D-F0692B42869A}"/>
                </a:ext>
              </a:extLst>
            </p:cNvPr>
            <p:cNvSpPr/>
            <p:nvPr/>
          </p:nvSpPr>
          <p:spPr>
            <a:xfrm>
              <a:off x="3093946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588" name="tx46">
              <a:extLst>
                <a:ext uri="{FF2B5EF4-FFF2-40B4-BE49-F238E27FC236}">
                  <a16:creationId xmlns:a16="http://schemas.microsoft.com/office/drawing/2014/main" id="{74765C38-E21F-E3AF-EA46-5A139282BE8E}"/>
                </a:ext>
              </a:extLst>
            </p:cNvPr>
            <p:cNvSpPr/>
            <p:nvPr/>
          </p:nvSpPr>
          <p:spPr>
            <a:xfrm>
              <a:off x="5143347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589" name="tx47">
              <a:extLst>
                <a:ext uri="{FF2B5EF4-FFF2-40B4-BE49-F238E27FC236}">
                  <a16:creationId xmlns:a16="http://schemas.microsoft.com/office/drawing/2014/main" id="{B941E773-173E-8FD1-7A88-534C05232D67}"/>
                </a:ext>
              </a:extLst>
            </p:cNvPr>
            <p:cNvSpPr/>
            <p:nvPr/>
          </p:nvSpPr>
          <p:spPr>
            <a:xfrm>
              <a:off x="7192748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590" name="tx48">
              <a:extLst>
                <a:ext uri="{FF2B5EF4-FFF2-40B4-BE49-F238E27FC236}">
                  <a16:creationId xmlns:a16="http://schemas.microsoft.com/office/drawing/2014/main" id="{C5B785FD-95B2-A4C9-84B8-042DE969992E}"/>
                </a:ext>
              </a:extLst>
            </p:cNvPr>
            <p:cNvSpPr/>
            <p:nvPr/>
          </p:nvSpPr>
          <p:spPr>
            <a:xfrm>
              <a:off x="4009884" y="3878778"/>
              <a:ext cx="1761529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 to Transplant (Days)</a:t>
              </a:r>
            </a:p>
          </p:txBody>
        </p:sp>
        <p:sp>
          <p:nvSpPr>
            <p:cNvPr id="591" name="tx49">
              <a:extLst>
                <a:ext uri="{FF2B5EF4-FFF2-40B4-BE49-F238E27FC236}">
                  <a16:creationId xmlns:a16="http://schemas.microsoft.com/office/drawing/2014/main" id="{1DC02FCD-59DE-E5BD-87EB-D480AA66B5C1}"/>
                </a:ext>
              </a:extLst>
            </p:cNvPr>
            <p:cNvSpPr/>
            <p:nvPr/>
          </p:nvSpPr>
          <p:spPr>
            <a:xfrm rot="-5400000">
              <a:off x="-985888" y="1845978"/>
              <a:ext cx="2668190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umulative Incidence of Transplant (%)</a:t>
              </a:r>
            </a:p>
          </p:txBody>
        </p:sp>
        <p:sp>
          <p:nvSpPr>
            <p:cNvPr id="592" name="rc50">
              <a:extLst>
                <a:ext uri="{FF2B5EF4-FFF2-40B4-BE49-F238E27FC236}">
                  <a16:creationId xmlns:a16="http://schemas.microsoft.com/office/drawing/2014/main" id="{55A41B3B-E327-B590-D82E-F9BBB4714762}"/>
                </a:ext>
              </a:extLst>
            </p:cNvPr>
            <p:cNvSpPr/>
            <p:nvPr/>
          </p:nvSpPr>
          <p:spPr>
            <a:xfrm>
              <a:off x="4276688" y="4189554"/>
              <a:ext cx="1227921" cy="358634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593" name="rc51">
              <a:extLst>
                <a:ext uri="{FF2B5EF4-FFF2-40B4-BE49-F238E27FC236}">
                  <a16:creationId xmlns:a16="http://schemas.microsoft.com/office/drawing/2014/main" id="{6894B862-E990-0904-975A-7CC587480B0F}"/>
                </a:ext>
              </a:extLst>
            </p:cNvPr>
            <p:cNvSpPr/>
            <p:nvPr/>
          </p:nvSpPr>
          <p:spPr>
            <a:xfrm>
              <a:off x="4415866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594" name="pl52">
              <a:extLst>
                <a:ext uri="{FF2B5EF4-FFF2-40B4-BE49-F238E27FC236}">
                  <a16:creationId xmlns:a16="http://schemas.microsoft.com/office/drawing/2014/main" id="{24EBD5E0-BF7E-B7BC-21F7-441F47788ABC}"/>
                </a:ext>
              </a:extLst>
            </p:cNvPr>
            <p:cNvSpPr/>
            <p:nvPr/>
          </p:nvSpPr>
          <p:spPr>
            <a:xfrm>
              <a:off x="4437812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95" name="rc53">
              <a:extLst>
                <a:ext uri="{FF2B5EF4-FFF2-40B4-BE49-F238E27FC236}">
                  <a16:creationId xmlns:a16="http://schemas.microsoft.com/office/drawing/2014/main" id="{CEE52C28-AE7A-2C2C-8AF2-74B0D5091204}"/>
                </a:ext>
              </a:extLst>
            </p:cNvPr>
            <p:cNvSpPr/>
            <p:nvPr/>
          </p:nvSpPr>
          <p:spPr>
            <a:xfrm>
              <a:off x="4926900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596" name="pl54">
              <a:extLst>
                <a:ext uri="{FF2B5EF4-FFF2-40B4-BE49-F238E27FC236}">
                  <a16:creationId xmlns:a16="http://schemas.microsoft.com/office/drawing/2014/main" id="{549A9125-F119-7CE6-9CD3-02C9042411D5}"/>
                </a:ext>
              </a:extLst>
            </p:cNvPr>
            <p:cNvSpPr/>
            <p:nvPr/>
          </p:nvSpPr>
          <p:spPr>
            <a:xfrm>
              <a:off x="4948846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597" name="tx55">
              <a:extLst>
                <a:ext uri="{FF2B5EF4-FFF2-40B4-BE49-F238E27FC236}">
                  <a16:creationId xmlns:a16="http://schemas.microsoft.com/office/drawing/2014/main" id="{53F57853-1AEC-F542-E67A-514567F0EF68}"/>
                </a:ext>
              </a:extLst>
            </p:cNvPr>
            <p:cNvSpPr/>
            <p:nvPr/>
          </p:nvSpPr>
          <p:spPr>
            <a:xfrm>
              <a:off x="4704911" y="4321929"/>
              <a:ext cx="162346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598" name="tx56">
              <a:extLst>
                <a:ext uri="{FF2B5EF4-FFF2-40B4-BE49-F238E27FC236}">
                  <a16:creationId xmlns:a16="http://schemas.microsoft.com/office/drawing/2014/main" id="{6BEB08BB-BD68-4E83-9763-F2D7501D199C}"/>
                </a:ext>
              </a:extLst>
            </p:cNvPr>
            <p:cNvSpPr/>
            <p:nvPr/>
          </p:nvSpPr>
          <p:spPr>
            <a:xfrm>
              <a:off x="5215945" y="4321929"/>
              <a:ext cx="218839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  <p:sp>
          <p:nvSpPr>
            <p:cNvPr id="599" name="rc57">
              <a:extLst>
                <a:ext uri="{FF2B5EF4-FFF2-40B4-BE49-F238E27FC236}">
                  <a16:creationId xmlns:a16="http://schemas.microsoft.com/office/drawing/2014/main" id="{DF54A996-8732-5618-80E1-6F7304ED6C10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00" name="rc58">
              <a:extLst>
                <a:ext uri="{FF2B5EF4-FFF2-40B4-BE49-F238E27FC236}">
                  <a16:creationId xmlns:a16="http://schemas.microsoft.com/office/drawing/2014/main" id="{A00B5285-F83C-DCD6-FB09-65385E58324F}"/>
                </a:ext>
              </a:extLst>
            </p:cNvPr>
            <p:cNvSpPr/>
            <p:nvPr/>
          </p:nvSpPr>
          <p:spPr>
            <a:xfrm>
              <a:off x="776476" y="4996549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601" name="tx59">
              <a:extLst>
                <a:ext uri="{FF2B5EF4-FFF2-40B4-BE49-F238E27FC236}">
                  <a16:creationId xmlns:a16="http://schemas.microsoft.com/office/drawing/2014/main" id="{E876DFB8-D5ED-F6BE-D0AD-F1B82DBEB9B7}"/>
                </a:ext>
              </a:extLst>
            </p:cNvPr>
            <p:cNvSpPr/>
            <p:nvPr/>
          </p:nvSpPr>
          <p:spPr>
            <a:xfrm>
              <a:off x="1115323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02" name="tx60">
              <a:extLst>
                <a:ext uri="{FF2B5EF4-FFF2-40B4-BE49-F238E27FC236}">
                  <a16:creationId xmlns:a16="http://schemas.microsoft.com/office/drawing/2014/main" id="{9E6F4A10-7D73-28BA-9F2D-F7BDDCAFE0A9}"/>
                </a:ext>
              </a:extLst>
            </p:cNvPr>
            <p:cNvSpPr/>
            <p:nvPr/>
          </p:nvSpPr>
          <p:spPr>
            <a:xfrm>
              <a:off x="1115323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603" name="tx61">
              <a:extLst>
                <a:ext uri="{FF2B5EF4-FFF2-40B4-BE49-F238E27FC236}">
                  <a16:creationId xmlns:a16="http://schemas.microsoft.com/office/drawing/2014/main" id="{F5DF7996-C651-2B5A-A9DC-A2A8C69C1BB8}"/>
                </a:ext>
              </a:extLst>
            </p:cNvPr>
            <p:cNvSpPr/>
            <p:nvPr/>
          </p:nvSpPr>
          <p:spPr>
            <a:xfrm>
              <a:off x="3164724" y="5437853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604" name="tx62">
              <a:extLst>
                <a:ext uri="{FF2B5EF4-FFF2-40B4-BE49-F238E27FC236}">
                  <a16:creationId xmlns:a16="http://schemas.microsoft.com/office/drawing/2014/main" id="{E74E379B-D987-04BC-F8C8-0245523BD40D}"/>
                </a:ext>
              </a:extLst>
            </p:cNvPr>
            <p:cNvSpPr/>
            <p:nvPr/>
          </p:nvSpPr>
          <p:spPr>
            <a:xfrm>
              <a:off x="3164724" y="5132512"/>
              <a:ext cx="70337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605" name="tx63">
              <a:extLst>
                <a:ext uri="{FF2B5EF4-FFF2-40B4-BE49-F238E27FC236}">
                  <a16:creationId xmlns:a16="http://schemas.microsoft.com/office/drawing/2014/main" id="{89D7A900-12EA-021F-D151-5E7C4FA3DB03}"/>
                </a:ext>
              </a:extLst>
            </p:cNvPr>
            <p:cNvSpPr/>
            <p:nvPr/>
          </p:nvSpPr>
          <p:spPr>
            <a:xfrm>
              <a:off x="5214125" y="5439829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606" name="tx64">
              <a:extLst>
                <a:ext uri="{FF2B5EF4-FFF2-40B4-BE49-F238E27FC236}">
                  <a16:creationId xmlns:a16="http://schemas.microsoft.com/office/drawing/2014/main" id="{ED37E9C5-9D86-7296-1419-F8F66B059FCF}"/>
                </a:ext>
              </a:extLst>
            </p:cNvPr>
            <p:cNvSpPr/>
            <p:nvPr/>
          </p:nvSpPr>
          <p:spPr>
            <a:xfrm>
              <a:off x="5214125" y="5134117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607" name="tx65">
              <a:extLst>
                <a:ext uri="{FF2B5EF4-FFF2-40B4-BE49-F238E27FC236}">
                  <a16:creationId xmlns:a16="http://schemas.microsoft.com/office/drawing/2014/main" id="{D58BE8A9-5083-3426-5A81-40EA17674CCD}"/>
                </a:ext>
              </a:extLst>
            </p:cNvPr>
            <p:cNvSpPr/>
            <p:nvPr/>
          </p:nvSpPr>
          <p:spPr>
            <a:xfrm>
              <a:off x="7263526" y="5439520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608" name="tx66">
              <a:extLst>
                <a:ext uri="{FF2B5EF4-FFF2-40B4-BE49-F238E27FC236}">
                  <a16:creationId xmlns:a16="http://schemas.microsoft.com/office/drawing/2014/main" id="{2D706ACD-BFDA-37C6-558C-F7B4463191F4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09" name="tx67">
              <a:extLst>
                <a:ext uri="{FF2B5EF4-FFF2-40B4-BE49-F238E27FC236}">
                  <a16:creationId xmlns:a16="http://schemas.microsoft.com/office/drawing/2014/main" id="{EC9C16EB-4D71-340C-5D0E-71C8659F7A88}"/>
                </a:ext>
              </a:extLst>
            </p:cNvPr>
            <p:cNvSpPr/>
            <p:nvPr/>
          </p:nvSpPr>
          <p:spPr>
            <a:xfrm>
              <a:off x="7263526" y="5439520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610" name="tx68">
              <a:extLst>
                <a:ext uri="{FF2B5EF4-FFF2-40B4-BE49-F238E27FC236}">
                  <a16:creationId xmlns:a16="http://schemas.microsoft.com/office/drawing/2014/main" id="{C09C869A-2CB1-F317-F91B-B0DFEA613A1B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11" name="tx69">
              <a:extLst>
                <a:ext uri="{FF2B5EF4-FFF2-40B4-BE49-F238E27FC236}">
                  <a16:creationId xmlns:a16="http://schemas.microsoft.com/office/drawing/2014/main" id="{BB6D3656-E11A-8C72-C26F-34CE4925F1F0}"/>
                </a:ext>
              </a:extLst>
            </p:cNvPr>
            <p:cNvSpPr/>
            <p:nvPr/>
          </p:nvSpPr>
          <p:spPr>
            <a:xfrm>
              <a:off x="325591" y="5438152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612" name="tx70">
              <a:extLst>
                <a:ext uri="{FF2B5EF4-FFF2-40B4-BE49-F238E27FC236}">
                  <a16:creationId xmlns:a16="http://schemas.microsoft.com/office/drawing/2014/main" id="{03337FC1-F218-990A-9D80-08B5EBE6D0E1}"/>
                </a:ext>
              </a:extLst>
            </p:cNvPr>
            <p:cNvSpPr/>
            <p:nvPr/>
          </p:nvSpPr>
          <p:spPr>
            <a:xfrm>
              <a:off x="311638" y="5132811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613" name="tx71">
              <a:extLst>
                <a:ext uri="{FF2B5EF4-FFF2-40B4-BE49-F238E27FC236}">
                  <a16:creationId xmlns:a16="http://schemas.microsoft.com/office/drawing/2014/main" id="{B587C471-6225-17E8-F51D-429FFBD2F165}"/>
                </a:ext>
              </a:extLst>
            </p:cNvPr>
            <p:cNvSpPr/>
            <p:nvPr/>
          </p:nvSpPr>
          <p:spPr>
            <a:xfrm>
              <a:off x="776476" y="4827633"/>
              <a:ext cx="17452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614" name="rc72">
              <a:extLst>
                <a:ext uri="{FF2B5EF4-FFF2-40B4-BE49-F238E27FC236}">
                  <a16:creationId xmlns:a16="http://schemas.microsoft.com/office/drawing/2014/main" id="{1FEF2859-70C7-C62D-148E-19B2498EB40A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15" name="rc73">
              <a:extLst>
                <a:ext uri="{FF2B5EF4-FFF2-40B4-BE49-F238E27FC236}">
                  <a16:creationId xmlns:a16="http://schemas.microsoft.com/office/drawing/2014/main" id="{F348A7AC-9B16-2555-08A2-9EA28766F276}"/>
                </a:ext>
              </a:extLst>
            </p:cNvPr>
            <p:cNvSpPr/>
            <p:nvPr/>
          </p:nvSpPr>
          <p:spPr>
            <a:xfrm>
              <a:off x="776476" y="6081865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616" name="tx74">
              <a:extLst>
                <a:ext uri="{FF2B5EF4-FFF2-40B4-BE49-F238E27FC236}">
                  <a16:creationId xmlns:a16="http://schemas.microsoft.com/office/drawing/2014/main" id="{6C0D1AC5-7888-6E79-D948-D046F039B664}"/>
                </a:ext>
              </a:extLst>
            </p:cNvPr>
            <p:cNvSpPr/>
            <p:nvPr/>
          </p:nvSpPr>
          <p:spPr>
            <a:xfrm>
              <a:off x="1115323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17" name="tx75">
              <a:extLst>
                <a:ext uri="{FF2B5EF4-FFF2-40B4-BE49-F238E27FC236}">
                  <a16:creationId xmlns:a16="http://schemas.microsoft.com/office/drawing/2014/main" id="{F79FB800-4068-5119-C0D0-5EC49E32600C}"/>
                </a:ext>
              </a:extLst>
            </p:cNvPr>
            <p:cNvSpPr/>
            <p:nvPr/>
          </p:nvSpPr>
          <p:spPr>
            <a:xfrm>
              <a:off x="1080154" y="6217890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5</a:t>
              </a:r>
            </a:p>
          </p:txBody>
        </p:sp>
        <p:sp>
          <p:nvSpPr>
            <p:cNvPr id="618" name="tx76">
              <a:extLst>
                <a:ext uri="{FF2B5EF4-FFF2-40B4-BE49-F238E27FC236}">
                  <a16:creationId xmlns:a16="http://schemas.microsoft.com/office/drawing/2014/main" id="{AECC8CEF-D843-1248-FD96-E010CF96C45F}"/>
                </a:ext>
              </a:extLst>
            </p:cNvPr>
            <p:cNvSpPr/>
            <p:nvPr/>
          </p:nvSpPr>
          <p:spPr>
            <a:xfrm>
              <a:off x="3129555" y="6523169"/>
              <a:ext cx="140675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5</a:t>
              </a:r>
            </a:p>
          </p:txBody>
        </p:sp>
        <p:sp>
          <p:nvSpPr>
            <p:cNvPr id="619" name="tx77">
              <a:extLst>
                <a:ext uri="{FF2B5EF4-FFF2-40B4-BE49-F238E27FC236}">
                  <a16:creationId xmlns:a16="http://schemas.microsoft.com/office/drawing/2014/main" id="{F150F803-770C-82BE-9C5A-E5A3717DAF94}"/>
                </a:ext>
              </a:extLst>
            </p:cNvPr>
            <p:cNvSpPr/>
            <p:nvPr/>
          </p:nvSpPr>
          <p:spPr>
            <a:xfrm>
              <a:off x="3129555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4</a:t>
              </a:r>
            </a:p>
          </p:txBody>
        </p:sp>
        <p:sp>
          <p:nvSpPr>
            <p:cNvPr id="620" name="tx78">
              <a:extLst>
                <a:ext uri="{FF2B5EF4-FFF2-40B4-BE49-F238E27FC236}">
                  <a16:creationId xmlns:a16="http://schemas.microsoft.com/office/drawing/2014/main" id="{D5994CCD-7B8E-643E-FE12-309885BB7C12}"/>
                </a:ext>
              </a:extLst>
            </p:cNvPr>
            <p:cNvSpPr/>
            <p:nvPr/>
          </p:nvSpPr>
          <p:spPr>
            <a:xfrm>
              <a:off x="5178956" y="6523602"/>
              <a:ext cx="140675" cy="9207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5</a:t>
              </a:r>
            </a:p>
          </p:txBody>
        </p:sp>
        <p:sp>
          <p:nvSpPr>
            <p:cNvPr id="621" name="tx79">
              <a:extLst>
                <a:ext uri="{FF2B5EF4-FFF2-40B4-BE49-F238E27FC236}">
                  <a16:creationId xmlns:a16="http://schemas.microsoft.com/office/drawing/2014/main" id="{C7387E0A-DDF6-42BA-370A-F5E10B902862}"/>
                </a:ext>
              </a:extLst>
            </p:cNvPr>
            <p:cNvSpPr/>
            <p:nvPr/>
          </p:nvSpPr>
          <p:spPr>
            <a:xfrm>
              <a:off x="5178956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1</a:t>
              </a:r>
            </a:p>
          </p:txBody>
        </p:sp>
        <p:sp>
          <p:nvSpPr>
            <p:cNvPr id="622" name="tx80">
              <a:extLst>
                <a:ext uri="{FF2B5EF4-FFF2-40B4-BE49-F238E27FC236}">
                  <a16:creationId xmlns:a16="http://schemas.microsoft.com/office/drawing/2014/main" id="{6961A845-E763-F65F-1B72-E59B9C89B9C9}"/>
                </a:ext>
              </a:extLst>
            </p:cNvPr>
            <p:cNvSpPr/>
            <p:nvPr/>
          </p:nvSpPr>
          <p:spPr>
            <a:xfrm>
              <a:off x="7228357" y="6523231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8</a:t>
              </a:r>
            </a:p>
          </p:txBody>
        </p:sp>
        <p:sp>
          <p:nvSpPr>
            <p:cNvPr id="623" name="tx81">
              <a:extLst>
                <a:ext uri="{FF2B5EF4-FFF2-40B4-BE49-F238E27FC236}">
                  <a16:creationId xmlns:a16="http://schemas.microsoft.com/office/drawing/2014/main" id="{C6131B1B-AD09-06A2-80B6-C32F91C8A13C}"/>
                </a:ext>
              </a:extLst>
            </p:cNvPr>
            <p:cNvSpPr/>
            <p:nvPr/>
          </p:nvSpPr>
          <p:spPr>
            <a:xfrm>
              <a:off x="7263526" y="6217890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624" name="tx82">
              <a:extLst>
                <a:ext uri="{FF2B5EF4-FFF2-40B4-BE49-F238E27FC236}">
                  <a16:creationId xmlns:a16="http://schemas.microsoft.com/office/drawing/2014/main" id="{9B000A99-AB9D-5163-B8C5-5D752028F122}"/>
                </a:ext>
              </a:extLst>
            </p:cNvPr>
            <p:cNvSpPr/>
            <p:nvPr/>
          </p:nvSpPr>
          <p:spPr>
            <a:xfrm>
              <a:off x="325591" y="6523468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625" name="tx83">
              <a:extLst>
                <a:ext uri="{FF2B5EF4-FFF2-40B4-BE49-F238E27FC236}">
                  <a16:creationId xmlns:a16="http://schemas.microsoft.com/office/drawing/2014/main" id="{483DAE96-4768-DEA8-3DB2-5A1D3B26DC90}"/>
                </a:ext>
              </a:extLst>
            </p:cNvPr>
            <p:cNvSpPr/>
            <p:nvPr/>
          </p:nvSpPr>
          <p:spPr>
            <a:xfrm>
              <a:off x="311638" y="6218127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626" name="tx84">
              <a:extLst>
                <a:ext uri="{FF2B5EF4-FFF2-40B4-BE49-F238E27FC236}">
                  <a16:creationId xmlns:a16="http://schemas.microsoft.com/office/drawing/2014/main" id="{C68DADB8-1A3D-453F-D746-474B3A0F8C08}"/>
                </a:ext>
              </a:extLst>
            </p:cNvPr>
            <p:cNvSpPr/>
            <p:nvPr/>
          </p:nvSpPr>
          <p:spPr>
            <a:xfrm>
              <a:off x="776476" y="5912949"/>
              <a:ext cx="23525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</p:grpSp>
      <p:sp>
        <p:nvSpPr>
          <p:cNvPr id="627" name="TextBox 626">
            <a:extLst>
              <a:ext uri="{FF2B5EF4-FFF2-40B4-BE49-F238E27FC236}">
                <a16:creationId xmlns:a16="http://schemas.microsoft.com/office/drawing/2014/main" id="{2834EC3E-680C-6505-2292-02DBAD556738}"/>
              </a:ext>
            </a:extLst>
          </p:cNvPr>
          <p:cNvSpPr txBox="1"/>
          <p:nvPr/>
        </p:nvSpPr>
        <p:spPr>
          <a:xfrm>
            <a:off x="646060" y="9314173"/>
            <a:ext cx="2877987" cy="6014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7" b="1" dirty="0">
                <a:latin typeface="Arial" panose="020B0604020202020204" pitchFamily="34" charset="0"/>
                <a:cs typeface="Arial" panose="020B0604020202020204" pitchFamily="34" charset="0"/>
              </a:rPr>
              <a:t>Potential Living Donor Total   Event   HR (95% CI)</a:t>
            </a:r>
          </a:p>
          <a:p>
            <a:r>
              <a:rPr lang="en-US" sz="827" dirty="0">
                <a:latin typeface="Arial" panose="020B0604020202020204" pitchFamily="34" charset="0"/>
                <a:cs typeface="Arial" panose="020B0604020202020204" pitchFamily="34" charset="0"/>
              </a:rPr>
              <a:t>No                                      6         5         Reference</a:t>
            </a:r>
          </a:p>
          <a:p>
            <a:r>
              <a:rPr lang="en-US" sz="827" dirty="0">
                <a:latin typeface="Arial" panose="020B0604020202020204" pitchFamily="34" charset="0"/>
                <a:cs typeface="Arial" panose="020B0604020202020204" pitchFamily="34" charset="0"/>
              </a:rPr>
              <a:t>Yes                                    65       48       0.92 (0.39 – 2.19)</a:t>
            </a:r>
          </a:p>
          <a:p>
            <a:r>
              <a:rPr lang="en-US" sz="827" dirty="0">
                <a:latin typeface="Arial" panose="020B0604020202020204" pitchFamily="34" charset="0"/>
                <a:cs typeface="Arial" panose="020B0604020202020204" pitchFamily="34" charset="0"/>
              </a:rPr>
              <a:t>Gray K-Sample Test P-value: 0.7811 </a:t>
            </a:r>
          </a:p>
        </p:txBody>
      </p:sp>
      <p:sp>
        <p:nvSpPr>
          <p:cNvPr id="628" name="pl48">
            <a:extLst>
              <a:ext uri="{FF2B5EF4-FFF2-40B4-BE49-F238E27FC236}">
                <a16:creationId xmlns:a16="http://schemas.microsoft.com/office/drawing/2014/main" id="{2BCF666B-63A4-6C2B-5FC2-CAD30CDEAB98}"/>
              </a:ext>
            </a:extLst>
          </p:cNvPr>
          <p:cNvSpPr/>
          <p:nvPr/>
        </p:nvSpPr>
        <p:spPr>
          <a:xfrm>
            <a:off x="508467" y="9541971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629" name="pl50">
            <a:extLst>
              <a:ext uri="{FF2B5EF4-FFF2-40B4-BE49-F238E27FC236}">
                <a16:creationId xmlns:a16="http://schemas.microsoft.com/office/drawing/2014/main" id="{9D511E2D-F780-C6A8-B370-E3E5214A107C}"/>
              </a:ext>
            </a:extLst>
          </p:cNvPr>
          <p:cNvSpPr/>
          <p:nvPr/>
        </p:nvSpPr>
        <p:spPr>
          <a:xfrm>
            <a:off x="507845" y="9666466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grpSp>
        <p:nvGrpSpPr>
          <p:cNvPr id="630" name="Group 629">
            <a:extLst>
              <a:ext uri="{FF2B5EF4-FFF2-40B4-BE49-F238E27FC236}">
                <a16:creationId xmlns:a16="http://schemas.microsoft.com/office/drawing/2014/main" id="{F333AF47-C06E-AC6E-05C1-E10CF30AF978}"/>
              </a:ext>
            </a:extLst>
          </p:cNvPr>
          <p:cNvGrpSpPr>
            <a:grpSpLocks noChangeAspect="1"/>
          </p:cNvGrpSpPr>
          <p:nvPr/>
        </p:nvGrpSpPr>
        <p:grpSpPr>
          <a:xfrm>
            <a:off x="4915896" y="9155285"/>
            <a:ext cx="4783952" cy="3571875"/>
            <a:chOff x="0" y="0"/>
            <a:chExt cx="9144000" cy="6858000"/>
          </a:xfrm>
        </p:grpSpPr>
        <p:sp>
          <p:nvSpPr>
            <p:cNvPr id="631" name="rc3">
              <a:extLst>
                <a:ext uri="{FF2B5EF4-FFF2-40B4-BE49-F238E27FC236}">
                  <a16:creationId xmlns:a16="http://schemas.microsoft.com/office/drawing/2014/main" id="{11F8DE60-5BA0-FFD8-BF20-31B8E3792CF3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32" name="rc4">
              <a:extLst>
                <a:ext uri="{FF2B5EF4-FFF2-40B4-BE49-F238E27FC236}">
                  <a16:creationId xmlns:a16="http://schemas.microsoft.com/office/drawing/2014/main" id="{43DA10F4-55FA-F7FC-B701-7F13936C0592}"/>
                </a:ext>
              </a:extLst>
            </p:cNvPr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33" name="rc5">
              <a:extLst>
                <a:ext uri="{FF2B5EF4-FFF2-40B4-BE49-F238E27FC236}">
                  <a16:creationId xmlns:a16="http://schemas.microsoft.com/office/drawing/2014/main" id="{C44A5F09-7CD3-EC51-A520-0A6A7DA95AB8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34" name="rc6">
              <a:extLst>
                <a:ext uri="{FF2B5EF4-FFF2-40B4-BE49-F238E27FC236}">
                  <a16:creationId xmlns:a16="http://schemas.microsoft.com/office/drawing/2014/main" id="{3F45FA27-D0C2-D082-16CE-F3772F499FAD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35" name="rc7">
              <a:extLst>
                <a:ext uri="{FF2B5EF4-FFF2-40B4-BE49-F238E27FC236}">
                  <a16:creationId xmlns:a16="http://schemas.microsoft.com/office/drawing/2014/main" id="{FBADC5AF-2D5A-7F66-2ABD-BEA302EAD796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38" name="rc8">
              <a:extLst>
                <a:ext uri="{FF2B5EF4-FFF2-40B4-BE49-F238E27FC236}">
                  <a16:creationId xmlns:a16="http://schemas.microsoft.com/office/drawing/2014/main" id="{5933D568-B2C5-9EF3-16E3-4CC9CE203D0E}"/>
                </a:ext>
              </a:extLst>
            </p:cNvPr>
            <p:cNvSpPr/>
            <p:nvPr/>
          </p:nvSpPr>
          <p:spPr>
            <a:xfrm>
              <a:off x="69589" y="69589"/>
              <a:ext cx="9004821" cy="454818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639" name="rc9">
              <a:extLst>
                <a:ext uri="{FF2B5EF4-FFF2-40B4-BE49-F238E27FC236}">
                  <a16:creationId xmlns:a16="http://schemas.microsoft.com/office/drawing/2014/main" id="{2A86440A-D41D-6B2D-A7E2-67983FBA2AF1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704" name="pl18">
              <a:extLst>
                <a:ext uri="{FF2B5EF4-FFF2-40B4-BE49-F238E27FC236}">
                  <a16:creationId xmlns:a16="http://schemas.microsoft.com/office/drawing/2014/main" id="{0A66F91F-255F-C089-1CA2-CEECA64F5F95}"/>
                </a:ext>
              </a:extLst>
            </p:cNvPr>
            <p:cNvSpPr/>
            <p:nvPr/>
          </p:nvSpPr>
          <p:spPr>
            <a:xfrm>
              <a:off x="776476" y="3534137"/>
              <a:ext cx="8228345" cy="0"/>
            </a:xfrm>
            <a:custGeom>
              <a:avLst/>
              <a:gdLst/>
              <a:ahLst/>
              <a:cxnLst/>
              <a:rect l="0" t="0" r="0" b="0"/>
              <a:pathLst>
                <a:path w="8228345">
                  <a:moveTo>
                    <a:pt x="0" y="0"/>
                  </a:moveTo>
                  <a:lnTo>
                    <a:pt x="8228345" y="0"/>
                  </a:lnTo>
                  <a:lnTo>
                    <a:pt x="8228345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05" name="pl23">
              <a:extLst>
                <a:ext uri="{FF2B5EF4-FFF2-40B4-BE49-F238E27FC236}">
                  <a16:creationId xmlns:a16="http://schemas.microsoft.com/office/drawing/2014/main" id="{185C8CC3-B641-2FAB-2EE1-9B1440BB4B1A}"/>
                </a:ext>
              </a:extLst>
            </p:cNvPr>
            <p:cNvSpPr/>
            <p:nvPr/>
          </p:nvSpPr>
          <p:spPr>
            <a:xfrm>
              <a:off x="1150492" y="139178"/>
              <a:ext cx="0" cy="3556623"/>
            </a:xfrm>
            <a:custGeom>
              <a:avLst/>
              <a:gdLst/>
              <a:ahLst/>
              <a:cxnLst/>
              <a:rect l="0" t="0" r="0" b="0"/>
              <a:pathLst>
                <a:path h="3556623">
                  <a:moveTo>
                    <a:pt x="0" y="35566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EBEBE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06" name="pl27">
              <a:extLst>
                <a:ext uri="{FF2B5EF4-FFF2-40B4-BE49-F238E27FC236}">
                  <a16:creationId xmlns:a16="http://schemas.microsoft.com/office/drawing/2014/main" id="{6C5848C9-BC1E-D6A2-07E6-08EEAA270A11}"/>
                </a:ext>
              </a:extLst>
            </p:cNvPr>
            <p:cNvSpPr/>
            <p:nvPr/>
          </p:nvSpPr>
          <p:spPr>
            <a:xfrm>
              <a:off x="1150492" y="1378607"/>
              <a:ext cx="4324236" cy="2155529"/>
            </a:xfrm>
            <a:custGeom>
              <a:avLst/>
              <a:gdLst/>
              <a:ahLst/>
              <a:cxnLst/>
              <a:rect l="0" t="0" r="0" b="0"/>
              <a:pathLst>
                <a:path w="4324236" h="2155529">
                  <a:moveTo>
                    <a:pt x="0" y="2155529"/>
                  </a:moveTo>
                  <a:lnTo>
                    <a:pt x="61482" y="2155529"/>
                  </a:lnTo>
                  <a:lnTo>
                    <a:pt x="61482" y="1796274"/>
                  </a:lnTo>
                  <a:lnTo>
                    <a:pt x="71729" y="1796274"/>
                  </a:lnTo>
                  <a:lnTo>
                    <a:pt x="71729" y="1437019"/>
                  </a:lnTo>
                  <a:lnTo>
                    <a:pt x="389386" y="1437019"/>
                  </a:lnTo>
                  <a:lnTo>
                    <a:pt x="389386" y="1077764"/>
                  </a:lnTo>
                  <a:lnTo>
                    <a:pt x="1014453" y="1077764"/>
                  </a:lnTo>
                  <a:lnTo>
                    <a:pt x="1014453" y="718509"/>
                  </a:lnTo>
                  <a:lnTo>
                    <a:pt x="2100636" y="718509"/>
                  </a:lnTo>
                  <a:lnTo>
                    <a:pt x="2100636" y="718509"/>
                  </a:lnTo>
                  <a:lnTo>
                    <a:pt x="2490022" y="718509"/>
                  </a:lnTo>
                  <a:lnTo>
                    <a:pt x="2490022" y="718509"/>
                  </a:lnTo>
                  <a:lnTo>
                    <a:pt x="3074101" y="718509"/>
                  </a:lnTo>
                  <a:lnTo>
                    <a:pt x="3074101" y="359254"/>
                  </a:lnTo>
                  <a:lnTo>
                    <a:pt x="3863120" y="359254"/>
                  </a:lnTo>
                  <a:lnTo>
                    <a:pt x="3863120" y="0"/>
                  </a:lnTo>
                  <a:lnTo>
                    <a:pt x="4324236" y="0"/>
                  </a:lnTo>
                  <a:lnTo>
                    <a:pt x="4324236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07" name="pl28">
              <a:extLst>
                <a:ext uri="{FF2B5EF4-FFF2-40B4-BE49-F238E27FC236}">
                  <a16:creationId xmlns:a16="http://schemas.microsoft.com/office/drawing/2014/main" id="{D3163FDF-8BCF-5EDC-FFF6-44EB971CF8A4}"/>
                </a:ext>
              </a:extLst>
            </p:cNvPr>
            <p:cNvSpPr/>
            <p:nvPr/>
          </p:nvSpPr>
          <p:spPr>
            <a:xfrm>
              <a:off x="1150492" y="1167209"/>
              <a:ext cx="7265126" cy="2366927"/>
            </a:xfrm>
            <a:custGeom>
              <a:avLst/>
              <a:gdLst/>
              <a:ahLst/>
              <a:cxnLst/>
              <a:rect l="0" t="0" r="0" b="0"/>
              <a:pathLst>
                <a:path w="7265126" h="2366927">
                  <a:moveTo>
                    <a:pt x="0" y="2366927"/>
                  </a:moveTo>
                  <a:lnTo>
                    <a:pt x="61482" y="2366927"/>
                  </a:lnTo>
                  <a:lnTo>
                    <a:pt x="61482" y="2296638"/>
                  </a:lnTo>
                  <a:lnTo>
                    <a:pt x="112717" y="2296638"/>
                  </a:lnTo>
                  <a:lnTo>
                    <a:pt x="112717" y="2226349"/>
                  </a:lnTo>
                  <a:lnTo>
                    <a:pt x="194693" y="2226349"/>
                  </a:lnTo>
                  <a:lnTo>
                    <a:pt x="194693" y="2156060"/>
                  </a:lnTo>
                  <a:lnTo>
                    <a:pt x="204940" y="2156060"/>
                  </a:lnTo>
                  <a:lnTo>
                    <a:pt x="204940" y="2156060"/>
                  </a:lnTo>
                  <a:lnTo>
                    <a:pt x="297163" y="2156060"/>
                  </a:lnTo>
                  <a:lnTo>
                    <a:pt x="297163" y="2084098"/>
                  </a:lnTo>
                  <a:lnTo>
                    <a:pt x="409880" y="2084098"/>
                  </a:lnTo>
                  <a:lnTo>
                    <a:pt x="409880" y="2012135"/>
                  </a:lnTo>
                  <a:lnTo>
                    <a:pt x="440621" y="2012135"/>
                  </a:lnTo>
                  <a:lnTo>
                    <a:pt x="440621" y="2012135"/>
                  </a:lnTo>
                  <a:lnTo>
                    <a:pt x="491856" y="2012135"/>
                  </a:lnTo>
                  <a:lnTo>
                    <a:pt x="491856" y="1940173"/>
                  </a:lnTo>
                  <a:lnTo>
                    <a:pt x="502103" y="1940173"/>
                  </a:lnTo>
                  <a:lnTo>
                    <a:pt x="502103" y="1868210"/>
                  </a:lnTo>
                  <a:lnTo>
                    <a:pt x="737784" y="1868210"/>
                  </a:lnTo>
                  <a:lnTo>
                    <a:pt x="737784" y="1796248"/>
                  </a:lnTo>
                  <a:lnTo>
                    <a:pt x="830007" y="1796248"/>
                  </a:lnTo>
                  <a:lnTo>
                    <a:pt x="830007" y="1724285"/>
                  </a:lnTo>
                  <a:lnTo>
                    <a:pt x="840254" y="1724285"/>
                  </a:lnTo>
                  <a:lnTo>
                    <a:pt x="840254" y="1724285"/>
                  </a:lnTo>
                  <a:lnTo>
                    <a:pt x="1034947" y="1724285"/>
                  </a:lnTo>
                  <a:lnTo>
                    <a:pt x="1034947" y="1652322"/>
                  </a:lnTo>
                  <a:lnTo>
                    <a:pt x="1096429" y="1652322"/>
                  </a:lnTo>
                  <a:lnTo>
                    <a:pt x="1096429" y="1580360"/>
                  </a:lnTo>
                  <a:lnTo>
                    <a:pt x="1168158" y="1580360"/>
                  </a:lnTo>
                  <a:lnTo>
                    <a:pt x="1168158" y="1508397"/>
                  </a:lnTo>
                  <a:lnTo>
                    <a:pt x="1178405" y="1508397"/>
                  </a:lnTo>
                  <a:lnTo>
                    <a:pt x="1178405" y="1436435"/>
                  </a:lnTo>
                  <a:lnTo>
                    <a:pt x="1280875" y="1436435"/>
                  </a:lnTo>
                  <a:lnTo>
                    <a:pt x="1280875" y="1364472"/>
                  </a:lnTo>
                  <a:lnTo>
                    <a:pt x="1434580" y="1364472"/>
                  </a:lnTo>
                  <a:lnTo>
                    <a:pt x="1434580" y="1292510"/>
                  </a:lnTo>
                  <a:lnTo>
                    <a:pt x="1485815" y="1292510"/>
                  </a:lnTo>
                  <a:lnTo>
                    <a:pt x="1485815" y="1220547"/>
                  </a:lnTo>
                  <a:lnTo>
                    <a:pt x="1649767" y="1220547"/>
                  </a:lnTo>
                  <a:lnTo>
                    <a:pt x="1649767" y="1220547"/>
                  </a:lnTo>
                  <a:lnTo>
                    <a:pt x="1711249" y="1220547"/>
                  </a:lnTo>
                  <a:lnTo>
                    <a:pt x="1711249" y="1148585"/>
                  </a:lnTo>
                  <a:lnTo>
                    <a:pt x="1741990" y="1148585"/>
                  </a:lnTo>
                  <a:lnTo>
                    <a:pt x="1741990" y="1076622"/>
                  </a:lnTo>
                  <a:lnTo>
                    <a:pt x="1752237" y="1076622"/>
                  </a:lnTo>
                  <a:lnTo>
                    <a:pt x="1752237" y="1076622"/>
                  </a:lnTo>
                  <a:lnTo>
                    <a:pt x="1905942" y="1076622"/>
                  </a:lnTo>
                  <a:lnTo>
                    <a:pt x="1905942" y="1001531"/>
                  </a:lnTo>
                  <a:lnTo>
                    <a:pt x="1957177" y="1001531"/>
                  </a:lnTo>
                  <a:lnTo>
                    <a:pt x="1957177" y="926439"/>
                  </a:lnTo>
                  <a:lnTo>
                    <a:pt x="2356811" y="926439"/>
                  </a:lnTo>
                  <a:lnTo>
                    <a:pt x="2356811" y="926439"/>
                  </a:lnTo>
                  <a:lnTo>
                    <a:pt x="2571998" y="926439"/>
                  </a:lnTo>
                  <a:lnTo>
                    <a:pt x="2571998" y="847593"/>
                  </a:lnTo>
                  <a:lnTo>
                    <a:pt x="2705209" y="847593"/>
                  </a:lnTo>
                  <a:lnTo>
                    <a:pt x="2705209" y="768747"/>
                  </a:lnTo>
                  <a:lnTo>
                    <a:pt x="2735950" y="768747"/>
                  </a:lnTo>
                  <a:lnTo>
                    <a:pt x="2735950" y="689901"/>
                  </a:lnTo>
                  <a:lnTo>
                    <a:pt x="2787185" y="689901"/>
                  </a:lnTo>
                  <a:lnTo>
                    <a:pt x="2787185" y="611055"/>
                  </a:lnTo>
                  <a:lnTo>
                    <a:pt x="3340523" y="611055"/>
                  </a:lnTo>
                  <a:lnTo>
                    <a:pt x="3340523" y="532210"/>
                  </a:lnTo>
                  <a:lnTo>
                    <a:pt x="3842626" y="532210"/>
                  </a:lnTo>
                  <a:lnTo>
                    <a:pt x="3842626" y="453364"/>
                  </a:lnTo>
                  <a:lnTo>
                    <a:pt x="3863120" y="453364"/>
                  </a:lnTo>
                  <a:lnTo>
                    <a:pt x="3863120" y="374518"/>
                  </a:lnTo>
                  <a:lnTo>
                    <a:pt x="4590658" y="374518"/>
                  </a:lnTo>
                  <a:lnTo>
                    <a:pt x="4590658" y="295672"/>
                  </a:lnTo>
                  <a:lnTo>
                    <a:pt x="5092761" y="295672"/>
                  </a:lnTo>
                  <a:lnTo>
                    <a:pt x="5092761" y="216826"/>
                  </a:lnTo>
                  <a:lnTo>
                    <a:pt x="5512888" y="216826"/>
                  </a:lnTo>
                  <a:lnTo>
                    <a:pt x="5512888" y="216826"/>
                  </a:lnTo>
                  <a:lnTo>
                    <a:pt x="6045733" y="216826"/>
                  </a:lnTo>
                  <a:lnTo>
                    <a:pt x="6045733" y="130095"/>
                  </a:lnTo>
                  <a:lnTo>
                    <a:pt x="6527342" y="130095"/>
                  </a:lnTo>
                  <a:lnTo>
                    <a:pt x="6527342" y="130095"/>
                  </a:lnTo>
                  <a:lnTo>
                    <a:pt x="7008951" y="130095"/>
                  </a:lnTo>
                  <a:lnTo>
                    <a:pt x="7008951" y="130095"/>
                  </a:lnTo>
                  <a:lnTo>
                    <a:pt x="7049939" y="130095"/>
                  </a:lnTo>
                  <a:lnTo>
                    <a:pt x="7049939" y="130095"/>
                  </a:lnTo>
                  <a:lnTo>
                    <a:pt x="7265126" y="130095"/>
                  </a:lnTo>
                  <a:lnTo>
                    <a:pt x="7265126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708" name="rc29">
              <a:extLst>
                <a:ext uri="{FF2B5EF4-FFF2-40B4-BE49-F238E27FC236}">
                  <a16:creationId xmlns:a16="http://schemas.microsoft.com/office/drawing/2014/main" id="{3E446489-8D70-C1BF-7531-181013FC527B}"/>
                </a:ext>
              </a:extLst>
            </p:cNvPr>
            <p:cNvSpPr/>
            <p:nvPr/>
          </p:nvSpPr>
          <p:spPr>
            <a:xfrm>
              <a:off x="776476" y="139178"/>
              <a:ext cx="8228345" cy="3556623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22" name="tx30">
              <a:extLst>
                <a:ext uri="{FF2B5EF4-FFF2-40B4-BE49-F238E27FC236}">
                  <a16:creationId xmlns:a16="http://schemas.microsoft.com/office/drawing/2014/main" id="{21B19C06-2BEC-A2B1-C6E4-8B03294FC518}"/>
                </a:ext>
              </a:extLst>
            </p:cNvPr>
            <p:cNvSpPr/>
            <p:nvPr/>
          </p:nvSpPr>
          <p:spPr>
            <a:xfrm>
              <a:off x="466667" y="3486760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</a:t>
              </a:r>
            </a:p>
          </p:txBody>
        </p:sp>
        <p:sp>
          <p:nvSpPr>
            <p:cNvPr id="823" name="tx31">
              <a:extLst>
                <a:ext uri="{FF2B5EF4-FFF2-40B4-BE49-F238E27FC236}">
                  <a16:creationId xmlns:a16="http://schemas.microsoft.com/office/drawing/2014/main" id="{B3DAEF4A-9246-B68C-DEFE-D2BA85DC5AC2}"/>
                </a:ext>
              </a:extLst>
            </p:cNvPr>
            <p:cNvSpPr/>
            <p:nvPr/>
          </p:nvSpPr>
          <p:spPr>
            <a:xfrm>
              <a:off x="466667" y="2678436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5</a:t>
              </a:r>
            </a:p>
          </p:txBody>
        </p:sp>
        <p:sp>
          <p:nvSpPr>
            <p:cNvPr id="824" name="tx32">
              <a:extLst>
                <a:ext uri="{FF2B5EF4-FFF2-40B4-BE49-F238E27FC236}">
                  <a16:creationId xmlns:a16="http://schemas.microsoft.com/office/drawing/2014/main" id="{0B0F95EF-8B37-3C15-BC60-B6B43B44F350}"/>
                </a:ext>
              </a:extLst>
            </p:cNvPr>
            <p:cNvSpPr/>
            <p:nvPr/>
          </p:nvSpPr>
          <p:spPr>
            <a:xfrm>
              <a:off x="466667" y="1870113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50</a:t>
              </a:r>
            </a:p>
          </p:txBody>
        </p:sp>
        <p:sp>
          <p:nvSpPr>
            <p:cNvPr id="825" name="tx33">
              <a:extLst>
                <a:ext uri="{FF2B5EF4-FFF2-40B4-BE49-F238E27FC236}">
                  <a16:creationId xmlns:a16="http://schemas.microsoft.com/office/drawing/2014/main" id="{0F1B33A3-95A0-E144-8899-B13DA0F9C037}"/>
                </a:ext>
              </a:extLst>
            </p:cNvPr>
            <p:cNvSpPr/>
            <p:nvPr/>
          </p:nvSpPr>
          <p:spPr>
            <a:xfrm>
              <a:off x="466667" y="1061789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826" name="tx34">
              <a:extLst>
                <a:ext uri="{FF2B5EF4-FFF2-40B4-BE49-F238E27FC236}">
                  <a16:creationId xmlns:a16="http://schemas.microsoft.com/office/drawing/2014/main" id="{47191655-3E13-387C-B1A3-FBACB99F9DE7}"/>
                </a:ext>
              </a:extLst>
            </p:cNvPr>
            <p:cNvSpPr/>
            <p:nvPr/>
          </p:nvSpPr>
          <p:spPr>
            <a:xfrm>
              <a:off x="466667" y="253465"/>
              <a:ext cx="247178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00</a:t>
              </a:r>
            </a:p>
          </p:txBody>
        </p:sp>
        <p:sp>
          <p:nvSpPr>
            <p:cNvPr id="827" name="pl35">
              <a:extLst>
                <a:ext uri="{FF2B5EF4-FFF2-40B4-BE49-F238E27FC236}">
                  <a16:creationId xmlns:a16="http://schemas.microsoft.com/office/drawing/2014/main" id="{FA28EA9E-02CC-DA03-C1F3-9ECC281F23F4}"/>
                </a:ext>
              </a:extLst>
            </p:cNvPr>
            <p:cNvSpPr/>
            <p:nvPr/>
          </p:nvSpPr>
          <p:spPr>
            <a:xfrm>
              <a:off x="741682" y="353413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28" name="pl36">
              <a:extLst>
                <a:ext uri="{FF2B5EF4-FFF2-40B4-BE49-F238E27FC236}">
                  <a16:creationId xmlns:a16="http://schemas.microsoft.com/office/drawing/2014/main" id="{CA190857-6A9C-F400-EE2F-A12364C7C9BF}"/>
                </a:ext>
              </a:extLst>
            </p:cNvPr>
            <p:cNvSpPr/>
            <p:nvPr/>
          </p:nvSpPr>
          <p:spPr>
            <a:xfrm>
              <a:off x="741682" y="272581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29" name="pl37">
              <a:extLst>
                <a:ext uri="{FF2B5EF4-FFF2-40B4-BE49-F238E27FC236}">
                  <a16:creationId xmlns:a16="http://schemas.microsoft.com/office/drawing/2014/main" id="{272120A9-D5D0-C652-E866-7D9F4E132411}"/>
                </a:ext>
              </a:extLst>
            </p:cNvPr>
            <p:cNvSpPr/>
            <p:nvPr/>
          </p:nvSpPr>
          <p:spPr>
            <a:xfrm>
              <a:off x="741682" y="191749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30" name="pl38">
              <a:extLst>
                <a:ext uri="{FF2B5EF4-FFF2-40B4-BE49-F238E27FC236}">
                  <a16:creationId xmlns:a16="http://schemas.microsoft.com/office/drawing/2014/main" id="{12F9AAFE-0E31-9CC1-17E1-999BB888DB53}"/>
                </a:ext>
              </a:extLst>
            </p:cNvPr>
            <p:cNvSpPr/>
            <p:nvPr/>
          </p:nvSpPr>
          <p:spPr>
            <a:xfrm>
              <a:off x="741682" y="11091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31" name="pl39">
              <a:extLst>
                <a:ext uri="{FF2B5EF4-FFF2-40B4-BE49-F238E27FC236}">
                  <a16:creationId xmlns:a16="http://schemas.microsoft.com/office/drawing/2014/main" id="{12C8C8DE-C56B-F209-044B-2A482177708E}"/>
                </a:ext>
              </a:extLst>
            </p:cNvPr>
            <p:cNvSpPr/>
            <p:nvPr/>
          </p:nvSpPr>
          <p:spPr>
            <a:xfrm>
              <a:off x="741682" y="30084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32" name="pl40">
              <a:extLst>
                <a:ext uri="{FF2B5EF4-FFF2-40B4-BE49-F238E27FC236}">
                  <a16:creationId xmlns:a16="http://schemas.microsoft.com/office/drawing/2014/main" id="{E9034796-1C51-77D8-104E-C76E57EDEA65}"/>
                </a:ext>
              </a:extLst>
            </p:cNvPr>
            <p:cNvSpPr/>
            <p:nvPr/>
          </p:nvSpPr>
          <p:spPr>
            <a:xfrm>
              <a:off x="1150492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33" name="pl41">
              <a:extLst>
                <a:ext uri="{FF2B5EF4-FFF2-40B4-BE49-F238E27FC236}">
                  <a16:creationId xmlns:a16="http://schemas.microsoft.com/office/drawing/2014/main" id="{84A80473-B2B9-6CBD-C393-16496E7CA285}"/>
                </a:ext>
              </a:extLst>
            </p:cNvPr>
            <p:cNvSpPr/>
            <p:nvPr/>
          </p:nvSpPr>
          <p:spPr>
            <a:xfrm>
              <a:off x="3199893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34" name="pl42">
              <a:extLst>
                <a:ext uri="{FF2B5EF4-FFF2-40B4-BE49-F238E27FC236}">
                  <a16:creationId xmlns:a16="http://schemas.microsoft.com/office/drawing/2014/main" id="{DAF15B95-8085-296E-6A32-CB77A09A53E3}"/>
                </a:ext>
              </a:extLst>
            </p:cNvPr>
            <p:cNvSpPr/>
            <p:nvPr/>
          </p:nvSpPr>
          <p:spPr>
            <a:xfrm>
              <a:off x="5249294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35" name="pl43">
              <a:extLst>
                <a:ext uri="{FF2B5EF4-FFF2-40B4-BE49-F238E27FC236}">
                  <a16:creationId xmlns:a16="http://schemas.microsoft.com/office/drawing/2014/main" id="{3816682E-8C80-3E49-6E04-BA0BBE0A1BE4}"/>
                </a:ext>
              </a:extLst>
            </p:cNvPr>
            <p:cNvSpPr/>
            <p:nvPr/>
          </p:nvSpPr>
          <p:spPr>
            <a:xfrm>
              <a:off x="7298695" y="369580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36" name="tx44">
              <a:extLst>
                <a:ext uri="{FF2B5EF4-FFF2-40B4-BE49-F238E27FC236}">
                  <a16:creationId xmlns:a16="http://schemas.microsoft.com/office/drawing/2014/main" id="{B6C47AC2-D0C9-3AA5-1758-694057E28008}"/>
                </a:ext>
              </a:extLst>
            </p:cNvPr>
            <p:cNvSpPr/>
            <p:nvPr/>
          </p:nvSpPr>
          <p:spPr>
            <a:xfrm>
              <a:off x="1115176" y="3756509"/>
              <a:ext cx="70631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837" name="tx45">
              <a:extLst>
                <a:ext uri="{FF2B5EF4-FFF2-40B4-BE49-F238E27FC236}">
                  <a16:creationId xmlns:a16="http://schemas.microsoft.com/office/drawing/2014/main" id="{54F37497-9CFA-E757-195A-5EF131AB6957}"/>
                </a:ext>
              </a:extLst>
            </p:cNvPr>
            <p:cNvSpPr/>
            <p:nvPr/>
          </p:nvSpPr>
          <p:spPr>
            <a:xfrm>
              <a:off x="3093946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838" name="tx46">
              <a:extLst>
                <a:ext uri="{FF2B5EF4-FFF2-40B4-BE49-F238E27FC236}">
                  <a16:creationId xmlns:a16="http://schemas.microsoft.com/office/drawing/2014/main" id="{E35D515D-1641-1518-570A-D1AF5F3570FE}"/>
                </a:ext>
              </a:extLst>
            </p:cNvPr>
            <p:cNvSpPr/>
            <p:nvPr/>
          </p:nvSpPr>
          <p:spPr>
            <a:xfrm>
              <a:off x="5143347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839" name="tx47">
              <a:extLst>
                <a:ext uri="{FF2B5EF4-FFF2-40B4-BE49-F238E27FC236}">
                  <a16:creationId xmlns:a16="http://schemas.microsoft.com/office/drawing/2014/main" id="{18637A4B-E966-C36A-1DBB-5782A01865C0}"/>
                </a:ext>
              </a:extLst>
            </p:cNvPr>
            <p:cNvSpPr/>
            <p:nvPr/>
          </p:nvSpPr>
          <p:spPr>
            <a:xfrm>
              <a:off x="7192748" y="3756509"/>
              <a:ext cx="211894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840" name="tx48">
              <a:extLst>
                <a:ext uri="{FF2B5EF4-FFF2-40B4-BE49-F238E27FC236}">
                  <a16:creationId xmlns:a16="http://schemas.microsoft.com/office/drawing/2014/main" id="{4E209C5C-1127-BEBD-0961-6156C7F87C25}"/>
                </a:ext>
              </a:extLst>
            </p:cNvPr>
            <p:cNvSpPr/>
            <p:nvPr/>
          </p:nvSpPr>
          <p:spPr>
            <a:xfrm>
              <a:off x="4009884" y="3878778"/>
              <a:ext cx="1761529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ime to Transplant (Days)</a:t>
              </a:r>
            </a:p>
          </p:txBody>
        </p:sp>
        <p:sp>
          <p:nvSpPr>
            <p:cNvPr id="841" name="tx49">
              <a:extLst>
                <a:ext uri="{FF2B5EF4-FFF2-40B4-BE49-F238E27FC236}">
                  <a16:creationId xmlns:a16="http://schemas.microsoft.com/office/drawing/2014/main" id="{8543B132-C8DB-BF05-301D-262365EA4ECD}"/>
                </a:ext>
              </a:extLst>
            </p:cNvPr>
            <p:cNvSpPr/>
            <p:nvPr/>
          </p:nvSpPr>
          <p:spPr>
            <a:xfrm rot="-5400000">
              <a:off x="-985888" y="1845978"/>
              <a:ext cx="2668190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992"/>
                </a:lnSpc>
              </a:pPr>
              <a:r>
                <a:rPr sz="992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umulative Incidence of Transplant (%)</a:t>
              </a:r>
            </a:p>
          </p:txBody>
        </p:sp>
        <p:sp>
          <p:nvSpPr>
            <p:cNvPr id="842" name="rc50">
              <a:extLst>
                <a:ext uri="{FF2B5EF4-FFF2-40B4-BE49-F238E27FC236}">
                  <a16:creationId xmlns:a16="http://schemas.microsoft.com/office/drawing/2014/main" id="{45256EAB-9A4C-7933-D558-B476B07041E6}"/>
                </a:ext>
              </a:extLst>
            </p:cNvPr>
            <p:cNvSpPr/>
            <p:nvPr/>
          </p:nvSpPr>
          <p:spPr>
            <a:xfrm>
              <a:off x="4276688" y="4189554"/>
              <a:ext cx="1227921" cy="358634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843" name="rc51">
              <a:extLst>
                <a:ext uri="{FF2B5EF4-FFF2-40B4-BE49-F238E27FC236}">
                  <a16:creationId xmlns:a16="http://schemas.microsoft.com/office/drawing/2014/main" id="{546776DE-A3CD-C6FD-B836-989BAFB800C1}"/>
                </a:ext>
              </a:extLst>
            </p:cNvPr>
            <p:cNvSpPr/>
            <p:nvPr/>
          </p:nvSpPr>
          <p:spPr>
            <a:xfrm>
              <a:off x="4415866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844" name="pl52">
              <a:extLst>
                <a:ext uri="{FF2B5EF4-FFF2-40B4-BE49-F238E27FC236}">
                  <a16:creationId xmlns:a16="http://schemas.microsoft.com/office/drawing/2014/main" id="{06DB654B-EE5D-B7A3-5E9E-DB84DAEF207C}"/>
                </a:ext>
              </a:extLst>
            </p:cNvPr>
            <p:cNvSpPr/>
            <p:nvPr/>
          </p:nvSpPr>
          <p:spPr>
            <a:xfrm>
              <a:off x="4437812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45" name="rc53">
              <a:extLst>
                <a:ext uri="{FF2B5EF4-FFF2-40B4-BE49-F238E27FC236}">
                  <a16:creationId xmlns:a16="http://schemas.microsoft.com/office/drawing/2014/main" id="{B86F7EB0-46C5-0D82-D1FE-40B992BAF0DE}"/>
                </a:ext>
              </a:extLst>
            </p:cNvPr>
            <p:cNvSpPr/>
            <p:nvPr/>
          </p:nvSpPr>
          <p:spPr>
            <a:xfrm>
              <a:off x="4926900" y="4259144"/>
              <a:ext cx="219455" cy="21945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846" name="pl54">
              <a:extLst>
                <a:ext uri="{FF2B5EF4-FFF2-40B4-BE49-F238E27FC236}">
                  <a16:creationId xmlns:a16="http://schemas.microsoft.com/office/drawing/2014/main" id="{7654B9B5-C3A1-B0B4-AA4E-D9542D6CE83F}"/>
                </a:ext>
              </a:extLst>
            </p:cNvPr>
            <p:cNvSpPr/>
            <p:nvPr/>
          </p:nvSpPr>
          <p:spPr>
            <a:xfrm>
              <a:off x="4948846" y="4368872"/>
              <a:ext cx="175564" cy="0"/>
            </a:xfrm>
            <a:custGeom>
              <a:avLst/>
              <a:gdLst/>
              <a:ahLst/>
              <a:cxnLst/>
              <a:rect l="0" t="0" r="0" b="0"/>
              <a:pathLst>
                <a:path w="175564">
                  <a:moveTo>
                    <a:pt x="0" y="0"/>
                  </a:moveTo>
                  <a:lnTo>
                    <a:pt x="175564" y="0"/>
                  </a:lnTo>
                </a:path>
              </a:pathLst>
            </a:custGeom>
            <a:ln w="13550" cap="flat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47" name="tx55">
              <a:extLst>
                <a:ext uri="{FF2B5EF4-FFF2-40B4-BE49-F238E27FC236}">
                  <a16:creationId xmlns:a16="http://schemas.microsoft.com/office/drawing/2014/main" id="{1B2E2301-DF92-3B8A-733F-BED4BE60BDB9}"/>
                </a:ext>
              </a:extLst>
            </p:cNvPr>
            <p:cNvSpPr/>
            <p:nvPr/>
          </p:nvSpPr>
          <p:spPr>
            <a:xfrm>
              <a:off x="4704911" y="4321929"/>
              <a:ext cx="162346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848" name="tx56">
              <a:extLst>
                <a:ext uri="{FF2B5EF4-FFF2-40B4-BE49-F238E27FC236}">
                  <a16:creationId xmlns:a16="http://schemas.microsoft.com/office/drawing/2014/main" id="{00FC4171-B7CB-A62D-C033-A8B646714ECF}"/>
                </a:ext>
              </a:extLst>
            </p:cNvPr>
            <p:cNvSpPr/>
            <p:nvPr/>
          </p:nvSpPr>
          <p:spPr>
            <a:xfrm>
              <a:off x="5215945" y="4321929"/>
              <a:ext cx="218839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  <p:sp>
          <p:nvSpPr>
            <p:cNvPr id="849" name="rc57">
              <a:extLst>
                <a:ext uri="{FF2B5EF4-FFF2-40B4-BE49-F238E27FC236}">
                  <a16:creationId xmlns:a16="http://schemas.microsoft.com/office/drawing/2014/main" id="{62C6F1E8-7137-2739-C109-74153AF184D2}"/>
                </a:ext>
              </a:extLst>
            </p:cNvPr>
            <p:cNvSpPr/>
            <p:nvPr/>
          </p:nvSpPr>
          <p:spPr>
            <a:xfrm>
              <a:off x="69589" y="4617778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50" name="rc58">
              <a:extLst>
                <a:ext uri="{FF2B5EF4-FFF2-40B4-BE49-F238E27FC236}">
                  <a16:creationId xmlns:a16="http://schemas.microsoft.com/office/drawing/2014/main" id="{39DFCF4F-E5A7-09A3-D8C0-B2913770532C}"/>
                </a:ext>
              </a:extLst>
            </p:cNvPr>
            <p:cNvSpPr/>
            <p:nvPr/>
          </p:nvSpPr>
          <p:spPr>
            <a:xfrm>
              <a:off x="776476" y="4996549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851" name="tx59">
              <a:extLst>
                <a:ext uri="{FF2B5EF4-FFF2-40B4-BE49-F238E27FC236}">
                  <a16:creationId xmlns:a16="http://schemas.microsoft.com/office/drawing/2014/main" id="{7C5DA49B-65B8-172C-73F7-57BA4EEEE496}"/>
                </a:ext>
              </a:extLst>
            </p:cNvPr>
            <p:cNvSpPr/>
            <p:nvPr/>
          </p:nvSpPr>
          <p:spPr>
            <a:xfrm>
              <a:off x="1115323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852" name="tx60">
              <a:extLst>
                <a:ext uri="{FF2B5EF4-FFF2-40B4-BE49-F238E27FC236}">
                  <a16:creationId xmlns:a16="http://schemas.microsoft.com/office/drawing/2014/main" id="{4BF9C9EA-1F38-9454-9CDF-3554F2C27833}"/>
                </a:ext>
              </a:extLst>
            </p:cNvPr>
            <p:cNvSpPr/>
            <p:nvPr/>
          </p:nvSpPr>
          <p:spPr>
            <a:xfrm>
              <a:off x="1115323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</a:t>
              </a:r>
            </a:p>
          </p:txBody>
        </p:sp>
        <p:sp>
          <p:nvSpPr>
            <p:cNvPr id="853" name="tx61">
              <a:extLst>
                <a:ext uri="{FF2B5EF4-FFF2-40B4-BE49-F238E27FC236}">
                  <a16:creationId xmlns:a16="http://schemas.microsoft.com/office/drawing/2014/main" id="{03D4F6B6-B3D0-1AC9-3A5A-FE9A391805B2}"/>
                </a:ext>
              </a:extLst>
            </p:cNvPr>
            <p:cNvSpPr/>
            <p:nvPr/>
          </p:nvSpPr>
          <p:spPr>
            <a:xfrm>
              <a:off x="3164724" y="5439829"/>
              <a:ext cx="70337" cy="905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854" name="tx62">
              <a:extLst>
                <a:ext uri="{FF2B5EF4-FFF2-40B4-BE49-F238E27FC236}">
                  <a16:creationId xmlns:a16="http://schemas.microsoft.com/office/drawing/2014/main" id="{0F3F9228-6F10-05CD-0F10-60D03D424B62}"/>
                </a:ext>
              </a:extLst>
            </p:cNvPr>
            <p:cNvSpPr/>
            <p:nvPr/>
          </p:nvSpPr>
          <p:spPr>
            <a:xfrm>
              <a:off x="3164724" y="5134179"/>
              <a:ext cx="70337" cy="9084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855" name="tx63">
              <a:extLst>
                <a:ext uri="{FF2B5EF4-FFF2-40B4-BE49-F238E27FC236}">
                  <a16:creationId xmlns:a16="http://schemas.microsoft.com/office/drawing/2014/main" id="{B169B54E-20CA-5B04-C26D-50FF92C5C2F5}"/>
                </a:ext>
              </a:extLst>
            </p:cNvPr>
            <p:cNvSpPr/>
            <p:nvPr/>
          </p:nvSpPr>
          <p:spPr>
            <a:xfrm>
              <a:off x="5214125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856" name="tx64">
              <a:extLst>
                <a:ext uri="{FF2B5EF4-FFF2-40B4-BE49-F238E27FC236}">
                  <a16:creationId xmlns:a16="http://schemas.microsoft.com/office/drawing/2014/main" id="{404756E9-457C-E179-9C77-4E7221B53F89}"/>
                </a:ext>
              </a:extLst>
            </p:cNvPr>
            <p:cNvSpPr/>
            <p:nvPr/>
          </p:nvSpPr>
          <p:spPr>
            <a:xfrm>
              <a:off x="5214125" y="5134117"/>
              <a:ext cx="70337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857" name="tx65">
              <a:extLst>
                <a:ext uri="{FF2B5EF4-FFF2-40B4-BE49-F238E27FC236}">
                  <a16:creationId xmlns:a16="http://schemas.microsoft.com/office/drawing/2014/main" id="{C08E2D3C-5291-D973-D236-472BE373CA0F}"/>
                </a:ext>
              </a:extLst>
            </p:cNvPr>
            <p:cNvSpPr/>
            <p:nvPr/>
          </p:nvSpPr>
          <p:spPr>
            <a:xfrm>
              <a:off x="7263526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858" name="tx66">
              <a:extLst>
                <a:ext uri="{FF2B5EF4-FFF2-40B4-BE49-F238E27FC236}">
                  <a16:creationId xmlns:a16="http://schemas.microsoft.com/office/drawing/2014/main" id="{A93C830E-CB1F-EB3A-7611-835D37D32B86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859" name="tx67">
              <a:extLst>
                <a:ext uri="{FF2B5EF4-FFF2-40B4-BE49-F238E27FC236}">
                  <a16:creationId xmlns:a16="http://schemas.microsoft.com/office/drawing/2014/main" id="{70F328C8-C9A2-DC50-3D40-B50EB0812942}"/>
                </a:ext>
              </a:extLst>
            </p:cNvPr>
            <p:cNvSpPr/>
            <p:nvPr/>
          </p:nvSpPr>
          <p:spPr>
            <a:xfrm>
              <a:off x="7263526" y="5437915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860" name="tx68">
              <a:extLst>
                <a:ext uri="{FF2B5EF4-FFF2-40B4-BE49-F238E27FC236}">
                  <a16:creationId xmlns:a16="http://schemas.microsoft.com/office/drawing/2014/main" id="{5F86A08C-1BCA-7856-BE9C-5AF1C8FE296B}"/>
                </a:ext>
              </a:extLst>
            </p:cNvPr>
            <p:cNvSpPr/>
            <p:nvPr/>
          </p:nvSpPr>
          <p:spPr>
            <a:xfrm>
              <a:off x="7263526" y="5132574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861" name="tx69">
              <a:extLst>
                <a:ext uri="{FF2B5EF4-FFF2-40B4-BE49-F238E27FC236}">
                  <a16:creationId xmlns:a16="http://schemas.microsoft.com/office/drawing/2014/main" id="{A0FEDDEB-2E01-F712-C0E1-1A72CE4AE9B6}"/>
                </a:ext>
              </a:extLst>
            </p:cNvPr>
            <p:cNvSpPr/>
            <p:nvPr/>
          </p:nvSpPr>
          <p:spPr>
            <a:xfrm>
              <a:off x="325591" y="5438152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862" name="tx70">
              <a:extLst>
                <a:ext uri="{FF2B5EF4-FFF2-40B4-BE49-F238E27FC236}">
                  <a16:creationId xmlns:a16="http://schemas.microsoft.com/office/drawing/2014/main" id="{D06F7A5C-40CA-65F4-A6F3-7D47FEA8B8E2}"/>
                </a:ext>
              </a:extLst>
            </p:cNvPr>
            <p:cNvSpPr/>
            <p:nvPr/>
          </p:nvSpPr>
          <p:spPr>
            <a:xfrm>
              <a:off x="311638" y="5132811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863" name="tx71">
              <a:extLst>
                <a:ext uri="{FF2B5EF4-FFF2-40B4-BE49-F238E27FC236}">
                  <a16:creationId xmlns:a16="http://schemas.microsoft.com/office/drawing/2014/main" id="{74742B52-999E-65EA-BE8A-1F20BAA18CF6}"/>
                </a:ext>
              </a:extLst>
            </p:cNvPr>
            <p:cNvSpPr/>
            <p:nvPr/>
          </p:nvSpPr>
          <p:spPr>
            <a:xfrm>
              <a:off x="776476" y="4827633"/>
              <a:ext cx="17452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</a:t>
              </a:r>
            </a:p>
          </p:txBody>
        </p:sp>
        <p:sp>
          <p:nvSpPr>
            <p:cNvPr id="864" name="rc72">
              <a:extLst>
                <a:ext uri="{FF2B5EF4-FFF2-40B4-BE49-F238E27FC236}">
                  <a16:creationId xmlns:a16="http://schemas.microsoft.com/office/drawing/2014/main" id="{D29CA052-FF4E-5946-062E-C00C636F0379}"/>
                </a:ext>
              </a:extLst>
            </p:cNvPr>
            <p:cNvSpPr/>
            <p:nvPr/>
          </p:nvSpPr>
          <p:spPr>
            <a:xfrm>
              <a:off x="69589" y="5703094"/>
              <a:ext cx="9004821" cy="108531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488"/>
            </a:p>
          </p:txBody>
        </p:sp>
        <p:sp>
          <p:nvSpPr>
            <p:cNvPr id="865" name="rc73">
              <a:extLst>
                <a:ext uri="{FF2B5EF4-FFF2-40B4-BE49-F238E27FC236}">
                  <a16:creationId xmlns:a16="http://schemas.microsoft.com/office/drawing/2014/main" id="{7F7157B2-EDE0-DFDA-02F6-AEB6A38296D5}"/>
                </a:ext>
              </a:extLst>
            </p:cNvPr>
            <p:cNvSpPr/>
            <p:nvPr/>
          </p:nvSpPr>
          <p:spPr>
            <a:xfrm>
              <a:off x="776476" y="6081865"/>
              <a:ext cx="8228345" cy="67175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488"/>
            </a:p>
          </p:txBody>
        </p:sp>
        <p:sp>
          <p:nvSpPr>
            <p:cNvPr id="866" name="tx74">
              <a:extLst>
                <a:ext uri="{FF2B5EF4-FFF2-40B4-BE49-F238E27FC236}">
                  <a16:creationId xmlns:a16="http://schemas.microsoft.com/office/drawing/2014/main" id="{E126BB2E-65B5-D9E2-30DC-B0BEFDCB9E78}"/>
                </a:ext>
              </a:extLst>
            </p:cNvPr>
            <p:cNvSpPr/>
            <p:nvPr/>
          </p:nvSpPr>
          <p:spPr>
            <a:xfrm>
              <a:off x="1115323" y="6523231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867" name="tx75">
              <a:extLst>
                <a:ext uri="{FF2B5EF4-FFF2-40B4-BE49-F238E27FC236}">
                  <a16:creationId xmlns:a16="http://schemas.microsoft.com/office/drawing/2014/main" id="{4EDF71CC-FBE0-6505-9AFD-F4D0682D9618}"/>
                </a:ext>
              </a:extLst>
            </p:cNvPr>
            <p:cNvSpPr/>
            <p:nvPr/>
          </p:nvSpPr>
          <p:spPr>
            <a:xfrm>
              <a:off x="1080154" y="6217890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6</a:t>
              </a:r>
            </a:p>
          </p:txBody>
        </p:sp>
        <p:sp>
          <p:nvSpPr>
            <p:cNvPr id="868" name="tx76">
              <a:extLst>
                <a:ext uri="{FF2B5EF4-FFF2-40B4-BE49-F238E27FC236}">
                  <a16:creationId xmlns:a16="http://schemas.microsoft.com/office/drawing/2014/main" id="{7BD21350-EF42-9058-4FCF-E757B211E143}"/>
                </a:ext>
              </a:extLst>
            </p:cNvPr>
            <p:cNvSpPr/>
            <p:nvPr/>
          </p:nvSpPr>
          <p:spPr>
            <a:xfrm>
              <a:off x="3129555" y="6523231"/>
              <a:ext cx="140675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869" name="tx77">
              <a:extLst>
                <a:ext uri="{FF2B5EF4-FFF2-40B4-BE49-F238E27FC236}">
                  <a16:creationId xmlns:a16="http://schemas.microsoft.com/office/drawing/2014/main" id="{FF7E7034-0934-D863-B074-0BEC7FD59BC1}"/>
                </a:ext>
              </a:extLst>
            </p:cNvPr>
            <p:cNvSpPr/>
            <p:nvPr/>
          </p:nvSpPr>
          <p:spPr>
            <a:xfrm>
              <a:off x="3129555" y="6219434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1</a:t>
              </a:r>
            </a:p>
          </p:txBody>
        </p:sp>
        <p:sp>
          <p:nvSpPr>
            <p:cNvPr id="870" name="tx78">
              <a:extLst>
                <a:ext uri="{FF2B5EF4-FFF2-40B4-BE49-F238E27FC236}">
                  <a16:creationId xmlns:a16="http://schemas.microsoft.com/office/drawing/2014/main" id="{2D57F4A1-564A-4195-E68D-06625154F251}"/>
                </a:ext>
              </a:extLst>
            </p:cNvPr>
            <p:cNvSpPr/>
            <p:nvPr/>
          </p:nvSpPr>
          <p:spPr>
            <a:xfrm>
              <a:off x="5178956" y="6524775"/>
              <a:ext cx="140675" cy="909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7</a:t>
              </a:r>
            </a:p>
          </p:txBody>
        </p:sp>
        <p:sp>
          <p:nvSpPr>
            <p:cNvPr id="871" name="tx79">
              <a:extLst>
                <a:ext uri="{FF2B5EF4-FFF2-40B4-BE49-F238E27FC236}">
                  <a16:creationId xmlns:a16="http://schemas.microsoft.com/office/drawing/2014/main" id="{584924EE-7649-7926-B21E-B40763B70387}"/>
                </a:ext>
              </a:extLst>
            </p:cNvPr>
            <p:cNvSpPr/>
            <p:nvPr/>
          </p:nvSpPr>
          <p:spPr>
            <a:xfrm>
              <a:off x="5178956" y="6217828"/>
              <a:ext cx="140675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3</a:t>
              </a:r>
            </a:p>
          </p:txBody>
        </p:sp>
        <p:sp>
          <p:nvSpPr>
            <p:cNvPr id="872" name="tx80">
              <a:extLst>
                <a:ext uri="{FF2B5EF4-FFF2-40B4-BE49-F238E27FC236}">
                  <a16:creationId xmlns:a16="http://schemas.microsoft.com/office/drawing/2014/main" id="{28D64F86-325C-CE05-0B51-29DBB0A5E600}"/>
                </a:ext>
              </a:extLst>
            </p:cNvPr>
            <p:cNvSpPr/>
            <p:nvPr/>
          </p:nvSpPr>
          <p:spPr>
            <a:xfrm>
              <a:off x="7228357" y="6523169"/>
              <a:ext cx="140675" cy="9250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873" name="tx81">
              <a:extLst>
                <a:ext uri="{FF2B5EF4-FFF2-40B4-BE49-F238E27FC236}">
                  <a16:creationId xmlns:a16="http://schemas.microsoft.com/office/drawing/2014/main" id="{27C09D56-1377-D7E0-DAE2-D8681884D744}"/>
                </a:ext>
              </a:extLst>
            </p:cNvPr>
            <p:cNvSpPr/>
            <p:nvPr/>
          </p:nvSpPr>
          <p:spPr>
            <a:xfrm>
              <a:off x="7263526" y="6217890"/>
              <a:ext cx="70337" cy="924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3"/>
                </a:lnSpc>
              </a:pPr>
              <a:r>
                <a:rPr sz="823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</a:t>
              </a:r>
            </a:p>
          </p:txBody>
        </p:sp>
        <p:sp>
          <p:nvSpPr>
            <p:cNvPr id="874" name="tx82">
              <a:extLst>
                <a:ext uri="{FF2B5EF4-FFF2-40B4-BE49-F238E27FC236}">
                  <a16:creationId xmlns:a16="http://schemas.microsoft.com/office/drawing/2014/main" id="{D6F81355-F1DD-88C9-E238-B37430BE99CD}"/>
                </a:ext>
              </a:extLst>
            </p:cNvPr>
            <p:cNvSpPr/>
            <p:nvPr/>
          </p:nvSpPr>
          <p:spPr>
            <a:xfrm>
              <a:off x="325591" y="6523468"/>
              <a:ext cx="388255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vents</a:t>
              </a:r>
            </a:p>
          </p:txBody>
        </p:sp>
        <p:sp>
          <p:nvSpPr>
            <p:cNvPr id="875" name="tx83">
              <a:extLst>
                <a:ext uri="{FF2B5EF4-FFF2-40B4-BE49-F238E27FC236}">
                  <a16:creationId xmlns:a16="http://schemas.microsoft.com/office/drawing/2014/main" id="{47DA4522-B433-9BF5-4BC5-E5AE804A0D1D}"/>
                </a:ext>
              </a:extLst>
            </p:cNvPr>
            <p:cNvSpPr/>
            <p:nvPr/>
          </p:nvSpPr>
          <p:spPr>
            <a:xfrm>
              <a:off x="311638" y="6218127"/>
              <a:ext cx="40220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27"/>
                </a:lnSpc>
              </a:pPr>
              <a:r>
                <a:rPr sz="827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t Risk</a:t>
              </a:r>
            </a:p>
          </p:txBody>
        </p:sp>
        <p:sp>
          <p:nvSpPr>
            <p:cNvPr id="876" name="tx84">
              <a:extLst>
                <a:ext uri="{FF2B5EF4-FFF2-40B4-BE49-F238E27FC236}">
                  <a16:creationId xmlns:a16="http://schemas.microsoft.com/office/drawing/2014/main" id="{2926DC0C-C97B-DCA8-C93F-7D1C30C7F11D}"/>
                </a:ext>
              </a:extLst>
            </p:cNvPr>
            <p:cNvSpPr/>
            <p:nvPr/>
          </p:nvSpPr>
          <p:spPr>
            <a:xfrm>
              <a:off x="776476" y="5912949"/>
              <a:ext cx="235252" cy="9932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889"/>
                </a:lnSpc>
              </a:pPr>
              <a:r>
                <a:rPr sz="889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Yes</a:t>
              </a:r>
            </a:p>
          </p:txBody>
        </p:sp>
      </p:grpSp>
      <p:sp>
        <p:nvSpPr>
          <p:cNvPr id="877" name="TextBox 876">
            <a:extLst>
              <a:ext uri="{FF2B5EF4-FFF2-40B4-BE49-F238E27FC236}">
                <a16:creationId xmlns:a16="http://schemas.microsoft.com/office/drawing/2014/main" id="{0E8A43B2-601C-B603-66C1-F17E390AF055}"/>
              </a:ext>
            </a:extLst>
          </p:cNvPr>
          <p:cNvSpPr txBox="1"/>
          <p:nvPr/>
        </p:nvSpPr>
        <p:spPr>
          <a:xfrm>
            <a:off x="5510874" y="9301761"/>
            <a:ext cx="2877987" cy="6014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27" b="1" dirty="0">
                <a:latin typeface="Arial" panose="020B0604020202020204" pitchFamily="34" charset="0"/>
                <a:cs typeface="Arial" panose="020B0604020202020204" pitchFamily="34" charset="0"/>
              </a:rPr>
              <a:t>Potential Living Donor Total   Event   HR (95% CI)</a:t>
            </a:r>
          </a:p>
          <a:p>
            <a:r>
              <a:rPr lang="en-US" sz="827" dirty="0">
                <a:latin typeface="Arial" panose="020B0604020202020204" pitchFamily="34" charset="0"/>
                <a:cs typeface="Arial" panose="020B0604020202020204" pitchFamily="34" charset="0"/>
              </a:rPr>
              <a:t>No                                      9         6         Reference</a:t>
            </a:r>
          </a:p>
          <a:p>
            <a:r>
              <a:rPr lang="en-US" sz="827" dirty="0">
                <a:latin typeface="Arial" panose="020B0604020202020204" pitchFamily="34" charset="0"/>
                <a:cs typeface="Arial" panose="020B0604020202020204" pitchFamily="34" charset="0"/>
              </a:rPr>
              <a:t>Yes                                    46       30       0.91 (0.35 – 2.36)</a:t>
            </a:r>
          </a:p>
          <a:p>
            <a:r>
              <a:rPr lang="en-US" sz="827" dirty="0">
                <a:latin typeface="Arial" panose="020B0604020202020204" pitchFamily="34" charset="0"/>
                <a:cs typeface="Arial" panose="020B0604020202020204" pitchFamily="34" charset="0"/>
              </a:rPr>
              <a:t>Gray K-Sample Test P-value: 0.6665</a:t>
            </a:r>
          </a:p>
        </p:txBody>
      </p:sp>
      <p:sp>
        <p:nvSpPr>
          <p:cNvPr id="878" name="pl48">
            <a:extLst>
              <a:ext uri="{FF2B5EF4-FFF2-40B4-BE49-F238E27FC236}">
                <a16:creationId xmlns:a16="http://schemas.microsoft.com/office/drawing/2014/main" id="{5E257A62-25A0-B02D-96E0-E294B690138D}"/>
              </a:ext>
            </a:extLst>
          </p:cNvPr>
          <p:cNvSpPr/>
          <p:nvPr/>
        </p:nvSpPr>
        <p:spPr>
          <a:xfrm>
            <a:off x="5373281" y="9529559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F8766D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  <p:sp>
        <p:nvSpPr>
          <p:cNvPr id="879" name="pl50">
            <a:extLst>
              <a:ext uri="{FF2B5EF4-FFF2-40B4-BE49-F238E27FC236}">
                <a16:creationId xmlns:a16="http://schemas.microsoft.com/office/drawing/2014/main" id="{A9E15B38-6615-B302-E384-FAB215FBD6CD}"/>
              </a:ext>
            </a:extLst>
          </p:cNvPr>
          <p:cNvSpPr/>
          <p:nvPr/>
        </p:nvSpPr>
        <p:spPr>
          <a:xfrm>
            <a:off x="5372658" y="9654054"/>
            <a:ext cx="131624" cy="0"/>
          </a:xfrm>
          <a:custGeom>
            <a:avLst/>
            <a:gdLst/>
            <a:ahLst/>
            <a:cxnLst/>
            <a:rect l="0" t="0" r="0" b="0"/>
            <a:pathLst>
              <a:path w="175564">
                <a:moveTo>
                  <a:pt x="0" y="0"/>
                </a:moveTo>
                <a:lnTo>
                  <a:pt x="175564" y="0"/>
                </a:lnTo>
              </a:path>
            </a:pathLst>
          </a:custGeom>
          <a:ln w="28575" cap="flat">
            <a:solidFill>
              <a:srgbClr val="00BFC4">
                <a:alpha val="100000"/>
              </a:srgbClr>
            </a:solidFill>
            <a:prstDash val="solid"/>
            <a:round/>
          </a:ln>
        </p:spPr>
        <p:txBody>
          <a:bodyPr/>
          <a:lstStyle/>
          <a:p>
            <a:endParaRPr sz="1488"/>
          </a:p>
        </p:txBody>
      </p:sp>
    </p:spTree>
    <p:extLst>
      <p:ext uri="{BB962C8B-B14F-4D97-AF65-F5344CB8AC3E}">
        <p14:creationId xmlns:p14="http://schemas.microsoft.com/office/powerpoint/2010/main" val="33505811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960EFA28E7E5B42BEBDE0FCA82B64D3" ma:contentTypeVersion="14" ma:contentTypeDescription="Create a new document." ma:contentTypeScope="" ma:versionID="f3d88e86c2abb1ff74ae06fbcffbeb5a">
  <xsd:schema xmlns:xsd="http://www.w3.org/2001/XMLSchema" xmlns:xs="http://www.w3.org/2001/XMLSchema" xmlns:p="http://schemas.microsoft.com/office/2006/metadata/properties" xmlns:ns3="19a5b3d0-3b33-4ae0-8139-d9ebc735e96b" xmlns:ns4="e527ef3d-44d7-4017-ac01-03a4af520efa" targetNamespace="http://schemas.microsoft.com/office/2006/metadata/properties" ma:root="true" ma:fieldsID="9481204a2702615b5455335d9fd37a27" ns3:_="" ns4:_="">
    <xsd:import namespace="19a5b3d0-3b33-4ae0-8139-d9ebc735e96b"/>
    <xsd:import namespace="e527ef3d-44d7-4017-ac01-03a4af520efa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a5b3d0-3b33-4ae0-8139-d9ebc735e96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dexed="true" ma:internalName="MediaServiceLocation" ma:readOnly="true">
      <xsd:simpleType>
        <xsd:restriction base="dms:Text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527ef3d-44d7-4017-ac01-03a4af520efa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9a5b3d0-3b33-4ae0-8139-d9ebc735e96b" xsi:nil="true"/>
  </documentManagement>
</p:properties>
</file>

<file path=customXml/itemProps1.xml><?xml version="1.0" encoding="utf-8"?>
<ds:datastoreItem xmlns:ds="http://schemas.openxmlformats.org/officeDocument/2006/customXml" ds:itemID="{2332618A-DCB6-460C-9F7E-BA5057A87B0A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5F443F8-37A4-480A-B8E6-2A080CA7729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9a5b3d0-3b33-4ae0-8139-d9ebc735e96b"/>
    <ds:schemaRef ds:uri="e527ef3d-44d7-4017-ac01-03a4af520ef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8AD95745-BAF0-43FC-8016-54EF614A3A16}">
  <ds:schemaRefs>
    <ds:schemaRef ds:uri="http://purl.org/dc/dcmitype/"/>
    <ds:schemaRef ds:uri="http://purl.org/dc/elements/1.1/"/>
    <ds:schemaRef ds:uri="http://schemas.microsoft.com/office/2006/metadata/properties"/>
    <ds:schemaRef ds:uri="http://schemas.microsoft.com/office/2006/documentManagement/types"/>
    <ds:schemaRef ds:uri="19a5b3d0-3b33-4ae0-8139-d9ebc735e96b"/>
    <ds:schemaRef ds:uri="http://www.w3.org/XML/1998/namespace"/>
    <ds:schemaRef ds:uri="http://purl.org/dc/terms/"/>
    <ds:schemaRef ds:uri="http://schemas.microsoft.com/office/infopath/2007/PartnerControls"/>
    <ds:schemaRef ds:uri="http://schemas.openxmlformats.org/package/2006/metadata/core-properties"/>
    <ds:schemaRef ds:uri="e527ef3d-44d7-4017-ac01-03a4af520ef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267</TotalTime>
  <Words>1933</Words>
  <Application>Microsoft Macintosh PowerPoint</Application>
  <PresentationFormat>Custom</PresentationFormat>
  <Paragraphs>742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Shiyi</dc:creator>
  <cp:lastModifiedBy>Katina Zheng</cp:lastModifiedBy>
  <cp:revision>176</cp:revision>
  <dcterms:created xsi:type="dcterms:W3CDTF">2023-02-27T00:36:48Z</dcterms:created>
  <dcterms:modified xsi:type="dcterms:W3CDTF">2023-04-14T04:04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960EFA28E7E5B42BEBDE0FCA82B64D3</vt:lpwstr>
  </property>
</Properties>
</file>